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theme/themeOverride1.xml" ContentType="application/vnd.openxmlformats-officedocument.themeOverride+xml"/>
  <Override PartName="/ppt/charts/chart2.xml" ContentType="application/vnd.openxmlformats-officedocument.drawingml.chart+xml"/>
  <Override PartName="/ppt/theme/themeOverride2.xml" ContentType="application/vnd.openxmlformats-officedocument.themeOverrid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6"/>
  </p:notesMasterIdLst>
  <p:sldIdLst>
    <p:sldId id="265" r:id="rId2"/>
    <p:sldId id="268" r:id="rId3"/>
    <p:sldId id="273" r:id="rId4"/>
    <p:sldId id="272" r:id="rId5"/>
    <p:sldId id="270" r:id="rId6"/>
    <p:sldId id="257" r:id="rId7"/>
    <p:sldId id="258" r:id="rId8"/>
    <p:sldId id="259" r:id="rId9"/>
    <p:sldId id="260" r:id="rId10"/>
    <p:sldId id="261" r:id="rId11"/>
    <p:sldId id="262" r:id="rId12"/>
    <p:sldId id="263" r:id="rId13"/>
    <p:sldId id="264" r:id="rId14"/>
    <p:sldId id="256" r:id="rId15"/>
  </p:sldIdLst>
  <p:sldSz cx="9144000" cy="6858000" type="screen4x3"/>
  <p:notesSz cx="6858000" cy="9144000"/>
  <p:defaultTextStyle>
    <a:defPPr>
      <a:defRPr lang="es-C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howGuides="1">
      <p:cViewPr varScale="1">
        <p:scale>
          <a:sx n="101" d="100"/>
          <a:sy n="101" d="100"/>
        </p:scale>
        <p:origin x="294" y="108"/>
      </p:cViewPr>
      <p:guideLst>
        <p:guide orient="horz" pos="2160"/>
        <p:guide pos="2880"/>
      </p:guideLst>
    </p:cSldViewPr>
  </p:slideViewPr>
  <p:notesTextViewPr>
    <p:cViewPr>
      <p:scale>
        <a:sx n="3" d="2"/>
        <a:sy n="3" d="2"/>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rts/_rels/chart1.xml.rels><?xml version="1.0" encoding="UTF-8" standalone="yes"?>
<Relationships xmlns="http://schemas.openxmlformats.org/package/2006/relationships"><Relationship Id="rId2" Type="http://schemas.openxmlformats.org/officeDocument/2006/relationships/oleObject" Target="file:///E:\ARQUEAS\datos%20excel\Antiguo\04%20abril%202017%20ALCOLOR(06042017)alb-coloreadas.XLS" TargetMode="External"/><Relationship Id="rId1" Type="http://schemas.openxmlformats.org/officeDocument/2006/relationships/themeOverride" Target="../theme/themeOverride1.xml"/></Relationships>
</file>

<file path=ppt/charts/_rels/chart2.xml.rels><?xml version="1.0" encoding="UTF-8" standalone="yes"?>
<Relationships xmlns="http://schemas.openxmlformats.org/package/2006/relationships"><Relationship Id="rId2" Type="http://schemas.openxmlformats.org/officeDocument/2006/relationships/oleObject" Target="file:///E:\ARQUEAS\datos%20excel\Antiguo\04%20abril%202017%20ALCOLOR(06042017)alb-coloreadas.XLS" TargetMode="External"/><Relationship Id="rId1" Type="http://schemas.openxmlformats.org/officeDocument/2006/relationships/themeOverride" Target="../theme/themeOverrid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1"/>
    </mc:Choice>
    <mc:Fallback>
      <c:style val="1"/>
    </mc:Fallback>
  </mc:AlternateContent>
  <c:clrMapOvr bg1="lt1" tx1="dk1" bg2="lt2" tx2="dk2" accent1="accent1" accent2="accent2" accent3="accent3" accent4="accent4" accent5="accent5" accent6="accent6" hlink="hlink" folHlink="folHlink"/>
  <c:chart>
    <c:autoTitleDeleted val="0"/>
    <c:plotArea>
      <c:layout>
        <c:manualLayout>
          <c:layoutTarget val="inner"/>
          <c:xMode val="edge"/>
          <c:yMode val="edge"/>
          <c:x val="0.12471380471380471"/>
          <c:y val="2.684864391951006E-2"/>
          <c:w val="0.820202903929938"/>
          <c:h val="0.8142193589437684"/>
        </c:manualLayout>
      </c:layout>
      <c:lineChart>
        <c:grouping val="standard"/>
        <c:varyColors val="0"/>
        <c:ser>
          <c:idx val="0"/>
          <c:order val="0"/>
          <c:tx>
            <c:strRef>
              <c:f>'Prod Car'!$P$3</c:f>
              <c:strCache>
                <c:ptCount val="1"/>
                <c:pt idx="0">
                  <c:v>15% NaCl</c:v>
                </c:pt>
              </c:strCache>
            </c:strRef>
          </c:tx>
          <c:spPr>
            <a:ln>
              <a:solidFill>
                <a:schemeClr val="tx1"/>
              </a:solidFill>
              <a:prstDash val="solid"/>
            </a:ln>
          </c:spPr>
          <c:errBars>
            <c:errDir val="y"/>
            <c:errBarType val="both"/>
            <c:errValType val="cust"/>
            <c:noEndCap val="0"/>
            <c:plus>
              <c:numRef>
                <c:f>'Prod Car'!$Q$12:$U$12</c:f>
                <c:numCache>
                  <c:formatCode>General</c:formatCode>
                  <c:ptCount val="5"/>
                  <c:pt idx="0">
                    <c:v>8.0330224924807236</c:v>
                  </c:pt>
                  <c:pt idx="1">
                    <c:v>0.99612582873182587</c:v>
                  </c:pt>
                  <c:pt idx="2">
                    <c:v>1.8890325046353056</c:v>
                  </c:pt>
                  <c:pt idx="3">
                    <c:v>0.82254925841869653</c:v>
                  </c:pt>
                  <c:pt idx="4">
                    <c:v>5.6068401703131645</c:v>
                  </c:pt>
                </c:numCache>
              </c:numRef>
            </c:plus>
            <c:minus>
              <c:numRef>
                <c:f>'Prod Car'!$Q$12:$U$12</c:f>
                <c:numCache>
                  <c:formatCode>General</c:formatCode>
                  <c:ptCount val="5"/>
                  <c:pt idx="0">
                    <c:v>8.0330224924807236</c:v>
                  </c:pt>
                  <c:pt idx="1">
                    <c:v>0.99612582873182587</c:v>
                  </c:pt>
                  <c:pt idx="2">
                    <c:v>1.8890325046353056</c:v>
                  </c:pt>
                  <c:pt idx="3">
                    <c:v>0.82254925841869653</c:v>
                  </c:pt>
                  <c:pt idx="4">
                    <c:v>5.6068401703131645</c:v>
                  </c:pt>
                </c:numCache>
              </c:numRef>
            </c:minus>
          </c:errBars>
          <c:cat>
            <c:numRef>
              <c:f>'Prod Car'!$Q$2:$U$2</c:f>
              <c:numCache>
                <c:formatCode>General</c:formatCode>
                <c:ptCount val="5"/>
                <c:pt idx="0">
                  <c:v>0</c:v>
                </c:pt>
                <c:pt idx="1">
                  <c:v>48</c:v>
                </c:pt>
                <c:pt idx="2">
                  <c:v>96</c:v>
                </c:pt>
                <c:pt idx="3">
                  <c:v>144</c:v>
                </c:pt>
                <c:pt idx="4">
                  <c:v>192</c:v>
                </c:pt>
              </c:numCache>
            </c:numRef>
          </c:cat>
          <c:val>
            <c:numRef>
              <c:f>'Prod Car'!$Q$3:$U$3</c:f>
              <c:numCache>
                <c:formatCode>0</c:formatCode>
                <c:ptCount val="5"/>
                <c:pt idx="0">
                  <c:v>37.578807676988106</c:v>
                </c:pt>
                <c:pt idx="1">
                  <c:v>2.44</c:v>
                </c:pt>
                <c:pt idx="2">
                  <c:v>14.326397518489356</c:v>
                </c:pt>
                <c:pt idx="3">
                  <c:v>19.023714466194924</c:v>
                </c:pt>
                <c:pt idx="4">
                  <c:v>22.768206997850807</c:v>
                </c:pt>
              </c:numCache>
            </c:numRef>
          </c:val>
          <c:smooth val="0"/>
          <c:extLst>
            <c:ext xmlns:c16="http://schemas.microsoft.com/office/drawing/2014/chart" uri="{C3380CC4-5D6E-409C-BE32-E72D297353CC}">
              <c16:uniqueId val="{00000000-B42F-4716-9C00-899448F787A5}"/>
            </c:ext>
          </c:extLst>
        </c:ser>
        <c:ser>
          <c:idx val="1"/>
          <c:order val="1"/>
          <c:tx>
            <c:strRef>
              <c:f>'Prod Car'!$P$4</c:f>
              <c:strCache>
                <c:ptCount val="1"/>
                <c:pt idx="0">
                  <c:v>25% NaCl</c:v>
                </c:pt>
              </c:strCache>
            </c:strRef>
          </c:tx>
          <c:spPr>
            <a:ln>
              <a:solidFill>
                <a:schemeClr val="tx1"/>
              </a:solidFill>
              <a:prstDash val="lgDash"/>
            </a:ln>
          </c:spPr>
          <c:marker>
            <c:spPr>
              <a:ln>
                <a:solidFill>
                  <a:schemeClr val="tx1"/>
                </a:solidFill>
              </a:ln>
            </c:spPr>
          </c:marker>
          <c:errBars>
            <c:errDir val="y"/>
            <c:errBarType val="both"/>
            <c:errValType val="cust"/>
            <c:noEndCap val="0"/>
            <c:plus>
              <c:numRef>
                <c:f>'Prod Car'!$Q$13:$U$13</c:f>
                <c:numCache>
                  <c:formatCode>General</c:formatCode>
                  <c:ptCount val="5"/>
                  <c:pt idx="0">
                    <c:v>6.0017978382301171</c:v>
                  </c:pt>
                  <c:pt idx="1">
                    <c:v>5.3562175708858826</c:v>
                  </c:pt>
                  <c:pt idx="2">
                    <c:v>13.65214880961989</c:v>
                  </c:pt>
                  <c:pt idx="3">
                    <c:v>17.035719271338607</c:v>
                  </c:pt>
                  <c:pt idx="4">
                    <c:v>21.87357364229663</c:v>
                  </c:pt>
                </c:numCache>
              </c:numRef>
            </c:plus>
            <c:minus>
              <c:numRef>
                <c:f>'Prod Car'!$Q$13:$U$13</c:f>
                <c:numCache>
                  <c:formatCode>General</c:formatCode>
                  <c:ptCount val="5"/>
                  <c:pt idx="0">
                    <c:v>6.0017978382301171</c:v>
                  </c:pt>
                  <c:pt idx="1">
                    <c:v>5.3562175708858826</c:v>
                  </c:pt>
                  <c:pt idx="2">
                    <c:v>13.65214880961989</c:v>
                  </c:pt>
                  <c:pt idx="3">
                    <c:v>17.035719271338607</c:v>
                  </c:pt>
                  <c:pt idx="4">
                    <c:v>21.87357364229663</c:v>
                  </c:pt>
                </c:numCache>
              </c:numRef>
            </c:minus>
          </c:errBars>
          <c:cat>
            <c:numRef>
              <c:f>'Prod Car'!$Q$2:$U$2</c:f>
              <c:numCache>
                <c:formatCode>General</c:formatCode>
                <c:ptCount val="5"/>
                <c:pt idx="0">
                  <c:v>0</c:v>
                </c:pt>
                <c:pt idx="1">
                  <c:v>48</c:v>
                </c:pt>
                <c:pt idx="2">
                  <c:v>96</c:v>
                </c:pt>
                <c:pt idx="3">
                  <c:v>144</c:v>
                </c:pt>
                <c:pt idx="4">
                  <c:v>192</c:v>
                </c:pt>
              </c:numCache>
            </c:numRef>
          </c:cat>
          <c:val>
            <c:numRef>
              <c:f>'Prod Car'!$Q$4:$U$4</c:f>
              <c:numCache>
                <c:formatCode>0</c:formatCode>
                <c:ptCount val="5"/>
                <c:pt idx="0">
                  <c:v>21.512762692026641</c:v>
                </c:pt>
                <c:pt idx="1">
                  <c:v>38.130000000000003</c:v>
                </c:pt>
                <c:pt idx="2">
                  <c:v>115.14145882413538</c:v>
                </c:pt>
                <c:pt idx="3">
                  <c:v>286.45912378369866</c:v>
                </c:pt>
                <c:pt idx="4">
                  <c:v>317.00611569561772</c:v>
                </c:pt>
              </c:numCache>
            </c:numRef>
          </c:val>
          <c:smooth val="0"/>
          <c:extLst>
            <c:ext xmlns:c16="http://schemas.microsoft.com/office/drawing/2014/chart" uri="{C3380CC4-5D6E-409C-BE32-E72D297353CC}">
              <c16:uniqueId val="{00000001-B42F-4716-9C00-899448F787A5}"/>
            </c:ext>
          </c:extLst>
        </c:ser>
        <c:ser>
          <c:idx val="2"/>
          <c:order val="2"/>
          <c:tx>
            <c:strRef>
              <c:f>'Prod Car'!$P$5</c:f>
              <c:strCache>
                <c:ptCount val="1"/>
                <c:pt idx="0">
                  <c:v>30% NaCl</c:v>
                </c:pt>
              </c:strCache>
            </c:strRef>
          </c:tx>
          <c:spPr>
            <a:ln>
              <a:solidFill>
                <a:schemeClr val="tx1"/>
              </a:solidFill>
              <a:prstDash val="sysDash"/>
            </a:ln>
          </c:spPr>
          <c:marker>
            <c:spPr>
              <a:ln>
                <a:solidFill>
                  <a:schemeClr val="tx1"/>
                </a:solidFill>
                <a:prstDash val="dash"/>
              </a:ln>
            </c:spPr>
          </c:marker>
          <c:errBars>
            <c:errDir val="y"/>
            <c:errBarType val="both"/>
            <c:errValType val="cust"/>
            <c:noEndCap val="0"/>
            <c:plus>
              <c:numRef>
                <c:f>'Prod Car'!$Q$14:$U$14</c:f>
                <c:numCache>
                  <c:formatCode>General</c:formatCode>
                  <c:ptCount val="5"/>
                  <c:pt idx="0">
                    <c:v>6.390385329453161</c:v>
                  </c:pt>
                  <c:pt idx="1">
                    <c:v>6.4911478183754223</c:v>
                  </c:pt>
                  <c:pt idx="2">
                    <c:v>22.023997074741327</c:v>
                  </c:pt>
                  <c:pt idx="3">
                    <c:v>18.214146989266425</c:v>
                  </c:pt>
                  <c:pt idx="4">
                    <c:v>3.3918432347851417</c:v>
                  </c:pt>
                </c:numCache>
              </c:numRef>
            </c:plus>
            <c:minus>
              <c:numRef>
                <c:f>'Prod Car'!$Q$14:$U$14</c:f>
                <c:numCache>
                  <c:formatCode>General</c:formatCode>
                  <c:ptCount val="5"/>
                  <c:pt idx="0">
                    <c:v>6.390385329453161</c:v>
                  </c:pt>
                  <c:pt idx="1">
                    <c:v>6.4911478183754223</c:v>
                  </c:pt>
                  <c:pt idx="2">
                    <c:v>22.023997074741327</c:v>
                  </c:pt>
                  <c:pt idx="3">
                    <c:v>18.214146989266425</c:v>
                  </c:pt>
                  <c:pt idx="4">
                    <c:v>3.3918432347851417</c:v>
                  </c:pt>
                </c:numCache>
              </c:numRef>
            </c:minus>
          </c:errBars>
          <c:cat>
            <c:numRef>
              <c:f>'Prod Car'!$Q$2:$U$2</c:f>
              <c:numCache>
                <c:formatCode>General</c:formatCode>
                <c:ptCount val="5"/>
                <c:pt idx="0">
                  <c:v>0</c:v>
                </c:pt>
                <c:pt idx="1">
                  <c:v>48</c:v>
                </c:pt>
                <c:pt idx="2">
                  <c:v>96</c:v>
                </c:pt>
                <c:pt idx="3">
                  <c:v>144</c:v>
                </c:pt>
                <c:pt idx="4">
                  <c:v>192</c:v>
                </c:pt>
              </c:numCache>
            </c:numRef>
          </c:cat>
          <c:val>
            <c:numRef>
              <c:f>'Prod Car'!$Q$5:$U$5</c:f>
              <c:numCache>
                <c:formatCode>0</c:formatCode>
                <c:ptCount val="5"/>
                <c:pt idx="0">
                  <c:v>34.293533350932954</c:v>
                </c:pt>
                <c:pt idx="1">
                  <c:v>82.23</c:v>
                </c:pt>
                <c:pt idx="2">
                  <c:v>186.66401475337193</c:v>
                </c:pt>
                <c:pt idx="3">
                  <c:v>282.99049550560085</c:v>
                </c:pt>
                <c:pt idx="4">
                  <c:v>392.54440421803525</c:v>
                </c:pt>
              </c:numCache>
            </c:numRef>
          </c:val>
          <c:smooth val="0"/>
          <c:extLst>
            <c:ext xmlns:c16="http://schemas.microsoft.com/office/drawing/2014/chart" uri="{C3380CC4-5D6E-409C-BE32-E72D297353CC}">
              <c16:uniqueId val="{00000002-B42F-4716-9C00-899448F787A5}"/>
            </c:ext>
          </c:extLst>
        </c:ser>
        <c:dLbls>
          <c:showLegendKey val="0"/>
          <c:showVal val="0"/>
          <c:showCatName val="0"/>
          <c:showSerName val="0"/>
          <c:showPercent val="0"/>
          <c:showBubbleSize val="0"/>
        </c:dLbls>
        <c:marker val="1"/>
        <c:smooth val="0"/>
        <c:axId val="96100352"/>
        <c:axId val="96102272"/>
      </c:lineChart>
      <c:catAx>
        <c:axId val="96100352"/>
        <c:scaling>
          <c:orientation val="minMax"/>
        </c:scaling>
        <c:delete val="0"/>
        <c:axPos val="b"/>
        <c:title>
          <c:tx>
            <c:rich>
              <a:bodyPr/>
              <a:lstStyle/>
              <a:p>
                <a:pPr>
                  <a:defRPr b="1"/>
                </a:pPr>
                <a:r>
                  <a:rPr lang="es-BO" b="1" dirty="0"/>
                  <a:t>Time (h)</a:t>
                </a:r>
              </a:p>
            </c:rich>
          </c:tx>
          <c:layout>
            <c:manualLayout>
              <c:xMode val="edge"/>
              <c:yMode val="edge"/>
              <c:x val="0.45762264644794642"/>
              <c:y val="0.91617598044661708"/>
            </c:manualLayout>
          </c:layout>
          <c:overlay val="0"/>
        </c:title>
        <c:numFmt formatCode="General" sourceLinked="1"/>
        <c:majorTickMark val="out"/>
        <c:minorTickMark val="none"/>
        <c:tickLblPos val="nextTo"/>
        <c:txPr>
          <a:bodyPr rot="0" vert="horz"/>
          <a:lstStyle/>
          <a:p>
            <a:pPr>
              <a:defRPr sz="1050" b="0"/>
            </a:pPr>
            <a:endParaRPr lang="en-US"/>
          </a:p>
        </c:txPr>
        <c:crossAx val="96102272"/>
        <c:crossesAt val="0"/>
        <c:auto val="1"/>
        <c:lblAlgn val="ctr"/>
        <c:lblOffset val="100"/>
        <c:noMultiLvlLbl val="0"/>
      </c:catAx>
      <c:valAx>
        <c:axId val="96102272"/>
        <c:scaling>
          <c:orientation val="minMax"/>
        </c:scaling>
        <c:delete val="0"/>
        <c:axPos val="l"/>
        <c:title>
          <c:tx>
            <c:rich>
              <a:bodyPr/>
              <a:lstStyle/>
              <a:p>
                <a:pPr>
                  <a:defRPr b="1"/>
                </a:pPr>
                <a:r>
                  <a:rPr lang="es-BO" b="1" dirty="0"/>
                  <a:t>ug carotenoids/g dry biomass</a:t>
                </a:r>
              </a:p>
            </c:rich>
          </c:tx>
          <c:layout>
            <c:manualLayout>
              <c:xMode val="edge"/>
              <c:yMode val="edge"/>
              <c:x val="4.9443504455789064E-3"/>
              <c:y val="0.18662753688028658"/>
            </c:manualLayout>
          </c:layout>
          <c:overlay val="0"/>
        </c:title>
        <c:numFmt formatCode="0" sourceLinked="1"/>
        <c:majorTickMark val="out"/>
        <c:minorTickMark val="none"/>
        <c:tickLblPos val="nextTo"/>
        <c:txPr>
          <a:bodyPr rot="0" vert="horz"/>
          <a:lstStyle/>
          <a:p>
            <a:pPr>
              <a:defRPr sz="1050" b="0"/>
            </a:pPr>
            <a:endParaRPr lang="en-US"/>
          </a:p>
        </c:txPr>
        <c:crossAx val="96100352"/>
        <c:crosses val="autoZero"/>
        <c:crossBetween val="midCat"/>
        <c:majorUnit val="100"/>
        <c:minorUnit val="20"/>
      </c:valAx>
    </c:plotArea>
    <c:legend>
      <c:legendPos val="t"/>
      <c:layout>
        <c:manualLayout>
          <c:xMode val="edge"/>
          <c:yMode val="edge"/>
          <c:x val="0.13332944791198065"/>
          <c:y val="6.2382973707528433E-2"/>
          <c:w val="0.78622161289911308"/>
          <c:h val="7.5317173430594436E-2"/>
        </c:manualLayout>
      </c:layout>
      <c:overlay val="0"/>
      <c:txPr>
        <a:bodyPr/>
        <a:lstStyle/>
        <a:p>
          <a:pPr>
            <a:defRPr sz="1050" b="0"/>
          </a:pPr>
          <a:endParaRPr lang="en-US"/>
        </a:p>
      </c:txPr>
    </c:legend>
    <c:plotVisOnly val="1"/>
    <c:dispBlanksAs val="gap"/>
    <c:showDLblsOverMax val="0"/>
  </c:chart>
  <c:spPr>
    <a:ln>
      <a:solidFill>
        <a:schemeClr val="tx1"/>
      </a:solidFill>
    </a:ln>
  </c:spPr>
  <c:txPr>
    <a:bodyPr/>
    <a:lstStyle/>
    <a:p>
      <a:pPr>
        <a:defRPr sz="1200" b="1">
          <a:latin typeface="Times New Roman" panose="02020603050405020304" pitchFamily="18" charset="0"/>
          <a:cs typeface="Times New Roman" panose="02020603050405020304" pitchFamily="18" charset="0"/>
        </a:defRPr>
      </a:pPr>
      <a:endParaRPr lang="en-US"/>
    </a:p>
  </c:txPr>
  <c:externalData r:id="rId2">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8.1583864419104951E-2"/>
          <c:y val="2.8038140802020002E-2"/>
          <c:w val="0.86449838906788135"/>
          <c:h val="0.8312261078972446"/>
        </c:manualLayout>
      </c:layout>
      <c:scatterChart>
        <c:scatterStyle val="smoothMarker"/>
        <c:varyColors val="0"/>
        <c:ser>
          <c:idx val="0"/>
          <c:order val="0"/>
          <c:tx>
            <c:strRef>
              <c:f>Hoja1!$BT$1</c:f>
              <c:strCache>
                <c:ptCount val="1"/>
                <c:pt idx="0">
                  <c:v>0d</c:v>
                </c:pt>
              </c:strCache>
            </c:strRef>
          </c:tx>
          <c:spPr>
            <a:ln>
              <a:solidFill>
                <a:schemeClr val="tx1"/>
              </a:solidFill>
            </a:ln>
          </c:spPr>
          <c:marker>
            <c:symbol val="none"/>
          </c:marker>
          <c:xVal>
            <c:numRef>
              <c:f>Hoja1!$BS$2:$BS$1255</c:f>
              <c:numCache>
                <c:formatCode>General</c:formatCode>
                <c:ptCount val="1254"/>
                <c:pt idx="2" formatCode="h:mm">
                  <c:v>0.68125000000000002</c:v>
                </c:pt>
                <c:pt idx="3">
                  <c:v>550</c:v>
                </c:pt>
                <c:pt idx="4">
                  <c:v>549.79999999999995</c:v>
                </c:pt>
                <c:pt idx="5">
                  <c:v>549.6</c:v>
                </c:pt>
                <c:pt idx="6">
                  <c:v>549.4</c:v>
                </c:pt>
                <c:pt idx="7">
                  <c:v>549.20000000000005</c:v>
                </c:pt>
                <c:pt idx="8">
                  <c:v>549</c:v>
                </c:pt>
                <c:pt idx="9">
                  <c:v>548.79999999999995</c:v>
                </c:pt>
                <c:pt idx="10">
                  <c:v>548.6</c:v>
                </c:pt>
                <c:pt idx="11">
                  <c:v>548.4</c:v>
                </c:pt>
                <c:pt idx="12">
                  <c:v>548.20000000000005</c:v>
                </c:pt>
                <c:pt idx="13">
                  <c:v>548</c:v>
                </c:pt>
                <c:pt idx="14">
                  <c:v>547.79999999999995</c:v>
                </c:pt>
                <c:pt idx="15">
                  <c:v>547.6</c:v>
                </c:pt>
                <c:pt idx="16">
                  <c:v>547.4</c:v>
                </c:pt>
                <c:pt idx="17">
                  <c:v>547.20000000000005</c:v>
                </c:pt>
                <c:pt idx="18">
                  <c:v>547</c:v>
                </c:pt>
                <c:pt idx="19">
                  <c:v>546.79999999999995</c:v>
                </c:pt>
                <c:pt idx="20">
                  <c:v>546.6</c:v>
                </c:pt>
                <c:pt idx="21">
                  <c:v>546.4</c:v>
                </c:pt>
                <c:pt idx="22">
                  <c:v>546.20000000000005</c:v>
                </c:pt>
                <c:pt idx="23">
                  <c:v>546</c:v>
                </c:pt>
                <c:pt idx="24">
                  <c:v>545.79999999999995</c:v>
                </c:pt>
                <c:pt idx="25">
                  <c:v>545.6</c:v>
                </c:pt>
                <c:pt idx="26">
                  <c:v>545.4</c:v>
                </c:pt>
                <c:pt idx="27">
                  <c:v>545.20000000000005</c:v>
                </c:pt>
                <c:pt idx="28">
                  <c:v>545</c:v>
                </c:pt>
                <c:pt idx="29">
                  <c:v>544.79999999999995</c:v>
                </c:pt>
                <c:pt idx="30">
                  <c:v>544.6</c:v>
                </c:pt>
                <c:pt idx="31">
                  <c:v>544.4</c:v>
                </c:pt>
                <c:pt idx="32">
                  <c:v>544.20000000000005</c:v>
                </c:pt>
                <c:pt idx="33">
                  <c:v>544</c:v>
                </c:pt>
                <c:pt idx="34">
                  <c:v>543.79999999999995</c:v>
                </c:pt>
                <c:pt idx="35">
                  <c:v>543.6</c:v>
                </c:pt>
                <c:pt idx="36">
                  <c:v>543.4</c:v>
                </c:pt>
                <c:pt idx="37">
                  <c:v>543.20000000000005</c:v>
                </c:pt>
                <c:pt idx="38">
                  <c:v>543</c:v>
                </c:pt>
                <c:pt idx="39">
                  <c:v>542.79999999999995</c:v>
                </c:pt>
                <c:pt idx="40">
                  <c:v>542.6</c:v>
                </c:pt>
                <c:pt idx="41">
                  <c:v>542.4</c:v>
                </c:pt>
                <c:pt idx="42">
                  <c:v>542.20000000000005</c:v>
                </c:pt>
                <c:pt idx="43">
                  <c:v>542</c:v>
                </c:pt>
                <c:pt idx="44">
                  <c:v>541.79999999999995</c:v>
                </c:pt>
                <c:pt idx="45">
                  <c:v>541.6</c:v>
                </c:pt>
                <c:pt idx="46">
                  <c:v>541.4</c:v>
                </c:pt>
                <c:pt idx="47">
                  <c:v>541.20000000000005</c:v>
                </c:pt>
                <c:pt idx="48">
                  <c:v>541</c:v>
                </c:pt>
                <c:pt idx="49">
                  <c:v>540.79999999999995</c:v>
                </c:pt>
                <c:pt idx="50">
                  <c:v>540.6</c:v>
                </c:pt>
                <c:pt idx="51">
                  <c:v>540.4</c:v>
                </c:pt>
                <c:pt idx="52">
                  <c:v>540.20000000000005</c:v>
                </c:pt>
                <c:pt idx="53">
                  <c:v>540</c:v>
                </c:pt>
                <c:pt idx="54">
                  <c:v>539.79999999999995</c:v>
                </c:pt>
                <c:pt idx="55">
                  <c:v>539.6</c:v>
                </c:pt>
                <c:pt idx="56">
                  <c:v>539.4</c:v>
                </c:pt>
                <c:pt idx="57">
                  <c:v>539.20000000000005</c:v>
                </c:pt>
                <c:pt idx="58">
                  <c:v>539</c:v>
                </c:pt>
                <c:pt idx="59">
                  <c:v>538.79999999999995</c:v>
                </c:pt>
                <c:pt idx="60">
                  <c:v>538.6</c:v>
                </c:pt>
                <c:pt idx="61">
                  <c:v>538.4</c:v>
                </c:pt>
                <c:pt idx="62">
                  <c:v>538.20000000000005</c:v>
                </c:pt>
                <c:pt idx="63">
                  <c:v>538</c:v>
                </c:pt>
                <c:pt idx="64">
                  <c:v>537.79999999999995</c:v>
                </c:pt>
                <c:pt idx="65">
                  <c:v>537.6</c:v>
                </c:pt>
                <c:pt idx="66">
                  <c:v>537.4</c:v>
                </c:pt>
                <c:pt idx="67">
                  <c:v>537.20000000000005</c:v>
                </c:pt>
                <c:pt idx="68">
                  <c:v>537</c:v>
                </c:pt>
                <c:pt idx="69">
                  <c:v>536.79999999999995</c:v>
                </c:pt>
                <c:pt idx="70">
                  <c:v>536.6</c:v>
                </c:pt>
                <c:pt idx="71">
                  <c:v>536.4</c:v>
                </c:pt>
                <c:pt idx="72">
                  <c:v>536.20000000000005</c:v>
                </c:pt>
                <c:pt idx="73">
                  <c:v>536</c:v>
                </c:pt>
                <c:pt idx="74">
                  <c:v>535.79999999999995</c:v>
                </c:pt>
                <c:pt idx="75">
                  <c:v>535.6</c:v>
                </c:pt>
                <c:pt idx="76">
                  <c:v>535.4</c:v>
                </c:pt>
                <c:pt idx="77">
                  <c:v>535.20000000000005</c:v>
                </c:pt>
                <c:pt idx="78">
                  <c:v>535</c:v>
                </c:pt>
                <c:pt idx="79">
                  <c:v>534.79999999999995</c:v>
                </c:pt>
                <c:pt idx="80">
                  <c:v>534.6</c:v>
                </c:pt>
                <c:pt idx="81">
                  <c:v>534.4</c:v>
                </c:pt>
                <c:pt idx="82">
                  <c:v>534.20000000000005</c:v>
                </c:pt>
                <c:pt idx="83">
                  <c:v>534</c:v>
                </c:pt>
                <c:pt idx="84">
                  <c:v>533.79999999999995</c:v>
                </c:pt>
                <c:pt idx="85">
                  <c:v>533.6</c:v>
                </c:pt>
                <c:pt idx="86">
                  <c:v>533.4</c:v>
                </c:pt>
                <c:pt idx="87">
                  <c:v>533.20000000000005</c:v>
                </c:pt>
                <c:pt idx="88">
                  <c:v>533</c:v>
                </c:pt>
                <c:pt idx="89">
                  <c:v>532.79999999999995</c:v>
                </c:pt>
                <c:pt idx="90">
                  <c:v>532.6</c:v>
                </c:pt>
                <c:pt idx="91">
                  <c:v>532.4</c:v>
                </c:pt>
                <c:pt idx="92">
                  <c:v>532.20000000000005</c:v>
                </c:pt>
                <c:pt idx="93">
                  <c:v>532</c:v>
                </c:pt>
                <c:pt idx="94">
                  <c:v>531.79999999999995</c:v>
                </c:pt>
                <c:pt idx="95">
                  <c:v>531.6</c:v>
                </c:pt>
                <c:pt idx="96">
                  <c:v>531.4</c:v>
                </c:pt>
                <c:pt idx="97">
                  <c:v>531.20000000000005</c:v>
                </c:pt>
                <c:pt idx="98">
                  <c:v>531</c:v>
                </c:pt>
                <c:pt idx="99">
                  <c:v>530.79999999999995</c:v>
                </c:pt>
                <c:pt idx="100">
                  <c:v>530.6</c:v>
                </c:pt>
                <c:pt idx="101">
                  <c:v>530.4</c:v>
                </c:pt>
                <c:pt idx="102">
                  <c:v>530.20000000000005</c:v>
                </c:pt>
                <c:pt idx="103">
                  <c:v>530</c:v>
                </c:pt>
                <c:pt idx="104">
                  <c:v>529.79999999999995</c:v>
                </c:pt>
                <c:pt idx="105">
                  <c:v>529.6</c:v>
                </c:pt>
                <c:pt idx="106">
                  <c:v>529.4</c:v>
                </c:pt>
                <c:pt idx="107">
                  <c:v>529.20000000000005</c:v>
                </c:pt>
                <c:pt idx="108">
                  <c:v>529</c:v>
                </c:pt>
                <c:pt idx="109">
                  <c:v>528.79999999999995</c:v>
                </c:pt>
                <c:pt idx="110">
                  <c:v>528.6</c:v>
                </c:pt>
                <c:pt idx="111">
                  <c:v>528.4</c:v>
                </c:pt>
                <c:pt idx="112">
                  <c:v>528.20000000000005</c:v>
                </c:pt>
                <c:pt idx="113">
                  <c:v>528</c:v>
                </c:pt>
                <c:pt idx="114">
                  <c:v>527.79999999999995</c:v>
                </c:pt>
                <c:pt idx="115">
                  <c:v>527.6</c:v>
                </c:pt>
                <c:pt idx="116">
                  <c:v>527.4</c:v>
                </c:pt>
                <c:pt idx="117">
                  <c:v>527.20000000000005</c:v>
                </c:pt>
                <c:pt idx="118">
                  <c:v>527</c:v>
                </c:pt>
                <c:pt idx="119">
                  <c:v>526.79999999999995</c:v>
                </c:pt>
                <c:pt idx="120">
                  <c:v>526.6</c:v>
                </c:pt>
                <c:pt idx="121">
                  <c:v>526.4</c:v>
                </c:pt>
                <c:pt idx="122">
                  <c:v>526.20000000000005</c:v>
                </c:pt>
                <c:pt idx="123">
                  <c:v>526</c:v>
                </c:pt>
                <c:pt idx="124">
                  <c:v>525.79999999999995</c:v>
                </c:pt>
                <c:pt idx="125">
                  <c:v>525.6</c:v>
                </c:pt>
                <c:pt idx="126">
                  <c:v>525.4</c:v>
                </c:pt>
                <c:pt idx="127">
                  <c:v>525.20000000000005</c:v>
                </c:pt>
                <c:pt idx="128">
                  <c:v>525</c:v>
                </c:pt>
                <c:pt idx="129">
                  <c:v>524.79999999999995</c:v>
                </c:pt>
                <c:pt idx="130">
                  <c:v>524.6</c:v>
                </c:pt>
                <c:pt idx="131">
                  <c:v>524.4</c:v>
                </c:pt>
                <c:pt idx="132">
                  <c:v>524.20000000000005</c:v>
                </c:pt>
                <c:pt idx="133">
                  <c:v>524</c:v>
                </c:pt>
                <c:pt idx="134">
                  <c:v>523.79999999999995</c:v>
                </c:pt>
                <c:pt idx="135">
                  <c:v>523.6</c:v>
                </c:pt>
                <c:pt idx="136">
                  <c:v>523.4</c:v>
                </c:pt>
                <c:pt idx="137">
                  <c:v>523.20000000000005</c:v>
                </c:pt>
                <c:pt idx="138">
                  <c:v>523</c:v>
                </c:pt>
                <c:pt idx="139">
                  <c:v>522.79999999999995</c:v>
                </c:pt>
                <c:pt idx="140">
                  <c:v>522.6</c:v>
                </c:pt>
                <c:pt idx="141">
                  <c:v>522.4</c:v>
                </c:pt>
                <c:pt idx="142">
                  <c:v>522.20000000000005</c:v>
                </c:pt>
                <c:pt idx="143">
                  <c:v>522</c:v>
                </c:pt>
                <c:pt idx="144">
                  <c:v>521.79999999999995</c:v>
                </c:pt>
                <c:pt idx="145">
                  <c:v>521.6</c:v>
                </c:pt>
                <c:pt idx="146">
                  <c:v>521.4</c:v>
                </c:pt>
                <c:pt idx="147">
                  <c:v>521.20000000000005</c:v>
                </c:pt>
                <c:pt idx="148">
                  <c:v>521</c:v>
                </c:pt>
                <c:pt idx="149">
                  <c:v>520.79999999999995</c:v>
                </c:pt>
                <c:pt idx="150">
                  <c:v>520.6</c:v>
                </c:pt>
                <c:pt idx="151">
                  <c:v>520.4</c:v>
                </c:pt>
                <c:pt idx="152">
                  <c:v>520.20000000000005</c:v>
                </c:pt>
                <c:pt idx="153">
                  <c:v>520</c:v>
                </c:pt>
                <c:pt idx="154">
                  <c:v>519.79999999999995</c:v>
                </c:pt>
                <c:pt idx="155">
                  <c:v>519.6</c:v>
                </c:pt>
                <c:pt idx="156">
                  <c:v>519.4</c:v>
                </c:pt>
                <c:pt idx="157">
                  <c:v>519.20000000000005</c:v>
                </c:pt>
                <c:pt idx="158">
                  <c:v>519</c:v>
                </c:pt>
                <c:pt idx="159">
                  <c:v>518.79999999999995</c:v>
                </c:pt>
                <c:pt idx="160">
                  <c:v>518.6</c:v>
                </c:pt>
                <c:pt idx="161">
                  <c:v>518.4</c:v>
                </c:pt>
                <c:pt idx="162">
                  <c:v>518.20000000000005</c:v>
                </c:pt>
                <c:pt idx="163">
                  <c:v>518</c:v>
                </c:pt>
                <c:pt idx="164">
                  <c:v>517.79999999999995</c:v>
                </c:pt>
                <c:pt idx="165">
                  <c:v>517.6</c:v>
                </c:pt>
                <c:pt idx="166">
                  <c:v>517.4</c:v>
                </c:pt>
                <c:pt idx="167">
                  <c:v>517.20000000000005</c:v>
                </c:pt>
                <c:pt idx="168">
                  <c:v>517</c:v>
                </c:pt>
                <c:pt idx="169">
                  <c:v>516.79999999999995</c:v>
                </c:pt>
                <c:pt idx="170">
                  <c:v>516.6</c:v>
                </c:pt>
                <c:pt idx="171">
                  <c:v>516.4</c:v>
                </c:pt>
                <c:pt idx="172">
                  <c:v>516.20000000000005</c:v>
                </c:pt>
                <c:pt idx="173">
                  <c:v>516</c:v>
                </c:pt>
                <c:pt idx="174">
                  <c:v>515.79999999999995</c:v>
                </c:pt>
                <c:pt idx="175">
                  <c:v>515.6</c:v>
                </c:pt>
                <c:pt idx="176">
                  <c:v>515.4</c:v>
                </c:pt>
                <c:pt idx="177">
                  <c:v>515.20000000000005</c:v>
                </c:pt>
                <c:pt idx="178">
                  <c:v>515</c:v>
                </c:pt>
                <c:pt idx="179">
                  <c:v>514.79999999999995</c:v>
                </c:pt>
                <c:pt idx="180">
                  <c:v>514.6</c:v>
                </c:pt>
                <c:pt idx="181">
                  <c:v>514.4</c:v>
                </c:pt>
                <c:pt idx="182">
                  <c:v>514.20000000000005</c:v>
                </c:pt>
                <c:pt idx="183">
                  <c:v>514</c:v>
                </c:pt>
                <c:pt idx="184">
                  <c:v>513.79999999999995</c:v>
                </c:pt>
                <c:pt idx="185">
                  <c:v>513.6</c:v>
                </c:pt>
                <c:pt idx="186">
                  <c:v>513.4</c:v>
                </c:pt>
                <c:pt idx="187">
                  <c:v>513.20000000000005</c:v>
                </c:pt>
                <c:pt idx="188">
                  <c:v>513</c:v>
                </c:pt>
                <c:pt idx="189">
                  <c:v>512.79999999999995</c:v>
                </c:pt>
                <c:pt idx="190">
                  <c:v>512.6</c:v>
                </c:pt>
                <c:pt idx="191">
                  <c:v>512.4</c:v>
                </c:pt>
                <c:pt idx="192">
                  <c:v>512.20000000000005</c:v>
                </c:pt>
                <c:pt idx="193">
                  <c:v>512</c:v>
                </c:pt>
                <c:pt idx="194">
                  <c:v>511.8</c:v>
                </c:pt>
                <c:pt idx="195">
                  <c:v>511.6</c:v>
                </c:pt>
                <c:pt idx="196">
                  <c:v>511.4</c:v>
                </c:pt>
                <c:pt idx="197">
                  <c:v>511.2</c:v>
                </c:pt>
                <c:pt idx="198">
                  <c:v>511</c:v>
                </c:pt>
                <c:pt idx="199">
                  <c:v>510.8</c:v>
                </c:pt>
                <c:pt idx="200">
                  <c:v>510.6</c:v>
                </c:pt>
                <c:pt idx="201">
                  <c:v>510.4</c:v>
                </c:pt>
                <c:pt idx="202">
                  <c:v>510.2</c:v>
                </c:pt>
                <c:pt idx="203">
                  <c:v>510</c:v>
                </c:pt>
                <c:pt idx="204">
                  <c:v>509.8</c:v>
                </c:pt>
                <c:pt idx="205">
                  <c:v>509.6</c:v>
                </c:pt>
                <c:pt idx="206">
                  <c:v>509.4</c:v>
                </c:pt>
                <c:pt idx="207">
                  <c:v>509.2</c:v>
                </c:pt>
                <c:pt idx="208">
                  <c:v>509</c:v>
                </c:pt>
                <c:pt idx="209">
                  <c:v>508.8</c:v>
                </c:pt>
                <c:pt idx="210">
                  <c:v>508.6</c:v>
                </c:pt>
                <c:pt idx="211">
                  <c:v>508.4</c:v>
                </c:pt>
                <c:pt idx="212">
                  <c:v>508.2</c:v>
                </c:pt>
                <c:pt idx="213">
                  <c:v>508</c:v>
                </c:pt>
                <c:pt idx="214">
                  <c:v>507.8</c:v>
                </c:pt>
                <c:pt idx="215">
                  <c:v>507.6</c:v>
                </c:pt>
                <c:pt idx="216">
                  <c:v>507.4</c:v>
                </c:pt>
                <c:pt idx="217">
                  <c:v>507.2</c:v>
                </c:pt>
                <c:pt idx="218">
                  <c:v>507</c:v>
                </c:pt>
                <c:pt idx="219">
                  <c:v>506.8</c:v>
                </c:pt>
                <c:pt idx="220">
                  <c:v>506.6</c:v>
                </c:pt>
                <c:pt idx="221">
                  <c:v>506.4</c:v>
                </c:pt>
                <c:pt idx="222">
                  <c:v>506.2</c:v>
                </c:pt>
                <c:pt idx="223">
                  <c:v>506</c:v>
                </c:pt>
                <c:pt idx="224">
                  <c:v>505.8</c:v>
                </c:pt>
                <c:pt idx="225">
                  <c:v>505.6</c:v>
                </c:pt>
                <c:pt idx="226">
                  <c:v>505.4</c:v>
                </c:pt>
                <c:pt idx="227">
                  <c:v>505.2</c:v>
                </c:pt>
                <c:pt idx="228">
                  <c:v>505</c:v>
                </c:pt>
                <c:pt idx="229">
                  <c:v>504.8</c:v>
                </c:pt>
                <c:pt idx="230">
                  <c:v>504.6</c:v>
                </c:pt>
                <c:pt idx="231">
                  <c:v>504.4</c:v>
                </c:pt>
                <c:pt idx="232">
                  <c:v>504.2</c:v>
                </c:pt>
                <c:pt idx="233">
                  <c:v>504</c:v>
                </c:pt>
                <c:pt idx="234">
                  <c:v>503.8</c:v>
                </c:pt>
                <c:pt idx="235">
                  <c:v>503.6</c:v>
                </c:pt>
                <c:pt idx="236">
                  <c:v>503.4</c:v>
                </c:pt>
                <c:pt idx="237">
                  <c:v>503.2</c:v>
                </c:pt>
                <c:pt idx="238">
                  <c:v>503</c:v>
                </c:pt>
                <c:pt idx="239">
                  <c:v>502.8</c:v>
                </c:pt>
                <c:pt idx="240">
                  <c:v>502.6</c:v>
                </c:pt>
                <c:pt idx="241">
                  <c:v>502.4</c:v>
                </c:pt>
                <c:pt idx="242">
                  <c:v>502.2</c:v>
                </c:pt>
                <c:pt idx="243">
                  <c:v>502</c:v>
                </c:pt>
                <c:pt idx="244">
                  <c:v>501.8</c:v>
                </c:pt>
                <c:pt idx="245">
                  <c:v>501.6</c:v>
                </c:pt>
                <c:pt idx="246">
                  <c:v>501.4</c:v>
                </c:pt>
                <c:pt idx="247">
                  <c:v>501.2</c:v>
                </c:pt>
                <c:pt idx="248">
                  <c:v>501</c:v>
                </c:pt>
                <c:pt idx="249">
                  <c:v>500.8</c:v>
                </c:pt>
                <c:pt idx="250">
                  <c:v>500.6</c:v>
                </c:pt>
                <c:pt idx="251">
                  <c:v>500.4</c:v>
                </c:pt>
                <c:pt idx="252">
                  <c:v>500.2</c:v>
                </c:pt>
                <c:pt idx="253">
                  <c:v>500</c:v>
                </c:pt>
                <c:pt idx="254">
                  <c:v>499.8</c:v>
                </c:pt>
                <c:pt idx="255">
                  <c:v>499.6</c:v>
                </c:pt>
                <c:pt idx="256">
                  <c:v>499.4</c:v>
                </c:pt>
                <c:pt idx="257">
                  <c:v>499.2</c:v>
                </c:pt>
                <c:pt idx="258">
                  <c:v>499</c:v>
                </c:pt>
                <c:pt idx="259">
                  <c:v>498.8</c:v>
                </c:pt>
                <c:pt idx="260">
                  <c:v>498.6</c:v>
                </c:pt>
                <c:pt idx="261">
                  <c:v>498.4</c:v>
                </c:pt>
                <c:pt idx="262">
                  <c:v>498.2</c:v>
                </c:pt>
                <c:pt idx="263">
                  <c:v>498</c:v>
                </c:pt>
                <c:pt idx="264">
                  <c:v>497.8</c:v>
                </c:pt>
                <c:pt idx="265">
                  <c:v>497.6</c:v>
                </c:pt>
                <c:pt idx="266">
                  <c:v>497.4</c:v>
                </c:pt>
                <c:pt idx="267">
                  <c:v>497.2</c:v>
                </c:pt>
                <c:pt idx="268">
                  <c:v>497</c:v>
                </c:pt>
                <c:pt idx="269">
                  <c:v>496.8</c:v>
                </c:pt>
                <c:pt idx="270">
                  <c:v>496.6</c:v>
                </c:pt>
                <c:pt idx="271">
                  <c:v>496.4</c:v>
                </c:pt>
                <c:pt idx="272">
                  <c:v>496.2</c:v>
                </c:pt>
                <c:pt idx="273">
                  <c:v>496</c:v>
                </c:pt>
                <c:pt idx="274">
                  <c:v>495.8</c:v>
                </c:pt>
                <c:pt idx="275">
                  <c:v>495.6</c:v>
                </c:pt>
                <c:pt idx="276">
                  <c:v>495.4</c:v>
                </c:pt>
                <c:pt idx="277">
                  <c:v>495.2</c:v>
                </c:pt>
                <c:pt idx="278">
                  <c:v>495</c:v>
                </c:pt>
                <c:pt idx="279">
                  <c:v>494.8</c:v>
                </c:pt>
                <c:pt idx="280">
                  <c:v>494.6</c:v>
                </c:pt>
                <c:pt idx="281">
                  <c:v>494.4</c:v>
                </c:pt>
                <c:pt idx="282">
                  <c:v>494.2</c:v>
                </c:pt>
                <c:pt idx="283">
                  <c:v>494</c:v>
                </c:pt>
                <c:pt idx="284">
                  <c:v>493.8</c:v>
                </c:pt>
                <c:pt idx="285">
                  <c:v>493.6</c:v>
                </c:pt>
                <c:pt idx="286">
                  <c:v>493.4</c:v>
                </c:pt>
                <c:pt idx="287">
                  <c:v>493.2</c:v>
                </c:pt>
                <c:pt idx="288">
                  <c:v>493</c:v>
                </c:pt>
                <c:pt idx="289">
                  <c:v>492.8</c:v>
                </c:pt>
                <c:pt idx="290">
                  <c:v>492.6</c:v>
                </c:pt>
                <c:pt idx="291">
                  <c:v>492.4</c:v>
                </c:pt>
                <c:pt idx="292">
                  <c:v>492.2</c:v>
                </c:pt>
                <c:pt idx="293">
                  <c:v>492</c:v>
                </c:pt>
                <c:pt idx="294">
                  <c:v>491.8</c:v>
                </c:pt>
                <c:pt idx="295">
                  <c:v>491.6</c:v>
                </c:pt>
                <c:pt idx="296">
                  <c:v>491.4</c:v>
                </c:pt>
                <c:pt idx="297">
                  <c:v>491.2</c:v>
                </c:pt>
                <c:pt idx="298">
                  <c:v>491</c:v>
                </c:pt>
                <c:pt idx="299">
                  <c:v>490.8</c:v>
                </c:pt>
                <c:pt idx="300">
                  <c:v>490.6</c:v>
                </c:pt>
                <c:pt idx="301">
                  <c:v>490.4</c:v>
                </c:pt>
                <c:pt idx="302">
                  <c:v>490.2</c:v>
                </c:pt>
                <c:pt idx="303">
                  <c:v>490</c:v>
                </c:pt>
                <c:pt idx="304">
                  <c:v>489.8</c:v>
                </c:pt>
                <c:pt idx="305">
                  <c:v>489.6</c:v>
                </c:pt>
                <c:pt idx="306">
                  <c:v>489.4</c:v>
                </c:pt>
                <c:pt idx="307">
                  <c:v>489.2</c:v>
                </c:pt>
                <c:pt idx="308">
                  <c:v>489</c:v>
                </c:pt>
                <c:pt idx="309">
                  <c:v>488.8</c:v>
                </c:pt>
                <c:pt idx="310">
                  <c:v>488.6</c:v>
                </c:pt>
                <c:pt idx="311">
                  <c:v>488.4</c:v>
                </c:pt>
                <c:pt idx="312">
                  <c:v>488.2</c:v>
                </c:pt>
                <c:pt idx="313">
                  <c:v>488</c:v>
                </c:pt>
                <c:pt idx="314">
                  <c:v>487.8</c:v>
                </c:pt>
                <c:pt idx="315">
                  <c:v>487.6</c:v>
                </c:pt>
                <c:pt idx="316">
                  <c:v>487.4</c:v>
                </c:pt>
                <c:pt idx="317">
                  <c:v>487.2</c:v>
                </c:pt>
                <c:pt idx="318">
                  <c:v>487</c:v>
                </c:pt>
                <c:pt idx="319">
                  <c:v>486.8</c:v>
                </c:pt>
                <c:pt idx="320">
                  <c:v>486.6</c:v>
                </c:pt>
                <c:pt idx="321">
                  <c:v>486.4</c:v>
                </c:pt>
                <c:pt idx="322">
                  <c:v>486.2</c:v>
                </c:pt>
                <c:pt idx="323">
                  <c:v>486</c:v>
                </c:pt>
                <c:pt idx="324">
                  <c:v>485.8</c:v>
                </c:pt>
                <c:pt idx="325">
                  <c:v>485.6</c:v>
                </c:pt>
                <c:pt idx="326">
                  <c:v>485.4</c:v>
                </c:pt>
                <c:pt idx="327">
                  <c:v>485.2</c:v>
                </c:pt>
                <c:pt idx="328">
                  <c:v>485</c:v>
                </c:pt>
                <c:pt idx="329">
                  <c:v>484.8</c:v>
                </c:pt>
                <c:pt idx="330">
                  <c:v>484.6</c:v>
                </c:pt>
                <c:pt idx="331">
                  <c:v>484.4</c:v>
                </c:pt>
                <c:pt idx="332">
                  <c:v>484.2</c:v>
                </c:pt>
                <c:pt idx="333">
                  <c:v>484</c:v>
                </c:pt>
                <c:pt idx="334">
                  <c:v>483.8</c:v>
                </c:pt>
                <c:pt idx="335">
                  <c:v>483.6</c:v>
                </c:pt>
                <c:pt idx="336">
                  <c:v>483.4</c:v>
                </c:pt>
                <c:pt idx="337">
                  <c:v>483.2</c:v>
                </c:pt>
                <c:pt idx="338">
                  <c:v>483</c:v>
                </c:pt>
                <c:pt idx="339">
                  <c:v>482.8</c:v>
                </c:pt>
                <c:pt idx="340">
                  <c:v>482.6</c:v>
                </c:pt>
                <c:pt idx="341">
                  <c:v>482.4</c:v>
                </c:pt>
                <c:pt idx="342">
                  <c:v>482.2</c:v>
                </c:pt>
                <c:pt idx="343">
                  <c:v>482</c:v>
                </c:pt>
                <c:pt idx="344">
                  <c:v>481.8</c:v>
                </c:pt>
                <c:pt idx="345">
                  <c:v>481.6</c:v>
                </c:pt>
                <c:pt idx="346">
                  <c:v>481.4</c:v>
                </c:pt>
                <c:pt idx="347">
                  <c:v>481.2</c:v>
                </c:pt>
                <c:pt idx="348">
                  <c:v>481</c:v>
                </c:pt>
                <c:pt idx="349">
                  <c:v>480.8</c:v>
                </c:pt>
                <c:pt idx="350">
                  <c:v>480.6</c:v>
                </c:pt>
                <c:pt idx="351">
                  <c:v>480.4</c:v>
                </c:pt>
                <c:pt idx="352">
                  <c:v>480.2</c:v>
                </c:pt>
                <c:pt idx="353">
                  <c:v>480</c:v>
                </c:pt>
                <c:pt idx="354">
                  <c:v>479.8</c:v>
                </c:pt>
                <c:pt idx="355">
                  <c:v>479.6</c:v>
                </c:pt>
                <c:pt idx="356">
                  <c:v>479.4</c:v>
                </c:pt>
                <c:pt idx="357">
                  <c:v>479.2</c:v>
                </c:pt>
                <c:pt idx="358">
                  <c:v>479</c:v>
                </c:pt>
                <c:pt idx="359">
                  <c:v>478.8</c:v>
                </c:pt>
                <c:pt idx="360">
                  <c:v>478.6</c:v>
                </c:pt>
                <c:pt idx="361">
                  <c:v>478.4</c:v>
                </c:pt>
                <c:pt idx="362">
                  <c:v>478.2</c:v>
                </c:pt>
                <c:pt idx="363">
                  <c:v>478</c:v>
                </c:pt>
                <c:pt idx="364">
                  <c:v>477.8</c:v>
                </c:pt>
                <c:pt idx="365">
                  <c:v>477.6</c:v>
                </c:pt>
                <c:pt idx="366">
                  <c:v>477.4</c:v>
                </c:pt>
                <c:pt idx="367">
                  <c:v>477.2</c:v>
                </c:pt>
                <c:pt idx="368">
                  <c:v>477</c:v>
                </c:pt>
                <c:pt idx="369">
                  <c:v>476.8</c:v>
                </c:pt>
                <c:pt idx="370">
                  <c:v>476.6</c:v>
                </c:pt>
                <c:pt idx="371">
                  <c:v>476.4</c:v>
                </c:pt>
                <c:pt idx="372">
                  <c:v>476.2</c:v>
                </c:pt>
                <c:pt idx="373">
                  <c:v>476</c:v>
                </c:pt>
                <c:pt idx="374">
                  <c:v>475.8</c:v>
                </c:pt>
                <c:pt idx="375">
                  <c:v>475.6</c:v>
                </c:pt>
                <c:pt idx="376">
                  <c:v>475.4</c:v>
                </c:pt>
                <c:pt idx="377">
                  <c:v>475.2</c:v>
                </c:pt>
                <c:pt idx="378">
                  <c:v>475</c:v>
                </c:pt>
                <c:pt idx="379">
                  <c:v>474.8</c:v>
                </c:pt>
                <c:pt idx="380">
                  <c:v>474.6</c:v>
                </c:pt>
                <c:pt idx="381">
                  <c:v>474.4</c:v>
                </c:pt>
                <c:pt idx="382">
                  <c:v>474.2</c:v>
                </c:pt>
                <c:pt idx="383">
                  <c:v>474</c:v>
                </c:pt>
                <c:pt idx="384">
                  <c:v>473.8</c:v>
                </c:pt>
                <c:pt idx="385">
                  <c:v>473.6</c:v>
                </c:pt>
                <c:pt idx="386">
                  <c:v>473.4</c:v>
                </c:pt>
                <c:pt idx="387">
                  <c:v>473.2</c:v>
                </c:pt>
                <c:pt idx="388">
                  <c:v>473</c:v>
                </c:pt>
                <c:pt idx="389">
                  <c:v>472.8</c:v>
                </c:pt>
                <c:pt idx="390">
                  <c:v>472.6</c:v>
                </c:pt>
                <c:pt idx="391">
                  <c:v>472.4</c:v>
                </c:pt>
                <c:pt idx="392">
                  <c:v>472.2</c:v>
                </c:pt>
                <c:pt idx="393">
                  <c:v>472</c:v>
                </c:pt>
                <c:pt idx="394">
                  <c:v>471.8</c:v>
                </c:pt>
                <c:pt idx="395">
                  <c:v>471.6</c:v>
                </c:pt>
                <c:pt idx="396">
                  <c:v>471.4</c:v>
                </c:pt>
                <c:pt idx="397">
                  <c:v>471.2</c:v>
                </c:pt>
                <c:pt idx="398">
                  <c:v>471</c:v>
                </c:pt>
                <c:pt idx="399">
                  <c:v>470.8</c:v>
                </c:pt>
                <c:pt idx="400">
                  <c:v>470.6</c:v>
                </c:pt>
                <c:pt idx="401">
                  <c:v>470.4</c:v>
                </c:pt>
                <c:pt idx="402">
                  <c:v>470.2</c:v>
                </c:pt>
                <c:pt idx="403">
                  <c:v>470</c:v>
                </c:pt>
                <c:pt idx="404">
                  <c:v>469.8</c:v>
                </c:pt>
                <c:pt idx="405">
                  <c:v>469.6</c:v>
                </c:pt>
                <c:pt idx="406">
                  <c:v>469.4</c:v>
                </c:pt>
                <c:pt idx="407">
                  <c:v>469.2</c:v>
                </c:pt>
                <c:pt idx="408">
                  <c:v>469</c:v>
                </c:pt>
                <c:pt idx="409">
                  <c:v>468.8</c:v>
                </c:pt>
                <c:pt idx="410">
                  <c:v>468.6</c:v>
                </c:pt>
                <c:pt idx="411">
                  <c:v>468.4</c:v>
                </c:pt>
                <c:pt idx="412">
                  <c:v>468.2</c:v>
                </c:pt>
                <c:pt idx="413">
                  <c:v>468</c:v>
                </c:pt>
                <c:pt idx="414">
                  <c:v>467.8</c:v>
                </c:pt>
                <c:pt idx="415">
                  <c:v>467.6</c:v>
                </c:pt>
                <c:pt idx="416">
                  <c:v>467.4</c:v>
                </c:pt>
                <c:pt idx="417">
                  <c:v>467.2</c:v>
                </c:pt>
                <c:pt idx="418">
                  <c:v>467</c:v>
                </c:pt>
                <c:pt idx="419">
                  <c:v>466.8</c:v>
                </c:pt>
                <c:pt idx="420">
                  <c:v>466.6</c:v>
                </c:pt>
                <c:pt idx="421">
                  <c:v>466.4</c:v>
                </c:pt>
                <c:pt idx="422">
                  <c:v>466.2</c:v>
                </c:pt>
                <c:pt idx="423">
                  <c:v>466</c:v>
                </c:pt>
                <c:pt idx="424">
                  <c:v>465.8</c:v>
                </c:pt>
                <c:pt idx="425">
                  <c:v>465.6</c:v>
                </c:pt>
                <c:pt idx="426">
                  <c:v>465.4</c:v>
                </c:pt>
                <c:pt idx="427">
                  <c:v>465.2</c:v>
                </c:pt>
                <c:pt idx="428">
                  <c:v>465</c:v>
                </c:pt>
                <c:pt idx="429">
                  <c:v>464.8</c:v>
                </c:pt>
                <c:pt idx="430">
                  <c:v>464.6</c:v>
                </c:pt>
                <c:pt idx="431">
                  <c:v>464.4</c:v>
                </c:pt>
                <c:pt idx="432">
                  <c:v>464.2</c:v>
                </c:pt>
                <c:pt idx="433">
                  <c:v>464</c:v>
                </c:pt>
                <c:pt idx="434">
                  <c:v>463.8</c:v>
                </c:pt>
                <c:pt idx="435">
                  <c:v>463.6</c:v>
                </c:pt>
                <c:pt idx="436">
                  <c:v>463.4</c:v>
                </c:pt>
                <c:pt idx="437">
                  <c:v>463.2</c:v>
                </c:pt>
                <c:pt idx="438">
                  <c:v>463</c:v>
                </c:pt>
                <c:pt idx="439">
                  <c:v>462.8</c:v>
                </c:pt>
                <c:pt idx="440">
                  <c:v>462.6</c:v>
                </c:pt>
                <c:pt idx="441">
                  <c:v>462.4</c:v>
                </c:pt>
                <c:pt idx="442">
                  <c:v>462.2</c:v>
                </c:pt>
                <c:pt idx="443">
                  <c:v>462</c:v>
                </c:pt>
                <c:pt idx="444">
                  <c:v>461.8</c:v>
                </c:pt>
                <c:pt idx="445">
                  <c:v>461.6</c:v>
                </c:pt>
                <c:pt idx="446">
                  <c:v>461.4</c:v>
                </c:pt>
                <c:pt idx="447">
                  <c:v>461.2</c:v>
                </c:pt>
                <c:pt idx="448">
                  <c:v>461</c:v>
                </c:pt>
                <c:pt idx="449">
                  <c:v>460.8</c:v>
                </c:pt>
                <c:pt idx="450">
                  <c:v>460.6</c:v>
                </c:pt>
                <c:pt idx="451">
                  <c:v>460.4</c:v>
                </c:pt>
                <c:pt idx="452">
                  <c:v>460.2</c:v>
                </c:pt>
                <c:pt idx="453">
                  <c:v>460</c:v>
                </c:pt>
                <c:pt idx="454">
                  <c:v>459.8</c:v>
                </c:pt>
                <c:pt idx="455">
                  <c:v>459.6</c:v>
                </c:pt>
                <c:pt idx="456">
                  <c:v>459.4</c:v>
                </c:pt>
                <c:pt idx="457">
                  <c:v>459.2</c:v>
                </c:pt>
                <c:pt idx="458">
                  <c:v>459</c:v>
                </c:pt>
                <c:pt idx="459">
                  <c:v>458.8</c:v>
                </c:pt>
                <c:pt idx="460">
                  <c:v>458.6</c:v>
                </c:pt>
                <c:pt idx="461">
                  <c:v>458.4</c:v>
                </c:pt>
                <c:pt idx="462">
                  <c:v>458.2</c:v>
                </c:pt>
                <c:pt idx="463">
                  <c:v>458</c:v>
                </c:pt>
                <c:pt idx="464">
                  <c:v>457.8</c:v>
                </c:pt>
                <c:pt idx="465">
                  <c:v>457.6</c:v>
                </c:pt>
                <c:pt idx="466">
                  <c:v>457.4</c:v>
                </c:pt>
                <c:pt idx="467">
                  <c:v>457.2</c:v>
                </c:pt>
                <c:pt idx="468">
                  <c:v>457</c:v>
                </c:pt>
                <c:pt idx="469">
                  <c:v>456.8</c:v>
                </c:pt>
                <c:pt idx="470">
                  <c:v>456.6</c:v>
                </c:pt>
                <c:pt idx="471">
                  <c:v>456.4</c:v>
                </c:pt>
                <c:pt idx="472">
                  <c:v>456.2</c:v>
                </c:pt>
                <c:pt idx="473">
                  <c:v>456</c:v>
                </c:pt>
                <c:pt idx="474">
                  <c:v>455.8</c:v>
                </c:pt>
                <c:pt idx="475">
                  <c:v>455.6</c:v>
                </c:pt>
                <c:pt idx="476">
                  <c:v>455.4</c:v>
                </c:pt>
                <c:pt idx="477">
                  <c:v>455.2</c:v>
                </c:pt>
                <c:pt idx="478">
                  <c:v>455</c:v>
                </c:pt>
                <c:pt idx="479">
                  <c:v>454.8</c:v>
                </c:pt>
                <c:pt idx="480">
                  <c:v>454.6</c:v>
                </c:pt>
                <c:pt idx="481">
                  <c:v>454.4</c:v>
                </c:pt>
                <c:pt idx="482">
                  <c:v>454.2</c:v>
                </c:pt>
                <c:pt idx="483">
                  <c:v>454</c:v>
                </c:pt>
                <c:pt idx="484">
                  <c:v>453.8</c:v>
                </c:pt>
                <c:pt idx="485">
                  <c:v>453.6</c:v>
                </c:pt>
                <c:pt idx="486">
                  <c:v>453.4</c:v>
                </c:pt>
                <c:pt idx="487">
                  <c:v>453.2</c:v>
                </c:pt>
                <c:pt idx="488">
                  <c:v>453</c:v>
                </c:pt>
                <c:pt idx="489">
                  <c:v>452.8</c:v>
                </c:pt>
                <c:pt idx="490">
                  <c:v>452.6</c:v>
                </c:pt>
                <c:pt idx="491">
                  <c:v>452.4</c:v>
                </c:pt>
                <c:pt idx="492">
                  <c:v>452.2</c:v>
                </c:pt>
                <c:pt idx="493">
                  <c:v>452</c:v>
                </c:pt>
                <c:pt idx="494">
                  <c:v>451.8</c:v>
                </c:pt>
                <c:pt idx="495">
                  <c:v>451.6</c:v>
                </c:pt>
                <c:pt idx="496">
                  <c:v>451.4</c:v>
                </c:pt>
                <c:pt idx="497">
                  <c:v>451.2</c:v>
                </c:pt>
                <c:pt idx="498">
                  <c:v>451</c:v>
                </c:pt>
                <c:pt idx="499">
                  <c:v>450.8</c:v>
                </c:pt>
                <c:pt idx="500">
                  <c:v>450.6</c:v>
                </c:pt>
                <c:pt idx="501">
                  <c:v>450.4</c:v>
                </c:pt>
                <c:pt idx="502">
                  <c:v>450.2</c:v>
                </c:pt>
                <c:pt idx="503">
                  <c:v>450</c:v>
                </c:pt>
                <c:pt idx="504">
                  <c:v>449.8</c:v>
                </c:pt>
                <c:pt idx="505">
                  <c:v>449.6</c:v>
                </c:pt>
                <c:pt idx="506">
                  <c:v>449.4</c:v>
                </c:pt>
                <c:pt idx="507">
                  <c:v>449.2</c:v>
                </c:pt>
                <c:pt idx="508">
                  <c:v>449</c:v>
                </c:pt>
                <c:pt idx="509">
                  <c:v>448.8</c:v>
                </c:pt>
                <c:pt idx="510">
                  <c:v>448.6</c:v>
                </c:pt>
                <c:pt idx="511">
                  <c:v>448.4</c:v>
                </c:pt>
                <c:pt idx="512">
                  <c:v>448.2</c:v>
                </c:pt>
                <c:pt idx="513">
                  <c:v>448</c:v>
                </c:pt>
                <c:pt idx="514">
                  <c:v>447.8</c:v>
                </c:pt>
                <c:pt idx="515">
                  <c:v>447.6</c:v>
                </c:pt>
                <c:pt idx="516">
                  <c:v>447.4</c:v>
                </c:pt>
                <c:pt idx="517">
                  <c:v>447.2</c:v>
                </c:pt>
                <c:pt idx="518">
                  <c:v>447</c:v>
                </c:pt>
                <c:pt idx="519">
                  <c:v>446.8</c:v>
                </c:pt>
                <c:pt idx="520">
                  <c:v>446.6</c:v>
                </c:pt>
                <c:pt idx="521">
                  <c:v>446.4</c:v>
                </c:pt>
                <c:pt idx="522">
                  <c:v>446.2</c:v>
                </c:pt>
                <c:pt idx="523">
                  <c:v>446</c:v>
                </c:pt>
                <c:pt idx="524">
                  <c:v>445.8</c:v>
                </c:pt>
                <c:pt idx="525">
                  <c:v>445.6</c:v>
                </c:pt>
                <c:pt idx="526">
                  <c:v>445.4</c:v>
                </c:pt>
                <c:pt idx="527">
                  <c:v>445.2</c:v>
                </c:pt>
                <c:pt idx="528">
                  <c:v>445</c:v>
                </c:pt>
                <c:pt idx="529">
                  <c:v>444.8</c:v>
                </c:pt>
                <c:pt idx="530">
                  <c:v>444.6</c:v>
                </c:pt>
                <c:pt idx="531">
                  <c:v>444.4</c:v>
                </c:pt>
                <c:pt idx="532">
                  <c:v>444.2</c:v>
                </c:pt>
                <c:pt idx="533">
                  <c:v>444</c:v>
                </c:pt>
                <c:pt idx="534">
                  <c:v>443.8</c:v>
                </c:pt>
                <c:pt idx="535">
                  <c:v>443.6</c:v>
                </c:pt>
                <c:pt idx="536">
                  <c:v>443.4</c:v>
                </c:pt>
                <c:pt idx="537">
                  <c:v>443.2</c:v>
                </c:pt>
                <c:pt idx="538">
                  <c:v>443</c:v>
                </c:pt>
                <c:pt idx="539">
                  <c:v>442.8</c:v>
                </c:pt>
                <c:pt idx="540">
                  <c:v>442.6</c:v>
                </c:pt>
                <c:pt idx="541">
                  <c:v>442.4</c:v>
                </c:pt>
                <c:pt idx="542">
                  <c:v>442.2</c:v>
                </c:pt>
                <c:pt idx="543">
                  <c:v>442</c:v>
                </c:pt>
                <c:pt idx="544">
                  <c:v>441.8</c:v>
                </c:pt>
                <c:pt idx="545">
                  <c:v>441.6</c:v>
                </c:pt>
                <c:pt idx="546">
                  <c:v>441.4</c:v>
                </c:pt>
                <c:pt idx="547">
                  <c:v>441.2</c:v>
                </c:pt>
                <c:pt idx="548">
                  <c:v>441</c:v>
                </c:pt>
                <c:pt idx="549">
                  <c:v>440.8</c:v>
                </c:pt>
                <c:pt idx="550">
                  <c:v>440.6</c:v>
                </c:pt>
                <c:pt idx="551">
                  <c:v>440.4</c:v>
                </c:pt>
                <c:pt idx="552">
                  <c:v>440.2</c:v>
                </c:pt>
                <c:pt idx="553">
                  <c:v>440</c:v>
                </c:pt>
                <c:pt idx="554">
                  <c:v>439.8</c:v>
                </c:pt>
                <c:pt idx="555">
                  <c:v>439.6</c:v>
                </c:pt>
                <c:pt idx="556">
                  <c:v>439.4</c:v>
                </c:pt>
                <c:pt idx="557">
                  <c:v>439.2</c:v>
                </c:pt>
                <c:pt idx="558">
                  <c:v>439</c:v>
                </c:pt>
                <c:pt idx="559">
                  <c:v>438.8</c:v>
                </c:pt>
                <c:pt idx="560">
                  <c:v>438.6</c:v>
                </c:pt>
                <c:pt idx="561">
                  <c:v>438.4</c:v>
                </c:pt>
                <c:pt idx="562">
                  <c:v>438.2</c:v>
                </c:pt>
                <c:pt idx="563">
                  <c:v>438</c:v>
                </c:pt>
                <c:pt idx="564">
                  <c:v>437.8</c:v>
                </c:pt>
                <c:pt idx="565">
                  <c:v>437.6</c:v>
                </c:pt>
                <c:pt idx="566">
                  <c:v>437.4</c:v>
                </c:pt>
                <c:pt idx="567">
                  <c:v>437.2</c:v>
                </c:pt>
                <c:pt idx="568">
                  <c:v>437</c:v>
                </c:pt>
                <c:pt idx="569">
                  <c:v>436.8</c:v>
                </c:pt>
                <c:pt idx="570">
                  <c:v>436.6</c:v>
                </c:pt>
                <c:pt idx="571">
                  <c:v>436.4</c:v>
                </c:pt>
                <c:pt idx="572">
                  <c:v>436.2</c:v>
                </c:pt>
                <c:pt idx="573">
                  <c:v>436</c:v>
                </c:pt>
                <c:pt idx="574">
                  <c:v>435.8</c:v>
                </c:pt>
                <c:pt idx="575">
                  <c:v>435.6</c:v>
                </c:pt>
                <c:pt idx="576">
                  <c:v>435.4</c:v>
                </c:pt>
                <c:pt idx="577">
                  <c:v>435.2</c:v>
                </c:pt>
                <c:pt idx="578">
                  <c:v>435</c:v>
                </c:pt>
                <c:pt idx="579">
                  <c:v>434.8</c:v>
                </c:pt>
                <c:pt idx="580">
                  <c:v>434.6</c:v>
                </c:pt>
                <c:pt idx="581">
                  <c:v>434.4</c:v>
                </c:pt>
                <c:pt idx="582">
                  <c:v>434.2</c:v>
                </c:pt>
                <c:pt idx="583">
                  <c:v>434</c:v>
                </c:pt>
                <c:pt idx="584">
                  <c:v>433.8</c:v>
                </c:pt>
                <c:pt idx="585">
                  <c:v>433.6</c:v>
                </c:pt>
                <c:pt idx="586">
                  <c:v>433.4</c:v>
                </c:pt>
                <c:pt idx="587">
                  <c:v>433.2</c:v>
                </c:pt>
                <c:pt idx="588">
                  <c:v>433</c:v>
                </c:pt>
                <c:pt idx="589">
                  <c:v>432.8</c:v>
                </c:pt>
                <c:pt idx="590">
                  <c:v>432.6</c:v>
                </c:pt>
                <c:pt idx="591">
                  <c:v>432.4</c:v>
                </c:pt>
                <c:pt idx="592">
                  <c:v>432.2</c:v>
                </c:pt>
                <c:pt idx="593">
                  <c:v>432</c:v>
                </c:pt>
                <c:pt idx="594">
                  <c:v>431.8</c:v>
                </c:pt>
                <c:pt idx="595">
                  <c:v>431.6</c:v>
                </c:pt>
                <c:pt idx="596">
                  <c:v>431.4</c:v>
                </c:pt>
                <c:pt idx="597">
                  <c:v>431.2</c:v>
                </c:pt>
                <c:pt idx="598">
                  <c:v>431</c:v>
                </c:pt>
                <c:pt idx="599">
                  <c:v>430.8</c:v>
                </c:pt>
                <c:pt idx="600">
                  <c:v>430.6</c:v>
                </c:pt>
                <c:pt idx="601">
                  <c:v>430.4</c:v>
                </c:pt>
                <c:pt idx="602">
                  <c:v>430.2</c:v>
                </c:pt>
                <c:pt idx="603">
                  <c:v>430</c:v>
                </c:pt>
                <c:pt idx="604">
                  <c:v>429.8</c:v>
                </c:pt>
                <c:pt idx="605">
                  <c:v>429.6</c:v>
                </c:pt>
                <c:pt idx="606">
                  <c:v>429.4</c:v>
                </c:pt>
                <c:pt idx="607">
                  <c:v>429.2</c:v>
                </c:pt>
                <c:pt idx="608">
                  <c:v>429</c:v>
                </c:pt>
                <c:pt idx="609">
                  <c:v>428.8</c:v>
                </c:pt>
                <c:pt idx="610">
                  <c:v>428.6</c:v>
                </c:pt>
                <c:pt idx="611">
                  <c:v>428.4</c:v>
                </c:pt>
                <c:pt idx="612">
                  <c:v>428.2</c:v>
                </c:pt>
                <c:pt idx="613">
                  <c:v>428</c:v>
                </c:pt>
                <c:pt idx="614">
                  <c:v>427.8</c:v>
                </c:pt>
                <c:pt idx="615">
                  <c:v>427.6</c:v>
                </c:pt>
                <c:pt idx="616">
                  <c:v>427.4</c:v>
                </c:pt>
                <c:pt idx="617">
                  <c:v>427.2</c:v>
                </c:pt>
                <c:pt idx="618">
                  <c:v>427</c:v>
                </c:pt>
                <c:pt idx="619">
                  <c:v>426.8</c:v>
                </c:pt>
                <c:pt idx="620">
                  <c:v>426.6</c:v>
                </c:pt>
                <c:pt idx="621">
                  <c:v>426.4</c:v>
                </c:pt>
                <c:pt idx="622">
                  <c:v>426.2</c:v>
                </c:pt>
                <c:pt idx="623">
                  <c:v>426</c:v>
                </c:pt>
                <c:pt idx="624">
                  <c:v>425.8</c:v>
                </c:pt>
                <c:pt idx="625">
                  <c:v>425.6</c:v>
                </c:pt>
                <c:pt idx="626">
                  <c:v>425.4</c:v>
                </c:pt>
                <c:pt idx="627">
                  <c:v>425.2</c:v>
                </c:pt>
                <c:pt idx="628">
                  <c:v>425</c:v>
                </c:pt>
                <c:pt idx="629">
                  <c:v>424.8</c:v>
                </c:pt>
                <c:pt idx="630">
                  <c:v>424.6</c:v>
                </c:pt>
                <c:pt idx="631">
                  <c:v>424.4</c:v>
                </c:pt>
                <c:pt idx="632">
                  <c:v>424.2</c:v>
                </c:pt>
                <c:pt idx="633">
                  <c:v>424</c:v>
                </c:pt>
                <c:pt idx="634">
                  <c:v>423.8</c:v>
                </c:pt>
                <c:pt idx="635">
                  <c:v>423.6</c:v>
                </c:pt>
                <c:pt idx="636">
                  <c:v>423.4</c:v>
                </c:pt>
                <c:pt idx="637">
                  <c:v>423.2</c:v>
                </c:pt>
                <c:pt idx="638">
                  <c:v>423</c:v>
                </c:pt>
                <c:pt idx="639">
                  <c:v>422.8</c:v>
                </c:pt>
                <c:pt idx="640">
                  <c:v>422.6</c:v>
                </c:pt>
                <c:pt idx="641">
                  <c:v>422.4</c:v>
                </c:pt>
                <c:pt idx="642">
                  <c:v>422.2</c:v>
                </c:pt>
                <c:pt idx="643">
                  <c:v>422</c:v>
                </c:pt>
                <c:pt idx="644">
                  <c:v>421.8</c:v>
                </c:pt>
                <c:pt idx="645">
                  <c:v>421.6</c:v>
                </c:pt>
                <c:pt idx="646">
                  <c:v>421.4</c:v>
                </c:pt>
                <c:pt idx="647">
                  <c:v>421.2</c:v>
                </c:pt>
                <c:pt idx="648">
                  <c:v>421</c:v>
                </c:pt>
                <c:pt idx="649">
                  <c:v>420.8</c:v>
                </c:pt>
                <c:pt idx="650">
                  <c:v>420.6</c:v>
                </c:pt>
                <c:pt idx="651">
                  <c:v>420.4</c:v>
                </c:pt>
                <c:pt idx="652">
                  <c:v>420.2</c:v>
                </c:pt>
                <c:pt idx="653">
                  <c:v>420</c:v>
                </c:pt>
                <c:pt idx="654">
                  <c:v>419.8</c:v>
                </c:pt>
                <c:pt idx="655">
                  <c:v>419.6</c:v>
                </c:pt>
                <c:pt idx="656">
                  <c:v>419.4</c:v>
                </c:pt>
                <c:pt idx="657">
                  <c:v>419.2</c:v>
                </c:pt>
                <c:pt idx="658">
                  <c:v>419</c:v>
                </c:pt>
                <c:pt idx="659">
                  <c:v>418.8</c:v>
                </c:pt>
                <c:pt idx="660">
                  <c:v>418.6</c:v>
                </c:pt>
                <c:pt idx="661">
                  <c:v>418.4</c:v>
                </c:pt>
                <c:pt idx="662">
                  <c:v>418.2</c:v>
                </c:pt>
                <c:pt idx="663">
                  <c:v>418</c:v>
                </c:pt>
                <c:pt idx="664">
                  <c:v>417.8</c:v>
                </c:pt>
                <c:pt idx="665">
                  <c:v>417.6</c:v>
                </c:pt>
                <c:pt idx="666">
                  <c:v>417.4</c:v>
                </c:pt>
                <c:pt idx="667">
                  <c:v>417.2</c:v>
                </c:pt>
                <c:pt idx="668">
                  <c:v>417</c:v>
                </c:pt>
                <c:pt idx="669">
                  <c:v>416.8</c:v>
                </c:pt>
                <c:pt idx="670">
                  <c:v>416.6</c:v>
                </c:pt>
                <c:pt idx="671">
                  <c:v>416.4</c:v>
                </c:pt>
                <c:pt idx="672">
                  <c:v>416.2</c:v>
                </c:pt>
                <c:pt idx="673">
                  <c:v>416</c:v>
                </c:pt>
                <c:pt idx="674">
                  <c:v>415.8</c:v>
                </c:pt>
                <c:pt idx="675">
                  <c:v>415.6</c:v>
                </c:pt>
                <c:pt idx="676">
                  <c:v>415.4</c:v>
                </c:pt>
                <c:pt idx="677">
                  <c:v>415.2</c:v>
                </c:pt>
                <c:pt idx="678">
                  <c:v>415</c:v>
                </c:pt>
                <c:pt idx="679">
                  <c:v>414.8</c:v>
                </c:pt>
                <c:pt idx="680">
                  <c:v>414.6</c:v>
                </c:pt>
                <c:pt idx="681">
                  <c:v>414.4</c:v>
                </c:pt>
                <c:pt idx="682">
                  <c:v>414.2</c:v>
                </c:pt>
                <c:pt idx="683">
                  <c:v>414</c:v>
                </c:pt>
                <c:pt idx="684">
                  <c:v>413.8</c:v>
                </c:pt>
                <c:pt idx="685">
                  <c:v>413.6</c:v>
                </c:pt>
                <c:pt idx="686">
                  <c:v>413.4</c:v>
                </c:pt>
                <c:pt idx="687">
                  <c:v>413.2</c:v>
                </c:pt>
                <c:pt idx="688">
                  <c:v>413</c:v>
                </c:pt>
                <c:pt idx="689">
                  <c:v>412.8</c:v>
                </c:pt>
                <c:pt idx="690">
                  <c:v>412.6</c:v>
                </c:pt>
                <c:pt idx="691">
                  <c:v>412.4</c:v>
                </c:pt>
                <c:pt idx="692">
                  <c:v>412.2</c:v>
                </c:pt>
                <c:pt idx="693">
                  <c:v>412</c:v>
                </c:pt>
                <c:pt idx="694">
                  <c:v>411.8</c:v>
                </c:pt>
                <c:pt idx="695">
                  <c:v>411.6</c:v>
                </c:pt>
                <c:pt idx="696">
                  <c:v>411.4</c:v>
                </c:pt>
                <c:pt idx="697">
                  <c:v>411.2</c:v>
                </c:pt>
                <c:pt idx="698">
                  <c:v>411</c:v>
                </c:pt>
                <c:pt idx="699">
                  <c:v>410.8</c:v>
                </c:pt>
                <c:pt idx="700">
                  <c:v>410.6</c:v>
                </c:pt>
                <c:pt idx="701">
                  <c:v>410.4</c:v>
                </c:pt>
                <c:pt idx="702">
                  <c:v>410.2</c:v>
                </c:pt>
                <c:pt idx="703">
                  <c:v>410</c:v>
                </c:pt>
                <c:pt idx="704">
                  <c:v>409.8</c:v>
                </c:pt>
                <c:pt idx="705">
                  <c:v>409.6</c:v>
                </c:pt>
                <c:pt idx="706">
                  <c:v>409.4</c:v>
                </c:pt>
                <c:pt idx="707">
                  <c:v>409.2</c:v>
                </c:pt>
                <c:pt idx="708">
                  <c:v>409</c:v>
                </c:pt>
                <c:pt idx="709">
                  <c:v>408.8</c:v>
                </c:pt>
                <c:pt idx="710">
                  <c:v>408.6</c:v>
                </c:pt>
                <c:pt idx="711">
                  <c:v>408.4</c:v>
                </c:pt>
                <c:pt idx="712">
                  <c:v>408.2</c:v>
                </c:pt>
                <c:pt idx="713">
                  <c:v>408</c:v>
                </c:pt>
                <c:pt idx="714">
                  <c:v>407.8</c:v>
                </c:pt>
                <c:pt idx="715">
                  <c:v>407.6</c:v>
                </c:pt>
                <c:pt idx="716">
                  <c:v>407.4</c:v>
                </c:pt>
                <c:pt idx="717">
                  <c:v>407.2</c:v>
                </c:pt>
                <c:pt idx="718">
                  <c:v>407</c:v>
                </c:pt>
                <c:pt idx="719">
                  <c:v>406.8</c:v>
                </c:pt>
                <c:pt idx="720">
                  <c:v>406.6</c:v>
                </c:pt>
                <c:pt idx="721">
                  <c:v>406.4</c:v>
                </c:pt>
                <c:pt idx="722">
                  <c:v>406.2</c:v>
                </c:pt>
                <c:pt idx="723">
                  <c:v>406</c:v>
                </c:pt>
                <c:pt idx="724">
                  <c:v>405.8</c:v>
                </c:pt>
                <c:pt idx="725">
                  <c:v>405.6</c:v>
                </c:pt>
                <c:pt idx="726">
                  <c:v>405.4</c:v>
                </c:pt>
                <c:pt idx="727">
                  <c:v>405.2</c:v>
                </c:pt>
                <c:pt idx="728">
                  <c:v>405</c:v>
                </c:pt>
                <c:pt idx="729">
                  <c:v>404.8</c:v>
                </c:pt>
                <c:pt idx="730">
                  <c:v>404.6</c:v>
                </c:pt>
                <c:pt idx="731">
                  <c:v>404.4</c:v>
                </c:pt>
                <c:pt idx="732">
                  <c:v>404.2</c:v>
                </c:pt>
                <c:pt idx="733">
                  <c:v>404</c:v>
                </c:pt>
                <c:pt idx="734">
                  <c:v>403.8</c:v>
                </c:pt>
                <c:pt idx="735">
                  <c:v>403.6</c:v>
                </c:pt>
                <c:pt idx="736">
                  <c:v>403.4</c:v>
                </c:pt>
                <c:pt idx="737">
                  <c:v>403.2</c:v>
                </c:pt>
                <c:pt idx="738">
                  <c:v>403</c:v>
                </c:pt>
                <c:pt idx="739">
                  <c:v>402.8</c:v>
                </c:pt>
                <c:pt idx="740">
                  <c:v>402.6</c:v>
                </c:pt>
                <c:pt idx="741">
                  <c:v>402.4</c:v>
                </c:pt>
                <c:pt idx="742">
                  <c:v>402.2</c:v>
                </c:pt>
                <c:pt idx="743">
                  <c:v>402</c:v>
                </c:pt>
                <c:pt idx="744">
                  <c:v>401.8</c:v>
                </c:pt>
                <c:pt idx="745">
                  <c:v>401.6</c:v>
                </c:pt>
                <c:pt idx="746">
                  <c:v>401.4</c:v>
                </c:pt>
                <c:pt idx="747">
                  <c:v>401.2</c:v>
                </c:pt>
                <c:pt idx="748">
                  <c:v>401</c:v>
                </c:pt>
                <c:pt idx="749">
                  <c:v>400.8</c:v>
                </c:pt>
                <c:pt idx="750">
                  <c:v>400.6</c:v>
                </c:pt>
                <c:pt idx="751">
                  <c:v>400.4</c:v>
                </c:pt>
                <c:pt idx="752">
                  <c:v>400.2</c:v>
                </c:pt>
                <c:pt idx="753">
                  <c:v>400</c:v>
                </c:pt>
                <c:pt idx="754">
                  <c:v>399.8</c:v>
                </c:pt>
                <c:pt idx="755">
                  <c:v>399.6</c:v>
                </c:pt>
                <c:pt idx="756">
                  <c:v>399.4</c:v>
                </c:pt>
                <c:pt idx="757">
                  <c:v>399.2</c:v>
                </c:pt>
                <c:pt idx="758">
                  <c:v>399</c:v>
                </c:pt>
                <c:pt idx="759">
                  <c:v>398.8</c:v>
                </c:pt>
                <c:pt idx="760">
                  <c:v>398.6</c:v>
                </c:pt>
                <c:pt idx="761">
                  <c:v>398.4</c:v>
                </c:pt>
                <c:pt idx="762">
                  <c:v>398.2</c:v>
                </c:pt>
                <c:pt idx="763">
                  <c:v>398</c:v>
                </c:pt>
                <c:pt idx="764">
                  <c:v>397.8</c:v>
                </c:pt>
                <c:pt idx="765">
                  <c:v>397.6</c:v>
                </c:pt>
                <c:pt idx="766">
                  <c:v>397.4</c:v>
                </c:pt>
                <c:pt idx="767">
                  <c:v>397.2</c:v>
                </c:pt>
                <c:pt idx="768">
                  <c:v>397</c:v>
                </c:pt>
                <c:pt idx="769">
                  <c:v>396.8</c:v>
                </c:pt>
                <c:pt idx="770">
                  <c:v>396.6</c:v>
                </c:pt>
                <c:pt idx="771">
                  <c:v>396.4</c:v>
                </c:pt>
                <c:pt idx="772">
                  <c:v>396.2</c:v>
                </c:pt>
                <c:pt idx="773">
                  <c:v>396</c:v>
                </c:pt>
                <c:pt idx="774">
                  <c:v>395.8</c:v>
                </c:pt>
                <c:pt idx="775">
                  <c:v>395.6</c:v>
                </c:pt>
                <c:pt idx="776">
                  <c:v>395.4</c:v>
                </c:pt>
                <c:pt idx="777">
                  <c:v>395.2</c:v>
                </c:pt>
                <c:pt idx="778">
                  <c:v>395</c:v>
                </c:pt>
                <c:pt idx="779">
                  <c:v>394.8</c:v>
                </c:pt>
                <c:pt idx="780">
                  <c:v>394.6</c:v>
                </c:pt>
                <c:pt idx="781">
                  <c:v>394.4</c:v>
                </c:pt>
                <c:pt idx="782">
                  <c:v>394.2</c:v>
                </c:pt>
                <c:pt idx="783">
                  <c:v>394</c:v>
                </c:pt>
                <c:pt idx="784">
                  <c:v>393.8</c:v>
                </c:pt>
                <c:pt idx="785">
                  <c:v>393.6</c:v>
                </c:pt>
                <c:pt idx="786">
                  <c:v>393.4</c:v>
                </c:pt>
                <c:pt idx="787">
                  <c:v>393.2</c:v>
                </c:pt>
                <c:pt idx="788">
                  <c:v>393</c:v>
                </c:pt>
                <c:pt idx="789">
                  <c:v>392.8</c:v>
                </c:pt>
                <c:pt idx="790">
                  <c:v>392.6</c:v>
                </c:pt>
                <c:pt idx="791">
                  <c:v>392.4</c:v>
                </c:pt>
                <c:pt idx="792">
                  <c:v>392.2</c:v>
                </c:pt>
                <c:pt idx="793">
                  <c:v>392</c:v>
                </c:pt>
                <c:pt idx="794">
                  <c:v>391.8</c:v>
                </c:pt>
                <c:pt idx="795">
                  <c:v>391.6</c:v>
                </c:pt>
                <c:pt idx="796">
                  <c:v>391.4</c:v>
                </c:pt>
                <c:pt idx="797">
                  <c:v>391.2</c:v>
                </c:pt>
                <c:pt idx="798">
                  <c:v>391</c:v>
                </c:pt>
                <c:pt idx="799">
                  <c:v>390.8</c:v>
                </c:pt>
                <c:pt idx="800">
                  <c:v>390.6</c:v>
                </c:pt>
                <c:pt idx="801">
                  <c:v>390.4</c:v>
                </c:pt>
                <c:pt idx="802">
                  <c:v>390.2</c:v>
                </c:pt>
                <c:pt idx="803">
                  <c:v>390</c:v>
                </c:pt>
                <c:pt idx="804">
                  <c:v>389.8</c:v>
                </c:pt>
                <c:pt idx="805">
                  <c:v>389.6</c:v>
                </c:pt>
                <c:pt idx="806">
                  <c:v>389.4</c:v>
                </c:pt>
                <c:pt idx="807">
                  <c:v>389.2</c:v>
                </c:pt>
                <c:pt idx="808">
                  <c:v>389</c:v>
                </c:pt>
                <c:pt idx="809">
                  <c:v>388.8</c:v>
                </c:pt>
                <c:pt idx="810">
                  <c:v>388.6</c:v>
                </c:pt>
                <c:pt idx="811">
                  <c:v>388.4</c:v>
                </c:pt>
                <c:pt idx="812">
                  <c:v>388.2</c:v>
                </c:pt>
                <c:pt idx="813">
                  <c:v>388</c:v>
                </c:pt>
                <c:pt idx="814">
                  <c:v>387.8</c:v>
                </c:pt>
                <c:pt idx="815">
                  <c:v>387.6</c:v>
                </c:pt>
                <c:pt idx="816">
                  <c:v>387.4</c:v>
                </c:pt>
                <c:pt idx="817">
                  <c:v>387.2</c:v>
                </c:pt>
                <c:pt idx="818">
                  <c:v>387</c:v>
                </c:pt>
                <c:pt idx="819">
                  <c:v>386.8</c:v>
                </c:pt>
                <c:pt idx="820">
                  <c:v>386.6</c:v>
                </c:pt>
                <c:pt idx="821">
                  <c:v>386.4</c:v>
                </c:pt>
                <c:pt idx="822">
                  <c:v>386.2</c:v>
                </c:pt>
                <c:pt idx="823">
                  <c:v>386</c:v>
                </c:pt>
                <c:pt idx="824">
                  <c:v>385.8</c:v>
                </c:pt>
                <c:pt idx="825">
                  <c:v>385.6</c:v>
                </c:pt>
                <c:pt idx="826">
                  <c:v>385.4</c:v>
                </c:pt>
                <c:pt idx="827">
                  <c:v>385.2</c:v>
                </c:pt>
                <c:pt idx="828">
                  <c:v>385</c:v>
                </c:pt>
                <c:pt idx="829">
                  <c:v>384.8</c:v>
                </c:pt>
                <c:pt idx="830">
                  <c:v>384.6</c:v>
                </c:pt>
                <c:pt idx="831">
                  <c:v>384.4</c:v>
                </c:pt>
                <c:pt idx="832">
                  <c:v>384.2</c:v>
                </c:pt>
                <c:pt idx="833">
                  <c:v>384</c:v>
                </c:pt>
                <c:pt idx="834">
                  <c:v>383.8</c:v>
                </c:pt>
                <c:pt idx="835">
                  <c:v>383.6</c:v>
                </c:pt>
                <c:pt idx="836">
                  <c:v>383.4</c:v>
                </c:pt>
                <c:pt idx="837">
                  <c:v>383.2</c:v>
                </c:pt>
                <c:pt idx="838">
                  <c:v>383</c:v>
                </c:pt>
                <c:pt idx="839">
                  <c:v>382.8</c:v>
                </c:pt>
                <c:pt idx="840">
                  <c:v>382.6</c:v>
                </c:pt>
                <c:pt idx="841">
                  <c:v>382.4</c:v>
                </c:pt>
                <c:pt idx="842">
                  <c:v>382.2</c:v>
                </c:pt>
                <c:pt idx="843">
                  <c:v>382</c:v>
                </c:pt>
                <c:pt idx="844">
                  <c:v>381.8</c:v>
                </c:pt>
                <c:pt idx="845">
                  <c:v>381.6</c:v>
                </c:pt>
                <c:pt idx="846">
                  <c:v>381.4</c:v>
                </c:pt>
                <c:pt idx="847">
                  <c:v>381.2</c:v>
                </c:pt>
                <c:pt idx="848">
                  <c:v>381</c:v>
                </c:pt>
                <c:pt idx="849">
                  <c:v>380.8</c:v>
                </c:pt>
                <c:pt idx="850">
                  <c:v>380.6</c:v>
                </c:pt>
                <c:pt idx="851">
                  <c:v>380.4</c:v>
                </c:pt>
                <c:pt idx="852">
                  <c:v>380.2</c:v>
                </c:pt>
                <c:pt idx="853">
                  <c:v>380</c:v>
                </c:pt>
                <c:pt idx="854">
                  <c:v>379.8</c:v>
                </c:pt>
                <c:pt idx="855">
                  <c:v>379.6</c:v>
                </c:pt>
                <c:pt idx="856">
                  <c:v>379.4</c:v>
                </c:pt>
                <c:pt idx="857">
                  <c:v>379.2</c:v>
                </c:pt>
                <c:pt idx="858">
                  <c:v>379</c:v>
                </c:pt>
                <c:pt idx="859">
                  <c:v>378.8</c:v>
                </c:pt>
                <c:pt idx="860">
                  <c:v>378.6</c:v>
                </c:pt>
                <c:pt idx="861">
                  <c:v>378.4</c:v>
                </c:pt>
                <c:pt idx="862">
                  <c:v>378.2</c:v>
                </c:pt>
                <c:pt idx="863">
                  <c:v>378</c:v>
                </c:pt>
                <c:pt idx="864">
                  <c:v>377.8</c:v>
                </c:pt>
                <c:pt idx="865">
                  <c:v>377.6</c:v>
                </c:pt>
                <c:pt idx="866">
                  <c:v>377.4</c:v>
                </c:pt>
                <c:pt idx="867">
                  <c:v>377.2</c:v>
                </c:pt>
                <c:pt idx="868">
                  <c:v>377</c:v>
                </c:pt>
                <c:pt idx="869">
                  <c:v>376.8</c:v>
                </c:pt>
                <c:pt idx="870">
                  <c:v>376.6</c:v>
                </c:pt>
                <c:pt idx="871">
                  <c:v>376.4</c:v>
                </c:pt>
                <c:pt idx="872">
                  <c:v>376.2</c:v>
                </c:pt>
                <c:pt idx="873">
                  <c:v>376</c:v>
                </c:pt>
                <c:pt idx="874">
                  <c:v>375.8</c:v>
                </c:pt>
                <c:pt idx="875">
                  <c:v>375.6</c:v>
                </c:pt>
                <c:pt idx="876">
                  <c:v>375.4</c:v>
                </c:pt>
                <c:pt idx="877">
                  <c:v>375.2</c:v>
                </c:pt>
                <c:pt idx="878">
                  <c:v>375</c:v>
                </c:pt>
                <c:pt idx="879">
                  <c:v>374.8</c:v>
                </c:pt>
                <c:pt idx="880">
                  <c:v>374.6</c:v>
                </c:pt>
                <c:pt idx="881">
                  <c:v>374.4</c:v>
                </c:pt>
                <c:pt idx="882">
                  <c:v>374.2</c:v>
                </c:pt>
                <c:pt idx="883">
                  <c:v>374</c:v>
                </c:pt>
                <c:pt idx="884">
                  <c:v>373.8</c:v>
                </c:pt>
                <c:pt idx="885">
                  <c:v>373.6</c:v>
                </c:pt>
                <c:pt idx="886">
                  <c:v>373.4</c:v>
                </c:pt>
                <c:pt idx="887">
                  <c:v>373.2</c:v>
                </c:pt>
                <c:pt idx="888">
                  <c:v>373</c:v>
                </c:pt>
                <c:pt idx="889">
                  <c:v>372.8</c:v>
                </c:pt>
                <c:pt idx="890">
                  <c:v>372.6</c:v>
                </c:pt>
                <c:pt idx="891">
                  <c:v>372.4</c:v>
                </c:pt>
                <c:pt idx="892">
                  <c:v>372.2</c:v>
                </c:pt>
                <c:pt idx="893">
                  <c:v>372</c:v>
                </c:pt>
                <c:pt idx="894">
                  <c:v>371.8</c:v>
                </c:pt>
                <c:pt idx="895">
                  <c:v>371.6</c:v>
                </c:pt>
                <c:pt idx="896">
                  <c:v>371.4</c:v>
                </c:pt>
                <c:pt idx="897">
                  <c:v>371.2</c:v>
                </c:pt>
                <c:pt idx="898">
                  <c:v>371</c:v>
                </c:pt>
                <c:pt idx="899">
                  <c:v>370.8</c:v>
                </c:pt>
                <c:pt idx="900">
                  <c:v>370.6</c:v>
                </c:pt>
                <c:pt idx="901">
                  <c:v>370.4</c:v>
                </c:pt>
                <c:pt idx="902">
                  <c:v>370.2</c:v>
                </c:pt>
                <c:pt idx="903">
                  <c:v>370</c:v>
                </c:pt>
                <c:pt idx="904">
                  <c:v>369.8</c:v>
                </c:pt>
                <c:pt idx="905">
                  <c:v>369.6</c:v>
                </c:pt>
                <c:pt idx="906">
                  <c:v>369.4</c:v>
                </c:pt>
                <c:pt idx="907">
                  <c:v>369.2</c:v>
                </c:pt>
                <c:pt idx="908">
                  <c:v>369</c:v>
                </c:pt>
                <c:pt idx="909">
                  <c:v>368.8</c:v>
                </c:pt>
                <c:pt idx="910">
                  <c:v>368.6</c:v>
                </c:pt>
                <c:pt idx="911">
                  <c:v>368.4</c:v>
                </c:pt>
                <c:pt idx="912">
                  <c:v>368.2</c:v>
                </c:pt>
                <c:pt idx="913">
                  <c:v>368</c:v>
                </c:pt>
                <c:pt idx="914">
                  <c:v>367.8</c:v>
                </c:pt>
                <c:pt idx="915">
                  <c:v>367.6</c:v>
                </c:pt>
                <c:pt idx="916">
                  <c:v>367.4</c:v>
                </c:pt>
                <c:pt idx="917">
                  <c:v>367.2</c:v>
                </c:pt>
                <c:pt idx="918">
                  <c:v>367</c:v>
                </c:pt>
                <c:pt idx="919">
                  <c:v>366.8</c:v>
                </c:pt>
                <c:pt idx="920">
                  <c:v>366.6</c:v>
                </c:pt>
                <c:pt idx="921">
                  <c:v>366.4</c:v>
                </c:pt>
                <c:pt idx="922">
                  <c:v>366.2</c:v>
                </c:pt>
                <c:pt idx="923">
                  <c:v>366</c:v>
                </c:pt>
                <c:pt idx="924">
                  <c:v>365.8</c:v>
                </c:pt>
                <c:pt idx="925">
                  <c:v>365.6</c:v>
                </c:pt>
                <c:pt idx="926">
                  <c:v>365.4</c:v>
                </c:pt>
                <c:pt idx="927">
                  <c:v>365.2</c:v>
                </c:pt>
                <c:pt idx="928">
                  <c:v>365</c:v>
                </c:pt>
                <c:pt idx="929">
                  <c:v>364.8</c:v>
                </c:pt>
                <c:pt idx="930">
                  <c:v>364.6</c:v>
                </c:pt>
                <c:pt idx="931">
                  <c:v>364.4</c:v>
                </c:pt>
                <c:pt idx="932">
                  <c:v>364.2</c:v>
                </c:pt>
                <c:pt idx="933">
                  <c:v>364</c:v>
                </c:pt>
                <c:pt idx="934">
                  <c:v>363.8</c:v>
                </c:pt>
                <c:pt idx="935">
                  <c:v>363.6</c:v>
                </c:pt>
                <c:pt idx="936">
                  <c:v>363.4</c:v>
                </c:pt>
                <c:pt idx="937">
                  <c:v>363.2</c:v>
                </c:pt>
                <c:pt idx="938">
                  <c:v>363</c:v>
                </c:pt>
                <c:pt idx="939">
                  <c:v>362.8</c:v>
                </c:pt>
                <c:pt idx="940">
                  <c:v>362.6</c:v>
                </c:pt>
                <c:pt idx="941">
                  <c:v>362.4</c:v>
                </c:pt>
                <c:pt idx="942">
                  <c:v>362.2</c:v>
                </c:pt>
                <c:pt idx="943">
                  <c:v>362</c:v>
                </c:pt>
                <c:pt idx="944">
                  <c:v>361.8</c:v>
                </c:pt>
                <c:pt idx="945">
                  <c:v>361.6</c:v>
                </c:pt>
                <c:pt idx="946">
                  <c:v>361.4</c:v>
                </c:pt>
                <c:pt idx="947">
                  <c:v>361.2</c:v>
                </c:pt>
                <c:pt idx="948">
                  <c:v>361</c:v>
                </c:pt>
                <c:pt idx="949">
                  <c:v>360.8</c:v>
                </c:pt>
                <c:pt idx="950">
                  <c:v>360.6</c:v>
                </c:pt>
                <c:pt idx="951">
                  <c:v>360.4</c:v>
                </c:pt>
                <c:pt idx="952">
                  <c:v>360.2</c:v>
                </c:pt>
                <c:pt idx="953">
                  <c:v>360</c:v>
                </c:pt>
                <c:pt idx="954">
                  <c:v>359.8</c:v>
                </c:pt>
                <c:pt idx="955">
                  <c:v>359.6</c:v>
                </c:pt>
                <c:pt idx="956">
                  <c:v>359.4</c:v>
                </c:pt>
                <c:pt idx="957">
                  <c:v>359.2</c:v>
                </c:pt>
                <c:pt idx="958">
                  <c:v>359</c:v>
                </c:pt>
                <c:pt idx="959">
                  <c:v>358.8</c:v>
                </c:pt>
                <c:pt idx="960">
                  <c:v>358.6</c:v>
                </c:pt>
                <c:pt idx="961">
                  <c:v>358.4</c:v>
                </c:pt>
                <c:pt idx="962">
                  <c:v>358.2</c:v>
                </c:pt>
                <c:pt idx="963">
                  <c:v>358</c:v>
                </c:pt>
                <c:pt idx="964">
                  <c:v>357.8</c:v>
                </c:pt>
                <c:pt idx="965">
                  <c:v>357.6</c:v>
                </c:pt>
                <c:pt idx="966">
                  <c:v>357.4</c:v>
                </c:pt>
                <c:pt idx="967">
                  <c:v>357.2</c:v>
                </c:pt>
                <c:pt idx="968">
                  <c:v>357</c:v>
                </c:pt>
                <c:pt idx="969">
                  <c:v>356.8</c:v>
                </c:pt>
                <c:pt idx="970">
                  <c:v>356.6</c:v>
                </c:pt>
                <c:pt idx="971">
                  <c:v>356.4</c:v>
                </c:pt>
                <c:pt idx="972">
                  <c:v>356.2</c:v>
                </c:pt>
                <c:pt idx="973">
                  <c:v>356</c:v>
                </c:pt>
                <c:pt idx="974">
                  <c:v>355.8</c:v>
                </c:pt>
                <c:pt idx="975">
                  <c:v>355.6</c:v>
                </c:pt>
                <c:pt idx="976">
                  <c:v>355.4</c:v>
                </c:pt>
                <c:pt idx="977">
                  <c:v>355.2</c:v>
                </c:pt>
                <c:pt idx="978">
                  <c:v>355</c:v>
                </c:pt>
                <c:pt idx="979">
                  <c:v>354.8</c:v>
                </c:pt>
                <c:pt idx="980">
                  <c:v>354.6</c:v>
                </c:pt>
                <c:pt idx="981">
                  <c:v>354.4</c:v>
                </c:pt>
                <c:pt idx="982">
                  <c:v>354.2</c:v>
                </c:pt>
                <c:pt idx="983">
                  <c:v>354</c:v>
                </c:pt>
                <c:pt idx="984">
                  <c:v>353.8</c:v>
                </c:pt>
                <c:pt idx="985">
                  <c:v>353.6</c:v>
                </c:pt>
                <c:pt idx="986">
                  <c:v>353.4</c:v>
                </c:pt>
                <c:pt idx="987">
                  <c:v>353.2</c:v>
                </c:pt>
                <c:pt idx="988">
                  <c:v>353</c:v>
                </c:pt>
                <c:pt idx="989">
                  <c:v>352.8</c:v>
                </c:pt>
                <c:pt idx="990">
                  <c:v>352.6</c:v>
                </c:pt>
                <c:pt idx="991">
                  <c:v>352.4</c:v>
                </c:pt>
                <c:pt idx="992">
                  <c:v>352.2</c:v>
                </c:pt>
                <c:pt idx="993">
                  <c:v>352</c:v>
                </c:pt>
                <c:pt idx="994">
                  <c:v>351.8</c:v>
                </c:pt>
                <c:pt idx="995">
                  <c:v>351.6</c:v>
                </c:pt>
                <c:pt idx="996">
                  <c:v>351.4</c:v>
                </c:pt>
                <c:pt idx="997">
                  <c:v>351.2</c:v>
                </c:pt>
                <c:pt idx="998">
                  <c:v>351</c:v>
                </c:pt>
                <c:pt idx="999">
                  <c:v>350.8</c:v>
                </c:pt>
                <c:pt idx="1000">
                  <c:v>350.6</c:v>
                </c:pt>
                <c:pt idx="1001">
                  <c:v>350.4</c:v>
                </c:pt>
                <c:pt idx="1002">
                  <c:v>350.2</c:v>
                </c:pt>
                <c:pt idx="1003">
                  <c:v>350</c:v>
                </c:pt>
                <c:pt idx="1004">
                  <c:v>349.8</c:v>
                </c:pt>
                <c:pt idx="1005">
                  <c:v>349.6</c:v>
                </c:pt>
                <c:pt idx="1006">
                  <c:v>349.4</c:v>
                </c:pt>
                <c:pt idx="1007">
                  <c:v>349.2</c:v>
                </c:pt>
                <c:pt idx="1008">
                  <c:v>349</c:v>
                </c:pt>
                <c:pt idx="1009">
                  <c:v>348.8</c:v>
                </c:pt>
                <c:pt idx="1010">
                  <c:v>348.6</c:v>
                </c:pt>
                <c:pt idx="1011">
                  <c:v>348.4</c:v>
                </c:pt>
                <c:pt idx="1012">
                  <c:v>348.2</c:v>
                </c:pt>
                <c:pt idx="1013">
                  <c:v>348</c:v>
                </c:pt>
                <c:pt idx="1014">
                  <c:v>347.8</c:v>
                </c:pt>
                <c:pt idx="1015">
                  <c:v>347.6</c:v>
                </c:pt>
                <c:pt idx="1016">
                  <c:v>347.4</c:v>
                </c:pt>
                <c:pt idx="1017">
                  <c:v>347.2</c:v>
                </c:pt>
                <c:pt idx="1018">
                  <c:v>347</c:v>
                </c:pt>
                <c:pt idx="1019">
                  <c:v>346.8</c:v>
                </c:pt>
                <c:pt idx="1020">
                  <c:v>346.6</c:v>
                </c:pt>
                <c:pt idx="1021">
                  <c:v>346.4</c:v>
                </c:pt>
                <c:pt idx="1022">
                  <c:v>346.2</c:v>
                </c:pt>
                <c:pt idx="1023">
                  <c:v>346</c:v>
                </c:pt>
                <c:pt idx="1024">
                  <c:v>345.8</c:v>
                </c:pt>
                <c:pt idx="1025">
                  <c:v>345.6</c:v>
                </c:pt>
                <c:pt idx="1026">
                  <c:v>345.4</c:v>
                </c:pt>
                <c:pt idx="1027">
                  <c:v>345.2</c:v>
                </c:pt>
                <c:pt idx="1028">
                  <c:v>345</c:v>
                </c:pt>
                <c:pt idx="1029">
                  <c:v>344.8</c:v>
                </c:pt>
                <c:pt idx="1030">
                  <c:v>344.6</c:v>
                </c:pt>
                <c:pt idx="1031">
                  <c:v>344.4</c:v>
                </c:pt>
                <c:pt idx="1032">
                  <c:v>344.2</c:v>
                </c:pt>
                <c:pt idx="1033">
                  <c:v>344</c:v>
                </c:pt>
                <c:pt idx="1034">
                  <c:v>343.8</c:v>
                </c:pt>
                <c:pt idx="1035">
                  <c:v>343.6</c:v>
                </c:pt>
                <c:pt idx="1036">
                  <c:v>343.4</c:v>
                </c:pt>
                <c:pt idx="1037">
                  <c:v>343.2</c:v>
                </c:pt>
                <c:pt idx="1038">
                  <c:v>343</c:v>
                </c:pt>
                <c:pt idx="1039">
                  <c:v>342.8</c:v>
                </c:pt>
                <c:pt idx="1040">
                  <c:v>342.6</c:v>
                </c:pt>
                <c:pt idx="1041">
                  <c:v>342.4</c:v>
                </c:pt>
                <c:pt idx="1042">
                  <c:v>342.2</c:v>
                </c:pt>
                <c:pt idx="1043">
                  <c:v>342</c:v>
                </c:pt>
                <c:pt idx="1044">
                  <c:v>341.8</c:v>
                </c:pt>
                <c:pt idx="1045">
                  <c:v>341.6</c:v>
                </c:pt>
                <c:pt idx="1046">
                  <c:v>341.4</c:v>
                </c:pt>
                <c:pt idx="1047">
                  <c:v>341.2</c:v>
                </c:pt>
                <c:pt idx="1048">
                  <c:v>341</c:v>
                </c:pt>
                <c:pt idx="1049">
                  <c:v>340.8</c:v>
                </c:pt>
                <c:pt idx="1050">
                  <c:v>340.6</c:v>
                </c:pt>
                <c:pt idx="1051">
                  <c:v>340.4</c:v>
                </c:pt>
                <c:pt idx="1052">
                  <c:v>340.2</c:v>
                </c:pt>
                <c:pt idx="1053">
                  <c:v>340</c:v>
                </c:pt>
                <c:pt idx="1054">
                  <c:v>339.8</c:v>
                </c:pt>
                <c:pt idx="1055">
                  <c:v>339.6</c:v>
                </c:pt>
                <c:pt idx="1056">
                  <c:v>339.4</c:v>
                </c:pt>
                <c:pt idx="1057">
                  <c:v>339.2</c:v>
                </c:pt>
                <c:pt idx="1058">
                  <c:v>339</c:v>
                </c:pt>
                <c:pt idx="1059">
                  <c:v>338.8</c:v>
                </c:pt>
                <c:pt idx="1060">
                  <c:v>338.6</c:v>
                </c:pt>
                <c:pt idx="1061">
                  <c:v>338.4</c:v>
                </c:pt>
                <c:pt idx="1062">
                  <c:v>338.2</c:v>
                </c:pt>
                <c:pt idx="1063">
                  <c:v>338</c:v>
                </c:pt>
                <c:pt idx="1064">
                  <c:v>337.8</c:v>
                </c:pt>
                <c:pt idx="1065">
                  <c:v>337.6</c:v>
                </c:pt>
                <c:pt idx="1066">
                  <c:v>337.4</c:v>
                </c:pt>
                <c:pt idx="1067">
                  <c:v>337.2</c:v>
                </c:pt>
                <c:pt idx="1068">
                  <c:v>337</c:v>
                </c:pt>
                <c:pt idx="1069">
                  <c:v>336.8</c:v>
                </c:pt>
                <c:pt idx="1070">
                  <c:v>336.6</c:v>
                </c:pt>
                <c:pt idx="1071">
                  <c:v>336.4</c:v>
                </c:pt>
                <c:pt idx="1072">
                  <c:v>336.2</c:v>
                </c:pt>
                <c:pt idx="1073">
                  <c:v>336</c:v>
                </c:pt>
                <c:pt idx="1074">
                  <c:v>335.8</c:v>
                </c:pt>
                <c:pt idx="1075">
                  <c:v>335.6</c:v>
                </c:pt>
                <c:pt idx="1076">
                  <c:v>335.4</c:v>
                </c:pt>
                <c:pt idx="1077">
                  <c:v>335.2</c:v>
                </c:pt>
                <c:pt idx="1078">
                  <c:v>335</c:v>
                </c:pt>
                <c:pt idx="1079">
                  <c:v>334.8</c:v>
                </c:pt>
                <c:pt idx="1080">
                  <c:v>334.6</c:v>
                </c:pt>
                <c:pt idx="1081">
                  <c:v>334.4</c:v>
                </c:pt>
                <c:pt idx="1082">
                  <c:v>334.2</c:v>
                </c:pt>
                <c:pt idx="1083">
                  <c:v>334</c:v>
                </c:pt>
                <c:pt idx="1084">
                  <c:v>333.8</c:v>
                </c:pt>
                <c:pt idx="1085">
                  <c:v>333.6</c:v>
                </c:pt>
                <c:pt idx="1086">
                  <c:v>333.4</c:v>
                </c:pt>
                <c:pt idx="1087">
                  <c:v>333.2</c:v>
                </c:pt>
                <c:pt idx="1088">
                  <c:v>333</c:v>
                </c:pt>
                <c:pt idx="1089">
                  <c:v>332.8</c:v>
                </c:pt>
                <c:pt idx="1090">
                  <c:v>332.6</c:v>
                </c:pt>
                <c:pt idx="1091">
                  <c:v>332.4</c:v>
                </c:pt>
                <c:pt idx="1092">
                  <c:v>332.2</c:v>
                </c:pt>
                <c:pt idx="1093">
                  <c:v>332</c:v>
                </c:pt>
                <c:pt idx="1094">
                  <c:v>331.8</c:v>
                </c:pt>
                <c:pt idx="1095">
                  <c:v>331.6</c:v>
                </c:pt>
                <c:pt idx="1096">
                  <c:v>331.4</c:v>
                </c:pt>
                <c:pt idx="1097">
                  <c:v>331.2</c:v>
                </c:pt>
                <c:pt idx="1098">
                  <c:v>331</c:v>
                </c:pt>
                <c:pt idx="1099">
                  <c:v>330.8</c:v>
                </c:pt>
                <c:pt idx="1100">
                  <c:v>330.6</c:v>
                </c:pt>
                <c:pt idx="1101">
                  <c:v>330.4</c:v>
                </c:pt>
                <c:pt idx="1102">
                  <c:v>330.2</c:v>
                </c:pt>
                <c:pt idx="1103">
                  <c:v>330</c:v>
                </c:pt>
                <c:pt idx="1104">
                  <c:v>329.8</c:v>
                </c:pt>
                <c:pt idx="1105">
                  <c:v>329.6</c:v>
                </c:pt>
                <c:pt idx="1106">
                  <c:v>329.4</c:v>
                </c:pt>
                <c:pt idx="1107">
                  <c:v>329.2</c:v>
                </c:pt>
                <c:pt idx="1108">
                  <c:v>329</c:v>
                </c:pt>
                <c:pt idx="1109">
                  <c:v>328.8</c:v>
                </c:pt>
                <c:pt idx="1110">
                  <c:v>328.6</c:v>
                </c:pt>
                <c:pt idx="1111">
                  <c:v>328.4</c:v>
                </c:pt>
                <c:pt idx="1112">
                  <c:v>328.2</c:v>
                </c:pt>
                <c:pt idx="1113">
                  <c:v>328</c:v>
                </c:pt>
                <c:pt idx="1114">
                  <c:v>327.8</c:v>
                </c:pt>
                <c:pt idx="1115">
                  <c:v>327.60000000000002</c:v>
                </c:pt>
                <c:pt idx="1116">
                  <c:v>327.39999999999998</c:v>
                </c:pt>
                <c:pt idx="1117">
                  <c:v>327.2</c:v>
                </c:pt>
                <c:pt idx="1118">
                  <c:v>327</c:v>
                </c:pt>
                <c:pt idx="1119">
                  <c:v>326.8</c:v>
                </c:pt>
                <c:pt idx="1120">
                  <c:v>326.60000000000002</c:v>
                </c:pt>
                <c:pt idx="1121">
                  <c:v>326.39999999999998</c:v>
                </c:pt>
                <c:pt idx="1122">
                  <c:v>326.2</c:v>
                </c:pt>
                <c:pt idx="1123">
                  <c:v>326</c:v>
                </c:pt>
                <c:pt idx="1124">
                  <c:v>325.8</c:v>
                </c:pt>
                <c:pt idx="1125">
                  <c:v>325.60000000000002</c:v>
                </c:pt>
                <c:pt idx="1126">
                  <c:v>325.39999999999998</c:v>
                </c:pt>
                <c:pt idx="1127">
                  <c:v>325.2</c:v>
                </c:pt>
                <c:pt idx="1128">
                  <c:v>325</c:v>
                </c:pt>
                <c:pt idx="1129">
                  <c:v>324.8</c:v>
                </c:pt>
                <c:pt idx="1130">
                  <c:v>324.60000000000002</c:v>
                </c:pt>
                <c:pt idx="1131">
                  <c:v>324.39999999999998</c:v>
                </c:pt>
                <c:pt idx="1132">
                  <c:v>324.2</c:v>
                </c:pt>
                <c:pt idx="1133">
                  <c:v>324</c:v>
                </c:pt>
                <c:pt idx="1134">
                  <c:v>323.8</c:v>
                </c:pt>
                <c:pt idx="1135">
                  <c:v>323.60000000000002</c:v>
                </c:pt>
                <c:pt idx="1136">
                  <c:v>323.39999999999998</c:v>
                </c:pt>
                <c:pt idx="1137">
                  <c:v>323.2</c:v>
                </c:pt>
                <c:pt idx="1138">
                  <c:v>323</c:v>
                </c:pt>
                <c:pt idx="1139">
                  <c:v>322.8</c:v>
                </c:pt>
                <c:pt idx="1140">
                  <c:v>322.60000000000002</c:v>
                </c:pt>
                <c:pt idx="1141">
                  <c:v>322.39999999999998</c:v>
                </c:pt>
                <c:pt idx="1142">
                  <c:v>322.2</c:v>
                </c:pt>
                <c:pt idx="1143">
                  <c:v>322</c:v>
                </c:pt>
                <c:pt idx="1144">
                  <c:v>321.8</c:v>
                </c:pt>
                <c:pt idx="1145">
                  <c:v>321.60000000000002</c:v>
                </c:pt>
                <c:pt idx="1146">
                  <c:v>321.39999999999998</c:v>
                </c:pt>
                <c:pt idx="1147">
                  <c:v>321.2</c:v>
                </c:pt>
                <c:pt idx="1148">
                  <c:v>321</c:v>
                </c:pt>
                <c:pt idx="1149">
                  <c:v>320.8</c:v>
                </c:pt>
                <c:pt idx="1150">
                  <c:v>320.60000000000002</c:v>
                </c:pt>
                <c:pt idx="1151">
                  <c:v>320.39999999999998</c:v>
                </c:pt>
                <c:pt idx="1152">
                  <c:v>320.2</c:v>
                </c:pt>
                <c:pt idx="1153">
                  <c:v>320</c:v>
                </c:pt>
                <c:pt idx="1154">
                  <c:v>319.8</c:v>
                </c:pt>
                <c:pt idx="1155">
                  <c:v>319.60000000000002</c:v>
                </c:pt>
                <c:pt idx="1156">
                  <c:v>319.39999999999998</c:v>
                </c:pt>
                <c:pt idx="1157">
                  <c:v>319.2</c:v>
                </c:pt>
                <c:pt idx="1158">
                  <c:v>319</c:v>
                </c:pt>
                <c:pt idx="1159">
                  <c:v>318.8</c:v>
                </c:pt>
                <c:pt idx="1160">
                  <c:v>318.60000000000002</c:v>
                </c:pt>
                <c:pt idx="1161">
                  <c:v>318.39999999999998</c:v>
                </c:pt>
                <c:pt idx="1162">
                  <c:v>318.2</c:v>
                </c:pt>
                <c:pt idx="1163">
                  <c:v>318</c:v>
                </c:pt>
                <c:pt idx="1164">
                  <c:v>317.8</c:v>
                </c:pt>
                <c:pt idx="1165">
                  <c:v>317.60000000000002</c:v>
                </c:pt>
                <c:pt idx="1166">
                  <c:v>317.39999999999998</c:v>
                </c:pt>
                <c:pt idx="1167">
                  <c:v>317.2</c:v>
                </c:pt>
                <c:pt idx="1168">
                  <c:v>317</c:v>
                </c:pt>
                <c:pt idx="1169">
                  <c:v>316.8</c:v>
                </c:pt>
                <c:pt idx="1170">
                  <c:v>316.60000000000002</c:v>
                </c:pt>
                <c:pt idx="1171">
                  <c:v>316.39999999999998</c:v>
                </c:pt>
                <c:pt idx="1172">
                  <c:v>316.2</c:v>
                </c:pt>
                <c:pt idx="1173">
                  <c:v>316</c:v>
                </c:pt>
                <c:pt idx="1174">
                  <c:v>315.8</c:v>
                </c:pt>
                <c:pt idx="1175">
                  <c:v>315.60000000000002</c:v>
                </c:pt>
                <c:pt idx="1176">
                  <c:v>315.39999999999998</c:v>
                </c:pt>
                <c:pt idx="1177">
                  <c:v>315.2</c:v>
                </c:pt>
                <c:pt idx="1178">
                  <c:v>315</c:v>
                </c:pt>
                <c:pt idx="1179">
                  <c:v>314.8</c:v>
                </c:pt>
                <c:pt idx="1180">
                  <c:v>314.60000000000002</c:v>
                </c:pt>
                <c:pt idx="1181">
                  <c:v>314.39999999999998</c:v>
                </c:pt>
                <c:pt idx="1182">
                  <c:v>314.2</c:v>
                </c:pt>
                <c:pt idx="1183">
                  <c:v>314</c:v>
                </c:pt>
                <c:pt idx="1184">
                  <c:v>313.8</c:v>
                </c:pt>
                <c:pt idx="1185">
                  <c:v>313.60000000000002</c:v>
                </c:pt>
                <c:pt idx="1186">
                  <c:v>313.39999999999998</c:v>
                </c:pt>
                <c:pt idx="1187">
                  <c:v>313.2</c:v>
                </c:pt>
                <c:pt idx="1188">
                  <c:v>313</c:v>
                </c:pt>
                <c:pt idx="1189">
                  <c:v>312.8</c:v>
                </c:pt>
                <c:pt idx="1190">
                  <c:v>312.60000000000002</c:v>
                </c:pt>
                <c:pt idx="1191">
                  <c:v>312.39999999999998</c:v>
                </c:pt>
                <c:pt idx="1192">
                  <c:v>312.2</c:v>
                </c:pt>
                <c:pt idx="1193">
                  <c:v>312</c:v>
                </c:pt>
                <c:pt idx="1194">
                  <c:v>311.8</c:v>
                </c:pt>
                <c:pt idx="1195">
                  <c:v>311.60000000000002</c:v>
                </c:pt>
                <c:pt idx="1196">
                  <c:v>311.39999999999998</c:v>
                </c:pt>
                <c:pt idx="1197">
                  <c:v>311.2</c:v>
                </c:pt>
                <c:pt idx="1198">
                  <c:v>311</c:v>
                </c:pt>
                <c:pt idx="1199">
                  <c:v>310.8</c:v>
                </c:pt>
                <c:pt idx="1200">
                  <c:v>310.60000000000002</c:v>
                </c:pt>
                <c:pt idx="1201">
                  <c:v>310.39999999999998</c:v>
                </c:pt>
                <c:pt idx="1202">
                  <c:v>310.2</c:v>
                </c:pt>
                <c:pt idx="1203">
                  <c:v>310</c:v>
                </c:pt>
                <c:pt idx="1204">
                  <c:v>309.8</c:v>
                </c:pt>
                <c:pt idx="1205">
                  <c:v>309.60000000000002</c:v>
                </c:pt>
                <c:pt idx="1206">
                  <c:v>309.39999999999998</c:v>
                </c:pt>
                <c:pt idx="1207">
                  <c:v>309.2</c:v>
                </c:pt>
                <c:pt idx="1208">
                  <c:v>309</c:v>
                </c:pt>
                <c:pt idx="1209">
                  <c:v>308.8</c:v>
                </c:pt>
                <c:pt idx="1210">
                  <c:v>308.60000000000002</c:v>
                </c:pt>
                <c:pt idx="1211">
                  <c:v>308.39999999999998</c:v>
                </c:pt>
                <c:pt idx="1212">
                  <c:v>308.2</c:v>
                </c:pt>
                <c:pt idx="1213">
                  <c:v>308</c:v>
                </c:pt>
                <c:pt idx="1214">
                  <c:v>307.8</c:v>
                </c:pt>
                <c:pt idx="1215">
                  <c:v>307.60000000000002</c:v>
                </c:pt>
                <c:pt idx="1216">
                  <c:v>307.39999999999998</c:v>
                </c:pt>
                <c:pt idx="1217">
                  <c:v>307.2</c:v>
                </c:pt>
                <c:pt idx="1218">
                  <c:v>307</c:v>
                </c:pt>
                <c:pt idx="1219">
                  <c:v>306.8</c:v>
                </c:pt>
                <c:pt idx="1220">
                  <c:v>306.60000000000002</c:v>
                </c:pt>
                <c:pt idx="1221">
                  <c:v>306.39999999999998</c:v>
                </c:pt>
                <c:pt idx="1222">
                  <c:v>306.2</c:v>
                </c:pt>
                <c:pt idx="1223">
                  <c:v>306</c:v>
                </c:pt>
                <c:pt idx="1224">
                  <c:v>305.8</c:v>
                </c:pt>
                <c:pt idx="1225">
                  <c:v>305.60000000000002</c:v>
                </c:pt>
                <c:pt idx="1226">
                  <c:v>305.39999999999998</c:v>
                </c:pt>
                <c:pt idx="1227">
                  <c:v>305.2</c:v>
                </c:pt>
                <c:pt idx="1228">
                  <c:v>305</c:v>
                </c:pt>
                <c:pt idx="1229">
                  <c:v>304.8</c:v>
                </c:pt>
                <c:pt idx="1230">
                  <c:v>304.60000000000002</c:v>
                </c:pt>
                <c:pt idx="1231">
                  <c:v>304.39999999999998</c:v>
                </c:pt>
                <c:pt idx="1232">
                  <c:v>304.2</c:v>
                </c:pt>
                <c:pt idx="1233">
                  <c:v>304</c:v>
                </c:pt>
                <c:pt idx="1234">
                  <c:v>303.8</c:v>
                </c:pt>
                <c:pt idx="1235">
                  <c:v>303.60000000000002</c:v>
                </c:pt>
                <c:pt idx="1236">
                  <c:v>303.39999999999998</c:v>
                </c:pt>
                <c:pt idx="1237">
                  <c:v>303.2</c:v>
                </c:pt>
                <c:pt idx="1238">
                  <c:v>303</c:v>
                </c:pt>
                <c:pt idx="1239">
                  <c:v>302.8</c:v>
                </c:pt>
                <c:pt idx="1240">
                  <c:v>302.60000000000002</c:v>
                </c:pt>
                <c:pt idx="1241">
                  <c:v>302.39999999999998</c:v>
                </c:pt>
                <c:pt idx="1242">
                  <c:v>302.2</c:v>
                </c:pt>
                <c:pt idx="1243">
                  <c:v>302</c:v>
                </c:pt>
                <c:pt idx="1244">
                  <c:v>301.8</c:v>
                </c:pt>
                <c:pt idx="1245">
                  <c:v>301.60000000000002</c:v>
                </c:pt>
                <c:pt idx="1246">
                  <c:v>301.39999999999998</c:v>
                </c:pt>
                <c:pt idx="1247">
                  <c:v>301.2</c:v>
                </c:pt>
                <c:pt idx="1248">
                  <c:v>301</c:v>
                </c:pt>
                <c:pt idx="1249">
                  <c:v>300.8</c:v>
                </c:pt>
                <c:pt idx="1250">
                  <c:v>300.60000000000002</c:v>
                </c:pt>
                <c:pt idx="1251">
                  <c:v>300.39999999999998</c:v>
                </c:pt>
                <c:pt idx="1252">
                  <c:v>300.2</c:v>
                </c:pt>
                <c:pt idx="1253">
                  <c:v>300</c:v>
                </c:pt>
              </c:numCache>
            </c:numRef>
          </c:xVal>
          <c:yVal>
            <c:numRef>
              <c:f>Hoja1!$BT$2:$BT$1255</c:f>
              <c:numCache>
                <c:formatCode>General</c:formatCode>
                <c:ptCount val="1254"/>
                <c:pt idx="0">
                  <c:v>0</c:v>
                </c:pt>
                <c:pt idx="1">
                  <c:v>0</c:v>
                </c:pt>
                <c:pt idx="3">
                  <c:v>8.3999999999999995E-3</c:v>
                </c:pt>
                <c:pt idx="4">
                  <c:v>8.3999999999999995E-3</c:v>
                </c:pt>
                <c:pt idx="5">
                  <c:v>8.3999999999999995E-3</c:v>
                </c:pt>
                <c:pt idx="6">
                  <c:v>8.5333333333333337E-3</c:v>
                </c:pt>
                <c:pt idx="7">
                  <c:v>8.6E-3</c:v>
                </c:pt>
                <c:pt idx="8">
                  <c:v>8.6999999999999994E-3</c:v>
                </c:pt>
                <c:pt idx="9">
                  <c:v>8.8000000000000005E-3</c:v>
                </c:pt>
                <c:pt idx="10">
                  <c:v>8.8999999999999999E-3</c:v>
                </c:pt>
                <c:pt idx="11">
                  <c:v>8.9666666666666662E-3</c:v>
                </c:pt>
                <c:pt idx="12">
                  <c:v>8.9666666666666662E-3</c:v>
                </c:pt>
                <c:pt idx="13">
                  <c:v>9.0333333333333325E-3</c:v>
                </c:pt>
                <c:pt idx="14">
                  <c:v>9.0666666666666673E-3</c:v>
                </c:pt>
                <c:pt idx="15">
                  <c:v>9.0666666666666673E-3</c:v>
                </c:pt>
                <c:pt idx="16">
                  <c:v>9.0666666666666673E-3</c:v>
                </c:pt>
                <c:pt idx="17">
                  <c:v>9.1333333333333336E-3</c:v>
                </c:pt>
                <c:pt idx="18">
                  <c:v>9.1666666666666684E-3</c:v>
                </c:pt>
                <c:pt idx="19">
                  <c:v>9.1666666666666684E-3</c:v>
                </c:pt>
                <c:pt idx="20">
                  <c:v>9.2333333333333347E-3</c:v>
                </c:pt>
                <c:pt idx="21">
                  <c:v>9.2666666666666661E-3</c:v>
                </c:pt>
                <c:pt idx="22">
                  <c:v>9.2666666666666661E-3</c:v>
                </c:pt>
                <c:pt idx="23">
                  <c:v>9.300000000000001E-3</c:v>
                </c:pt>
                <c:pt idx="24">
                  <c:v>9.300000000000001E-3</c:v>
                </c:pt>
                <c:pt idx="25">
                  <c:v>9.3333333333333341E-3</c:v>
                </c:pt>
                <c:pt idx="26">
                  <c:v>9.4333333333333335E-3</c:v>
                </c:pt>
                <c:pt idx="27">
                  <c:v>9.5333333333333329E-3</c:v>
                </c:pt>
                <c:pt idx="28">
                  <c:v>9.5666666666666678E-3</c:v>
                </c:pt>
                <c:pt idx="29">
                  <c:v>9.5999999999999992E-3</c:v>
                </c:pt>
                <c:pt idx="30">
                  <c:v>9.5999999999999992E-3</c:v>
                </c:pt>
                <c:pt idx="31">
                  <c:v>9.5999999999999992E-3</c:v>
                </c:pt>
                <c:pt idx="32">
                  <c:v>9.6666666666666654E-3</c:v>
                </c:pt>
                <c:pt idx="33">
                  <c:v>9.7333333333333352E-3</c:v>
                </c:pt>
                <c:pt idx="34">
                  <c:v>9.7333333333333352E-3</c:v>
                </c:pt>
                <c:pt idx="35">
                  <c:v>9.7666666666666666E-3</c:v>
                </c:pt>
                <c:pt idx="36">
                  <c:v>9.8000000000000014E-3</c:v>
                </c:pt>
                <c:pt idx="37">
                  <c:v>9.8000000000000014E-3</c:v>
                </c:pt>
                <c:pt idx="38">
                  <c:v>9.8333333333333328E-3</c:v>
                </c:pt>
                <c:pt idx="39">
                  <c:v>9.9000000000000008E-3</c:v>
                </c:pt>
                <c:pt idx="40">
                  <c:v>9.9666666666666671E-3</c:v>
                </c:pt>
                <c:pt idx="41">
                  <c:v>1.0066666666666666E-2</c:v>
                </c:pt>
                <c:pt idx="42">
                  <c:v>1.0066666666666666E-2</c:v>
                </c:pt>
                <c:pt idx="43">
                  <c:v>1.01E-2</c:v>
                </c:pt>
                <c:pt idx="44">
                  <c:v>1.01E-2</c:v>
                </c:pt>
                <c:pt idx="45">
                  <c:v>1.01E-2</c:v>
                </c:pt>
                <c:pt idx="46">
                  <c:v>1.0166666666666666E-2</c:v>
                </c:pt>
                <c:pt idx="47">
                  <c:v>1.0233333333333332E-2</c:v>
                </c:pt>
                <c:pt idx="48">
                  <c:v>1.0333333333333333E-2</c:v>
                </c:pt>
                <c:pt idx="49">
                  <c:v>1.0400000000000001E-2</c:v>
                </c:pt>
                <c:pt idx="50">
                  <c:v>1.0433333333333334E-2</c:v>
                </c:pt>
                <c:pt idx="51">
                  <c:v>1.0500000000000001E-2</c:v>
                </c:pt>
                <c:pt idx="52">
                  <c:v>1.0500000000000001E-2</c:v>
                </c:pt>
                <c:pt idx="53">
                  <c:v>1.0500000000000001E-2</c:v>
                </c:pt>
                <c:pt idx="54">
                  <c:v>1.0533333333333334E-2</c:v>
                </c:pt>
                <c:pt idx="55">
                  <c:v>1.06E-2</c:v>
                </c:pt>
                <c:pt idx="56">
                  <c:v>1.0700000000000001E-2</c:v>
                </c:pt>
                <c:pt idx="57">
                  <c:v>1.0766666666666666E-2</c:v>
                </c:pt>
                <c:pt idx="58">
                  <c:v>1.0766666666666666E-2</c:v>
                </c:pt>
                <c:pt idx="59">
                  <c:v>1.0833333333333334E-2</c:v>
                </c:pt>
                <c:pt idx="60">
                  <c:v>1.0833333333333334E-2</c:v>
                </c:pt>
                <c:pt idx="61">
                  <c:v>1.0933333333333335E-2</c:v>
                </c:pt>
                <c:pt idx="62">
                  <c:v>1.0966666666666666E-2</c:v>
                </c:pt>
                <c:pt idx="63">
                  <c:v>1.1000000000000001E-2</c:v>
                </c:pt>
                <c:pt idx="64">
                  <c:v>1.1066666666666667E-2</c:v>
                </c:pt>
                <c:pt idx="65">
                  <c:v>1.1066666666666667E-2</c:v>
                </c:pt>
                <c:pt idx="66">
                  <c:v>1.1166666666666667E-2</c:v>
                </c:pt>
                <c:pt idx="67">
                  <c:v>1.1233333333333333E-2</c:v>
                </c:pt>
                <c:pt idx="68">
                  <c:v>1.1266666666666666E-2</c:v>
                </c:pt>
                <c:pt idx="69">
                  <c:v>1.1299999999999999E-2</c:v>
                </c:pt>
                <c:pt idx="70">
                  <c:v>1.1366666666666666E-2</c:v>
                </c:pt>
                <c:pt idx="71">
                  <c:v>1.1200000000000002E-2</c:v>
                </c:pt>
                <c:pt idx="72">
                  <c:v>1.1033333333333332E-2</c:v>
                </c:pt>
                <c:pt idx="73">
                  <c:v>1.0866666666666665E-2</c:v>
                </c:pt>
                <c:pt idx="74">
                  <c:v>1.0733333333333333E-2</c:v>
                </c:pt>
                <c:pt idx="75">
                  <c:v>1.0766666666666667E-2</c:v>
                </c:pt>
                <c:pt idx="76">
                  <c:v>1.0799999999999999E-2</c:v>
                </c:pt>
                <c:pt idx="77">
                  <c:v>1.0833333333333334E-2</c:v>
                </c:pt>
                <c:pt idx="78">
                  <c:v>1.0866666666666665E-2</c:v>
                </c:pt>
                <c:pt idx="79">
                  <c:v>1.1000000000000001E-2</c:v>
                </c:pt>
                <c:pt idx="80">
                  <c:v>1.1033333333333334E-2</c:v>
                </c:pt>
                <c:pt idx="81">
                  <c:v>1.1099999999999999E-2</c:v>
                </c:pt>
                <c:pt idx="82">
                  <c:v>1.1133333333333334E-2</c:v>
                </c:pt>
                <c:pt idx="83">
                  <c:v>1.1133333333333334E-2</c:v>
                </c:pt>
                <c:pt idx="84">
                  <c:v>1.12E-2</c:v>
                </c:pt>
                <c:pt idx="85">
                  <c:v>1.1233333333333333E-2</c:v>
                </c:pt>
                <c:pt idx="86">
                  <c:v>1.1299999999999999E-2</c:v>
                </c:pt>
                <c:pt idx="87">
                  <c:v>1.1333333333333334E-2</c:v>
                </c:pt>
                <c:pt idx="88">
                  <c:v>1.14E-2</c:v>
                </c:pt>
                <c:pt idx="89">
                  <c:v>1.14E-2</c:v>
                </c:pt>
                <c:pt idx="90">
                  <c:v>1.1466666666666667E-2</c:v>
                </c:pt>
                <c:pt idx="91">
                  <c:v>1.1533333333333333E-2</c:v>
                </c:pt>
                <c:pt idx="92">
                  <c:v>1.1533333333333333E-2</c:v>
                </c:pt>
                <c:pt idx="93">
                  <c:v>1.1599999999999999E-2</c:v>
                </c:pt>
                <c:pt idx="94">
                  <c:v>1.17E-2</c:v>
                </c:pt>
                <c:pt idx="95">
                  <c:v>1.1733333333333333E-2</c:v>
                </c:pt>
                <c:pt idx="96">
                  <c:v>1.1766666666666667E-2</c:v>
                </c:pt>
                <c:pt idx="97">
                  <c:v>1.18E-2</c:v>
                </c:pt>
                <c:pt idx="98">
                  <c:v>1.1833333333333333E-2</c:v>
                </c:pt>
                <c:pt idx="99">
                  <c:v>1.18E-2</c:v>
                </c:pt>
                <c:pt idx="100">
                  <c:v>1.1933333333333332E-2</c:v>
                </c:pt>
                <c:pt idx="101">
                  <c:v>1.1933333333333332E-2</c:v>
                </c:pt>
                <c:pt idx="102">
                  <c:v>1.1933333333333332E-2</c:v>
                </c:pt>
                <c:pt idx="103">
                  <c:v>1.1966666666666667E-2</c:v>
                </c:pt>
                <c:pt idx="104">
                  <c:v>1.2033333333333333E-2</c:v>
                </c:pt>
                <c:pt idx="105">
                  <c:v>1.2033333333333333E-2</c:v>
                </c:pt>
                <c:pt idx="106">
                  <c:v>1.2166666666666668E-2</c:v>
                </c:pt>
                <c:pt idx="107">
                  <c:v>1.2200000000000001E-2</c:v>
                </c:pt>
                <c:pt idx="108">
                  <c:v>1.23E-2</c:v>
                </c:pt>
                <c:pt idx="109">
                  <c:v>1.23E-2</c:v>
                </c:pt>
                <c:pt idx="110">
                  <c:v>1.24E-2</c:v>
                </c:pt>
                <c:pt idx="111">
                  <c:v>1.2433333333333333E-2</c:v>
                </c:pt>
                <c:pt idx="112">
                  <c:v>1.2466666666666668E-2</c:v>
                </c:pt>
                <c:pt idx="113">
                  <c:v>1.2499999999999999E-2</c:v>
                </c:pt>
                <c:pt idx="114">
                  <c:v>1.2533333333333332E-2</c:v>
                </c:pt>
                <c:pt idx="115">
                  <c:v>1.2533333333333332E-2</c:v>
                </c:pt>
                <c:pt idx="116">
                  <c:v>1.2533333333333332E-2</c:v>
                </c:pt>
                <c:pt idx="117">
                  <c:v>1.2633333333333331E-2</c:v>
                </c:pt>
                <c:pt idx="118">
                  <c:v>1.2633333333333331E-2</c:v>
                </c:pt>
                <c:pt idx="119">
                  <c:v>1.2633333333333331E-2</c:v>
                </c:pt>
                <c:pt idx="120">
                  <c:v>1.2700000000000001E-2</c:v>
                </c:pt>
                <c:pt idx="121">
                  <c:v>1.2700000000000001E-2</c:v>
                </c:pt>
                <c:pt idx="122">
                  <c:v>1.2733333333333334E-2</c:v>
                </c:pt>
                <c:pt idx="123">
                  <c:v>1.2733333333333334E-2</c:v>
                </c:pt>
                <c:pt idx="124">
                  <c:v>1.2866666666666667E-2</c:v>
                </c:pt>
                <c:pt idx="125">
                  <c:v>1.29E-2</c:v>
                </c:pt>
                <c:pt idx="126">
                  <c:v>1.29E-2</c:v>
                </c:pt>
                <c:pt idx="127">
                  <c:v>1.2966666666666666E-2</c:v>
                </c:pt>
                <c:pt idx="128">
                  <c:v>1.2966666666666666E-2</c:v>
                </c:pt>
                <c:pt idx="129">
                  <c:v>1.3033333333333333E-2</c:v>
                </c:pt>
                <c:pt idx="130">
                  <c:v>1.3033333333333333E-2</c:v>
                </c:pt>
                <c:pt idx="131">
                  <c:v>1.3200000000000002E-2</c:v>
                </c:pt>
                <c:pt idx="132">
                  <c:v>1.3233333333333335E-2</c:v>
                </c:pt>
                <c:pt idx="133">
                  <c:v>1.3233333333333335E-2</c:v>
                </c:pt>
                <c:pt idx="134">
                  <c:v>1.3299999999999999E-2</c:v>
                </c:pt>
                <c:pt idx="135">
                  <c:v>1.3299999999999999E-2</c:v>
                </c:pt>
                <c:pt idx="136">
                  <c:v>1.3366666666666666E-2</c:v>
                </c:pt>
                <c:pt idx="137">
                  <c:v>1.34E-2</c:v>
                </c:pt>
                <c:pt idx="138">
                  <c:v>1.34E-2</c:v>
                </c:pt>
                <c:pt idx="139">
                  <c:v>1.35E-2</c:v>
                </c:pt>
                <c:pt idx="140">
                  <c:v>1.3533333333333333E-2</c:v>
                </c:pt>
                <c:pt idx="141">
                  <c:v>1.3566666666666666E-2</c:v>
                </c:pt>
                <c:pt idx="142">
                  <c:v>1.3566666666666666E-2</c:v>
                </c:pt>
                <c:pt idx="143">
                  <c:v>1.3566666666666666E-2</c:v>
                </c:pt>
                <c:pt idx="144">
                  <c:v>1.3599999999999999E-2</c:v>
                </c:pt>
                <c:pt idx="145">
                  <c:v>1.3666666666666667E-2</c:v>
                </c:pt>
                <c:pt idx="146">
                  <c:v>1.3699999999999999E-2</c:v>
                </c:pt>
                <c:pt idx="147">
                  <c:v>1.3833333333333331E-2</c:v>
                </c:pt>
                <c:pt idx="148">
                  <c:v>1.3833333333333331E-2</c:v>
                </c:pt>
                <c:pt idx="149">
                  <c:v>1.3833333333333331E-2</c:v>
                </c:pt>
                <c:pt idx="150">
                  <c:v>1.3833333333333331E-2</c:v>
                </c:pt>
                <c:pt idx="151">
                  <c:v>1.3933333333333334E-2</c:v>
                </c:pt>
                <c:pt idx="152">
                  <c:v>1.3933333333333334E-2</c:v>
                </c:pt>
                <c:pt idx="153">
                  <c:v>1.3999999999999999E-2</c:v>
                </c:pt>
                <c:pt idx="154">
                  <c:v>1.4033333333333333E-2</c:v>
                </c:pt>
                <c:pt idx="155">
                  <c:v>1.4033333333333333E-2</c:v>
                </c:pt>
                <c:pt idx="156">
                  <c:v>1.4166666666666666E-2</c:v>
                </c:pt>
                <c:pt idx="157">
                  <c:v>1.4233333333333334E-2</c:v>
                </c:pt>
                <c:pt idx="158">
                  <c:v>1.4266666666666669E-2</c:v>
                </c:pt>
                <c:pt idx="159">
                  <c:v>1.43E-2</c:v>
                </c:pt>
                <c:pt idx="160">
                  <c:v>1.4333333333333335E-2</c:v>
                </c:pt>
                <c:pt idx="161">
                  <c:v>1.4333333333333335E-2</c:v>
                </c:pt>
                <c:pt idx="162">
                  <c:v>1.4433333333333333E-2</c:v>
                </c:pt>
                <c:pt idx="163">
                  <c:v>1.4433333333333333E-2</c:v>
                </c:pt>
                <c:pt idx="164">
                  <c:v>1.4466666666666664E-2</c:v>
                </c:pt>
                <c:pt idx="165">
                  <c:v>1.4566666666666667E-2</c:v>
                </c:pt>
                <c:pt idx="166">
                  <c:v>1.46E-2</c:v>
                </c:pt>
                <c:pt idx="167">
                  <c:v>1.46E-2</c:v>
                </c:pt>
                <c:pt idx="168">
                  <c:v>1.4633333333333333E-2</c:v>
                </c:pt>
                <c:pt idx="169">
                  <c:v>1.4666666666666668E-2</c:v>
                </c:pt>
                <c:pt idx="170">
                  <c:v>1.4666666666666668E-2</c:v>
                </c:pt>
                <c:pt idx="171">
                  <c:v>1.4766666666666666E-2</c:v>
                </c:pt>
                <c:pt idx="172">
                  <c:v>1.4866666666666667E-2</c:v>
                </c:pt>
                <c:pt idx="173">
                  <c:v>1.4866666666666667E-2</c:v>
                </c:pt>
                <c:pt idx="174">
                  <c:v>1.4933333333333333E-2</c:v>
                </c:pt>
                <c:pt idx="175">
                  <c:v>1.4933333333333333E-2</c:v>
                </c:pt>
                <c:pt idx="176">
                  <c:v>1.4966666666666668E-2</c:v>
                </c:pt>
                <c:pt idx="177">
                  <c:v>1.5033333333333334E-2</c:v>
                </c:pt>
                <c:pt idx="178">
                  <c:v>1.5066666666666667E-2</c:v>
                </c:pt>
                <c:pt idx="179">
                  <c:v>1.5100000000000001E-2</c:v>
                </c:pt>
                <c:pt idx="180">
                  <c:v>1.5100000000000001E-2</c:v>
                </c:pt>
                <c:pt idx="181">
                  <c:v>1.5133333333333334E-2</c:v>
                </c:pt>
                <c:pt idx="182">
                  <c:v>1.5133333333333334E-2</c:v>
                </c:pt>
                <c:pt idx="183">
                  <c:v>1.5166666666666667E-2</c:v>
                </c:pt>
                <c:pt idx="184">
                  <c:v>1.52E-2</c:v>
                </c:pt>
                <c:pt idx="185">
                  <c:v>1.5266666666666664E-2</c:v>
                </c:pt>
                <c:pt idx="186">
                  <c:v>1.5333333333333332E-2</c:v>
                </c:pt>
                <c:pt idx="187">
                  <c:v>1.5433333333333335E-2</c:v>
                </c:pt>
                <c:pt idx="188">
                  <c:v>1.5466666666666665E-2</c:v>
                </c:pt>
                <c:pt idx="189">
                  <c:v>1.5600000000000001E-2</c:v>
                </c:pt>
                <c:pt idx="190">
                  <c:v>1.5600000000000001E-2</c:v>
                </c:pt>
                <c:pt idx="191">
                  <c:v>1.5700000000000002E-2</c:v>
                </c:pt>
                <c:pt idx="192">
                  <c:v>1.5700000000000002E-2</c:v>
                </c:pt>
                <c:pt idx="193">
                  <c:v>1.5700000000000002E-2</c:v>
                </c:pt>
                <c:pt idx="194">
                  <c:v>1.5799999999999998E-2</c:v>
                </c:pt>
                <c:pt idx="195">
                  <c:v>1.5833333333333335E-2</c:v>
                </c:pt>
                <c:pt idx="196">
                  <c:v>1.5833333333333335E-2</c:v>
                </c:pt>
                <c:pt idx="197">
                  <c:v>1.5866666666666664E-2</c:v>
                </c:pt>
                <c:pt idx="198">
                  <c:v>1.5933333333333331E-2</c:v>
                </c:pt>
                <c:pt idx="199">
                  <c:v>1.5966666666666667E-2</c:v>
                </c:pt>
                <c:pt idx="200">
                  <c:v>1.6033333333333333E-2</c:v>
                </c:pt>
                <c:pt idx="201">
                  <c:v>1.606666666666667E-2</c:v>
                </c:pt>
                <c:pt idx="202">
                  <c:v>1.6133333333333333E-2</c:v>
                </c:pt>
                <c:pt idx="203">
                  <c:v>1.6199999999999999E-2</c:v>
                </c:pt>
                <c:pt idx="204">
                  <c:v>1.6233333333333332E-2</c:v>
                </c:pt>
                <c:pt idx="205">
                  <c:v>1.6266666666666665E-2</c:v>
                </c:pt>
                <c:pt idx="206">
                  <c:v>1.6366666666666665E-2</c:v>
                </c:pt>
                <c:pt idx="207">
                  <c:v>1.6400000000000001E-2</c:v>
                </c:pt>
                <c:pt idx="208">
                  <c:v>1.6533333333333334E-2</c:v>
                </c:pt>
                <c:pt idx="209">
                  <c:v>1.6533333333333334E-2</c:v>
                </c:pt>
                <c:pt idx="210">
                  <c:v>1.6566666666666671E-2</c:v>
                </c:pt>
                <c:pt idx="211">
                  <c:v>1.6566666666666671E-2</c:v>
                </c:pt>
                <c:pt idx="212">
                  <c:v>1.67E-2</c:v>
                </c:pt>
                <c:pt idx="213">
                  <c:v>1.6733333333333333E-2</c:v>
                </c:pt>
                <c:pt idx="214">
                  <c:v>1.6799999999999999E-2</c:v>
                </c:pt>
                <c:pt idx="215">
                  <c:v>1.6833333333333336E-2</c:v>
                </c:pt>
                <c:pt idx="216">
                  <c:v>1.6866666666666669E-2</c:v>
                </c:pt>
                <c:pt idx="217">
                  <c:v>1.6899999999999998E-2</c:v>
                </c:pt>
                <c:pt idx="218">
                  <c:v>1.6933333333333331E-2</c:v>
                </c:pt>
                <c:pt idx="219">
                  <c:v>1.6966666666666668E-2</c:v>
                </c:pt>
                <c:pt idx="220">
                  <c:v>1.6966666666666668E-2</c:v>
                </c:pt>
                <c:pt idx="221">
                  <c:v>1.7033333333333334E-2</c:v>
                </c:pt>
                <c:pt idx="222">
                  <c:v>1.7100000000000001E-2</c:v>
                </c:pt>
                <c:pt idx="223">
                  <c:v>1.72E-2</c:v>
                </c:pt>
                <c:pt idx="224">
                  <c:v>1.72E-2</c:v>
                </c:pt>
                <c:pt idx="225">
                  <c:v>1.7299999999999999E-2</c:v>
                </c:pt>
                <c:pt idx="226">
                  <c:v>1.7333333333333333E-2</c:v>
                </c:pt>
                <c:pt idx="227">
                  <c:v>1.7400000000000002E-2</c:v>
                </c:pt>
                <c:pt idx="228">
                  <c:v>1.7466666666666669E-2</c:v>
                </c:pt>
                <c:pt idx="229">
                  <c:v>1.7500000000000002E-2</c:v>
                </c:pt>
                <c:pt idx="230">
                  <c:v>1.7533333333333331E-2</c:v>
                </c:pt>
                <c:pt idx="231">
                  <c:v>1.7566666666666664E-2</c:v>
                </c:pt>
                <c:pt idx="232">
                  <c:v>1.7600000000000001E-2</c:v>
                </c:pt>
                <c:pt idx="233">
                  <c:v>1.7633333333333334E-2</c:v>
                </c:pt>
                <c:pt idx="234">
                  <c:v>1.77E-2</c:v>
                </c:pt>
                <c:pt idx="235">
                  <c:v>1.7766666666666663E-2</c:v>
                </c:pt>
                <c:pt idx="236">
                  <c:v>1.7833333333333333E-2</c:v>
                </c:pt>
                <c:pt idx="237">
                  <c:v>1.7866666666666666E-2</c:v>
                </c:pt>
                <c:pt idx="238">
                  <c:v>1.7966666666666666E-2</c:v>
                </c:pt>
                <c:pt idx="239">
                  <c:v>1.7966666666666666E-2</c:v>
                </c:pt>
                <c:pt idx="240">
                  <c:v>1.8033333333333332E-2</c:v>
                </c:pt>
                <c:pt idx="241">
                  <c:v>1.8033333333333332E-2</c:v>
                </c:pt>
                <c:pt idx="242">
                  <c:v>1.8033333333333332E-2</c:v>
                </c:pt>
                <c:pt idx="243">
                  <c:v>1.8066666666666665E-2</c:v>
                </c:pt>
                <c:pt idx="244">
                  <c:v>1.8133333333333335E-2</c:v>
                </c:pt>
                <c:pt idx="245">
                  <c:v>1.8199999999999997E-2</c:v>
                </c:pt>
                <c:pt idx="246">
                  <c:v>1.833333333333333E-2</c:v>
                </c:pt>
                <c:pt idx="247">
                  <c:v>1.8366666666666667E-2</c:v>
                </c:pt>
                <c:pt idx="248">
                  <c:v>1.84E-2</c:v>
                </c:pt>
                <c:pt idx="249">
                  <c:v>1.8433333333333333E-2</c:v>
                </c:pt>
                <c:pt idx="250">
                  <c:v>1.8433333333333333E-2</c:v>
                </c:pt>
                <c:pt idx="251">
                  <c:v>1.8533333333333332E-2</c:v>
                </c:pt>
                <c:pt idx="252">
                  <c:v>1.8600000000000002E-2</c:v>
                </c:pt>
                <c:pt idx="253">
                  <c:v>1.8633333333333335E-2</c:v>
                </c:pt>
                <c:pt idx="254">
                  <c:v>1.8633333333333335E-2</c:v>
                </c:pt>
                <c:pt idx="255">
                  <c:v>1.8666666666666668E-2</c:v>
                </c:pt>
                <c:pt idx="256">
                  <c:v>1.8700000000000001E-2</c:v>
                </c:pt>
                <c:pt idx="257">
                  <c:v>1.8766666666666668E-2</c:v>
                </c:pt>
                <c:pt idx="258">
                  <c:v>1.8833333333333337E-2</c:v>
                </c:pt>
                <c:pt idx="259">
                  <c:v>1.8800000000000001E-2</c:v>
                </c:pt>
                <c:pt idx="260">
                  <c:v>1.8800000000000001E-2</c:v>
                </c:pt>
                <c:pt idx="261">
                  <c:v>1.8933333333333333E-2</c:v>
                </c:pt>
                <c:pt idx="262">
                  <c:v>1.8933333333333333E-2</c:v>
                </c:pt>
                <c:pt idx="263">
                  <c:v>1.9066666666666666E-2</c:v>
                </c:pt>
                <c:pt idx="264">
                  <c:v>1.9066666666666666E-2</c:v>
                </c:pt>
                <c:pt idx="265">
                  <c:v>1.9100000000000002E-2</c:v>
                </c:pt>
                <c:pt idx="266">
                  <c:v>1.9133333333333336E-2</c:v>
                </c:pt>
                <c:pt idx="267">
                  <c:v>1.9100000000000002E-2</c:v>
                </c:pt>
                <c:pt idx="268">
                  <c:v>1.9166666666666665E-2</c:v>
                </c:pt>
                <c:pt idx="269">
                  <c:v>1.9199999999999998E-2</c:v>
                </c:pt>
                <c:pt idx="270">
                  <c:v>1.9199999999999998E-2</c:v>
                </c:pt>
                <c:pt idx="271">
                  <c:v>1.9300000000000001E-2</c:v>
                </c:pt>
                <c:pt idx="272">
                  <c:v>1.9333333333333331E-2</c:v>
                </c:pt>
                <c:pt idx="273">
                  <c:v>1.9333333333333331E-2</c:v>
                </c:pt>
                <c:pt idx="274">
                  <c:v>1.9400000000000001E-2</c:v>
                </c:pt>
                <c:pt idx="275">
                  <c:v>1.9433333333333334E-2</c:v>
                </c:pt>
                <c:pt idx="276">
                  <c:v>1.95E-2</c:v>
                </c:pt>
                <c:pt idx="277">
                  <c:v>1.9533333333333333E-2</c:v>
                </c:pt>
                <c:pt idx="278">
                  <c:v>1.9533333333333333E-2</c:v>
                </c:pt>
                <c:pt idx="279">
                  <c:v>1.9566666666666666E-2</c:v>
                </c:pt>
                <c:pt idx="280">
                  <c:v>1.9566666666666666E-2</c:v>
                </c:pt>
                <c:pt idx="281">
                  <c:v>1.9566666666666666E-2</c:v>
                </c:pt>
                <c:pt idx="282">
                  <c:v>1.9600000000000003E-2</c:v>
                </c:pt>
                <c:pt idx="283">
                  <c:v>1.9600000000000003E-2</c:v>
                </c:pt>
                <c:pt idx="284">
                  <c:v>1.9633333333333332E-2</c:v>
                </c:pt>
                <c:pt idx="285">
                  <c:v>1.9699999999999999E-2</c:v>
                </c:pt>
                <c:pt idx="286">
                  <c:v>1.9699999999999999E-2</c:v>
                </c:pt>
                <c:pt idx="287">
                  <c:v>1.9699999999999999E-2</c:v>
                </c:pt>
                <c:pt idx="288">
                  <c:v>1.9733333333333335E-2</c:v>
                </c:pt>
                <c:pt idx="289">
                  <c:v>1.9766666666666665E-2</c:v>
                </c:pt>
                <c:pt idx="290">
                  <c:v>1.9866666666666668E-2</c:v>
                </c:pt>
                <c:pt idx="291">
                  <c:v>1.9900000000000001E-2</c:v>
                </c:pt>
                <c:pt idx="292">
                  <c:v>1.9933333333333334E-2</c:v>
                </c:pt>
                <c:pt idx="293">
                  <c:v>1.9966666666666664E-2</c:v>
                </c:pt>
                <c:pt idx="294">
                  <c:v>0.02</c:v>
                </c:pt>
                <c:pt idx="295">
                  <c:v>0.02</c:v>
                </c:pt>
                <c:pt idx="296">
                  <c:v>2.0066666666666667E-2</c:v>
                </c:pt>
                <c:pt idx="297">
                  <c:v>2.0133333333333333E-2</c:v>
                </c:pt>
                <c:pt idx="298">
                  <c:v>2.0133333333333333E-2</c:v>
                </c:pt>
                <c:pt idx="299">
                  <c:v>2.0166666666666666E-2</c:v>
                </c:pt>
                <c:pt idx="300">
                  <c:v>2.0199999999999999E-2</c:v>
                </c:pt>
                <c:pt idx="301">
                  <c:v>2.0199999999999999E-2</c:v>
                </c:pt>
                <c:pt idx="302">
                  <c:v>2.0199999999999999E-2</c:v>
                </c:pt>
                <c:pt idx="303">
                  <c:v>2.0233333333333332E-2</c:v>
                </c:pt>
                <c:pt idx="304">
                  <c:v>2.0233333333333332E-2</c:v>
                </c:pt>
                <c:pt idx="305">
                  <c:v>2.0300000000000002E-2</c:v>
                </c:pt>
                <c:pt idx="306">
                  <c:v>2.0300000000000002E-2</c:v>
                </c:pt>
                <c:pt idx="307">
                  <c:v>2.0333333333333335E-2</c:v>
                </c:pt>
                <c:pt idx="308">
                  <c:v>2.0366666666666668E-2</c:v>
                </c:pt>
                <c:pt idx="309">
                  <c:v>2.0333333333333332E-2</c:v>
                </c:pt>
                <c:pt idx="310">
                  <c:v>2.0333333333333332E-2</c:v>
                </c:pt>
                <c:pt idx="311">
                  <c:v>2.0333333333333332E-2</c:v>
                </c:pt>
                <c:pt idx="312">
                  <c:v>2.0400000000000001E-2</c:v>
                </c:pt>
                <c:pt idx="313">
                  <c:v>2.0433333333333335E-2</c:v>
                </c:pt>
                <c:pt idx="314">
                  <c:v>2.0566666666666667E-2</c:v>
                </c:pt>
                <c:pt idx="315">
                  <c:v>2.0566666666666667E-2</c:v>
                </c:pt>
                <c:pt idx="316">
                  <c:v>2.0599999999999997E-2</c:v>
                </c:pt>
                <c:pt idx="317">
                  <c:v>2.0599999999999997E-2</c:v>
                </c:pt>
                <c:pt idx="318">
                  <c:v>2.0633333333333333E-2</c:v>
                </c:pt>
                <c:pt idx="319">
                  <c:v>2.0666666666666667E-2</c:v>
                </c:pt>
                <c:pt idx="320">
                  <c:v>2.07E-2</c:v>
                </c:pt>
                <c:pt idx="321">
                  <c:v>2.0666666666666667E-2</c:v>
                </c:pt>
                <c:pt idx="322">
                  <c:v>2.07E-2</c:v>
                </c:pt>
                <c:pt idx="323">
                  <c:v>2.07E-2</c:v>
                </c:pt>
                <c:pt idx="324">
                  <c:v>2.0733333333333336E-2</c:v>
                </c:pt>
                <c:pt idx="325">
                  <c:v>2.0766666666666669E-2</c:v>
                </c:pt>
                <c:pt idx="326">
                  <c:v>2.0833333333333332E-2</c:v>
                </c:pt>
                <c:pt idx="327">
                  <c:v>2.0833333333333332E-2</c:v>
                </c:pt>
                <c:pt idx="328">
                  <c:v>2.0833333333333332E-2</c:v>
                </c:pt>
                <c:pt idx="329">
                  <c:v>2.0900000000000002E-2</c:v>
                </c:pt>
                <c:pt idx="330">
                  <c:v>2.1000000000000001E-2</c:v>
                </c:pt>
                <c:pt idx="331">
                  <c:v>2.1000000000000001E-2</c:v>
                </c:pt>
                <c:pt idx="332">
                  <c:v>2.1066666666666664E-2</c:v>
                </c:pt>
                <c:pt idx="333">
                  <c:v>2.1066666666666664E-2</c:v>
                </c:pt>
                <c:pt idx="334">
                  <c:v>2.1066666666666664E-2</c:v>
                </c:pt>
                <c:pt idx="335">
                  <c:v>2.1133333333333334E-2</c:v>
                </c:pt>
                <c:pt idx="336">
                  <c:v>2.1199999999999997E-2</c:v>
                </c:pt>
                <c:pt idx="337">
                  <c:v>2.1233333333333337E-2</c:v>
                </c:pt>
                <c:pt idx="338">
                  <c:v>2.1266666666666666E-2</c:v>
                </c:pt>
                <c:pt idx="339">
                  <c:v>2.1333333333333333E-2</c:v>
                </c:pt>
                <c:pt idx="340">
                  <c:v>2.1333333333333333E-2</c:v>
                </c:pt>
                <c:pt idx="341">
                  <c:v>2.1366666666666669E-2</c:v>
                </c:pt>
                <c:pt idx="342">
                  <c:v>2.1400000000000002E-2</c:v>
                </c:pt>
                <c:pt idx="343">
                  <c:v>2.1433333333333332E-2</c:v>
                </c:pt>
                <c:pt idx="344">
                  <c:v>2.1500000000000002E-2</c:v>
                </c:pt>
                <c:pt idx="345">
                  <c:v>2.1500000000000002E-2</c:v>
                </c:pt>
                <c:pt idx="346">
                  <c:v>2.1633333333333334E-2</c:v>
                </c:pt>
                <c:pt idx="347">
                  <c:v>2.1633333333333334E-2</c:v>
                </c:pt>
                <c:pt idx="348">
                  <c:v>2.1699999999999997E-2</c:v>
                </c:pt>
                <c:pt idx="349">
                  <c:v>2.1699999999999997E-2</c:v>
                </c:pt>
                <c:pt idx="350">
                  <c:v>2.1766666666666667E-2</c:v>
                </c:pt>
                <c:pt idx="351">
                  <c:v>2.1833333333333333E-2</c:v>
                </c:pt>
                <c:pt idx="352">
                  <c:v>2.186666666666667E-2</c:v>
                </c:pt>
                <c:pt idx="353">
                  <c:v>2.1933333333333332E-2</c:v>
                </c:pt>
                <c:pt idx="354">
                  <c:v>2.1933333333333332E-2</c:v>
                </c:pt>
                <c:pt idx="355">
                  <c:v>2.2033333333333332E-2</c:v>
                </c:pt>
                <c:pt idx="356">
                  <c:v>2.2066666666666668E-2</c:v>
                </c:pt>
                <c:pt idx="357">
                  <c:v>2.2133333333333335E-2</c:v>
                </c:pt>
                <c:pt idx="358">
                  <c:v>2.2266666666666667E-2</c:v>
                </c:pt>
                <c:pt idx="359">
                  <c:v>2.23E-2</c:v>
                </c:pt>
                <c:pt idx="360">
                  <c:v>2.236666666666667E-2</c:v>
                </c:pt>
                <c:pt idx="361">
                  <c:v>2.2466666666666666E-2</c:v>
                </c:pt>
                <c:pt idx="362">
                  <c:v>2.2466666666666666E-2</c:v>
                </c:pt>
                <c:pt idx="363">
                  <c:v>2.2633333333333335E-2</c:v>
                </c:pt>
                <c:pt idx="364">
                  <c:v>2.2633333333333335E-2</c:v>
                </c:pt>
                <c:pt idx="365">
                  <c:v>2.2733333333333331E-2</c:v>
                </c:pt>
                <c:pt idx="366">
                  <c:v>2.2766666666666668E-2</c:v>
                </c:pt>
                <c:pt idx="367">
                  <c:v>2.2833333333333334E-2</c:v>
                </c:pt>
                <c:pt idx="368">
                  <c:v>2.29E-2</c:v>
                </c:pt>
                <c:pt idx="369">
                  <c:v>2.2966666666666663E-2</c:v>
                </c:pt>
                <c:pt idx="370">
                  <c:v>2.3099999999999999E-2</c:v>
                </c:pt>
                <c:pt idx="371">
                  <c:v>2.3266666666666668E-2</c:v>
                </c:pt>
                <c:pt idx="372">
                  <c:v>2.3333333333333334E-2</c:v>
                </c:pt>
                <c:pt idx="373">
                  <c:v>2.3433333333333334E-2</c:v>
                </c:pt>
                <c:pt idx="374">
                  <c:v>2.3499999999999997E-2</c:v>
                </c:pt>
                <c:pt idx="375">
                  <c:v>2.3533333333333333E-2</c:v>
                </c:pt>
                <c:pt idx="376">
                  <c:v>2.3633333333333336E-2</c:v>
                </c:pt>
                <c:pt idx="377">
                  <c:v>2.3766666666666669E-2</c:v>
                </c:pt>
                <c:pt idx="378">
                  <c:v>2.3833333333333335E-2</c:v>
                </c:pt>
                <c:pt idx="379">
                  <c:v>2.3866666666666665E-2</c:v>
                </c:pt>
                <c:pt idx="380">
                  <c:v>2.4033333333333334E-2</c:v>
                </c:pt>
                <c:pt idx="381">
                  <c:v>2.4066666666666667E-2</c:v>
                </c:pt>
                <c:pt idx="382">
                  <c:v>2.416666666666667E-2</c:v>
                </c:pt>
                <c:pt idx="383">
                  <c:v>2.416666666666667E-2</c:v>
                </c:pt>
                <c:pt idx="384">
                  <c:v>2.4299999999999999E-2</c:v>
                </c:pt>
                <c:pt idx="385">
                  <c:v>2.4366666666666665E-2</c:v>
                </c:pt>
                <c:pt idx="386">
                  <c:v>2.4399999999999995E-2</c:v>
                </c:pt>
                <c:pt idx="387">
                  <c:v>2.4533333333333334E-2</c:v>
                </c:pt>
                <c:pt idx="388">
                  <c:v>2.46E-2</c:v>
                </c:pt>
                <c:pt idx="389">
                  <c:v>2.466666666666667E-2</c:v>
                </c:pt>
                <c:pt idx="390">
                  <c:v>2.466666666666667E-2</c:v>
                </c:pt>
                <c:pt idx="391">
                  <c:v>2.4733333333333333E-2</c:v>
                </c:pt>
                <c:pt idx="392">
                  <c:v>2.4799999999999999E-2</c:v>
                </c:pt>
                <c:pt idx="393">
                  <c:v>2.4833333333333336E-2</c:v>
                </c:pt>
                <c:pt idx="394">
                  <c:v>2.4900000000000002E-2</c:v>
                </c:pt>
                <c:pt idx="395">
                  <c:v>2.4900000000000002E-2</c:v>
                </c:pt>
                <c:pt idx="396">
                  <c:v>2.4966666666666665E-2</c:v>
                </c:pt>
                <c:pt idx="397">
                  <c:v>2.4966666666666665E-2</c:v>
                </c:pt>
                <c:pt idx="398">
                  <c:v>2.4999999999999998E-2</c:v>
                </c:pt>
                <c:pt idx="399">
                  <c:v>2.4999999999999998E-2</c:v>
                </c:pt>
                <c:pt idx="400">
                  <c:v>2.4999999999999998E-2</c:v>
                </c:pt>
                <c:pt idx="401">
                  <c:v>2.4999999999999998E-2</c:v>
                </c:pt>
                <c:pt idx="402">
                  <c:v>2.5033333333333335E-2</c:v>
                </c:pt>
                <c:pt idx="403">
                  <c:v>2.4966666666666665E-2</c:v>
                </c:pt>
                <c:pt idx="404">
                  <c:v>2.4933333333333335E-2</c:v>
                </c:pt>
                <c:pt idx="405">
                  <c:v>2.4933333333333335E-2</c:v>
                </c:pt>
                <c:pt idx="406">
                  <c:v>2.4900000000000002E-2</c:v>
                </c:pt>
                <c:pt idx="407">
                  <c:v>2.4833333333333332E-2</c:v>
                </c:pt>
                <c:pt idx="408">
                  <c:v>2.4833333333333332E-2</c:v>
                </c:pt>
                <c:pt idx="409">
                  <c:v>2.4799999999999999E-2</c:v>
                </c:pt>
                <c:pt idx="410">
                  <c:v>2.4733333333333333E-2</c:v>
                </c:pt>
                <c:pt idx="411">
                  <c:v>2.4733333333333329E-2</c:v>
                </c:pt>
                <c:pt idx="412">
                  <c:v>2.463333333333333E-2</c:v>
                </c:pt>
                <c:pt idx="413">
                  <c:v>2.46E-2</c:v>
                </c:pt>
                <c:pt idx="414">
                  <c:v>2.4533333333333334E-2</c:v>
                </c:pt>
                <c:pt idx="415">
                  <c:v>2.4499999999999997E-2</c:v>
                </c:pt>
                <c:pt idx="416">
                  <c:v>2.4400000000000002E-2</c:v>
                </c:pt>
                <c:pt idx="417">
                  <c:v>2.4233333333333329E-2</c:v>
                </c:pt>
                <c:pt idx="418">
                  <c:v>2.4199999999999999E-2</c:v>
                </c:pt>
                <c:pt idx="419">
                  <c:v>2.413333333333333E-2</c:v>
                </c:pt>
                <c:pt idx="420">
                  <c:v>2.413333333333333E-2</c:v>
                </c:pt>
                <c:pt idx="421">
                  <c:v>2.4000000000000004E-2</c:v>
                </c:pt>
                <c:pt idx="422">
                  <c:v>2.3966666666666667E-2</c:v>
                </c:pt>
                <c:pt idx="423">
                  <c:v>2.3866666666666665E-2</c:v>
                </c:pt>
                <c:pt idx="424">
                  <c:v>2.3833333333333331E-2</c:v>
                </c:pt>
                <c:pt idx="425">
                  <c:v>2.3733333333333332E-2</c:v>
                </c:pt>
                <c:pt idx="426">
                  <c:v>2.3733333333333332E-2</c:v>
                </c:pt>
                <c:pt idx="427">
                  <c:v>2.3699999999999999E-2</c:v>
                </c:pt>
                <c:pt idx="428">
                  <c:v>2.3666666666666669E-2</c:v>
                </c:pt>
                <c:pt idx="429">
                  <c:v>2.3599999999999999E-2</c:v>
                </c:pt>
                <c:pt idx="430">
                  <c:v>2.3566666666666666E-2</c:v>
                </c:pt>
                <c:pt idx="431">
                  <c:v>2.3500000000000004E-2</c:v>
                </c:pt>
                <c:pt idx="432">
                  <c:v>2.3466666666666667E-2</c:v>
                </c:pt>
                <c:pt idx="433">
                  <c:v>2.3466666666666667E-2</c:v>
                </c:pt>
                <c:pt idx="434">
                  <c:v>2.3400000000000001E-2</c:v>
                </c:pt>
                <c:pt idx="435">
                  <c:v>2.3400000000000001E-2</c:v>
                </c:pt>
                <c:pt idx="436">
                  <c:v>2.3366666666666664E-2</c:v>
                </c:pt>
                <c:pt idx="437">
                  <c:v>2.3266666666666668E-2</c:v>
                </c:pt>
                <c:pt idx="438">
                  <c:v>2.3266666666666668E-2</c:v>
                </c:pt>
                <c:pt idx="439">
                  <c:v>2.3333333333333334E-2</c:v>
                </c:pt>
                <c:pt idx="440">
                  <c:v>2.3366666666666664E-2</c:v>
                </c:pt>
                <c:pt idx="441">
                  <c:v>2.3333333333333334E-2</c:v>
                </c:pt>
                <c:pt idx="442">
                  <c:v>2.3366666666666664E-2</c:v>
                </c:pt>
                <c:pt idx="443">
                  <c:v>2.3466666666666663E-2</c:v>
                </c:pt>
                <c:pt idx="444">
                  <c:v>2.3433333333333334E-2</c:v>
                </c:pt>
                <c:pt idx="445">
                  <c:v>2.3533333333333333E-2</c:v>
                </c:pt>
                <c:pt idx="446">
                  <c:v>2.3499999999999997E-2</c:v>
                </c:pt>
                <c:pt idx="447">
                  <c:v>2.3533333333333333E-2</c:v>
                </c:pt>
                <c:pt idx="448">
                  <c:v>2.3633333333333336E-2</c:v>
                </c:pt>
                <c:pt idx="449">
                  <c:v>2.3633333333333336E-2</c:v>
                </c:pt>
                <c:pt idx="450">
                  <c:v>2.3733333333333332E-2</c:v>
                </c:pt>
                <c:pt idx="451">
                  <c:v>2.3766666666666669E-2</c:v>
                </c:pt>
                <c:pt idx="452">
                  <c:v>2.3766666666666669E-2</c:v>
                </c:pt>
                <c:pt idx="453">
                  <c:v>2.3733333333333332E-2</c:v>
                </c:pt>
                <c:pt idx="454">
                  <c:v>2.3666666666666669E-2</c:v>
                </c:pt>
                <c:pt idx="455">
                  <c:v>2.3666666666666669E-2</c:v>
                </c:pt>
                <c:pt idx="456">
                  <c:v>2.3633333333333329E-2</c:v>
                </c:pt>
                <c:pt idx="457">
                  <c:v>2.3566666666666666E-2</c:v>
                </c:pt>
                <c:pt idx="458">
                  <c:v>2.3500000000000004E-2</c:v>
                </c:pt>
                <c:pt idx="459">
                  <c:v>2.3500000000000004E-2</c:v>
                </c:pt>
                <c:pt idx="460">
                  <c:v>2.3433333333333334E-2</c:v>
                </c:pt>
                <c:pt idx="461">
                  <c:v>2.3400000000000001E-2</c:v>
                </c:pt>
                <c:pt idx="462">
                  <c:v>2.3333333333333334E-2</c:v>
                </c:pt>
                <c:pt idx="463">
                  <c:v>2.3299999999999998E-2</c:v>
                </c:pt>
                <c:pt idx="464">
                  <c:v>2.3233333333333332E-2</c:v>
                </c:pt>
                <c:pt idx="465">
                  <c:v>2.3033333333333333E-2</c:v>
                </c:pt>
                <c:pt idx="466">
                  <c:v>2.2966666666666666E-2</c:v>
                </c:pt>
                <c:pt idx="467">
                  <c:v>2.2933333333333333E-2</c:v>
                </c:pt>
                <c:pt idx="468">
                  <c:v>2.2866666666666664E-2</c:v>
                </c:pt>
                <c:pt idx="469">
                  <c:v>2.2799999999999997E-2</c:v>
                </c:pt>
                <c:pt idx="470">
                  <c:v>2.2733333333333338E-2</c:v>
                </c:pt>
                <c:pt idx="471">
                  <c:v>2.2733333333333338E-2</c:v>
                </c:pt>
                <c:pt idx="472">
                  <c:v>2.2633333333333335E-2</c:v>
                </c:pt>
                <c:pt idx="473">
                  <c:v>2.2666666666666668E-2</c:v>
                </c:pt>
                <c:pt idx="474">
                  <c:v>2.2666666666666668E-2</c:v>
                </c:pt>
                <c:pt idx="475">
                  <c:v>2.2699999999999998E-2</c:v>
                </c:pt>
                <c:pt idx="476">
                  <c:v>2.2666666666666668E-2</c:v>
                </c:pt>
                <c:pt idx="477">
                  <c:v>2.2699999999999998E-2</c:v>
                </c:pt>
                <c:pt idx="478">
                  <c:v>2.2733333333333338E-2</c:v>
                </c:pt>
                <c:pt idx="479">
                  <c:v>2.2733333333333338E-2</c:v>
                </c:pt>
                <c:pt idx="480">
                  <c:v>2.2833333333333334E-2</c:v>
                </c:pt>
                <c:pt idx="481">
                  <c:v>2.2866666666666671E-2</c:v>
                </c:pt>
                <c:pt idx="482">
                  <c:v>2.2933333333333333E-2</c:v>
                </c:pt>
                <c:pt idx="483">
                  <c:v>2.3133333333333329E-2</c:v>
                </c:pt>
                <c:pt idx="484">
                  <c:v>2.3166666666666669E-2</c:v>
                </c:pt>
                <c:pt idx="485">
                  <c:v>2.3199999999999998E-2</c:v>
                </c:pt>
                <c:pt idx="486">
                  <c:v>2.3299999999999998E-2</c:v>
                </c:pt>
                <c:pt idx="487">
                  <c:v>2.3333333333333331E-2</c:v>
                </c:pt>
                <c:pt idx="488">
                  <c:v>2.3500000000000004E-2</c:v>
                </c:pt>
                <c:pt idx="489">
                  <c:v>2.3566666666666666E-2</c:v>
                </c:pt>
                <c:pt idx="490">
                  <c:v>2.3733333333333332E-2</c:v>
                </c:pt>
                <c:pt idx="491">
                  <c:v>2.3799999999999998E-2</c:v>
                </c:pt>
                <c:pt idx="492">
                  <c:v>2.3799999999999998E-2</c:v>
                </c:pt>
                <c:pt idx="493">
                  <c:v>2.3966666666666667E-2</c:v>
                </c:pt>
                <c:pt idx="494">
                  <c:v>2.4033333333333334E-2</c:v>
                </c:pt>
                <c:pt idx="495">
                  <c:v>2.4166666666666666E-2</c:v>
                </c:pt>
                <c:pt idx="496">
                  <c:v>2.4266666666666669E-2</c:v>
                </c:pt>
                <c:pt idx="497">
                  <c:v>2.4333333333333332E-2</c:v>
                </c:pt>
                <c:pt idx="498">
                  <c:v>2.4433333333333335E-2</c:v>
                </c:pt>
                <c:pt idx="499">
                  <c:v>2.4533333333333334E-2</c:v>
                </c:pt>
                <c:pt idx="500">
                  <c:v>2.4733333333333333E-2</c:v>
                </c:pt>
                <c:pt idx="501">
                  <c:v>2.4833333333333332E-2</c:v>
                </c:pt>
                <c:pt idx="502">
                  <c:v>2.4933333333333335E-2</c:v>
                </c:pt>
                <c:pt idx="503">
                  <c:v>2.5066666666666668E-2</c:v>
                </c:pt>
                <c:pt idx="504">
                  <c:v>2.513333333333333E-2</c:v>
                </c:pt>
                <c:pt idx="505">
                  <c:v>2.53E-2</c:v>
                </c:pt>
                <c:pt idx="506">
                  <c:v>2.5399999999999995E-2</c:v>
                </c:pt>
                <c:pt idx="507">
                  <c:v>2.5600000000000001E-2</c:v>
                </c:pt>
                <c:pt idx="508">
                  <c:v>2.5666666666666667E-2</c:v>
                </c:pt>
                <c:pt idx="509">
                  <c:v>2.5700000000000001E-2</c:v>
                </c:pt>
                <c:pt idx="510">
                  <c:v>2.5900000000000003E-2</c:v>
                </c:pt>
                <c:pt idx="511">
                  <c:v>2.5966666666666669E-2</c:v>
                </c:pt>
                <c:pt idx="512">
                  <c:v>2.6066666666666665E-2</c:v>
                </c:pt>
                <c:pt idx="513">
                  <c:v>2.6166666666666668E-2</c:v>
                </c:pt>
                <c:pt idx="514">
                  <c:v>2.63E-2</c:v>
                </c:pt>
                <c:pt idx="515">
                  <c:v>2.6399999999999996E-2</c:v>
                </c:pt>
                <c:pt idx="516">
                  <c:v>2.6499999999999996E-2</c:v>
                </c:pt>
                <c:pt idx="517">
                  <c:v>2.6533333333333336E-2</c:v>
                </c:pt>
                <c:pt idx="518">
                  <c:v>2.6599999999999999E-2</c:v>
                </c:pt>
                <c:pt idx="519">
                  <c:v>2.6633333333333332E-2</c:v>
                </c:pt>
                <c:pt idx="520">
                  <c:v>2.6633333333333332E-2</c:v>
                </c:pt>
                <c:pt idx="521">
                  <c:v>2.6700000000000002E-2</c:v>
                </c:pt>
                <c:pt idx="522">
                  <c:v>2.6766666666666671E-2</c:v>
                </c:pt>
                <c:pt idx="523">
                  <c:v>2.6766666666666671E-2</c:v>
                </c:pt>
                <c:pt idx="524">
                  <c:v>2.6800000000000001E-2</c:v>
                </c:pt>
                <c:pt idx="525">
                  <c:v>2.6833333333333334E-2</c:v>
                </c:pt>
                <c:pt idx="526">
                  <c:v>2.6899999999999997E-2</c:v>
                </c:pt>
                <c:pt idx="527">
                  <c:v>2.7033333333333329E-2</c:v>
                </c:pt>
                <c:pt idx="528">
                  <c:v>2.7099999999999999E-2</c:v>
                </c:pt>
                <c:pt idx="529">
                  <c:v>2.7200000000000002E-2</c:v>
                </c:pt>
                <c:pt idx="530">
                  <c:v>2.7200000000000002E-2</c:v>
                </c:pt>
                <c:pt idx="531">
                  <c:v>2.7266666666666672E-2</c:v>
                </c:pt>
                <c:pt idx="532">
                  <c:v>2.7266666666666672E-2</c:v>
                </c:pt>
                <c:pt idx="533">
                  <c:v>2.7333333333333334E-2</c:v>
                </c:pt>
                <c:pt idx="534">
                  <c:v>2.7366666666666668E-2</c:v>
                </c:pt>
                <c:pt idx="535">
                  <c:v>2.753333333333333E-2</c:v>
                </c:pt>
                <c:pt idx="536">
                  <c:v>2.7566666666666666E-2</c:v>
                </c:pt>
                <c:pt idx="537">
                  <c:v>2.7666666666666662E-2</c:v>
                </c:pt>
                <c:pt idx="538">
                  <c:v>2.7800000000000002E-2</c:v>
                </c:pt>
                <c:pt idx="539">
                  <c:v>2.7800000000000002E-2</c:v>
                </c:pt>
                <c:pt idx="540">
                  <c:v>2.7899999999999998E-2</c:v>
                </c:pt>
                <c:pt idx="541">
                  <c:v>2.7999999999999997E-2</c:v>
                </c:pt>
                <c:pt idx="542">
                  <c:v>2.8066666666666667E-2</c:v>
                </c:pt>
                <c:pt idx="543">
                  <c:v>2.81E-2</c:v>
                </c:pt>
                <c:pt idx="544">
                  <c:v>2.8133333333333333E-2</c:v>
                </c:pt>
                <c:pt idx="545">
                  <c:v>2.8266666666666673E-2</c:v>
                </c:pt>
                <c:pt idx="546">
                  <c:v>2.8366666666666669E-2</c:v>
                </c:pt>
                <c:pt idx="547">
                  <c:v>2.8499999999999998E-2</c:v>
                </c:pt>
                <c:pt idx="548">
                  <c:v>2.8566666666666667E-2</c:v>
                </c:pt>
                <c:pt idx="549">
                  <c:v>2.8633333333333334E-2</c:v>
                </c:pt>
                <c:pt idx="550">
                  <c:v>2.86E-2</c:v>
                </c:pt>
                <c:pt idx="551">
                  <c:v>2.8733333333333333E-2</c:v>
                </c:pt>
                <c:pt idx="552">
                  <c:v>2.8800000000000003E-2</c:v>
                </c:pt>
                <c:pt idx="553">
                  <c:v>2.8800000000000003E-2</c:v>
                </c:pt>
                <c:pt idx="554">
                  <c:v>2.8999999999999998E-2</c:v>
                </c:pt>
                <c:pt idx="555">
                  <c:v>2.8999999999999998E-2</c:v>
                </c:pt>
                <c:pt idx="556">
                  <c:v>2.9066666666666668E-2</c:v>
                </c:pt>
                <c:pt idx="557">
                  <c:v>2.9166666666666664E-2</c:v>
                </c:pt>
                <c:pt idx="558">
                  <c:v>2.92E-2</c:v>
                </c:pt>
                <c:pt idx="559">
                  <c:v>2.9300000000000003E-2</c:v>
                </c:pt>
                <c:pt idx="560">
                  <c:v>2.9366666666666669E-2</c:v>
                </c:pt>
                <c:pt idx="561">
                  <c:v>2.9399999999999999E-2</c:v>
                </c:pt>
                <c:pt idx="562">
                  <c:v>2.9466666666666669E-2</c:v>
                </c:pt>
                <c:pt idx="563">
                  <c:v>2.9466666666666669E-2</c:v>
                </c:pt>
                <c:pt idx="564">
                  <c:v>2.9633333333333334E-2</c:v>
                </c:pt>
                <c:pt idx="565">
                  <c:v>2.9666666666666664E-2</c:v>
                </c:pt>
                <c:pt idx="566">
                  <c:v>2.9700000000000001E-2</c:v>
                </c:pt>
                <c:pt idx="567">
                  <c:v>2.9766666666666667E-2</c:v>
                </c:pt>
                <c:pt idx="568">
                  <c:v>2.9833333333333333E-2</c:v>
                </c:pt>
                <c:pt idx="569">
                  <c:v>2.9899999999999999E-2</c:v>
                </c:pt>
                <c:pt idx="570">
                  <c:v>3.0033333333333332E-2</c:v>
                </c:pt>
                <c:pt idx="571">
                  <c:v>3.0066666666666669E-2</c:v>
                </c:pt>
                <c:pt idx="572">
                  <c:v>3.0099999999999998E-2</c:v>
                </c:pt>
                <c:pt idx="573">
                  <c:v>3.0133333333333335E-2</c:v>
                </c:pt>
                <c:pt idx="574">
                  <c:v>3.0233333333333334E-2</c:v>
                </c:pt>
                <c:pt idx="575">
                  <c:v>3.0266666666666664E-2</c:v>
                </c:pt>
                <c:pt idx="576">
                  <c:v>3.0333333333333334E-2</c:v>
                </c:pt>
                <c:pt idx="577">
                  <c:v>3.04E-2</c:v>
                </c:pt>
                <c:pt idx="578">
                  <c:v>3.043333333333333E-2</c:v>
                </c:pt>
                <c:pt idx="579">
                  <c:v>3.0499999999999999E-2</c:v>
                </c:pt>
                <c:pt idx="580">
                  <c:v>3.0566666666666669E-2</c:v>
                </c:pt>
                <c:pt idx="581">
                  <c:v>3.0499999999999999E-2</c:v>
                </c:pt>
                <c:pt idx="582">
                  <c:v>3.0499999999999999E-2</c:v>
                </c:pt>
                <c:pt idx="583">
                  <c:v>3.0466666666666666E-2</c:v>
                </c:pt>
                <c:pt idx="584">
                  <c:v>3.0499999999999999E-2</c:v>
                </c:pt>
                <c:pt idx="585">
                  <c:v>3.0666666666666665E-2</c:v>
                </c:pt>
                <c:pt idx="586">
                  <c:v>3.0766666666666664E-2</c:v>
                </c:pt>
                <c:pt idx="587">
                  <c:v>3.0833333333333334E-2</c:v>
                </c:pt>
                <c:pt idx="588">
                  <c:v>3.0833333333333334E-2</c:v>
                </c:pt>
                <c:pt idx="589">
                  <c:v>3.09E-2</c:v>
                </c:pt>
                <c:pt idx="590">
                  <c:v>3.1E-2</c:v>
                </c:pt>
                <c:pt idx="591">
                  <c:v>3.106666666666667E-2</c:v>
                </c:pt>
                <c:pt idx="592">
                  <c:v>3.1033333333333333E-2</c:v>
                </c:pt>
                <c:pt idx="593">
                  <c:v>3.1033333333333333E-2</c:v>
                </c:pt>
                <c:pt idx="594">
                  <c:v>3.1E-2</c:v>
                </c:pt>
                <c:pt idx="595">
                  <c:v>3.106666666666667E-2</c:v>
                </c:pt>
                <c:pt idx="596">
                  <c:v>3.1099999999999999E-2</c:v>
                </c:pt>
                <c:pt idx="597">
                  <c:v>3.1066666666666663E-2</c:v>
                </c:pt>
                <c:pt idx="598">
                  <c:v>3.1166666666666665E-2</c:v>
                </c:pt>
                <c:pt idx="599">
                  <c:v>3.1099999999999999E-2</c:v>
                </c:pt>
                <c:pt idx="600">
                  <c:v>3.1166666666666665E-2</c:v>
                </c:pt>
                <c:pt idx="601">
                  <c:v>3.1099999999999999E-2</c:v>
                </c:pt>
                <c:pt idx="602">
                  <c:v>3.1133333333333332E-2</c:v>
                </c:pt>
                <c:pt idx="603">
                  <c:v>3.1133333333333332E-2</c:v>
                </c:pt>
                <c:pt idx="604">
                  <c:v>3.1166666666666665E-2</c:v>
                </c:pt>
                <c:pt idx="605">
                  <c:v>3.1233333333333335E-2</c:v>
                </c:pt>
                <c:pt idx="606">
                  <c:v>3.1300000000000001E-2</c:v>
                </c:pt>
                <c:pt idx="607">
                  <c:v>3.1366666666666668E-2</c:v>
                </c:pt>
                <c:pt idx="608">
                  <c:v>3.1400000000000004E-2</c:v>
                </c:pt>
                <c:pt idx="609">
                  <c:v>3.1400000000000004E-2</c:v>
                </c:pt>
                <c:pt idx="610">
                  <c:v>3.1400000000000004E-2</c:v>
                </c:pt>
                <c:pt idx="611">
                  <c:v>3.1433333333333334E-2</c:v>
                </c:pt>
                <c:pt idx="612">
                  <c:v>3.1533333333333337E-2</c:v>
                </c:pt>
                <c:pt idx="613">
                  <c:v>3.15E-2</c:v>
                </c:pt>
                <c:pt idx="614">
                  <c:v>3.1466666666666664E-2</c:v>
                </c:pt>
                <c:pt idx="615">
                  <c:v>3.1466666666666664E-2</c:v>
                </c:pt>
                <c:pt idx="616">
                  <c:v>3.1366666666666668E-2</c:v>
                </c:pt>
                <c:pt idx="617">
                  <c:v>3.1433333333333334E-2</c:v>
                </c:pt>
                <c:pt idx="618">
                  <c:v>3.1566666666666666E-2</c:v>
                </c:pt>
                <c:pt idx="619">
                  <c:v>3.1599999999999996E-2</c:v>
                </c:pt>
                <c:pt idx="620">
                  <c:v>3.1666666666666669E-2</c:v>
                </c:pt>
                <c:pt idx="621">
                  <c:v>3.1666666666666669E-2</c:v>
                </c:pt>
                <c:pt idx="622">
                  <c:v>3.1699999999999999E-2</c:v>
                </c:pt>
                <c:pt idx="623">
                  <c:v>3.1699999999999999E-2</c:v>
                </c:pt>
                <c:pt idx="624">
                  <c:v>3.1699999999999999E-2</c:v>
                </c:pt>
                <c:pt idx="625">
                  <c:v>3.1699999999999999E-2</c:v>
                </c:pt>
                <c:pt idx="626">
                  <c:v>3.1733333333333336E-2</c:v>
                </c:pt>
                <c:pt idx="627">
                  <c:v>3.1766666666666665E-2</c:v>
                </c:pt>
                <c:pt idx="628">
                  <c:v>3.1833333333333332E-2</c:v>
                </c:pt>
                <c:pt idx="629">
                  <c:v>3.1899999999999998E-2</c:v>
                </c:pt>
                <c:pt idx="630">
                  <c:v>3.1900000000000005E-2</c:v>
                </c:pt>
                <c:pt idx="631">
                  <c:v>3.2066666666666667E-2</c:v>
                </c:pt>
                <c:pt idx="632">
                  <c:v>3.1933333333333334E-2</c:v>
                </c:pt>
                <c:pt idx="633">
                  <c:v>3.1933333333333334E-2</c:v>
                </c:pt>
                <c:pt idx="634">
                  <c:v>3.1966666666666664E-2</c:v>
                </c:pt>
                <c:pt idx="635">
                  <c:v>3.1933333333333334E-2</c:v>
                </c:pt>
                <c:pt idx="636">
                  <c:v>3.2066666666666667E-2</c:v>
                </c:pt>
                <c:pt idx="637">
                  <c:v>3.2099999999999997E-2</c:v>
                </c:pt>
                <c:pt idx="638">
                  <c:v>3.2266666666666666E-2</c:v>
                </c:pt>
                <c:pt idx="639">
                  <c:v>3.2333333333333332E-2</c:v>
                </c:pt>
                <c:pt idx="640">
                  <c:v>3.2366666666666662E-2</c:v>
                </c:pt>
                <c:pt idx="641">
                  <c:v>3.2299999999999995E-2</c:v>
                </c:pt>
                <c:pt idx="642">
                  <c:v>3.2366666666666662E-2</c:v>
                </c:pt>
                <c:pt idx="643">
                  <c:v>3.2399999999999998E-2</c:v>
                </c:pt>
                <c:pt idx="644">
                  <c:v>3.2433333333333335E-2</c:v>
                </c:pt>
                <c:pt idx="645">
                  <c:v>3.2533333333333331E-2</c:v>
                </c:pt>
                <c:pt idx="646">
                  <c:v>3.2599999999999997E-2</c:v>
                </c:pt>
                <c:pt idx="647">
                  <c:v>3.27E-2</c:v>
                </c:pt>
                <c:pt idx="648">
                  <c:v>3.266666666666667E-2</c:v>
                </c:pt>
                <c:pt idx="649">
                  <c:v>3.2800000000000003E-2</c:v>
                </c:pt>
                <c:pt idx="650">
                  <c:v>3.2766666666666666E-2</c:v>
                </c:pt>
                <c:pt idx="651">
                  <c:v>3.2800000000000003E-2</c:v>
                </c:pt>
                <c:pt idx="652">
                  <c:v>3.2899999999999999E-2</c:v>
                </c:pt>
                <c:pt idx="653">
                  <c:v>3.2900000000000006E-2</c:v>
                </c:pt>
                <c:pt idx="654">
                  <c:v>3.3033333333333338E-2</c:v>
                </c:pt>
                <c:pt idx="655">
                  <c:v>3.3099999999999997E-2</c:v>
                </c:pt>
                <c:pt idx="656">
                  <c:v>3.3166666666666671E-2</c:v>
                </c:pt>
                <c:pt idx="657">
                  <c:v>3.323333333333333E-2</c:v>
                </c:pt>
                <c:pt idx="658">
                  <c:v>3.3133333333333334E-2</c:v>
                </c:pt>
                <c:pt idx="659">
                  <c:v>3.323333333333333E-2</c:v>
                </c:pt>
                <c:pt idx="660">
                  <c:v>3.32E-2</c:v>
                </c:pt>
                <c:pt idx="661">
                  <c:v>3.3299999999999996E-2</c:v>
                </c:pt>
                <c:pt idx="662">
                  <c:v>3.3366666666666663E-2</c:v>
                </c:pt>
                <c:pt idx="663">
                  <c:v>3.3366666666666663E-2</c:v>
                </c:pt>
                <c:pt idx="664">
                  <c:v>3.3433333333333336E-2</c:v>
                </c:pt>
                <c:pt idx="665">
                  <c:v>3.3500000000000002E-2</c:v>
                </c:pt>
                <c:pt idx="666">
                  <c:v>3.3533333333333339E-2</c:v>
                </c:pt>
                <c:pt idx="667">
                  <c:v>3.3733333333333337E-2</c:v>
                </c:pt>
                <c:pt idx="668">
                  <c:v>3.3733333333333337E-2</c:v>
                </c:pt>
                <c:pt idx="669">
                  <c:v>3.3933333333333336E-2</c:v>
                </c:pt>
                <c:pt idx="670">
                  <c:v>3.4033333333333332E-2</c:v>
                </c:pt>
                <c:pt idx="671">
                  <c:v>3.3399999999999999E-2</c:v>
                </c:pt>
                <c:pt idx="672">
                  <c:v>3.2800000000000003E-2</c:v>
                </c:pt>
                <c:pt idx="673">
                  <c:v>3.2099999999999997E-2</c:v>
                </c:pt>
                <c:pt idx="674">
                  <c:v>3.153333333333333E-2</c:v>
                </c:pt>
                <c:pt idx="675">
                  <c:v>3.1599999999999996E-2</c:v>
                </c:pt>
                <c:pt idx="676">
                  <c:v>3.1666666666666669E-2</c:v>
                </c:pt>
                <c:pt idx="677">
                  <c:v>3.1699999999999999E-2</c:v>
                </c:pt>
                <c:pt idx="678">
                  <c:v>3.1666666666666669E-2</c:v>
                </c:pt>
                <c:pt idx="679">
                  <c:v>3.1766666666666665E-2</c:v>
                </c:pt>
                <c:pt idx="680">
                  <c:v>3.1800000000000002E-2</c:v>
                </c:pt>
                <c:pt idx="681">
                  <c:v>3.2066666666666667E-2</c:v>
                </c:pt>
                <c:pt idx="682">
                  <c:v>3.2266666666666666E-2</c:v>
                </c:pt>
                <c:pt idx="683">
                  <c:v>3.2300000000000002E-2</c:v>
                </c:pt>
                <c:pt idx="684">
                  <c:v>3.2466666666666665E-2</c:v>
                </c:pt>
                <c:pt idx="685">
                  <c:v>3.2366666666666662E-2</c:v>
                </c:pt>
                <c:pt idx="686">
                  <c:v>3.2366666666666662E-2</c:v>
                </c:pt>
                <c:pt idx="687">
                  <c:v>3.2566666666666667E-2</c:v>
                </c:pt>
                <c:pt idx="688">
                  <c:v>3.2433333333333335E-2</c:v>
                </c:pt>
                <c:pt idx="689">
                  <c:v>3.2500000000000001E-2</c:v>
                </c:pt>
                <c:pt idx="690">
                  <c:v>3.2533333333333331E-2</c:v>
                </c:pt>
                <c:pt idx="691">
                  <c:v>3.266666666666667E-2</c:v>
                </c:pt>
                <c:pt idx="692">
                  <c:v>3.2799999999999996E-2</c:v>
                </c:pt>
                <c:pt idx="693">
                  <c:v>3.2999999999999995E-2</c:v>
                </c:pt>
                <c:pt idx="694">
                  <c:v>3.3099999999999997E-2</c:v>
                </c:pt>
                <c:pt idx="695">
                  <c:v>3.32E-2</c:v>
                </c:pt>
                <c:pt idx="696">
                  <c:v>3.3366666666666663E-2</c:v>
                </c:pt>
                <c:pt idx="697">
                  <c:v>3.3433333333333336E-2</c:v>
                </c:pt>
                <c:pt idx="698">
                  <c:v>3.3499999999999995E-2</c:v>
                </c:pt>
                <c:pt idx="699">
                  <c:v>3.3499999999999995E-2</c:v>
                </c:pt>
                <c:pt idx="700">
                  <c:v>3.3533333333333332E-2</c:v>
                </c:pt>
                <c:pt idx="701">
                  <c:v>3.3633333333333335E-2</c:v>
                </c:pt>
                <c:pt idx="702">
                  <c:v>3.3700000000000001E-2</c:v>
                </c:pt>
                <c:pt idx="703">
                  <c:v>3.3766666666666667E-2</c:v>
                </c:pt>
                <c:pt idx="704">
                  <c:v>3.3800000000000004E-2</c:v>
                </c:pt>
                <c:pt idx="705">
                  <c:v>3.3799999999999997E-2</c:v>
                </c:pt>
                <c:pt idx="706">
                  <c:v>3.3933333333333336E-2</c:v>
                </c:pt>
                <c:pt idx="707">
                  <c:v>3.4000000000000002E-2</c:v>
                </c:pt>
                <c:pt idx="708">
                  <c:v>3.4233333333333331E-2</c:v>
                </c:pt>
                <c:pt idx="709">
                  <c:v>3.44E-2</c:v>
                </c:pt>
                <c:pt idx="710">
                  <c:v>3.4499999999999996E-2</c:v>
                </c:pt>
                <c:pt idx="711">
                  <c:v>3.4666666666666672E-2</c:v>
                </c:pt>
                <c:pt idx="712">
                  <c:v>3.4700000000000002E-2</c:v>
                </c:pt>
                <c:pt idx="713">
                  <c:v>3.4766666666666668E-2</c:v>
                </c:pt>
                <c:pt idx="714">
                  <c:v>3.4966666666666667E-2</c:v>
                </c:pt>
                <c:pt idx="715">
                  <c:v>3.4933333333333337E-2</c:v>
                </c:pt>
                <c:pt idx="716">
                  <c:v>3.5033333333333333E-2</c:v>
                </c:pt>
                <c:pt idx="717">
                  <c:v>3.5066666666666663E-2</c:v>
                </c:pt>
                <c:pt idx="718">
                  <c:v>3.5166666666666666E-2</c:v>
                </c:pt>
                <c:pt idx="719">
                  <c:v>3.5266666666666661E-2</c:v>
                </c:pt>
                <c:pt idx="720">
                  <c:v>3.5266666666666668E-2</c:v>
                </c:pt>
                <c:pt idx="721">
                  <c:v>3.5400000000000008E-2</c:v>
                </c:pt>
                <c:pt idx="722">
                  <c:v>3.5566666666666663E-2</c:v>
                </c:pt>
                <c:pt idx="723">
                  <c:v>3.5633333333333336E-2</c:v>
                </c:pt>
                <c:pt idx="724">
                  <c:v>3.5833333333333335E-2</c:v>
                </c:pt>
                <c:pt idx="725">
                  <c:v>3.5966666666666668E-2</c:v>
                </c:pt>
                <c:pt idx="726">
                  <c:v>3.6000000000000004E-2</c:v>
                </c:pt>
                <c:pt idx="727">
                  <c:v>3.6166666666666673E-2</c:v>
                </c:pt>
                <c:pt idx="728">
                  <c:v>3.6266666666666669E-2</c:v>
                </c:pt>
                <c:pt idx="729">
                  <c:v>3.6399999999999995E-2</c:v>
                </c:pt>
                <c:pt idx="730">
                  <c:v>3.6666666666666674E-2</c:v>
                </c:pt>
                <c:pt idx="731">
                  <c:v>3.6833333333333329E-2</c:v>
                </c:pt>
                <c:pt idx="732">
                  <c:v>3.6966666666666669E-2</c:v>
                </c:pt>
                <c:pt idx="733">
                  <c:v>3.7000000000000005E-2</c:v>
                </c:pt>
                <c:pt idx="734">
                  <c:v>3.7033333333333335E-2</c:v>
                </c:pt>
                <c:pt idx="735">
                  <c:v>3.7133333333333331E-2</c:v>
                </c:pt>
                <c:pt idx="736">
                  <c:v>3.7133333333333331E-2</c:v>
                </c:pt>
                <c:pt idx="737">
                  <c:v>3.7233333333333334E-2</c:v>
                </c:pt>
                <c:pt idx="738">
                  <c:v>3.7200000000000004E-2</c:v>
                </c:pt>
                <c:pt idx="739">
                  <c:v>3.7200000000000004E-2</c:v>
                </c:pt>
                <c:pt idx="740">
                  <c:v>3.7433333333333339E-2</c:v>
                </c:pt>
                <c:pt idx="741">
                  <c:v>3.7566666666666665E-2</c:v>
                </c:pt>
                <c:pt idx="742">
                  <c:v>3.7633333333333331E-2</c:v>
                </c:pt>
                <c:pt idx="743">
                  <c:v>3.78E-2</c:v>
                </c:pt>
                <c:pt idx="744">
                  <c:v>3.7833333333333337E-2</c:v>
                </c:pt>
                <c:pt idx="745">
                  <c:v>3.7933333333333333E-2</c:v>
                </c:pt>
                <c:pt idx="746">
                  <c:v>3.7966666666666669E-2</c:v>
                </c:pt>
                <c:pt idx="747">
                  <c:v>3.8100000000000002E-2</c:v>
                </c:pt>
                <c:pt idx="748">
                  <c:v>3.8233333333333334E-2</c:v>
                </c:pt>
                <c:pt idx="749">
                  <c:v>3.8266666666666664E-2</c:v>
                </c:pt>
                <c:pt idx="750">
                  <c:v>3.8433333333333326E-2</c:v>
                </c:pt>
                <c:pt idx="751">
                  <c:v>3.8533333333333329E-2</c:v>
                </c:pt>
                <c:pt idx="752">
                  <c:v>3.8399999999999997E-2</c:v>
                </c:pt>
                <c:pt idx="753">
                  <c:v>3.8599999999999995E-2</c:v>
                </c:pt>
                <c:pt idx="754">
                  <c:v>3.8700000000000005E-2</c:v>
                </c:pt>
                <c:pt idx="755">
                  <c:v>3.8666666666666662E-2</c:v>
                </c:pt>
                <c:pt idx="756">
                  <c:v>3.8700000000000005E-2</c:v>
                </c:pt>
                <c:pt idx="757">
                  <c:v>3.8666666666666669E-2</c:v>
                </c:pt>
                <c:pt idx="758">
                  <c:v>3.8633333333333332E-2</c:v>
                </c:pt>
                <c:pt idx="759">
                  <c:v>3.8933333333333334E-2</c:v>
                </c:pt>
                <c:pt idx="760">
                  <c:v>3.8899999999999997E-2</c:v>
                </c:pt>
                <c:pt idx="761">
                  <c:v>3.903333333333333E-2</c:v>
                </c:pt>
                <c:pt idx="762">
                  <c:v>3.9066666666666666E-2</c:v>
                </c:pt>
                <c:pt idx="763">
                  <c:v>3.9099999999999996E-2</c:v>
                </c:pt>
                <c:pt idx="764">
                  <c:v>3.9266666666666665E-2</c:v>
                </c:pt>
                <c:pt idx="765">
                  <c:v>3.9133333333333332E-2</c:v>
                </c:pt>
                <c:pt idx="766">
                  <c:v>3.9433333333333327E-2</c:v>
                </c:pt>
                <c:pt idx="767">
                  <c:v>3.9333333333333331E-2</c:v>
                </c:pt>
                <c:pt idx="768">
                  <c:v>3.9266666666666665E-2</c:v>
                </c:pt>
                <c:pt idx="769">
                  <c:v>3.9399999999999998E-2</c:v>
                </c:pt>
                <c:pt idx="770">
                  <c:v>3.9300000000000002E-2</c:v>
                </c:pt>
                <c:pt idx="771">
                  <c:v>3.9200000000000006E-2</c:v>
                </c:pt>
                <c:pt idx="772">
                  <c:v>3.9399999999999998E-2</c:v>
                </c:pt>
                <c:pt idx="773">
                  <c:v>3.9300000000000002E-2</c:v>
                </c:pt>
                <c:pt idx="774">
                  <c:v>3.9300000000000002E-2</c:v>
                </c:pt>
                <c:pt idx="775">
                  <c:v>3.9266666666666665E-2</c:v>
                </c:pt>
                <c:pt idx="776">
                  <c:v>3.9133333333333332E-2</c:v>
                </c:pt>
                <c:pt idx="777">
                  <c:v>3.9200000000000006E-2</c:v>
                </c:pt>
                <c:pt idx="778">
                  <c:v>3.9166666666666662E-2</c:v>
                </c:pt>
                <c:pt idx="779">
                  <c:v>3.9233333333333335E-2</c:v>
                </c:pt>
                <c:pt idx="780">
                  <c:v>3.9300000000000002E-2</c:v>
                </c:pt>
                <c:pt idx="781">
                  <c:v>3.9366666666666661E-2</c:v>
                </c:pt>
                <c:pt idx="782">
                  <c:v>3.9300000000000002E-2</c:v>
                </c:pt>
                <c:pt idx="783">
                  <c:v>3.9366666666666668E-2</c:v>
                </c:pt>
                <c:pt idx="784">
                  <c:v>3.9366666666666668E-2</c:v>
                </c:pt>
                <c:pt idx="785">
                  <c:v>3.95E-2</c:v>
                </c:pt>
                <c:pt idx="786">
                  <c:v>3.956666666666666E-2</c:v>
                </c:pt>
                <c:pt idx="787">
                  <c:v>3.9633333333333333E-2</c:v>
                </c:pt>
                <c:pt idx="788">
                  <c:v>3.9633333333333333E-2</c:v>
                </c:pt>
                <c:pt idx="789">
                  <c:v>3.9399999999999998E-2</c:v>
                </c:pt>
                <c:pt idx="790">
                  <c:v>3.9600000000000003E-2</c:v>
                </c:pt>
                <c:pt idx="791">
                  <c:v>3.95E-2</c:v>
                </c:pt>
                <c:pt idx="792">
                  <c:v>3.9466666666666671E-2</c:v>
                </c:pt>
                <c:pt idx="793">
                  <c:v>3.95E-2</c:v>
                </c:pt>
                <c:pt idx="794">
                  <c:v>3.9466666666666671E-2</c:v>
                </c:pt>
                <c:pt idx="795">
                  <c:v>3.9600000000000003E-2</c:v>
                </c:pt>
                <c:pt idx="796">
                  <c:v>3.9633333333333333E-2</c:v>
                </c:pt>
                <c:pt idx="797">
                  <c:v>3.9566666666666667E-2</c:v>
                </c:pt>
                <c:pt idx="798">
                  <c:v>3.953333333333333E-2</c:v>
                </c:pt>
                <c:pt idx="799">
                  <c:v>3.9333333333333331E-2</c:v>
                </c:pt>
                <c:pt idx="800">
                  <c:v>3.9366666666666668E-2</c:v>
                </c:pt>
                <c:pt idx="801">
                  <c:v>3.9433333333333327E-2</c:v>
                </c:pt>
                <c:pt idx="802">
                  <c:v>3.9633333333333333E-2</c:v>
                </c:pt>
                <c:pt idx="803">
                  <c:v>3.9766666666666665E-2</c:v>
                </c:pt>
                <c:pt idx="804">
                  <c:v>3.9899999999999998E-2</c:v>
                </c:pt>
                <c:pt idx="805">
                  <c:v>3.9833333333333332E-2</c:v>
                </c:pt>
                <c:pt idx="806">
                  <c:v>3.9600000000000003E-2</c:v>
                </c:pt>
                <c:pt idx="807">
                  <c:v>3.95E-2</c:v>
                </c:pt>
                <c:pt idx="808">
                  <c:v>3.9466666666666671E-2</c:v>
                </c:pt>
                <c:pt idx="809">
                  <c:v>3.9333333333333338E-2</c:v>
                </c:pt>
                <c:pt idx="810">
                  <c:v>3.95E-2</c:v>
                </c:pt>
                <c:pt idx="811">
                  <c:v>3.9433333333333334E-2</c:v>
                </c:pt>
                <c:pt idx="812">
                  <c:v>3.9699999999999999E-2</c:v>
                </c:pt>
                <c:pt idx="813">
                  <c:v>3.9866666666666668E-2</c:v>
                </c:pt>
                <c:pt idx="814">
                  <c:v>3.9799999999999995E-2</c:v>
                </c:pt>
                <c:pt idx="815">
                  <c:v>3.966666666666667E-2</c:v>
                </c:pt>
                <c:pt idx="816">
                  <c:v>3.9399999999999998E-2</c:v>
                </c:pt>
                <c:pt idx="817">
                  <c:v>3.9466666666666671E-2</c:v>
                </c:pt>
                <c:pt idx="818">
                  <c:v>3.9633333333333333E-2</c:v>
                </c:pt>
                <c:pt idx="819">
                  <c:v>3.9666666666666663E-2</c:v>
                </c:pt>
                <c:pt idx="820">
                  <c:v>3.9800000000000002E-2</c:v>
                </c:pt>
                <c:pt idx="821">
                  <c:v>3.9733333333333336E-2</c:v>
                </c:pt>
                <c:pt idx="822">
                  <c:v>3.9566666666666667E-2</c:v>
                </c:pt>
                <c:pt idx="823">
                  <c:v>3.9599999999999996E-2</c:v>
                </c:pt>
                <c:pt idx="824">
                  <c:v>3.9333333333333331E-2</c:v>
                </c:pt>
                <c:pt idx="825">
                  <c:v>3.9466666666666671E-2</c:v>
                </c:pt>
                <c:pt idx="826">
                  <c:v>3.9700000000000006E-2</c:v>
                </c:pt>
                <c:pt idx="827">
                  <c:v>3.966666666666667E-2</c:v>
                </c:pt>
                <c:pt idx="828">
                  <c:v>3.9666666666666663E-2</c:v>
                </c:pt>
                <c:pt idx="829">
                  <c:v>3.9399999999999998E-2</c:v>
                </c:pt>
                <c:pt idx="830">
                  <c:v>3.9533333333333337E-2</c:v>
                </c:pt>
                <c:pt idx="831">
                  <c:v>3.9333333333333331E-2</c:v>
                </c:pt>
                <c:pt idx="832">
                  <c:v>3.9666666666666663E-2</c:v>
                </c:pt>
                <c:pt idx="833">
                  <c:v>3.9766666666666672E-2</c:v>
                </c:pt>
                <c:pt idx="834">
                  <c:v>3.9466666666666664E-2</c:v>
                </c:pt>
                <c:pt idx="835">
                  <c:v>3.9733333333333336E-2</c:v>
                </c:pt>
                <c:pt idx="836">
                  <c:v>3.9766666666666665E-2</c:v>
                </c:pt>
                <c:pt idx="837">
                  <c:v>3.9833333333333339E-2</c:v>
                </c:pt>
                <c:pt idx="838">
                  <c:v>4.0133333333333333E-2</c:v>
                </c:pt>
                <c:pt idx="839">
                  <c:v>4.0166666666666663E-2</c:v>
                </c:pt>
                <c:pt idx="840">
                  <c:v>3.9866666666666668E-2</c:v>
                </c:pt>
                <c:pt idx="841">
                  <c:v>4.0066666666666667E-2</c:v>
                </c:pt>
                <c:pt idx="842">
                  <c:v>4.0066666666666667E-2</c:v>
                </c:pt>
                <c:pt idx="843">
                  <c:v>4.0300000000000002E-2</c:v>
                </c:pt>
                <c:pt idx="844">
                  <c:v>4.0299999999999996E-2</c:v>
                </c:pt>
                <c:pt idx="845">
                  <c:v>4.02E-2</c:v>
                </c:pt>
                <c:pt idx="846">
                  <c:v>4.0299999999999996E-2</c:v>
                </c:pt>
                <c:pt idx="847">
                  <c:v>0.04</c:v>
                </c:pt>
                <c:pt idx="848">
                  <c:v>0.04</c:v>
                </c:pt>
                <c:pt idx="849">
                  <c:v>4.0233333333333336E-2</c:v>
                </c:pt>
                <c:pt idx="850">
                  <c:v>3.9966666666666671E-2</c:v>
                </c:pt>
                <c:pt idx="851">
                  <c:v>4.0033333333333337E-2</c:v>
                </c:pt>
                <c:pt idx="852">
                  <c:v>0.04</c:v>
                </c:pt>
                <c:pt idx="853">
                  <c:v>3.9899999999999998E-2</c:v>
                </c:pt>
                <c:pt idx="854">
                  <c:v>3.9899999999999998E-2</c:v>
                </c:pt>
                <c:pt idx="855">
                  <c:v>3.9899999999999998E-2</c:v>
                </c:pt>
                <c:pt idx="856">
                  <c:v>4.0233333333333336E-2</c:v>
                </c:pt>
                <c:pt idx="857">
                  <c:v>4.0066666666666667E-2</c:v>
                </c:pt>
                <c:pt idx="858">
                  <c:v>4.0300000000000002E-2</c:v>
                </c:pt>
                <c:pt idx="859">
                  <c:v>4.0466666666666665E-2</c:v>
                </c:pt>
                <c:pt idx="860">
                  <c:v>4.0466666666666672E-2</c:v>
                </c:pt>
                <c:pt idx="861">
                  <c:v>4.0966666666666665E-2</c:v>
                </c:pt>
                <c:pt idx="862">
                  <c:v>4.0833333333333333E-2</c:v>
                </c:pt>
                <c:pt idx="863">
                  <c:v>4.0899999999999999E-2</c:v>
                </c:pt>
                <c:pt idx="864">
                  <c:v>4.0733333333333337E-2</c:v>
                </c:pt>
                <c:pt idx="865">
                  <c:v>4.0433333333333328E-2</c:v>
                </c:pt>
                <c:pt idx="866">
                  <c:v>4.0866666666666669E-2</c:v>
                </c:pt>
                <c:pt idx="867">
                  <c:v>4.0833333333333333E-2</c:v>
                </c:pt>
                <c:pt idx="868">
                  <c:v>4.1099999999999998E-2</c:v>
                </c:pt>
                <c:pt idx="869">
                  <c:v>4.1533333333333332E-2</c:v>
                </c:pt>
                <c:pt idx="870">
                  <c:v>4.1500000000000002E-2</c:v>
                </c:pt>
                <c:pt idx="871">
                  <c:v>4.1666666666666664E-2</c:v>
                </c:pt>
                <c:pt idx="872">
                  <c:v>4.1099999999999998E-2</c:v>
                </c:pt>
                <c:pt idx="873">
                  <c:v>4.0933333333333329E-2</c:v>
                </c:pt>
                <c:pt idx="874">
                  <c:v>4.1299999999999996E-2</c:v>
                </c:pt>
                <c:pt idx="875">
                  <c:v>4.1399999999999999E-2</c:v>
                </c:pt>
                <c:pt idx="876">
                  <c:v>4.2133333333333335E-2</c:v>
                </c:pt>
                <c:pt idx="877">
                  <c:v>4.2033333333333332E-2</c:v>
                </c:pt>
                <c:pt idx="878">
                  <c:v>4.1699999999999994E-2</c:v>
                </c:pt>
                <c:pt idx="879">
                  <c:v>4.2066666666666669E-2</c:v>
                </c:pt>
                <c:pt idx="880">
                  <c:v>4.1866666666666663E-2</c:v>
                </c:pt>
                <c:pt idx="881">
                  <c:v>4.2166666666666665E-2</c:v>
                </c:pt>
                <c:pt idx="882">
                  <c:v>4.2000000000000003E-2</c:v>
                </c:pt>
                <c:pt idx="883">
                  <c:v>4.136666666666667E-2</c:v>
                </c:pt>
                <c:pt idx="884">
                  <c:v>4.1800000000000004E-2</c:v>
                </c:pt>
                <c:pt idx="885">
                  <c:v>4.1633333333333335E-2</c:v>
                </c:pt>
                <c:pt idx="886">
                  <c:v>4.1966666666666673E-2</c:v>
                </c:pt>
                <c:pt idx="887">
                  <c:v>4.24E-2</c:v>
                </c:pt>
                <c:pt idx="888">
                  <c:v>4.2133333333333335E-2</c:v>
                </c:pt>
                <c:pt idx="889">
                  <c:v>4.1966666666666659E-2</c:v>
                </c:pt>
                <c:pt idx="890">
                  <c:v>4.1966666666666673E-2</c:v>
                </c:pt>
                <c:pt idx="891">
                  <c:v>4.2033333333333332E-2</c:v>
                </c:pt>
                <c:pt idx="892">
                  <c:v>4.2133333333333335E-2</c:v>
                </c:pt>
                <c:pt idx="893">
                  <c:v>4.2633333333333336E-2</c:v>
                </c:pt>
                <c:pt idx="894">
                  <c:v>4.2733333333333338E-2</c:v>
                </c:pt>
                <c:pt idx="895">
                  <c:v>4.2733333333333338E-2</c:v>
                </c:pt>
                <c:pt idx="896">
                  <c:v>4.2666666666666665E-2</c:v>
                </c:pt>
                <c:pt idx="897">
                  <c:v>4.2799999999999998E-2</c:v>
                </c:pt>
                <c:pt idx="898">
                  <c:v>4.2766666666666654E-2</c:v>
                </c:pt>
                <c:pt idx="899">
                  <c:v>4.2800000000000005E-2</c:v>
                </c:pt>
                <c:pt idx="900">
                  <c:v>4.3033333333333333E-2</c:v>
                </c:pt>
                <c:pt idx="901">
                  <c:v>4.3166666666666666E-2</c:v>
                </c:pt>
                <c:pt idx="902">
                  <c:v>4.293333333333333E-2</c:v>
                </c:pt>
                <c:pt idx="903">
                  <c:v>4.3166666666666666E-2</c:v>
                </c:pt>
                <c:pt idx="904">
                  <c:v>4.3033333333333333E-2</c:v>
                </c:pt>
                <c:pt idx="905">
                  <c:v>4.3333333333333335E-2</c:v>
                </c:pt>
                <c:pt idx="906">
                  <c:v>4.4066666666666664E-2</c:v>
                </c:pt>
                <c:pt idx="907">
                  <c:v>4.3966666666666661E-2</c:v>
                </c:pt>
                <c:pt idx="908">
                  <c:v>4.4633333333333337E-2</c:v>
                </c:pt>
                <c:pt idx="909">
                  <c:v>4.4433333333333332E-2</c:v>
                </c:pt>
                <c:pt idx="910">
                  <c:v>4.4199999999999996E-2</c:v>
                </c:pt>
                <c:pt idx="911">
                  <c:v>4.423333333333334E-2</c:v>
                </c:pt>
                <c:pt idx="912">
                  <c:v>4.3966666666666675E-2</c:v>
                </c:pt>
                <c:pt idx="913">
                  <c:v>4.4166666666666667E-2</c:v>
                </c:pt>
                <c:pt idx="914">
                  <c:v>4.4300000000000006E-2</c:v>
                </c:pt>
                <c:pt idx="915">
                  <c:v>4.4500000000000005E-2</c:v>
                </c:pt>
                <c:pt idx="916">
                  <c:v>4.4699999999999997E-2</c:v>
                </c:pt>
                <c:pt idx="917">
                  <c:v>4.4733333333333326E-2</c:v>
                </c:pt>
                <c:pt idx="918">
                  <c:v>4.463333333333333E-2</c:v>
                </c:pt>
                <c:pt idx="919">
                  <c:v>4.4933333333333332E-2</c:v>
                </c:pt>
                <c:pt idx="920">
                  <c:v>4.5133333333333331E-2</c:v>
                </c:pt>
                <c:pt idx="921">
                  <c:v>4.5399999999999996E-2</c:v>
                </c:pt>
                <c:pt idx="922">
                  <c:v>4.6100000000000002E-2</c:v>
                </c:pt>
                <c:pt idx="923">
                  <c:v>4.58E-2</c:v>
                </c:pt>
                <c:pt idx="924">
                  <c:v>4.6133333333333332E-2</c:v>
                </c:pt>
                <c:pt idx="925">
                  <c:v>4.6233333333333328E-2</c:v>
                </c:pt>
                <c:pt idx="926">
                  <c:v>4.6000000000000006E-2</c:v>
                </c:pt>
                <c:pt idx="927">
                  <c:v>4.7766666666666659E-2</c:v>
                </c:pt>
                <c:pt idx="928">
                  <c:v>4.8799999999999989E-2</c:v>
                </c:pt>
                <c:pt idx="929">
                  <c:v>5.0333333333333334E-2</c:v>
                </c:pt>
                <c:pt idx="930">
                  <c:v>5.1833333333333335E-2</c:v>
                </c:pt>
                <c:pt idx="931">
                  <c:v>5.1966666666666661E-2</c:v>
                </c:pt>
                <c:pt idx="932">
                  <c:v>5.2366666666666672E-2</c:v>
                </c:pt>
                <c:pt idx="933">
                  <c:v>5.2299999999999992E-2</c:v>
                </c:pt>
                <c:pt idx="934">
                  <c:v>5.2200000000000003E-2</c:v>
                </c:pt>
                <c:pt idx="935">
                  <c:v>5.2166666666666667E-2</c:v>
                </c:pt>
                <c:pt idx="936">
                  <c:v>5.2200000000000003E-2</c:v>
                </c:pt>
                <c:pt idx="937">
                  <c:v>5.213333333333333E-2</c:v>
                </c:pt>
                <c:pt idx="938">
                  <c:v>5.2466666666666661E-2</c:v>
                </c:pt>
                <c:pt idx="939">
                  <c:v>5.2466666666666661E-2</c:v>
                </c:pt>
                <c:pt idx="940">
                  <c:v>5.2700000000000004E-2</c:v>
                </c:pt>
                <c:pt idx="941">
                  <c:v>5.2966666666666669E-2</c:v>
                </c:pt>
                <c:pt idx="942">
                  <c:v>5.3033333333333328E-2</c:v>
                </c:pt>
                <c:pt idx="943">
                  <c:v>5.3433333333333333E-2</c:v>
                </c:pt>
                <c:pt idx="944">
                  <c:v>5.3233333333333334E-2</c:v>
                </c:pt>
                <c:pt idx="945">
                  <c:v>5.3766666666666664E-2</c:v>
                </c:pt>
                <c:pt idx="946">
                  <c:v>5.3566666666666672E-2</c:v>
                </c:pt>
                <c:pt idx="947">
                  <c:v>5.3833333333333323E-2</c:v>
                </c:pt>
                <c:pt idx="948">
                  <c:v>5.4100000000000002E-2</c:v>
                </c:pt>
                <c:pt idx="949">
                  <c:v>5.4266666666666664E-2</c:v>
                </c:pt>
                <c:pt idx="950">
                  <c:v>5.4566666666666673E-2</c:v>
                </c:pt>
                <c:pt idx="951">
                  <c:v>5.2933333333333332E-2</c:v>
                </c:pt>
                <c:pt idx="952">
                  <c:v>5.1299999999999991E-2</c:v>
                </c:pt>
                <c:pt idx="953">
                  <c:v>4.986666666666667E-2</c:v>
                </c:pt>
                <c:pt idx="954">
                  <c:v>4.8133333333333334E-2</c:v>
                </c:pt>
                <c:pt idx="955">
                  <c:v>4.7233333333333329E-2</c:v>
                </c:pt>
                <c:pt idx="956">
                  <c:v>4.8300000000000003E-2</c:v>
                </c:pt>
                <c:pt idx="957">
                  <c:v>4.8066666666666667E-2</c:v>
                </c:pt>
                <c:pt idx="958">
                  <c:v>4.8333333333333339E-2</c:v>
                </c:pt>
                <c:pt idx="959">
                  <c:v>4.9933333333333337E-2</c:v>
                </c:pt>
                <c:pt idx="960">
                  <c:v>4.8933333333333336E-2</c:v>
                </c:pt>
                <c:pt idx="961">
                  <c:v>4.9700000000000001E-2</c:v>
                </c:pt>
                <c:pt idx="962">
                  <c:v>5.103333333333334E-2</c:v>
                </c:pt>
                <c:pt idx="963">
                  <c:v>4.993333333333333E-2</c:v>
                </c:pt>
                <c:pt idx="964">
                  <c:v>5.0300000000000004E-2</c:v>
                </c:pt>
                <c:pt idx="965">
                  <c:v>5.0999999999999997E-2</c:v>
                </c:pt>
                <c:pt idx="966">
                  <c:v>4.9399999999999999E-2</c:v>
                </c:pt>
                <c:pt idx="967">
                  <c:v>5.0666666666666665E-2</c:v>
                </c:pt>
                <c:pt idx="968">
                  <c:v>5.0700000000000002E-2</c:v>
                </c:pt>
                <c:pt idx="969">
                  <c:v>4.933333333333334E-2</c:v>
                </c:pt>
                <c:pt idx="970">
                  <c:v>5.0800000000000005E-2</c:v>
                </c:pt>
                <c:pt idx="971">
                  <c:v>5.0200000000000002E-2</c:v>
                </c:pt>
                <c:pt idx="972">
                  <c:v>5.0166666666666665E-2</c:v>
                </c:pt>
                <c:pt idx="973">
                  <c:v>5.0366666666666671E-2</c:v>
                </c:pt>
                <c:pt idx="974">
                  <c:v>5.0066666666666669E-2</c:v>
                </c:pt>
                <c:pt idx="975">
                  <c:v>5.1466666666666668E-2</c:v>
                </c:pt>
                <c:pt idx="976">
                  <c:v>5.156666666666667E-2</c:v>
                </c:pt>
                <c:pt idx="977">
                  <c:v>5.1999999999999998E-2</c:v>
                </c:pt>
                <c:pt idx="978">
                  <c:v>5.1666666666666666E-2</c:v>
                </c:pt>
                <c:pt idx="979">
                  <c:v>5.16E-2</c:v>
                </c:pt>
                <c:pt idx="980">
                  <c:v>5.2766666666666663E-2</c:v>
                </c:pt>
                <c:pt idx="981">
                  <c:v>5.3666666666666668E-2</c:v>
                </c:pt>
                <c:pt idx="982">
                  <c:v>5.4166666666666669E-2</c:v>
                </c:pt>
                <c:pt idx="983">
                  <c:v>5.4100000000000002E-2</c:v>
                </c:pt>
                <c:pt idx="984">
                  <c:v>5.3733333333333334E-2</c:v>
                </c:pt>
                <c:pt idx="985">
                  <c:v>5.3966666666666663E-2</c:v>
                </c:pt>
                <c:pt idx="986">
                  <c:v>5.3466666666666669E-2</c:v>
                </c:pt>
                <c:pt idx="987">
                  <c:v>5.3499999999999999E-2</c:v>
                </c:pt>
                <c:pt idx="988">
                  <c:v>5.4033333333333329E-2</c:v>
                </c:pt>
                <c:pt idx="989">
                  <c:v>5.4100000000000002E-2</c:v>
                </c:pt>
                <c:pt idx="990">
                  <c:v>5.4833333333333324E-2</c:v>
                </c:pt>
                <c:pt idx="991">
                  <c:v>5.4966666666666664E-2</c:v>
                </c:pt>
                <c:pt idx="992">
                  <c:v>5.4566666666666673E-2</c:v>
                </c:pt>
                <c:pt idx="993">
                  <c:v>5.4533333333333329E-2</c:v>
                </c:pt>
                <c:pt idx="994">
                  <c:v>5.4633333333333332E-2</c:v>
                </c:pt>
                <c:pt idx="995">
                  <c:v>5.553333333333333E-2</c:v>
                </c:pt>
                <c:pt idx="996">
                  <c:v>5.5066666666666673E-2</c:v>
                </c:pt>
                <c:pt idx="997">
                  <c:v>5.5100000000000003E-2</c:v>
                </c:pt>
                <c:pt idx="998">
                  <c:v>5.6333333333333326E-2</c:v>
                </c:pt>
                <c:pt idx="999">
                  <c:v>5.6166666666666663E-2</c:v>
                </c:pt>
                <c:pt idx="1000">
                  <c:v>5.7799999999999997E-2</c:v>
                </c:pt>
                <c:pt idx="1001">
                  <c:v>5.7299999999999997E-2</c:v>
                </c:pt>
                <c:pt idx="1002">
                  <c:v>5.6299999999999996E-2</c:v>
                </c:pt>
                <c:pt idx="1003">
                  <c:v>5.6366666666666669E-2</c:v>
                </c:pt>
                <c:pt idx="1004">
                  <c:v>5.6233333333333337E-2</c:v>
                </c:pt>
                <c:pt idx="1005">
                  <c:v>5.7466666666666666E-2</c:v>
                </c:pt>
                <c:pt idx="1006">
                  <c:v>5.7766666666666668E-2</c:v>
                </c:pt>
                <c:pt idx="1007">
                  <c:v>5.7100000000000005E-2</c:v>
                </c:pt>
                <c:pt idx="1008">
                  <c:v>5.6499999999999995E-2</c:v>
                </c:pt>
                <c:pt idx="1009">
                  <c:v>5.5866666666666669E-2</c:v>
                </c:pt>
                <c:pt idx="1010">
                  <c:v>5.6633333333333334E-2</c:v>
                </c:pt>
                <c:pt idx="1011">
                  <c:v>5.7166666666666664E-2</c:v>
                </c:pt>
                <c:pt idx="1012">
                  <c:v>5.7700000000000001E-2</c:v>
                </c:pt>
                <c:pt idx="1013">
                  <c:v>5.7999999999999996E-2</c:v>
                </c:pt>
                <c:pt idx="1014">
                  <c:v>5.7766666666666668E-2</c:v>
                </c:pt>
                <c:pt idx="1015">
                  <c:v>5.8266666666666668E-2</c:v>
                </c:pt>
                <c:pt idx="1016">
                  <c:v>5.8266666666666668E-2</c:v>
                </c:pt>
                <c:pt idx="1017">
                  <c:v>5.8499999999999996E-2</c:v>
                </c:pt>
                <c:pt idx="1018">
                  <c:v>5.8833333333333328E-2</c:v>
                </c:pt>
                <c:pt idx="1019">
                  <c:v>5.9299999999999999E-2</c:v>
                </c:pt>
                <c:pt idx="1020">
                  <c:v>6.0299999999999999E-2</c:v>
                </c:pt>
                <c:pt idx="1021">
                  <c:v>6.0533333333333335E-2</c:v>
                </c:pt>
                <c:pt idx="1022">
                  <c:v>6.0233333333333333E-2</c:v>
                </c:pt>
                <c:pt idx="1023">
                  <c:v>6.0633333333333338E-2</c:v>
                </c:pt>
                <c:pt idx="1024">
                  <c:v>6.0366666666666659E-2</c:v>
                </c:pt>
                <c:pt idx="1025">
                  <c:v>6.0666666666666667E-2</c:v>
                </c:pt>
                <c:pt idx="1026">
                  <c:v>6.1433333333333333E-2</c:v>
                </c:pt>
                <c:pt idx="1027">
                  <c:v>6.1366666666666674E-2</c:v>
                </c:pt>
                <c:pt idx="1028">
                  <c:v>6.186666666666666E-2</c:v>
                </c:pt>
                <c:pt idx="1029">
                  <c:v>6.2300000000000001E-2</c:v>
                </c:pt>
                <c:pt idx="1030">
                  <c:v>6.2300000000000001E-2</c:v>
                </c:pt>
                <c:pt idx="1031">
                  <c:v>6.2099999999999995E-2</c:v>
                </c:pt>
                <c:pt idx="1032">
                  <c:v>6.2E-2</c:v>
                </c:pt>
                <c:pt idx="1033">
                  <c:v>6.2166666666666669E-2</c:v>
                </c:pt>
                <c:pt idx="1034">
                  <c:v>6.2166666666666669E-2</c:v>
                </c:pt>
                <c:pt idx="1035">
                  <c:v>6.2600000000000003E-2</c:v>
                </c:pt>
                <c:pt idx="1036">
                  <c:v>6.3433333333333328E-2</c:v>
                </c:pt>
                <c:pt idx="1037">
                  <c:v>6.3966666666666672E-2</c:v>
                </c:pt>
                <c:pt idx="1038">
                  <c:v>6.4166666666666664E-2</c:v>
                </c:pt>
                <c:pt idx="1039">
                  <c:v>6.536666666666667E-2</c:v>
                </c:pt>
                <c:pt idx="1040">
                  <c:v>6.5566666666666662E-2</c:v>
                </c:pt>
                <c:pt idx="1041">
                  <c:v>6.5199999999999994E-2</c:v>
                </c:pt>
                <c:pt idx="1042">
                  <c:v>6.5833333333333341E-2</c:v>
                </c:pt>
                <c:pt idx="1043">
                  <c:v>6.5199999999999994E-2</c:v>
                </c:pt>
                <c:pt idx="1044">
                  <c:v>6.5699999999999995E-2</c:v>
                </c:pt>
                <c:pt idx="1045">
                  <c:v>6.6133333333333336E-2</c:v>
                </c:pt>
                <c:pt idx="1046">
                  <c:v>6.6333333333333341E-2</c:v>
                </c:pt>
                <c:pt idx="1047">
                  <c:v>6.6866666666666671E-2</c:v>
                </c:pt>
                <c:pt idx="1048">
                  <c:v>6.7233333333333326E-2</c:v>
                </c:pt>
                <c:pt idx="1049">
                  <c:v>6.7433333333333331E-2</c:v>
                </c:pt>
                <c:pt idx="1050">
                  <c:v>6.7900000000000002E-2</c:v>
                </c:pt>
                <c:pt idx="1051">
                  <c:v>6.6800000000000012E-2</c:v>
                </c:pt>
                <c:pt idx="1052">
                  <c:v>6.6733333333333325E-2</c:v>
                </c:pt>
                <c:pt idx="1053">
                  <c:v>6.7366666666666672E-2</c:v>
                </c:pt>
                <c:pt idx="1054">
                  <c:v>6.7500000000000004E-2</c:v>
                </c:pt>
                <c:pt idx="1055">
                  <c:v>6.8266666666666656E-2</c:v>
                </c:pt>
                <c:pt idx="1056">
                  <c:v>6.8500000000000005E-2</c:v>
                </c:pt>
                <c:pt idx="1057">
                  <c:v>6.8566666666666665E-2</c:v>
                </c:pt>
                <c:pt idx="1058">
                  <c:v>6.9199999999999998E-2</c:v>
                </c:pt>
                <c:pt idx="1059">
                  <c:v>7.0033333333333336E-2</c:v>
                </c:pt>
                <c:pt idx="1060">
                  <c:v>6.9833333333333331E-2</c:v>
                </c:pt>
                <c:pt idx="1061">
                  <c:v>6.9733333333333328E-2</c:v>
                </c:pt>
                <c:pt idx="1062">
                  <c:v>6.9166666666666668E-2</c:v>
                </c:pt>
                <c:pt idx="1063">
                  <c:v>6.9633333333333339E-2</c:v>
                </c:pt>
                <c:pt idx="1064">
                  <c:v>6.9966666666666663E-2</c:v>
                </c:pt>
                <c:pt idx="1065">
                  <c:v>7.0099999999999996E-2</c:v>
                </c:pt>
                <c:pt idx="1066">
                  <c:v>7.0999999999999994E-2</c:v>
                </c:pt>
                <c:pt idx="1067">
                  <c:v>7.1300000000000002E-2</c:v>
                </c:pt>
                <c:pt idx="1068">
                  <c:v>7.1333333333333346E-2</c:v>
                </c:pt>
                <c:pt idx="1069">
                  <c:v>7.1266666666666673E-2</c:v>
                </c:pt>
                <c:pt idx="1070">
                  <c:v>7.1066666666666667E-2</c:v>
                </c:pt>
                <c:pt idx="1071">
                  <c:v>7.0766666666666658E-2</c:v>
                </c:pt>
                <c:pt idx="1072">
                  <c:v>7.0966666666666664E-2</c:v>
                </c:pt>
                <c:pt idx="1073">
                  <c:v>7.1433333333333335E-2</c:v>
                </c:pt>
                <c:pt idx="1074">
                  <c:v>7.166666666666667E-2</c:v>
                </c:pt>
                <c:pt idx="1075">
                  <c:v>7.2066666666666668E-2</c:v>
                </c:pt>
                <c:pt idx="1076">
                  <c:v>7.3499999999999996E-2</c:v>
                </c:pt>
                <c:pt idx="1077">
                  <c:v>7.4099999999999999E-2</c:v>
                </c:pt>
                <c:pt idx="1078">
                  <c:v>7.5233333333333333E-2</c:v>
                </c:pt>
                <c:pt idx="1079">
                  <c:v>7.5533333333333327E-2</c:v>
                </c:pt>
                <c:pt idx="1080">
                  <c:v>7.453333333333334E-2</c:v>
                </c:pt>
                <c:pt idx="1081">
                  <c:v>7.5833333333333336E-2</c:v>
                </c:pt>
                <c:pt idx="1082">
                  <c:v>7.5333333333333335E-2</c:v>
                </c:pt>
                <c:pt idx="1083">
                  <c:v>7.530000000000002E-2</c:v>
                </c:pt>
                <c:pt idx="1084">
                  <c:v>7.6200000000000004E-2</c:v>
                </c:pt>
                <c:pt idx="1085">
                  <c:v>7.5600000000000001E-2</c:v>
                </c:pt>
                <c:pt idx="1086">
                  <c:v>7.640000000000001E-2</c:v>
                </c:pt>
                <c:pt idx="1087">
                  <c:v>7.6700000000000004E-2</c:v>
                </c:pt>
                <c:pt idx="1088">
                  <c:v>7.7200000000000005E-2</c:v>
                </c:pt>
                <c:pt idx="1089">
                  <c:v>7.8166666666666662E-2</c:v>
                </c:pt>
                <c:pt idx="1090">
                  <c:v>7.7899999999999997E-2</c:v>
                </c:pt>
                <c:pt idx="1091">
                  <c:v>7.7899999999999997E-2</c:v>
                </c:pt>
                <c:pt idx="1092">
                  <c:v>7.7766666666666664E-2</c:v>
                </c:pt>
                <c:pt idx="1093">
                  <c:v>7.796666666666667E-2</c:v>
                </c:pt>
                <c:pt idx="1094">
                  <c:v>7.8E-2</c:v>
                </c:pt>
                <c:pt idx="1095">
                  <c:v>7.7833333333333324E-2</c:v>
                </c:pt>
                <c:pt idx="1096">
                  <c:v>7.8133333333333332E-2</c:v>
                </c:pt>
                <c:pt idx="1097">
                  <c:v>7.7733333333333335E-2</c:v>
                </c:pt>
                <c:pt idx="1098">
                  <c:v>7.8399999999999997E-2</c:v>
                </c:pt>
                <c:pt idx="1099">
                  <c:v>8.0133333333333334E-2</c:v>
                </c:pt>
                <c:pt idx="1100">
                  <c:v>8.1066666666666662E-2</c:v>
                </c:pt>
                <c:pt idx="1101">
                  <c:v>8.1400000000000014E-2</c:v>
                </c:pt>
                <c:pt idx="1102">
                  <c:v>8.1633333333333336E-2</c:v>
                </c:pt>
                <c:pt idx="1103">
                  <c:v>8.2133333333333336E-2</c:v>
                </c:pt>
                <c:pt idx="1104">
                  <c:v>8.1566666666666662E-2</c:v>
                </c:pt>
                <c:pt idx="1105">
                  <c:v>8.1600000000000006E-2</c:v>
                </c:pt>
                <c:pt idx="1106">
                  <c:v>8.2533333333333334E-2</c:v>
                </c:pt>
                <c:pt idx="1107">
                  <c:v>8.3066666666666664E-2</c:v>
                </c:pt>
                <c:pt idx="1108">
                  <c:v>8.4099999999999994E-2</c:v>
                </c:pt>
                <c:pt idx="1109">
                  <c:v>8.5000000000000006E-2</c:v>
                </c:pt>
                <c:pt idx="1110">
                  <c:v>8.4533333333333335E-2</c:v>
                </c:pt>
                <c:pt idx="1111">
                  <c:v>8.4066666666666678E-2</c:v>
                </c:pt>
                <c:pt idx="1112">
                  <c:v>8.3933333333333346E-2</c:v>
                </c:pt>
                <c:pt idx="1113">
                  <c:v>8.43E-2</c:v>
                </c:pt>
                <c:pt idx="1114">
                  <c:v>8.5533333333333336E-2</c:v>
                </c:pt>
                <c:pt idx="1115">
                  <c:v>8.5600000000000009E-2</c:v>
                </c:pt>
                <c:pt idx="1116">
                  <c:v>8.6166666666666669E-2</c:v>
                </c:pt>
                <c:pt idx="1117">
                  <c:v>8.6399999999999991E-2</c:v>
                </c:pt>
                <c:pt idx="1118">
                  <c:v>8.6599999999999996E-2</c:v>
                </c:pt>
                <c:pt idx="1119">
                  <c:v>8.7266666666666659E-2</c:v>
                </c:pt>
                <c:pt idx="1120">
                  <c:v>8.7433333333333321E-2</c:v>
                </c:pt>
                <c:pt idx="1121">
                  <c:v>8.72E-2</c:v>
                </c:pt>
                <c:pt idx="1122">
                  <c:v>8.7033333333333338E-2</c:v>
                </c:pt>
                <c:pt idx="1123">
                  <c:v>8.7433333333333349E-2</c:v>
                </c:pt>
                <c:pt idx="1124">
                  <c:v>8.7599999999999997E-2</c:v>
                </c:pt>
                <c:pt idx="1125">
                  <c:v>8.7833333333333333E-2</c:v>
                </c:pt>
                <c:pt idx="1126">
                  <c:v>8.8533333333333339E-2</c:v>
                </c:pt>
                <c:pt idx="1127">
                  <c:v>8.8200000000000001E-2</c:v>
                </c:pt>
                <c:pt idx="1128">
                  <c:v>8.9066666666666669E-2</c:v>
                </c:pt>
                <c:pt idx="1129">
                  <c:v>8.9666666666666672E-2</c:v>
                </c:pt>
                <c:pt idx="1130">
                  <c:v>8.9099999999999999E-2</c:v>
                </c:pt>
                <c:pt idx="1131">
                  <c:v>8.9799999999999991E-2</c:v>
                </c:pt>
                <c:pt idx="1132">
                  <c:v>9.01E-2</c:v>
                </c:pt>
                <c:pt idx="1133">
                  <c:v>9.0433333333333324E-2</c:v>
                </c:pt>
                <c:pt idx="1134">
                  <c:v>9.0899999999999995E-2</c:v>
                </c:pt>
                <c:pt idx="1135">
                  <c:v>9.1566666666666671E-2</c:v>
                </c:pt>
                <c:pt idx="1136">
                  <c:v>9.1766666666666663E-2</c:v>
                </c:pt>
                <c:pt idx="1137">
                  <c:v>9.2766666666666664E-2</c:v>
                </c:pt>
                <c:pt idx="1138">
                  <c:v>9.3466666666666656E-2</c:v>
                </c:pt>
                <c:pt idx="1139">
                  <c:v>9.3399999999999997E-2</c:v>
                </c:pt>
                <c:pt idx="1140">
                  <c:v>9.3500000000000014E-2</c:v>
                </c:pt>
                <c:pt idx="1141">
                  <c:v>9.3133333333333332E-2</c:v>
                </c:pt>
                <c:pt idx="1142">
                  <c:v>9.3700000000000006E-2</c:v>
                </c:pt>
                <c:pt idx="1143">
                  <c:v>9.4533333333333344E-2</c:v>
                </c:pt>
                <c:pt idx="1144">
                  <c:v>9.5100000000000004E-2</c:v>
                </c:pt>
                <c:pt idx="1145">
                  <c:v>9.6233333333333337E-2</c:v>
                </c:pt>
                <c:pt idx="1146">
                  <c:v>9.5833333333333326E-2</c:v>
                </c:pt>
                <c:pt idx="1147">
                  <c:v>9.5999999999999988E-2</c:v>
                </c:pt>
                <c:pt idx="1148">
                  <c:v>9.5933333333333329E-2</c:v>
                </c:pt>
                <c:pt idx="1149">
                  <c:v>9.5499999999999988E-2</c:v>
                </c:pt>
                <c:pt idx="1150">
                  <c:v>9.6466666666666659E-2</c:v>
                </c:pt>
                <c:pt idx="1151">
                  <c:v>9.7299999999999998E-2</c:v>
                </c:pt>
                <c:pt idx="1152">
                  <c:v>9.8666666666666666E-2</c:v>
                </c:pt>
                <c:pt idx="1153">
                  <c:v>9.8799999999999999E-2</c:v>
                </c:pt>
                <c:pt idx="1154">
                  <c:v>9.9000000000000019E-2</c:v>
                </c:pt>
                <c:pt idx="1155">
                  <c:v>9.9466666666666662E-2</c:v>
                </c:pt>
                <c:pt idx="1156">
                  <c:v>9.8833333333333329E-2</c:v>
                </c:pt>
                <c:pt idx="1157">
                  <c:v>0.10063333333333334</c:v>
                </c:pt>
                <c:pt idx="1158">
                  <c:v>0.10173333333333333</c:v>
                </c:pt>
                <c:pt idx="1159">
                  <c:v>0.10116666666666667</c:v>
                </c:pt>
                <c:pt idx="1160">
                  <c:v>0.10149999999999999</c:v>
                </c:pt>
                <c:pt idx="1161">
                  <c:v>0.10106666666666668</c:v>
                </c:pt>
                <c:pt idx="1162">
                  <c:v>0.1002</c:v>
                </c:pt>
                <c:pt idx="1163">
                  <c:v>0.1012</c:v>
                </c:pt>
                <c:pt idx="1164">
                  <c:v>0.1018</c:v>
                </c:pt>
                <c:pt idx="1165">
                  <c:v>0.10289999999999999</c:v>
                </c:pt>
                <c:pt idx="1166">
                  <c:v>0.10459999999999998</c:v>
                </c:pt>
                <c:pt idx="1167">
                  <c:v>0.10473333333333333</c:v>
                </c:pt>
                <c:pt idx="1168">
                  <c:v>0.10513333333333334</c:v>
                </c:pt>
                <c:pt idx="1169">
                  <c:v>0.10573333333333333</c:v>
                </c:pt>
                <c:pt idx="1170">
                  <c:v>0.10540000000000001</c:v>
                </c:pt>
                <c:pt idx="1171">
                  <c:v>0.10613333333333334</c:v>
                </c:pt>
                <c:pt idx="1172">
                  <c:v>0.10683333333333334</c:v>
                </c:pt>
                <c:pt idx="1173">
                  <c:v>0.10580000000000001</c:v>
                </c:pt>
                <c:pt idx="1174">
                  <c:v>0.10693333333333332</c:v>
                </c:pt>
                <c:pt idx="1175">
                  <c:v>0.10693333333333332</c:v>
                </c:pt>
                <c:pt idx="1176">
                  <c:v>0.10713333333333334</c:v>
                </c:pt>
                <c:pt idx="1177">
                  <c:v>0.10780000000000001</c:v>
                </c:pt>
                <c:pt idx="1178">
                  <c:v>0.1082</c:v>
                </c:pt>
                <c:pt idx="1179">
                  <c:v>0.10873333333333333</c:v>
                </c:pt>
                <c:pt idx="1180">
                  <c:v>0.10916666666666668</c:v>
                </c:pt>
                <c:pt idx="1181">
                  <c:v>0.11010000000000002</c:v>
                </c:pt>
                <c:pt idx="1182">
                  <c:v>0.10993333333333333</c:v>
                </c:pt>
                <c:pt idx="1183">
                  <c:v>0.11096666666666667</c:v>
                </c:pt>
                <c:pt idx="1184">
                  <c:v>0.1113</c:v>
                </c:pt>
                <c:pt idx="1185">
                  <c:v>0.11113333333333335</c:v>
                </c:pt>
                <c:pt idx="1186">
                  <c:v>0.11123333333333334</c:v>
                </c:pt>
                <c:pt idx="1187">
                  <c:v>0.11109999999999999</c:v>
                </c:pt>
                <c:pt idx="1188">
                  <c:v>0.11159999999999999</c:v>
                </c:pt>
                <c:pt idx="1189">
                  <c:v>0.11170000000000001</c:v>
                </c:pt>
                <c:pt idx="1190">
                  <c:v>0.11213333333333332</c:v>
                </c:pt>
                <c:pt idx="1191">
                  <c:v>0.11243333333333333</c:v>
                </c:pt>
                <c:pt idx="1192">
                  <c:v>0.1125</c:v>
                </c:pt>
                <c:pt idx="1193">
                  <c:v>0.11366666666666668</c:v>
                </c:pt>
                <c:pt idx="1194">
                  <c:v>0.11426666666666667</c:v>
                </c:pt>
                <c:pt idx="1195">
                  <c:v>0.11416666666666668</c:v>
                </c:pt>
                <c:pt idx="1196">
                  <c:v>0.11486666666666667</c:v>
                </c:pt>
                <c:pt idx="1197">
                  <c:v>0.11516666666666668</c:v>
                </c:pt>
                <c:pt idx="1198">
                  <c:v>0.11583333333333334</c:v>
                </c:pt>
                <c:pt idx="1199">
                  <c:v>0.11623333333333334</c:v>
                </c:pt>
                <c:pt idx="1200">
                  <c:v>0.11626666666666667</c:v>
                </c:pt>
                <c:pt idx="1201">
                  <c:v>0.11673333333333334</c:v>
                </c:pt>
                <c:pt idx="1202">
                  <c:v>0.11676666666666667</c:v>
                </c:pt>
                <c:pt idx="1203">
                  <c:v>0.11743333333333333</c:v>
                </c:pt>
                <c:pt idx="1204">
                  <c:v>0.11803333333333332</c:v>
                </c:pt>
                <c:pt idx="1205">
                  <c:v>0.11849999999999999</c:v>
                </c:pt>
                <c:pt idx="1206">
                  <c:v>0.11933333333333333</c:v>
                </c:pt>
                <c:pt idx="1207">
                  <c:v>0.11936666666666668</c:v>
                </c:pt>
                <c:pt idx="1208">
                  <c:v>0.12069999999999999</c:v>
                </c:pt>
                <c:pt idx="1209">
                  <c:v>0.12169999999999999</c:v>
                </c:pt>
                <c:pt idx="1210">
                  <c:v>0.12176666666666668</c:v>
                </c:pt>
                <c:pt idx="1211">
                  <c:v>0.12316666666666666</c:v>
                </c:pt>
                <c:pt idx="1212">
                  <c:v>0.12356666666666667</c:v>
                </c:pt>
                <c:pt idx="1213">
                  <c:v>0.12353333333333333</c:v>
                </c:pt>
                <c:pt idx="1214">
                  <c:v>0.12463333333333333</c:v>
                </c:pt>
                <c:pt idx="1215">
                  <c:v>0.12516666666666665</c:v>
                </c:pt>
                <c:pt idx="1216">
                  <c:v>0.12493333333333334</c:v>
                </c:pt>
                <c:pt idx="1217">
                  <c:v>0.12583333333333332</c:v>
                </c:pt>
                <c:pt idx="1218">
                  <c:v>0.12653333333333336</c:v>
                </c:pt>
                <c:pt idx="1219">
                  <c:v>0.12709999999999999</c:v>
                </c:pt>
                <c:pt idx="1220">
                  <c:v>0.1278</c:v>
                </c:pt>
                <c:pt idx="1221">
                  <c:v>0.12813333333333332</c:v>
                </c:pt>
                <c:pt idx="1222">
                  <c:v>0.12903333333333333</c:v>
                </c:pt>
                <c:pt idx="1223">
                  <c:v>0.1275</c:v>
                </c:pt>
                <c:pt idx="1224">
                  <c:v>0.12646666666666664</c:v>
                </c:pt>
                <c:pt idx="1225">
                  <c:v>0.12520000000000001</c:v>
                </c:pt>
                <c:pt idx="1226">
                  <c:v>0.12333333333333334</c:v>
                </c:pt>
                <c:pt idx="1227">
                  <c:v>0.12433333333333334</c:v>
                </c:pt>
                <c:pt idx="1228">
                  <c:v>0.12506666666666666</c:v>
                </c:pt>
                <c:pt idx="1229">
                  <c:v>0.12563333333333335</c:v>
                </c:pt>
                <c:pt idx="1230">
                  <c:v>0.12620000000000001</c:v>
                </c:pt>
                <c:pt idx="1231">
                  <c:v>0.12626666666666667</c:v>
                </c:pt>
                <c:pt idx="1232">
                  <c:v>0.12686666666666666</c:v>
                </c:pt>
                <c:pt idx="1233">
                  <c:v>0.12726666666666667</c:v>
                </c:pt>
                <c:pt idx="1234">
                  <c:v>0.12756666666666669</c:v>
                </c:pt>
                <c:pt idx="1235">
                  <c:v>0.12803333333333333</c:v>
                </c:pt>
                <c:pt idx="1236">
                  <c:v>0.12863333333333335</c:v>
                </c:pt>
                <c:pt idx="1237">
                  <c:v>0.12913333333333335</c:v>
                </c:pt>
                <c:pt idx="1238">
                  <c:v>0.12996666666666667</c:v>
                </c:pt>
                <c:pt idx="1239">
                  <c:v>0.13073333333333334</c:v>
                </c:pt>
                <c:pt idx="1240">
                  <c:v>0.13066666666666668</c:v>
                </c:pt>
                <c:pt idx="1241">
                  <c:v>0.13090000000000002</c:v>
                </c:pt>
                <c:pt idx="1242">
                  <c:v>0.13110000000000002</c:v>
                </c:pt>
                <c:pt idx="1243">
                  <c:v>0.13143333333333332</c:v>
                </c:pt>
                <c:pt idx="1244">
                  <c:v>0.13233333333333333</c:v>
                </c:pt>
                <c:pt idx="1245">
                  <c:v>0.13296666666666668</c:v>
                </c:pt>
                <c:pt idx="1246">
                  <c:v>0.13366666666666668</c:v>
                </c:pt>
                <c:pt idx="1247">
                  <c:v>0.13450000000000001</c:v>
                </c:pt>
                <c:pt idx="1248">
                  <c:v>0.13516666666666666</c:v>
                </c:pt>
                <c:pt idx="1249">
                  <c:v>0.13523333333333334</c:v>
                </c:pt>
                <c:pt idx="1250">
                  <c:v>0.13596666666666665</c:v>
                </c:pt>
                <c:pt idx="1251">
                  <c:v>0.13663333333333333</c:v>
                </c:pt>
                <c:pt idx="1252">
                  <c:v>0.1371</c:v>
                </c:pt>
                <c:pt idx="1253">
                  <c:v>0.13813333333333333</c:v>
                </c:pt>
              </c:numCache>
            </c:numRef>
          </c:yVal>
          <c:smooth val="1"/>
          <c:extLst>
            <c:ext xmlns:c16="http://schemas.microsoft.com/office/drawing/2014/chart" uri="{C3380CC4-5D6E-409C-BE32-E72D297353CC}">
              <c16:uniqueId val="{00000000-AA13-49CE-A792-B5AEE7BA5538}"/>
            </c:ext>
          </c:extLst>
        </c:ser>
        <c:ser>
          <c:idx val="1"/>
          <c:order val="1"/>
          <c:tx>
            <c:strRef>
              <c:f>Hoja1!$BU$1</c:f>
              <c:strCache>
                <c:ptCount val="1"/>
                <c:pt idx="0">
                  <c:v>2d</c:v>
                </c:pt>
              </c:strCache>
            </c:strRef>
          </c:tx>
          <c:spPr>
            <a:ln>
              <a:solidFill>
                <a:srgbClr val="7030A0"/>
              </a:solidFill>
              <a:prstDash val="lgDashDotDot"/>
            </a:ln>
          </c:spPr>
          <c:marker>
            <c:symbol val="none"/>
          </c:marker>
          <c:xVal>
            <c:numRef>
              <c:f>Hoja1!$BS$2:$BS$1255</c:f>
              <c:numCache>
                <c:formatCode>General</c:formatCode>
                <c:ptCount val="1254"/>
                <c:pt idx="2" formatCode="h:mm">
                  <c:v>0.68125000000000002</c:v>
                </c:pt>
                <c:pt idx="3">
                  <c:v>550</c:v>
                </c:pt>
                <c:pt idx="4">
                  <c:v>549.79999999999995</c:v>
                </c:pt>
                <c:pt idx="5">
                  <c:v>549.6</c:v>
                </c:pt>
                <c:pt idx="6">
                  <c:v>549.4</c:v>
                </c:pt>
                <c:pt idx="7">
                  <c:v>549.20000000000005</c:v>
                </c:pt>
                <c:pt idx="8">
                  <c:v>549</c:v>
                </c:pt>
                <c:pt idx="9">
                  <c:v>548.79999999999995</c:v>
                </c:pt>
                <c:pt idx="10">
                  <c:v>548.6</c:v>
                </c:pt>
                <c:pt idx="11">
                  <c:v>548.4</c:v>
                </c:pt>
                <c:pt idx="12">
                  <c:v>548.20000000000005</c:v>
                </c:pt>
                <c:pt idx="13">
                  <c:v>548</c:v>
                </c:pt>
                <c:pt idx="14">
                  <c:v>547.79999999999995</c:v>
                </c:pt>
                <c:pt idx="15">
                  <c:v>547.6</c:v>
                </c:pt>
                <c:pt idx="16">
                  <c:v>547.4</c:v>
                </c:pt>
                <c:pt idx="17">
                  <c:v>547.20000000000005</c:v>
                </c:pt>
                <c:pt idx="18">
                  <c:v>547</c:v>
                </c:pt>
                <c:pt idx="19">
                  <c:v>546.79999999999995</c:v>
                </c:pt>
                <c:pt idx="20">
                  <c:v>546.6</c:v>
                </c:pt>
                <c:pt idx="21">
                  <c:v>546.4</c:v>
                </c:pt>
                <c:pt idx="22">
                  <c:v>546.20000000000005</c:v>
                </c:pt>
                <c:pt idx="23">
                  <c:v>546</c:v>
                </c:pt>
                <c:pt idx="24">
                  <c:v>545.79999999999995</c:v>
                </c:pt>
                <c:pt idx="25">
                  <c:v>545.6</c:v>
                </c:pt>
                <c:pt idx="26">
                  <c:v>545.4</c:v>
                </c:pt>
                <c:pt idx="27">
                  <c:v>545.20000000000005</c:v>
                </c:pt>
                <c:pt idx="28">
                  <c:v>545</c:v>
                </c:pt>
                <c:pt idx="29">
                  <c:v>544.79999999999995</c:v>
                </c:pt>
                <c:pt idx="30">
                  <c:v>544.6</c:v>
                </c:pt>
                <c:pt idx="31">
                  <c:v>544.4</c:v>
                </c:pt>
                <c:pt idx="32">
                  <c:v>544.20000000000005</c:v>
                </c:pt>
                <c:pt idx="33">
                  <c:v>544</c:v>
                </c:pt>
                <c:pt idx="34">
                  <c:v>543.79999999999995</c:v>
                </c:pt>
                <c:pt idx="35">
                  <c:v>543.6</c:v>
                </c:pt>
                <c:pt idx="36">
                  <c:v>543.4</c:v>
                </c:pt>
                <c:pt idx="37">
                  <c:v>543.20000000000005</c:v>
                </c:pt>
                <c:pt idx="38">
                  <c:v>543</c:v>
                </c:pt>
                <c:pt idx="39">
                  <c:v>542.79999999999995</c:v>
                </c:pt>
                <c:pt idx="40">
                  <c:v>542.6</c:v>
                </c:pt>
                <c:pt idx="41">
                  <c:v>542.4</c:v>
                </c:pt>
                <c:pt idx="42">
                  <c:v>542.20000000000005</c:v>
                </c:pt>
                <c:pt idx="43">
                  <c:v>542</c:v>
                </c:pt>
                <c:pt idx="44">
                  <c:v>541.79999999999995</c:v>
                </c:pt>
                <c:pt idx="45">
                  <c:v>541.6</c:v>
                </c:pt>
                <c:pt idx="46">
                  <c:v>541.4</c:v>
                </c:pt>
                <c:pt idx="47">
                  <c:v>541.20000000000005</c:v>
                </c:pt>
                <c:pt idx="48">
                  <c:v>541</c:v>
                </c:pt>
                <c:pt idx="49">
                  <c:v>540.79999999999995</c:v>
                </c:pt>
                <c:pt idx="50">
                  <c:v>540.6</c:v>
                </c:pt>
                <c:pt idx="51">
                  <c:v>540.4</c:v>
                </c:pt>
                <c:pt idx="52">
                  <c:v>540.20000000000005</c:v>
                </c:pt>
                <c:pt idx="53">
                  <c:v>540</c:v>
                </c:pt>
                <c:pt idx="54">
                  <c:v>539.79999999999995</c:v>
                </c:pt>
                <c:pt idx="55">
                  <c:v>539.6</c:v>
                </c:pt>
                <c:pt idx="56">
                  <c:v>539.4</c:v>
                </c:pt>
                <c:pt idx="57">
                  <c:v>539.20000000000005</c:v>
                </c:pt>
                <c:pt idx="58">
                  <c:v>539</c:v>
                </c:pt>
                <c:pt idx="59">
                  <c:v>538.79999999999995</c:v>
                </c:pt>
                <c:pt idx="60">
                  <c:v>538.6</c:v>
                </c:pt>
                <c:pt idx="61">
                  <c:v>538.4</c:v>
                </c:pt>
                <c:pt idx="62">
                  <c:v>538.20000000000005</c:v>
                </c:pt>
                <c:pt idx="63">
                  <c:v>538</c:v>
                </c:pt>
                <c:pt idx="64">
                  <c:v>537.79999999999995</c:v>
                </c:pt>
                <c:pt idx="65">
                  <c:v>537.6</c:v>
                </c:pt>
                <c:pt idx="66">
                  <c:v>537.4</c:v>
                </c:pt>
                <c:pt idx="67">
                  <c:v>537.20000000000005</c:v>
                </c:pt>
                <c:pt idx="68">
                  <c:v>537</c:v>
                </c:pt>
                <c:pt idx="69">
                  <c:v>536.79999999999995</c:v>
                </c:pt>
                <c:pt idx="70">
                  <c:v>536.6</c:v>
                </c:pt>
                <c:pt idx="71">
                  <c:v>536.4</c:v>
                </c:pt>
                <c:pt idx="72">
                  <c:v>536.20000000000005</c:v>
                </c:pt>
                <c:pt idx="73">
                  <c:v>536</c:v>
                </c:pt>
                <c:pt idx="74">
                  <c:v>535.79999999999995</c:v>
                </c:pt>
                <c:pt idx="75">
                  <c:v>535.6</c:v>
                </c:pt>
                <c:pt idx="76">
                  <c:v>535.4</c:v>
                </c:pt>
                <c:pt idx="77">
                  <c:v>535.20000000000005</c:v>
                </c:pt>
                <c:pt idx="78">
                  <c:v>535</c:v>
                </c:pt>
                <c:pt idx="79">
                  <c:v>534.79999999999995</c:v>
                </c:pt>
                <c:pt idx="80">
                  <c:v>534.6</c:v>
                </c:pt>
                <c:pt idx="81">
                  <c:v>534.4</c:v>
                </c:pt>
                <c:pt idx="82">
                  <c:v>534.20000000000005</c:v>
                </c:pt>
                <c:pt idx="83">
                  <c:v>534</c:v>
                </c:pt>
                <c:pt idx="84">
                  <c:v>533.79999999999995</c:v>
                </c:pt>
                <c:pt idx="85">
                  <c:v>533.6</c:v>
                </c:pt>
                <c:pt idx="86">
                  <c:v>533.4</c:v>
                </c:pt>
                <c:pt idx="87">
                  <c:v>533.20000000000005</c:v>
                </c:pt>
                <c:pt idx="88">
                  <c:v>533</c:v>
                </c:pt>
                <c:pt idx="89">
                  <c:v>532.79999999999995</c:v>
                </c:pt>
                <c:pt idx="90">
                  <c:v>532.6</c:v>
                </c:pt>
                <c:pt idx="91">
                  <c:v>532.4</c:v>
                </c:pt>
                <c:pt idx="92">
                  <c:v>532.20000000000005</c:v>
                </c:pt>
                <c:pt idx="93">
                  <c:v>532</c:v>
                </c:pt>
                <c:pt idx="94">
                  <c:v>531.79999999999995</c:v>
                </c:pt>
                <c:pt idx="95">
                  <c:v>531.6</c:v>
                </c:pt>
                <c:pt idx="96">
                  <c:v>531.4</c:v>
                </c:pt>
                <c:pt idx="97">
                  <c:v>531.20000000000005</c:v>
                </c:pt>
                <c:pt idx="98">
                  <c:v>531</c:v>
                </c:pt>
                <c:pt idx="99">
                  <c:v>530.79999999999995</c:v>
                </c:pt>
                <c:pt idx="100">
                  <c:v>530.6</c:v>
                </c:pt>
                <c:pt idx="101">
                  <c:v>530.4</c:v>
                </c:pt>
                <c:pt idx="102">
                  <c:v>530.20000000000005</c:v>
                </c:pt>
                <c:pt idx="103">
                  <c:v>530</c:v>
                </c:pt>
                <c:pt idx="104">
                  <c:v>529.79999999999995</c:v>
                </c:pt>
                <c:pt idx="105">
                  <c:v>529.6</c:v>
                </c:pt>
                <c:pt idx="106">
                  <c:v>529.4</c:v>
                </c:pt>
                <c:pt idx="107">
                  <c:v>529.20000000000005</c:v>
                </c:pt>
                <c:pt idx="108">
                  <c:v>529</c:v>
                </c:pt>
                <c:pt idx="109">
                  <c:v>528.79999999999995</c:v>
                </c:pt>
                <c:pt idx="110">
                  <c:v>528.6</c:v>
                </c:pt>
                <c:pt idx="111">
                  <c:v>528.4</c:v>
                </c:pt>
                <c:pt idx="112">
                  <c:v>528.20000000000005</c:v>
                </c:pt>
                <c:pt idx="113">
                  <c:v>528</c:v>
                </c:pt>
                <c:pt idx="114">
                  <c:v>527.79999999999995</c:v>
                </c:pt>
                <c:pt idx="115">
                  <c:v>527.6</c:v>
                </c:pt>
                <c:pt idx="116">
                  <c:v>527.4</c:v>
                </c:pt>
                <c:pt idx="117">
                  <c:v>527.20000000000005</c:v>
                </c:pt>
                <c:pt idx="118">
                  <c:v>527</c:v>
                </c:pt>
                <c:pt idx="119">
                  <c:v>526.79999999999995</c:v>
                </c:pt>
                <c:pt idx="120">
                  <c:v>526.6</c:v>
                </c:pt>
                <c:pt idx="121">
                  <c:v>526.4</c:v>
                </c:pt>
                <c:pt idx="122">
                  <c:v>526.20000000000005</c:v>
                </c:pt>
                <c:pt idx="123">
                  <c:v>526</c:v>
                </c:pt>
                <c:pt idx="124">
                  <c:v>525.79999999999995</c:v>
                </c:pt>
                <c:pt idx="125">
                  <c:v>525.6</c:v>
                </c:pt>
                <c:pt idx="126">
                  <c:v>525.4</c:v>
                </c:pt>
                <c:pt idx="127">
                  <c:v>525.20000000000005</c:v>
                </c:pt>
                <c:pt idx="128">
                  <c:v>525</c:v>
                </c:pt>
                <c:pt idx="129">
                  <c:v>524.79999999999995</c:v>
                </c:pt>
                <c:pt idx="130">
                  <c:v>524.6</c:v>
                </c:pt>
                <c:pt idx="131">
                  <c:v>524.4</c:v>
                </c:pt>
                <c:pt idx="132">
                  <c:v>524.20000000000005</c:v>
                </c:pt>
                <c:pt idx="133">
                  <c:v>524</c:v>
                </c:pt>
                <c:pt idx="134">
                  <c:v>523.79999999999995</c:v>
                </c:pt>
                <c:pt idx="135">
                  <c:v>523.6</c:v>
                </c:pt>
                <c:pt idx="136">
                  <c:v>523.4</c:v>
                </c:pt>
                <c:pt idx="137">
                  <c:v>523.20000000000005</c:v>
                </c:pt>
                <c:pt idx="138">
                  <c:v>523</c:v>
                </c:pt>
                <c:pt idx="139">
                  <c:v>522.79999999999995</c:v>
                </c:pt>
                <c:pt idx="140">
                  <c:v>522.6</c:v>
                </c:pt>
                <c:pt idx="141">
                  <c:v>522.4</c:v>
                </c:pt>
                <c:pt idx="142">
                  <c:v>522.20000000000005</c:v>
                </c:pt>
                <c:pt idx="143">
                  <c:v>522</c:v>
                </c:pt>
                <c:pt idx="144">
                  <c:v>521.79999999999995</c:v>
                </c:pt>
                <c:pt idx="145">
                  <c:v>521.6</c:v>
                </c:pt>
                <c:pt idx="146">
                  <c:v>521.4</c:v>
                </c:pt>
                <c:pt idx="147">
                  <c:v>521.20000000000005</c:v>
                </c:pt>
                <c:pt idx="148">
                  <c:v>521</c:v>
                </c:pt>
                <c:pt idx="149">
                  <c:v>520.79999999999995</c:v>
                </c:pt>
                <c:pt idx="150">
                  <c:v>520.6</c:v>
                </c:pt>
                <c:pt idx="151">
                  <c:v>520.4</c:v>
                </c:pt>
                <c:pt idx="152">
                  <c:v>520.20000000000005</c:v>
                </c:pt>
                <c:pt idx="153">
                  <c:v>520</c:v>
                </c:pt>
                <c:pt idx="154">
                  <c:v>519.79999999999995</c:v>
                </c:pt>
                <c:pt idx="155">
                  <c:v>519.6</c:v>
                </c:pt>
                <c:pt idx="156">
                  <c:v>519.4</c:v>
                </c:pt>
                <c:pt idx="157">
                  <c:v>519.20000000000005</c:v>
                </c:pt>
                <c:pt idx="158">
                  <c:v>519</c:v>
                </c:pt>
                <c:pt idx="159">
                  <c:v>518.79999999999995</c:v>
                </c:pt>
                <c:pt idx="160">
                  <c:v>518.6</c:v>
                </c:pt>
                <c:pt idx="161">
                  <c:v>518.4</c:v>
                </c:pt>
                <c:pt idx="162">
                  <c:v>518.20000000000005</c:v>
                </c:pt>
                <c:pt idx="163">
                  <c:v>518</c:v>
                </c:pt>
                <c:pt idx="164">
                  <c:v>517.79999999999995</c:v>
                </c:pt>
                <c:pt idx="165">
                  <c:v>517.6</c:v>
                </c:pt>
                <c:pt idx="166">
                  <c:v>517.4</c:v>
                </c:pt>
                <c:pt idx="167">
                  <c:v>517.20000000000005</c:v>
                </c:pt>
                <c:pt idx="168">
                  <c:v>517</c:v>
                </c:pt>
                <c:pt idx="169">
                  <c:v>516.79999999999995</c:v>
                </c:pt>
                <c:pt idx="170">
                  <c:v>516.6</c:v>
                </c:pt>
                <c:pt idx="171">
                  <c:v>516.4</c:v>
                </c:pt>
                <c:pt idx="172">
                  <c:v>516.20000000000005</c:v>
                </c:pt>
                <c:pt idx="173">
                  <c:v>516</c:v>
                </c:pt>
                <c:pt idx="174">
                  <c:v>515.79999999999995</c:v>
                </c:pt>
                <c:pt idx="175">
                  <c:v>515.6</c:v>
                </c:pt>
                <c:pt idx="176">
                  <c:v>515.4</c:v>
                </c:pt>
                <c:pt idx="177">
                  <c:v>515.20000000000005</c:v>
                </c:pt>
                <c:pt idx="178">
                  <c:v>515</c:v>
                </c:pt>
                <c:pt idx="179">
                  <c:v>514.79999999999995</c:v>
                </c:pt>
                <c:pt idx="180">
                  <c:v>514.6</c:v>
                </c:pt>
                <c:pt idx="181">
                  <c:v>514.4</c:v>
                </c:pt>
                <c:pt idx="182">
                  <c:v>514.20000000000005</c:v>
                </c:pt>
                <c:pt idx="183">
                  <c:v>514</c:v>
                </c:pt>
                <c:pt idx="184">
                  <c:v>513.79999999999995</c:v>
                </c:pt>
                <c:pt idx="185">
                  <c:v>513.6</c:v>
                </c:pt>
                <c:pt idx="186">
                  <c:v>513.4</c:v>
                </c:pt>
                <c:pt idx="187">
                  <c:v>513.20000000000005</c:v>
                </c:pt>
                <c:pt idx="188">
                  <c:v>513</c:v>
                </c:pt>
                <c:pt idx="189">
                  <c:v>512.79999999999995</c:v>
                </c:pt>
                <c:pt idx="190">
                  <c:v>512.6</c:v>
                </c:pt>
                <c:pt idx="191">
                  <c:v>512.4</c:v>
                </c:pt>
                <c:pt idx="192">
                  <c:v>512.20000000000005</c:v>
                </c:pt>
                <c:pt idx="193">
                  <c:v>512</c:v>
                </c:pt>
                <c:pt idx="194">
                  <c:v>511.8</c:v>
                </c:pt>
                <c:pt idx="195">
                  <c:v>511.6</c:v>
                </c:pt>
                <c:pt idx="196">
                  <c:v>511.4</c:v>
                </c:pt>
                <c:pt idx="197">
                  <c:v>511.2</c:v>
                </c:pt>
                <c:pt idx="198">
                  <c:v>511</c:v>
                </c:pt>
                <c:pt idx="199">
                  <c:v>510.8</c:v>
                </c:pt>
                <c:pt idx="200">
                  <c:v>510.6</c:v>
                </c:pt>
                <c:pt idx="201">
                  <c:v>510.4</c:v>
                </c:pt>
                <c:pt idx="202">
                  <c:v>510.2</c:v>
                </c:pt>
                <c:pt idx="203">
                  <c:v>510</c:v>
                </c:pt>
                <c:pt idx="204">
                  <c:v>509.8</c:v>
                </c:pt>
                <c:pt idx="205">
                  <c:v>509.6</c:v>
                </c:pt>
                <c:pt idx="206">
                  <c:v>509.4</c:v>
                </c:pt>
                <c:pt idx="207">
                  <c:v>509.2</c:v>
                </c:pt>
                <c:pt idx="208">
                  <c:v>509</c:v>
                </c:pt>
                <c:pt idx="209">
                  <c:v>508.8</c:v>
                </c:pt>
                <c:pt idx="210">
                  <c:v>508.6</c:v>
                </c:pt>
                <c:pt idx="211">
                  <c:v>508.4</c:v>
                </c:pt>
                <c:pt idx="212">
                  <c:v>508.2</c:v>
                </c:pt>
                <c:pt idx="213">
                  <c:v>508</c:v>
                </c:pt>
                <c:pt idx="214">
                  <c:v>507.8</c:v>
                </c:pt>
                <c:pt idx="215">
                  <c:v>507.6</c:v>
                </c:pt>
                <c:pt idx="216">
                  <c:v>507.4</c:v>
                </c:pt>
                <c:pt idx="217">
                  <c:v>507.2</c:v>
                </c:pt>
                <c:pt idx="218">
                  <c:v>507</c:v>
                </c:pt>
                <c:pt idx="219">
                  <c:v>506.8</c:v>
                </c:pt>
                <c:pt idx="220">
                  <c:v>506.6</c:v>
                </c:pt>
                <c:pt idx="221">
                  <c:v>506.4</c:v>
                </c:pt>
                <c:pt idx="222">
                  <c:v>506.2</c:v>
                </c:pt>
                <c:pt idx="223">
                  <c:v>506</c:v>
                </c:pt>
                <c:pt idx="224">
                  <c:v>505.8</c:v>
                </c:pt>
                <c:pt idx="225">
                  <c:v>505.6</c:v>
                </c:pt>
                <c:pt idx="226">
                  <c:v>505.4</c:v>
                </c:pt>
                <c:pt idx="227">
                  <c:v>505.2</c:v>
                </c:pt>
                <c:pt idx="228">
                  <c:v>505</c:v>
                </c:pt>
                <c:pt idx="229">
                  <c:v>504.8</c:v>
                </c:pt>
                <c:pt idx="230">
                  <c:v>504.6</c:v>
                </c:pt>
                <c:pt idx="231">
                  <c:v>504.4</c:v>
                </c:pt>
                <c:pt idx="232">
                  <c:v>504.2</c:v>
                </c:pt>
                <c:pt idx="233">
                  <c:v>504</c:v>
                </c:pt>
                <c:pt idx="234">
                  <c:v>503.8</c:v>
                </c:pt>
                <c:pt idx="235">
                  <c:v>503.6</c:v>
                </c:pt>
                <c:pt idx="236">
                  <c:v>503.4</c:v>
                </c:pt>
                <c:pt idx="237">
                  <c:v>503.2</c:v>
                </c:pt>
                <c:pt idx="238">
                  <c:v>503</c:v>
                </c:pt>
                <c:pt idx="239">
                  <c:v>502.8</c:v>
                </c:pt>
                <c:pt idx="240">
                  <c:v>502.6</c:v>
                </c:pt>
                <c:pt idx="241">
                  <c:v>502.4</c:v>
                </c:pt>
                <c:pt idx="242">
                  <c:v>502.2</c:v>
                </c:pt>
                <c:pt idx="243">
                  <c:v>502</c:v>
                </c:pt>
                <c:pt idx="244">
                  <c:v>501.8</c:v>
                </c:pt>
                <c:pt idx="245">
                  <c:v>501.6</c:v>
                </c:pt>
                <c:pt idx="246">
                  <c:v>501.4</c:v>
                </c:pt>
                <c:pt idx="247">
                  <c:v>501.2</c:v>
                </c:pt>
                <c:pt idx="248">
                  <c:v>501</c:v>
                </c:pt>
                <c:pt idx="249">
                  <c:v>500.8</c:v>
                </c:pt>
                <c:pt idx="250">
                  <c:v>500.6</c:v>
                </c:pt>
                <c:pt idx="251">
                  <c:v>500.4</c:v>
                </c:pt>
                <c:pt idx="252">
                  <c:v>500.2</c:v>
                </c:pt>
                <c:pt idx="253">
                  <c:v>500</c:v>
                </c:pt>
                <c:pt idx="254">
                  <c:v>499.8</c:v>
                </c:pt>
                <c:pt idx="255">
                  <c:v>499.6</c:v>
                </c:pt>
                <c:pt idx="256">
                  <c:v>499.4</c:v>
                </c:pt>
                <c:pt idx="257">
                  <c:v>499.2</c:v>
                </c:pt>
                <c:pt idx="258">
                  <c:v>499</c:v>
                </c:pt>
                <c:pt idx="259">
                  <c:v>498.8</c:v>
                </c:pt>
                <c:pt idx="260">
                  <c:v>498.6</c:v>
                </c:pt>
                <c:pt idx="261">
                  <c:v>498.4</c:v>
                </c:pt>
                <c:pt idx="262">
                  <c:v>498.2</c:v>
                </c:pt>
                <c:pt idx="263">
                  <c:v>498</c:v>
                </c:pt>
                <c:pt idx="264">
                  <c:v>497.8</c:v>
                </c:pt>
                <c:pt idx="265">
                  <c:v>497.6</c:v>
                </c:pt>
                <c:pt idx="266">
                  <c:v>497.4</c:v>
                </c:pt>
                <c:pt idx="267">
                  <c:v>497.2</c:v>
                </c:pt>
                <c:pt idx="268">
                  <c:v>497</c:v>
                </c:pt>
                <c:pt idx="269">
                  <c:v>496.8</c:v>
                </c:pt>
                <c:pt idx="270">
                  <c:v>496.6</c:v>
                </c:pt>
                <c:pt idx="271">
                  <c:v>496.4</c:v>
                </c:pt>
                <c:pt idx="272">
                  <c:v>496.2</c:v>
                </c:pt>
                <c:pt idx="273">
                  <c:v>496</c:v>
                </c:pt>
                <c:pt idx="274">
                  <c:v>495.8</c:v>
                </c:pt>
                <c:pt idx="275">
                  <c:v>495.6</c:v>
                </c:pt>
                <c:pt idx="276">
                  <c:v>495.4</c:v>
                </c:pt>
                <c:pt idx="277">
                  <c:v>495.2</c:v>
                </c:pt>
                <c:pt idx="278">
                  <c:v>495</c:v>
                </c:pt>
                <c:pt idx="279">
                  <c:v>494.8</c:v>
                </c:pt>
                <c:pt idx="280">
                  <c:v>494.6</c:v>
                </c:pt>
                <c:pt idx="281">
                  <c:v>494.4</c:v>
                </c:pt>
                <c:pt idx="282">
                  <c:v>494.2</c:v>
                </c:pt>
                <c:pt idx="283">
                  <c:v>494</c:v>
                </c:pt>
                <c:pt idx="284">
                  <c:v>493.8</c:v>
                </c:pt>
                <c:pt idx="285">
                  <c:v>493.6</c:v>
                </c:pt>
                <c:pt idx="286">
                  <c:v>493.4</c:v>
                </c:pt>
                <c:pt idx="287">
                  <c:v>493.2</c:v>
                </c:pt>
                <c:pt idx="288">
                  <c:v>493</c:v>
                </c:pt>
                <c:pt idx="289">
                  <c:v>492.8</c:v>
                </c:pt>
                <c:pt idx="290">
                  <c:v>492.6</c:v>
                </c:pt>
                <c:pt idx="291">
                  <c:v>492.4</c:v>
                </c:pt>
                <c:pt idx="292">
                  <c:v>492.2</c:v>
                </c:pt>
                <c:pt idx="293">
                  <c:v>492</c:v>
                </c:pt>
                <c:pt idx="294">
                  <c:v>491.8</c:v>
                </c:pt>
                <c:pt idx="295">
                  <c:v>491.6</c:v>
                </c:pt>
                <c:pt idx="296">
                  <c:v>491.4</c:v>
                </c:pt>
                <c:pt idx="297">
                  <c:v>491.2</c:v>
                </c:pt>
                <c:pt idx="298">
                  <c:v>491</c:v>
                </c:pt>
                <c:pt idx="299">
                  <c:v>490.8</c:v>
                </c:pt>
                <c:pt idx="300">
                  <c:v>490.6</c:v>
                </c:pt>
                <c:pt idx="301">
                  <c:v>490.4</c:v>
                </c:pt>
                <c:pt idx="302">
                  <c:v>490.2</c:v>
                </c:pt>
                <c:pt idx="303">
                  <c:v>490</c:v>
                </c:pt>
                <c:pt idx="304">
                  <c:v>489.8</c:v>
                </c:pt>
                <c:pt idx="305">
                  <c:v>489.6</c:v>
                </c:pt>
                <c:pt idx="306">
                  <c:v>489.4</c:v>
                </c:pt>
                <c:pt idx="307">
                  <c:v>489.2</c:v>
                </c:pt>
                <c:pt idx="308">
                  <c:v>489</c:v>
                </c:pt>
                <c:pt idx="309">
                  <c:v>488.8</c:v>
                </c:pt>
                <c:pt idx="310">
                  <c:v>488.6</c:v>
                </c:pt>
                <c:pt idx="311">
                  <c:v>488.4</c:v>
                </c:pt>
                <c:pt idx="312">
                  <c:v>488.2</c:v>
                </c:pt>
                <c:pt idx="313">
                  <c:v>488</c:v>
                </c:pt>
                <c:pt idx="314">
                  <c:v>487.8</c:v>
                </c:pt>
                <c:pt idx="315">
                  <c:v>487.6</c:v>
                </c:pt>
                <c:pt idx="316">
                  <c:v>487.4</c:v>
                </c:pt>
                <c:pt idx="317">
                  <c:v>487.2</c:v>
                </c:pt>
                <c:pt idx="318">
                  <c:v>487</c:v>
                </c:pt>
                <c:pt idx="319">
                  <c:v>486.8</c:v>
                </c:pt>
                <c:pt idx="320">
                  <c:v>486.6</c:v>
                </c:pt>
                <c:pt idx="321">
                  <c:v>486.4</c:v>
                </c:pt>
                <c:pt idx="322">
                  <c:v>486.2</c:v>
                </c:pt>
                <c:pt idx="323">
                  <c:v>486</c:v>
                </c:pt>
                <c:pt idx="324">
                  <c:v>485.8</c:v>
                </c:pt>
                <c:pt idx="325">
                  <c:v>485.6</c:v>
                </c:pt>
                <c:pt idx="326">
                  <c:v>485.4</c:v>
                </c:pt>
                <c:pt idx="327">
                  <c:v>485.2</c:v>
                </c:pt>
                <c:pt idx="328">
                  <c:v>485</c:v>
                </c:pt>
                <c:pt idx="329">
                  <c:v>484.8</c:v>
                </c:pt>
                <c:pt idx="330">
                  <c:v>484.6</c:v>
                </c:pt>
                <c:pt idx="331">
                  <c:v>484.4</c:v>
                </c:pt>
                <c:pt idx="332">
                  <c:v>484.2</c:v>
                </c:pt>
                <c:pt idx="333">
                  <c:v>484</c:v>
                </c:pt>
                <c:pt idx="334">
                  <c:v>483.8</c:v>
                </c:pt>
                <c:pt idx="335">
                  <c:v>483.6</c:v>
                </c:pt>
                <c:pt idx="336">
                  <c:v>483.4</c:v>
                </c:pt>
                <c:pt idx="337">
                  <c:v>483.2</c:v>
                </c:pt>
                <c:pt idx="338">
                  <c:v>483</c:v>
                </c:pt>
                <c:pt idx="339">
                  <c:v>482.8</c:v>
                </c:pt>
                <c:pt idx="340">
                  <c:v>482.6</c:v>
                </c:pt>
                <c:pt idx="341">
                  <c:v>482.4</c:v>
                </c:pt>
                <c:pt idx="342">
                  <c:v>482.2</c:v>
                </c:pt>
                <c:pt idx="343">
                  <c:v>482</c:v>
                </c:pt>
                <c:pt idx="344">
                  <c:v>481.8</c:v>
                </c:pt>
                <c:pt idx="345">
                  <c:v>481.6</c:v>
                </c:pt>
                <c:pt idx="346">
                  <c:v>481.4</c:v>
                </c:pt>
                <c:pt idx="347">
                  <c:v>481.2</c:v>
                </c:pt>
                <c:pt idx="348">
                  <c:v>481</c:v>
                </c:pt>
                <c:pt idx="349">
                  <c:v>480.8</c:v>
                </c:pt>
                <c:pt idx="350">
                  <c:v>480.6</c:v>
                </c:pt>
                <c:pt idx="351">
                  <c:v>480.4</c:v>
                </c:pt>
                <c:pt idx="352">
                  <c:v>480.2</c:v>
                </c:pt>
                <c:pt idx="353">
                  <c:v>480</c:v>
                </c:pt>
                <c:pt idx="354">
                  <c:v>479.8</c:v>
                </c:pt>
                <c:pt idx="355">
                  <c:v>479.6</c:v>
                </c:pt>
                <c:pt idx="356">
                  <c:v>479.4</c:v>
                </c:pt>
                <c:pt idx="357">
                  <c:v>479.2</c:v>
                </c:pt>
                <c:pt idx="358">
                  <c:v>479</c:v>
                </c:pt>
                <c:pt idx="359">
                  <c:v>478.8</c:v>
                </c:pt>
                <c:pt idx="360">
                  <c:v>478.6</c:v>
                </c:pt>
                <c:pt idx="361">
                  <c:v>478.4</c:v>
                </c:pt>
                <c:pt idx="362">
                  <c:v>478.2</c:v>
                </c:pt>
                <c:pt idx="363">
                  <c:v>478</c:v>
                </c:pt>
                <c:pt idx="364">
                  <c:v>477.8</c:v>
                </c:pt>
                <c:pt idx="365">
                  <c:v>477.6</c:v>
                </c:pt>
                <c:pt idx="366">
                  <c:v>477.4</c:v>
                </c:pt>
                <c:pt idx="367">
                  <c:v>477.2</c:v>
                </c:pt>
                <c:pt idx="368">
                  <c:v>477</c:v>
                </c:pt>
                <c:pt idx="369">
                  <c:v>476.8</c:v>
                </c:pt>
                <c:pt idx="370">
                  <c:v>476.6</c:v>
                </c:pt>
                <c:pt idx="371">
                  <c:v>476.4</c:v>
                </c:pt>
                <c:pt idx="372">
                  <c:v>476.2</c:v>
                </c:pt>
                <c:pt idx="373">
                  <c:v>476</c:v>
                </c:pt>
                <c:pt idx="374">
                  <c:v>475.8</c:v>
                </c:pt>
                <c:pt idx="375">
                  <c:v>475.6</c:v>
                </c:pt>
                <c:pt idx="376">
                  <c:v>475.4</c:v>
                </c:pt>
                <c:pt idx="377">
                  <c:v>475.2</c:v>
                </c:pt>
                <c:pt idx="378">
                  <c:v>475</c:v>
                </c:pt>
                <c:pt idx="379">
                  <c:v>474.8</c:v>
                </c:pt>
                <c:pt idx="380">
                  <c:v>474.6</c:v>
                </c:pt>
                <c:pt idx="381">
                  <c:v>474.4</c:v>
                </c:pt>
                <c:pt idx="382">
                  <c:v>474.2</c:v>
                </c:pt>
                <c:pt idx="383">
                  <c:v>474</c:v>
                </c:pt>
                <c:pt idx="384">
                  <c:v>473.8</c:v>
                </c:pt>
                <c:pt idx="385">
                  <c:v>473.6</c:v>
                </c:pt>
                <c:pt idx="386">
                  <c:v>473.4</c:v>
                </c:pt>
                <c:pt idx="387">
                  <c:v>473.2</c:v>
                </c:pt>
                <c:pt idx="388">
                  <c:v>473</c:v>
                </c:pt>
                <c:pt idx="389">
                  <c:v>472.8</c:v>
                </c:pt>
                <c:pt idx="390">
                  <c:v>472.6</c:v>
                </c:pt>
                <c:pt idx="391">
                  <c:v>472.4</c:v>
                </c:pt>
                <c:pt idx="392">
                  <c:v>472.2</c:v>
                </c:pt>
                <c:pt idx="393">
                  <c:v>472</c:v>
                </c:pt>
                <c:pt idx="394">
                  <c:v>471.8</c:v>
                </c:pt>
                <c:pt idx="395">
                  <c:v>471.6</c:v>
                </c:pt>
                <c:pt idx="396">
                  <c:v>471.4</c:v>
                </c:pt>
                <c:pt idx="397">
                  <c:v>471.2</c:v>
                </c:pt>
                <c:pt idx="398">
                  <c:v>471</c:v>
                </c:pt>
                <c:pt idx="399">
                  <c:v>470.8</c:v>
                </c:pt>
                <c:pt idx="400">
                  <c:v>470.6</c:v>
                </c:pt>
                <c:pt idx="401">
                  <c:v>470.4</c:v>
                </c:pt>
                <c:pt idx="402">
                  <c:v>470.2</c:v>
                </c:pt>
                <c:pt idx="403">
                  <c:v>470</c:v>
                </c:pt>
                <c:pt idx="404">
                  <c:v>469.8</c:v>
                </c:pt>
                <c:pt idx="405">
                  <c:v>469.6</c:v>
                </c:pt>
                <c:pt idx="406">
                  <c:v>469.4</c:v>
                </c:pt>
                <c:pt idx="407">
                  <c:v>469.2</c:v>
                </c:pt>
                <c:pt idx="408">
                  <c:v>469</c:v>
                </c:pt>
                <c:pt idx="409">
                  <c:v>468.8</c:v>
                </c:pt>
                <c:pt idx="410">
                  <c:v>468.6</c:v>
                </c:pt>
                <c:pt idx="411">
                  <c:v>468.4</c:v>
                </c:pt>
                <c:pt idx="412">
                  <c:v>468.2</c:v>
                </c:pt>
                <c:pt idx="413">
                  <c:v>468</c:v>
                </c:pt>
                <c:pt idx="414">
                  <c:v>467.8</c:v>
                </c:pt>
                <c:pt idx="415">
                  <c:v>467.6</c:v>
                </c:pt>
                <c:pt idx="416">
                  <c:v>467.4</c:v>
                </c:pt>
                <c:pt idx="417">
                  <c:v>467.2</c:v>
                </c:pt>
                <c:pt idx="418">
                  <c:v>467</c:v>
                </c:pt>
                <c:pt idx="419">
                  <c:v>466.8</c:v>
                </c:pt>
                <c:pt idx="420">
                  <c:v>466.6</c:v>
                </c:pt>
                <c:pt idx="421">
                  <c:v>466.4</c:v>
                </c:pt>
                <c:pt idx="422">
                  <c:v>466.2</c:v>
                </c:pt>
                <c:pt idx="423">
                  <c:v>466</c:v>
                </c:pt>
                <c:pt idx="424">
                  <c:v>465.8</c:v>
                </c:pt>
                <c:pt idx="425">
                  <c:v>465.6</c:v>
                </c:pt>
                <c:pt idx="426">
                  <c:v>465.4</c:v>
                </c:pt>
                <c:pt idx="427">
                  <c:v>465.2</c:v>
                </c:pt>
                <c:pt idx="428">
                  <c:v>465</c:v>
                </c:pt>
                <c:pt idx="429">
                  <c:v>464.8</c:v>
                </c:pt>
                <c:pt idx="430">
                  <c:v>464.6</c:v>
                </c:pt>
                <c:pt idx="431">
                  <c:v>464.4</c:v>
                </c:pt>
                <c:pt idx="432">
                  <c:v>464.2</c:v>
                </c:pt>
                <c:pt idx="433">
                  <c:v>464</c:v>
                </c:pt>
                <c:pt idx="434">
                  <c:v>463.8</c:v>
                </c:pt>
                <c:pt idx="435">
                  <c:v>463.6</c:v>
                </c:pt>
                <c:pt idx="436">
                  <c:v>463.4</c:v>
                </c:pt>
                <c:pt idx="437">
                  <c:v>463.2</c:v>
                </c:pt>
                <c:pt idx="438">
                  <c:v>463</c:v>
                </c:pt>
                <c:pt idx="439">
                  <c:v>462.8</c:v>
                </c:pt>
                <c:pt idx="440">
                  <c:v>462.6</c:v>
                </c:pt>
                <c:pt idx="441">
                  <c:v>462.4</c:v>
                </c:pt>
                <c:pt idx="442">
                  <c:v>462.2</c:v>
                </c:pt>
                <c:pt idx="443">
                  <c:v>462</c:v>
                </c:pt>
                <c:pt idx="444">
                  <c:v>461.8</c:v>
                </c:pt>
                <c:pt idx="445">
                  <c:v>461.6</c:v>
                </c:pt>
                <c:pt idx="446">
                  <c:v>461.4</c:v>
                </c:pt>
                <c:pt idx="447">
                  <c:v>461.2</c:v>
                </c:pt>
                <c:pt idx="448">
                  <c:v>461</c:v>
                </c:pt>
                <c:pt idx="449">
                  <c:v>460.8</c:v>
                </c:pt>
                <c:pt idx="450">
                  <c:v>460.6</c:v>
                </c:pt>
                <c:pt idx="451">
                  <c:v>460.4</c:v>
                </c:pt>
                <c:pt idx="452">
                  <c:v>460.2</c:v>
                </c:pt>
                <c:pt idx="453">
                  <c:v>460</c:v>
                </c:pt>
                <c:pt idx="454">
                  <c:v>459.8</c:v>
                </c:pt>
                <c:pt idx="455">
                  <c:v>459.6</c:v>
                </c:pt>
                <c:pt idx="456">
                  <c:v>459.4</c:v>
                </c:pt>
                <c:pt idx="457">
                  <c:v>459.2</c:v>
                </c:pt>
                <c:pt idx="458">
                  <c:v>459</c:v>
                </c:pt>
                <c:pt idx="459">
                  <c:v>458.8</c:v>
                </c:pt>
                <c:pt idx="460">
                  <c:v>458.6</c:v>
                </c:pt>
                <c:pt idx="461">
                  <c:v>458.4</c:v>
                </c:pt>
                <c:pt idx="462">
                  <c:v>458.2</c:v>
                </c:pt>
                <c:pt idx="463">
                  <c:v>458</c:v>
                </c:pt>
                <c:pt idx="464">
                  <c:v>457.8</c:v>
                </c:pt>
                <c:pt idx="465">
                  <c:v>457.6</c:v>
                </c:pt>
                <c:pt idx="466">
                  <c:v>457.4</c:v>
                </c:pt>
                <c:pt idx="467">
                  <c:v>457.2</c:v>
                </c:pt>
                <c:pt idx="468">
                  <c:v>457</c:v>
                </c:pt>
                <c:pt idx="469">
                  <c:v>456.8</c:v>
                </c:pt>
                <c:pt idx="470">
                  <c:v>456.6</c:v>
                </c:pt>
                <c:pt idx="471">
                  <c:v>456.4</c:v>
                </c:pt>
                <c:pt idx="472">
                  <c:v>456.2</c:v>
                </c:pt>
                <c:pt idx="473">
                  <c:v>456</c:v>
                </c:pt>
                <c:pt idx="474">
                  <c:v>455.8</c:v>
                </c:pt>
                <c:pt idx="475">
                  <c:v>455.6</c:v>
                </c:pt>
                <c:pt idx="476">
                  <c:v>455.4</c:v>
                </c:pt>
                <c:pt idx="477">
                  <c:v>455.2</c:v>
                </c:pt>
                <c:pt idx="478">
                  <c:v>455</c:v>
                </c:pt>
                <c:pt idx="479">
                  <c:v>454.8</c:v>
                </c:pt>
                <c:pt idx="480">
                  <c:v>454.6</c:v>
                </c:pt>
                <c:pt idx="481">
                  <c:v>454.4</c:v>
                </c:pt>
                <c:pt idx="482">
                  <c:v>454.2</c:v>
                </c:pt>
                <c:pt idx="483">
                  <c:v>454</c:v>
                </c:pt>
                <c:pt idx="484">
                  <c:v>453.8</c:v>
                </c:pt>
                <c:pt idx="485">
                  <c:v>453.6</c:v>
                </c:pt>
                <c:pt idx="486">
                  <c:v>453.4</c:v>
                </c:pt>
                <c:pt idx="487">
                  <c:v>453.2</c:v>
                </c:pt>
                <c:pt idx="488">
                  <c:v>453</c:v>
                </c:pt>
                <c:pt idx="489">
                  <c:v>452.8</c:v>
                </c:pt>
                <c:pt idx="490">
                  <c:v>452.6</c:v>
                </c:pt>
                <c:pt idx="491">
                  <c:v>452.4</c:v>
                </c:pt>
                <c:pt idx="492">
                  <c:v>452.2</c:v>
                </c:pt>
                <c:pt idx="493">
                  <c:v>452</c:v>
                </c:pt>
                <c:pt idx="494">
                  <c:v>451.8</c:v>
                </c:pt>
                <c:pt idx="495">
                  <c:v>451.6</c:v>
                </c:pt>
                <c:pt idx="496">
                  <c:v>451.4</c:v>
                </c:pt>
                <c:pt idx="497">
                  <c:v>451.2</c:v>
                </c:pt>
                <c:pt idx="498">
                  <c:v>451</c:v>
                </c:pt>
                <c:pt idx="499">
                  <c:v>450.8</c:v>
                </c:pt>
                <c:pt idx="500">
                  <c:v>450.6</c:v>
                </c:pt>
                <c:pt idx="501">
                  <c:v>450.4</c:v>
                </c:pt>
                <c:pt idx="502">
                  <c:v>450.2</c:v>
                </c:pt>
                <c:pt idx="503">
                  <c:v>450</c:v>
                </c:pt>
                <c:pt idx="504">
                  <c:v>449.8</c:v>
                </c:pt>
                <c:pt idx="505">
                  <c:v>449.6</c:v>
                </c:pt>
                <c:pt idx="506">
                  <c:v>449.4</c:v>
                </c:pt>
                <c:pt idx="507">
                  <c:v>449.2</c:v>
                </c:pt>
                <c:pt idx="508">
                  <c:v>449</c:v>
                </c:pt>
                <c:pt idx="509">
                  <c:v>448.8</c:v>
                </c:pt>
                <c:pt idx="510">
                  <c:v>448.6</c:v>
                </c:pt>
                <c:pt idx="511">
                  <c:v>448.4</c:v>
                </c:pt>
                <c:pt idx="512">
                  <c:v>448.2</c:v>
                </c:pt>
                <c:pt idx="513">
                  <c:v>448</c:v>
                </c:pt>
                <c:pt idx="514">
                  <c:v>447.8</c:v>
                </c:pt>
                <c:pt idx="515">
                  <c:v>447.6</c:v>
                </c:pt>
                <c:pt idx="516">
                  <c:v>447.4</c:v>
                </c:pt>
                <c:pt idx="517">
                  <c:v>447.2</c:v>
                </c:pt>
                <c:pt idx="518">
                  <c:v>447</c:v>
                </c:pt>
                <c:pt idx="519">
                  <c:v>446.8</c:v>
                </c:pt>
                <c:pt idx="520">
                  <c:v>446.6</c:v>
                </c:pt>
                <c:pt idx="521">
                  <c:v>446.4</c:v>
                </c:pt>
                <c:pt idx="522">
                  <c:v>446.2</c:v>
                </c:pt>
                <c:pt idx="523">
                  <c:v>446</c:v>
                </c:pt>
                <c:pt idx="524">
                  <c:v>445.8</c:v>
                </c:pt>
                <c:pt idx="525">
                  <c:v>445.6</c:v>
                </c:pt>
                <c:pt idx="526">
                  <c:v>445.4</c:v>
                </c:pt>
                <c:pt idx="527">
                  <c:v>445.2</c:v>
                </c:pt>
                <c:pt idx="528">
                  <c:v>445</c:v>
                </c:pt>
                <c:pt idx="529">
                  <c:v>444.8</c:v>
                </c:pt>
                <c:pt idx="530">
                  <c:v>444.6</c:v>
                </c:pt>
                <c:pt idx="531">
                  <c:v>444.4</c:v>
                </c:pt>
                <c:pt idx="532">
                  <c:v>444.2</c:v>
                </c:pt>
                <c:pt idx="533">
                  <c:v>444</c:v>
                </c:pt>
                <c:pt idx="534">
                  <c:v>443.8</c:v>
                </c:pt>
                <c:pt idx="535">
                  <c:v>443.6</c:v>
                </c:pt>
                <c:pt idx="536">
                  <c:v>443.4</c:v>
                </c:pt>
                <c:pt idx="537">
                  <c:v>443.2</c:v>
                </c:pt>
                <c:pt idx="538">
                  <c:v>443</c:v>
                </c:pt>
                <c:pt idx="539">
                  <c:v>442.8</c:v>
                </c:pt>
                <c:pt idx="540">
                  <c:v>442.6</c:v>
                </c:pt>
                <c:pt idx="541">
                  <c:v>442.4</c:v>
                </c:pt>
                <c:pt idx="542">
                  <c:v>442.2</c:v>
                </c:pt>
                <c:pt idx="543">
                  <c:v>442</c:v>
                </c:pt>
                <c:pt idx="544">
                  <c:v>441.8</c:v>
                </c:pt>
                <c:pt idx="545">
                  <c:v>441.6</c:v>
                </c:pt>
                <c:pt idx="546">
                  <c:v>441.4</c:v>
                </c:pt>
                <c:pt idx="547">
                  <c:v>441.2</c:v>
                </c:pt>
                <c:pt idx="548">
                  <c:v>441</c:v>
                </c:pt>
                <c:pt idx="549">
                  <c:v>440.8</c:v>
                </c:pt>
                <c:pt idx="550">
                  <c:v>440.6</c:v>
                </c:pt>
                <c:pt idx="551">
                  <c:v>440.4</c:v>
                </c:pt>
                <c:pt idx="552">
                  <c:v>440.2</c:v>
                </c:pt>
                <c:pt idx="553">
                  <c:v>440</c:v>
                </c:pt>
                <c:pt idx="554">
                  <c:v>439.8</c:v>
                </c:pt>
                <c:pt idx="555">
                  <c:v>439.6</c:v>
                </c:pt>
                <c:pt idx="556">
                  <c:v>439.4</c:v>
                </c:pt>
                <c:pt idx="557">
                  <c:v>439.2</c:v>
                </c:pt>
                <c:pt idx="558">
                  <c:v>439</c:v>
                </c:pt>
                <c:pt idx="559">
                  <c:v>438.8</c:v>
                </c:pt>
                <c:pt idx="560">
                  <c:v>438.6</c:v>
                </c:pt>
                <c:pt idx="561">
                  <c:v>438.4</c:v>
                </c:pt>
                <c:pt idx="562">
                  <c:v>438.2</c:v>
                </c:pt>
                <c:pt idx="563">
                  <c:v>438</c:v>
                </c:pt>
                <c:pt idx="564">
                  <c:v>437.8</c:v>
                </c:pt>
                <c:pt idx="565">
                  <c:v>437.6</c:v>
                </c:pt>
                <c:pt idx="566">
                  <c:v>437.4</c:v>
                </c:pt>
                <c:pt idx="567">
                  <c:v>437.2</c:v>
                </c:pt>
                <c:pt idx="568">
                  <c:v>437</c:v>
                </c:pt>
                <c:pt idx="569">
                  <c:v>436.8</c:v>
                </c:pt>
                <c:pt idx="570">
                  <c:v>436.6</c:v>
                </c:pt>
                <c:pt idx="571">
                  <c:v>436.4</c:v>
                </c:pt>
                <c:pt idx="572">
                  <c:v>436.2</c:v>
                </c:pt>
                <c:pt idx="573">
                  <c:v>436</c:v>
                </c:pt>
                <c:pt idx="574">
                  <c:v>435.8</c:v>
                </c:pt>
                <c:pt idx="575">
                  <c:v>435.6</c:v>
                </c:pt>
                <c:pt idx="576">
                  <c:v>435.4</c:v>
                </c:pt>
                <c:pt idx="577">
                  <c:v>435.2</c:v>
                </c:pt>
                <c:pt idx="578">
                  <c:v>435</c:v>
                </c:pt>
                <c:pt idx="579">
                  <c:v>434.8</c:v>
                </c:pt>
                <c:pt idx="580">
                  <c:v>434.6</c:v>
                </c:pt>
                <c:pt idx="581">
                  <c:v>434.4</c:v>
                </c:pt>
                <c:pt idx="582">
                  <c:v>434.2</c:v>
                </c:pt>
                <c:pt idx="583">
                  <c:v>434</c:v>
                </c:pt>
                <c:pt idx="584">
                  <c:v>433.8</c:v>
                </c:pt>
                <c:pt idx="585">
                  <c:v>433.6</c:v>
                </c:pt>
                <c:pt idx="586">
                  <c:v>433.4</c:v>
                </c:pt>
                <c:pt idx="587">
                  <c:v>433.2</c:v>
                </c:pt>
                <c:pt idx="588">
                  <c:v>433</c:v>
                </c:pt>
                <c:pt idx="589">
                  <c:v>432.8</c:v>
                </c:pt>
                <c:pt idx="590">
                  <c:v>432.6</c:v>
                </c:pt>
                <c:pt idx="591">
                  <c:v>432.4</c:v>
                </c:pt>
                <c:pt idx="592">
                  <c:v>432.2</c:v>
                </c:pt>
                <c:pt idx="593">
                  <c:v>432</c:v>
                </c:pt>
                <c:pt idx="594">
                  <c:v>431.8</c:v>
                </c:pt>
                <c:pt idx="595">
                  <c:v>431.6</c:v>
                </c:pt>
                <c:pt idx="596">
                  <c:v>431.4</c:v>
                </c:pt>
                <c:pt idx="597">
                  <c:v>431.2</c:v>
                </c:pt>
                <c:pt idx="598">
                  <c:v>431</c:v>
                </c:pt>
                <c:pt idx="599">
                  <c:v>430.8</c:v>
                </c:pt>
                <c:pt idx="600">
                  <c:v>430.6</c:v>
                </c:pt>
                <c:pt idx="601">
                  <c:v>430.4</c:v>
                </c:pt>
                <c:pt idx="602">
                  <c:v>430.2</c:v>
                </c:pt>
                <c:pt idx="603">
                  <c:v>430</c:v>
                </c:pt>
                <c:pt idx="604">
                  <c:v>429.8</c:v>
                </c:pt>
                <c:pt idx="605">
                  <c:v>429.6</c:v>
                </c:pt>
                <c:pt idx="606">
                  <c:v>429.4</c:v>
                </c:pt>
                <c:pt idx="607">
                  <c:v>429.2</c:v>
                </c:pt>
                <c:pt idx="608">
                  <c:v>429</c:v>
                </c:pt>
                <c:pt idx="609">
                  <c:v>428.8</c:v>
                </c:pt>
                <c:pt idx="610">
                  <c:v>428.6</c:v>
                </c:pt>
                <c:pt idx="611">
                  <c:v>428.4</c:v>
                </c:pt>
                <c:pt idx="612">
                  <c:v>428.2</c:v>
                </c:pt>
                <c:pt idx="613">
                  <c:v>428</c:v>
                </c:pt>
                <c:pt idx="614">
                  <c:v>427.8</c:v>
                </c:pt>
                <c:pt idx="615">
                  <c:v>427.6</c:v>
                </c:pt>
                <c:pt idx="616">
                  <c:v>427.4</c:v>
                </c:pt>
                <c:pt idx="617">
                  <c:v>427.2</c:v>
                </c:pt>
                <c:pt idx="618">
                  <c:v>427</c:v>
                </c:pt>
                <c:pt idx="619">
                  <c:v>426.8</c:v>
                </c:pt>
                <c:pt idx="620">
                  <c:v>426.6</c:v>
                </c:pt>
                <c:pt idx="621">
                  <c:v>426.4</c:v>
                </c:pt>
                <c:pt idx="622">
                  <c:v>426.2</c:v>
                </c:pt>
                <c:pt idx="623">
                  <c:v>426</c:v>
                </c:pt>
                <c:pt idx="624">
                  <c:v>425.8</c:v>
                </c:pt>
                <c:pt idx="625">
                  <c:v>425.6</c:v>
                </c:pt>
                <c:pt idx="626">
                  <c:v>425.4</c:v>
                </c:pt>
                <c:pt idx="627">
                  <c:v>425.2</c:v>
                </c:pt>
                <c:pt idx="628">
                  <c:v>425</c:v>
                </c:pt>
                <c:pt idx="629">
                  <c:v>424.8</c:v>
                </c:pt>
                <c:pt idx="630">
                  <c:v>424.6</c:v>
                </c:pt>
                <c:pt idx="631">
                  <c:v>424.4</c:v>
                </c:pt>
                <c:pt idx="632">
                  <c:v>424.2</c:v>
                </c:pt>
                <c:pt idx="633">
                  <c:v>424</c:v>
                </c:pt>
                <c:pt idx="634">
                  <c:v>423.8</c:v>
                </c:pt>
                <c:pt idx="635">
                  <c:v>423.6</c:v>
                </c:pt>
                <c:pt idx="636">
                  <c:v>423.4</c:v>
                </c:pt>
                <c:pt idx="637">
                  <c:v>423.2</c:v>
                </c:pt>
                <c:pt idx="638">
                  <c:v>423</c:v>
                </c:pt>
                <c:pt idx="639">
                  <c:v>422.8</c:v>
                </c:pt>
                <c:pt idx="640">
                  <c:v>422.6</c:v>
                </c:pt>
                <c:pt idx="641">
                  <c:v>422.4</c:v>
                </c:pt>
                <c:pt idx="642">
                  <c:v>422.2</c:v>
                </c:pt>
                <c:pt idx="643">
                  <c:v>422</c:v>
                </c:pt>
                <c:pt idx="644">
                  <c:v>421.8</c:v>
                </c:pt>
                <c:pt idx="645">
                  <c:v>421.6</c:v>
                </c:pt>
                <c:pt idx="646">
                  <c:v>421.4</c:v>
                </c:pt>
                <c:pt idx="647">
                  <c:v>421.2</c:v>
                </c:pt>
                <c:pt idx="648">
                  <c:v>421</c:v>
                </c:pt>
                <c:pt idx="649">
                  <c:v>420.8</c:v>
                </c:pt>
                <c:pt idx="650">
                  <c:v>420.6</c:v>
                </c:pt>
                <c:pt idx="651">
                  <c:v>420.4</c:v>
                </c:pt>
                <c:pt idx="652">
                  <c:v>420.2</c:v>
                </c:pt>
                <c:pt idx="653">
                  <c:v>420</c:v>
                </c:pt>
                <c:pt idx="654">
                  <c:v>419.8</c:v>
                </c:pt>
                <c:pt idx="655">
                  <c:v>419.6</c:v>
                </c:pt>
                <c:pt idx="656">
                  <c:v>419.4</c:v>
                </c:pt>
                <c:pt idx="657">
                  <c:v>419.2</c:v>
                </c:pt>
                <c:pt idx="658">
                  <c:v>419</c:v>
                </c:pt>
                <c:pt idx="659">
                  <c:v>418.8</c:v>
                </c:pt>
                <c:pt idx="660">
                  <c:v>418.6</c:v>
                </c:pt>
                <c:pt idx="661">
                  <c:v>418.4</c:v>
                </c:pt>
                <c:pt idx="662">
                  <c:v>418.2</c:v>
                </c:pt>
                <c:pt idx="663">
                  <c:v>418</c:v>
                </c:pt>
                <c:pt idx="664">
                  <c:v>417.8</c:v>
                </c:pt>
                <c:pt idx="665">
                  <c:v>417.6</c:v>
                </c:pt>
                <c:pt idx="666">
                  <c:v>417.4</c:v>
                </c:pt>
                <c:pt idx="667">
                  <c:v>417.2</c:v>
                </c:pt>
                <c:pt idx="668">
                  <c:v>417</c:v>
                </c:pt>
                <c:pt idx="669">
                  <c:v>416.8</c:v>
                </c:pt>
                <c:pt idx="670">
                  <c:v>416.6</c:v>
                </c:pt>
                <c:pt idx="671">
                  <c:v>416.4</c:v>
                </c:pt>
                <c:pt idx="672">
                  <c:v>416.2</c:v>
                </c:pt>
                <c:pt idx="673">
                  <c:v>416</c:v>
                </c:pt>
                <c:pt idx="674">
                  <c:v>415.8</c:v>
                </c:pt>
                <c:pt idx="675">
                  <c:v>415.6</c:v>
                </c:pt>
                <c:pt idx="676">
                  <c:v>415.4</c:v>
                </c:pt>
                <c:pt idx="677">
                  <c:v>415.2</c:v>
                </c:pt>
                <c:pt idx="678">
                  <c:v>415</c:v>
                </c:pt>
                <c:pt idx="679">
                  <c:v>414.8</c:v>
                </c:pt>
                <c:pt idx="680">
                  <c:v>414.6</c:v>
                </c:pt>
                <c:pt idx="681">
                  <c:v>414.4</c:v>
                </c:pt>
                <c:pt idx="682">
                  <c:v>414.2</c:v>
                </c:pt>
                <c:pt idx="683">
                  <c:v>414</c:v>
                </c:pt>
                <c:pt idx="684">
                  <c:v>413.8</c:v>
                </c:pt>
                <c:pt idx="685">
                  <c:v>413.6</c:v>
                </c:pt>
                <c:pt idx="686">
                  <c:v>413.4</c:v>
                </c:pt>
                <c:pt idx="687">
                  <c:v>413.2</c:v>
                </c:pt>
                <c:pt idx="688">
                  <c:v>413</c:v>
                </c:pt>
                <c:pt idx="689">
                  <c:v>412.8</c:v>
                </c:pt>
                <c:pt idx="690">
                  <c:v>412.6</c:v>
                </c:pt>
                <c:pt idx="691">
                  <c:v>412.4</c:v>
                </c:pt>
                <c:pt idx="692">
                  <c:v>412.2</c:v>
                </c:pt>
                <c:pt idx="693">
                  <c:v>412</c:v>
                </c:pt>
                <c:pt idx="694">
                  <c:v>411.8</c:v>
                </c:pt>
                <c:pt idx="695">
                  <c:v>411.6</c:v>
                </c:pt>
                <c:pt idx="696">
                  <c:v>411.4</c:v>
                </c:pt>
                <c:pt idx="697">
                  <c:v>411.2</c:v>
                </c:pt>
                <c:pt idx="698">
                  <c:v>411</c:v>
                </c:pt>
                <c:pt idx="699">
                  <c:v>410.8</c:v>
                </c:pt>
                <c:pt idx="700">
                  <c:v>410.6</c:v>
                </c:pt>
                <c:pt idx="701">
                  <c:v>410.4</c:v>
                </c:pt>
                <c:pt idx="702">
                  <c:v>410.2</c:v>
                </c:pt>
                <c:pt idx="703">
                  <c:v>410</c:v>
                </c:pt>
                <c:pt idx="704">
                  <c:v>409.8</c:v>
                </c:pt>
                <c:pt idx="705">
                  <c:v>409.6</c:v>
                </c:pt>
                <c:pt idx="706">
                  <c:v>409.4</c:v>
                </c:pt>
                <c:pt idx="707">
                  <c:v>409.2</c:v>
                </c:pt>
                <c:pt idx="708">
                  <c:v>409</c:v>
                </c:pt>
                <c:pt idx="709">
                  <c:v>408.8</c:v>
                </c:pt>
                <c:pt idx="710">
                  <c:v>408.6</c:v>
                </c:pt>
                <c:pt idx="711">
                  <c:v>408.4</c:v>
                </c:pt>
                <c:pt idx="712">
                  <c:v>408.2</c:v>
                </c:pt>
                <c:pt idx="713">
                  <c:v>408</c:v>
                </c:pt>
                <c:pt idx="714">
                  <c:v>407.8</c:v>
                </c:pt>
                <c:pt idx="715">
                  <c:v>407.6</c:v>
                </c:pt>
                <c:pt idx="716">
                  <c:v>407.4</c:v>
                </c:pt>
                <c:pt idx="717">
                  <c:v>407.2</c:v>
                </c:pt>
                <c:pt idx="718">
                  <c:v>407</c:v>
                </c:pt>
                <c:pt idx="719">
                  <c:v>406.8</c:v>
                </c:pt>
                <c:pt idx="720">
                  <c:v>406.6</c:v>
                </c:pt>
                <c:pt idx="721">
                  <c:v>406.4</c:v>
                </c:pt>
                <c:pt idx="722">
                  <c:v>406.2</c:v>
                </c:pt>
                <c:pt idx="723">
                  <c:v>406</c:v>
                </c:pt>
                <c:pt idx="724">
                  <c:v>405.8</c:v>
                </c:pt>
                <c:pt idx="725">
                  <c:v>405.6</c:v>
                </c:pt>
                <c:pt idx="726">
                  <c:v>405.4</c:v>
                </c:pt>
                <c:pt idx="727">
                  <c:v>405.2</c:v>
                </c:pt>
                <c:pt idx="728">
                  <c:v>405</c:v>
                </c:pt>
                <c:pt idx="729">
                  <c:v>404.8</c:v>
                </c:pt>
                <c:pt idx="730">
                  <c:v>404.6</c:v>
                </c:pt>
                <c:pt idx="731">
                  <c:v>404.4</c:v>
                </c:pt>
                <c:pt idx="732">
                  <c:v>404.2</c:v>
                </c:pt>
                <c:pt idx="733">
                  <c:v>404</c:v>
                </c:pt>
                <c:pt idx="734">
                  <c:v>403.8</c:v>
                </c:pt>
                <c:pt idx="735">
                  <c:v>403.6</c:v>
                </c:pt>
                <c:pt idx="736">
                  <c:v>403.4</c:v>
                </c:pt>
                <c:pt idx="737">
                  <c:v>403.2</c:v>
                </c:pt>
                <c:pt idx="738">
                  <c:v>403</c:v>
                </c:pt>
                <c:pt idx="739">
                  <c:v>402.8</c:v>
                </c:pt>
                <c:pt idx="740">
                  <c:v>402.6</c:v>
                </c:pt>
                <c:pt idx="741">
                  <c:v>402.4</c:v>
                </c:pt>
                <c:pt idx="742">
                  <c:v>402.2</c:v>
                </c:pt>
                <c:pt idx="743">
                  <c:v>402</c:v>
                </c:pt>
                <c:pt idx="744">
                  <c:v>401.8</c:v>
                </c:pt>
                <c:pt idx="745">
                  <c:v>401.6</c:v>
                </c:pt>
                <c:pt idx="746">
                  <c:v>401.4</c:v>
                </c:pt>
                <c:pt idx="747">
                  <c:v>401.2</c:v>
                </c:pt>
                <c:pt idx="748">
                  <c:v>401</c:v>
                </c:pt>
                <c:pt idx="749">
                  <c:v>400.8</c:v>
                </c:pt>
                <c:pt idx="750">
                  <c:v>400.6</c:v>
                </c:pt>
                <c:pt idx="751">
                  <c:v>400.4</c:v>
                </c:pt>
                <c:pt idx="752">
                  <c:v>400.2</c:v>
                </c:pt>
                <c:pt idx="753">
                  <c:v>400</c:v>
                </c:pt>
                <c:pt idx="754">
                  <c:v>399.8</c:v>
                </c:pt>
                <c:pt idx="755">
                  <c:v>399.6</c:v>
                </c:pt>
                <c:pt idx="756">
                  <c:v>399.4</c:v>
                </c:pt>
                <c:pt idx="757">
                  <c:v>399.2</c:v>
                </c:pt>
                <c:pt idx="758">
                  <c:v>399</c:v>
                </c:pt>
                <c:pt idx="759">
                  <c:v>398.8</c:v>
                </c:pt>
                <c:pt idx="760">
                  <c:v>398.6</c:v>
                </c:pt>
                <c:pt idx="761">
                  <c:v>398.4</c:v>
                </c:pt>
                <c:pt idx="762">
                  <c:v>398.2</c:v>
                </c:pt>
                <c:pt idx="763">
                  <c:v>398</c:v>
                </c:pt>
                <c:pt idx="764">
                  <c:v>397.8</c:v>
                </c:pt>
                <c:pt idx="765">
                  <c:v>397.6</c:v>
                </c:pt>
                <c:pt idx="766">
                  <c:v>397.4</c:v>
                </c:pt>
                <c:pt idx="767">
                  <c:v>397.2</c:v>
                </c:pt>
                <c:pt idx="768">
                  <c:v>397</c:v>
                </c:pt>
                <c:pt idx="769">
                  <c:v>396.8</c:v>
                </c:pt>
                <c:pt idx="770">
                  <c:v>396.6</c:v>
                </c:pt>
                <c:pt idx="771">
                  <c:v>396.4</c:v>
                </c:pt>
                <c:pt idx="772">
                  <c:v>396.2</c:v>
                </c:pt>
                <c:pt idx="773">
                  <c:v>396</c:v>
                </c:pt>
                <c:pt idx="774">
                  <c:v>395.8</c:v>
                </c:pt>
                <c:pt idx="775">
                  <c:v>395.6</c:v>
                </c:pt>
                <c:pt idx="776">
                  <c:v>395.4</c:v>
                </c:pt>
                <c:pt idx="777">
                  <c:v>395.2</c:v>
                </c:pt>
                <c:pt idx="778">
                  <c:v>395</c:v>
                </c:pt>
                <c:pt idx="779">
                  <c:v>394.8</c:v>
                </c:pt>
                <c:pt idx="780">
                  <c:v>394.6</c:v>
                </c:pt>
                <c:pt idx="781">
                  <c:v>394.4</c:v>
                </c:pt>
                <c:pt idx="782">
                  <c:v>394.2</c:v>
                </c:pt>
                <c:pt idx="783">
                  <c:v>394</c:v>
                </c:pt>
                <c:pt idx="784">
                  <c:v>393.8</c:v>
                </c:pt>
                <c:pt idx="785">
                  <c:v>393.6</c:v>
                </c:pt>
                <c:pt idx="786">
                  <c:v>393.4</c:v>
                </c:pt>
                <c:pt idx="787">
                  <c:v>393.2</c:v>
                </c:pt>
                <c:pt idx="788">
                  <c:v>393</c:v>
                </c:pt>
                <c:pt idx="789">
                  <c:v>392.8</c:v>
                </c:pt>
                <c:pt idx="790">
                  <c:v>392.6</c:v>
                </c:pt>
                <c:pt idx="791">
                  <c:v>392.4</c:v>
                </c:pt>
                <c:pt idx="792">
                  <c:v>392.2</c:v>
                </c:pt>
                <c:pt idx="793">
                  <c:v>392</c:v>
                </c:pt>
                <c:pt idx="794">
                  <c:v>391.8</c:v>
                </c:pt>
                <c:pt idx="795">
                  <c:v>391.6</c:v>
                </c:pt>
                <c:pt idx="796">
                  <c:v>391.4</c:v>
                </c:pt>
                <c:pt idx="797">
                  <c:v>391.2</c:v>
                </c:pt>
                <c:pt idx="798">
                  <c:v>391</c:v>
                </c:pt>
                <c:pt idx="799">
                  <c:v>390.8</c:v>
                </c:pt>
                <c:pt idx="800">
                  <c:v>390.6</c:v>
                </c:pt>
                <c:pt idx="801">
                  <c:v>390.4</c:v>
                </c:pt>
                <c:pt idx="802">
                  <c:v>390.2</c:v>
                </c:pt>
                <c:pt idx="803">
                  <c:v>390</c:v>
                </c:pt>
                <c:pt idx="804">
                  <c:v>389.8</c:v>
                </c:pt>
                <c:pt idx="805">
                  <c:v>389.6</c:v>
                </c:pt>
                <c:pt idx="806">
                  <c:v>389.4</c:v>
                </c:pt>
                <c:pt idx="807">
                  <c:v>389.2</c:v>
                </c:pt>
                <c:pt idx="808">
                  <c:v>389</c:v>
                </c:pt>
                <c:pt idx="809">
                  <c:v>388.8</c:v>
                </c:pt>
                <c:pt idx="810">
                  <c:v>388.6</c:v>
                </c:pt>
                <c:pt idx="811">
                  <c:v>388.4</c:v>
                </c:pt>
                <c:pt idx="812">
                  <c:v>388.2</c:v>
                </c:pt>
                <c:pt idx="813">
                  <c:v>388</c:v>
                </c:pt>
                <c:pt idx="814">
                  <c:v>387.8</c:v>
                </c:pt>
                <c:pt idx="815">
                  <c:v>387.6</c:v>
                </c:pt>
                <c:pt idx="816">
                  <c:v>387.4</c:v>
                </c:pt>
                <c:pt idx="817">
                  <c:v>387.2</c:v>
                </c:pt>
                <c:pt idx="818">
                  <c:v>387</c:v>
                </c:pt>
                <c:pt idx="819">
                  <c:v>386.8</c:v>
                </c:pt>
                <c:pt idx="820">
                  <c:v>386.6</c:v>
                </c:pt>
                <c:pt idx="821">
                  <c:v>386.4</c:v>
                </c:pt>
                <c:pt idx="822">
                  <c:v>386.2</c:v>
                </c:pt>
                <c:pt idx="823">
                  <c:v>386</c:v>
                </c:pt>
                <c:pt idx="824">
                  <c:v>385.8</c:v>
                </c:pt>
                <c:pt idx="825">
                  <c:v>385.6</c:v>
                </c:pt>
                <c:pt idx="826">
                  <c:v>385.4</c:v>
                </c:pt>
                <c:pt idx="827">
                  <c:v>385.2</c:v>
                </c:pt>
                <c:pt idx="828">
                  <c:v>385</c:v>
                </c:pt>
                <c:pt idx="829">
                  <c:v>384.8</c:v>
                </c:pt>
                <c:pt idx="830">
                  <c:v>384.6</c:v>
                </c:pt>
                <c:pt idx="831">
                  <c:v>384.4</c:v>
                </c:pt>
                <c:pt idx="832">
                  <c:v>384.2</c:v>
                </c:pt>
                <c:pt idx="833">
                  <c:v>384</c:v>
                </c:pt>
                <c:pt idx="834">
                  <c:v>383.8</c:v>
                </c:pt>
                <c:pt idx="835">
                  <c:v>383.6</c:v>
                </c:pt>
                <c:pt idx="836">
                  <c:v>383.4</c:v>
                </c:pt>
                <c:pt idx="837">
                  <c:v>383.2</c:v>
                </c:pt>
                <c:pt idx="838">
                  <c:v>383</c:v>
                </c:pt>
                <c:pt idx="839">
                  <c:v>382.8</c:v>
                </c:pt>
                <c:pt idx="840">
                  <c:v>382.6</c:v>
                </c:pt>
                <c:pt idx="841">
                  <c:v>382.4</c:v>
                </c:pt>
                <c:pt idx="842">
                  <c:v>382.2</c:v>
                </c:pt>
                <c:pt idx="843">
                  <c:v>382</c:v>
                </c:pt>
                <c:pt idx="844">
                  <c:v>381.8</c:v>
                </c:pt>
                <c:pt idx="845">
                  <c:v>381.6</c:v>
                </c:pt>
                <c:pt idx="846">
                  <c:v>381.4</c:v>
                </c:pt>
                <c:pt idx="847">
                  <c:v>381.2</c:v>
                </c:pt>
                <c:pt idx="848">
                  <c:v>381</c:v>
                </c:pt>
                <c:pt idx="849">
                  <c:v>380.8</c:v>
                </c:pt>
                <c:pt idx="850">
                  <c:v>380.6</c:v>
                </c:pt>
                <c:pt idx="851">
                  <c:v>380.4</c:v>
                </c:pt>
                <c:pt idx="852">
                  <c:v>380.2</c:v>
                </c:pt>
                <c:pt idx="853">
                  <c:v>380</c:v>
                </c:pt>
                <c:pt idx="854">
                  <c:v>379.8</c:v>
                </c:pt>
                <c:pt idx="855">
                  <c:v>379.6</c:v>
                </c:pt>
                <c:pt idx="856">
                  <c:v>379.4</c:v>
                </c:pt>
                <c:pt idx="857">
                  <c:v>379.2</c:v>
                </c:pt>
                <c:pt idx="858">
                  <c:v>379</c:v>
                </c:pt>
                <c:pt idx="859">
                  <c:v>378.8</c:v>
                </c:pt>
                <c:pt idx="860">
                  <c:v>378.6</c:v>
                </c:pt>
                <c:pt idx="861">
                  <c:v>378.4</c:v>
                </c:pt>
                <c:pt idx="862">
                  <c:v>378.2</c:v>
                </c:pt>
                <c:pt idx="863">
                  <c:v>378</c:v>
                </c:pt>
                <c:pt idx="864">
                  <c:v>377.8</c:v>
                </c:pt>
                <c:pt idx="865">
                  <c:v>377.6</c:v>
                </c:pt>
                <c:pt idx="866">
                  <c:v>377.4</c:v>
                </c:pt>
                <c:pt idx="867">
                  <c:v>377.2</c:v>
                </c:pt>
                <c:pt idx="868">
                  <c:v>377</c:v>
                </c:pt>
                <c:pt idx="869">
                  <c:v>376.8</c:v>
                </c:pt>
                <c:pt idx="870">
                  <c:v>376.6</c:v>
                </c:pt>
                <c:pt idx="871">
                  <c:v>376.4</c:v>
                </c:pt>
                <c:pt idx="872">
                  <c:v>376.2</c:v>
                </c:pt>
                <c:pt idx="873">
                  <c:v>376</c:v>
                </c:pt>
                <c:pt idx="874">
                  <c:v>375.8</c:v>
                </c:pt>
                <c:pt idx="875">
                  <c:v>375.6</c:v>
                </c:pt>
                <c:pt idx="876">
                  <c:v>375.4</c:v>
                </c:pt>
                <c:pt idx="877">
                  <c:v>375.2</c:v>
                </c:pt>
                <c:pt idx="878">
                  <c:v>375</c:v>
                </c:pt>
                <c:pt idx="879">
                  <c:v>374.8</c:v>
                </c:pt>
                <c:pt idx="880">
                  <c:v>374.6</c:v>
                </c:pt>
                <c:pt idx="881">
                  <c:v>374.4</c:v>
                </c:pt>
                <c:pt idx="882">
                  <c:v>374.2</c:v>
                </c:pt>
                <c:pt idx="883">
                  <c:v>374</c:v>
                </c:pt>
                <c:pt idx="884">
                  <c:v>373.8</c:v>
                </c:pt>
                <c:pt idx="885">
                  <c:v>373.6</c:v>
                </c:pt>
                <c:pt idx="886">
                  <c:v>373.4</c:v>
                </c:pt>
                <c:pt idx="887">
                  <c:v>373.2</c:v>
                </c:pt>
                <c:pt idx="888">
                  <c:v>373</c:v>
                </c:pt>
                <c:pt idx="889">
                  <c:v>372.8</c:v>
                </c:pt>
                <c:pt idx="890">
                  <c:v>372.6</c:v>
                </c:pt>
                <c:pt idx="891">
                  <c:v>372.4</c:v>
                </c:pt>
                <c:pt idx="892">
                  <c:v>372.2</c:v>
                </c:pt>
                <c:pt idx="893">
                  <c:v>372</c:v>
                </c:pt>
                <c:pt idx="894">
                  <c:v>371.8</c:v>
                </c:pt>
                <c:pt idx="895">
                  <c:v>371.6</c:v>
                </c:pt>
                <c:pt idx="896">
                  <c:v>371.4</c:v>
                </c:pt>
                <c:pt idx="897">
                  <c:v>371.2</c:v>
                </c:pt>
                <c:pt idx="898">
                  <c:v>371</c:v>
                </c:pt>
                <c:pt idx="899">
                  <c:v>370.8</c:v>
                </c:pt>
                <c:pt idx="900">
                  <c:v>370.6</c:v>
                </c:pt>
                <c:pt idx="901">
                  <c:v>370.4</c:v>
                </c:pt>
                <c:pt idx="902">
                  <c:v>370.2</c:v>
                </c:pt>
                <c:pt idx="903">
                  <c:v>370</c:v>
                </c:pt>
                <c:pt idx="904">
                  <c:v>369.8</c:v>
                </c:pt>
                <c:pt idx="905">
                  <c:v>369.6</c:v>
                </c:pt>
                <c:pt idx="906">
                  <c:v>369.4</c:v>
                </c:pt>
                <c:pt idx="907">
                  <c:v>369.2</c:v>
                </c:pt>
                <c:pt idx="908">
                  <c:v>369</c:v>
                </c:pt>
                <c:pt idx="909">
                  <c:v>368.8</c:v>
                </c:pt>
                <c:pt idx="910">
                  <c:v>368.6</c:v>
                </c:pt>
                <c:pt idx="911">
                  <c:v>368.4</c:v>
                </c:pt>
                <c:pt idx="912">
                  <c:v>368.2</c:v>
                </c:pt>
                <c:pt idx="913">
                  <c:v>368</c:v>
                </c:pt>
                <c:pt idx="914">
                  <c:v>367.8</c:v>
                </c:pt>
                <c:pt idx="915">
                  <c:v>367.6</c:v>
                </c:pt>
                <c:pt idx="916">
                  <c:v>367.4</c:v>
                </c:pt>
                <c:pt idx="917">
                  <c:v>367.2</c:v>
                </c:pt>
                <c:pt idx="918">
                  <c:v>367</c:v>
                </c:pt>
                <c:pt idx="919">
                  <c:v>366.8</c:v>
                </c:pt>
                <c:pt idx="920">
                  <c:v>366.6</c:v>
                </c:pt>
                <c:pt idx="921">
                  <c:v>366.4</c:v>
                </c:pt>
                <c:pt idx="922">
                  <c:v>366.2</c:v>
                </c:pt>
                <c:pt idx="923">
                  <c:v>366</c:v>
                </c:pt>
                <c:pt idx="924">
                  <c:v>365.8</c:v>
                </c:pt>
                <c:pt idx="925">
                  <c:v>365.6</c:v>
                </c:pt>
                <c:pt idx="926">
                  <c:v>365.4</c:v>
                </c:pt>
                <c:pt idx="927">
                  <c:v>365.2</c:v>
                </c:pt>
                <c:pt idx="928">
                  <c:v>365</c:v>
                </c:pt>
                <c:pt idx="929">
                  <c:v>364.8</c:v>
                </c:pt>
                <c:pt idx="930">
                  <c:v>364.6</c:v>
                </c:pt>
                <c:pt idx="931">
                  <c:v>364.4</c:v>
                </c:pt>
                <c:pt idx="932">
                  <c:v>364.2</c:v>
                </c:pt>
                <c:pt idx="933">
                  <c:v>364</c:v>
                </c:pt>
                <c:pt idx="934">
                  <c:v>363.8</c:v>
                </c:pt>
                <c:pt idx="935">
                  <c:v>363.6</c:v>
                </c:pt>
                <c:pt idx="936">
                  <c:v>363.4</c:v>
                </c:pt>
                <c:pt idx="937">
                  <c:v>363.2</c:v>
                </c:pt>
                <c:pt idx="938">
                  <c:v>363</c:v>
                </c:pt>
                <c:pt idx="939">
                  <c:v>362.8</c:v>
                </c:pt>
                <c:pt idx="940">
                  <c:v>362.6</c:v>
                </c:pt>
                <c:pt idx="941">
                  <c:v>362.4</c:v>
                </c:pt>
                <c:pt idx="942">
                  <c:v>362.2</c:v>
                </c:pt>
                <c:pt idx="943">
                  <c:v>362</c:v>
                </c:pt>
                <c:pt idx="944">
                  <c:v>361.8</c:v>
                </c:pt>
                <c:pt idx="945">
                  <c:v>361.6</c:v>
                </c:pt>
                <c:pt idx="946">
                  <c:v>361.4</c:v>
                </c:pt>
                <c:pt idx="947">
                  <c:v>361.2</c:v>
                </c:pt>
                <c:pt idx="948">
                  <c:v>361</c:v>
                </c:pt>
                <c:pt idx="949">
                  <c:v>360.8</c:v>
                </c:pt>
                <c:pt idx="950">
                  <c:v>360.6</c:v>
                </c:pt>
                <c:pt idx="951">
                  <c:v>360.4</c:v>
                </c:pt>
                <c:pt idx="952">
                  <c:v>360.2</c:v>
                </c:pt>
                <c:pt idx="953">
                  <c:v>360</c:v>
                </c:pt>
                <c:pt idx="954">
                  <c:v>359.8</c:v>
                </c:pt>
                <c:pt idx="955">
                  <c:v>359.6</c:v>
                </c:pt>
                <c:pt idx="956">
                  <c:v>359.4</c:v>
                </c:pt>
                <c:pt idx="957">
                  <c:v>359.2</c:v>
                </c:pt>
                <c:pt idx="958">
                  <c:v>359</c:v>
                </c:pt>
                <c:pt idx="959">
                  <c:v>358.8</c:v>
                </c:pt>
                <c:pt idx="960">
                  <c:v>358.6</c:v>
                </c:pt>
                <c:pt idx="961">
                  <c:v>358.4</c:v>
                </c:pt>
                <c:pt idx="962">
                  <c:v>358.2</c:v>
                </c:pt>
                <c:pt idx="963">
                  <c:v>358</c:v>
                </c:pt>
                <c:pt idx="964">
                  <c:v>357.8</c:v>
                </c:pt>
                <c:pt idx="965">
                  <c:v>357.6</c:v>
                </c:pt>
                <c:pt idx="966">
                  <c:v>357.4</c:v>
                </c:pt>
                <c:pt idx="967">
                  <c:v>357.2</c:v>
                </c:pt>
                <c:pt idx="968">
                  <c:v>357</c:v>
                </c:pt>
                <c:pt idx="969">
                  <c:v>356.8</c:v>
                </c:pt>
                <c:pt idx="970">
                  <c:v>356.6</c:v>
                </c:pt>
                <c:pt idx="971">
                  <c:v>356.4</c:v>
                </c:pt>
                <c:pt idx="972">
                  <c:v>356.2</c:v>
                </c:pt>
                <c:pt idx="973">
                  <c:v>356</c:v>
                </c:pt>
                <c:pt idx="974">
                  <c:v>355.8</c:v>
                </c:pt>
                <c:pt idx="975">
                  <c:v>355.6</c:v>
                </c:pt>
                <c:pt idx="976">
                  <c:v>355.4</c:v>
                </c:pt>
                <c:pt idx="977">
                  <c:v>355.2</c:v>
                </c:pt>
                <c:pt idx="978">
                  <c:v>355</c:v>
                </c:pt>
                <c:pt idx="979">
                  <c:v>354.8</c:v>
                </c:pt>
                <c:pt idx="980">
                  <c:v>354.6</c:v>
                </c:pt>
                <c:pt idx="981">
                  <c:v>354.4</c:v>
                </c:pt>
                <c:pt idx="982">
                  <c:v>354.2</c:v>
                </c:pt>
                <c:pt idx="983">
                  <c:v>354</c:v>
                </c:pt>
                <c:pt idx="984">
                  <c:v>353.8</c:v>
                </c:pt>
                <c:pt idx="985">
                  <c:v>353.6</c:v>
                </c:pt>
                <c:pt idx="986">
                  <c:v>353.4</c:v>
                </c:pt>
                <c:pt idx="987">
                  <c:v>353.2</c:v>
                </c:pt>
                <c:pt idx="988">
                  <c:v>353</c:v>
                </c:pt>
                <c:pt idx="989">
                  <c:v>352.8</c:v>
                </c:pt>
                <c:pt idx="990">
                  <c:v>352.6</c:v>
                </c:pt>
                <c:pt idx="991">
                  <c:v>352.4</c:v>
                </c:pt>
                <c:pt idx="992">
                  <c:v>352.2</c:v>
                </c:pt>
                <c:pt idx="993">
                  <c:v>352</c:v>
                </c:pt>
                <c:pt idx="994">
                  <c:v>351.8</c:v>
                </c:pt>
                <c:pt idx="995">
                  <c:v>351.6</c:v>
                </c:pt>
                <c:pt idx="996">
                  <c:v>351.4</c:v>
                </c:pt>
                <c:pt idx="997">
                  <c:v>351.2</c:v>
                </c:pt>
                <c:pt idx="998">
                  <c:v>351</c:v>
                </c:pt>
                <c:pt idx="999">
                  <c:v>350.8</c:v>
                </c:pt>
                <c:pt idx="1000">
                  <c:v>350.6</c:v>
                </c:pt>
                <c:pt idx="1001">
                  <c:v>350.4</c:v>
                </c:pt>
                <c:pt idx="1002">
                  <c:v>350.2</c:v>
                </c:pt>
                <c:pt idx="1003">
                  <c:v>350</c:v>
                </c:pt>
                <c:pt idx="1004">
                  <c:v>349.8</c:v>
                </c:pt>
                <c:pt idx="1005">
                  <c:v>349.6</c:v>
                </c:pt>
                <c:pt idx="1006">
                  <c:v>349.4</c:v>
                </c:pt>
                <c:pt idx="1007">
                  <c:v>349.2</c:v>
                </c:pt>
                <c:pt idx="1008">
                  <c:v>349</c:v>
                </c:pt>
                <c:pt idx="1009">
                  <c:v>348.8</c:v>
                </c:pt>
                <c:pt idx="1010">
                  <c:v>348.6</c:v>
                </c:pt>
                <c:pt idx="1011">
                  <c:v>348.4</c:v>
                </c:pt>
                <c:pt idx="1012">
                  <c:v>348.2</c:v>
                </c:pt>
                <c:pt idx="1013">
                  <c:v>348</c:v>
                </c:pt>
                <c:pt idx="1014">
                  <c:v>347.8</c:v>
                </c:pt>
                <c:pt idx="1015">
                  <c:v>347.6</c:v>
                </c:pt>
                <c:pt idx="1016">
                  <c:v>347.4</c:v>
                </c:pt>
                <c:pt idx="1017">
                  <c:v>347.2</c:v>
                </c:pt>
                <c:pt idx="1018">
                  <c:v>347</c:v>
                </c:pt>
                <c:pt idx="1019">
                  <c:v>346.8</c:v>
                </c:pt>
                <c:pt idx="1020">
                  <c:v>346.6</c:v>
                </c:pt>
                <c:pt idx="1021">
                  <c:v>346.4</c:v>
                </c:pt>
                <c:pt idx="1022">
                  <c:v>346.2</c:v>
                </c:pt>
                <c:pt idx="1023">
                  <c:v>346</c:v>
                </c:pt>
                <c:pt idx="1024">
                  <c:v>345.8</c:v>
                </c:pt>
                <c:pt idx="1025">
                  <c:v>345.6</c:v>
                </c:pt>
                <c:pt idx="1026">
                  <c:v>345.4</c:v>
                </c:pt>
                <c:pt idx="1027">
                  <c:v>345.2</c:v>
                </c:pt>
                <c:pt idx="1028">
                  <c:v>345</c:v>
                </c:pt>
                <c:pt idx="1029">
                  <c:v>344.8</c:v>
                </c:pt>
                <c:pt idx="1030">
                  <c:v>344.6</c:v>
                </c:pt>
                <c:pt idx="1031">
                  <c:v>344.4</c:v>
                </c:pt>
                <c:pt idx="1032">
                  <c:v>344.2</c:v>
                </c:pt>
                <c:pt idx="1033">
                  <c:v>344</c:v>
                </c:pt>
                <c:pt idx="1034">
                  <c:v>343.8</c:v>
                </c:pt>
                <c:pt idx="1035">
                  <c:v>343.6</c:v>
                </c:pt>
                <c:pt idx="1036">
                  <c:v>343.4</c:v>
                </c:pt>
                <c:pt idx="1037">
                  <c:v>343.2</c:v>
                </c:pt>
                <c:pt idx="1038">
                  <c:v>343</c:v>
                </c:pt>
                <c:pt idx="1039">
                  <c:v>342.8</c:v>
                </c:pt>
                <c:pt idx="1040">
                  <c:v>342.6</c:v>
                </c:pt>
                <c:pt idx="1041">
                  <c:v>342.4</c:v>
                </c:pt>
                <c:pt idx="1042">
                  <c:v>342.2</c:v>
                </c:pt>
                <c:pt idx="1043">
                  <c:v>342</c:v>
                </c:pt>
                <c:pt idx="1044">
                  <c:v>341.8</c:v>
                </c:pt>
                <c:pt idx="1045">
                  <c:v>341.6</c:v>
                </c:pt>
                <c:pt idx="1046">
                  <c:v>341.4</c:v>
                </c:pt>
                <c:pt idx="1047">
                  <c:v>341.2</c:v>
                </c:pt>
                <c:pt idx="1048">
                  <c:v>341</c:v>
                </c:pt>
                <c:pt idx="1049">
                  <c:v>340.8</c:v>
                </c:pt>
                <c:pt idx="1050">
                  <c:v>340.6</c:v>
                </c:pt>
                <c:pt idx="1051">
                  <c:v>340.4</c:v>
                </c:pt>
                <c:pt idx="1052">
                  <c:v>340.2</c:v>
                </c:pt>
                <c:pt idx="1053">
                  <c:v>340</c:v>
                </c:pt>
                <c:pt idx="1054">
                  <c:v>339.8</c:v>
                </c:pt>
                <c:pt idx="1055">
                  <c:v>339.6</c:v>
                </c:pt>
                <c:pt idx="1056">
                  <c:v>339.4</c:v>
                </c:pt>
                <c:pt idx="1057">
                  <c:v>339.2</c:v>
                </c:pt>
                <c:pt idx="1058">
                  <c:v>339</c:v>
                </c:pt>
                <c:pt idx="1059">
                  <c:v>338.8</c:v>
                </c:pt>
                <c:pt idx="1060">
                  <c:v>338.6</c:v>
                </c:pt>
                <c:pt idx="1061">
                  <c:v>338.4</c:v>
                </c:pt>
                <c:pt idx="1062">
                  <c:v>338.2</c:v>
                </c:pt>
                <c:pt idx="1063">
                  <c:v>338</c:v>
                </c:pt>
                <c:pt idx="1064">
                  <c:v>337.8</c:v>
                </c:pt>
                <c:pt idx="1065">
                  <c:v>337.6</c:v>
                </c:pt>
                <c:pt idx="1066">
                  <c:v>337.4</c:v>
                </c:pt>
                <c:pt idx="1067">
                  <c:v>337.2</c:v>
                </c:pt>
                <c:pt idx="1068">
                  <c:v>337</c:v>
                </c:pt>
                <c:pt idx="1069">
                  <c:v>336.8</c:v>
                </c:pt>
                <c:pt idx="1070">
                  <c:v>336.6</c:v>
                </c:pt>
                <c:pt idx="1071">
                  <c:v>336.4</c:v>
                </c:pt>
                <c:pt idx="1072">
                  <c:v>336.2</c:v>
                </c:pt>
                <c:pt idx="1073">
                  <c:v>336</c:v>
                </c:pt>
                <c:pt idx="1074">
                  <c:v>335.8</c:v>
                </c:pt>
                <c:pt idx="1075">
                  <c:v>335.6</c:v>
                </c:pt>
                <c:pt idx="1076">
                  <c:v>335.4</c:v>
                </c:pt>
                <c:pt idx="1077">
                  <c:v>335.2</c:v>
                </c:pt>
                <c:pt idx="1078">
                  <c:v>335</c:v>
                </c:pt>
                <c:pt idx="1079">
                  <c:v>334.8</c:v>
                </c:pt>
                <c:pt idx="1080">
                  <c:v>334.6</c:v>
                </c:pt>
                <c:pt idx="1081">
                  <c:v>334.4</c:v>
                </c:pt>
                <c:pt idx="1082">
                  <c:v>334.2</c:v>
                </c:pt>
                <c:pt idx="1083">
                  <c:v>334</c:v>
                </c:pt>
                <c:pt idx="1084">
                  <c:v>333.8</c:v>
                </c:pt>
                <c:pt idx="1085">
                  <c:v>333.6</c:v>
                </c:pt>
                <c:pt idx="1086">
                  <c:v>333.4</c:v>
                </c:pt>
                <c:pt idx="1087">
                  <c:v>333.2</c:v>
                </c:pt>
                <c:pt idx="1088">
                  <c:v>333</c:v>
                </c:pt>
                <c:pt idx="1089">
                  <c:v>332.8</c:v>
                </c:pt>
                <c:pt idx="1090">
                  <c:v>332.6</c:v>
                </c:pt>
                <c:pt idx="1091">
                  <c:v>332.4</c:v>
                </c:pt>
                <c:pt idx="1092">
                  <c:v>332.2</c:v>
                </c:pt>
                <c:pt idx="1093">
                  <c:v>332</c:v>
                </c:pt>
                <c:pt idx="1094">
                  <c:v>331.8</c:v>
                </c:pt>
                <c:pt idx="1095">
                  <c:v>331.6</c:v>
                </c:pt>
                <c:pt idx="1096">
                  <c:v>331.4</c:v>
                </c:pt>
                <c:pt idx="1097">
                  <c:v>331.2</c:v>
                </c:pt>
                <c:pt idx="1098">
                  <c:v>331</c:v>
                </c:pt>
                <c:pt idx="1099">
                  <c:v>330.8</c:v>
                </c:pt>
                <c:pt idx="1100">
                  <c:v>330.6</c:v>
                </c:pt>
                <c:pt idx="1101">
                  <c:v>330.4</c:v>
                </c:pt>
                <c:pt idx="1102">
                  <c:v>330.2</c:v>
                </c:pt>
                <c:pt idx="1103">
                  <c:v>330</c:v>
                </c:pt>
                <c:pt idx="1104">
                  <c:v>329.8</c:v>
                </c:pt>
                <c:pt idx="1105">
                  <c:v>329.6</c:v>
                </c:pt>
                <c:pt idx="1106">
                  <c:v>329.4</c:v>
                </c:pt>
                <c:pt idx="1107">
                  <c:v>329.2</c:v>
                </c:pt>
                <c:pt idx="1108">
                  <c:v>329</c:v>
                </c:pt>
                <c:pt idx="1109">
                  <c:v>328.8</c:v>
                </c:pt>
                <c:pt idx="1110">
                  <c:v>328.6</c:v>
                </c:pt>
                <c:pt idx="1111">
                  <c:v>328.4</c:v>
                </c:pt>
                <c:pt idx="1112">
                  <c:v>328.2</c:v>
                </c:pt>
                <c:pt idx="1113">
                  <c:v>328</c:v>
                </c:pt>
                <c:pt idx="1114">
                  <c:v>327.8</c:v>
                </c:pt>
                <c:pt idx="1115">
                  <c:v>327.60000000000002</c:v>
                </c:pt>
                <c:pt idx="1116">
                  <c:v>327.39999999999998</c:v>
                </c:pt>
                <c:pt idx="1117">
                  <c:v>327.2</c:v>
                </c:pt>
                <c:pt idx="1118">
                  <c:v>327</c:v>
                </c:pt>
                <c:pt idx="1119">
                  <c:v>326.8</c:v>
                </c:pt>
                <c:pt idx="1120">
                  <c:v>326.60000000000002</c:v>
                </c:pt>
                <c:pt idx="1121">
                  <c:v>326.39999999999998</c:v>
                </c:pt>
                <c:pt idx="1122">
                  <c:v>326.2</c:v>
                </c:pt>
                <c:pt idx="1123">
                  <c:v>326</c:v>
                </c:pt>
                <c:pt idx="1124">
                  <c:v>325.8</c:v>
                </c:pt>
                <c:pt idx="1125">
                  <c:v>325.60000000000002</c:v>
                </c:pt>
                <c:pt idx="1126">
                  <c:v>325.39999999999998</c:v>
                </c:pt>
                <c:pt idx="1127">
                  <c:v>325.2</c:v>
                </c:pt>
                <c:pt idx="1128">
                  <c:v>325</c:v>
                </c:pt>
                <c:pt idx="1129">
                  <c:v>324.8</c:v>
                </c:pt>
                <c:pt idx="1130">
                  <c:v>324.60000000000002</c:v>
                </c:pt>
                <c:pt idx="1131">
                  <c:v>324.39999999999998</c:v>
                </c:pt>
                <c:pt idx="1132">
                  <c:v>324.2</c:v>
                </c:pt>
                <c:pt idx="1133">
                  <c:v>324</c:v>
                </c:pt>
                <c:pt idx="1134">
                  <c:v>323.8</c:v>
                </c:pt>
                <c:pt idx="1135">
                  <c:v>323.60000000000002</c:v>
                </c:pt>
                <c:pt idx="1136">
                  <c:v>323.39999999999998</c:v>
                </c:pt>
                <c:pt idx="1137">
                  <c:v>323.2</c:v>
                </c:pt>
                <c:pt idx="1138">
                  <c:v>323</c:v>
                </c:pt>
                <c:pt idx="1139">
                  <c:v>322.8</c:v>
                </c:pt>
                <c:pt idx="1140">
                  <c:v>322.60000000000002</c:v>
                </c:pt>
                <c:pt idx="1141">
                  <c:v>322.39999999999998</c:v>
                </c:pt>
                <c:pt idx="1142">
                  <c:v>322.2</c:v>
                </c:pt>
                <c:pt idx="1143">
                  <c:v>322</c:v>
                </c:pt>
                <c:pt idx="1144">
                  <c:v>321.8</c:v>
                </c:pt>
                <c:pt idx="1145">
                  <c:v>321.60000000000002</c:v>
                </c:pt>
                <c:pt idx="1146">
                  <c:v>321.39999999999998</c:v>
                </c:pt>
                <c:pt idx="1147">
                  <c:v>321.2</c:v>
                </c:pt>
                <c:pt idx="1148">
                  <c:v>321</c:v>
                </c:pt>
                <c:pt idx="1149">
                  <c:v>320.8</c:v>
                </c:pt>
                <c:pt idx="1150">
                  <c:v>320.60000000000002</c:v>
                </c:pt>
                <c:pt idx="1151">
                  <c:v>320.39999999999998</c:v>
                </c:pt>
                <c:pt idx="1152">
                  <c:v>320.2</c:v>
                </c:pt>
                <c:pt idx="1153">
                  <c:v>320</c:v>
                </c:pt>
                <c:pt idx="1154">
                  <c:v>319.8</c:v>
                </c:pt>
                <c:pt idx="1155">
                  <c:v>319.60000000000002</c:v>
                </c:pt>
                <c:pt idx="1156">
                  <c:v>319.39999999999998</c:v>
                </c:pt>
                <c:pt idx="1157">
                  <c:v>319.2</c:v>
                </c:pt>
                <c:pt idx="1158">
                  <c:v>319</c:v>
                </c:pt>
                <c:pt idx="1159">
                  <c:v>318.8</c:v>
                </c:pt>
                <c:pt idx="1160">
                  <c:v>318.60000000000002</c:v>
                </c:pt>
                <c:pt idx="1161">
                  <c:v>318.39999999999998</c:v>
                </c:pt>
                <c:pt idx="1162">
                  <c:v>318.2</c:v>
                </c:pt>
                <c:pt idx="1163">
                  <c:v>318</c:v>
                </c:pt>
                <c:pt idx="1164">
                  <c:v>317.8</c:v>
                </c:pt>
                <c:pt idx="1165">
                  <c:v>317.60000000000002</c:v>
                </c:pt>
                <c:pt idx="1166">
                  <c:v>317.39999999999998</c:v>
                </c:pt>
                <c:pt idx="1167">
                  <c:v>317.2</c:v>
                </c:pt>
                <c:pt idx="1168">
                  <c:v>317</c:v>
                </c:pt>
                <c:pt idx="1169">
                  <c:v>316.8</c:v>
                </c:pt>
                <c:pt idx="1170">
                  <c:v>316.60000000000002</c:v>
                </c:pt>
                <c:pt idx="1171">
                  <c:v>316.39999999999998</c:v>
                </c:pt>
                <c:pt idx="1172">
                  <c:v>316.2</c:v>
                </c:pt>
                <c:pt idx="1173">
                  <c:v>316</c:v>
                </c:pt>
                <c:pt idx="1174">
                  <c:v>315.8</c:v>
                </c:pt>
                <c:pt idx="1175">
                  <c:v>315.60000000000002</c:v>
                </c:pt>
                <c:pt idx="1176">
                  <c:v>315.39999999999998</c:v>
                </c:pt>
                <c:pt idx="1177">
                  <c:v>315.2</c:v>
                </c:pt>
                <c:pt idx="1178">
                  <c:v>315</c:v>
                </c:pt>
                <c:pt idx="1179">
                  <c:v>314.8</c:v>
                </c:pt>
                <c:pt idx="1180">
                  <c:v>314.60000000000002</c:v>
                </c:pt>
                <c:pt idx="1181">
                  <c:v>314.39999999999998</c:v>
                </c:pt>
                <c:pt idx="1182">
                  <c:v>314.2</c:v>
                </c:pt>
                <c:pt idx="1183">
                  <c:v>314</c:v>
                </c:pt>
                <c:pt idx="1184">
                  <c:v>313.8</c:v>
                </c:pt>
                <c:pt idx="1185">
                  <c:v>313.60000000000002</c:v>
                </c:pt>
                <c:pt idx="1186">
                  <c:v>313.39999999999998</c:v>
                </c:pt>
                <c:pt idx="1187">
                  <c:v>313.2</c:v>
                </c:pt>
                <c:pt idx="1188">
                  <c:v>313</c:v>
                </c:pt>
                <c:pt idx="1189">
                  <c:v>312.8</c:v>
                </c:pt>
                <c:pt idx="1190">
                  <c:v>312.60000000000002</c:v>
                </c:pt>
                <c:pt idx="1191">
                  <c:v>312.39999999999998</c:v>
                </c:pt>
                <c:pt idx="1192">
                  <c:v>312.2</c:v>
                </c:pt>
                <c:pt idx="1193">
                  <c:v>312</c:v>
                </c:pt>
                <c:pt idx="1194">
                  <c:v>311.8</c:v>
                </c:pt>
                <c:pt idx="1195">
                  <c:v>311.60000000000002</c:v>
                </c:pt>
                <c:pt idx="1196">
                  <c:v>311.39999999999998</c:v>
                </c:pt>
                <c:pt idx="1197">
                  <c:v>311.2</c:v>
                </c:pt>
                <c:pt idx="1198">
                  <c:v>311</c:v>
                </c:pt>
                <c:pt idx="1199">
                  <c:v>310.8</c:v>
                </c:pt>
                <c:pt idx="1200">
                  <c:v>310.60000000000002</c:v>
                </c:pt>
                <c:pt idx="1201">
                  <c:v>310.39999999999998</c:v>
                </c:pt>
                <c:pt idx="1202">
                  <c:v>310.2</c:v>
                </c:pt>
                <c:pt idx="1203">
                  <c:v>310</c:v>
                </c:pt>
                <c:pt idx="1204">
                  <c:v>309.8</c:v>
                </c:pt>
                <c:pt idx="1205">
                  <c:v>309.60000000000002</c:v>
                </c:pt>
                <c:pt idx="1206">
                  <c:v>309.39999999999998</c:v>
                </c:pt>
                <c:pt idx="1207">
                  <c:v>309.2</c:v>
                </c:pt>
                <c:pt idx="1208">
                  <c:v>309</c:v>
                </c:pt>
                <c:pt idx="1209">
                  <c:v>308.8</c:v>
                </c:pt>
                <c:pt idx="1210">
                  <c:v>308.60000000000002</c:v>
                </c:pt>
                <c:pt idx="1211">
                  <c:v>308.39999999999998</c:v>
                </c:pt>
                <c:pt idx="1212">
                  <c:v>308.2</c:v>
                </c:pt>
                <c:pt idx="1213">
                  <c:v>308</c:v>
                </c:pt>
                <c:pt idx="1214">
                  <c:v>307.8</c:v>
                </c:pt>
                <c:pt idx="1215">
                  <c:v>307.60000000000002</c:v>
                </c:pt>
                <c:pt idx="1216">
                  <c:v>307.39999999999998</c:v>
                </c:pt>
                <c:pt idx="1217">
                  <c:v>307.2</c:v>
                </c:pt>
                <c:pt idx="1218">
                  <c:v>307</c:v>
                </c:pt>
                <c:pt idx="1219">
                  <c:v>306.8</c:v>
                </c:pt>
                <c:pt idx="1220">
                  <c:v>306.60000000000002</c:v>
                </c:pt>
                <c:pt idx="1221">
                  <c:v>306.39999999999998</c:v>
                </c:pt>
                <c:pt idx="1222">
                  <c:v>306.2</c:v>
                </c:pt>
                <c:pt idx="1223">
                  <c:v>306</c:v>
                </c:pt>
                <c:pt idx="1224">
                  <c:v>305.8</c:v>
                </c:pt>
                <c:pt idx="1225">
                  <c:v>305.60000000000002</c:v>
                </c:pt>
                <c:pt idx="1226">
                  <c:v>305.39999999999998</c:v>
                </c:pt>
                <c:pt idx="1227">
                  <c:v>305.2</c:v>
                </c:pt>
                <c:pt idx="1228">
                  <c:v>305</c:v>
                </c:pt>
                <c:pt idx="1229">
                  <c:v>304.8</c:v>
                </c:pt>
                <c:pt idx="1230">
                  <c:v>304.60000000000002</c:v>
                </c:pt>
                <c:pt idx="1231">
                  <c:v>304.39999999999998</c:v>
                </c:pt>
                <c:pt idx="1232">
                  <c:v>304.2</c:v>
                </c:pt>
                <c:pt idx="1233">
                  <c:v>304</c:v>
                </c:pt>
                <c:pt idx="1234">
                  <c:v>303.8</c:v>
                </c:pt>
                <c:pt idx="1235">
                  <c:v>303.60000000000002</c:v>
                </c:pt>
                <c:pt idx="1236">
                  <c:v>303.39999999999998</c:v>
                </c:pt>
                <c:pt idx="1237">
                  <c:v>303.2</c:v>
                </c:pt>
                <c:pt idx="1238">
                  <c:v>303</c:v>
                </c:pt>
                <c:pt idx="1239">
                  <c:v>302.8</c:v>
                </c:pt>
                <c:pt idx="1240">
                  <c:v>302.60000000000002</c:v>
                </c:pt>
                <c:pt idx="1241">
                  <c:v>302.39999999999998</c:v>
                </c:pt>
                <c:pt idx="1242">
                  <c:v>302.2</c:v>
                </c:pt>
                <c:pt idx="1243">
                  <c:v>302</c:v>
                </c:pt>
                <c:pt idx="1244">
                  <c:v>301.8</c:v>
                </c:pt>
                <c:pt idx="1245">
                  <c:v>301.60000000000002</c:v>
                </c:pt>
                <c:pt idx="1246">
                  <c:v>301.39999999999998</c:v>
                </c:pt>
                <c:pt idx="1247">
                  <c:v>301.2</c:v>
                </c:pt>
                <c:pt idx="1248">
                  <c:v>301</c:v>
                </c:pt>
                <c:pt idx="1249">
                  <c:v>300.8</c:v>
                </c:pt>
                <c:pt idx="1250">
                  <c:v>300.60000000000002</c:v>
                </c:pt>
                <c:pt idx="1251">
                  <c:v>300.39999999999998</c:v>
                </c:pt>
                <c:pt idx="1252">
                  <c:v>300.2</c:v>
                </c:pt>
                <c:pt idx="1253">
                  <c:v>300</c:v>
                </c:pt>
              </c:numCache>
            </c:numRef>
          </c:xVal>
          <c:yVal>
            <c:numRef>
              <c:f>Hoja1!$BU$2:$BU$1255</c:f>
              <c:numCache>
                <c:formatCode>General</c:formatCode>
                <c:ptCount val="1254"/>
                <c:pt idx="0">
                  <c:v>0</c:v>
                </c:pt>
                <c:pt idx="1">
                  <c:v>0</c:v>
                </c:pt>
                <c:pt idx="3">
                  <c:v>9.633333333333334E-3</c:v>
                </c:pt>
                <c:pt idx="4">
                  <c:v>9.633333333333334E-3</c:v>
                </c:pt>
                <c:pt idx="5">
                  <c:v>9.633333333333334E-3</c:v>
                </c:pt>
                <c:pt idx="6">
                  <c:v>9.6833333333333337E-3</c:v>
                </c:pt>
                <c:pt idx="7">
                  <c:v>9.7833333333333331E-3</c:v>
                </c:pt>
                <c:pt idx="8">
                  <c:v>9.9000000000000008E-3</c:v>
                </c:pt>
                <c:pt idx="9">
                  <c:v>9.9499999999999988E-3</c:v>
                </c:pt>
                <c:pt idx="10">
                  <c:v>1.0083333333333335E-2</c:v>
                </c:pt>
                <c:pt idx="11">
                  <c:v>1.0116666666666668E-2</c:v>
                </c:pt>
                <c:pt idx="12">
                  <c:v>1.0116666666666668E-2</c:v>
                </c:pt>
                <c:pt idx="13">
                  <c:v>1.0133333333333334E-2</c:v>
                </c:pt>
                <c:pt idx="14">
                  <c:v>1.0166666666666668E-2</c:v>
                </c:pt>
                <c:pt idx="15">
                  <c:v>1.0183333333333332E-2</c:v>
                </c:pt>
                <c:pt idx="16">
                  <c:v>1.0199999999999999E-2</c:v>
                </c:pt>
                <c:pt idx="17">
                  <c:v>1.0266666666666667E-2</c:v>
                </c:pt>
                <c:pt idx="18">
                  <c:v>1.0300000000000002E-2</c:v>
                </c:pt>
                <c:pt idx="19">
                  <c:v>1.0316666666666668E-2</c:v>
                </c:pt>
                <c:pt idx="20">
                  <c:v>1.0283333333333334E-2</c:v>
                </c:pt>
                <c:pt idx="21">
                  <c:v>1.0283333333333334E-2</c:v>
                </c:pt>
                <c:pt idx="22">
                  <c:v>1.0283333333333334E-2</c:v>
                </c:pt>
                <c:pt idx="23">
                  <c:v>1.0283333333333334E-2</c:v>
                </c:pt>
                <c:pt idx="24">
                  <c:v>1.035E-2</c:v>
                </c:pt>
                <c:pt idx="25">
                  <c:v>1.0383333333333333E-2</c:v>
                </c:pt>
                <c:pt idx="26">
                  <c:v>1.0433333333333331E-2</c:v>
                </c:pt>
                <c:pt idx="27">
                  <c:v>1.0433333333333331E-2</c:v>
                </c:pt>
                <c:pt idx="28">
                  <c:v>1.0516666666666667E-2</c:v>
                </c:pt>
                <c:pt idx="29">
                  <c:v>1.0516666666666667E-2</c:v>
                </c:pt>
                <c:pt idx="30">
                  <c:v>1.0533333333333334E-2</c:v>
                </c:pt>
                <c:pt idx="31">
                  <c:v>1.0549999999999999E-2</c:v>
                </c:pt>
                <c:pt idx="32">
                  <c:v>1.0566666666666667E-2</c:v>
                </c:pt>
                <c:pt idx="33">
                  <c:v>1.0616666666666668E-2</c:v>
                </c:pt>
                <c:pt idx="34">
                  <c:v>1.065E-2</c:v>
                </c:pt>
                <c:pt idx="35">
                  <c:v>1.0716666666666668E-2</c:v>
                </c:pt>
                <c:pt idx="36">
                  <c:v>1.0750000000000001E-2</c:v>
                </c:pt>
                <c:pt idx="37">
                  <c:v>1.0816666666666667E-2</c:v>
                </c:pt>
                <c:pt idx="38">
                  <c:v>1.09E-2</c:v>
                </c:pt>
                <c:pt idx="39">
                  <c:v>1.0950000000000001E-2</c:v>
                </c:pt>
                <c:pt idx="40">
                  <c:v>1.1000000000000001E-2</c:v>
                </c:pt>
                <c:pt idx="41">
                  <c:v>1.1049999999999999E-2</c:v>
                </c:pt>
                <c:pt idx="42">
                  <c:v>1.1116666666666665E-2</c:v>
                </c:pt>
                <c:pt idx="43">
                  <c:v>1.115E-2</c:v>
                </c:pt>
                <c:pt idx="44">
                  <c:v>1.1166666666666665E-2</c:v>
                </c:pt>
                <c:pt idx="45">
                  <c:v>1.12E-2</c:v>
                </c:pt>
                <c:pt idx="46">
                  <c:v>1.1216666666666666E-2</c:v>
                </c:pt>
                <c:pt idx="47">
                  <c:v>1.1233333333333333E-2</c:v>
                </c:pt>
                <c:pt idx="48">
                  <c:v>1.1283333333333333E-2</c:v>
                </c:pt>
                <c:pt idx="49">
                  <c:v>1.1350000000000001E-2</c:v>
                </c:pt>
                <c:pt idx="50">
                  <c:v>1.14E-2</c:v>
                </c:pt>
                <c:pt idx="51">
                  <c:v>1.1466666666666667E-2</c:v>
                </c:pt>
                <c:pt idx="52">
                  <c:v>1.1516666666666666E-2</c:v>
                </c:pt>
                <c:pt idx="53">
                  <c:v>1.1583333333333333E-2</c:v>
                </c:pt>
                <c:pt idx="54">
                  <c:v>1.1616666666666666E-2</c:v>
                </c:pt>
                <c:pt idx="55">
                  <c:v>1.1616666666666666E-2</c:v>
                </c:pt>
                <c:pt idx="56">
                  <c:v>1.1633333333333331E-2</c:v>
                </c:pt>
                <c:pt idx="57">
                  <c:v>1.1683333333333332E-2</c:v>
                </c:pt>
                <c:pt idx="58">
                  <c:v>1.1683333333333332E-2</c:v>
                </c:pt>
                <c:pt idx="59">
                  <c:v>1.1733333333333333E-2</c:v>
                </c:pt>
                <c:pt idx="60">
                  <c:v>1.1783333333333333E-2</c:v>
                </c:pt>
                <c:pt idx="61">
                  <c:v>1.18E-2</c:v>
                </c:pt>
                <c:pt idx="62">
                  <c:v>1.1850000000000001E-2</c:v>
                </c:pt>
                <c:pt idx="63">
                  <c:v>1.1883333333333334E-2</c:v>
                </c:pt>
                <c:pt idx="64">
                  <c:v>1.1950000000000001E-2</c:v>
                </c:pt>
                <c:pt idx="65">
                  <c:v>1.2000000000000002E-2</c:v>
                </c:pt>
                <c:pt idx="66">
                  <c:v>1.2149999999999999E-2</c:v>
                </c:pt>
                <c:pt idx="67">
                  <c:v>1.2149999999999999E-2</c:v>
                </c:pt>
                <c:pt idx="68">
                  <c:v>1.2166666666666666E-2</c:v>
                </c:pt>
                <c:pt idx="69">
                  <c:v>1.2216666666666666E-2</c:v>
                </c:pt>
                <c:pt idx="70">
                  <c:v>1.2233333333333332E-2</c:v>
                </c:pt>
                <c:pt idx="71">
                  <c:v>1.2083333333333333E-2</c:v>
                </c:pt>
                <c:pt idx="72">
                  <c:v>1.1950000000000001E-2</c:v>
                </c:pt>
                <c:pt idx="73">
                  <c:v>1.18E-2</c:v>
                </c:pt>
                <c:pt idx="74">
                  <c:v>1.1650000000000001E-2</c:v>
                </c:pt>
                <c:pt idx="75">
                  <c:v>1.1683333333333335E-2</c:v>
                </c:pt>
                <c:pt idx="76">
                  <c:v>1.1700000000000002E-2</c:v>
                </c:pt>
                <c:pt idx="77">
                  <c:v>1.1750000000000002E-2</c:v>
                </c:pt>
                <c:pt idx="78">
                  <c:v>1.1766666666666668E-2</c:v>
                </c:pt>
                <c:pt idx="79">
                  <c:v>1.1833333333333335E-2</c:v>
                </c:pt>
                <c:pt idx="80">
                  <c:v>1.1883333333333334E-2</c:v>
                </c:pt>
                <c:pt idx="81">
                  <c:v>1.1899999999999999E-2</c:v>
                </c:pt>
                <c:pt idx="82">
                  <c:v>1.1916666666666666E-2</c:v>
                </c:pt>
                <c:pt idx="83">
                  <c:v>1.1933333333333332E-2</c:v>
                </c:pt>
                <c:pt idx="84">
                  <c:v>1.1950000000000001E-2</c:v>
                </c:pt>
                <c:pt idx="85">
                  <c:v>1.1950000000000001E-2</c:v>
                </c:pt>
                <c:pt idx="86">
                  <c:v>1.1966666666666667E-2</c:v>
                </c:pt>
                <c:pt idx="87">
                  <c:v>1.2016666666666667E-2</c:v>
                </c:pt>
                <c:pt idx="88">
                  <c:v>1.2083333333333333E-2</c:v>
                </c:pt>
                <c:pt idx="89">
                  <c:v>1.2150000000000001E-2</c:v>
                </c:pt>
                <c:pt idx="90">
                  <c:v>1.2166666666666666E-2</c:v>
                </c:pt>
                <c:pt idx="91">
                  <c:v>1.2183333333333332E-2</c:v>
                </c:pt>
                <c:pt idx="92">
                  <c:v>1.2216666666666667E-2</c:v>
                </c:pt>
                <c:pt idx="93">
                  <c:v>1.2283333333333334E-2</c:v>
                </c:pt>
                <c:pt idx="94">
                  <c:v>1.2400000000000001E-2</c:v>
                </c:pt>
                <c:pt idx="95">
                  <c:v>1.2466666666666668E-2</c:v>
                </c:pt>
                <c:pt idx="96">
                  <c:v>1.2533333333333334E-2</c:v>
                </c:pt>
                <c:pt idx="97">
                  <c:v>1.26E-2</c:v>
                </c:pt>
                <c:pt idx="98">
                  <c:v>1.265E-2</c:v>
                </c:pt>
                <c:pt idx="99">
                  <c:v>1.2683333333333333E-2</c:v>
                </c:pt>
                <c:pt idx="100">
                  <c:v>1.2700000000000001E-2</c:v>
                </c:pt>
                <c:pt idx="101">
                  <c:v>1.2716666666666668E-2</c:v>
                </c:pt>
                <c:pt idx="102">
                  <c:v>1.2783333333333334E-2</c:v>
                </c:pt>
                <c:pt idx="103">
                  <c:v>1.2800000000000001E-2</c:v>
                </c:pt>
                <c:pt idx="104">
                  <c:v>1.2816666666666665E-2</c:v>
                </c:pt>
                <c:pt idx="105">
                  <c:v>1.285E-2</c:v>
                </c:pt>
                <c:pt idx="106">
                  <c:v>1.285E-2</c:v>
                </c:pt>
                <c:pt idx="107">
                  <c:v>1.2883333333333335E-2</c:v>
                </c:pt>
                <c:pt idx="108">
                  <c:v>1.2883333333333335E-2</c:v>
                </c:pt>
                <c:pt idx="109">
                  <c:v>1.2883333333333335E-2</c:v>
                </c:pt>
                <c:pt idx="110">
                  <c:v>1.29E-2</c:v>
                </c:pt>
                <c:pt idx="111">
                  <c:v>1.2933333333333333E-2</c:v>
                </c:pt>
                <c:pt idx="112">
                  <c:v>1.2966666666666668E-2</c:v>
                </c:pt>
                <c:pt idx="113">
                  <c:v>1.2983333333333335E-2</c:v>
                </c:pt>
                <c:pt idx="114">
                  <c:v>1.3050000000000001E-2</c:v>
                </c:pt>
                <c:pt idx="115">
                  <c:v>1.3083333333333334E-2</c:v>
                </c:pt>
                <c:pt idx="116">
                  <c:v>1.3166666666666667E-2</c:v>
                </c:pt>
                <c:pt idx="117">
                  <c:v>1.3183333333333333E-2</c:v>
                </c:pt>
                <c:pt idx="118">
                  <c:v>1.325E-2</c:v>
                </c:pt>
                <c:pt idx="119">
                  <c:v>1.3316666666666666E-2</c:v>
                </c:pt>
                <c:pt idx="120">
                  <c:v>1.3383333333333336E-2</c:v>
                </c:pt>
                <c:pt idx="121">
                  <c:v>1.3433333333333334E-2</c:v>
                </c:pt>
                <c:pt idx="122">
                  <c:v>1.3450000000000002E-2</c:v>
                </c:pt>
                <c:pt idx="123">
                  <c:v>1.3533333333333335E-2</c:v>
                </c:pt>
                <c:pt idx="124">
                  <c:v>1.3566666666666666E-2</c:v>
                </c:pt>
                <c:pt idx="125">
                  <c:v>1.3600000000000001E-2</c:v>
                </c:pt>
                <c:pt idx="126">
                  <c:v>1.3633333333333332E-2</c:v>
                </c:pt>
                <c:pt idx="127">
                  <c:v>1.3650000000000001E-2</c:v>
                </c:pt>
                <c:pt idx="128">
                  <c:v>1.3716666666666667E-2</c:v>
                </c:pt>
                <c:pt idx="129">
                  <c:v>1.3733333333333334E-2</c:v>
                </c:pt>
                <c:pt idx="130">
                  <c:v>1.38E-2</c:v>
                </c:pt>
                <c:pt idx="131">
                  <c:v>1.3816666666666666E-2</c:v>
                </c:pt>
                <c:pt idx="132">
                  <c:v>1.3816666666666666E-2</c:v>
                </c:pt>
                <c:pt idx="133">
                  <c:v>1.3816666666666666E-2</c:v>
                </c:pt>
                <c:pt idx="134">
                  <c:v>1.3816666666666666E-2</c:v>
                </c:pt>
                <c:pt idx="135">
                  <c:v>1.3833333333333335E-2</c:v>
                </c:pt>
                <c:pt idx="136">
                  <c:v>1.3900000000000001E-2</c:v>
                </c:pt>
                <c:pt idx="137">
                  <c:v>1.3933333333333334E-2</c:v>
                </c:pt>
                <c:pt idx="138">
                  <c:v>1.3966666666666667E-2</c:v>
                </c:pt>
                <c:pt idx="139">
                  <c:v>1.3983333333333334E-2</c:v>
                </c:pt>
                <c:pt idx="140">
                  <c:v>1.3983333333333334E-2</c:v>
                </c:pt>
                <c:pt idx="141">
                  <c:v>1.4033333333333335E-2</c:v>
                </c:pt>
                <c:pt idx="142">
                  <c:v>1.4050000000000002E-2</c:v>
                </c:pt>
                <c:pt idx="143">
                  <c:v>1.4066666666666667E-2</c:v>
                </c:pt>
                <c:pt idx="144">
                  <c:v>1.4083333333333335E-2</c:v>
                </c:pt>
                <c:pt idx="145">
                  <c:v>1.4066666666666667E-2</c:v>
                </c:pt>
                <c:pt idx="146">
                  <c:v>1.4066666666666667E-2</c:v>
                </c:pt>
                <c:pt idx="147">
                  <c:v>1.41E-2</c:v>
                </c:pt>
                <c:pt idx="148">
                  <c:v>1.4116666666666668E-2</c:v>
                </c:pt>
                <c:pt idx="149">
                  <c:v>1.4116666666666668E-2</c:v>
                </c:pt>
                <c:pt idx="150">
                  <c:v>1.4150000000000001E-2</c:v>
                </c:pt>
                <c:pt idx="151">
                  <c:v>1.4199999999999999E-2</c:v>
                </c:pt>
                <c:pt idx="152">
                  <c:v>1.4266666666666665E-2</c:v>
                </c:pt>
                <c:pt idx="153">
                  <c:v>1.4266666666666665E-2</c:v>
                </c:pt>
                <c:pt idx="154">
                  <c:v>1.4266666666666665E-2</c:v>
                </c:pt>
                <c:pt idx="155">
                  <c:v>1.43E-2</c:v>
                </c:pt>
                <c:pt idx="156">
                  <c:v>1.4316666666666665E-2</c:v>
                </c:pt>
                <c:pt idx="157">
                  <c:v>1.4316666666666665E-2</c:v>
                </c:pt>
                <c:pt idx="158">
                  <c:v>1.435E-2</c:v>
                </c:pt>
                <c:pt idx="159">
                  <c:v>1.4366666666666666E-2</c:v>
                </c:pt>
                <c:pt idx="160">
                  <c:v>1.4383333333333333E-2</c:v>
                </c:pt>
                <c:pt idx="161">
                  <c:v>1.4383333333333333E-2</c:v>
                </c:pt>
                <c:pt idx="162">
                  <c:v>1.4466666666666668E-2</c:v>
                </c:pt>
                <c:pt idx="163">
                  <c:v>1.4483333333333334E-2</c:v>
                </c:pt>
                <c:pt idx="164">
                  <c:v>1.4516666666666669E-2</c:v>
                </c:pt>
                <c:pt idx="165">
                  <c:v>1.4516666666666669E-2</c:v>
                </c:pt>
                <c:pt idx="166">
                  <c:v>1.4500000000000001E-2</c:v>
                </c:pt>
                <c:pt idx="167">
                  <c:v>1.4483333333333334E-2</c:v>
                </c:pt>
                <c:pt idx="168">
                  <c:v>1.4466666666666668E-2</c:v>
                </c:pt>
                <c:pt idx="169">
                  <c:v>1.4483333333333334E-2</c:v>
                </c:pt>
                <c:pt idx="170">
                  <c:v>1.4516666666666666E-2</c:v>
                </c:pt>
                <c:pt idx="171">
                  <c:v>1.4549999999999999E-2</c:v>
                </c:pt>
                <c:pt idx="172">
                  <c:v>1.4566666666666667E-2</c:v>
                </c:pt>
                <c:pt idx="173">
                  <c:v>1.4583333333333332E-2</c:v>
                </c:pt>
                <c:pt idx="174">
                  <c:v>1.4566666666666667E-2</c:v>
                </c:pt>
                <c:pt idx="175">
                  <c:v>1.4616666666666667E-2</c:v>
                </c:pt>
                <c:pt idx="176">
                  <c:v>1.4633333333333333E-2</c:v>
                </c:pt>
                <c:pt idx="177">
                  <c:v>1.4649999999999998E-2</c:v>
                </c:pt>
                <c:pt idx="178">
                  <c:v>1.4683333333333333E-2</c:v>
                </c:pt>
                <c:pt idx="179">
                  <c:v>1.4699999999999998E-2</c:v>
                </c:pt>
                <c:pt idx="180">
                  <c:v>1.47E-2</c:v>
                </c:pt>
                <c:pt idx="181">
                  <c:v>1.4716666666666668E-2</c:v>
                </c:pt>
                <c:pt idx="182">
                  <c:v>1.4800000000000001E-2</c:v>
                </c:pt>
                <c:pt idx="183">
                  <c:v>1.4833333333333332E-2</c:v>
                </c:pt>
                <c:pt idx="184">
                  <c:v>1.4883333333333333E-2</c:v>
                </c:pt>
                <c:pt idx="185">
                  <c:v>1.495E-2</c:v>
                </c:pt>
                <c:pt idx="186">
                  <c:v>1.5000000000000001E-2</c:v>
                </c:pt>
                <c:pt idx="187">
                  <c:v>1.4999999999999999E-2</c:v>
                </c:pt>
                <c:pt idx="188">
                  <c:v>1.5066666666666666E-2</c:v>
                </c:pt>
                <c:pt idx="189">
                  <c:v>1.5099999999999997E-2</c:v>
                </c:pt>
                <c:pt idx="190">
                  <c:v>1.5116666666666665E-2</c:v>
                </c:pt>
                <c:pt idx="191">
                  <c:v>1.5133333333333334E-2</c:v>
                </c:pt>
                <c:pt idx="192">
                  <c:v>1.5100000000000001E-2</c:v>
                </c:pt>
                <c:pt idx="193">
                  <c:v>1.5116666666666667E-2</c:v>
                </c:pt>
                <c:pt idx="194">
                  <c:v>1.5166666666666667E-2</c:v>
                </c:pt>
                <c:pt idx="195">
                  <c:v>1.52E-2</c:v>
                </c:pt>
                <c:pt idx="196">
                  <c:v>1.52E-2</c:v>
                </c:pt>
                <c:pt idx="197">
                  <c:v>1.5250000000000001E-2</c:v>
                </c:pt>
                <c:pt idx="198">
                  <c:v>1.5283333333333331E-2</c:v>
                </c:pt>
                <c:pt idx="199">
                  <c:v>1.5316666666666671E-2</c:v>
                </c:pt>
                <c:pt idx="200">
                  <c:v>1.5366666666666666E-2</c:v>
                </c:pt>
                <c:pt idx="201">
                  <c:v>1.5350000000000001E-2</c:v>
                </c:pt>
                <c:pt idx="202">
                  <c:v>1.5383333333333334E-2</c:v>
                </c:pt>
                <c:pt idx="203">
                  <c:v>1.5416666666666669E-2</c:v>
                </c:pt>
                <c:pt idx="204">
                  <c:v>1.5383333333333334E-2</c:v>
                </c:pt>
                <c:pt idx="205">
                  <c:v>1.5383333333333334E-2</c:v>
                </c:pt>
                <c:pt idx="206">
                  <c:v>1.5433333333333334E-2</c:v>
                </c:pt>
                <c:pt idx="207">
                  <c:v>1.5466666666666665E-2</c:v>
                </c:pt>
                <c:pt idx="208">
                  <c:v>1.5566666666666666E-2</c:v>
                </c:pt>
                <c:pt idx="209">
                  <c:v>1.5599999999999998E-2</c:v>
                </c:pt>
                <c:pt idx="210">
                  <c:v>1.5616666666666666E-2</c:v>
                </c:pt>
                <c:pt idx="211">
                  <c:v>1.5700000000000002E-2</c:v>
                </c:pt>
                <c:pt idx="212">
                  <c:v>1.5766666666666665E-2</c:v>
                </c:pt>
                <c:pt idx="213">
                  <c:v>1.5766666666666665E-2</c:v>
                </c:pt>
                <c:pt idx="214">
                  <c:v>1.581666666666667E-2</c:v>
                </c:pt>
                <c:pt idx="215">
                  <c:v>1.5833333333333335E-2</c:v>
                </c:pt>
                <c:pt idx="216">
                  <c:v>1.585E-2</c:v>
                </c:pt>
                <c:pt idx="217">
                  <c:v>1.5883333333333329E-2</c:v>
                </c:pt>
                <c:pt idx="218">
                  <c:v>1.5900000000000001E-2</c:v>
                </c:pt>
                <c:pt idx="219">
                  <c:v>1.5916666666666666E-2</c:v>
                </c:pt>
                <c:pt idx="220">
                  <c:v>1.5933333333333334E-2</c:v>
                </c:pt>
                <c:pt idx="221">
                  <c:v>1.5933333333333334E-2</c:v>
                </c:pt>
                <c:pt idx="222">
                  <c:v>1.6E-2</c:v>
                </c:pt>
                <c:pt idx="223">
                  <c:v>1.6066666666666663E-2</c:v>
                </c:pt>
                <c:pt idx="224">
                  <c:v>1.6066666666666663E-2</c:v>
                </c:pt>
                <c:pt idx="225">
                  <c:v>1.6116666666666665E-2</c:v>
                </c:pt>
                <c:pt idx="226">
                  <c:v>1.6150000000000001E-2</c:v>
                </c:pt>
                <c:pt idx="227">
                  <c:v>1.6166666666666666E-2</c:v>
                </c:pt>
                <c:pt idx="228">
                  <c:v>1.6233333333333332E-2</c:v>
                </c:pt>
                <c:pt idx="229">
                  <c:v>1.6250000000000001E-2</c:v>
                </c:pt>
                <c:pt idx="230">
                  <c:v>1.631666666666667E-2</c:v>
                </c:pt>
                <c:pt idx="231">
                  <c:v>1.6366666666666668E-2</c:v>
                </c:pt>
                <c:pt idx="232">
                  <c:v>1.6466666666666668E-2</c:v>
                </c:pt>
                <c:pt idx="233">
                  <c:v>1.6500000000000001E-2</c:v>
                </c:pt>
                <c:pt idx="234">
                  <c:v>1.6516666666666666E-2</c:v>
                </c:pt>
                <c:pt idx="235">
                  <c:v>1.6549999999999999E-2</c:v>
                </c:pt>
                <c:pt idx="236">
                  <c:v>1.6583333333333332E-2</c:v>
                </c:pt>
                <c:pt idx="237">
                  <c:v>1.6616666666666665E-2</c:v>
                </c:pt>
                <c:pt idx="238">
                  <c:v>1.6616666666666665E-2</c:v>
                </c:pt>
                <c:pt idx="239">
                  <c:v>1.6666666666666666E-2</c:v>
                </c:pt>
                <c:pt idx="240">
                  <c:v>1.67E-2</c:v>
                </c:pt>
                <c:pt idx="241">
                  <c:v>1.6716666666666664E-2</c:v>
                </c:pt>
                <c:pt idx="242">
                  <c:v>1.6766666666666666E-2</c:v>
                </c:pt>
                <c:pt idx="243">
                  <c:v>1.6766666666666666E-2</c:v>
                </c:pt>
                <c:pt idx="244">
                  <c:v>1.6783333333333334E-2</c:v>
                </c:pt>
                <c:pt idx="245">
                  <c:v>1.6816666666666667E-2</c:v>
                </c:pt>
                <c:pt idx="246">
                  <c:v>1.685E-2</c:v>
                </c:pt>
                <c:pt idx="247">
                  <c:v>1.6833333333333336E-2</c:v>
                </c:pt>
                <c:pt idx="248">
                  <c:v>1.6833333333333336E-2</c:v>
                </c:pt>
                <c:pt idx="249">
                  <c:v>1.6916666666666667E-2</c:v>
                </c:pt>
                <c:pt idx="250">
                  <c:v>1.6933333333333331E-2</c:v>
                </c:pt>
                <c:pt idx="251">
                  <c:v>1.6966666666666668E-2</c:v>
                </c:pt>
                <c:pt idx="252">
                  <c:v>1.7066666666666664E-2</c:v>
                </c:pt>
                <c:pt idx="253">
                  <c:v>1.7116666666666665E-2</c:v>
                </c:pt>
                <c:pt idx="254">
                  <c:v>1.7083333333333329E-2</c:v>
                </c:pt>
                <c:pt idx="255">
                  <c:v>1.7183333333333332E-2</c:v>
                </c:pt>
                <c:pt idx="256">
                  <c:v>1.7199999999999997E-2</c:v>
                </c:pt>
                <c:pt idx="257">
                  <c:v>1.7233333333333333E-2</c:v>
                </c:pt>
                <c:pt idx="258">
                  <c:v>1.7283333333333335E-2</c:v>
                </c:pt>
                <c:pt idx="259">
                  <c:v>1.7316666666666664E-2</c:v>
                </c:pt>
                <c:pt idx="260">
                  <c:v>1.7316666666666664E-2</c:v>
                </c:pt>
                <c:pt idx="261">
                  <c:v>1.7316666666666664E-2</c:v>
                </c:pt>
                <c:pt idx="262">
                  <c:v>1.7350000000000001E-2</c:v>
                </c:pt>
                <c:pt idx="263">
                  <c:v>1.7366666666666666E-2</c:v>
                </c:pt>
                <c:pt idx="264">
                  <c:v>1.7450000000000004E-2</c:v>
                </c:pt>
                <c:pt idx="265">
                  <c:v>1.751666666666667E-2</c:v>
                </c:pt>
                <c:pt idx="266">
                  <c:v>1.751666666666667E-2</c:v>
                </c:pt>
                <c:pt idx="267">
                  <c:v>1.7533333333333335E-2</c:v>
                </c:pt>
                <c:pt idx="268">
                  <c:v>1.755E-2</c:v>
                </c:pt>
                <c:pt idx="269">
                  <c:v>1.755E-2</c:v>
                </c:pt>
                <c:pt idx="270">
                  <c:v>1.7583333333333336E-2</c:v>
                </c:pt>
                <c:pt idx="271">
                  <c:v>1.7633333333333334E-2</c:v>
                </c:pt>
                <c:pt idx="272">
                  <c:v>1.7633333333333334E-2</c:v>
                </c:pt>
                <c:pt idx="273">
                  <c:v>1.7666666666666667E-2</c:v>
                </c:pt>
                <c:pt idx="274">
                  <c:v>1.7716666666666669E-2</c:v>
                </c:pt>
                <c:pt idx="275">
                  <c:v>1.7749999999999998E-2</c:v>
                </c:pt>
                <c:pt idx="276">
                  <c:v>1.7783333333333332E-2</c:v>
                </c:pt>
                <c:pt idx="277">
                  <c:v>1.78E-2</c:v>
                </c:pt>
                <c:pt idx="278">
                  <c:v>1.7916666666666668E-2</c:v>
                </c:pt>
                <c:pt idx="279">
                  <c:v>1.7933333333333332E-2</c:v>
                </c:pt>
                <c:pt idx="280">
                  <c:v>1.7950000000000001E-2</c:v>
                </c:pt>
                <c:pt idx="281">
                  <c:v>1.7950000000000001E-2</c:v>
                </c:pt>
                <c:pt idx="282">
                  <c:v>1.7950000000000001E-2</c:v>
                </c:pt>
                <c:pt idx="283">
                  <c:v>1.7950000000000001E-2</c:v>
                </c:pt>
                <c:pt idx="284">
                  <c:v>1.7966666666666669E-2</c:v>
                </c:pt>
                <c:pt idx="285">
                  <c:v>1.7999999999999999E-2</c:v>
                </c:pt>
                <c:pt idx="286">
                  <c:v>1.805E-2</c:v>
                </c:pt>
                <c:pt idx="287">
                  <c:v>1.8033333333333335E-2</c:v>
                </c:pt>
                <c:pt idx="288">
                  <c:v>1.805E-2</c:v>
                </c:pt>
                <c:pt idx="289">
                  <c:v>1.8066666666666668E-2</c:v>
                </c:pt>
                <c:pt idx="290">
                  <c:v>1.8083333333333333E-2</c:v>
                </c:pt>
                <c:pt idx="291">
                  <c:v>1.8133333333333331E-2</c:v>
                </c:pt>
                <c:pt idx="292">
                  <c:v>1.8150000000000003E-2</c:v>
                </c:pt>
                <c:pt idx="293">
                  <c:v>1.8183333333333336E-2</c:v>
                </c:pt>
                <c:pt idx="294">
                  <c:v>1.8183333333333336E-2</c:v>
                </c:pt>
                <c:pt idx="295">
                  <c:v>1.8166666666666668E-2</c:v>
                </c:pt>
                <c:pt idx="296">
                  <c:v>1.8216666666666666E-2</c:v>
                </c:pt>
                <c:pt idx="297">
                  <c:v>1.8249999999999999E-2</c:v>
                </c:pt>
                <c:pt idx="298">
                  <c:v>1.8249999999999999E-2</c:v>
                </c:pt>
                <c:pt idx="299">
                  <c:v>1.8249999999999999E-2</c:v>
                </c:pt>
                <c:pt idx="300">
                  <c:v>1.8266666666666667E-2</c:v>
                </c:pt>
                <c:pt idx="301">
                  <c:v>1.8266666666666667E-2</c:v>
                </c:pt>
                <c:pt idx="302">
                  <c:v>1.8266666666666667E-2</c:v>
                </c:pt>
                <c:pt idx="303">
                  <c:v>1.8266666666666671E-2</c:v>
                </c:pt>
                <c:pt idx="304">
                  <c:v>1.8266666666666671E-2</c:v>
                </c:pt>
                <c:pt idx="305">
                  <c:v>1.83E-2</c:v>
                </c:pt>
                <c:pt idx="306">
                  <c:v>1.8283333333333335E-2</c:v>
                </c:pt>
                <c:pt idx="307">
                  <c:v>1.8283333333333335E-2</c:v>
                </c:pt>
                <c:pt idx="308">
                  <c:v>1.8333333333333337E-2</c:v>
                </c:pt>
                <c:pt idx="309">
                  <c:v>1.8266666666666667E-2</c:v>
                </c:pt>
                <c:pt idx="310">
                  <c:v>1.8250000000000002E-2</c:v>
                </c:pt>
                <c:pt idx="311">
                  <c:v>1.8283333333333335E-2</c:v>
                </c:pt>
                <c:pt idx="312">
                  <c:v>1.8316666666666665E-2</c:v>
                </c:pt>
                <c:pt idx="313">
                  <c:v>1.8333333333333333E-2</c:v>
                </c:pt>
                <c:pt idx="314">
                  <c:v>1.8416666666666668E-2</c:v>
                </c:pt>
                <c:pt idx="315">
                  <c:v>1.8416666666666668E-2</c:v>
                </c:pt>
                <c:pt idx="316">
                  <c:v>1.8416666666666668E-2</c:v>
                </c:pt>
                <c:pt idx="317">
                  <c:v>1.8466666666666666E-2</c:v>
                </c:pt>
                <c:pt idx="318">
                  <c:v>1.8483333333333334E-2</c:v>
                </c:pt>
                <c:pt idx="319">
                  <c:v>1.8483333333333334E-2</c:v>
                </c:pt>
                <c:pt idx="320">
                  <c:v>1.8483333333333334E-2</c:v>
                </c:pt>
                <c:pt idx="321">
                  <c:v>1.8466666666666669E-2</c:v>
                </c:pt>
                <c:pt idx="322">
                  <c:v>1.8466666666666669E-2</c:v>
                </c:pt>
                <c:pt idx="323">
                  <c:v>1.8499999999999999E-2</c:v>
                </c:pt>
                <c:pt idx="324">
                  <c:v>1.8516666666666667E-2</c:v>
                </c:pt>
                <c:pt idx="325">
                  <c:v>1.8499999999999999E-2</c:v>
                </c:pt>
                <c:pt idx="326">
                  <c:v>1.8533333333333336E-2</c:v>
                </c:pt>
                <c:pt idx="327">
                  <c:v>1.8533333333333336E-2</c:v>
                </c:pt>
                <c:pt idx="328">
                  <c:v>1.8533333333333336E-2</c:v>
                </c:pt>
                <c:pt idx="329">
                  <c:v>1.8550000000000001E-2</c:v>
                </c:pt>
                <c:pt idx="330">
                  <c:v>1.8550000000000001E-2</c:v>
                </c:pt>
                <c:pt idx="331">
                  <c:v>1.8566666666666665E-2</c:v>
                </c:pt>
                <c:pt idx="332">
                  <c:v>1.8583333333333334E-2</c:v>
                </c:pt>
                <c:pt idx="333">
                  <c:v>1.8566666666666669E-2</c:v>
                </c:pt>
                <c:pt idx="334">
                  <c:v>1.8550000000000001E-2</c:v>
                </c:pt>
                <c:pt idx="335">
                  <c:v>1.8550000000000001E-2</c:v>
                </c:pt>
                <c:pt idx="336">
                  <c:v>1.8583333333333334E-2</c:v>
                </c:pt>
                <c:pt idx="337">
                  <c:v>1.8600000000000002E-2</c:v>
                </c:pt>
                <c:pt idx="338">
                  <c:v>1.8600000000000002E-2</c:v>
                </c:pt>
                <c:pt idx="339">
                  <c:v>1.8616666666666667E-2</c:v>
                </c:pt>
                <c:pt idx="340">
                  <c:v>1.8616666666666667E-2</c:v>
                </c:pt>
                <c:pt idx="341">
                  <c:v>1.8633333333333332E-2</c:v>
                </c:pt>
                <c:pt idx="342">
                  <c:v>1.865E-2</c:v>
                </c:pt>
                <c:pt idx="343">
                  <c:v>1.8700000000000001E-2</c:v>
                </c:pt>
                <c:pt idx="344">
                  <c:v>1.8666666666666668E-2</c:v>
                </c:pt>
                <c:pt idx="345">
                  <c:v>1.8683333333333333E-2</c:v>
                </c:pt>
                <c:pt idx="346">
                  <c:v>1.8733333333333334E-2</c:v>
                </c:pt>
                <c:pt idx="347">
                  <c:v>1.8733333333333334E-2</c:v>
                </c:pt>
                <c:pt idx="348">
                  <c:v>1.8749999999999999E-2</c:v>
                </c:pt>
                <c:pt idx="349">
                  <c:v>1.8799999999999997E-2</c:v>
                </c:pt>
                <c:pt idx="350">
                  <c:v>1.8866666666666667E-2</c:v>
                </c:pt>
                <c:pt idx="351">
                  <c:v>1.8916666666666665E-2</c:v>
                </c:pt>
                <c:pt idx="352">
                  <c:v>1.8933333333333333E-2</c:v>
                </c:pt>
                <c:pt idx="353">
                  <c:v>1.8949999999999998E-2</c:v>
                </c:pt>
                <c:pt idx="354">
                  <c:v>1.8966666666666666E-2</c:v>
                </c:pt>
                <c:pt idx="355">
                  <c:v>1.9E-2</c:v>
                </c:pt>
                <c:pt idx="356">
                  <c:v>1.9066666666666666E-2</c:v>
                </c:pt>
                <c:pt idx="357">
                  <c:v>1.9099999999999995E-2</c:v>
                </c:pt>
                <c:pt idx="358">
                  <c:v>1.9133333333333332E-2</c:v>
                </c:pt>
                <c:pt idx="359">
                  <c:v>1.9166666666666665E-2</c:v>
                </c:pt>
                <c:pt idx="360">
                  <c:v>1.9199999999999998E-2</c:v>
                </c:pt>
                <c:pt idx="361">
                  <c:v>1.9233333333333335E-2</c:v>
                </c:pt>
                <c:pt idx="362">
                  <c:v>1.9300000000000001E-2</c:v>
                </c:pt>
                <c:pt idx="363">
                  <c:v>1.9316666666666669E-2</c:v>
                </c:pt>
                <c:pt idx="364">
                  <c:v>1.9350000000000003E-2</c:v>
                </c:pt>
                <c:pt idx="365">
                  <c:v>1.9383333333333332E-2</c:v>
                </c:pt>
                <c:pt idx="366">
                  <c:v>1.9449999999999999E-2</c:v>
                </c:pt>
                <c:pt idx="367">
                  <c:v>1.95E-2</c:v>
                </c:pt>
                <c:pt idx="368">
                  <c:v>1.9566666666666666E-2</c:v>
                </c:pt>
                <c:pt idx="369">
                  <c:v>1.9633333333333332E-2</c:v>
                </c:pt>
                <c:pt idx="370">
                  <c:v>1.9666666666666669E-2</c:v>
                </c:pt>
                <c:pt idx="371">
                  <c:v>1.9733333333333335E-2</c:v>
                </c:pt>
                <c:pt idx="372">
                  <c:v>1.9850000000000003E-2</c:v>
                </c:pt>
                <c:pt idx="373">
                  <c:v>1.9916666666666666E-2</c:v>
                </c:pt>
                <c:pt idx="374">
                  <c:v>2.0016666666666669E-2</c:v>
                </c:pt>
                <c:pt idx="375">
                  <c:v>2.0066666666666667E-2</c:v>
                </c:pt>
                <c:pt idx="376">
                  <c:v>2.0116666666666668E-2</c:v>
                </c:pt>
                <c:pt idx="377">
                  <c:v>2.0149999999999998E-2</c:v>
                </c:pt>
                <c:pt idx="378">
                  <c:v>2.0216666666666668E-2</c:v>
                </c:pt>
                <c:pt idx="379">
                  <c:v>2.0250000000000001E-2</c:v>
                </c:pt>
                <c:pt idx="380">
                  <c:v>2.0283333333333337E-2</c:v>
                </c:pt>
                <c:pt idx="381">
                  <c:v>2.0366666666666668E-2</c:v>
                </c:pt>
                <c:pt idx="382">
                  <c:v>2.0416666666666666E-2</c:v>
                </c:pt>
                <c:pt idx="383">
                  <c:v>2.0516666666666666E-2</c:v>
                </c:pt>
                <c:pt idx="384">
                  <c:v>2.0600000000000004E-2</c:v>
                </c:pt>
                <c:pt idx="385">
                  <c:v>2.0650000000000002E-2</c:v>
                </c:pt>
                <c:pt idx="386">
                  <c:v>2.0733333333333333E-2</c:v>
                </c:pt>
                <c:pt idx="387">
                  <c:v>2.0750000000000001E-2</c:v>
                </c:pt>
                <c:pt idx="388">
                  <c:v>2.0799999999999999E-2</c:v>
                </c:pt>
                <c:pt idx="389">
                  <c:v>2.0799999999999999E-2</c:v>
                </c:pt>
                <c:pt idx="390">
                  <c:v>2.0899999999999998E-2</c:v>
                </c:pt>
                <c:pt idx="391">
                  <c:v>2.0933333333333335E-2</c:v>
                </c:pt>
                <c:pt idx="392">
                  <c:v>2.095E-2</c:v>
                </c:pt>
                <c:pt idx="393">
                  <c:v>2.0983333333333336E-2</c:v>
                </c:pt>
                <c:pt idx="394">
                  <c:v>2.101666666666667E-2</c:v>
                </c:pt>
                <c:pt idx="395">
                  <c:v>2.1033333333333334E-2</c:v>
                </c:pt>
                <c:pt idx="396">
                  <c:v>2.1083333333333332E-2</c:v>
                </c:pt>
                <c:pt idx="397">
                  <c:v>2.1083333333333332E-2</c:v>
                </c:pt>
                <c:pt idx="398">
                  <c:v>2.1050000000000003E-2</c:v>
                </c:pt>
                <c:pt idx="399">
                  <c:v>2.1083333333333332E-2</c:v>
                </c:pt>
                <c:pt idx="400">
                  <c:v>2.1083333333333332E-2</c:v>
                </c:pt>
                <c:pt idx="401">
                  <c:v>2.1050000000000003E-2</c:v>
                </c:pt>
                <c:pt idx="402">
                  <c:v>2.1050000000000003E-2</c:v>
                </c:pt>
                <c:pt idx="403">
                  <c:v>2.1050000000000003E-2</c:v>
                </c:pt>
                <c:pt idx="404">
                  <c:v>2.0983333333333336E-2</c:v>
                </c:pt>
                <c:pt idx="405">
                  <c:v>2.0966666666666672E-2</c:v>
                </c:pt>
                <c:pt idx="406">
                  <c:v>2.0916666666666667E-2</c:v>
                </c:pt>
                <c:pt idx="407">
                  <c:v>2.0883333333333334E-2</c:v>
                </c:pt>
                <c:pt idx="408">
                  <c:v>2.0833333333333332E-2</c:v>
                </c:pt>
                <c:pt idx="409">
                  <c:v>2.0783333333333331E-2</c:v>
                </c:pt>
                <c:pt idx="410">
                  <c:v>2.0766666666666666E-2</c:v>
                </c:pt>
                <c:pt idx="411">
                  <c:v>2.07E-2</c:v>
                </c:pt>
                <c:pt idx="412">
                  <c:v>2.0650000000000002E-2</c:v>
                </c:pt>
                <c:pt idx="413">
                  <c:v>2.0616666666666665E-2</c:v>
                </c:pt>
                <c:pt idx="414">
                  <c:v>2.0549999999999999E-2</c:v>
                </c:pt>
                <c:pt idx="415">
                  <c:v>2.0516666666666666E-2</c:v>
                </c:pt>
                <c:pt idx="416">
                  <c:v>2.0433333333333335E-2</c:v>
                </c:pt>
                <c:pt idx="417">
                  <c:v>2.0349999999999997E-2</c:v>
                </c:pt>
                <c:pt idx="418">
                  <c:v>2.0266666666666665E-2</c:v>
                </c:pt>
                <c:pt idx="419">
                  <c:v>2.0250000000000001E-2</c:v>
                </c:pt>
                <c:pt idx="420">
                  <c:v>2.0133333333333333E-2</c:v>
                </c:pt>
                <c:pt idx="421">
                  <c:v>2.0066666666666667E-2</c:v>
                </c:pt>
                <c:pt idx="422">
                  <c:v>2.0016666666666665E-2</c:v>
                </c:pt>
                <c:pt idx="423">
                  <c:v>1.9983333333333336E-2</c:v>
                </c:pt>
                <c:pt idx="424">
                  <c:v>1.9916666666666666E-2</c:v>
                </c:pt>
                <c:pt idx="425">
                  <c:v>1.9849999999999996E-2</c:v>
                </c:pt>
                <c:pt idx="426">
                  <c:v>1.9783333333333333E-2</c:v>
                </c:pt>
                <c:pt idx="427">
                  <c:v>1.9716666666666671E-2</c:v>
                </c:pt>
                <c:pt idx="428">
                  <c:v>1.9683333333333334E-2</c:v>
                </c:pt>
                <c:pt idx="429">
                  <c:v>1.9683333333333334E-2</c:v>
                </c:pt>
                <c:pt idx="430">
                  <c:v>1.9616666666666668E-2</c:v>
                </c:pt>
                <c:pt idx="431">
                  <c:v>1.9633333333333336E-2</c:v>
                </c:pt>
                <c:pt idx="432">
                  <c:v>1.9600000000000003E-2</c:v>
                </c:pt>
                <c:pt idx="433">
                  <c:v>1.9566666666666666E-2</c:v>
                </c:pt>
                <c:pt idx="434">
                  <c:v>1.9550000000000001E-2</c:v>
                </c:pt>
                <c:pt idx="435">
                  <c:v>1.9516666666666665E-2</c:v>
                </c:pt>
                <c:pt idx="436">
                  <c:v>1.9516666666666665E-2</c:v>
                </c:pt>
                <c:pt idx="437">
                  <c:v>1.95E-2</c:v>
                </c:pt>
                <c:pt idx="438">
                  <c:v>1.95E-2</c:v>
                </c:pt>
                <c:pt idx="439">
                  <c:v>1.9533333333333333E-2</c:v>
                </c:pt>
                <c:pt idx="440">
                  <c:v>1.9533333333333333E-2</c:v>
                </c:pt>
                <c:pt idx="441">
                  <c:v>1.9533333333333333E-2</c:v>
                </c:pt>
                <c:pt idx="442">
                  <c:v>1.9583333333333335E-2</c:v>
                </c:pt>
                <c:pt idx="443">
                  <c:v>1.9566666666666666E-2</c:v>
                </c:pt>
                <c:pt idx="444">
                  <c:v>1.9616666666666668E-2</c:v>
                </c:pt>
                <c:pt idx="445">
                  <c:v>1.9666666666666669E-2</c:v>
                </c:pt>
                <c:pt idx="446">
                  <c:v>1.9700000000000002E-2</c:v>
                </c:pt>
                <c:pt idx="447">
                  <c:v>1.9716666666666671E-2</c:v>
                </c:pt>
                <c:pt idx="448">
                  <c:v>1.975E-2</c:v>
                </c:pt>
                <c:pt idx="449">
                  <c:v>1.9783333333333337E-2</c:v>
                </c:pt>
                <c:pt idx="450">
                  <c:v>1.9816666666666666E-2</c:v>
                </c:pt>
                <c:pt idx="451">
                  <c:v>1.9833333333333331E-2</c:v>
                </c:pt>
                <c:pt idx="452">
                  <c:v>1.9849999999999996E-2</c:v>
                </c:pt>
                <c:pt idx="453">
                  <c:v>1.9816666666666666E-2</c:v>
                </c:pt>
                <c:pt idx="454">
                  <c:v>1.9783333333333333E-2</c:v>
                </c:pt>
                <c:pt idx="455">
                  <c:v>1.9766666666666668E-2</c:v>
                </c:pt>
                <c:pt idx="456">
                  <c:v>1.9783333333333337E-2</c:v>
                </c:pt>
                <c:pt idx="457">
                  <c:v>1.9733333333333335E-2</c:v>
                </c:pt>
                <c:pt idx="458">
                  <c:v>1.9683333333333334E-2</c:v>
                </c:pt>
                <c:pt idx="459">
                  <c:v>1.9616666666666664E-2</c:v>
                </c:pt>
                <c:pt idx="460">
                  <c:v>1.9533333333333333E-2</c:v>
                </c:pt>
                <c:pt idx="461">
                  <c:v>1.9433333333333334E-2</c:v>
                </c:pt>
                <c:pt idx="462">
                  <c:v>1.9416666666666665E-2</c:v>
                </c:pt>
                <c:pt idx="463">
                  <c:v>1.9316666666666666E-2</c:v>
                </c:pt>
                <c:pt idx="464">
                  <c:v>1.9266666666666668E-2</c:v>
                </c:pt>
                <c:pt idx="465">
                  <c:v>1.9166666666666669E-2</c:v>
                </c:pt>
                <c:pt idx="466">
                  <c:v>1.9099999999999999E-2</c:v>
                </c:pt>
                <c:pt idx="467">
                  <c:v>1.8983333333333335E-2</c:v>
                </c:pt>
                <c:pt idx="468">
                  <c:v>1.8949999999999998E-2</c:v>
                </c:pt>
                <c:pt idx="469">
                  <c:v>1.8899999999999997E-2</c:v>
                </c:pt>
                <c:pt idx="470">
                  <c:v>1.8866666666666667E-2</c:v>
                </c:pt>
                <c:pt idx="471">
                  <c:v>1.8800000000000001E-2</c:v>
                </c:pt>
                <c:pt idx="472">
                  <c:v>1.8733333333333334E-2</c:v>
                </c:pt>
                <c:pt idx="473">
                  <c:v>1.871666666666667E-2</c:v>
                </c:pt>
                <c:pt idx="474">
                  <c:v>1.8699999999999998E-2</c:v>
                </c:pt>
                <c:pt idx="475">
                  <c:v>1.8749999999999999E-2</c:v>
                </c:pt>
                <c:pt idx="476">
                  <c:v>1.8766666666666668E-2</c:v>
                </c:pt>
                <c:pt idx="477">
                  <c:v>1.8800000000000001E-2</c:v>
                </c:pt>
                <c:pt idx="478">
                  <c:v>1.8833333333333334E-2</c:v>
                </c:pt>
                <c:pt idx="479">
                  <c:v>1.8833333333333334E-2</c:v>
                </c:pt>
                <c:pt idx="480">
                  <c:v>1.8850000000000002E-2</c:v>
                </c:pt>
                <c:pt idx="481">
                  <c:v>1.8916666666666665E-2</c:v>
                </c:pt>
                <c:pt idx="482">
                  <c:v>1.9033333333333333E-2</c:v>
                </c:pt>
                <c:pt idx="483">
                  <c:v>1.9116666666666667E-2</c:v>
                </c:pt>
                <c:pt idx="484">
                  <c:v>1.9166666666666665E-2</c:v>
                </c:pt>
                <c:pt idx="485">
                  <c:v>1.9266666666666665E-2</c:v>
                </c:pt>
                <c:pt idx="486">
                  <c:v>1.9366666666666667E-2</c:v>
                </c:pt>
                <c:pt idx="487">
                  <c:v>1.9400000000000001E-2</c:v>
                </c:pt>
                <c:pt idx="488">
                  <c:v>1.9483333333333335E-2</c:v>
                </c:pt>
                <c:pt idx="489">
                  <c:v>1.9533333333333337E-2</c:v>
                </c:pt>
                <c:pt idx="490">
                  <c:v>1.9666666666666666E-2</c:v>
                </c:pt>
                <c:pt idx="491">
                  <c:v>1.9766666666666668E-2</c:v>
                </c:pt>
                <c:pt idx="492">
                  <c:v>1.985E-2</c:v>
                </c:pt>
                <c:pt idx="493">
                  <c:v>1.9966666666666667E-2</c:v>
                </c:pt>
                <c:pt idx="494">
                  <c:v>2.0083333333333338E-2</c:v>
                </c:pt>
                <c:pt idx="495">
                  <c:v>2.0166666666666666E-2</c:v>
                </c:pt>
                <c:pt idx="496">
                  <c:v>2.0266666666666669E-2</c:v>
                </c:pt>
                <c:pt idx="497">
                  <c:v>2.035E-2</c:v>
                </c:pt>
                <c:pt idx="498">
                  <c:v>2.0416666666666666E-2</c:v>
                </c:pt>
                <c:pt idx="499">
                  <c:v>2.0500000000000001E-2</c:v>
                </c:pt>
                <c:pt idx="500">
                  <c:v>2.0649999999999998E-2</c:v>
                </c:pt>
                <c:pt idx="501">
                  <c:v>2.0750000000000001E-2</c:v>
                </c:pt>
                <c:pt idx="502">
                  <c:v>2.0816666666666667E-2</c:v>
                </c:pt>
                <c:pt idx="503">
                  <c:v>2.095E-2</c:v>
                </c:pt>
                <c:pt idx="504">
                  <c:v>2.098333333333333E-2</c:v>
                </c:pt>
                <c:pt idx="505">
                  <c:v>2.1183333333333332E-2</c:v>
                </c:pt>
                <c:pt idx="506">
                  <c:v>2.1250000000000002E-2</c:v>
                </c:pt>
                <c:pt idx="507">
                  <c:v>2.1366666666666669E-2</c:v>
                </c:pt>
                <c:pt idx="508">
                  <c:v>2.1466666666666662E-2</c:v>
                </c:pt>
                <c:pt idx="509">
                  <c:v>2.1566666666666665E-2</c:v>
                </c:pt>
                <c:pt idx="510">
                  <c:v>2.1750000000000002E-2</c:v>
                </c:pt>
                <c:pt idx="511">
                  <c:v>2.18E-2</c:v>
                </c:pt>
                <c:pt idx="512">
                  <c:v>2.1900000000000003E-2</c:v>
                </c:pt>
                <c:pt idx="513">
                  <c:v>2.2000000000000002E-2</c:v>
                </c:pt>
                <c:pt idx="514">
                  <c:v>2.205E-2</c:v>
                </c:pt>
                <c:pt idx="515">
                  <c:v>2.2183333333333333E-2</c:v>
                </c:pt>
                <c:pt idx="516">
                  <c:v>2.2316666666666669E-2</c:v>
                </c:pt>
                <c:pt idx="517">
                  <c:v>2.2366666666666663E-2</c:v>
                </c:pt>
                <c:pt idx="518">
                  <c:v>2.2383333333333338E-2</c:v>
                </c:pt>
                <c:pt idx="519">
                  <c:v>2.2433333333333333E-2</c:v>
                </c:pt>
                <c:pt idx="520">
                  <c:v>2.2499999999999996E-2</c:v>
                </c:pt>
                <c:pt idx="521">
                  <c:v>2.2499999999999996E-2</c:v>
                </c:pt>
                <c:pt idx="522">
                  <c:v>2.2550000000000001E-2</c:v>
                </c:pt>
                <c:pt idx="523">
                  <c:v>2.2599999999999999E-2</c:v>
                </c:pt>
                <c:pt idx="524">
                  <c:v>2.2666666666666668E-2</c:v>
                </c:pt>
                <c:pt idx="525">
                  <c:v>2.2733333333333331E-2</c:v>
                </c:pt>
                <c:pt idx="526">
                  <c:v>2.2800000000000001E-2</c:v>
                </c:pt>
                <c:pt idx="527">
                  <c:v>2.2849999999999999E-2</c:v>
                </c:pt>
                <c:pt idx="528">
                  <c:v>2.2883333333333335E-2</c:v>
                </c:pt>
                <c:pt idx="529">
                  <c:v>2.2966666666666663E-2</c:v>
                </c:pt>
                <c:pt idx="530">
                  <c:v>2.3033333333333333E-2</c:v>
                </c:pt>
                <c:pt idx="531">
                  <c:v>2.3083333333333334E-2</c:v>
                </c:pt>
                <c:pt idx="532">
                  <c:v>2.3133333333333336E-2</c:v>
                </c:pt>
                <c:pt idx="533">
                  <c:v>2.3183333333333334E-2</c:v>
                </c:pt>
                <c:pt idx="534">
                  <c:v>2.3250000000000003E-2</c:v>
                </c:pt>
                <c:pt idx="535">
                  <c:v>2.3316666666666666E-2</c:v>
                </c:pt>
                <c:pt idx="536">
                  <c:v>2.3416666666666669E-2</c:v>
                </c:pt>
                <c:pt idx="537">
                  <c:v>2.3483333333333332E-2</c:v>
                </c:pt>
                <c:pt idx="538">
                  <c:v>2.3550000000000001E-2</c:v>
                </c:pt>
                <c:pt idx="539">
                  <c:v>2.3616666666666664E-2</c:v>
                </c:pt>
                <c:pt idx="540">
                  <c:v>2.3616666666666664E-2</c:v>
                </c:pt>
                <c:pt idx="541">
                  <c:v>2.3750000000000004E-2</c:v>
                </c:pt>
                <c:pt idx="542">
                  <c:v>2.3833333333333335E-2</c:v>
                </c:pt>
                <c:pt idx="543">
                  <c:v>2.3916666666666666E-2</c:v>
                </c:pt>
                <c:pt idx="544">
                  <c:v>2.3983333333333332E-2</c:v>
                </c:pt>
                <c:pt idx="545">
                  <c:v>2.4033333333333337E-2</c:v>
                </c:pt>
                <c:pt idx="546">
                  <c:v>2.4116666666666665E-2</c:v>
                </c:pt>
                <c:pt idx="547">
                  <c:v>2.4183333333333331E-2</c:v>
                </c:pt>
                <c:pt idx="548">
                  <c:v>2.4299999999999999E-2</c:v>
                </c:pt>
                <c:pt idx="549">
                  <c:v>2.438333333333333E-2</c:v>
                </c:pt>
                <c:pt idx="550">
                  <c:v>2.4499999999999997E-2</c:v>
                </c:pt>
                <c:pt idx="551">
                  <c:v>2.4550000000000002E-2</c:v>
                </c:pt>
                <c:pt idx="552">
                  <c:v>2.4616666666666665E-2</c:v>
                </c:pt>
                <c:pt idx="553">
                  <c:v>2.4650000000000002E-2</c:v>
                </c:pt>
                <c:pt idx="554">
                  <c:v>2.4766666666666663E-2</c:v>
                </c:pt>
                <c:pt idx="555">
                  <c:v>2.4883333333333337E-2</c:v>
                </c:pt>
                <c:pt idx="556">
                  <c:v>2.4900000000000002E-2</c:v>
                </c:pt>
                <c:pt idx="557">
                  <c:v>2.4966666666666668E-2</c:v>
                </c:pt>
                <c:pt idx="558">
                  <c:v>2.5050000000000003E-2</c:v>
                </c:pt>
                <c:pt idx="559">
                  <c:v>2.5116666666666666E-2</c:v>
                </c:pt>
                <c:pt idx="560">
                  <c:v>2.5166666666666667E-2</c:v>
                </c:pt>
                <c:pt idx="561">
                  <c:v>2.5250000000000005E-2</c:v>
                </c:pt>
                <c:pt idx="562">
                  <c:v>2.5283333333333335E-2</c:v>
                </c:pt>
                <c:pt idx="563">
                  <c:v>2.5400000000000006E-2</c:v>
                </c:pt>
                <c:pt idx="564">
                  <c:v>2.5483333333333334E-2</c:v>
                </c:pt>
                <c:pt idx="565">
                  <c:v>2.5499999999999998E-2</c:v>
                </c:pt>
                <c:pt idx="566">
                  <c:v>2.5600000000000001E-2</c:v>
                </c:pt>
                <c:pt idx="567">
                  <c:v>2.5616666666666666E-2</c:v>
                </c:pt>
                <c:pt idx="568">
                  <c:v>2.5616666666666666E-2</c:v>
                </c:pt>
                <c:pt idx="569">
                  <c:v>2.5716666666666665E-2</c:v>
                </c:pt>
                <c:pt idx="570">
                  <c:v>2.573333333333333E-2</c:v>
                </c:pt>
                <c:pt idx="571">
                  <c:v>2.576666666666667E-2</c:v>
                </c:pt>
                <c:pt idx="572">
                  <c:v>2.5833333333333333E-2</c:v>
                </c:pt>
                <c:pt idx="573">
                  <c:v>2.5983333333333331E-2</c:v>
                </c:pt>
                <c:pt idx="574">
                  <c:v>2.6016666666666664E-2</c:v>
                </c:pt>
                <c:pt idx="575">
                  <c:v>2.6066666666666669E-2</c:v>
                </c:pt>
                <c:pt idx="576">
                  <c:v>2.6216666666666666E-2</c:v>
                </c:pt>
                <c:pt idx="577">
                  <c:v>2.6249999999999999E-2</c:v>
                </c:pt>
                <c:pt idx="578">
                  <c:v>2.6300000000000004E-2</c:v>
                </c:pt>
                <c:pt idx="579">
                  <c:v>2.6366666666666667E-2</c:v>
                </c:pt>
                <c:pt idx="580">
                  <c:v>2.6366666666666667E-2</c:v>
                </c:pt>
                <c:pt idx="581">
                  <c:v>2.6400000000000003E-2</c:v>
                </c:pt>
                <c:pt idx="582">
                  <c:v>2.6466666666666666E-2</c:v>
                </c:pt>
                <c:pt idx="583">
                  <c:v>2.6483333333333331E-2</c:v>
                </c:pt>
                <c:pt idx="584">
                  <c:v>2.6483333333333334E-2</c:v>
                </c:pt>
                <c:pt idx="585">
                  <c:v>2.6516666666666671E-2</c:v>
                </c:pt>
                <c:pt idx="586">
                  <c:v>2.6533333333333336E-2</c:v>
                </c:pt>
                <c:pt idx="587">
                  <c:v>2.6583333333333334E-2</c:v>
                </c:pt>
                <c:pt idx="588">
                  <c:v>2.6599999999999999E-2</c:v>
                </c:pt>
                <c:pt idx="589">
                  <c:v>2.6666666666666668E-2</c:v>
                </c:pt>
                <c:pt idx="590">
                  <c:v>2.6716666666666666E-2</c:v>
                </c:pt>
                <c:pt idx="591">
                  <c:v>2.6749999999999999E-2</c:v>
                </c:pt>
                <c:pt idx="592">
                  <c:v>2.6783333333333336E-2</c:v>
                </c:pt>
                <c:pt idx="593">
                  <c:v>2.6816666666666666E-2</c:v>
                </c:pt>
                <c:pt idx="594">
                  <c:v>2.6816666666666666E-2</c:v>
                </c:pt>
                <c:pt idx="595">
                  <c:v>2.6866666666666667E-2</c:v>
                </c:pt>
                <c:pt idx="596">
                  <c:v>2.6933333333333337E-2</c:v>
                </c:pt>
                <c:pt idx="597">
                  <c:v>2.6933333333333333E-2</c:v>
                </c:pt>
                <c:pt idx="598">
                  <c:v>2.6933333333333333E-2</c:v>
                </c:pt>
                <c:pt idx="599">
                  <c:v>2.6966666666666667E-2</c:v>
                </c:pt>
                <c:pt idx="600">
                  <c:v>2.6933333333333333E-2</c:v>
                </c:pt>
                <c:pt idx="601">
                  <c:v>2.6966666666666667E-2</c:v>
                </c:pt>
                <c:pt idx="602">
                  <c:v>2.7116666666666664E-2</c:v>
                </c:pt>
                <c:pt idx="603">
                  <c:v>2.7166666666666662E-2</c:v>
                </c:pt>
                <c:pt idx="604">
                  <c:v>2.7166666666666669E-2</c:v>
                </c:pt>
                <c:pt idx="605">
                  <c:v>2.7133333333333332E-2</c:v>
                </c:pt>
                <c:pt idx="606">
                  <c:v>2.7116666666666664E-2</c:v>
                </c:pt>
                <c:pt idx="607">
                  <c:v>2.7116666666666667E-2</c:v>
                </c:pt>
                <c:pt idx="608">
                  <c:v>2.7099999999999999E-2</c:v>
                </c:pt>
                <c:pt idx="609">
                  <c:v>2.7166666666666662E-2</c:v>
                </c:pt>
                <c:pt idx="610">
                  <c:v>2.7166666666666662E-2</c:v>
                </c:pt>
                <c:pt idx="611">
                  <c:v>2.7166666666666662E-2</c:v>
                </c:pt>
                <c:pt idx="612">
                  <c:v>2.7166666666666669E-2</c:v>
                </c:pt>
                <c:pt idx="613">
                  <c:v>2.7183333333333334E-2</c:v>
                </c:pt>
                <c:pt idx="614">
                  <c:v>2.721666666666667E-2</c:v>
                </c:pt>
                <c:pt idx="615">
                  <c:v>2.7233333333333332E-2</c:v>
                </c:pt>
                <c:pt idx="616">
                  <c:v>2.7216666666666667E-2</c:v>
                </c:pt>
                <c:pt idx="617">
                  <c:v>2.725E-2</c:v>
                </c:pt>
                <c:pt idx="618">
                  <c:v>2.7283333333333337E-2</c:v>
                </c:pt>
                <c:pt idx="619">
                  <c:v>2.7300000000000001E-2</c:v>
                </c:pt>
                <c:pt idx="620">
                  <c:v>2.7333333333333334E-2</c:v>
                </c:pt>
                <c:pt idx="621">
                  <c:v>2.7349999999999999E-2</c:v>
                </c:pt>
                <c:pt idx="622">
                  <c:v>2.7316666666666666E-2</c:v>
                </c:pt>
                <c:pt idx="623">
                  <c:v>2.7333333333333334E-2</c:v>
                </c:pt>
                <c:pt idx="624">
                  <c:v>2.7333333333333334E-2</c:v>
                </c:pt>
                <c:pt idx="625">
                  <c:v>2.7383333333333332E-2</c:v>
                </c:pt>
                <c:pt idx="626">
                  <c:v>2.7383333333333332E-2</c:v>
                </c:pt>
                <c:pt idx="627">
                  <c:v>2.7399999999999997E-2</c:v>
                </c:pt>
                <c:pt idx="628">
                  <c:v>2.7399999999999997E-2</c:v>
                </c:pt>
                <c:pt idx="629">
                  <c:v>2.7483333333333332E-2</c:v>
                </c:pt>
                <c:pt idx="630">
                  <c:v>2.756666666666667E-2</c:v>
                </c:pt>
                <c:pt idx="631">
                  <c:v>2.756666666666667E-2</c:v>
                </c:pt>
                <c:pt idx="632">
                  <c:v>2.7633333333333333E-2</c:v>
                </c:pt>
                <c:pt idx="633">
                  <c:v>2.7600000000000003E-2</c:v>
                </c:pt>
                <c:pt idx="634">
                  <c:v>2.7600000000000003E-2</c:v>
                </c:pt>
                <c:pt idx="635">
                  <c:v>2.7616666666666668E-2</c:v>
                </c:pt>
                <c:pt idx="636">
                  <c:v>2.7633333333333333E-2</c:v>
                </c:pt>
                <c:pt idx="637">
                  <c:v>2.7666666666666662E-2</c:v>
                </c:pt>
                <c:pt idx="638">
                  <c:v>2.7716666666666667E-2</c:v>
                </c:pt>
                <c:pt idx="639">
                  <c:v>2.7716666666666667E-2</c:v>
                </c:pt>
                <c:pt idx="640">
                  <c:v>2.7700000000000002E-2</c:v>
                </c:pt>
                <c:pt idx="641">
                  <c:v>2.7649999999999997E-2</c:v>
                </c:pt>
                <c:pt idx="642">
                  <c:v>2.7766666666666665E-2</c:v>
                </c:pt>
                <c:pt idx="643">
                  <c:v>2.7816666666666667E-2</c:v>
                </c:pt>
                <c:pt idx="644">
                  <c:v>2.7850000000000003E-2</c:v>
                </c:pt>
                <c:pt idx="645">
                  <c:v>2.7933333333333327E-2</c:v>
                </c:pt>
                <c:pt idx="646">
                  <c:v>2.7949999999999999E-2</c:v>
                </c:pt>
                <c:pt idx="647">
                  <c:v>2.7983333333333336E-2</c:v>
                </c:pt>
                <c:pt idx="648">
                  <c:v>2.7900000000000005E-2</c:v>
                </c:pt>
                <c:pt idx="649">
                  <c:v>2.8000000000000001E-2</c:v>
                </c:pt>
                <c:pt idx="650">
                  <c:v>2.8016666666666672E-2</c:v>
                </c:pt>
                <c:pt idx="651">
                  <c:v>2.8050000000000002E-2</c:v>
                </c:pt>
                <c:pt idx="652">
                  <c:v>2.816666666666667E-2</c:v>
                </c:pt>
                <c:pt idx="653">
                  <c:v>2.8150000000000005E-2</c:v>
                </c:pt>
                <c:pt idx="654">
                  <c:v>2.8233333333333333E-2</c:v>
                </c:pt>
                <c:pt idx="655">
                  <c:v>2.8233333333333333E-2</c:v>
                </c:pt>
                <c:pt idx="656">
                  <c:v>2.8316666666666667E-2</c:v>
                </c:pt>
                <c:pt idx="657">
                  <c:v>2.8316666666666667E-2</c:v>
                </c:pt>
                <c:pt idx="658">
                  <c:v>2.8366666666666669E-2</c:v>
                </c:pt>
                <c:pt idx="659">
                  <c:v>2.8399999999999998E-2</c:v>
                </c:pt>
                <c:pt idx="660">
                  <c:v>2.8383333333333333E-2</c:v>
                </c:pt>
                <c:pt idx="661">
                  <c:v>2.841666666666667E-2</c:v>
                </c:pt>
                <c:pt idx="662">
                  <c:v>2.8433333333333335E-2</c:v>
                </c:pt>
                <c:pt idx="663">
                  <c:v>2.8433333333333335E-2</c:v>
                </c:pt>
                <c:pt idx="664">
                  <c:v>2.8466666666666668E-2</c:v>
                </c:pt>
                <c:pt idx="665">
                  <c:v>2.8500000000000001E-2</c:v>
                </c:pt>
                <c:pt idx="666">
                  <c:v>2.8500000000000001E-2</c:v>
                </c:pt>
                <c:pt idx="667">
                  <c:v>2.8499999999999998E-2</c:v>
                </c:pt>
                <c:pt idx="668">
                  <c:v>2.8550000000000002E-2</c:v>
                </c:pt>
                <c:pt idx="669">
                  <c:v>2.8716666666666668E-2</c:v>
                </c:pt>
                <c:pt idx="670">
                  <c:v>2.8700000000000003E-2</c:v>
                </c:pt>
                <c:pt idx="671">
                  <c:v>2.8149999999999998E-2</c:v>
                </c:pt>
                <c:pt idx="672">
                  <c:v>2.7649999999999997E-2</c:v>
                </c:pt>
                <c:pt idx="673">
                  <c:v>2.6999999999999996E-2</c:v>
                </c:pt>
                <c:pt idx="674">
                  <c:v>2.6483333333333331E-2</c:v>
                </c:pt>
                <c:pt idx="675">
                  <c:v>2.6533333333333329E-2</c:v>
                </c:pt>
                <c:pt idx="676">
                  <c:v>2.6450000000000001E-2</c:v>
                </c:pt>
                <c:pt idx="677">
                  <c:v>2.6566666666666669E-2</c:v>
                </c:pt>
                <c:pt idx="678">
                  <c:v>2.6650000000000004E-2</c:v>
                </c:pt>
                <c:pt idx="679">
                  <c:v>2.6616666666666667E-2</c:v>
                </c:pt>
                <c:pt idx="680">
                  <c:v>2.6699999999999998E-2</c:v>
                </c:pt>
                <c:pt idx="681">
                  <c:v>2.6700000000000002E-2</c:v>
                </c:pt>
                <c:pt idx="682">
                  <c:v>2.6749999999999996E-2</c:v>
                </c:pt>
                <c:pt idx="683">
                  <c:v>2.6850000000000002E-2</c:v>
                </c:pt>
                <c:pt idx="684">
                  <c:v>2.6916666666666669E-2</c:v>
                </c:pt>
                <c:pt idx="685">
                  <c:v>2.7050000000000005E-2</c:v>
                </c:pt>
                <c:pt idx="686">
                  <c:v>2.7116666666666667E-2</c:v>
                </c:pt>
                <c:pt idx="687">
                  <c:v>2.7199999999999998E-2</c:v>
                </c:pt>
                <c:pt idx="688">
                  <c:v>2.7249999999999996E-2</c:v>
                </c:pt>
                <c:pt idx="689">
                  <c:v>2.7216666666666667E-2</c:v>
                </c:pt>
                <c:pt idx="690">
                  <c:v>2.7166666666666672E-2</c:v>
                </c:pt>
                <c:pt idx="691">
                  <c:v>2.7116666666666664E-2</c:v>
                </c:pt>
                <c:pt idx="692">
                  <c:v>2.7133333333333332E-2</c:v>
                </c:pt>
                <c:pt idx="693">
                  <c:v>2.7233333333333332E-2</c:v>
                </c:pt>
                <c:pt idx="694">
                  <c:v>2.7333333333333338E-2</c:v>
                </c:pt>
                <c:pt idx="695">
                  <c:v>2.7366666666666668E-2</c:v>
                </c:pt>
                <c:pt idx="696">
                  <c:v>2.7433333333333334E-2</c:v>
                </c:pt>
                <c:pt idx="697">
                  <c:v>2.7516666666666665E-2</c:v>
                </c:pt>
                <c:pt idx="698">
                  <c:v>2.7616666666666668E-2</c:v>
                </c:pt>
                <c:pt idx="699">
                  <c:v>2.7783333333333337E-2</c:v>
                </c:pt>
                <c:pt idx="700">
                  <c:v>2.781666666666667E-2</c:v>
                </c:pt>
                <c:pt idx="701">
                  <c:v>2.7850000000000003E-2</c:v>
                </c:pt>
                <c:pt idx="702">
                  <c:v>2.7833333333333335E-2</c:v>
                </c:pt>
                <c:pt idx="703">
                  <c:v>2.785E-2</c:v>
                </c:pt>
                <c:pt idx="704">
                  <c:v>2.7866666666666668E-2</c:v>
                </c:pt>
                <c:pt idx="705">
                  <c:v>2.7950000000000003E-2</c:v>
                </c:pt>
                <c:pt idx="706">
                  <c:v>2.806666666666667E-2</c:v>
                </c:pt>
                <c:pt idx="707">
                  <c:v>2.8100000000000003E-2</c:v>
                </c:pt>
                <c:pt idx="708">
                  <c:v>2.8149999999999998E-2</c:v>
                </c:pt>
                <c:pt idx="709">
                  <c:v>2.8133333333333333E-2</c:v>
                </c:pt>
                <c:pt idx="710">
                  <c:v>2.8233333333333333E-2</c:v>
                </c:pt>
                <c:pt idx="711">
                  <c:v>2.8249999999999997E-2</c:v>
                </c:pt>
                <c:pt idx="712">
                  <c:v>2.8316666666666667E-2</c:v>
                </c:pt>
                <c:pt idx="713">
                  <c:v>2.841666666666667E-2</c:v>
                </c:pt>
                <c:pt idx="714">
                  <c:v>2.8399999999999998E-2</c:v>
                </c:pt>
                <c:pt idx="715">
                  <c:v>2.8566666666666667E-2</c:v>
                </c:pt>
                <c:pt idx="716">
                  <c:v>2.863333333333333E-2</c:v>
                </c:pt>
                <c:pt idx="717">
                  <c:v>2.87E-2</c:v>
                </c:pt>
                <c:pt idx="718">
                  <c:v>2.8899999999999999E-2</c:v>
                </c:pt>
                <c:pt idx="719">
                  <c:v>2.8900000000000006E-2</c:v>
                </c:pt>
                <c:pt idx="720">
                  <c:v>2.8966666666666668E-2</c:v>
                </c:pt>
                <c:pt idx="721">
                  <c:v>2.9083333333333333E-2</c:v>
                </c:pt>
                <c:pt idx="722">
                  <c:v>2.9066666666666668E-2</c:v>
                </c:pt>
                <c:pt idx="723">
                  <c:v>2.9166666666666664E-2</c:v>
                </c:pt>
                <c:pt idx="724">
                  <c:v>2.9183333333333335E-2</c:v>
                </c:pt>
                <c:pt idx="725">
                  <c:v>2.9349999999999998E-2</c:v>
                </c:pt>
                <c:pt idx="726">
                  <c:v>2.9349999999999998E-2</c:v>
                </c:pt>
                <c:pt idx="727">
                  <c:v>2.945E-2</c:v>
                </c:pt>
                <c:pt idx="728">
                  <c:v>2.9533333333333332E-2</c:v>
                </c:pt>
                <c:pt idx="729">
                  <c:v>2.945E-2</c:v>
                </c:pt>
                <c:pt idx="730">
                  <c:v>2.9533333333333332E-2</c:v>
                </c:pt>
                <c:pt idx="731">
                  <c:v>2.9599999999999998E-2</c:v>
                </c:pt>
                <c:pt idx="732">
                  <c:v>2.9716666666666666E-2</c:v>
                </c:pt>
                <c:pt idx="733">
                  <c:v>2.973333333333333E-2</c:v>
                </c:pt>
                <c:pt idx="734">
                  <c:v>2.9816666666666668E-2</c:v>
                </c:pt>
                <c:pt idx="735">
                  <c:v>2.986666666666667E-2</c:v>
                </c:pt>
                <c:pt idx="736">
                  <c:v>2.9816666666666668E-2</c:v>
                </c:pt>
                <c:pt idx="737">
                  <c:v>3.0016666666666667E-2</c:v>
                </c:pt>
                <c:pt idx="738">
                  <c:v>3.0033333333333332E-2</c:v>
                </c:pt>
                <c:pt idx="739">
                  <c:v>3.0050000000000004E-2</c:v>
                </c:pt>
                <c:pt idx="740">
                  <c:v>3.0116666666666667E-2</c:v>
                </c:pt>
                <c:pt idx="741">
                  <c:v>3.0133333333333331E-2</c:v>
                </c:pt>
                <c:pt idx="742">
                  <c:v>3.0183333333333329E-2</c:v>
                </c:pt>
                <c:pt idx="743">
                  <c:v>3.0166666666666665E-2</c:v>
                </c:pt>
                <c:pt idx="744">
                  <c:v>3.0266666666666667E-2</c:v>
                </c:pt>
                <c:pt idx="745">
                  <c:v>3.036666666666667E-2</c:v>
                </c:pt>
                <c:pt idx="746">
                  <c:v>3.046666666666667E-2</c:v>
                </c:pt>
                <c:pt idx="747">
                  <c:v>3.0633333333333332E-2</c:v>
                </c:pt>
                <c:pt idx="748">
                  <c:v>3.0649999999999997E-2</c:v>
                </c:pt>
                <c:pt idx="749">
                  <c:v>3.0633333333333332E-2</c:v>
                </c:pt>
                <c:pt idx="750">
                  <c:v>3.075E-2</c:v>
                </c:pt>
                <c:pt idx="751">
                  <c:v>3.0700000000000002E-2</c:v>
                </c:pt>
                <c:pt idx="752">
                  <c:v>3.0816666666666669E-2</c:v>
                </c:pt>
                <c:pt idx="753">
                  <c:v>3.0916666666666672E-2</c:v>
                </c:pt>
                <c:pt idx="754">
                  <c:v>3.0850000000000002E-2</c:v>
                </c:pt>
                <c:pt idx="755">
                  <c:v>3.1016666666666665E-2</c:v>
                </c:pt>
                <c:pt idx="756">
                  <c:v>3.0983333333333331E-2</c:v>
                </c:pt>
                <c:pt idx="757">
                  <c:v>3.0983333333333335E-2</c:v>
                </c:pt>
                <c:pt idx="758">
                  <c:v>3.106666666666667E-2</c:v>
                </c:pt>
                <c:pt idx="759">
                  <c:v>3.093333333333334E-2</c:v>
                </c:pt>
                <c:pt idx="760">
                  <c:v>3.096666666666667E-2</c:v>
                </c:pt>
                <c:pt idx="761">
                  <c:v>3.093333333333333E-2</c:v>
                </c:pt>
                <c:pt idx="762">
                  <c:v>3.1116666666666667E-2</c:v>
                </c:pt>
                <c:pt idx="763">
                  <c:v>3.128333333333333E-2</c:v>
                </c:pt>
                <c:pt idx="764">
                  <c:v>3.1350000000000003E-2</c:v>
                </c:pt>
                <c:pt idx="765">
                  <c:v>3.1466666666666671E-2</c:v>
                </c:pt>
                <c:pt idx="766">
                  <c:v>3.1433333333333334E-2</c:v>
                </c:pt>
                <c:pt idx="767">
                  <c:v>3.1383333333333333E-2</c:v>
                </c:pt>
                <c:pt idx="768">
                  <c:v>3.1399999999999997E-2</c:v>
                </c:pt>
                <c:pt idx="769">
                  <c:v>3.1333333333333338E-2</c:v>
                </c:pt>
                <c:pt idx="770">
                  <c:v>3.1333333333333331E-2</c:v>
                </c:pt>
                <c:pt idx="771">
                  <c:v>3.1400000000000004E-2</c:v>
                </c:pt>
                <c:pt idx="772">
                  <c:v>3.1466666666666664E-2</c:v>
                </c:pt>
                <c:pt idx="773">
                  <c:v>3.1550000000000002E-2</c:v>
                </c:pt>
                <c:pt idx="774">
                  <c:v>3.1533333333333337E-2</c:v>
                </c:pt>
                <c:pt idx="775">
                  <c:v>3.1533333333333337E-2</c:v>
                </c:pt>
                <c:pt idx="776">
                  <c:v>3.1516666666666672E-2</c:v>
                </c:pt>
                <c:pt idx="777">
                  <c:v>3.1449999999999999E-2</c:v>
                </c:pt>
                <c:pt idx="778">
                  <c:v>3.1500000000000007E-2</c:v>
                </c:pt>
                <c:pt idx="779">
                  <c:v>3.1550000000000002E-2</c:v>
                </c:pt>
                <c:pt idx="780">
                  <c:v>3.1566666666666666E-2</c:v>
                </c:pt>
                <c:pt idx="781">
                  <c:v>3.1783333333333337E-2</c:v>
                </c:pt>
                <c:pt idx="782">
                  <c:v>3.1800000000000002E-2</c:v>
                </c:pt>
                <c:pt idx="783">
                  <c:v>3.1849999999999996E-2</c:v>
                </c:pt>
                <c:pt idx="784">
                  <c:v>3.1733333333333329E-2</c:v>
                </c:pt>
                <c:pt idx="785">
                  <c:v>3.1733333333333336E-2</c:v>
                </c:pt>
                <c:pt idx="786">
                  <c:v>3.175E-2</c:v>
                </c:pt>
                <c:pt idx="787">
                  <c:v>3.1849999999999996E-2</c:v>
                </c:pt>
                <c:pt idx="788">
                  <c:v>3.1933333333333334E-2</c:v>
                </c:pt>
                <c:pt idx="789">
                  <c:v>3.1949999999999999E-2</c:v>
                </c:pt>
                <c:pt idx="790">
                  <c:v>3.1833333333333332E-2</c:v>
                </c:pt>
                <c:pt idx="791">
                  <c:v>3.1766666666666665E-2</c:v>
                </c:pt>
                <c:pt idx="792">
                  <c:v>3.1900000000000005E-2</c:v>
                </c:pt>
                <c:pt idx="793">
                  <c:v>3.1883333333333333E-2</c:v>
                </c:pt>
                <c:pt idx="794">
                  <c:v>3.1933333333333334E-2</c:v>
                </c:pt>
                <c:pt idx="795">
                  <c:v>3.2016666666666665E-2</c:v>
                </c:pt>
                <c:pt idx="796">
                  <c:v>3.188333333333334E-2</c:v>
                </c:pt>
                <c:pt idx="797">
                  <c:v>3.1833333333333332E-2</c:v>
                </c:pt>
                <c:pt idx="798">
                  <c:v>3.1966666666666671E-2</c:v>
                </c:pt>
                <c:pt idx="799">
                  <c:v>3.2050000000000002E-2</c:v>
                </c:pt>
                <c:pt idx="800">
                  <c:v>3.2133333333333333E-2</c:v>
                </c:pt>
                <c:pt idx="801">
                  <c:v>3.2050000000000002E-2</c:v>
                </c:pt>
                <c:pt idx="802">
                  <c:v>3.1933333333333341E-2</c:v>
                </c:pt>
                <c:pt idx="803">
                  <c:v>3.1933333333333334E-2</c:v>
                </c:pt>
                <c:pt idx="804">
                  <c:v>3.2016666666666665E-2</c:v>
                </c:pt>
                <c:pt idx="805">
                  <c:v>3.2183333333333335E-2</c:v>
                </c:pt>
                <c:pt idx="806">
                  <c:v>3.2233333333333329E-2</c:v>
                </c:pt>
                <c:pt idx="807">
                  <c:v>3.2133333333333333E-2</c:v>
                </c:pt>
                <c:pt idx="808">
                  <c:v>3.2066666666666667E-2</c:v>
                </c:pt>
                <c:pt idx="809">
                  <c:v>3.2050000000000002E-2</c:v>
                </c:pt>
                <c:pt idx="810">
                  <c:v>3.2216666666666664E-2</c:v>
                </c:pt>
                <c:pt idx="811">
                  <c:v>3.245E-2</c:v>
                </c:pt>
                <c:pt idx="812">
                  <c:v>3.241666666666667E-2</c:v>
                </c:pt>
                <c:pt idx="813">
                  <c:v>3.2600000000000004E-2</c:v>
                </c:pt>
                <c:pt idx="814">
                  <c:v>3.2666666666666663E-2</c:v>
                </c:pt>
                <c:pt idx="815">
                  <c:v>3.2483333333333336E-2</c:v>
                </c:pt>
                <c:pt idx="816">
                  <c:v>3.27E-2</c:v>
                </c:pt>
                <c:pt idx="817">
                  <c:v>3.2500000000000001E-2</c:v>
                </c:pt>
                <c:pt idx="818">
                  <c:v>3.2516666666666673E-2</c:v>
                </c:pt>
                <c:pt idx="819">
                  <c:v>3.2566666666666667E-2</c:v>
                </c:pt>
                <c:pt idx="820">
                  <c:v>3.2400000000000005E-2</c:v>
                </c:pt>
                <c:pt idx="821">
                  <c:v>3.2583333333333332E-2</c:v>
                </c:pt>
                <c:pt idx="822">
                  <c:v>3.238333333333334E-2</c:v>
                </c:pt>
                <c:pt idx="823">
                  <c:v>3.2650000000000005E-2</c:v>
                </c:pt>
                <c:pt idx="824">
                  <c:v>3.2599999999999997E-2</c:v>
                </c:pt>
                <c:pt idx="825">
                  <c:v>3.2650000000000005E-2</c:v>
                </c:pt>
                <c:pt idx="826">
                  <c:v>3.2633333333333327E-2</c:v>
                </c:pt>
                <c:pt idx="827">
                  <c:v>3.2550000000000003E-2</c:v>
                </c:pt>
                <c:pt idx="828">
                  <c:v>3.2483333333333329E-2</c:v>
                </c:pt>
                <c:pt idx="829">
                  <c:v>3.245E-2</c:v>
                </c:pt>
                <c:pt idx="830">
                  <c:v>3.2500000000000001E-2</c:v>
                </c:pt>
                <c:pt idx="831">
                  <c:v>3.2599999999999997E-2</c:v>
                </c:pt>
                <c:pt idx="832">
                  <c:v>3.2883333333333327E-2</c:v>
                </c:pt>
                <c:pt idx="833">
                  <c:v>3.2866666666666662E-2</c:v>
                </c:pt>
                <c:pt idx="834">
                  <c:v>3.3066666666666668E-2</c:v>
                </c:pt>
                <c:pt idx="835">
                  <c:v>3.3033333333333338E-2</c:v>
                </c:pt>
                <c:pt idx="836">
                  <c:v>3.2933333333333335E-2</c:v>
                </c:pt>
                <c:pt idx="837">
                  <c:v>3.2933333333333335E-2</c:v>
                </c:pt>
                <c:pt idx="838">
                  <c:v>3.2783333333333331E-2</c:v>
                </c:pt>
                <c:pt idx="839">
                  <c:v>3.266666666666667E-2</c:v>
                </c:pt>
                <c:pt idx="840">
                  <c:v>3.2599999999999997E-2</c:v>
                </c:pt>
                <c:pt idx="841">
                  <c:v>3.27E-2</c:v>
                </c:pt>
                <c:pt idx="842">
                  <c:v>3.2800000000000003E-2</c:v>
                </c:pt>
                <c:pt idx="843">
                  <c:v>3.2850000000000004E-2</c:v>
                </c:pt>
                <c:pt idx="844">
                  <c:v>3.2899999999999999E-2</c:v>
                </c:pt>
                <c:pt idx="845">
                  <c:v>3.2783333333333331E-2</c:v>
                </c:pt>
                <c:pt idx="846">
                  <c:v>3.2766666666666666E-2</c:v>
                </c:pt>
                <c:pt idx="847">
                  <c:v>3.2999999999999995E-2</c:v>
                </c:pt>
                <c:pt idx="848">
                  <c:v>3.3116666666666662E-2</c:v>
                </c:pt>
                <c:pt idx="849">
                  <c:v>3.3433333333333336E-2</c:v>
                </c:pt>
                <c:pt idx="850">
                  <c:v>3.3366666666666663E-2</c:v>
                </c:pt>
                <c:pt idx="851">
                  <c:v>3.3416666666666671E-2</c:v>
                </c:pt>
                <c:pt idx="852">
                  <c:v>3.3583333333333333E-2</c:v>
                </c:pt>
                <c:pt idx="853">
                  <c:v>3.3466666666666665E-2</c:v>
                </c:pt>
                <c:pt idx="854">
                  <c:v>3.3466666666666665E-2</c:v>
                </c:pt>
                <c:pt idx="855">
                  <c:v>3.3466666666666665E-2</c:v>
                </c:pt>
                <c:pt idx="856">
                  <c:v>3.3283333333333338E-2</c:v>
                </c:pt>
                <c:pt idx="857">
                  <c:v>3.3183333333333336E-2</c:v>
                </c:pt>
                <c:pt idx="858">
                  <c:v>3.3349999999999998E-2</c:v>
                </c:pt>
                <c:pt idx="859">
                  <c:v>3.348333333333333E-2</c:v>
                </c:pt>
                <c:pt idx="860">
                  <c:v>3.3566666666666668E-2</c:v>
                </c:pt>
                <c:pt idx="861">
                  <c:v>3.3633333333333335E-2</c:v>
                </c:pt>
                <c:pt idx="862">
                  <c:v>3.4000000000000002E-2</c:v>
                </c:pt>
                <c:pt idx="863">
                  <c:v>3.3966666666666666E-2</c:v>
                </c:pt>
                <c:pt idx="864">
                  <c:v>3.3933333333333336E-2</c:v>
                </c:pt>
                <c:pt idx="865">
                  <c:v>3.4049999999999997E-2</c:v>
                </c:pt>
                <c:pt idx="866">
                  <c:v>3.373333333333333E-2</c:v>
                </c:pt>
                <c:pt idx="867">
                  <c:v>3.3966666666666666E-2</c:v>
                </c:pt>
                <c:pt idx="868">
                  <c:v>3.3950000000000001E-2</c:v>
                </c:pt>
                <c:pt idx="869">
                  <c:v>3.3833333333333333E-2</c:v>
                </c:pt>
                <c:pt idx="870">
                  <c:v>3.3783333333333339E-2</c:v>
                </c:pt>
                <c:pt idx="871">
                  <c:v>3.3450000000000001E-2</c:v>
                </c:pt>
                <c:pt idx="872">
                  <c:v>3.3633333333333335E-2</c:v>
                </c:pt>
                <c:pt idx="873">
                  <c:v>3.3583333333333333E-2</c:v>
                </c:pt>
                <c:pt idx="874">
                  <c:v>3.3649999999999999E-2</c:v>
                </c:pt>
                <c:pt idx="875">
                  <c:v>3.4083333333333334E-2</c:v>
                </c:pt>
                <c:pt idx="876">
                  <c:v>3.4016666666666674E-2</c:v>
                </c:pt>
                <c:pt idx="877">
                  <c:v>3.415E-2</c:v>
                </c:pt>
                <c:pt idx="878">
                  <c:v>3.4183333333333336E-2</c:v>
                </c:pt>
                <c:pt idx="879">
                  <c:v>3.3966666666666666E-2</c:v>
                </c:pt>
                <c:pt idx="880">
                  <c:v>3.4000000000000002E-2</c:v>
                </c:pt>
                <c:pt idx="881">
                  <c:v>3.3950000000000001E-2</c:v>
                </c:pt>
                <c:pt idx="882">
                  <c:v>3.3883333333333328E-2</c:v>
                </c:pt>
                <c:pt idx="883">
                  <c:v>3.3916666666666671E-2</c:v>
                </c:pt>
                <c:pt idx="884">
                  <c:v>3.4183333333333336E-2</c:v>
                </c:pt>
                <c:pt idx="885">
                  <c:v>3.4483333333333331E-2</c:v>
                </c:pt>
                <c:pt idx="886">
                  <c:v>3.4599999999999999E-2</c:v>
                </c:pt>
                <c:pt idx="887">
                  <c:v>3.4533333333333333E-2</c:v>
                </c:pt>
                <c:pt idx="888">
                  <c:v>3.44E-2</c:v>
                </c:pt>
                <c:pt idx="889">
                  <c:v>3.4466666666666666E-2</c:v>
                </c:pt>
                <c:pt idx="890">
                  <c:v>3.4666666666666665E-2</c:v>
                </c:pt>
                <c:pt idx="891">
                  <c:v>3.4866666666666664E-2</c:v>
                </c:pt>
                <c:pt idx="892">
                  <c:v>3.4916666666666665E-2</c:v>
                </c:pt>
                <c:pt idx="893">
                  <c:v>3.4583333333333334E-2</c:v>
                </c:pt>
                <c:pt idx="894">
                  <c:v>3.4566666666666669E-2</c:v>
                </c:pt>
                <c:pt idx="895">
                  <c:v>3.4933333333333337E-2</c:v>
                </c:pt>
                <c:pt idx="896">
                  <c:v>3.5133333333333329E-2</c:v>
                </c:pt>
                <c:pt idx="897">
                  <c:v>3.5466666666666667E-2</c:v>
                </c:pt>
                <c:pt idx="898">
                  <c:v>3.5633333333333336E-2</c:v>
                </c:pt>
                <c:pt idx="899">
                  <c:v>3.5450000000000002E-2</c:v>
                </c:pt>
                <c:pt idx="900">
                  <c:v>3.5249999999999997E-2</c:v>
                </c:pt>
                <c:pt idx="901">
                  <c:v>3.5416666666666666E-2</c:v>
                </c:pt>
                <c:pt idx="902">
                  <c:v>3.5366666666666671E-2</c:v>
                </c:pt>
                <c:pt idx="903">
                  <c:v>3.5466666666666667E-2</c:v>
                </c:pt>
                <c:pt idx="904">
                  <c:v>3.5616666666666671E-2</c:v>
                </c:pt>
                <c:pt idx="905">
                  <c:v>3.556666666666667E-2</c:v>
                </c:pt>
                <c:pt idx="906">
                  <c:v>3.5683333333333331E-2</c:v>
                </c:pt>
                <c:pt idx="907">
                  <c:v>3.5549999999999998E-2</c:v>
                </c:pt>
                <c:pt idx="908">
                  <c:v>3.5550000000000005E-2</c:v>
                </c:pt>
                <c:pt idx="909">
                  <c:v>3.5466666666666667E-2</c:v>
                </c:pt>
                <c:pt idx="910">
                  <c:v>3.5366666666666664E-2</c:v>
                </c:pt>
                <c:pt idx="911">
                  <c:v>3.5549999999999998E-2</c:v>
                </c:pt>
                <c:pt idx="912">
                  <c:v>3.5683333333333331E-2</c:v>
                </c:pt>
                <c:pt idx="913">
                  <c:v>3.613333333333333E-2</c:v>
                </c:pt>
                <c:pt idx="914">
                  <c:v>3.6416666666666667E-2</c:v>
                </c:pt>
                <c:pt idx="915">
                  <c:v>3.6933333333333339E-2</c:v>
                </c:pt>
                <c:pt idx="916">
                  <c:v>3.7166666666666667E-2</c:v>
                </c:pt>
                <c:pt idx="917">
                  <c:v>3.7216666666666669E-2</c:v>
                </c:pt>
                <c:pt idx="918">
                  <c:v>3.7516666666666663E-2</c:v>
                </c:pt>
                <c:pt idx="919">
                  <c:v>3.7249999999999998E-2</c:v>
                </c:pt>
                <c:pt idx="920">
                  <c:v>3.7483333333333334E-2</c:v>
                </c:pt>
                <c:pt idx="921">
                  <c:v>3.716666666666666E-2</c:v>
                </c:pt>
                <c:pt idx="922">
                  <c:v>3.7116666666666666E-2</c:v>
                </c:pt>
                <c:pt idx="923">
                  <c:v>3.7533333333333328E-2</c:v>
                </c:pt>
                <c:pt idx="924">
                  <c:v>3.7483333333333334E-2</c:v>
                </c:pt>
                <c:pt idx="925">
                  <c:v>3.7983333333333334E-2</c:v>
                </c:pt>
                <c:pt idx="926">
                  <c:v>3.8183333333333326E-2</c:v>
                </c:pt>
                <c:pt idx="927">
                  <c:v>3.9399999999999998E-2</c:v>
                </c:pt>
                <c:pt idx="928">
                  <c:v>4.0350000000000004E-2</c:v>
                </c:pt>
                <c:pt idx="929">
                  <c:v>4.1300000000000003E-2</c:v>
                </c:pt>
                <c:pt idx="930">
                  <c:v>4.2783333333333333E-2</c:v>
                </c:pt>
                <c:pt idx="931">
                  <c:v>4.2549999999999998E-2</c:v>
                </c:pt>
                <c:pt idx="932">
                  <c:v>4.2500000000000003E-2</c:v>
                </c:pt>
                <c:pt idx="933">
                  <c:v>4.2800000000000005E-2</c:v>
                </c:pt>
                <c:pt idx="934">
                  <c:v>4.2533333333333333E-2</c:v>
                </c:pt>
                <c:pt idx="935">
                  <c:v>4.2833333333333334E-2</c:v>
                </c:pt>
                <c:pt idx="936">
                  <c:v>4.3116666666666664E-2</c:v>
                </c:pt>
                <c:pt idx="937">
                  <c:v>4.3116666666666664E-2</c:v>
                </c:pt>
                <c:pt idx="938">
                  <c:v>4.3449999999999996E-2</c:v>
                </c:pt>
                <c:pt idx="939">
                  <c:v>4.3200000000000009E-2</c:v>
                </c:pt>
                <c:pt idx="940">
                  <c:v>4.3500000000000004E-2</c:v>
                </c:pt>
                <c:pt idx="941">
                  <c:v>4.3733333333333325E-2</c:v>
                </c:pt>
                <c:pt idx="942">
                  <c:v>4.388333333333333E-2</c:v>
                </c:pt>
                <c:pt idx="943">
                  <c:v>4.4050000000000006E-2</c:v>
                </c:pt>
                <c:pt idx="944">
                  <c:v>4.4216666666666675E-2</c:v>
                </c:pt>
                <c:pt idx="945">
                  <c:v>4.41E-2</c:v>
                </c:pt>
                <c:pt idx="946">
                  <c:v>4.3849999999999993E-2</c:v>
                </c:pt>
                <c:pt idx="947">
                  <c:v>4.4449999999999996E-2</c:v>
                </c:pt>
                <c:pt idx="948">
                  <c:v>4.4266666666666669E-2</c:v>
                </c:pt>
                <c:pt idx="949">
                  <c:v>4.4399999999999995E-2</c:v>
                </c:pt>
                <c:pt idx="950">
                  <c:v>4.4733333333333326E-2</c:v>
                </c:pt>
                <c:pt idx="951">
                  <c:v>4.2950000000000009E-2</c:v>
                </c:pt>
                <c:pt idx="952">
                  <c:v>4.2283333333333332E-2</c:v>
                </c:pt>
                <c:pt idx="953">
                  <c:v>4.1199999999999994E-2</c:v>
                </c:pt>
                <c:pt idx="954">
                  <c:v>4.0083333333333339E-2</c:v>
                </c:pt>
                <c:pt idx="955">
                  <c:v>3.9816666666666667E-2</c:v>
                </c:pt>
                <c:pt idx="956">
                  <c:v>4.0149999999999998E-2</c:v>
                </c:pt>
                <c:pt idx="957">
                  <c:v>3.9899999999999998E-2</c:v>
                </c:pt>
                <c:pt idx="958">
                  <c:v>4.003333333333333E-2</c:v>
                </c:pt>
                <c:pt idx="959">
                  <c:v>4.0833333333333333E-2</c:v>
                </c:pt>
                <c:pt idx="960">
                  <c:v>3.9700000000000006E-2</c:v>
                </c:pt>
                <c:pt idx="961">
                  <c:v>3.9966666666666671E-2</c:v>
                </c:pt>
                <c:pt idx="962">
                  <c:v>3.9350000000000003E-2</c:v>
                </c:pt>
                <c:pt idx="963">
                  <c:v>3.9750000000000001E-2</c:v>
                </c:pt>
                <c:pt idx="964">
                  <c:v>4.0550000000000003E-2</c:v>
                </c:pt>
                <c:pt idx="965">
                  <c:v>4.045E-2</c:v>
                </c:pt>
                <c:pt idx="966">
                  <c:v>4.1383333333333334E-2</c:v>
                </c:pt>
                <c:pt idx="967">
                  <c:v>4.1316666666666668E-2</c:v>
                </c:pt>
                <c:pt idx="968">
                  <c:v>4.1683333333333329E-2</c:v>
                </c:pt>
                <c:pt idx="969">
                  <c:v>4.1966666666666673E-2</c:v>
                </c:pt>
                <c:pt idx="970">
                  <c:v>4.2033333333333339E-2</c:v>
                </c:pt>
                <c:pt idx="971">
                  <c:v>4.1599999999999998E-2</c:v>
                </c:pt>
                <c:pt idx="972">
                  <c:v>4.1183333333333329E-2</c:v>
                </c:pt>
                <c:pt idx="973">
                  <c:v>4.1433333333333329E-2</c:v>
                </c:pt>
                <c:pt idx="974">
                  <c:v>4.1516666666666667E-2</c:v>
                </c:pt>
                <c:pt idx="975">
                  <c:v>4.2049999999999997E-2</c:v>
                </c:pt>
                <c:pt idx="976">
                  <c:v>4.218333333333333E-2</c:v>
                </c:pt>
                <c:pt idx="977">
                  <c:v>4.2633333333333336E-2</c:v>
                </c:pt>
                <c:pt idx="978">
                  <c:v>4.2733333333333338E-2</c:v>
                </c:pt>
                <c:pt idx="979">
                  <c:v>4.2949999999999988E-2</c:v>
                </c:pt>
                <c:pt idx="980">
                  <c:v>4.3483333333333325E-2</c:v>
                </c:pt>
                <c:pt idx="981">
                  <c:v>4.3116666666666664E-2</c:v>
                </c:pt>
                <c:pt idx="982">
                  <c:v>4.3000000000000003E-2</c:v>
                </c:pt>
                <c:pt idx="983">
                  <c:v>4.2299999999999997E-2</c:v>
                </c:pt>
                <c:pt idx="984">
                  <c:v>4.2383333333333335E-2</c:v>
                </c:pt>
                <c:pt idx="985">
                  <c:v>4.2383333333333335E-2</c:v>
                </c:pt>
                <c:pt idx="986">
                  <c:v>4.2316666666666669E-2</c:v>
                </c:pt>
                <c:pt idx="987">
                  <c:v>4.3250000000000004E-2</c:v>
                </c:pt>
                <c:pt idx="988">
                  <c:v>4.3616666666666672E-2</c:v>
                </c:pt>
                <c:pt idx="989">
                  <c:v>4.4166666666666667E-2</c:v>
                </c:pt>
                <c:pt idx="990">
                  <c:v>4.3916666666666666E-2</c:v>
                </c:pt>
                <c:pt idx="991">
                  <c:v>4.3866666666666665E-2</c:v>
                </c:pt>
                <c:pt idx="992">
                  <c:v>4.2799999999999998E-2</c:v>
                </c:pt>
                <c:pt idx="993">
                  <c:v>4.2866666666666664E-2</c:v>
                </c:pt>
                <c:pt idx="994">
                  <c:v>4.4116666666666665E-2</c:v>
                </c:pt>
                <c:pt idx="995">
                  <c:v>4.3650000000000001E-2</c:v>
                </c:pt>
                <c:pt idx="996">
                  <c:v>4.5133333333333331E-2</c:v>
                </c:pt>
                <c:pt idx="997">
                  <c:v>4.4983333333333327E-2</c:v>
                </c:pt>
                <c:pt idx="998">
                  <c:v>4.4316666666666664E-2</c:v>
                </c:pt>
                <c:pt idx="999">
                  <c:v>4.4466666666666661E-2</c:v>
                </c:pt>
                <c:pt idx="1000">
                  <c:v>4.4066666666666664E-2</c:v>
                </c:pt>
                <c:pt idx="1001">
                  <c:v>4.4616666666666673E-2</c:v>
                </c:pt>
                <c:pt idx="1002">
                  <c:v>4.5033333333333335E-2</c:v>
                </c:pt>
                <c:pt idx="1003">
                  <c:v>4.5866666666666667E-2</c:v>
                </c:pt>
                <c:pt idx="1004">
                  <c:v>4.5666666666666668E-2</c:v>
                </c:pt>
                <c:pt idx="1005">
                  <c:v>4.5999999999999992E-2</c:v>
                </c:pt>
                <c:pt idx="1006">
                  <c:v>4.6183333333333333E-2</c:v>
                </c:pt>
                <c:pt idx="1007">
                  <c:v>4.6100000000000002E-2</c:v>
                </c:pt>
                <c:pt idx="1008">
                  <c:v>4.6366666666666667E-2</c:v>
                </c:pt>
                <c:pt idx="1009">
                  <c:v>4.6166666666666668E-2</c:v>
                </c:pt>
                <c:pt idx="1010">
                  <c:v>4.6416666666666669E-2</c:v>
                </c:pt>
                <c:pt idx="1011">
                  <c:v>4.6749999999999993E-2</c:v>
                </c:pt>
                <c:pt idx="1012">
                  <c:v>4.6616666666666667E-2</c:v>
                </c:pt>
                <c:pt idx="1013">
                  <c:v>4.6800000000000001E-2</c:v>
                </c:pt>
                <c:pt idx="1014">
                  <c:v>4.6833333333333331E-2</c:v>
                </c:pt>
                <c:pt idx="1015">
                  <c:v>4.6666666666666669E-2</c:v>
                </c:pt>
                <c:pt idx="1016">
                  <c:v>4.6766666666666672E-2</c:v>
                </c:pt>
                <c:pt idx="1017">
                  <c:v>4.7149999999999997E-2</c:v>
                </c:pt>
                <c:pt idx="1018">
                  <c:v>4.7183333333333334E-2</c:v>
                </c:pt>
                <c:pt idx="1019">
                  <c:v>4.7199999999999999E-2</c:v>
                </c:pt>
                <c:pt idx="1020">
                  <c:v>4.7883333333333333E-2</c:v>
                </c:pt>
                <c:pt idx="1021">
                  <c:v>4.8066666666666667E-2</c:v>
                </c:pt>
                <c:pt idx="1022">
                  <c:v>4.8366666666666669E-2</c:v>
                </c:pt>
                <c:pt idx="1023">
                  <c:v>4.873333333333333E-2</c:v>
                </c:pt>
                <c:pt idx="1024">
                  <c:v>4.8383333333333334E-2</c:v>
                </c:pt>
                <c:pt idx="1025">
                  <c:v>4.845E-2</c:v>
                </c:pt>
                <c:pt idx="1026">
                  <c:v>4.8566666666666668E-2</c:v>
                </c:pt>
                <c:pt idx="1027">
                  <c:v>4.8666666666666664E-2</c:v>
                </c:pt>
                <c:pt idx="1028">
                  <c:v>4.9149999999999999E-2</c:v>
                </c:pt>
                <c:pt idx="1029">
                  <c:v>4.911666666666667E-2</c:v>
                </c:pt>
                <c:pt idx="1030">
                  <c:v>4.9066666666666668E-2</c:v>
                </c:pt>
                <c:pt idx="1031">
                  <c:v>4.9800000000000004E-2</c:v>
                </c:pt>
                <c:pt idx="1032">
                  <c:v>5.1166666666666666E-2</c:v>
                </c:pt>
                <c:pt idx="1033">
                  <c:v>5.1816666666666657E-2</c:v>
                </c:pt>
                <c:pt idx="1034">
                  <c:v>5.2116666666666665E-2</c:v>
                </c:pt>
                <c:pt idx="1035">
                  <c:v>5.1816666666666671E-2</c:v>
                </c:pt>
                <c:pt idx="1036">
                  <c:v>5.1383333333333336E-2</c:v>
                </c:pt>
                <c:pt idx="1037">
                  <c:v>5.131666666666667E-2</c:v>
                </c:pt>
                <c:pt idx="1038">
                  <c:v>5.1783333333333341E-2</c:v>
                </c:pt>
                <c:pt idx="1039">
                  <c:v>5.1833333333333335E-2</c:v>
                </c:pt>
                <c:pt idx="1040">
                  <c:v>5.1199999999999996E-2</c:v>
                </c:pt>
                <c:pt idx="1041">
                  <c:v>5.1416666666666666E-2</c:v>
                </c:pt>
                <c:pt idx="1042">
                  <c:v>5.1116666666666671E-2</c:v>
                </c:pt>
                <c:pt idx="1043">
                  <c:v>5.1700000000000003E-2</c:v>
                </c:pt>
                <c:pt idx="1044">
                  <c:v>5.1733333333333333E-2</c:v>
                </c:pt>
                <c:pt idx="1045">
                  <c:v>5.1249999999999997E-2</c:v>
                </c:pt>
                <c:pt idx="1046">
                  <c:v>5.1483333333333332E-2</c:v>
                </c:pt>
                <c:pt idx="1047">
                  <c:v>5.1333333333333335E-2</c:v>
                </c:pt>
                <c:pt idx="1048">
                  <c:v>5.2149999999999995E-2</c:v>
                </c:pt>
                <c:pt idx="1049">
                  <c:v>5.2216666666666661E-2</c:v>
                </c:pt>
                <c:pt idx="1050">
                  <c:v>5.2199999999999996E-2</c:v>
                </c:pt>
                <c:pt idx="1051">
                  <c:v>5.238333333333333E-2</c:v>
                </c:pt>
                <c:pt idx="1052">
                  <c:v>5.2083333333333336E-2</c:v>
                </c:pt>
                <c:pt idx="1053">
                  <c:v>5.2966666666666662E-2</c:v>
                </c:pt>
                <c:pt idx="1054">
                  <c:v>5.3733333333333327E-2</c:v>
                </c:pt>
                <c:pt idx="1055">
                  <c:v>5.3766666666666678E-2</c:v>
                </c:pt>
                <c:pt idx="1056">
                  <c:v>5.4199999999999998E-2</c:v>
                </c:pt>
                <c:pt idx="1057">
                  <c:v>5.4283333333333329E-2</c:v>
                </c:pt>
                <c:pt idx="1058">
                  <c:v>5.4100000000000002E-2</c:v>
                </c:pt>
                <c:pt idx="1059">
                  <c:v>5.4383333333333332E-2</c:v>
                </c:pt>
                <c:pt idx="1060">
                  <c:v>5.4299999999999994E-2</c:v>
                </c:pt>
                <c:pt idx="1061">
                  <c:v>5.4400000000000004E-2</c:v>
                </c:pt>
                <c:pt idx="1062">
                  <c:v>5.528333333333333E-2</c:v>
                </c:pt>
                <c:pt idx="1063">
                  <c:v>5.6049999999999996E-2</c:v>
                </c:pt>
                <c:pt idx="1064">
                  <c:v>5.6216666666666665E-2</c:v>
                </c:pt>
                <c:pt idx="1065">
                  <c:v>5.6383333333333334E-2</c:v>
                </c:pt>
                <c:pt idx="1066">
                  <c:v>5.6149999999999999E-2</c:v>
                </c:pt>
                <c:pt idx="1067">
                  <c:v>5.6583333333333326E-2</c:v>
                </c:pt>
                <c:pt idx="1068">
                  <c:v>5.6649999999999999E-2</c:v>
                </c:pt>
                <c:pt idx="1069">
                  <c:v>5.7066666666666661E-2</c:v>
                </c:pt>
                <c:pt idx="1070">
                  <c:v>5.6966666666666665E-2</c:v>
                </c:pt>
                <c:pt idx="1071">
                  <c:v>5.67E-2</c:v>
                </c:pt>
                <c:pt idx="1072">
                  <c:v>5.7533333333333332E-2</c:v>
                </c:pt>
                <c:pt idx="1073">
                  <c:v>5.7500000000000002E-2</c:v>
                </c:pt>
                <c:pt idx="1074">
                  <c:v>5.8166666666666665E-2</c:v>
                </c:pt>
                <c:pt idx="1075">
                  <c:v>5.786666666666667E-2</c:v>
                </c:pt>
                <c:pt idx="1076">
                  <c:v>5.7666666666666672E-2</c:v>
                </c:pt>
                <c:pt idx="1077">
                  <c:v>5.8100000000000006E-2</c:v>
                </c:pt>
                <c:pt idx="1078">
                  <c:v>5.8166666666666665E-2</c:v>
                </c:pt>
                <c:pt idx="1079">
                  <c:v>5.8866666666666671E-2</c:v>
                </c:pt>
                <c:pt idx="1080">
                  <c:v>5.9033333333333333E-2</c:v>
                </c:pt>
                <c:pt idx="1081">
                  <c:v>5.9283333333333334E-2</c:v>
                </c:pt>
                <c:pt idx="1082">
                  <c:v>5.9133333333333336E-2</c:v>
                </c:pt>
                <c:pt idx="1083">
                  <c:v>5.9199999999999996E-2</c:v>
                </c:pt>
                <c:pt idx="1084">
                  <c:v>5.9766666666666662E-2</c:v>
                </c:pt>
                <c:pt idx="1085">
                  <c:v>5.9816666666666657E-2</c:v>
                </c:pt>
                <c:pt idx="1086">
                  <c:v>6.0083333333333322E-2</c:v>
                </c:pt>
                <c:pt idx="1087">
                  <c:v>6.0049999999999999E-2</c:v>
                </c:pt>
                <c:pt idx="1088">
                  <c:v>6.0466666666666669E-2</c:v>
                </c:pt>
                <c:pt idx="1089">
                  <c:v>6.0033333333333334E-2</c:v>
                </c:pt>
                <c:pt idx="1090">
                  <c:v>6.0166666666666667E-2</c:v>
                </c:pt>
                <c:pt idx="1091">
                  <c:v>6.0433333333333332E-2</c:v>
                </c:pt>
                <c:pt idx="1092">
                  <c:v>6.0366666666666673E-2</c:v>
                </c:pt>
                <c:pt idx="1093">
                  <c:v>6.0983333333333341E-2</c:v>
                </c:pt>
                <c:pt idx="1094">
                  <c:v>6.1166666666666668E-2</c:v>
                </c:pt>
                <c:pt idx="1095">
                  <c:v>6.108333333333333E-2</c:v>
                </c:pt>
                <c:pt idx="1096">
                  <c:v>6.1700000000000005E-2</c:v>
                </c:pt>
                <c:pt idx="1097">
                  <c:v>6.196666666666667E-2</c:v>
                </c:pt>
                <c:pt idx="1098">
                  <c:v>6.2500000000000014E-2</c:v>
                </c:pt>
                <c:pt idx="1099">
                  <c:v>6.3550000000000009E-2</c:v>
                </c:pt>
                <c:pt idx="1100">
                  <c:v>6.4000000000000001E-2</c:v>
                </c:pt>
                <c:pt idx="1101">
                  <c:v>6.4316666666666661E-2</c:v>
                </c:pt>
                <c:pt idx="1102">
                  <c:v>6.4416666666666664E-2</c:v>
                </c:pt>
                <c:pt idx="1103">
                  <c:v>6.433333333333334E-2</c:v>
                </c:pt>
                <c:pt idx="1104">
                  <c:v>6.3966666666666658E-2</c:v>
                </c:pt>
                <c:pt idx="1105">
                  <c:v>6.4399999999999999E-2</c:v>
                </c:pt>
                <c:pt idx="1106">
                  <c:v>6.4750000000000002E-2</c:v>
                </c:pt>
                <c:pt idx="1107">
                  <c:v>6.5533333333333346E-2</c:v>
                </c:pt>
                <c:pt idx="1108">
                  <c:v>6.5716666666666659E-2</c:v>
                </c:pt>
                <c:pt idx="1109">
                  <c:v>6.6183333333333344E-2</c:v>
                </c:pt>
                <c:pt idx="1110">
                  <c:v>6.6166666666666665E-2</c:v>
                </c:pt>
                <c:pt idx="1111">
                  <c:v>6.5833333333333341E-2</c:v>
                </c:pt>
                <c:pt idx="1112">
                  <c:v>6.6016666666666668E-2</c:v>
                </c:pt>
                <c:pt idx="1113">
                  <c:v>6.618333333333333E-2</c:v>
                </c:pt>
                <c:pt idx="1114">
                  <c:v>6.6650000000000001E-2</c:v>
                </c:pt>
                <c:pt idx="1115">
                  <c:v>6.6666666666666666E-2</c:v>
                </c:pt>
                <c:pt idx="1116">
                  <c:v>6.6983333333333325E-2</c:v>
                </c:pt>
                <c:pt idx="1117">
                  <c:v>6.7133333333333337E-2</c:v>
                </c:pt>
                <c:pt idx="1118">
                  <c:v>6.7400000000000002E-2</c:v>
                </c:pt>
                <c:pt idx="1119">
                  <c:v>6.7833333333333329E-2</c:v>
                </c:pt>
                <c:pt idx="1120">
                  <c:v>6.8249999999999991E-2</c:v>
                </c:pt>
                <c:pt idx="1121">
                  <c:v>6.8733333333333327E-2</c:v>
                </c:pt>
                <c:pt idx="1122">
                  <c:v>6.9099999999999995E-2</c:v>
                </c:pt>
                <c:pt idx="1123">
                  <c:v>6.9516666666666671E-2</c:v>
                </c:pt>
                <c:pt idx="1124">
                  <c:v>6.9749999999999993E-2</c:v>
                </c:pt>
                <c:pt idx="1125">
                  <c:v>6.9433333333333333E-2</c:v>
                </c:pt>
                <c:pt idx="1126">
                  <c:v>6.9433333333333333E-2</c:v>
                </c:pt>
                <c:pt idx="1127">
                  <c:v>6.9650000000000004E-2</c:v>
                </c:pt>
                <c:pt idx="1128">
                  <c:v>6.9550000000000001E-2</c:v>
                </c:pt>
                <c:pt idx="1129">
                  <c:v>6.9833333333333331E-2</c:v>
                </c:pt>
                <c:pt idx="1130">
                  <c:v>6.9933333333333333E-2</c:v>
                </c:pt>
                <c:pt idx="1131">
                  <c:v>7.0000000000000007E-2</c:v>
                </c:pt>
                <c:pt idx="1132">
                  <c:v>7.0783333333333351E-2</c:v>
                </c:pt>
                <c:pt idx="1133">
                  <c:v>7.1349999999999997E-2</c:v>
                </c:pt>
                <c:pt idx="1134">
                  <c:v>7.2383333333333341E-2</c:v>
                </c:pt>
                <c:pt idx="1135">
                  <c:v>7.3150000000000007E-2</c:v>
                </c:pt>
                <c:pt idx="1136">
                  <c:v>7.3566666666666669E-2</c:v>
                </c:pt>
                <c:pt idx="1137">
                  <c:v>7.3466666666666666E-2</c:v>
                </c:pt>
                <c:pt idx="1138">
                  <c:v>7.3733333333333345E-2</c:v>
                </c:pt>
                <c:pt idx="1139">
                  <c:v>7.3683333333333323E-2</c:v>
                </c:pt>
                <c:pt idx="1140">
                  <c:v>7.3266666666666661E-2</c:v>
                </c:pt>
                <c:pt idx="1141">
                  <c:v>7.3983333333333332E-2</c:v>
                </c:pt>
                <c:pt idx="1142">
                  <c:v>7.4200000000000002E-2</c:v>
                </c:pt>
                <c:pt idx="1143">
                  <c:v>7.4200000000000002E-2</c:v>
                </c:pt>
                <c:pt idx="1144">
                  <c:v>7.5316666666666671E-2</c:v>
                </c:pt>
                <c:pt idx="1145">
                  <c:v>7.5749999999999998E-2</c:v>
                </c:pt>
                <c:pt idx="1146">
                  <c:v>7.6116666666666666E-2</c:v>
                </c:pt>
                <c:pt idx="1147">
                  <c:v>7.6366666666666666E-2</c:v>
                </c:pt>
                <c:pt idx="1148">
                  <c:v>7.5999999999999998E-2</c:v>
                </c:pt>
                <c:pt idx="1149">
                  <c:v>7.6183333333333325E-2</c:v>
                </c:pt>
                <c:pt idx="1150">
                  <c:v>7.6166666666666674E-2</c:v>
                </c:pt>
                <c:pt idx="1151">
                  <c:v>7.6350000000000001E-2</c:v>
                </c:pt>
                <c:pt idx="1152">
                  <c:v>7.7149999999999996E-2</c:v>
                </c:pt>
                <c:pt idx="1153">
                  <c:v>7.7533333333333329E-2</c:v>
                </c:pt>
                <c:pt idx="1154">
                  <c:v>7.7499999999999999E-2</c:v>
                </c:pt>
                <c:pt idx="1155">
                  <c:v>7.7816666666666659E-2</c:v>
                </c:pt>
                <c:pt idx="1156">
                  <c:v>7.771666666666667E-2</c:v>
                </c:pt>
                <c:pt idx="1157">
                  <c:v>7.7666666666666676E-2</c:v>
                </c:pt>
                <c:pt idx="1158">
                  <c:v>7.8133333333333319E-2</c:v>
                </c:pt>
                <c:pt idx="1159">
                  <c:v>7.8949999999999992E-2</c:v>
                </c:pt>
                <c:pt idx="1160">
                  <c:v>7.9283333333333331E-2</c:v>
                </c:pt>
                <c:pt idx="1161">
                  <c:v>7.9533333333333345E-2</c:v>
                </c:pt>
                <c:pt idx="1162">
                  <c:v>7.9466666666666658E-2</c:v>
                </c:pt>
                <c:pt idx="1163">
                  <c:v>7.9583333333333339E-2</c:v>
                </c:pt>
                <c:pt idx="1164">
                  <c:v>8.0349999999999991E-2</c:v>
                </c:pt>
                <c:pt idx="1165">
                  <c:v>8.0516666666666667E-2</c:v>
                </c:pt>
                <c:pt idx="1166">
                  <c:v>8.1916666666666652E-2</c:v>
                </c:pt>
                <c:pt idx="1167">
                  <c:v>8.2033333333333333E-2</c:v>
                </c:pt>
                <c:pt idx="1168">
                  <c:v>8.2216666666666674E-2</c:v>
                </c:pt>
                <c:pt idx="1169">
                  <c:v>8.2400000000000015E-2</c:v>
                </c:pt>
                <c:pt idx="1170">
                  <c:v>8.1766666666666668E-2</c:v>
                </c:pt>
                <c:pt idx="1171">
                  <c:v>8.2200000000000009E-2</c:v>
                </c:pt>
                <c:pt idx="1172">
                  <c:v>8.2166666666666666E-2</c:v>
                </c:pt>
                <c:pt idx="1173">
                  <c:v>8.2866666666666658E-2</c:v>
                </c:pt>
                <c:pt idx="1174">
                  <c:v>8.3466666666666647E-2</c:v>
                </c:pt>
                <c:pt idx="1175">
                  <c:v>8.3650000000000002E-2</c:v>
                </c:pt>
                <c:pt idx="1176">
                  <c:v>8.4483333333333313E-2</c:v>
                </c:pt>
                <c:pt idx="1177">
                  <c:v>8.4766666666666657E-2</c:v>
                </c:pt>
                <c:pt idx="1178">
                  <c:v>8.4983333333333341E-2</c:v>
                </c:pt>
                <c:pt idx="1179">
                  <c:v>8.5199999999999998E-2</c:v>
                </c:pt>
                <c:pt idx="1180">
                  <c:v>8.5050000000000001E-2</c:v>
                </c:pt>
                <c:pt idx="1181">
                  <c:v>8.5249999999999992E-2</c:v>
                </c:pt>
                <c:pt idx="1182">
                  <c:v>8.5833333333333331E-2</c:v>
                </c:pt>
                <c:pt idx="1183">
                  <c:v>8.5916666666666655E-2</c:v>
                </c:pt>
                <c:pt idx="1184">
                  <c:v>8.6199999999999999E-2</c:v>
                </c:pt>
                <c:pt idx="1185">
                  <c:v>8.6533333333333337E-2</c:v>
                </c:pt>
                <c:pt idx="1186">
                  <c:v>8.643333333333332E-2</c:v>
                </c:pt>
                <c:pt idx="1187">
                  <c:v>8.6983333333333343E-2</c:v>
                </c:pt>
                <c:pt idx="1188">
                  <c:v>8.7483333333333316E-2</c:v>
                </c:pt>
                <c:pt idx="1189">
                  <c:v>8.776666666666666E-2</c:v>
                </c:pt>
                <c:pt idx="1190">
                  <c:v>8.8349999999999998E-2</c:v>
                </c:pt>
                <c:pt idx="1191">
                  <c:v>8.8416666666666657E-2</c:v>
                </c:pt>
                <c:pt idx="1192">
                  <c:v>8.8249999999999995E-2</c:v>
                </c:pt>
                <c:pt idx="1193">
                  <c:v>8.8466666666666652E-2</c:v>
                </c:pt>
                <c:pt idx="1194">
                  <c:v>8.8433333333333322E-2</c:v>
                </c:pt>
                <c:pt idx="1195">
                  <c:v>8.8550000000000004E-2</c:v>
                </c:pt>
                <c:pt idx="1196">
                  <c:v>8.9083333333333334E-2</c:v>
                </c:pt>
                <c:pt idx="1197">
                  <c:v>8.9483333333333345E-2</c:v>
                </c:pt>
                <c:pt idx="1198">
                  <c:v>9.0483333333333346E-2</c:v>
                </c:pt>
                <c:pt idx="1199">
                  <c:v>9.1583333333333336E-2</c:v>
                </c:pt>
                <c:pt idx="1200">
                  <c:v>9.1933333333333325E-2</c:v>
                </c:pt>
                <c:pt idx="1201">
                  <c:v>9.2316666666666672E-2</c:v>
                </c:pt>
                <c:pt idx="1202">
                  <c:v>9.2533333333333342E-2</c:v>
                </c:pt>
                <c:pt idx="1203">
                  <c:v>9.2133333333333345E-2</c:v>
                </c:pt>
                <c:pt idx="1204">
                  <c:v>9.321666666666667E-2</c:v>
                </c:pt>
                <c:pt idx="1205">
                  <c:v>9.3533333333333316E-2</c:v>
                </c:pt>
                <c:pt idx="1206">
                  <c:v>9.3633333333333332E-2</c:v>
                </c:pt>
                <c:pt idx="1207">
                  <c:v>9.4533333333333344E-2</c:v>
                </c:pt>
                <c:pt idx="1208">
                  <c:v>9.4066666666666673E-2</c:v>
                </c:pt>
                <c:pt idx="1209">
                  <c:v>9.4700000000000006E-2</c:v>
                </c:pt>
                <c:pt idx="1210">
                  <c:v>9.5216666666666672E-2</c:v>
                </c:pt>
                <c:pt idx="1211">
                  <c:v>9.5549999999999982E-2</c:v>
                </c:pt>
                <c:pt idx="1212">
                  <c:v>9.6100000000000005E-2</c:v>
                </c:pt>
                <c:pt idx="1213">
                  <c:v>9.6316666666666662E-2</c:v>
                </c:pt>
                <c:pt idx="1214">
                  <c:v>9.693333333333333E-2</c:v>
                </c:pt>
                <c:pt idx="1215">
                  <c:v>9.7449999999999995E-2</c:v>
                </c:pt>
                <c:pt idx="1216">
                  <c:v>9.8133333333333336E-2</c:v>
                </c:pt>
                <c:pt idx="1217">
                  <c:v>9.8866666666666658E-2</c:v>
                </c:pt>
                <c:pt idx="1218">
                  <c:v>9.9199999999999997E-2</c:v>
                </c:pt>
                <c:pt idx="1219">
                  <c:v>9.9133333333333337E-2</c:v>
                </c:pt>
                <c:pt idx="1220">
                  <c:v>9.9866666666666659E-2</c:v>
                </c:pt>
                <c:pt idx="1221">
                  <c:v>0.10025000000000001</c:v>
                </c:pt>
                <c:pt idx="1222">
                  <c:v>0.10068333333333333</c:v>
                </c:pt>
                <c:pt idx="1223">
                  <c:v>9.9366666666666659E-2</c:v>
                </c:pt>
                <c:pt idx="1224">
                  <c:v>9.7583333333333341E-2</c:v>
                </c:pt>
                <c:pt idx="1225">
                  <c:v>9.5799999999999996E-2</c:v>
                </c:pt>
                <c:pt idx="1226">
                  <c:v>9.3916666666666662E-2</c:v>
                </c:pt>
                <c:pt idx="1227">
                  <c:v>9.4550000000000009E-2</c:v>
                </c:pt>
                <c:pt idx="1228">
                  <c:v>9.4516666666666679E-2</c:v>
                </c:pt>
                <c:pt idx="1229">
                  <c:v>9.5350000000000004E-2</c:v>
                </c:pt>
                <c:pt idx="1230">
                  <c:v>9.5816666666666661E-2</c:v>
                </c:pt>
                <c:pt idx="1231">
                  <c:v>9.6066666666666647E-2</c:v>
                </c:pt>
                <c:pt idx="1232">
                  <c:v>9.6333333333333326E-2</c:v>
                </c:pt>
                <c:pt idx="1233">
                  <c:v>9.6483333333333351E-2</c:v>
                </c:pt>
                <c:pt idx="1234">
                  <c:v>9.7383333333333336E-2</c:v>
                </c:pt>
                <c:pt idx="1235">
                  <c:v>9.8000000000000018E-2</c:v>
                </c:pt>
                <c:pt idx="1236">
                  <c:v>9.9233333333333326E-2</c:v>
                </c:pt>
                <c:pt idx="1237">
                  <c:v>9.9316666666666664E-2</c:v>
                </c:pt>
                <c:pt idx="1238">
                  <c:v>9.9349999999999994E-2</c:v>
                </c:pt>
                <c:pt idx="1239">
                  <c:v>0.10003333333333335</c:v>
                </c:pt>
                <c:pt idx="1240">
                  <c:v>9.9883333333333324E-2</c:v>
                </c:pt>
                <c:pt idx="1241">
                  <c:v>0.10068333333333335</c:v>
                </c:pt>
                <c:pt idx="1242">
                  <c:v>0.10139999999999999</c:v>
                </c:pt>
                <c:pt idx="1243">
                  <c:v>0.10126666666666667</c:v>
                </c:pt>
                <c:pt idx="1244">
                  <c:v>0.10161666666666667</c:v>
                </c:pt>
                <c:pt idx="1245">
                  <c:v>0.10146666666666666</c:v>
                </c:pt>
                <c:pt idx="1246">
                  <c:v>0.10163333333333334</c:v>
                </c:pt>
                <c:pt idx="1247">
                  <c:v>0.10210000000000001</c:v>
                </c:pt>
                <c:pt idx="1248">
                  <c:v>0.10266666666666667</c:v>
                </c:pt>
                <c:pt idx="1249">
                  <c:v>0.1032</c:v>
                </c:pt>
                <c:pt idx="1250">
                  <c:v>0.10358333333333332</c:v>
                </c:pt>
                <c:pt idx="1251">
                  <c:v>0.10396666666666667</c:v>
                </c:pt>
                <c:pt idx="1252">
                  <c:v>0.10421666666666667</c:v>
                </c:pt>
                <c:pt idx="1253">
                  <c:v>0.10453333333333335</c:v>
                </c:pt>
              </c:numCache>
            </c:numRef>
          </c:yVal>
          <c:smooth val="1"/>
          <c:extLst>
            <c:ext xmlns:c16="http://schemas.microsoft.com/office/drawing/2014/chart" uri="{C3380CC4-5D6E-409C-BE32-E72D297353CC}">
              <c16:uniqueId val="{00000001-AA13-49CE-A792-B5AEE7BA5538}"/>
            </c:ext>
          </c:extLst>
        </c:ser>
        <c:ser>
          <c:idx val="3"/>
          <c:order val="2"/>
          <c:tx>
            <c:strRef>
              <c:f>Hoja1!$BW$1</c:f>
              <c:strCache>
                <c:ptCount val="1"/>
                <c:pt idx="0">
                  <c:v>4d</c:v>
                </c:pt>
              </c:strCache>
            </c:strRef>
          </c:tx>
          <c:spPr>
            <a:ln>
              <a:solidFill>
                <a:srgbClr val="F79646">
                  <a:lumMod val="75000"/>
                </a:srgbClr>
              </a:solidFill>
              <a:prstDash val="sysDash"/>
            </a:ln>
          </c:spPr>
          <c:marker>
            <c:symbol val="none"/>
          </c:marker>
          <c:xVal>
            <c:numRef>
              <c:f>Hoja1!$BS$2:$BS$1255</c:f>
              <c:numCache>
                <c:formatCode>General</c:formatCode>
                <c:ptCount val="1254"/>
                <c:pt idx="2" formatCode="h:mm">
                  <c:v>0.68125000000000002</c:v>
                </c:pt>
                <c:pt idx="3">
                  <c:v>550</c:v>
                </c:pt>
                <c:pt idx="4">
                  <c:v>549.79999999999995</c:v>
                </c:pt>
                <c:pt idx="5">
                  <c:v>549.6</c:v>
                </c:pt>
                <c:pt idx="6">
                  <c:v>549.4</c:v>
                </c:pt>
                <c:pt idx="7">
                  <c:v>549.20000000000005</c:v>
                </c:pt>
                <c:pt idx="8">
                  <c:v>549</c:v>
                </c:pt>
                <c:pt idx="9">
                  <c:v>548.79999999999995</c:v>
                </c:pt>
                <c:pt idx="10">
                  <c:v>548.6</c:v>
                </c:pt>
                <c:pt idx="11">
                  <c:v>548.4</c:v>
                </c:pt>
                <c:pt idx="12">
                  <c:v>548.20000000000005</c:v>
                </c:pt>
                <c:pt idx="13">
                  <c:v>548</c:v>
                </c:pt>
                <c:pt idx="14">
                  <c:v>547.79999999999995</c:v>
                </c:pt>
                <c:pt idx="15">
                  <c:v>547.6</c:v>
                </c:pt>
                <c:pt idx="16">
                  <c:v>547.4</c:v>
                </c:pt>
                <c:pt idx="17">
                  <c:v>547.20000000000005</c:v>
                </c:pt>
                <c:pt idx="18">
                  <c:v>547</c:v>
                </c:pt>
                <c:pt idx="19">
                  <c:v>546.79999999999995</c:v>
                </c:pt>
                <c:pt idx="20">
                  <c:v>546.6</c:v>
                </c:pt>
                <c:pt idx="21">
                  <c:v>546.4</c:v>
                </c:pt>
                <c:pt idx="22">
                  <c:v>546.20000000000005</c:v>
                </c:pt>
                <c:pt idx="23">
                  <c:v>546</c:v>
                </c:pt>
                <c:pt idx="24">
                  <c:v>545.79999999999995</c:v>
                </c:pt>
                <c:pt idx="25">
                  <c:v>545.6</c:v>
                </c:pt>
                <c:pt idx="26">
                  <c:v>545.4</c:v>
                </c:pt>
                <c:pt idx="27">
                  <c:v>545.20000000000005</c:v>
                </c:pt>
                <c:pt idx="28">
                  <c:v>545</c:v>
                </c:pt>
                <c:pt idx="29">
                  <c:v>544.79999999999995</c:v>
                </c:pt>
                <c:pt idx="30">
                  <c:v>544.6</c:v>
                </c:pt>
                <c:pt idx="31">
                  <c:v>544.4</c:v>
                </c:pt>
                <c:pt idx="32">
                  <c:v>544.20000000000005</c:v>
                </c:pt>
                <c:pt idx="33">
                  <c:v>544</c:v>
                </c:pt>
                <c:pt idx="34">
                  <c:v>543.79999999999995</c:v>
                </c:pt>
                <c:pt idx="35">
                  <c:v>543.6</c:v>
                </c:pt>
                <c:pt idx="36">
                  <c:v>543.4</c:v>
                </c:pt>
                <c:pt idx="37">
                  <c:v>543.20000000000005</c:v>
                </c:pt>
                <c:pt idx="38">
                  <c:v>543</c:v>
                </c:pt>
                <c:pt idx="39">
                  <c:v>542.79999999999995</c:v>
                </c:pt>
                <c:pt idx="40">
                  <c:v>542.6</c:v>
                </c:pt>
                <c:pt idx="41">
                  <c:v>542.4</c:v>
                </c:pt>
                <c:pt idx="42">
                  <c:v>542.20000000000005</c:v>
                </c:pt>
                <c:pt idx="43">
                  <c:v>542</c:v>
                </c:pt>
                <c:pt idx="44">
                  <c:v>541.79999999999995</c:v>
                </c:pt>
                <c:pt idx="45">
                  <c:v>541.6</c:v>
                </c:pt>
                <c:pt idx="46">
                  <c:v>541.4</c:v>
                </c:pt>
                <c:pt idx="47">
                  <c:v>541.20000000000005</c:v>
                </c:pt>
                <c:pt idx="48">
                  <c:v>541</c:v>
                </c:pt>
                <c:pt idx="49">
                  <c:v>540.79999999999995</c:v>
                </c:pt>
                <c:pt idx="50">
                  <c:v>540.6</c:v>
                </c:pt>
                <c:pt idx="51">
                  <c:v>540.4</c:v>
                </c:pt>
                <c:pt idx="52">
                  <c:v>540.20000000000005</c:v>
                </c:pt>
                <c:pt idx="53">
                  <c:v>540</c:v>
                </c:pt>
                <c:pt idx="54">
                  <c:v>539.79999999999995</c:v>
                </c:pt>
                <c:pt idx="55">
                  <c:v>539.6</c:v>
                </c:pt>
                <c:pt idx="56">
                  <c:v>539.4</c:v>
                </c:pt>
                <c:pt idx="57">
                  <c:v>539.20000000000005</c:v>
                </c:pt>
                <c:pt idx="58">
                  <c:v>539</c:v>
                </c:pt>
                <c:pt idx="59">
                  <c:v>538.79999999999995</c:v>
                </c:pt>
                <c:pt idx="60">
                  <c:v>538.6</c:v>
                </c:pt>
                <c:pt idx="61">
                  <c:v>538.4</c:v>
                </c:pt>
                <c:pt idx="62">
                  <c:v>538.20000000000005</c:v>
                </c:pt>
                <c:pt idx="63">
                  <c:v>538</c:v>
                </c:pt>
                <c:pt idx="64">
                  <c:v>537.79999999999995</c:v>
                </c:pt>
                <c:pt idx="65">
                  <c:v>537.6</c:v>
                </c:pt>
                <c:pt idx="66">
                  <c:v>537.4</c:v>
                </c:pt>
                <c:pt idx="67">
                  <c:v>537.20000000000005</c:v>
                </c:pt>
                <c:pt idx="68">
                  <c:v>537</c:v>
                </c:pt>
                <c:pt idx="69">
                  <c:v>536.79999999999995</c:v>
                </c:pt>
                <c:pt idx="70">
                  <c:v>536.6</c:v>
                </c:pt>
                <c:pt idx="71">
                  <c:v>536.4</c:v>
                </c:pt>
                <c:pt idx="72">
                  <c:v>536.20000000000005</c:v>
                </c:pt>
                <c:pt idx="73">
                  <c:v>536</c:v>
                </c:pt>
                <c:pt idx="74">
                  <c:v>535.79999999999995</c:v>
                </c:pt>
                <c:pt idx="75">
                  <c:v>535.6</c:v>
                </c:pt>
                <c:pt idx="76">
                  <c:v>535.4</c:v>
                </c:pt>
                <c:pt idx="77">
                  <c:v>535.20000000000005</c:v>
                </c:pt>
                <c:pt idx="78">
                  <c:v>535</c:v>
                </c:pt>
                <c:pt idx="79">
                  <c:v>534.79999999999995</c:v>
                </c:pt>
                <c:pt idx="80">
                  <c:v>534.6</c:v>
                </c:pt>
                <c:pt idx="81">
                  <c:v>534.4</c:v>
                </c:pt>
                <c:pt idx="82">
                  <c:v>534.20000000000005</c:v>
                </c:pt>
                <c:pt idx="83">
                  <c:v>534</c:v>
                </c:pt>
                <c:pt idx="84">
                  <c:v>533.79999999999995</c:v>
                </c:pt>
                <c:pt idx="85">
                  <c:v>533.6</c:v>
                </c:pt>
                <c:pt idx="86">
                  <c:v>533.4</c:v>
                </c:pt>
                <c:pt idx="87">
                  <c:v>533.20000000000005</c:v>
                </c:pt>
                <c:pt idx="88">
                  <c:v>533</c:v>
                </c:pt>
                <c:pt idx="89">
                  <c:v>532.79999999999995</c:v>
                </c:pt>
                <c:pt idx="90">
                  <c:v>532.6</c:v>
                </c:pt>
                <c:pt idx="91">
                  <c:v>532.4</c:v>
                </c:pt>
                <c:pt idx="92">
                  <c:v>532.20000000000005</c:v>
                </c:pt>
                <c:pt idx="93">
                  <c:v>532</c:v>
                </c:pt>
                <c:pt idx="94">
                  <c:v>531.79999999999995</c:v>
                </c:pt>
                <c:pt idx="95">
                  <c:v>531.6</c:v>
                </c:pt>
                <c:pt idx="96">
                  <c:v>531.4</c:v>
                </c:pt>
                <c:pt idx="97">
                  <c:v>531.20000000000005</c:v>
                </c:pt>
                <c:pt idx="98">
                  <c:v>531</c:v>
                </c:pt>
                <c:pt idx="99">
                  <c:v>530.79999999999995</c:v>
                </c:pt>
                <c:pt idx="100">
                  <c:v>530.6</c:v>
                </c:pt>
                <c:pt idx="101">
                  <c:v>530.4</c:v>
                </c:pt>
                <c:pt idx="102">
                  <c:v>530.20000000000005</c:v>
                </c:pt>
                <c:pt idx="103">
                  <c:v>530</c:v>
                </c:pt>
                <c:pt idx="104">
                  <c:v>529.79999999999995</c:v>
                </c:pt>
                <c:pt idx="105">
                  <c:v>529.6</c:v>
                </c:pt>
                <c:pt idx="106">
                  <c:v>529.4</c:v>
                </c:pt>
                <c:pt idx="107">
                  <c:v>529.20000000000005</c:v>
                </c:pt>
                <c:pt idx="108">
                  <c:v>529</c:v>
                </c:pt>
                <c:pt idx="109">
                  <c:v>528.79999999999995</c:v>
                </c:pt>
                <c:pt idx="110">
                  <c:v>528.6</c:v>
                </c:pt>
                <c:pt idx="111">
                  <c:v>528.4</c:v>
                </c:pt>
                <c:pt idx="112">
                  <c:v>528.20000000000005</c:v>
                </c:pt>
                <c:pt idx="113">
                  <c:v>528</c:v>
                </c:pt>
                <c:pt idx="114">
                  <c:v>527.79999999999995</c:v>
                </c:pt>
                <c:pt idx="115">
                  <c:v>527.6</c:v>
                </c:pt>
                <c:pt idx="116">
                  <c:v>527.4</c:v>
                </c:pt>
                <c:pt idx="117">
                  <c:v>527.20000000000005</c:v>
                </c:pt>
                <c:pt idx="118">
                  <c:v>527</c:v>
                </c:pt>
                <c:pt idx="119">
                  <c:v>526.79999999999995</c:v>
                </c:pt>
                <c:pt idx="120">
                  <c:v>526.6</c:v>
                </c:pt>
                <c:pt idx="121">
                  <c:v>526.4</c:v>
                </c:pt>
                <c:pt idx="122">
                  <c:v>526.20000000000005</c:v>
                </c:pt>
                <c:pt idx="123">
                  <c:v>526</c:v>
                </c:pt>
                <c:pt idx="124">
                  <c:v>525.79999999999995</c:v>
                </c:pt>
                <c:pt idx="125">
                  <c:v>525.6</c:v>
                </c:pt>
                <c:pt idx="126">
                  <c:v>525.4</c:v>
                </c:pt>
                <c:pt idx="127">
                  <c:v>525.20000000000005</c:v>
                </c:pt>
                <c:pt idx="128">
                  <c:v>525</c:v>
                </c:pt>
                <c:pt idx="129">
                  <c:v>524.79999999999995</c:v>
                </c:pt>
                <c:pt idx="130">
                  <c:v>524.6</c:v>
                </c:pt>
                <c:pt idx="131">
                  <c:v>524.4</c:v>
                </c:pt>
                <c:pt idx="132">
                  <c:v>524.20000000000005</c:v>
                </c:pt>
                <c:pt idx="133">
                  <c:v>524</c:v>
                </c:pt>
                <c:pt idx="134">
                  <c:v>523.79999999999995</c:v>
                </c:pt>
                <c:pt idx="135">
                  <c:v>523.6</c:v>
                </c:pt>
                <c:pt idx="136">
                  <c:v>523.4</c:v>
                </c:pt>
                <c:pt idx="137">
                  <c:v>523.20000000000005</c:v>
                </c:pt>
                <c:pt idx="138">
                  <c:v>523</c:v>
                </c:pt>
                <c:pt idx="139">
                  <c:v>522.79999999999995</c:v>
                </c:pt>
                <c:pt idx="140">
                  <c:v>522.6</c:v>
                </c:pt>
                <c:pt idx="141">
                  <c:v>522.4</c:v>
                </c:pt>
                <c:pt idx="142">
                  <c:v>522.20000000000005</c:v>
                </c:pt>
                <c:pt idx="143">
                  <c:v>522</c:v>
                </c:pt>
                <c:pt idx="144">
                  <c:v>521.79999999999995</c:v>
                </c:pt>
                <c:pt idx="145">
                  <c:v>521.6</c:v>
                </c:pt>
                <c:pt idx="146">
                  <c:v>521.4</c:v>
                </c:pt>
                <c:pt idx="147">
                  <c:v>521.20000000000005</c:v>
                </c:pt>
                <c:pt idx="148">
                  <c:v>521</c:v>
                </c:pt>
                <c:pt idx="149">
                  <c:v>520.79999999999995</c:v>
                </c:pt>
                <c:pt idx="150">
                  <c:v>520.6</c:v>
                </c:pt>
                <c:pt idx="151">
                  <c:v>520.4</c:v>
                </c:pt>
                <c:pt idx="152">
                  <c:v>520.20000000000005</c:v>
                </c:pt>
                <c:pt idx="153">
                  <c:v>520</c:v>
                </c:pt>
                <c:pt idx="154">
                  <c:v>519.79999999999995</c:v>
                </c:pt>
                <c:pt idx="155">
                  <c:v>519.6</c:v>
                </c:pt>
                <c:pt idx="156">
                  <c:v>519.4</c:v>
                </c:pt>
                <c:pt idx="157">
                  <c:v>519.20000000000005</c:v>
                </c:pt>
                <c:pt idx="158">
                  <c:v>519</c:v>
                </c:pt>
                <c:pt idx="159">
                  <c:v>518.79999999999995</c:v>
                </c:pt>
                <c:pt idx="160">
                  <c:v>518.6</c:v>
                </c:pt>
                <c:pt idx="161">
                  <c:v>518.4</c:v>
                </c:pt>
                <c:pt idx="162">
                  <c:v>518.20000000000005</c:v>
                </c:pt>
                <c:pt idx="163">
                  <c:v>518</c:v>
                </c:pt>
                <c:pt idx="164">
                  <c:v>517.79999999999995</c:v>
                </c:pt>
                <c:pt idx="165">
                  <c:v>517.6</c:v>
                </c:pt>
                <c:pt idx="166">
                  <c:v>517.4</c:v>
                </c:pt>
                <c:pt idx="167">
                  <c:v>517.20000000000005</c:v>
                </c:pt>
                <c:pt idx="168">
                  <c:v>517</c:v>
                </c:pt>
                <c:pt idx="169">
                  <c:v>516.79999999999995</c:v>
                </c:pt>
                <c:pt idx="170">
                  <c:v>516.6</c:v>
                </c:pt>
                <c:pt idx="171">
                  <c:v>516.4</c:v>
                </c:pt>
                <c:pt idx="172">
                  <c:v>516.20000000000005</c:v>
                </c:pt>
                <c:pt idx="173">
                  <c:v>516</c:v>
                </c:pt>
                <c:pt idx="174">
                  <c:v>515.79999999999995</c:v>
                </c:pt>
                <c:pt idx="175">
                  <c:v>515.6</c:v>
                </c:pt>
                <c:pt idx="176">
                  <c:v>515.4</c:v>
                </c:pt>
                <c:pt idx="177">
                  <c:v>515.20000000000005</c:v>
                </c:pt>
                <c:pt idx="178">
                  <c:v>515</c:v>
                </c:pt>
                <c:pt idx="179">
                  <c:v>514.79999999999995</c:v>
                </c:pt>
                <c:pt idx="180">
                  <c:v>514.6</c:v>
                </c:pt>
                <c:pt idx="181">
                  <c:v>514.4</c:v>
                </c:pt>
                <c:pt idx="182">
                  <c:v>514.20000000000005</c:v>
                </c:pt>
                <c:pt idx="183">
                  <c:v>514</c:v>
                </c:pt>
                <c:pt idx="184">
                  <c:v>513.79999999999995</c:v>
                </c:pt>
                <c:pt idx="185">
                  <c:v>513.6</c:v>
                </c:pt>
                <c:pt idx="186">
                  <c:v>513.4</c:v>
                </c:pt>
                <c:pt idx="187">
                  <c:v>513.20000000000005</c:v>
                </c:pt>
                <c:pt idx="188">
                  <c:v>513</c:v>
                </c:pt>
                <c:pt idx="189">
                  <c:v>512.79999999999995</c:v>
                </c:pt>
                <c:pt idx="190">
                  <c:v>512.6</c:v>
                </c:pt>
                <c:pt idx="191">
                  <c:v>512.4</c:v>
                </c:pt>
                <c:pt idx="192">
                  <c:v>512.20000000000005</c:v>
                </c:pt>
                <c:pt idx="193">
                  <c:v>512</c:v>
                </c:pt>
                <c:pt idx="194">
                  <c:v>511.8</c:v>
                </c:pt>
                <c:pt idx="195">
                  <c:v>511.6</c:v>
                </c:pt>
                <c:pt idx="196">
                  <c:v>511.4</c:v>
                </c:pt>
                <c:pt idx="197">
                  <c:v>511.2</c:v>
                </c:pt>
                <c:pt idx="198">
                  <c:v>511</c:v>
                </c:pt>
                <c:pt idx="199">
                  <c:v>510.8</c:v>
                </c:pt>
                <c:pt idx="200">
                  <c:v>510.6</c:v>
                </c:pt>
                <c:pt idx="201">
                  <c:v>510.4</c:v>
                </c:pt>
                <c:pt idx="202">
                  <c:v>510.2</c:v>
                </c:pt>
                <c:pt idx="203">
                  <c:v>510</c:v>
                </c:pt>
                <c:pt idx="204">
                  <c:v>509.8</c:v>
                </c:pt>
                <c:pt idx="205">
                  <c:v>509.6</c:v>
                </c:pt>
                <c:pt idx="206">
                  <c:v>509.4</c:v>
                </c:pt>
                <c:pt idx="207">
                  <c:v>509.2</c:v>
                </c:pt>
                <c:pt idx="208">
                  <c:v>509</c:v>
                </c:pt>
                <c:pt idx="209">
                  <c:v>508.8</c:v>
                </c:pt>
                <c:pt idx="210">
                  <c:v>508.6</c:v>
                </c:pt>
                <c:pt idx="211">
                  <c:v>508.4</c:v>
                </c:pt>
                <c:pt idx="212">
                  <c:v>508.2</c:v>
                </c:pt>
                <c:pt idx="213">
                  <c:v>508</c:v>
                </c:pt>
                <c:pt idx="214">
                  <c:v>507.8</c:v>
                </c:pt>
                <c:pt idx="215">
                  <c:v>507.6</c:v>
                </c:pt>
                <c:pt idx="216">
                  <c:v>507.4</c:v>
                </c:pt>
                <c:pt idx="217">
                  <c:v>507.2</c:v>
                </c:pt>
                <c:pt idx="218">
                  <c:v>507</c:v>
                </c:pt>
                <c:pt idx="219">
                  <c:v>506.8</c:v>
                </c:pt>
                <c:pt idx="220">
                  <c:v>506.6</c:v>
                </c:pt>
                <c:pt idx="221">
                  <c:v>506.4</c:v>
                </c:pt>
                <c:pt idx="222">
                  <c:v>506.2</c:v>
                </c:pt>
                <c:pt idx="223">
                  <c:v>506</c:v>
                </c:pt>
                <c:pt idx="224">
                  <c:v>505.8</c:v>
                </c:pt>
                <c:pt idx="225">
                  <c:v>505.6</c:v>
                </c:pt>
                <c:pt idx="226">
                  <c:v>505.4</c:v>
                </c:pt>
                <c:pt idx="227">
                  <c:v>505.2</c:v>
                </c:pt>
                <c:pt idx="228">
                  <c:v>505</c:v>
                </c:pt>
                <c:pt idx="229">
                  <c:v>504.8</c:v>
                </c:pt>
                <c:pt idx="230">
                  <c:v>504.6</c:v>
                </c:pt>
                <c:pt idx="231">
                  <c:v>504.4</c:v>
                </c:pt>
                <c:pt idx="232">
                  <c:v>504.2</c:v>
                </c:pt>
                <c:pt idx="233">
                  <c:v>504</c:v>
                </c:pt>
                <c:pt idx="234">
                  <c:v>503.8</c:v>
                </c:pt>
                <c:pt idx="235">
                  <c:v>503.6</c:v>
                </c:pt>
                <c:pt idx="236">
                  <c:v>503.4</c:v>
                </c:pt>
                <c:pt idx="237">
                  <c:v>503.2</c:v>
                </c:pt>
                <c:pt idx="238">
                  <c:v>503</c:v>
                </c:pt>
                <c:pt idx="239">
                  <c:v>502.8</c:v>
                </c:pt>
                <c:pt idx="240">
                  <c:v>502.6</c:v>
                </c:pt>
                <c:pt idx="241">
                  <c:v>502.4</c:v>
                </c:pt>
                <c:pt idx="242">
                  <c:v>502.2</c:v>
                </c:pt>
                <c:pt idx="243">
                  <c:v>502</c:v>
                </c:pt>
                <c:pt idx="244">
                  <c:v>501.8</c:v>
                </c:pt>
                <c:pt idx="245">
                  <c:v>501.6</c:v>
                </c:pt>
                <c:pt idx="246">
                  <c:v>501.4</c:v>
                </c:pt>
                <c:pt idx="247">
                  <c:v>501.2</c:v>
                </c:pt>
                <c:pt idx="248">
                  <c:v>501</c:v>
                </c:pt>
                <c:pt idx="249">
                  <c:v>500.8</c:v>
                </c:pt>
                <c:pt idx="250">
                  <c:v>500.6</c:v>
                </c:pt>
                <c:pt idx="251">
                  <c:v>500.4</c:v>
                </c:pt>
                <c:pt idx="252">
                  <c:v>500.2</c:v>
                </c:pt>
                <c:pt idx="253">
                  <c:v>500</c:v>
                </c:pt>
                <c:pt idx="254">
                  <c:v>499.8</c:v>
                </c:pt>
                <c:pt idx="255">
                  <c:v>499.6</c:v>
                </c:pt>
                <c:pt idx="256">
                  <c:v>499.4</c:v>
                </c:pt>
                <c:pt idx="257">
                  <c:v>499.2</c:v>
                </c:pt>
                <c:pt idx="258">
                  <c:v>499</c:v>
                </c:pt>
                <c:pt idx="259">
                  <c:v>498.8</c:v>
                </c:pt>
                <c:pt idx="260">
                  <c:v>498.6</c:v>
                </c:pt>
                <c:pt idx="261">
                  <c:v>498.4</c:v>
                </c:pt>
                <c:pt idx="262">
                  <c:v>498.2</c:v>
                </c:pt>
                <c:pt idx="263">
                  <c:v>498</c:v>
                </c:pt>
                <c:pt idx="264">
                  <c:v>497.8</c:v>
                </c:pt>
                <c:pt idx="265">
                  <c:v>497.6</c:v>
                </c:pt>
                <c:pt idx="266">
                  <c:v>497.4</c:v>
                </c:pt>
                <c:pt idx="267">
                  <c:v>497.2</c:v>
                </c:pt>
                <c:pt idx="268">
                  <c:v>497</c:v>
                </c:pt>
                <c:pt idx="269">
                  <c:v>496.8</c:v>
                </c:pt>
                <c:pt idx="270">
                  <c:v>496.6</c:v>
                </c:pt>
                <c:pt idx="271">
                  <c:v>496.4</c:v>
                </c:pt>
                <c:pt idx="272">
                  <c:v>496.2</c:v>
                </c:pt>
                <c:pt idx="273">
                  <c:v>496</c:v>
                </c:pt>
                <c:pt idx="274">
                  <c:v>495.8</c:v>
                </c:pt>
                <c:pt idx="275">
                  <c:v>495.6</c:v>
                </c:pt>
                <c:pt idx="276">
                  <c:v>495.4</c:v>
                </c:pt>
                <c:pt idx="277">
                  <c:v>495.2</c:v>
                </c:pt>
                <c:pt idx="278">
                  <c:v>495</c:v>
                </c:pt>
                <c:pt idx="279">
                  <c:v>494.8</c:v>
                </c:pt>
                <c:pt idx="280">
                  <c:v>494.6</c:v>
                </c:pt>
                <c:pt idx="281">
                  <c:v>494.4</c:v>
                </c:pt>
                <c:pt idx="282">
                  <c:v>494.2</c:v>
                </c:pt>
                <c:pt idx="283">
                  <c:v>494</c:v>
                </c:pt>
                <c:pt idx="284">
                  <c:v>493.8</c:v>
                </c:pt>
                <c:pt idx="285">
                  <c:v>493.6</c:v>
                </c:pt>
                <c:pt idx="286">
                  <c:v>493.4</c:v>
                </c:pt>
                <c:pt idx="287">
                  <c:v>493.2</c:v>
                </c:pt>
                <c:pt idx="288">
                  <c:v>493</c:v>
                </c:pt>
                <c:pt idx="289">
                  <c:v>492.8</c:v>
                </c:pt>
                <c:pt idx="290">
                  <c:v>492.6</c:v>
                </c:pt>
                <c:pt idx="291">
                  <c:v>492.4</c:v>
                </c:pt>
                <c:pt idx="292">
                  <c:v>492.2</c:v>
                </c:pt>
                <c:pt idx="293">
                  <c:v>492</c:v>
                </c:pt>
                <c:pt idx="294">
                  <c:v>491.8</c:v>
                </c:pt>
                <c:pt idx="295">
                  <c:v>491.6</c:v>
                </c:pt>
                <c:pt idx="296">
                  <c:v>491.4</c:v>
                </c:pt>
                <c:pt idx="297">
                  <c:v>491.2</c:v>
                </c:pt>
                <c:pt idx="298">
                  <c:v>491</c:v>
                </c:pt>
                <c:pt idx="299">
                  <c:v>490.8</c:v>
                </c:pt>
                <c:pt idx="300">
                  <c:v>490.6</c:v>
                </c:pt>
                <c:pt idx="301">
                  <c:v>490.4</c:v>
                </c:pt>
                <c:pt idx="302">
                  <c:v>490.2</c:v>
                </c:pt>
                <c:pt idx="303">
                  <c:v>490</c:v>
                </c:pt>
                <c:pt idx="304">
                  <c:v>489.8</c:v>
                </c:pt>
                <c:pt idx="305">
                  <c:v>489.6</c:v>
                </c:pt>
                <c:pt idx="306">
                  <c:v>489.4</c:v>
                </c:pt>
                <c:pt idx="307">
                  <c:v>489.2</c:v>
                </c:pt>
                <c:pt idx="308">
                  <c:v>489</c:v>
                </c:pt>
                <c:pt idx="309">
                  <c:v>488.8</c:v>
                </c:pt>
                <c:pt idx="310">
                  <c:v>488.6</c:v>
                </c:pt>
                <c:pt idx="311">
                  <c:v>488.4</c:v>
                </c:pt>
                <c:pt idx="312">
                  <c:v>488.2</c:v>
                </c:pt>
                <c:pt idx="313">
                  <c:v>488</c:v>
                </c:pt>
                <c:pt idx="314">
                  <c:v>487.8</c:v>
                </c:pt>
                <c:pt idx="315">
                  <c:v>487.6</c:v>
                </c:pt>
                <c:pt idx="316">
                  <c:v>487.4</c:v>
                </c:pt>
                <c:pt idx="317">
                  <c:v>487.2</c:v>
                </c:pt>
                <c:pt idx="318">
                  <c:v>487</c:v>
                </c:pt>
                <c:pt idx="319">
                  <c:v>486.8</c:v>
                </c:pt>
                <c:pt idx="320">
                  <c:v>486.6</c:v>
                </c:pt>
                <c:pt idx="321">
                  <c:v>486.4</c:v>
                </c:pt>
                <c:pt idx="322">
                  <c:v>486.2</c:v>
                </c:pt>
                <c:pt idx="323">
                  <c:v>486</c:v>
                </c:pt>
                <c:pt idx="324">
                  <c:v>485.8</c:v>
                </c:pt>
                <c:pt idx="325">
                  <c:v>485.6</c:v>
                </c:pt>
                <c:pt idx="326">
                  <c:v>485.4</c:v>
                </c:pt>
                <c:pt idx="327">
                  <c:v>485.2</c:v>
                </c:pt>
                <c:pt idx="328">
                  <c:v>485</c:v>
                </c:pt>
                <c:pt idx="329">
                  <c:v>484.8</c:v>
                </c:pt>
                <c:pt idx="330">
                  <c:v>484.6</c:v>
                </c:pt>
                <c:pt idx="331">
                  <c:v>484.4</c:v>
                </c:pt>
                <c:pt idx="332">
                  <c:v>484.2</c:v>
                </c:pt>
                <c:pt idx="333">
                  <c:v>484</c:v>
                </c:pt>
                <c:pt idx="334">
                  <c:v>483.8</c:v>
                </c:pt>
                <c:pt idx="335">
                  <c:v>483.6</c:v>
                </c:pt>
                <c:pt idx="336">
                  <c:v>483.4</c:v>
                </c:pt>
                <c:pt idx="337">
                  <c:v>483.2</c:v>
                </c:pt>
                <c:pt idx="338">
                  <c:v>483</c:v>
                </c:pt>
                <c:pt idx="339">
                  <c:v>482.8</c:v>
                </c:pt>
                <c:pt idx="340">
                  <c:v>482.6</c:v>
                </c:pt>
                <c:pt idx="341">
                  <c:v>482.4</c:v>
                </c:pt>
                <c:pt idx="342">
                  <c:v>482.2</c:v>
                </c:pt>
                <c:pt idx="343">
                  <c:v>482</c:v>
                </c:pt>
                <c:pt idx="344">
                  <c:v>481.8</c:v>
                </c:pt>
                <c:pt idx="345">
                  <c:v>481.6</c:v>
                </c:pt>
                <c:pt idx="346">
                  <c:v>481.4</c:v>
                </c:pt>
                <c:pt idx="347">
                  <c:v>481.2</c:v>
                </c:pt>
                <c:pt idx="348">
                  <c:v>481</c:v>
                </c:pt>
                <c:pt idx="349">
                  <c:v>480.8</c:v>
                </c:pt>
                <c:pt idx="350">
                  <c:v>480.6</c:v>
                </c:pt>
                <c:pt idx="351">
                  <c:v>480.4</c:v>
                </c:pt>
                <c:pt idx="352">
                  <c:v>480.2</c:v>
                </c:pt>
                <c:pt idx="353">
                  <c:v>480</c:v>
                </c:pt>
                <c:pt idx="354">
                  <c:v>479.8</c:v>
                </c:pt>
                <c:pt idx="355">
                  <c:v>479.6</c:v>
                </c:pt>
                <c:pt idx="356">
                  <c:v>479.4</c:v>
                </c:pt>
                <c:pt idx="357">
                  <c:v>479.2</c:v>
                </c:pt>
                <c:pt idx="358">
                  <c:v>479</c:v>
                </c:pt>
                <c:pt idx="359">
                  <c:v>478.8</c:v>
                </c:pt>
                <c:pt idx="360">
                  <c:v>478.6</c:v>
                </c:pt>
                <c:pt idx="361">
                  <c:v>478.4</c:v>
                </c:pt>
                <c:pt idx="362">
                  <c:v>478.2</c:v>
                </c:pt>
                <c:pt idx="363">
                  <c:v>478</c:v>
                </c:pt>
                <c:pt idx="364">
                  <c:v>477.8</c:v>
                </c:pt>
                <c:pt idx="365">
                  <c:v>477.6</c:v>
                </c:pt>
                <c:pt idx="366">
                  <c:v>477.4</c:v>
                </c:pt>
                <c:pt idx="367">
                  <c:v>477.2</c:v>
                </c:pt>
                <c:pt idx="368">
                  <c:v>477</c:v>
                </c:pt>
                <c:pt idx="369">
                  <c:v>476.8</c:v>
                </c:pt>
                <c:pt idx="370">
                  <c:v>476.6</c:v>
                </c:pt>
                <c:pt idx="371">
                  <c:v>476.4</c:v>
                </c:pt>
                <c:pt idx="372">
                  <c:v>476.2</c:v>
                </c:pt>
                <c:pt idx="373">
                  <c:v>476</c:v>
                </c:pt>
                <c:pt idx="374">
                  <c:v>475.8</c:v>
                </c:pt>
                <c:pt idx="375">
                  <c:v>475.6</c:v>
                </c:pt>
                <c:pt idx="376">
                  <c:v>475.4</c:v>
                </c:pt>
                <c:pt idx="377">
                  <c:v>475.2</c:v>
                </c:pt>
                <c:pt idx="378">
                  <c:v>475</c:v>
                </c:pt>
                <c:pt idx="379">
                  <c:v>474.8</c:v>
                </c:pt>
                <c:pt idx="380">
                  <c:v>474.6</c:v>
                </c:pt>
                <c:pt idx="381">
                  <c:v>474.4</c:v>
                </c:pt>
                <c:pt idx="382">
                  <c:v>474.2</c:v>
                </c:pt>
                <c:pt idx="383">
                  <c:v>474</c:v>
                </c:pt>
                <c:pt idx="384">
                  <c:v>473.8</c:v>
                </c:pt>
                <c:pt idx="385">
                  <c:v>473.6</c:v>
                </c:pt>
                <c:pt idx="386">
                  <c:v>473.4</c:v>
                </c:pt>
                <c:pt idx="387">
                  <c:v>473.2</c:v>
                </c:pt>
                <c:pt idx="388">
                  <c:v>473</c:v>
                </c:pt>
                <c:pt idx="389">
                  <c:v>472.8</c:v>
                </c:pt>
                <c:pt idx="390">
                  <c:v>472.6</c:v>
                </c:pt>
                <c:pt idx="391">
                  <c:v>472.4</c:v>
                </c:pt>
                <c:pt idx="392">
                  <c:v>472.2</c:v>
                </c:pt>
                <c:pt idx="393">
                  <c:v>472</c:v>
                </c:pt>
                <c:pt idx="394">
                  <c:v>471.8</c:v>
                </c:pt>
                <c:pt idx="395">
                  <c:v>471.6</c:v>
                </c:pt>
                <c:pt idx="396">
                  <c:v>471.4</c:v>
                </c:pt>
                <c:pt idx="397">
                  <c:v>471.2</c:v>
                </c:pt>
                <c:pt idx="398">
                  <c:v>471</c:v>
                </c:pt>
                <c:pt idx="399">
                  <c:v>470.8</c:v>
                </c:pt>
                <c:pt idx="400">
                  <c:v>470.6</c:v>
                </c:pt>
                <c:pt idx="401">
                  <c:v>470.4</c:v>
                </c:pt>
                <c:pt idx="402">
                  <c:v>470.2</c:v>
                </c:pt>
                <c:pt idx="403">
                  <c:v>470</c:v>
                </c:pt>
                <c:pt idx="404">
                  <c:v>469.8</c:v>
                </c:pt>
                <c:pt idx="405">
                  <c:v>469.6</c:v>
                </c:pt>
                <c:pt idx="406">
                  <c:v>469.4</c:v>
                </c:pt>
                <c:pt idx="407">
                  <c:v>469.2</c:v>
                </c:pt>
                <c:pt idx="408">
                  <c:v>469</c:v>
                </c:pt>
                <c:pt idx="409">
                  <c:v>468.8</c:v>
                </c:pt>
                <c:pt idx="410">
                  <c:v>468.6</c:v>
                </c:pt>
                <c:pt idx="411">
                  <c:v>468.4</c:v>
                </c:pt>
                <c:pt idx="412">
                  <c:v>468.2</c:v>
                </c:pt>
                <c:pt idx="413">
                  <c:v>468</c:v>
                </c:pt>
                <c:pt idx="414">
                  <c:v>467.8</c:v>
                </c:pt>
                <c:pt idx="415">
                  <c:v>467.6</c:v>
                </c:pt>
                <c:pt idx="416">
                  <c:v>467.4</c:v>
                </c:pt>
                <c:pt idx="417">
                  <c:v>467.2</c:v>
                </c:pt>
                <c:pt idx="418">
                  <c:v>467</c:v>
                </c:pt>
                <c:pt idx="419">
                  <c:v>466.8</c:v>
                </c:pt>
                <c:pt idx="420">
                  <c:v>466.6</c:v>
                </c:pt>
                <c:pt idx="421">
                  <c:v>466.4</c:v>
                </c:pt>
                <c:pt idx="422">
                  <c:v>466.2</c:v>
                </c:pt>
                <c:pt idx="423">
                  <c:v>466</c:v>
                </c:pt>
                <c:pt idx="424">
                  <c:v>465.8</c:v>
                </c:pt>
                <c:pt idx="425">
                  <c:v>465.6</c:v>
                </c:pt>
                <c:pt idx="426">
                  <c:v>465.4</c:v>
                </c:pt>
                <c:pt idx="427">
                  <c:v>465.2</c:v>
                </c:pt>
                <c:pt idx="428">
                  <c:v>465</c:v>
                </c:pt>
                <c:pt idx="429">
                  <c:v>464.8</c:v>
                </c:pt>
                <c:pt idx="430">
                  <c:v>464.6</c:v>
                </c:pt>
                <c:pt idx="431">
                  <c:v>464.4</c:v>
                </c:pt>
                <c:pt idx="432">
                  <c:v>464.2</c:v>
                </c:pt>
                <c:pt idx="433">
                  <c:v>464</c:v>
                </c:pt>
                <c:pt idx="434">
                  <c:v>463.8</c:v>
                </c:pt>
                <c:pt idx="435">
                  <c:v>463.6</c:v>
                </c:pt>
                <c:pt idx="436">
                  <c:v>463.4</c:v>
                </c:pt>
                <c:pt idx="437">
                  <c:v>463.2</c:v>
                </c:pt>
                <c:pt idx="438">
                  <c:v>463</c:v>
                </c:pt>
                <c:pt idx="439">
                  <c:v>462.8</c:v>
                </c:pt>
                <c:pt idx="440">
                  <c:v>462.6</c:v>
                </c:pt>
                <c:pt idx="441">
                  <c:v>462.4</c:v>
                </c:pt>
                <c:pt idx="442">
                  <c:v>462.2</c:v>
                </c:pt>
                <c:pt idx="443">
                  <c:v>462</c:v>
                </c:pt>
                <c:pt idx="444">
                  <c:v>461.8</c:v>
                </c:pt>
                <c:pt idx="445">
                  <c:v>461.6</c:v>
                </c:pt>
                <c:pt idx="446">
                  <c:v>461.4</c:v>
                </c:pt>
                <c:pt idx="447">
                  <c:v>461.2</c:v>
                </c:pt>
                <c:pt idx="448">
                  <c:v>461</c:v>
                </c:pt>
                <c:pt idx="449">
                  <c:v>460.8</c:v>
                </c:pt>
                <c:pt idx="450">
                  <c:v>460.6</c:v>
                </c:pt>
                <c:pt idx="451">
                  <c:v>460.4</c:v>
                </c:pt>
                <c:pt idx="452">
                  <c:v>460.2</c:v>
                </c:pt>
                <c:pt idx="453">
                  <c:v>460</c:v>
                </c:pt>
                <c:pt idx="454">
                  <c:v>459.8</c:v>
                </c:pt>
                <c:pt idx="455">
                  <c:v>459.6</c:v>
                </c:pt>
                <c:pt idx="456">
                  <c:v>459.4</c:v>
                </c:pt>
                <c:pt idx="457">
                  <c:v>459.2</c:v>
                </c:pt>
                <c:pt idx="458">
                  <c:v>459</c:v>
                </c:pt>
                <c:pt idx="459">
                  <c:v>458.8</c:v>
                </c:pt>
                <c:pt idx="460">
                  <c:v>458.6</c:v>
                </c:pt>
                <c:pt idx="461">
                  <c:v>458.4</c:v>
                </c:pt>
                <c:pt idx="462">
                  <c:v>458.2</c:v>
                </c:pt>
                <c:pt idx="463">
                  <c:v>458</c:v>
                </c:pt>
                <c:pt idx="464">
                  <c:v>457.8</c:v>
                </c:pt>
                <c:pt idx="465">
                  <c:v>457.6</c:v>
                </c:pt>
                <c:pt idx="466">
                  <c:v>457.4</c:v>
                </c:pt>
                <c:pt idx="467">
                  <c:v>457.2</c:v>
                </c:pt>
                <c:pt idx="468">
                  <c:v>457</c:v>
                </c:pt>
                <c:pt idx="469">
                  <c:v>456.8</c:v>
                </c:pt>
                <c:pt idx="470">
                  <c:v>456.6</c:v>
                </c:pt>
                <c:pt idx="471">
                  <c:v>456.4</c:v>
                </c:pt>
                <c:pt idx="472">
                  <c:v>456.2</c:v>
                </c:pt>
                <c:pt idx="473">
                  <c:v>456</c:v>
                </c:pt>
                <c:pt idx="474">
                  <c:v>455.8</c:v>
                </c:pt>
                <c:pt idx="475">
                  <c:v>455.6</c:v>
                </c:pt>
                <c:pt idx="476">
                  <c:v>455.4</c:v>
                </c:pt>
                <c:pt idx="477">
                  <c:v>455.2</c:v>
                </c:pt>
                <c:pt idx="478">
                  <c:v>455</c:v>
                </c:pt>
                <c:pt idx="479">
                  <c:v>454.8</c:v>
                </c:pt>
                <c:pt idx="480">
                  <c:v>454.6</c:v>
                </c:pt>
                <c:pt idx="481">
                  <c:v>454.4</c:v>
                </c:pt>
                <c:pt idx="482">
                  <c:v>454.2</c:v>
                </c:pt>
                <c:pt idx="483">
                  <c:v>454</c:v>
                </c:pt>
                <c:pt idx="484">
                  <c:v>453.8</c:v>
                </c:pt>
                <c:pt idx="485">
                  <c:v>453.6</c:v>
                </c:pt>
                <c:pt idx="486">
                  <c:v>453.4</c:v>
                </c:pt>
                <c:pt idx="487">
                  <c:v>453.2</c:v>
                </c:pt>
                <c:pt idx="488">
                  <c:v>453</c:v>
                </c:pt>
                <c:pt idx="489">
                  <c:v>452.8</c:v>
                </c:pt>
                <c:pt idx="490">
                  <c:v>452.6</c:v>
                </c:pt>
                <c:pt idx="491">
                  <c:v>452.4</c:v>
                </c:pt>
                <c:pt idx="492">
                  <c:v>452.2</c:v>
                </c:pt>
                <c:pt idx="493">
                  <c:v>452</c:v>
                </c:pt>
                <c:pt idx="494">
                  <c:v>451.8</c:v>
                </c:pt>
                <c:pt idx="495">
                  <c:v>451.6</c:v>
                </c:pt>
                <c:pt idx="496">
                  <c:v>451.4</c:v>
                </c:pt>
                <c:pt idx="497">
                  <c:v>451.2</c:v>
                </c:pt>
                <c:pt idx="498">
                  <c:v>451</c:v>
                </c:pt>
                <c:pt idx="499">
                  <c:v>450.8</c:v>
                </c:pt>
                <c:pt idx="500">
                  <c:v>450.6</c:v>
                </c:pt>
                <c:pt idx="501">
                  <c:v>450.4</c:v>
                </c:pt>
                <c:pt idx="502">
                  <c:v>450.2</c:v>
                </c:pt>
                <c:pt idx="503">
                  <c:v>450</c:v>
                </c:pt>
                <c:pt idx="504">
                  <c:v>449.8</c:v>
                </c:pt>
                <c:pt idx="505">
                  <c:v>449.6</c:v>
                </c:pt>
                <c:pt idx="506">
                  <c:v>449.4</c:v>
                </c:pt>
                <c:pt idx="507">
                  <c:v>449.2</c:v>
                </c:pt>
                <c:pt idx="508">
                  <c:v>449</c:v>
                </c:pt>
                <c:pt idx="509">
                  <c:v>448.8</c:v>
                </c:pt>
                <c:pt idx="510">
                  <c:v>448.6</c:v>
                </c:pt>
                <c:pt idx="511">
                  <c:v>448.4</c:v>
                </c:pt>
                <c:pt idx="512">
                  <c:v>448.2</c:v>
                </c:pt>
                <c:pt idx="513">
                  <c:v>448</c:v>
                </c:pt>
                <c:pt idx="514">
                  <c:v>447.8</c:v>
                </c:pt>
                <c:pt idx="515">
                  <c:v>447.6</c:v>
                </c:pt>
                <c:pt idx="516">
                  <c:v>447.4</c:v>
                </c:pt>
                <c:pt idx="517">
                  <c:v>447.2</c:v>
                </c:pt>
                <c:pt idx="518">
                  <c:v>447</c:v>
                </c:pt>
                <c:pt idx="519">
                  <c:v>446.8</c:v>
                </c:pt>
                <c:pt idx="520">
                  <c:v>446.6</c:v>
                </c:pt>
                <c:pt idx="521">
                  <c:v>446.4</c:v>
                </c:pt>
                <c:pt idx="522">
                  <c:v>446.2</c:v>
                </c:pt>
                <c:pt idx="523">
                  <c:v>446</c:v>
                </c:pt>
                <c:pt idx="524">
                  <c:v>445.8</c:v>
                </c:pt>
                <c:pt idx="525">
                  <c:v>445.6</c:v>
                </c:pt>
                <c:pt idx="526">
                  <c:v>445.4</c:v>
                </c:pt>
                <c:pt idx="527">
                  <c:v>445.2</c:v>
                </c:pt>
                <c:pt idx="528">
                  <c:v>445</c:v>
                </c:pt>
                <c:pt idx="529">
                  <c:v>444.8</c:v>
                </c:pt>
                <c:pt idx="530">
                  <c:v>444.6</c:v>
                </c:pt>
                <c:pt idx="531">
                  <c:v>444.4</c:v>
                </c:pt>
                <c:pt idx="532">
                  <c:v>444.2</c:v>
                </c:pt>
                <c:pt idx="533">
                  <c:v>444</c:v>
                </c:pt>
                <c:pt idx="534">
                  <c:v>443.8</c:v>
                </c:pt>
                <c:pt idx="535">
                  <c:v>443.6</c:v>
                </c:pt>
                <c:pt idx="536">
                  <c:v>443.4</c:v>
                </c:pt>
                <c:pt idx="537">
                  <c:v>443.2</c:v>
                </c:pt>
                <c:pt idx="538">
                  <c:v>443</c:v>
                </c:pt>
                <c:pt idx="539">
                  <c:v>442.8</c:v>
                </c:pt>
                <c:pt idx="540">
                  <c:v>442.6</c:v>
                </c:pt>
                <c:pt idx="541">
                  <c:v>442.4</c:v>
                </c:pt>
                <c:pt idx="542">
                  <c:v>442.2</c:v>
                </c:pt>
                <c:pt idx="543">
                  <c:v>442</c:v>
                </c:pt>
                <c:pt idx="544">
                  <c:v>441.8</c:v>
                </c:pt>
                <c:pt idx="545">
                  <c:v>441.6</c:v>
                </c:pt>
                <c:pt idx="546">
                  <c:v>441.4</c:v>
                </c:pt>
                <c:pt idx="547">
                  <c:v>441.2</c:v>
                </c:pt>
                <c:pt idx="548">
                  <c:v>441</c:v>
                </c:pt>
                <c:pt idx="549">
                  <c:v>440.8</c:v>
                </c:pt>
                <c:pt idx="550">
                  <c:v>440.6</c:v>
                </c:pt>
                <c:pt idx="551">
                  <c:v>440.4</c:v>
                </c:pt>
                <c:pt idx="552">
                  <c:v>440.2</c:v>
                </c:pt>
                <c:pt idx="553">
                  <c:v>440</c:v>
                </c:pt>
                <c:pt idx="554">
                  <c:v>439.8</c:v>
                </c:pt>
                <c:pt idx="555">
                  <c:v>439.6</c:v>
                </c:pt>
                <c:pt idx="556">
                  <c:v>439.4</c:v>
                </c:pt>
                <c:pt idx="557">
                  <c:v>439.2</c:v>
                </c:pt>
                <c:pt idx="558">
                  <c:v>439</c:v>
                </c:pt>
                <c:pt idx="559">
                  <c:v>438.8</c:v>
                </c:pt>
                <c:pt idx="560">
                  <c:v>438.6</c:v>
                </c:pt>
                <c:pt idx="561">
                  <c:v>438.4</c:v>
                </c:pt>
                <c:pt idx="562">
                  <c:v>438.2</c:v>
                </c:pt>
                <c:pt idx="563">
                  <c:v>438</c:v>
                </c:pt>
                <c:pt idx="564">
                  <c:v>437.8</c:v>
                </c:pt>
                <c:pt idx="565">
                  <c:v>437.6</c:v>
                </c:pt>
                <c:pt idx="566">
                  <c:v>437.4</c:v>
                </c:pt>
                <c:pt idx="567">
                  <c:v>437.2</c:v>
                </c:pt>
                <c:pt idx="568">
                  <c:v>437</c:v>
                </c:pt>
                <c:pt idx="569">
                  <c:v>436.8</c:v>
                </c:pt>
                <c:pt idx="570">
                  <c:v>436.6</c:v>
                </c:pt>
                <c:pt idx="571">
                  <c:v>436.4</c:v>
                </c:pt>
                <c:pt idx="572">
                  <c:v>436.2</c:v>
                </c:pt>
                <c:pt idx="573">
                  <c:v>436</c:v>
                </c:pt>
                <c:pt idx="574">
                  <c:v>435.8</c:v>
                </c:pt>
                <c:pt idx="575">
                  <c:v>435.6</c:v>
                </c:pt>
                <c:pt idx="576">
                  <c:v>435.4</c:v>
                </c:pt>
                <c:pt idx="577">
                  <c:v>435.2</c:v>
                </c:pt>
                <c:pt idx="578">
                  <c:v>435</c:v>
                </c:pt>
                <c:pt idx="579">
                  <c:v>434.8</c:v>
                </c:pt>
                <c:pt idx="580">
                  <c:v>434.6</c:v>
                </c:pt>
                <c:pt idx="581">
                  <c:v>434.4</c:v>
                </c:pt>
                <c:pt idx="582">
                  <c:v>434.2</c:v>
                </c:pt>
                <c:pt idx="583">
                  <c:v>434</c:v>
                </c:pt>
                <c:pt idx="584">
                  <c:v>433.8</c:v>
                </c:pt>
                <c:pt idx="585">
                  <c:v>433.6</c:v>
                </c:pt>
                <c:pt idx="586">
                  <c:v>433.4</c:v>
                </c:pt>
                <c:pt idx="587">
                  <c:v>433.2</c:v>
                </c:pt>
                <c:pt idx="588">
                  <c:v>433</c:v>
                </c:pt>
                <c:pt idx="589">
                  <c:v>432.8</c:v>
                </c:pt>
                <c:pt idx="590">
                  <c:v>432.6</c:v>
                </c:pt>
                <c:pt idx="591">
                  <c:v>432.4</c:v>
                </c:pt>
                <c:pt idx="592">
                  <c:v>432.2</c:v>
                </c:pt>
                <c:pt idx="593">
                  <c:v>432</c:v>
                </c:pt>
                <c:pt idx="594">
                  <c:v>431.8</c:v>
                </c:pt>
                <c:pt idx="595">
                  <c:v>431.6</c:v>
                </c:pt>
                <c:pt idx="596">
                  <c:v>431.4</c:v>
                </c:pt>
                <c:pt idx="597">
                  <c:v>431.2</c:v>
                </c:pt>
                <c:pt idx="598">
                  <c:v>431</c:v>
                </c:pt>
                <c:pt idx="599">
                  <c:v>430.8</c:v>
                </c:pt>
                <c:pt idx="600">
                  <c:v>430.6</c:v>
                </c:pt>
                <c:pt idx="601">
                  <c:v>430.4</c:v>
                </c:pt>
                <c:pt idx="602">
                  <c:v>430.2</c:v>
                </c:pt>
                <c:pt idx="603">
                  <c:v>430</c:v>
                </c:pt>
                <c:pt idx="604">
                  <c:v>429.8</c:v>
                </c:pt>
                <c:pt idx="605">
                  <c:v>429.6</c:v>
                </c:pt>
                <c:pt idx="606">
                  <c:v>429.4</c:v>
                </c:pt>
                <c:pt idx="607">
                  <c:v>429.2</c:v>
                </c:pt>
                <c:pt idx="608">
                  <c:v>429</c:v>
                </c:pt>
                <c:pt idx="609">
                  <c:v>428.8</c:v>
                </c:pt>
                <c:pt idx="610">
                  <c:v>428.6</c:v>
                </c:pt>
                <c:pt idx="611">
                  <c:v>428.4</c:v>
                </c:pt>
                <c:pt idx="612">
                  <c:v>428.2</c:v>
                </c:pt>
                <c:pt idx="613">
                  <c:v>428</c:v>
                </c:pt>
                <c:pt idx="614">
                  <c:v>427.8</c:v>
                </c:pt>
                <c:pt idx="615">
                  <c:v>427.6</c:v>
                </c:pt>
                <c:pt idx="616">
                  <c:v>427.4</c:v>
                </c:pt>
                <c:pt idx="617">
                  <c:v>427.2</c:v>
                </c:pt>
                <c:pt idx="618">
                  <c:v>427</c:v>
                </c:pt>
                <c:pt idx="619">
                  <c:v>426.8</c:v>
                </c:pt>
                <c:pt idx="620">
                  <c:v>426.6</c:v>
                </c:pt>
                <c:pt idx="621">
                  <c:v>426.4</c:v>
                </c:pt>
                <c:pt idx="622">
                  <c:v>426.2</c:v>
                </c:pt>
                <c:pt idx="623">
                  <c:v>426</c:v>
                </c:pt>
                <c:pt idx="624">
                  <c:v>425.8</c:v>
                </c:pt>
                <c:pt idx="625">
                  <c:v>425.6</c:v>
                </c:pt>
                <c:pt idx="626">
                  <c:v>425.4</c:v>
                </c:pt>
                <c:pt idx="627">
                  <c:v>425.2</c:v>
                </c:pt>
                <c:pt idx="628">
                  <c:v>425</c:v>
                </c:pt>
                <c:pt idx="629">
                  <c:v>424.8</c:v>
                </c:pt>
                <c:pt idx="630">
                  <c:v>424.6</c:v>
                </c:pt>
                <c:pt idx="631">
                  <c:v>424.4</c:v>
                </c:pt>
                <c:pt idx="632">
                  <c:v>424.2</c:v>
                </c:pt>
                <c:pt idx="633">
                  <c:v>424</c:v>
                </c:pt>
                <c:pt idx="634">
                  <c:v>423.8</c:v>
                </c:pt>
                <c:pt idx="635">
                  <c:v>423.6</c:v>
                </c:pt>
                <c:pt idx="636">
                  <c:v>423.4</c:v>
                </c:pt>
                <c:pt idx="637">
                  <c:v>423.2</c:v>
                </c:pt>
                <c:pt idx="638">
                  <c:v>423</c:v>
                </c:pt>
                <c:pt idx="639">
                  <c:v>422.8</c:v>
                </c:pt>
                <c:pt idx="640">
                  <c:v>422.6</c:v>
                </c:pt>
                <c:pt idx="641">
                  <c:v>422.4</c:v>
                </c:pt>
                <c:pt idx="642">
                  <c:v>422.2</c:v>
                </c:pt>
                <c:pt idx="643">
                  <c:v>422</c:v>
                </c:pt>
                <c:pt idx="644">
                  <c:v>421.8</c:v>
                </c:pt>
                <c:pt idx="645">
                  <c:v>421.6</c:v>
                </c:pt>
                <c:pt idx="646">
                  <c:v>421.4</c:v>
                </c:pt>
                <c:pt idx="647">
                  <c:v>421.2</c:v>
                </c:pt>
                <c:pt idx="648">
                  <c:v>421</c:v>
                </c:pt>
                <c:pt idx="649">
                  <c:v>420.8</c:v>
                </c:pt>
                <c:pt idx="650">
                  <c:v>420.6</c:v>
                </c:pt>
                <c:pt idx="651">
                  <c:v>420.4</c:v>
                </c:pt>
                <c:pt idx="652">
                  <c:v>420.2</c:v>
                </c:pt>
                <c:pt idx="653">
                  <c:v>420</c:v>
                </c:pt>
                <c:pt idx="654">
                  <c:v>419.8</c:v>
                </c:pt>
                <c:pt idx="655">
                  <c:v>419.6</c:v>
                </c:pt>
                <c:pt idx="656">
                  <c:v>419.4</c:v>
                </c:pt>
                <c:pt idx="657">
                  <c:v>419.2</c:v>
                </c:pt>
                <c:pt idx="658">
                  <c:v>419</c:v>
                </c:pt>
                <c:pt idx="659">
                  <c:v>418.8</c:v>
                </c:pt>
                <c:pt idx="660">
                  <c:v>418.6</c:v>
                </c:pt>
                <c:pt idx="661">
                  <c:v>418.4</c:v>
                </c:pt>
                <c:pt idx="662">
                  <c:v>418.2</c:v>
                </c:pt>
                <c:pt idx="663">
                  <c:v>418</c:v>
                </c:pt>
                <c:pt idx="664">
                  <c:v>417.8</c:v>
                </c:pt>
                <c:pt idx="665">
                  <c:v>417.6</c:v>
                </c:pt>
                <c:pt idx="666">
                  <c:v>417.4</c:v>
                </c:pt>
                <c:pt idx="667">
                  <c:v>417.2</c:v>
                </c:pt>
                <c:pt idx="668">
                  <c:v>417</c:v>
                </c:pt>
                <c:pt idx="669">
                  <c:v>416.8</c:v>
                </c:pt>
                <c:pt idx="670">
                  <c:v>416.6</c:v>
                </c:pt>
                <c:pt idx="671">
                  <c:v>416.4</c:v>
                </c:pt>
                <c:pt idx="672">
                  <c:v>416.2</c:v>
                </c:pt>
                <c:pt idx="673">
                  <c:v>416</c:v>
                </c:pt>
                <c:pt idx="674">
                  <c:v>415.8</c:v>
                </c:pt>
                <c:pt idx="675">
                  <c:v>415.6</c:v>
                </c:pt>
                <c:pt idx="676">
                  <c:v>415.4</c:v>
                </c:pt>
                <c:pt idx="677">
                  <c:v>415.2</c:v>
                </c:pt>
                <c:pt idx="678">
                  <c:v>415</c:v>
                </c:pt>
                <c:pt idx="679">
                  <c:v>414.8</c:v>
                </c:pt>
                <c:pt idx="680">
                  <c:v>414.6</c:v>
                </c:pt>
                <c:pt idx="681">
                  <c:v>414.4</c:v>
                </c:pt>
                <c:pt idx="682">
                  <c:v>414.2</c:v>
                </c:pt>
                <c:pt idx="683">
                  <c:v>414</c:v>
                </c:pt>
                <c:pt idx="684">
                  <c:v>413.8</c:v>
                </c:pt>
                <c:pt idx="685">
                  <c:v>413.6</c:v>
                </c:pt>
                <c:pt idx="686">
                  <c:v>413.4</c:v>
                </c:pt>
                <c:pt idx="687">
                  <c:v>413.2</c:v>
                </c:pt>
                <c:pt idx="688">
                  <c:v>413</c:v>
                </c:pt>
                <c:pt idx="689">
                  <c:v>412.8</c:v>
                </c:pt>
                <c:pt idx="690">
                  <c:v>412.6</c:v>
                </c:pt>
                <c:pt idx="691">
                  <c:v>412.4</c:v>
                </c:pt>
                <c:pt idx="692">
                  <c:v>412.2</c:v>
                </c:pt>
                <c:pt idx="693">
                  <c:v>412</c:v>
                </c:pt>
                <c:pt idx="694">
                  <c:v>411.8</c:v>
                </c:pt>
                <c:pt idx="695">
                  <c:v>411.6</c:v>
                </c:pt>
                <c:pt idx="696">
                  <c:v>411.4</c:v>
                </c:pt>
                <c:pt idx="697">
                  <c:v>411.2</c:v>
                </c:pt>
                <c:pt idx="698">
                  <c:v>411</c:v>
                </c:pt>
                <c:pt idx="699">
                  <c:v>410.8</c:v>
                </c:pt>
                <c:pt idx="700">
                  <c:v>410.6</c:v>
                </c:pt>
                <c:pt idx="701">
                  <c:v>410.4</c:v>
                </c:pt>
                <c:pt idx="702">
                  <c:v>410.2</c:v>
                </c:pt>
                <c:pt idx="703">
                  <c:v>410</c:v>
                </c:pt>
                <c:pt idx="704">
                  <c:v>409.8</c:v>
                </c:pt>
                <c:pt idx="705">
                  <c:v>409.6</c:v>
                </c:pt>
                <c:pt idx="706">
                  <c:v>409.4</c:v>
                </c:pt>
                <c:pt idx="707">
                  <c:v>409.2</c:v>
                </c:pt>
                <c:pt idx="708">
                  <c:v>409</c:v>
                </c:pt>
                <c:pt idx="709">
                  <c:v>408.8</c:v>
                </c:pt>
                <c:pt idx="710">
                  <c:v>408.6</c:v>
                </c:pt>
                <c:pt idx="711">
                  <c:v>408.4</c:v>
                </c:pt>
                <c:pt idx="712">
                  <c:v>408.2</c:v>
                </c:pt>
                <c:pt idx="713">
                  <c:v>408</c:v>
                </c:pt>
                <c:pt idx="714">
                  <c:v>407.8</c:v>
                </c:pt>
                <c:pt idx="715">
                  <c:v>407.6</c:v>
                </c:pt>
                <c:pt idx="716">
                  <c:v>407.4</c:v>
                </c:pt>
                <c:pt idx="717">
                  <c:v>407.2</c:v>
                </c:pt>
                <c:pt idx="718">
                  <c:v>407</c:v>
                </c:pt>
                <c:pt idx="719">
                  <c:v>406.8</c:v>
                </c:pt>
                <c:pt idx="720">
                  <c:v>406.6</c:v>
                </c:pt>
                <c:pt idx="721">
                  <c:v>406.4</c:v>
                </c:pt>
                <c:pt idx="722">
                  <c:v>406.2</c:v>
                </c:pt>
                <c:pt idx="723">
                  <c:v>406</c:v>
                </c:pt>
                <c:pt idx="724">
                  <c:v>405.8</c:v>
                </c:pt>
                <c:pt idx="725">
                  <c:v>405.6</c:v>
                </c:pt>
                <c:pt idx="726">
                  <c:v>405.4</c:v>
                </c:pt>
                <c:pt idx="727">
                  <c:v>405.2</c:v>
                </c:pt>
                <c:pt idx="728">
                  <c:v>405</c:v>
                </c:pt>
                <c:pt idx="729">
                  <c:v>404.8</c:v>
                </c:pt>
                <c:pt idx="730">
                  <c:v>404.6</c:v>
                </c:pt>
                <c:pt idx="731">
                  <c:v>404.4</c:v>
                </c:pt>
                <c:pt idx="732">
                  <c:v>404.2</c:v>
                </c:pt>
                <c:pt idx="733">
                  <c:v>404</c:v>
                </c:pt>
                <c:pt idx="734">
                  <c:v>403.8</c:v>
                </c:pt>
                <c:pt idx="735">
                  <c:v>403.6</c:v>
                </c:pt>
                <c:pt idx="736">
                  <c:v>403.4</c:v>
                </c:pt>
                <c:pt idx="737">
                  <c:v>403.2</c:v>
                </c:pt>
                <c:pt idx="738">
                  <c:v>403</c:v>
                </c:pt>
                <c:pt idx="739">
                  <c:v>402.8</c:v>
                </c:pt>
                <c:pt idx="740">
                  <c:v>402.6</c:v>
                </c:pt>
                <c:pt idx="741">
                  <c:v>402.4</c:v>
                </c:pt>
                <c:pt idx="742">
                  <c:v>402.2</c:v>
                </c:pt>
                <c:pt idx="743">
                  <c:v>402</c:v>
                </c:pt>
                <c:pt idx="744">
                  <c:v>401.8</c:v>
                </c:pt>
                <c:pt idx="745">
                  <c:v>401.6</c:v>
                </c:pt>
                <c:pt idx="746">
                  <c:v>401.4</c:v>
                </c:pt>
                <c:pt idx="747">
                  <c:v>401.2</c:v>
                </c:pt>
                <c:pt idx="748">
                  <c:v>401</c:v>
                </c:pt>
                <c:pt idx="749">
                  <c:v>400.8</c:v>
                </c:pt>
                <c:pt idx="750">
                  <c:v>400.6</c:v>
                </c:pt>
                <c:pt idx="751">
                  <c:v>400.4</c:v>
                </c:pt>
                <c:pt idx="752">
                  <c:v>400.2</c:v>
                </c:pt>
                <c:pt idx="753">
                  <c:v>400</c:v>
                </c:pt>
                <c:pt idx="754">
                  <c:v>399.8</c:v>
                </c:pt>
                <c:pt idx="755">
                  <c:v>399.6</c:v>
                </c:pt>
                <c:pt idx="756">
                  <c:v>399.4</c:v>
                </c:pt>
                <c:pt idx="757">
                  <c:v>399.2</c:v>
                </c:pt>
                <c:pt idx="758">
                  <c:v>399</c:v>
                </c:pt>
                <c:pt idx="759">
                  <c:v>398.8</c:v>
                </c:pt>
                <c:pt idx="760">
                  <c:v>398.6</c:v>
                </c:pt>
                <c:pt idx="761">
                  <c:v>398.4</c:v>
                </c:pt>
                <c:pt idx="762">
                  <c:v>398.2</c:v>
                </c:pt>
                <c:pt idx="763">
                  <c:v>398</c:v>
                </c:pt>
                <c:pt idx="764">
                  <c:v>397.8</c:v>
                </c:pt>
                <c:pt idx="765">
                  <c:v>397.6</c:v>
                </c:pt>
                <c:pt idx="766">
                  <c:v>397.4</c:v>
                </c:pt>
                <c:pt idx="767">
                  <c:v>397.2</c:v>
                </c:pt>
                <c:pt idx="768">
                  <c:v>397</c:v>
                </c:pt>
                <c:pt idx="769">
                  <c:v>396.8</c:v>
                </c:pt>
                <c:pt idx="770">
                  <c:v>396.6</c:v>
                </c:pt>
                <c:pt idx="771">
                  <c:v>396.4</c:v>
                </c:pt>
                <c:pt idx="772">
                  <c:v>396.2</c:v>
                </c:pt>
                <c:pt idx="773">
                  <c:v>396</c:v>
                </c:pt>
                <c:pt idx="774">
                  <c:v>395.8</c:v>
                </c:pt>
                <c:pt idx="775">
                  <c:v>395.6</c:v>
                </c:pt>
                <c:pt idx="776">
                  <c:v>395.4</c:v>
                </c:pt>
                <c:pt idx="777">
                  <c:v>395.2</c:v>
                </c:pt>
                <c:pt idx="778">
                  <c:v>395</c:v>
                </c:pt>
                <c:pt idx="779">
                  <c:v>394.8</c:v>
                </c:pt>
                <c:pt idx="780">
                  <c:v>394.6</c:v>
                </c:pt>
                <c:pt idx="781">
                  <c:v>394.4</c:v>
                </c:pt>
                <c:pt idx="782">
                  <c:v>394.2</c:v>
                </c:pt>
                <c:pt idx="783">
                  <c:v>394</c:v>
                </c:pt>
                <c:pt idx="784">
                  <c:v>393.8</c:v>
                </c:pt>
                <c:pt idx="785">
                  <c:v>393.6</c:v>
                </c:pt>
                <c:pt idx="786">
                  <c:v>393.4</c:v>
                </c:pt>
                <c:pt idx="787">
                  <c:v>393.2</c:v>
                </c:pt>
                <c:pt idx="788">
                  <c:v>393</c:v>
                </c:pt>
                <c:pt idx="789">
                  <c:v>392.8</c:v>
                </c:pt>
                <c:pt idx="790">
                  <c:v>392.6</c:v>
                </c:pt>
                <c:pt idx="791">
                  <c:v>392.4</c:v>
                </c:pt>
                <c:pt idx="792">
                  <c:v>392.2</c:v>
                </c:pt>
                <c:pt idx="793">
                  <c:v>392</c:v>
                </c:pt>
                <c:pt idx="794">
                  <c:v>391.8</c:v>
                </c:pt>
                <c:pt idx="795">
                  <c:v>391.6</c:v>
                </c:pt>
                <c:pt idx="796">
                  <c:v>391.4</c:v>
                </c:pt>
                <c:pt idx="797">
                  <c:v>391.2</c:v>
                </c:pt>
                <c:pt idx="798">
                  <c:v>391</c:v>
                </c:pt>
                <c:pt idx="799">
                  <c:v>390.8</c:v>
                </c:pt>
                <c:pt idx="800">
                  <c:v>390.6</c:v>
                </c:pt>
                <c:pt idx="801">
                  <c:v>390.4</c:v>
                </c:pt>
                <c:pt idx="802">
                  <c:v>390.2</c:v>
                </c:pt>
                <c:pt idx="803">
                  <c:v>390</c:v>
                </c:pt>
                <c:pt idx="804">
                  <c:v>389.8</c:v>
                </c:pt>
                <c:pt idx="805">
                  <c:v>389.6</c:v>
                </c:pt>
                <c:pt idx="806">
                  <c:v>389.4</c:v>
                </c:pt>
                <c:pt idx="807">
                  <c:v>389.2</c:v>
                </c:pt>
                <c:pt idx="808">
                  <c:v>389</c:v>
                </c:pt>
                <c:pt idx="809">
                  <c:v>388.8</c:v>
                </c:pt>
                <c:pt idx="810">
                  <c:v>388.6</c:v>
                </c:pt>
                <c:pt idx="811">
                  <c:v>388.4</c:v>
                </c:pt>
                <c:pt idx="812">
                  <c:v>388.2</c:v>
                </c:pt>
                <c:pt idx="813">
                  <c:v>388</c:v>
                </c:pt>
                <c:pt idx="814">
                  <c:v>387.8</c:v>
                </c:pt>
                <c:pt idx="815">
                  <c:v>387.6</c:v>
                </c:pt>
                <c:pt idx="816">
                  <c:v>387.4</c:v>
                </c:pt>
                <c:pt idx="817">
                  <c:v>387.2</c:v>
                </c:pt>
                <c:pt idx="818">
                  <c:v>387</c:v>
                </c:pt>
                <c:pt idx="819">
                  <c:v>386.8</c:v>
                </c:pt>
                <c:pt idx="820">
                  <c:v>386.6</c:v>
                </c:pt>
                <c:pt idx="821">
                  <c:v>386.4</c:v>
                </c:pt>
                <c:pt idx="822">
                  <c:v>386.2</c:v>
                </c:pt>
                <c:pt idx="823">
                  <c:v>386</c:v>
                </c:pt>
                <c:pt idx="824">
                  <c:v>385.8</c:v>
                </c:pt>
                <c:pt idx="825">
                  <c:v>385.6</c:v>
                </c:pt>
                <c:pt idx="826">
                  <c:v>385.4</c:v>
                </c:pt>
                <c:pt idx="827">
                  <c:v>385.2</c:v>
                </c:pt>
                <c:pt idx="828">
                  <c:v>385</c:v>
                </c:pt>
                <c:pt idx="829">
                  <c:v>384.8</c:v>
                </c:pt>
                <c:pt idx="830">
                  <c:v>384.6</c:v>
                </c:pt>
                <c:pt idx="831">
                  <c:v>384.4</c:v>
                </c:pt>
                <c:pt idx="832">
                  <c:v>384.2</c:v>
                </c:pt>
                <c:pt idx="833">
                  <c:v>384</c:v>
                </c:pt>
                <c:pt idx="834">
                  <c:v>383.8</c:v>
                </c:pt>
                <c:pt idx="835">
                  <c:v>383.6</c:v>
                </c:pt>
                <c:pt idx="836">
                  <c:v>383.4</c:v>
                </c:pt>
                <c:pt idx="837">
                  <c:v>383.2</c:v>
                </c:pt>
                <c:pt idx="838">
                  <c:v>383</c:v>
                </c:pt>
                <c:pt idx="839">
                  <c:v>382.8</c:v>
                </c:pt>
                <c:pt idx="840">
                  <c:v>382.6</c:v>
                </c:pt>
                <c:pt idx="841">
                  <c:v>382.4</c:v>
                </c:pt>
                <c:pt idx="842">
                  <c:v>382.2</c:v>
                </c:pt>
                <c:pt idx="843">
                  <c:v>382</c:v>
                </c:pt>
                <c:pt idx="844">
                  <c:v>381.8</c:v>
                </c:pt>
                <c:pt idx="845">
                  <c:v>381.6</c:v>
                </c:pt>
                <c:pt idx="846">
                  <c:v>381.4</c:v>
                </c:pt>
                <c:pt idx="847">
                  <c:v>381.2</c:v>
                </c:pt>
                <c:pt idx="848">
                  <c:v>381</c:v>
                </c:pt>
                <c:pt idx="849">
                  <c:v>380.8</c:v>
                </c:pt>
                <c:pt idx="850">
                  <c:v>380.6</c:v>
                </c:pt>
                <c:pt idx="851">
                  <c:v>380.4</c:v>
                </c:pt>
                <c:pt idx="852">
                  <c:v>380.2</c:v>
                </c:pt>
                <c:pt idx="853">
                  <c:v>380</c:v>
                </c:pt>
                <c:pt idx="854">
                  <c:v>379.8</c:v>
                </c:pt>
                <c:pt idx="855">
                  <c:v>379.6</c:v>
                </c:pt>
                <c:pt idx="856">
                  <c:v>379.4</c:v>
                </c:pt>
                <c:pt idx="857">
                  <c:v>379.2</c:v>
                </c:pt>
                <c:pt idx="858">
                  <c:v>379</c:v>
                </c:pt>
                <c:pt idx="859">
                  <c:v>378.8</c:v>
                </c:pt>
                <c:pt idx="860">
                  <c:v>378.6</c:v>
                </c:pt>
                <c:pt idx="861">
                  <c:v>378.4</c:v>
                </c:pt>
                <c:pt idx="862">
                  <c:v>378.2</c:v>
                </c:pt>
                <c:pt idx="863">
                  <c:v>378</c:v>
                </c:pt>
                <c:pt idx="864">
                  <c:v>377.8</c:v>
                </c:pt>
                <c:pt idx="865">
                  <c:v>377.6</c:v>
                </c:pt>
                <c:pt idx="866">
                  <c:v>377.4</c:v>
                </c:pt>
                <c:pt idx="867">
                  <c:v>377.2</c:v>
                </c:pt>
                <c:pt idx="868">
                  <c:v>377</c:v>
                </c:pt>
                <c:pt idx="869">
                  <c:v>376.8</c:v>
                </c:pt>
                <c:pt idx="870">
                  <c:v>376.6</c:v>
                </c:pt>
                <c:pt idx="871">
                  <c:v>376.4</c:v>
                </c:pt>
                <c:pt idx="872">
                  <c:v>376.2</c:v>
                </c:pt>
                <c:pt idx="873">
                  <c:v>376</c:v>
                </c:pt>
                <c:pt idx="874">
                  <c:v>375.8</c:v>
                </c:pt>
                <c:pt idx="875">
                  <c:v>375.6</c:v>
                </c:pt>
                <c:pt idx="876">
                  <c:v>375.4</c:v>
                </c:pt>
                <c:pt idx="877">
                  <c:v>375.2</c:v>
                </c:pt>
                <c:pt idx="878">
                  <c:v>375</c:v>
                </c:pt>
                <c:pt idx="879">
                  <c:v>374.8</c:v>
                </c:pt>
                <c:pt idx="880">
                  <c:v>374.6</c:v>
                </c:pt>
                <c:pt idx="881">
                  <c:v>374.4</c:v>
                </c:pt>
                <c:pt idx="882">
                  <c:v>374.2</c:v>
                </c:pt>
                <c:pt idx="883">
                  <c:v>374</c:v>
                </c:pt>
                <c:pt idx="884">
                  <c:v>373.8</c:v>
                </c:pt>
                <c:pt idx="885">
                  <c:v>373.6</c:v>
                </c:pt>
                <c:pt idx="886">
                  <c:v>373.4</c:v>
                </c:pt>
                <c:pt idx="887">
                  <c:v>373.2</c:v>
                </c:pt>
                <c:pt idx="888">
                  <c:v>373</c:v>
                </c:pt>
                <c:pt idx="889">
                  <c:v>372.8</c:v>
                </c:pt>
                <c:pt idx="890">
                  <c:v>372.6</c:v>
                </c:pt>
                <c:pt idx="891">
                  <c:v>372.4</c:v>
                </c:pt>
                <c:pt idx="892">
                  <c:v>372.2</c:v>
                </c:pt>
                <c:pt idx="893">
                  <c:v>372</c:v>
                </c:pt>
                <c:pt idx="894">
                  <c:v>371.8</c:v>
                </c:pt>
                <c:pt idx="895">
                  <c:v>371.6</c:v>
                </c:pt>
                <c:pt idx="896">
                  <c:v>371.4</c:v>
                </c:pt>
                <c:pt idx="897">
                  <c:v>371.2</c:v>
                </c:pt>
                <c:pt idx="898">
                  <c:v>371</c:v>
                </c:pt>
                <c:pt idx="899">
                  <c:v>370.8</c:v>
                </c:pt>
                <c:pt idx="900">
                  <c:v>370.6</c:v>
                </c:pt>
                <c:pt idx="901">
                  <c:v>370.4</c:v>
                </c:pt>
                <c:pt idx="902">
                  <c:v>370.2</c:v>
                </c:pt>
                <c:pt idx="903">
                  <c:v>370</c:v>
                </c:pt>
                <c:pt idx="904">
                  <c:v>369.8</c:v>
                </c:pt>
                <c:pt idx="905">
                  <c:v>369.6</c:v>
                </c:pt>
                <c:pt idx="906">
                  <c:v>369.4</c:v>
                </c:pt>
                <c:pt idx="907">
                  <c:v>369.2</c:v>
                </c:pt>
                <c:pt idx="908">
                  <c:v>369</c:v>
                </c:pt>
                <c:pt idx="909">
                  <c:v>368.8</c:v>
                </c:pt>
                <c:pt idx="910">
                  <c:v>368.6</c:v>
                </c:pt>
                <c:pt idx="911">
                  <c:v>368.4</c:v>
                </c:pt>
                <c:pt idx="912">
                  <c:v>368.2</c:v>
                </c:pt>
                <c:pt idx="913">
                  <c:v>368</c:v>
                </c:pt>
                <c:pt idx="914">
                  <c:v>367.8</c:v>
                </c:pt>
                <c:pt idx="915">
                  <c:v>367.6</c:v>
                </c:pt>
                <c:pt idx="916">
                  <c:v>367.4</c:v>
                </c:pt>
                <c:pt idx="917">
                  <c:v>367.2</c:v>
                </c:pt>
                <c:pt idx="918">
                  <c:v>367</c:v>
                </c:pt>
                <c:pt idx="919">
                  <c:v>366.8</c:v>
                </c:pt>
                <c:pt idx="920">
                  <c:v>366.6</c:v>
                </c:pt>
                <c:pt idx="921">
                  <c:v>366.4</c:v>
                </c:pt>
                <c:pt idx="922">
                  <c:v>366.2</c:v>
                </c:pt>
                <c:pt idx="923">
                  <c:v>366</c:v>
                </c:pt>
                <c:pt idx="924">
                  <c:v>365.8</c:v>
                </c:pt>
                <c:pt idx="925">
                  <c:v>365.6</c:v>
                </c:pt>
                <c:pt idx="926">
                  <c:v>365.4</c:v>
                </c:pt>
                <c:pt idx="927">
                  <c:v>365.2</c:v>
                </c:pt>
                <c:pt idx="928">
                  <c:v>365</c:v>
                </c:pt>
                <c:pt idx="929">
                  <c:v>364.8</c:v>
                </c:pt>
                <c:pt idx="930">
                  <c:v>364.6</c:v>
                </c:pt>
                <c:pt idx="931">
                  <c:v>364.4</c:v>
                </c:pt>
                <c:pt idx="932">
                  <c:v>364.2</c:v>
                </c:pt>
                <c:pt idx="933">
                  <c:v>364</c:v>
                </c:pt>
                <c:pt idx="934">
                  <c:v>363.8</c:v>
                </c:pt>
                <c:pt idx="935">
                  <c:v>363.6</c:v>
                </c:pt>
                <c:pt idx="936">
                  <c:v>363.4</c:v>
                </c:pt>
                <c:pt idx="937">
                  <c:v>363.2</c:v>
                </c:pt>
                <c:pt idx="938">
                  <c:v>363</c:v>
                </c:pt>
                <c:pt idx="939">
                  <c:v>362.8</c:v>
                </c:pt>
                <c:pt idx="940">
                  <c:v>362.6</c:v>
                </c:pt>
                <c:pt idx="941">
                  <c:v>362.4</c:v>
                </c:pt>
                <c:pt idx="942">
                  <c:v>362.2</c:v>
                </c:pt>
                <c:pt idx="943">
                  <c:v>362</c:v>
                </c:pt>
                <c:pt idx="944">
                  <c:v>361.8</c:v>
                </c:pt>
                <c:pt idx="945">
                  <c:v>361.6</c:v>
                </c:pt>
                <c:pt idx="946">
                  <c:v>361.4</c:v>
                </c:pt>
                <c:pt idx="947">
                  <c:v>361.2</c:v>
                </c:pt>
                <c:pt idx="948">
                  <c:v>361</c:v>
                </c:pt>
                <c:pt idx="949">
                  <c:v>360.8</c:v>
                </c:pt>
                <c:pt idx="950">
                  <c:v>360.6</c:v>
                </c:pt>
                <c:pt idx="951">
                  <c:v>360.4</c:v>
                </c:pt>
                <c:pt idx="952">
                  <c:v>360.2</c:v>
                </c:pt>
                <c:pt idx="953">
                  <c:v>360</c:v>
                </c:pt>
                <c:pt idx="954">
                  <c:v>359.8</c:v>
                </c:pt>
                <c:pt idx="955">
                  <c:v>359.6</c:v>
                </c:pt>
                <c:pt idx="956">
                  <c:v>359.4</c:v>
                </c:pt>
                <c:pt idx="957">
                  <c:v>359.2</c:v>
                </c:pt>
                <c:pt idx="958">
                  <c:v>359</c:v>
                </c:pt>
                <c:pt idx="959">
                  <c:v>358.8</c:v>
                </c:pt>
                <c:pt idx="960">
                  <c:v>358.6</c:v>
                </c:pt>
                <c:pt idx="961">
                  <c:v>358.4</c:v>
                </c:pt>
                <c:pt idx="962">
                  <c:v>358.2</c:v>
                </c:pt>
                <c:pt idx="963">
                  <c:v>358</c:v>
                </c:pt>
                <c:pt idx="964">
                  <c:v>357.8</c:v>
                </c:pt>
                <c:pt idx="965">
                  <c:v>357.6</c:v>
                </c:pt>
                <c:pt idx="966">
                  <c:v>357.4</c:v>
                </c:pt>
                <c:pt idx="967">
                  <c:v>357.2</c:v>
                </c:pt>
                <c:pt idx="968">
                  <c:v>357</c:v>
                </c:pt>
                <c:pt idx="969">
                  <c:v>356.8</c:v>
                </c:pt>
                <c:pt idx="970">
                  <c:v>356.6</c:v>
                </c:pt>
                <c:pt idx="971">
                  <c:v>356.4</c:v>
                </c:pt>
                <c:pt idx="972">
                  <c:v>356.2</c:v>
                </c:pt>
                <c:pt idx="973">
                  <c:v>356</c:v>
                </c:pt>
                <c:pt idx="974">
                  <c:v>355.8</c:v>
                </c:pt>
                <c:pt idx="975">
                  <c:v>355.6</c:v>
                </c:pt>
                <c:pt idx="976">
                  <c:v>355.4</c:v>
                </c:pt>
                <c:pt idx="977">
                  <c:v>355.2</c:v>
                </c:pt>
                <c:pt idx="978">
                  <c:v>355</c:v>
                </c:pt>
                <c:pt idx="979">
                  <c:v>354.8</c:v>
                </c:pt>
                <c:pt idx="980">
                  <c:v>354.6</c:v>
                </c:pt>
                <c:pt idx="981">
                  <c:v>354.4</c:v>
                </c:pt>
                <c:pt idx="982">
                  <c:v>354.2</c:v>
                </c:pt>
                <c:pt idx="983">
                  <c:v>354</c:v>
                </c:pt>
                <c:pt idx="984">
                  <c:v>353.8</c:v>
                </c:pt>
                <c:pt idx="985">
                  <c:v>353.6</c:v>
                </c:pt>
                <c:pt idx="986">
                  <c:v>353.4</c:v>
                </c:pt>
                <c:pt idx="987">
                  <c:v>353.2</c:v>
                </c:pt>
                <c:pt idx="988">
                  <c:v>353</c:v>
                </c:pt>
                <c:pt idx="989">
                  <c:v>352.8</c:v>
                </c:pt>
                <c:pt idx="990">
                  <c:v>352.6</c:v>
                </c:pt>
                <c:pt idx="991">
                  <c:v>352.4</c:v>
                </c:pt>
                <c:pt idx="992">
                  <c:v>352.2</c:v>
                </c:pt>
                <c:pt idx="993">
                  <c:v>352</c:v>
                </c:pt>
                <c:pt idx="994">
                  <c:v>351.8</c:v>
                </c:pt>
                <c:pt idx="995">
                  <c:v>351.6</c:v>
                </c:pt>
                <c:pt idx="996">
                  <c:v>351.4</c:v>
                </c:pt>
                <c:pt idx="997">
                  <c:v>351.2</c:v>
                </c:pt>
                <c:pt idx="998">
                  <c:v>351</c:v>
                </c:pt>
                <c:pt idx="999">
                  <c:v>350.8</c:v>
                </c:pt>
                <c:pt idx="1000">
                  <c:v>350.6</c:v>
                </c:pt>
                <c:pt idx="1001">
                  <c:v>350.4</c:v>
                </c:pt>
                <c:pt idx="1002">
                  <c:v>350.2</c:v>
                </c:pt>
                <c:pt idx="1003">
                  <c:v>350</c:v>
                </c:pt>
                <c:pt idx="1004">
                  <c:v>349.8</c:v>
                </c:pt>
                <c:pt idx="1005">
                  <c:v>349.6</c:v>
                </c:pt>
                <c:pt idx="1006">
                  <c:v>349.4</c:v>
                </c:pt>
                <c:pt idx="1007">
                  <c:v>349.2</c:v>
                </c:pt>
                <c:pt idx="1008">
                  <c:v>349</c:v>
                </c:pt>
                <c:pt idx="1009">
                  <c:v>348.8</c:v>
                </c:pt>
                <c:pt idx="1010">
                  <c:v>348.6</c:v>
                </c:pt>
                <c:pt idx="1011">
                  <c:v>348.4</c:v>
                </c:pt>
                <c:pt idx="1012">
                  <c:v>348.2</c:v>
                </c:pt>
                <c:pt idx="1013">
                  <c:v>348</c:v>
                </c:pt>
                <c:pt idx="1014">
                  <c:v>347.8</c:v>
                </c:pt>
                <c:pt idx="1015">
                  <c:v>347.6</c:v>
                </c:pt>
                <c:pt idx="1016">
                  <c:v>347.4</c:v>
                </c:pt>
                <c:pt idx="1017">
                  <c:v>347.2</c:v>
                </c:pt>
                <c:pt idx="1018">
                  <c:v>347</c:v>
                </c:pt>
                <c:pt idx="1019">
                  <c:v>346.8</c:v>
                </c:pt>
                <c:pt idx="1020">
                  <c:v>346.6</c:v>
                </c:pt>
                <c:pt idx="1021">
                  <c:v>346.4</c:v>
                </c:pt>
                <c:pt idx="1022">
                  <c:v>346.2</c:v>
                </c:pt>
                <c:pt idx="1023">
                  <c:v>346</c:v>
                </c:pt>
                <c:pt idx="1024">
                  <c:v>345.8</c:v>
                </c:pt>
                <c:pt idx="1025">
                  <c:v>345.6</c:v>
                </c:pt>
                <c:pt idx="1026">
                  <c:v>345.4</c:v>
                </c:pt>
                <c:pt idx="1027">
                  <c:v>345.2</c:v>
                </c:pt>
                <c:pt idx="1028">
                  <c:v>345</c:v>
                </c:pt>
                <c:pt idx="1029">
                  <c:v>344.8</c:v>
                </c:pt>
                <c:pt idx="1030">
                  <c:v>344.6</c:v>
                </c:pt>
                <c:pt idx="1031">
                  <c:v>344.4</c:v>
                </c:pt>
                <c:pt idx="1032">
                  <c:v>344.2</c:v>
                </c:pt>
                <c:pt idx="1033">
                  <c:v>344</c:v>
                </c:pt>
                <c:pt idx="1034">
                  <c:v>343.8</c:v>
                </c:pt>
                <c:pt idx="1035">
                  <c:v>343.6</c:v>
                </c:pt>
                <c:pt idx="1036">
                  <c:v>343.4</c:v>
                </c:pt>
                <c:pt idx="1037">
                  <c:v>343.2</c:v>
                </c:pt>
                <c:pt idx="1038">
                  <c:v>343</c:v>
                </c:pt>
                <c:pt idx="1039">
                  <c:v>342.8</c:v>
                </c:pt>
                <c:pt idx="1040">
                  <c:v>342.6</c:v>
                </c:pt>
                <c:pt idx="1041">
                  <c:v>342.4</c:v>
                </c:pt>
                <c:pt idx="1042">
                  <c:v>342.2</c:v>
                </c:pt>
                <c:pt idx="1043">
                  <c:v>342</c:v>
                </c:pt>
                <c:pt idx="1044">
                  <c:v>341.8</c:v>
                </c:pt>
                <c:pt idx="1045">
                  <c:v>341.6</c:v>
                </c:pt>
                <c:pt idx="1046">
                  <c:v>341.4</c:v>
                </c:pt>
                <c:pt idx="1047">
                  <c:v>341.2</c:v>
                </c:pt>
                <c:pt idx="1048">
                  <c:v>341</c:v>
                </c:pt>
                <c:pt idx="1049">
                  <c:v>340.8</c:v>
                </c:pt>
                <c:pt idx="1050">
                  <c:v>340.6</c:v>
                </c:pt>
                <c:pt idx="1051">
                  <c:v>340.4</c:v>
                </c:pt>
                <c:pt idx="1052">
                  <c:v>340.2</c:v>
                </c:pt>
                <c:pt idx="1053">
                  <c:v>340</c:v>
                </c:pt>
                <c:pt idx="1054">
                  <c:v>339.8</c:v>
                </c:pt>
                <c:pt idx="1055">
                  <c:v>339.6</c:v>
                </c:pt>
                <c:pt idx="1056">
                  <c:v>339.4</c:v>
                </c:pt>
                <c:pt idx="1057">
                  <c:v>339.2</c:v>
                </c:pt>
                <c:pt idx="1058">
                  <c:v>339</c:v>
                </c:pt>
                <c:pt idx="1059">
                  <c:v>338.8</c:v>
                </c:pt>
                <c:pt idx="1060">
                  <c:v>338.6</c:v>
                </c:pt>
                <c:pt idx="1061">
                  <c:v>338.4</c:v>
                </c:pt>
                <c:pt idx="1062">
                  <c:v>338.2</c:v>
                </c:pt>
                <c:pt idx="1063">
                  <c:v>338</c:v>
                </c:pt>
                <c:pt idx="1064">
                  <c:v>337.8</c:v>
                </c:pt>
                <c:pt idx="1065">
                  <c:v>337.6</c:v>
                </c:pt>
                <c:pt idx="1066">
                  <c:v>337.4</c:v>
                </c:pt>
                <c:pt idx="1067">
                  <c:v>337.2</c:v>
                </c:pt>
                <c:pt idx="1068">
                  <c:v>337</c:v>
                </c:pt>
                <c:pt idx="1069">
                  <c:v>336.8</c:v>
                </c:pt>
                <c:pt idx="1070">
                  <c:v>336.6</c:v>
                </c:pt>
                <c:pt idx="1071">
                  <c:v>336.4</c:v>
                </c:pt>
                <c:pt idx="1072">
                  <c:v>336.2</c:v>
                </c:pt>
                <c:pt idx="1073">
                  <c:v>336</c:v>
                </c:pt>
                <c:pt idx="1074">
                  <c:v>335.8</c:v>
                </c:pt>
                <c:pt idx="1075">
                  <c:v>335.6</c:v>
                </c:pt>
                <c:pt idx="1076">
                  <c:v>335.4</c:v>
                </c:pt>
                <c:pt idx="1077">
                  <c:v>335.2</c:v>
                </c:pt>
                <c:pt idx="1078">
                  <c:v>335</c:v>
                </c:pt>
                <c:pt idx="1079">
                  <c:v>334.8</c:v>
                </c:pt>
                <c:pt idx="1080">
                  <c:v>334.6</c:v>
                </c:pt>
                <c:pt idx="1081">
                  <c:v>334.4</c:v>
                </c:pt>
                <c:pt idx="1082">
                  <c:v>334.2</c:v>
                </c:pt>
                <c:pt idx="1083">
                  <c:v>334</c:v>
                </c:pt>
                <c:pt idx="1084">
                  <c:v>333.8</c:v>
                </c:pt>
                <c:pt idx="1085">
                  <c:v>333.6</c:v>
                </c:pt>
                <c:pt idx="1086">
                  <c:v>333.4</c:v>
                </c:pt>
                <c:pt idx="1087">
                  <c:v>333.2</c:v>
                </c:pt>
                <c:pt idx="1088">
                  <c:v>333</c:v>
                </c:pt>
                <c:pt idx="1089">
                  <c:v>332.8</c:v>
                </c:pt>
                <c:pt idx="1090">
                  <c:v>332.6</c:v>
                </c:pt>
                <c:pt idx="1091">
                  <c:v>332.4</c:v>
                </c:pt>
                <c:pt idx="1092">
                  <c:v>332.2</c:v>
                </c:pt>
                <c:pt idx="1093">
                  <c:v>332</c:v>
                </c:pt>
                <c:pt idx="1094">
                  <c:v>331.8</c:v>
                </c:pt>
                <c:pt idx="1095">
                  <c:v>331.6</c:v>
                </c:pt>
                <c:pt idx="1096">
                  <c:v>331.4</c:v>
                </c:pt>
                <c:pt idx="1097">
                  <c:v>331.2</c:v>
                </c:pt>
                <c:pt idx="1098">
                  <c:v>331</c:v>
                </c:pt>
                <c:pt idx="1099">
                  <c:v>330.8</c:v>
                </c:pt>
                <c:pt idx="1100">
                  <c:v>330.6</c:v>
                </c:pt>
                <c:pt idx="1101">
                  <c:v>330.4</c:v>
                </c:pt>
                <c:pt idx="1102">
                  <c:v>330.2</c:v>
                </c:pt>
                <c:pt idx="1103">
                  <c:v>330</c:v>
                </c:pt>
                <c:pt idx="1104">
                  <c:v>329.8</c:v>
                </c:pt>
                <c:pt idx="1105">
                  <c:v>329.6</c:v>
                </c:pt>
                <c:pt idx="1106">
                  <c:v>329.4</c:v>
                </c:pt>
                <c:pt idx="1107">
                  <c:v>329.2</c:v>
                </c:pt>
                <c:pt idx="1108">
                  <c:v>329</c:v>
                </c:pt>
                <c:pt idx="1109">
                  <c:v>328.8</c:v>
                </c:pt>
                <c:pt idx="1110">
                  <c:v>328.6</c:v>
                </c:pt>
                <c:pt idx="1111">
                  <c:v>328.4</c:v>
                </c:pt>
                <c:pt idx="1112">
                  <c:v>328.2</c:v>
                </c:pt>
                <c:pt idx="1113">
                  <c:v>328</c:v>
                </c:pt>
                <c:pt idx="1114">
                  <c:v>327.8</c:v>
                </c:pt>
                <c:pt idx="1115">
                  <c:v>327.60000000000002</c:v>
                </c:pt>
                <c:pt idx="1116">
                  <c:v>327.39999999999998</c:v>
                </c:pt>
                <c:pt idx="1117">
                  <c:v>327.2</c:v>
                </c:pt>
                <c:pt idx="1118">
                  <c:v>327</c:v>
                </c:pt>
                <c:pt idx="1119">
                  <c:v>326.8</c:v>
                </c:pt>
                <c:pt idx="1120">
                  <c:v>326.60000000000002</c:v>
                </c:pt>
                <c:pt idx="1121">
                  <c:v>326.39999999999998</c:v>
                </c:pt>
                <c:pt idx="1122">
                  <c:v>326.2</c:v>
                </c:pt>
                <c:pt idx="1123">
                  <c:v>326</c:v>
                </c:pt>
                <c:pt idx="1124">
                  <c:v>325.8</c:v>
                </c:pt>
                <c:pt idx="1125">
                  <c:v>325.60000000000002</c:v>
                </c:pt>
                <c:pt idx="1126">
                  <c:v>325.39999999999998</c:v>
                </c:pt>
                <c:pt idx="1127">
                  <c:v>325.2</c:v>
                </c:pt>
                <c:pt idx="1128">
                  <c:v>325</c:v>
                </c:pt>
                <c:pt idx="1129">
                  <c:v>324.8</c:v>
                </c:pt>
                <c:pt idx="1130">
                  <c:v>324.60000000000002</c:v>
                </c:pt>
                <c:pt idx="1131">
                  <c:v>324.39999999999998</c:v>
                </c:pt>
                <c:pt idx="1132">
                  <c:v>324.2</c:v>
                </c:pt>
                <c:pt idx="1133">
                  <c:v>324</c:v>
                </c:pt>
                <c:pt idx="1134">
                  <c:v>323.8</c:v>
                </c:pt>
                <c:pt idx="1135">
                  <c:v>323.60000000000002</c:v>
                </c:pt>
                <c:pt idx="1136">
                  <c:v>323.39999999999998</c:v>
                </c:pt>
                <c:pt idx="1137">
                  <c:v>323.2</c:v>
                </c:pt>
                <c:pt idx="1138">
                  <c:v>323</c:v>
                </c:pt>
                <c:pt idx="1139">
                  <c:v>322.8</c:v>
                </c:pt>
                <c:pt idx="1140">
                  <c:v>322.60000000000002</c:v>
                </c:pt>
                <c:pt idx="1141">
                  <c:v>322.39999999999998</c:v>
                </c:pt>
                <c:pt idx="1142">
                  <c:v>322.2</c:v>
                </c:pt>
                <c:pt idx="1143">
                  <c:v>322</c:v>
                </c:pt>
                <c:pt idx="1144">
                  <c:v>321.8</c:v>
                </c:pt>
                <c:pt idx="1145">
                  <c:v>321.60000000000002</c:v>
                </c:pt>
                <c:pt idx="1146">
                  <c:v>321.39999999999998</c:v>
                </c:pt>
                <c:pt idx="1147">
                  <c:v>321.2</c:v>
                </c:pt>
                <c:pt idx="1148">
                  <c:v>321</c:v>
                </c:pt>
                <c:pt idx="1149">
                  <c:v>320.8</c:v>
                </c:pt>
                <c:pt idx="1150">
                  <c:v>320.60000000000002</c:v>
                </c:pt>
                <c:pt idx="1151">
                  <c:v>320.39999999999998</c:v>
                </c:pt>
                <c:pt idx="1152">
                  <c:v>320.2</c:v>
                </c:pt>
                <c:pt idx="1153">
                  <c:v>320</c:v>
                </c:pt>
                <c:pt idx="1154">
                  <c:v>319.8</c:v>
                </c:pt>
                <c:pt idx="1155">
                  <c:v>319.60000000000002</c:v>
                </c:pt>
                <c:pt idx="1156">
                  <c:v>319.39999999999998</c:v>
                </c:pt>
                <c:pt idx="1157">
                  <c:v>319.2</c:v>
                </c:pt>
                <c:pt idx="1158">
                  <c:v>319</c:v>
                </c:pt>
                <c:pt idx="1159">
                  <c:v>318.8</c:v>
                </c:pt>
                <c:pt idx="1160">
                  <c:v>318.60000000000002</c:v>
                </c:pt>
                <c:pt idx="1161">
                  <c:v>318.39999999999998</c:v>
                </c:pt>
                <c:pt idx="1162">
                  <c:v>318.2</c:v>
                </c:pt>
                <c:pt idx="1163">
                  <c:v>318</c:v>
                </c:pt>
                <c:pt idx="1164">
                  <c:v>317.8</c:v>
                </c:pt>
                <c:pt idx="1165">
                  <c:v>317.60000000000002</c:v>
                </c:pt>
                <c:pt idx="1166">
                  <c:v>317.39999999999998</c:v>
                </c:pt>
                <c:pt idx="1167">
                  <c:v>317.2</c:v>
                </c:pt>
                <c:pt idx="1168">
                  <c:v>317</c:v>
                </c:pt>
                <c:pt idx="1169">
                  <c:v>316.8</c:v>
                </c:pt>
                <c:pt idx="1170">
                  <c:v>316.60000000000002</c:v>
                </c:pt>
                <c:pt idx="1171">
                  <c:v>316.39999999999998</c:v>
                </c:pt>
                <c:pt idx="1172">
                  <c:v>316.2</c:v>
                </c:pt>
                <c:pt idx="1173">
                  <c:v>316</c:v>
                </c:pt>
                <c:pt idx="1174">
                  <c:v>315.8</c:v>
                </c:pt>
                <c:pt idx="1175">
                  <c:v>315.60000000000002</c:v>
                </c:pt>
                <c:pt idx="1176">
                  <c:v>315.39999999999998</c:v>
                </c:pt>
                <c:pt idx="1177">
                  <c:v>315.2</c:v>
                </c:pt>
                <c:pt idx="1178">
                  <c:v>315</c:v>
                </c:pt>
                <c:pt idx="1179">
                  <c:v>314.8</c:v>
                </c:pt>
                <c:pt idx="1180">
                  <c:v>314.60000000000002</c:v>
                </c:pt>
                <c:pt idx="1181">
                  <c:v>314.39999999999998</c:v>
                </c:pt>
                <c:pt idx="1182">
                  <c:v>314.2</c:v>
                </c:pt>
                <c:pt idx="1183">
                  <c:v>314</c:v>
                </c:pt>
                <c:pt idx="1184">
                  <c:v>313.8</c:v>
                </c:pt>
                <c:pt idx="1185">
                  <c:v>313.60000000000002</c:v>
                </c:pt>
                <c:pt idx="1186">
                  <c:v>313.39999999999998</c:v>
                </c:pt>
                <c:pt idx="1187">
                  <c:v>313.2</c:v>
                </c:pt>
                <c:pt idx="1188">
                  <c:v>313</c:v>
                </c:pt>
                <c:pt idx="1189">
                  <c:v>312.8</c:v>
                </c:pt>
                <c:pt idx="1190">
                  <c:v>312.60000000000002</c:v>
                </c:pt>
                <c:pt idx="1191">
                  <c:v>312.39999999999998</c:v>
                </c:pt>
                <c:pt idx="1192">
                  <c:v>312.2</c:v>
                </c:pt>
                <c:pt idx="1193">
                  <c:v>312</c:v>
                </c:pt>
                <c:pt idx="1194">
                  <c:v>311.8</c:v>
                </c:pt>
                <c:pt idx="1195">
                  <c:v>311.60000000000002</c:v>
                </c:pt>
                <c:pt idx="1196">
                  <c:v>311.39999999999998</c:v>
                </c:pt>
                <c:pt idx="1197">
                  <c:v>311.2</c:v>
                </c:pt>
                <c:pt idx="1198">
                  <c:v>311</c:v>
                </c:pt>
                <c:pt idx="1199">
                  <c:v>310.8</c:v>
                </c:pt>
                <c:pt idx="1200">
                  <c:v>310.60000000000002</c:v>
                </c:pt>
                <c:pt idx="1201">
                  <c:v>310.39999999999998</c:v>
                </c:pt>
                <c:pt idx="1202">
                  <c:v>310.2</c:v>
                </c:pt>
                <c:pt idx="1203">
                  <c:v>310</c:v>
                </c:pt>
                <c:pt idx="1204">
                  <c:v>309.8</c:v>
                </c:pt>
                <c:pt idx="1205">
                  <c:v>309.60000000000002</c:v>
                </c:pt>
                <c:pt idx="1206">
                  <c:v>309.39999999999998</c:v>
                </c:pt>
                <c:pt idx="1207">
                  <c:v>309.2</c:v>
                </c:pt>
                <c:pt idx="1208">
                  <c:v>309</c:v>
                </c:pt>
                <c:pt idx="1209">
                  <c:v>308.8</c:v>
                </c:pt>
                <c:pt idx="1210">
                  <c:v>308.60000000000002</c:v>
                </c:pt>
                <c:pt idx="1211">
                  <c:v>308.39999999999998</c:v>
                </c:pt>
                <c:pt idx="1212">
                  <c:v>308.2</c:v>
                </c:pt>
                <c:pt idx="1213">
                  <c:v>308</c:v>
                </c:pt>
                <c:pt idx="1214">
                  <c:v>307.8</c:v>
                </c:pt>
                <c:pt idx="1215">
                  <c:v>307.60000000000002</c:v>
                </c:pt>
                <c:pt idx="1216">
                  <c:v>307.39999999999998</c:v>
                </c:pt>
                <c:pt idx="1217">
                  <c:v>307.2</c:v>
                </c:pt>
                <c:pt idx="1218">
                  <c:v>307</c:v>
                </c:pt>
                <c:pt idx="1219">
                  <c:v>306.8</c:v>
                </c:pt>
                <c:pt idx="1220">
                  <c:v>306.60000000000002</c:v>
                </c:pt>
                <c:pt idx="1221">
                  <c:v>306.39999999999998</c:v>
                </c:pt>
                <c:pt idx="1222">
                  <c:v>306.2</c:v>
                </c:pt>
                <c:pt idx="1223">
                  <c:v>306</c:v>
                </c:pt>
                <c:pt idx="1224">
                  <c:v>305.8</c:v>
                </c:pt>
                <c:pt idx="1225">
                  <c:v>305.60000000000002</c:v>
                </c:pt>
                <c:pt idx="1226">
                  <c:v>305.39999999999998</c:v>
                </c:pt>
                <c:pt idx="1227">
                  <c:v>305.2</c:v>
                </c:pt>
                <c:pt idx="1228">
                  <c:v>305</c:v>
                </c:pt>
                <c:pt idx="1229">
                  <c:v>304.8</c:v>
                </c:pt>
                <c:pt idx="1230">
                  <c:v>304.60000000000002</c:v>
                </c:pt>
                <c:pt idx="1231">
                  <c:v>304.39999999999998</c:v>
                </c:pt>
                <c:pt idx="1232">
                  <c:v>304.2</c:v>
                </c:pt>
                <c:pt idx="1233">
                  <c:v>304</c:v>
                </c:pt>
                <c:pt idx="1234">
                  <c:v>303.8</c:v>
                </c:pt>
                <c:pt idx="1235">
                  <c:v>303.60000000000002</c:v>
                </c:pt>
                <c:pt idx="1236">
                  <c:v>303.39999999999998</c:v>
                </c:pt>
                <c:pt idx="1237">
                  <c:v>303.2</c:v>
                </c:pt>
                <c:pt idx="1238">
                  <c:v>303</c:v>
                </c:pt>
                <c:pt idx="1239">
                  <c:v>302.8</c:v>
                </c:pt>
                <c:pt idx="1240">
                  <c:v>302.60000000000002</c:v>
                </c:pt>
                <c:pt idx="1241">
                  <c:v>302.39999999999998</c:v>
                </c:pt>
                <c:pt idx="1242">
                  <c:v>302.2</c:v>
                </c:pt>
                <c:pt idx="1243">
                  <c:v>302</c:v>
                </c:pt>
                <c:pt idx="1244">
                  <c:v>301.8</c:v>
                </c:pt>
                <c:pt idx="1245">
                  <c:v>301.60000000000002</c:v>
                </c:pt>
                <c:pt idx="1246">
                  <c:v>301.39999999999998</c:v>
                </c:pt>
                <c:pt idx="1247">
                  <c:v>301.2</c:v>
                </c:pt>
                <c:pt idx="1248">
                  <c:v>301</c:v>
                </c:pt>
                <c:pt idx="1249">
                  <c:v>300.8</c:v>
                </c:pt>
                <c:pt idx="1250">
                  <c:v>300.60000000000002</c:v>
                </c:pt>
                <c:pt idx="1251">
                  <c:v>300.39999999999998</c:v>
                </c:pt>
                <c:pt idx="1252">
                  <c:v>300.2</c:v>
                </c:pt>
                <c:pt idx="1253">
                  <c:v>300</c:v>
                </c:pt>
              </c:numCache>
            </c:numRef>
          </c:xVal>
          <c:yVal>
            <c:numRef>
              <c:f>Hoja1!$BW$2:$BW$1255</c:f>
              <c:numCache>
                <c:formatCode>General</c:formatCode>
                <c:ptCount val="1254"/>
                <c:pt idx="0">
                  <c:v>0</c:v>
                </c:pt>
                <c:pt idx="1">
                  <c:v>0</c:v>
                </c:pt>
                <c:pt idx="3">
                  <c:v>5.7333333333333333E-3</c:v>
                </c:pt>
                <c:pt idx="4">
                  <c:v>6.1000000000000013E-3</c:v>
                </c:pt>
                <c:pt idx="5">
                  <c:v>6.5833333333333343E-3</c:v>
                </c:pt>
                <c:pt idx="6">
                  <c:v>7.1000000000000021E-3</c:v>
                </c:pt>
                <c:pt idx="7">
                  <c:v>7.6666666666666662E-3</c:v>
                </c:pt>
                <c:pt idx="8">
                  <c:v>8.2833333333333318E-3</c:v>
                </c:pt>
                <c:pt idx="9">
                  <c:v>8.850000000000002E-3</c:v>
                </c:pt>
                <c:pt idx="10">
                  <c:v>9.4833333333333349E-3</c:v>
                </c:pt>
                <c:pt idx="11">
                  <c:v>9.9833333333333319E-3</c:v>
                </c:pt>
                <c:pt idx="12">
                  <c:v>1.0566666666666667E-2</c:v>
                </c:pt>
                <c:pt idx="13">
                  <c:v>1.1116666666666669E-2</c:v>
                </c:pt>
                <c:pt idx="14">
                  <c:v>1.1716666666666667E-2</c:v>
                </c:pt>
                <c:pt idx="15">
                  <c:v>1.2250000000000002E-2</c:v>
                </c:pt>
                <c:pt idx="16">
                  <c:v>1.2816666666666665E-2</c:v>
                </c:pt>
                <c:pt idx="17">
                  <c:v>1.3433333333333334E-2</c:v>
                </c:pt>
                <c:pt idx="18">
                  <c:v>1.4033333333333335E-2</c:v>
                </c:pt>
                <c:pt idx="19">
                  <c:v>1.4683333333333335E-2</c:v>
                </c:pt>
                <c:pt idx="20">
                  <c:v>1.5300000000000001E-2</c:v>
                </c:pt>
                <c:pt idx="21">
                  <c:v>1.5933333333333334E-2</c:v>
                </c:pt>
                <c:pt idx="22">
                  <c:v>1.6566666666666667E-2</c:v>
                </c:pt>
                <c:pt idx="23">
                  <c:v>1.72E-2</c:v>
                </c:pt>
                <c:pt idx="24">
                  <c:v>1.7866666666666666E-2</c:v>
                </c:pt>
                <c:pt idx="25">
                  <c:v>1.8533333333333336E-2</c:v>
                </c:pt>
                <c:pt idx="26">
                  <c:v>1.921666666666667E-2</c:v>
                </c:pt>
                <c:pt idx="27">
                  <c:v>1.9866666666666668E-2</c:v>
                </c:pt>
                <c:pt idx="28">
                  <c:v>2.06E-2</c:v>
                </c:pt>
                <c:pt idx="29">
                  <c:v>2.1299999999999999E-2</c:v>
                </c:pt>
                <c:pt idx="30">
                  <c:v>2.2016666666666667E-2</c:v>
                </c:pt>
                <c:pt idx="31">
                  <c:v>2.2750000000000003E-2</c:v>
                </c:pt>
                <c:pt idx="32">
                  <c:v>2.3466666666666667E-2</c:v>
                </c:pt>
                <c:pt idx="33">
                  <c:v>2.4249999999999997E-2</c:v>
                </c:pt>
                <c:pt idx="34">
                  <c:v>2.4966666666666668E-2</c:v>
                </c:pt>
                <c:pt idx="35">
                  <c:v>2.5749999999999999E-2</c:v>
                </c:pt>
                <c:pt idx="36">
                  <c:v>2.6550000000000001E-2</c:v>
                </c:pt>
                <c:pt idx="37">
                  <c:v>2.7333333333333334E-2</c:v>
                </c:pt>
                <c:pt idx="38">
                  <c:v>2.8116666666666668E-2</c:v>
                </c:pt>
                <c:pt idx="39">
                  <c:v>2.8950000000000004E-2</c:v>
                </c:pt>
                <c:pt idx="40">
                  <c:v>2.9783333333333328E-2</c:v>
                </c:pt>
                <c:pt idx="41">
                  <c:v>3.0616666666666667E-2</c:v>
                </c:pt>
                <c:pt idx="42">
                  <c:v>3.1533333333333337E-2</c:v>
                </c:pt>
                <c:pt idx="43">
                  <c:v>3.2399999999999998E-2</c:v>
                </c:pt>
                <c:pt idx="44">
                  <c:v>3.32E-2</c:v>
                </c:pt>
                <c:pt idx="45">
                  <c:v>3.4099999999999998E-2</c:v>
                </c:pt>
                <c:pt idx="46">
                  <c:v>3.4916666666666665E-2</c:v>
                </c:pt>
                <c:pt idx="47">
                  <c:v>3.5749999999999997E-2</c:v>
                </c:pt>
                <c:pt idx="48">
                  <c:v>3.6716666666666675E-2</c:v>
                </c:pt>
                <c:pt idx="49">
                  <c:v>3.755E-2</c:v>
                </c:pt>
                <c:pt idx="50">
                  <c:v>3.846666666666667E-2</c:v>
                </c:pt>
                <c:pt idx="51">
                  <c:v>3.9399999999999998E-2</c:v>
                </c:pt>
                <c:pt idx="52">
                  <c:v>4.0299999999999996E-2</c:v>
                </c:pt>
                <c:pt idx="53">
                  <c:v>4.1216666666666672E-2</c:v>
                </c:pt>
                <c:pt idx="54">
                  <c:v>4.218333333333333E-2</c:v>
                </c:pt>
                <c:pt idx="55">
                  <c:v>4.3116666666666671E-2</c:v>
                </c:pt>
                <c:pt idx="56">
                  <c:v>4.3983333333333326E-2</c:v>
                </c:pt>
                <c:pt idx="57">
                  <c:v>4.4899999999999995E-2</c:v>
                </c:pt>
                <c:pt idx="58">
                  <c:v>4.5883333333333332E-2</c:v>
                </c:pt>
                <c:pt idx="59">
                  <c:v>4.6783333333333336E-2</c:v>
                </c:pt>
                <c:pt idx="60">
                  <c:v>4.7766666666666673E-2</c:v>
                </c:pt>
                <c:pt idx="61">
                  <c:v>4.87E-2</c:v>
                </c:pt>
                <c:pt idx="62">
                  <c:v>4.965E-2</c:v>
                </c:pt>
                <c:pt idx="63">
                  <c:v>5.0666666666666658E-2</c:v>
                </c:pt>
                <c:pt idx="64">
                  <c:v>5.1616666666666665E-2</c:v>
                </c:pt>
                <c:pt idx="65">
                  <c:v>5.2650000000000009E-2</c:v>
                </c:pt>
                <c:pt idx="66">
                  <c:v>5.371666666666667E-2</c:v>
                </c:pt>
                <c:pt idx="67">
                  <c:v>5.4683333333333341E-2</c:v>
                </c:pt>
                <c:pt idx="68">
                  <c:v>5.5733333333333329E-2</c:v>
                </c:pt>
                <c:pt idx="69">
                  <c:v>5.6716666666666665E-2</c:v>
                </c:pt>
                <c:pt idx="70">
                  <c:v>5.7700000000000001E-2</c:v>
                </c:pt>
                <c:pt idx="71">
                  <c:v>5.8533333333333333E-2</c:v>
                </c:pt>
                <c:pt idx="72">
                  <c:v>5.9399999999999988E-2</c:v>
                </c:pt>
                <c:pt idx="73">
                  <c:v>6.0233333333333333E-2</c:v>
                </c:pt>
                <c:pt idx="74">
                  <c:v>6.1066666666666665E-2</c:v>
                </c:pt>
                <c:pt idx="75">
                  <c:v>6.2049999999999994E-2</c:v>
                </c:pt>
                <c:pt idx="76">
                  <c:v>6.3066666666666674E-2</c:v>
                </c:pt>
                <c:pt idx="77">
                  <c:v>6.4066666666666661E-2</c:v>
                </c:pt>
                <c:pt idx="78">
                  <c:v>6.5016666666666667E-2</c:v>
                </c:pt>
                <c:pt idx="79">
                  <c:v>6.6083333333333327E-2</c:v>
                </c:pt>
                <c:pt idx="80">
                  <c:v>6.696666666666666E-2</c:v>
                </c:pt>
                <c:pt idx="81">
                  <c:v>6.7966666666666661E-2</c:v>
                </c:pt>
                <c:pt idx="82">
                  <c:v>6.9000000000000006E-2</c:v>
                </c:pt>
                <c:pt idx="83">
                  <c:v>6.9949999999999998E-2</c:v>
                </c:pt>
                <c:pt idx="84">
                  <c:v>7.0933333333333348E-2</c:v>
                </c:pt>
                <c:pt idx="85">
                  <c:v>7.1900000000000006E-2</c:v>
                </c:pt>
                <c:pt idx="86">
                  <c:v>7.2883333333333342E-2</c:v>
                </c:pt>
                <c:pt idx="87">
                  <c:v>7.3833333333333334E-2</c:v>
                </c:pt>
                <c:pt idx="88">
                  <c:v>7.481666666666667E-2</c:v>
                </c:pt>
                <c:pt idx="89">
                  <c:v>7.5799999999999992E-2</c:v>
                </c:pt>
                <c:pt idx="90">
                  <c:v>7.6733333333333334E-2</c:v>
                </c:pt>
                <c:pt idx="91">
                  <c:v>7.7683333333333326E-2</c:v>
                </c:pt>
                <c:pt idx="92">
                  <c:v>7.8600000000000003E-2</c:v>
                </c:pt>
                <c:pt idx="93">
                  <c:v>7.9500000000000001E-2</c:v>
                </c:pt>
                <c:pt idx="94">
                  <c:v>8.0450000000000008E-2</c:v>
                </c:pt>
                <c:pt idx="95">
                  <c:v>8.1366666666666657E-2</c:v>
                </c:pt>
                <c:pt idx="96">
                  <c:v>8.2266666666666655E-2</c:v>
                </c:pt>
                <c:pt idx="97">
                  <c:v>8.3100000000000007E-2</c:v>
                </c:pt>
                <c:pt idx="98">
                  <c:v>8.3933333333333346E-2</c:v>
                </c:pt>
                <c:pt idx="99">
                  <c:v>8.4849999999999995E-2</c:v>
                </c:pt>
                <c:pt idx="100">
                  <c:v>8.5716666666666677E-2</c:v>
                </c:pt>
                <c:pt idx="101">
                  <c:v>8.6516666666666672E-2</c:v>
                </c:pt>
                <c:pt idx="102">
                  <c:v>8.7333333333333332E-2</c:v>
                </c:pt>
                <c:pt idx="103">
                  <c:v>8.8116666666666663E-2</c:v>
                </c:pt>
                <c:pt idx="104">
                  <c:v>8.8899999999999993E-2</c:v>
                </c:pt>
                <c:pt idx="105">
                  <c:v>8.9683333333333337E-2</c:v>
                </c:pt>
                <c:pt idx="106">
                  <c:v>9.0466666666666681E-2</c:v>
                </c:pt>
                <c:pt idx="107">
                  <c:v>9.1249999999999984E-2</c:v>
                </c:pt>
                <c:pt idx="108">
                  <c:v>9.1950000000000018E-2</c:v>
                </c:pt>
                <c:pt idx="109">
                  <c:v>9.2700000000000005E-2</c:v>
                </c:pt>
                <c:pt idx="110">
                  <c:v>9.3383333333333332E-2</c:v>
                </c:pt>
                <c:pt idx="111">
                  <c:v>9.4016666666666651E-2</c:v>
                </c:pt>
                <c:pt idx="112">
                  <c:v>9.4583333333333339E-2</c:v>
                </c:pt>
                <c:pt idx="113">
                  <c:v>9.5233333333333337E-2</c:v>
                </c:pt>
                <c:pt idx="114">
                  <c:v>9.5799999999999996E-2</c:v>
                </c:pt>
                <c:pt idx="115">
                  <c:v>9.6383333333333335E-2</c:v>
                </c:pt>
                <c:pt idx="116">
                  <c:v>9.6966666666666659E-2</c:v>
                </c:pt>
                <c:pt idx="117">
                  <c:v>9.7533333333333319E-2</c:v>
                </c:pt>
                <c:pt idx="118">
                  <c:v>9.8016666666666682E-2</c:v>
                </c:pt>
                <c:pt idx="119">
                  <c:v>9.849999999999999E-2</c:v>
                </c:pt>
                <c:pt idx="120">
                  <c:v>9.8983333333333326E-2</c:v>
                </c:pt>
                <c:pt idx="121">
                  <c:v>9.9400000000000002E-2</c:v>
                </c:pt>
                <c:pt idx="122">
                  <c:v>9.98E-2</c:v>
                </c:pt>
                <c:pt idx="123">
                  <c:v>0.1002</c:v>
                </c:pt>
                <c:pt idx="124">
                  <c:v>0.10061666666666665</c:v>
                </c:pt>
                <c:pt idx="125">
                  <c:v>0.1009166666666667</c:v>
                </c:pt>
                <c:pt idx="126">
                  <c:v>0.10125000000000001</c:v>
                </c:pt>
                <c:pt idx="127">
                  <c:v>0.10155000000000002</c:v>
                </c:pt>
                <c:pt idx="128">
                  <c:v>0.10183333333333333</c:v>
                </c:pt>
                <c:pt idx="129">
                  <c:v>0.10210000000000001</c:v>
                </c:pt>
                <c:pt idx="130">
                  <c:v>0.10236666666666666</c:v>
                </c:pt>
                <c:pt idx="131">
                  <c:v>0.10261666666666669</c:v>
                </c:pt>
                <c:pt idx="132">
                  <c:v>0.1028</c:v>
                </c:pt>
                <c:pt idx="133">
                  <c:v>0.10306666666666665</c:v>
                </c:pt>
                <c:pt idx="134">
                  <c:v>0.10318333333333335</c:v>
                </c:pt>
                <c:pt idx="135">
                  <c:v>0.10333333333333333</c:v>
                </c:pt>
                <c:pt idx="136">
                  <c:v>0.10350000000000002</c:v>
                </c:pt>
                <c:pt idx="137">
                  <c:v>0.10358333333333335</c:v>
                </c:pt>
                <c:pt idx="138">
                  <c:v>0.1037</c:v>
                </c:pt>
                <c:pt idx="139">
                  <c:v>0.10371666666666668</c:v>
                </c:pt>
                <c:pt idx="140">
                  <c:v>0.10376666666666667</c:v>
                </c:pt>
                <c:pt idx="141">
                  <c:v>0.10385000000000001</c:v>
                </c:pt>
                <c:pt idx="142">
                  <c:v>0.10388333333333334</c:v>
                </c:pt>
                <c:pt idx="143">
                  <c:v>0.10391666666666667</c:v>
                </c:pt>
                <c:pt idx="144">
                  <c:v>0.10390000000000001</c:v>
                </c:pt>
                <c:pt idx="145">
                  <c:v>0.10385000000000001</c:v>
                </c:pt>
                <c:pt idx="146">
                  <c:v>0.1038</c:v>
                </c:pt>
                <c:pt idx="147">
                  <c:v>0.10371666666666667</c:v>
                </c:pt>
                <c:pt idx="148">
                  <c:v>0.10366666666666664</c:v>
                </c:pt>
                <c:pt idx="149">
                  <c:v>0.10354999999999999</c:v>
                </c:pt>
                <c:pt idx="150">
                  <c:v>0.10345</c:v>
                </c:pt>
                <c:pt idx="151">
                  <c:v>0.10335</c:v>
                </c:pt>
                <c:pt idx="152">
                  <c:v>0.10321666666666668</c:v>
                </c:pt>
                <c:pt idx="153">
                  <c:v>0.10306666666666668</c:v>
                </c:pt>
                <c:pt idx="154">
                  <c:v>0.10288333333333333</c:v>
                </c:pt>
                <c:pt idx="155">
                  <c:v>0.10276666666666666</c:v>
                </c:pt>
                <c:pt idx="156">
                  <c:v>0.10260000000000001</c:v>
                </c:pt>
                <c:pt idx="157">
                  <c:v>0.10246666666666666</c:v>
                </c:pt>
                <c:pt idx="158">
                  <c:v>0.10231666666666667</c:v>
                </c:pt>
                <c:pt idx="159">
                  <c:v>0.10210000000000001</c:v>
                </c:pt>
                <c:pt idx="160">
                  <c:v>0.1019</c:v>
                </c:pt>
                <c:pt idx="161">
                  <c:v>0.10171666666666668</c:v>
                </c:pt>
                <c:pt idx="162">
                  <c:v>0.10148333333333333</c:v>
                </c:pt>
                <c:pt idx="163">
                  <c:v>0.10128333333333335</c:v>
                </c:pt>
                <c:pt idx="164">
                  <c:v>0.10103333333333332</c:v>
                </c:pt>
                <c:pt idx="165">
                  <c:v>0.10089999999999999</c:v>
                </c:pt>
                <c:pt idx="166">
                  <c:v>0.10068333333333333</c:v>
                </c:pt>
                <c:pt idx="167">
                  <c:v>0.10051666666666666</c:v>
                </c:pt>
                <c:pt idx="168">
                  <c:v>0.10038333333333332</c:v>
                </c:pt>
                <c:pt idx="169">
                  <c:v>0.10023333333333334</c:v>
                </c:pt>
                <c:pt idx="170">
                  <c:v>9.9983333333333327E-2</c:v>
                </c:pt>
                <c:pt idx="171">
                  <c:v>9.976666666666667E-2</c:v>
                </c:pt>
                <c:pt idx="172">
                  <c:v>9.9616666666666687E-2</c:v>
                </c:pt>
                <c:pt idx="173">
                  <c:v>9.9416666666666667E-2</c:v>
                </c:pt>
                <c:pt idx="174">
                  <c:v>9.9233333333333326E-2</c:v>
                </c:pt>
                <c:pt idx="175">
                  <c:v>9.906666666666665E-2</c:v>
                </c:pt>
                <c:pt idx="176">
                  <c:v>9.8916666666666653E-2</c:v>
                </c:pt>
                <c:pt idx="177">
                  <c:v>9.873333333333334E-2</c:v>
                </c:pt>
                <c:pt idx="178">
                  <c:v>9.8583333333333342E-2</c:v>
                </c:pt>
                <c:pt idx="179">
                  <c:v>9.8483333333333326E-2</c:v>
                </c:pt>
                <c:pt idx="180">
                  <c:v>9.8383333333333323E-2</c:v>
                </c:pt>
                <c:pt idx="181">
                  <c:v>9.8250000000000004E-2</c:v>
                </c:pt>
                <c:pt idx="182">
                  <c:v>9.8166666666666666E-2</c:v>
                </c:pt>
                <c:pt idx="183">
                  <c:v>9.8083333333333342E-2</c:v>
                </c:pt>
                <c:pt idx="184">
                  <c:v>9.7983333333333353E-2</c:v>
                </c:pt>
                <c:pt idx="185">
                  <c:v>9.7866666666666671E-2</c:v>
                </c:pt>
                <c:pt idx="186">
                  <c:v>9.7800000000000012E-2</c:v>
                </c:pt>
                <c:pt idx="187">
                  <c:v>9.7700000000000009E-2</c:v>
                </c:pt>
                <c:pt idx="188">
                  <c:v>9.7666666666666679E-2</c:v>
                </c:pt>
                <c:pt idx="189">
                  <c:v>9.7666666666666666E-2</c:v>
                </c:pt>
                <c:pt idx="190">
                  <c:v>9.7650000000000001E-2</c:v>
                </c:pt>
                <c:pt idx="191">
                  <c:v>9.7633333333333336E-2</c:v>
                </c:pt>
                <c:pt idx="192">
                  <c:v>9.7666666666666666E-2</c:v>
                </c:pt>
                <c:pt idx="193">
                  <c:v>9.768333333333333E-2</c:v>
                </c:pt>
                <c:pt idx="194">
                  <c:v>9.7699999999999995E-2</c:v>
                </c:pt>
                <c:pt idx="195">
                  <c:v>9.7766666666666655E-2</c:v>
                </c:pt>
                <c:pt idx="196">
                  <c:v>9.7833333333333328E-2</c:v>
                </c:pt>
                <c:pt idx="197">
                  <c:v>9.7866666666666699E-2</c:v>
                </c:pt>
                <c:pt idx="198">
                  <c:v>9.7983333333333353E-2</c:v>
                </c:pt>
                <c:pt idx="199">
                  <c:v>9.8100000000000007E-2</c:v>
                </c:pt>
                <c:pt idx="200">
                  <c:v>9.8199999999999996E-2</c:v>
                </c:pt>
                <c:pt idx="201">
                  <c:v>9.8299999999999998E-2</c:v>
                </c:pt>
                <c:pt idx="202">
                  <c:v>9.853333333333332E-2</c:v>
                </c:pt>
                <c:pt idx="203">
                  <c:v>9.8650000000000002E-2</c:v>
                </c:pt>
                <c:pt idx="204">
                  <c:v>9.8783333333333334E-2</c:v>
                </c:pt>
                <c:pt idx="205">
                  <c:v>9.8983333333333354E-2</c:v>
                </c:pt>
                <c:pt idx="206">
                  <c:v>9.9133333333333337E-2</c:v>
                </c:pt>
                <c:pt idx="207">
                  <c:v>9.9383333333333324E-2</c:v>
                </c:pt>
                <c:pt idx="208">
                  <c:v>9.9650000000000002E-2</c:v>
                </c:pt>
                <c:pt idx="209">
                  <c:v>9.9933333333333332E-2</c:v>
                </c:pt>
                <c:pt idx="210">
                  <c:v>0.1002</c:v>
                </c:pt>
                <c:pt idx="211">
                  <c:v>0.10048333333333336</c:v>
                </c:pt>
                <c:pt idx="212">
                  <c:v>0.10073333333333334</c:v>
                </c:pt>
                <c:pt idx="213">
                  <c:v>0.10108333333333334</c:v>
                </c:pt>
                <c:pt idx="214">
                  <c:v>0.10143333333333332</c:v>
                </c:pt>
                <c:pt idx="215">
                  <c:v>0.10181666666666667</c:v>
                </c:pt>
                <c:pt idx="216">
                  <c:v>0.10218333333333333</c:v>
                </c:pt>
                <c:pt idx="217">
                  <c:v>0.10251666666666666</c:v>
                </c:pt>
                <c:pt idx="218">
                  <c:v>0.10291666666666667</c:v>
                </c:pt>
                <c:pt idx="219">
                  <c:v>0.10333333333333333</c:v>
                </c:pt>
                <c:pt idx="220">
                  <c:v>0.10371666666666668</c:v>
                </c:pt>
                <c:pt idx="221">
                  <c:v>0.1042</c:v>
                </c:pt>
                <c:pt idx="222">
                  <c:v>0.10459999999999998</c:v>
                </c:pt>
                <c:pt idx="223">
                  <c:v>0.10503333333333333</c:v>
                </c:pt>
                <c:pt idx="224">
                  <c:v>0.10546666666666667</c:v>
                </c:pt>
                <c:pt idx="225">
                  <c:v>0.10596666666666665</c:v>
                </c:pt>
                <c:pt idx="226">
                  <c:v>0.10643333333333334</c:v>
                </c:pt>
                <c:pt idx="227">
                  <c:v>0.10691666666666666</c:v>
                </c:pt>
                <c:pt idx="228">
                  <c:v>0.10751666666666669</c:v>
                </c:pt>
                <c:pt idx="229">
                  <c:v>0.10801666666666666</c:v>
                </c:pt>
                <c:pt idx="230">
                  <c:v>0.10863333333333335</c:v>
                </c:pt>
                <c:pt idx="231">
                  <c:v>0.10923333333333334</c:v>
                </c:pt>
                <c:pt idx="232">
                  <c:v>0.10981666666666666</c:v>
                </c:pt>
                <c:pt idx="233">
                  <c:v>0.11041666666666666</c:v>
                </c:pt>
                <c:pt idx="234">
                  <c:v>0.111</c:v>
                </c:pt>
                <c:pt idx="235">
                  <c:v>0.11158333333333333</c:v>
                </c:pt>
                <c:pt idx="236">
                  <c:v>0.11221666666666667</c:v>
                </c:pt>
                <c:pt idx="237">
                  <c:v>0.11283333333333334</c:v>
                </c:pt>
                <c:pt idx="238">
                  <c:v>0.11349999999999999</c:v>
                </c:pt>
                <c:pt idx="239">
                  <c:v>0.11413333333333335</c:v>
                </c:pt>
                <c:pt idx="240">
                  <c:v>0.11473333333333334</c:v>
                </c:pt>
                <c:pt idx="241">
                  <c:v>0.11536666666666666</c:v>
                </c:pt>
                <c:pt idx="242">
                  <c:v>0.11596666666666668</c:v>
                </c:pt>
                <c:pt idx="243">
                  <c:v>0.11663333333333332</c:v>
                </c:pt>
                <c:pt idx="244">
                  <c:v>0.11728333333333334</c:v>
                </c:pt>
                <c:pt idx="245">
                  <c:v>0.11793333333333333</c:v>
                </c:pt>
                <c:pt idx="246">
                  <c:v>0.11861666666666669</c:v>
                </c:pt>
                <c:pt idx="247">
                  <c:v>0.11931666666666667</c:v>
                </c:pt>
                <c:pt idx="248">
                  <c:v>0.11998333333333332</c:v>
                </c:pt>
                <c:pt idx="249">
                  <c:v>0.12061666666666666</c:v>
                </c:pt>
                <c:pt idx="250">
                  <c:v>0.12125000000000001</c:v>
                </c:pt>
                <c:pt idx="251">
                  <c:v>0.12195</c:v>
                </c:pt>
                <c:pt idx="252">
                  <c:v>0.12259999999999999</c:v>
                </c:pt>
                <c:pt idx="253">
                  <c:v>0.12328333333333334</c:v>
                </c:pt>
                <c:pt idx="254">
                  <c:v>0.124</c:v>
                </c:pt>
                <c:pt idx="255">
                  <c:v>0.12469999999999999</c:v>
                </c:pt>
                <c:pt idx="256">
                  <c:v>0.12538333333333335</c:v>
                </c:pt>
                <c:pt idx="257">
                  <c:v>0.12603333333333333</c:v>
                </c:pt>
                <c:pt idx="258">
                  <c:v>0.12668333333333334</c:v>
                </c:pt>
                <c:pt idx="259">
                  <c:v>0.1273</c:v>
                </c:pt>
                <c:pt idx="260">
                  <c:v>0.12796666666666667</c:v>
                </c:pt>
                <c:pt idx="261">
                  <c:v>0.12856666666666666</c:v>
                </c:pt>
                <c:pt idx="262">
                  <c:v>0.12918333333333334</c:v>
                </c:pt>
                <c:pt idx="263">
                  <c:v>0.12984999999999999</c:v>
                </c:pt>
                <c:pt idx="264">
                  <c:v>0.13046666666666668</c:v>
                </c:pt>
                <c:pt idx="265">
                  <c:v>0.13109999999999999</c:v>
                </c:pt>
                <c:pt idx="266">
                  <c:v>0.13168333333333335</c:v>
                </c:pt>
                <c:pt idx="267">
                  <c:v>0.13228333333333334</c:v>
                </c:pt>
                <c:pt idx="268">
                  <c:v>0.13283333333333333</c:v>
                </c:pt>
                <c:pt idx="269">
                  <c:v>0.13338333333333333</c:v>
                </c:pt>
                <c:pt idx="270">
                  <c:v>0.13395000000000001</c:v>
                </c:pt>
                <c:pt idx="271">
                  <c:v>0.13444999999999999</c:v>
                </c:pt>
                <c:pt idx="272">
                  <c:v>0.13503333333333334</c:v>
                </c:pt>
                <c:pt idx="273">
                  <c:v>0.13554999999999998</c:v>
                </c:pt>
                <c:pt idx="274">
                  <c:v>0.13606666666666667</c:v>
                </c:pt>
                <c:pt idx="275">
                  <c:v>0.13653333333333334</c:v>
                </c:pt>
                <c:pt idx="276">
                  <c:v>0.13704999999999998</c:v>
                </c:pt>
                <c:pt idx="277">
                  <c:v>0.13753333333333331</c:v>
                </c:pt>
                <c:pt idx="278">
                  <c:v>0.13795000000000002</c:v>
                </c:pt>
                <c:pt idx="279">
                  <c:v>0.1384</c:v>
                </c:pt>
                <c:pt idx="280">
                  <c:v>0.13878333333333334</c:v>
                </c:pt>
                <c:pt idx="281">
                  <c:v>0.13918333333333335</c:v>
                </c:pt>
                <c:pt idx="282">
                  <c:v>0.13956666666666667</c:v>
                </c:pt>
                <c:pt idx="283">
                  <c:v>0.13999999999999999</c:v>
                </c:pt>
                <c:pt idx="284">
                  <c:v>0.14028333333333334</c:v>
                </c:pt>
                <c:pt idx="285">
                  <c:v>0.1406166666666667</c:v>
                </c:pt>
                <c:pt idx="286">
                  <c:v>0.1409</c:v>
                </c:pt>
                <c:pt idx="287">
                  <c:v>0.14118333333333333</c:v>
                </c:pt>
                <c:pt idx="288">
                  <c:v>0.14148333333333332</c:v>
                </c:pt>
                <c:pt idx="289">
                  <c:v>0.14176666666666668</c:v>
                </c:pt>
                <c:pt idx="290">
                  <c:v>0.14200000000000002</c:v>
                </c:pt>
                <c:pt idx="291">
                  <c:v>0.14225000000000002</c:v>
                </c:pt>
                <c:pt idx="292">
                  <c:v>0.14246666666666666</c:v>
                </c:pt>
                <c:pt idx="293">
                  <c:v>0.14263333333333333</c:v>
                </c:pt>
                <c:pt idx="294">
                  <c:v>0.14276666666666665</c:v>
                </c:pt>
                <c:pt idx="295">
                  <c:v>0.14294999999999999</c:v>
                </c:pt>
                <c:pt idx="296">
                  <c:v>0.14308333333333334</c:v>
                </c:pt>
                <c:pt idx="297">
                  <c:v>0.14321666666666666</c:v>
                </c:pt>
                <c:pt idx="298">
                  <c:v>0.14326666666666668</c:v>
                </c:pt>
                <c:pt idx="299">
                  <c:v>0.14330000000000001</c:v>
                </c:pt>
                <c:pt idx="300">
                  <c:v>0.14333333333333334</c:v>
                </c:pt>
                <c:pt idx="301">
                  <c:v>0.1434</c:v>
                </c:pt>
                <c:pt idx="302">
                  <c:v>0.14338333333333333</c:v>
                </c:pt>
                <c:pt idx="303">
                  <c:v>0.14341666666666666</c:v>
                </c:pt>
                <c:pt idx="304">
                  <c:v>0.1434</c:v>
                </c:pt>
                <c:pt idx="305">
                  <c:v>0.14335000000000001</c:v>
                </c:pt>
                <c:pt idx="306">
                  <c:v>0.14333333333333334</c:v>
                </c:pt>
                <c:pt idx="307">
                  <c:v>0.14323333333333335</c:v>
                </c:pt>
                <c:pt idx="308">
                  <c:v>0.14313333333333333</c:v>
                </c:pt>
                <c:pt idx="309">
                  <c:v>0.14301666666666665</c:v>
                </c:pt>
                <c:pt idx="310">
                  <c:v>0.1429</c:v>
                </c:pt>
                <c:pt idx="311">
                  <c:v>0.14276666666666665</c:v>
                </c:pt>
                <c:pt idx="312">
                  <c:v>0.14261666666666667</c:v>
                </c:pt>
                <c:pt idx="313">
                  <c:v>0.14248333333333332</c:v>
                </c:pt>
                <c:pt idx="314">
                  <c:v>0.14225000000000002</c:v>
                </c:pt>
                <c:pt idx="315">
                  <c:v>0.14206666666666667</c:v>
                </c:pt>
                <c:pt idx="316">
                  <c:v>0.14181666666666667</c:v>
                </c:pt>
                <c:pt idx="317">
                  <c:v>0.14155000000000001</c:v>
                </c:pt>
                <c:pt idx="318">
                  <c:v>0.14131666666666667</c:v>
                </c:pt>
                <c:pt idx="319">
                  <c:v>0.1410666666666667</c:v>
                </c:pt>
                <c:pt idx="320">
                  <c:v>0.14076666666666668</c:v>
                </c:pt>
                <c:pt idx="321">
                  <c:v>0.14048333333333332</c:v>
                </c:pt>
                <c:pt idx="322">
                  <c:v>0.14018333333333335</c:v>
                </c:pt>
                <c:pt idx="323">
                  <c:v>0.13988333333333336</c:v>
                </c:pt>
                <c:pt idx="324">
                  <c:v>0.13953333333333331</c:v>
                </c:pt>
                <c:pt idx="325">
                  <c:v>0.13919999999999999</c:v>
                </c:pt>
                <c:pt idx="326">
                  <c:v>0.13886666666666667</c:v>
                </c:pt>
                <c:pt idx="327">
                  <c:v>0.13858333333333334</c:v>
                </c:pt>
                <c:pt idx="328">
                  <c:v>0.13819999999999999</c:v>
                </c:pt>
                <c:pt idx="329">
                  <c:v>0.13783333333333334</c:v>
                </c:pt>
                <c:pt idx="330">
                  <c:v>0.1375166666666667</c:v>
                </c:pt>
                <c:pt idx="331">
                  <c:v>0.13711666666666666</c:v>
                </c:pt>
                <c:pt idx="332">
                  <c:v>0.1368</c:v>
                </c:pt>
                <c:pt idx="333">
                  <c:v>0.13641666666666666</c:v>
                </c:pt>
                <c:pt idx="334">
                  <c:v>0.13598333333333334</c:v>
                </c:pt>
                <c:pt idx="335">
                  <c:v>0.13565000000000002</c:v>
                </c:pt>
                <c:pt idx="336">
                  <c:v>0.13523333333333334</c:v>
                </c:pt>
                <c:pt idx="337">
                  <c:v>0.13478333333333334</c:v>
                </c:pt>
                <c:pt idx="338">
                  <c:v>0.13438333333333333</c:v>
                </c:pt>
                <c:pt idx="339">
                  <c:v>0.13393333333333332</c:v>
                </c:pt>
                <c:pt idx="340">
                  <c:v>0.13356666666666667</c:v>
                </c:pt>
                <c:pt idx="341">
                  <c:v>0.13313333333333333</c:v>
                </c:pt>
                <c:pt idx="342">
                  <c:v>0.13271666666666665</c:v>
                </c:pt>
                <c:pt idx="343">
                  <c:v>0.1323</c:v>
                </c:pt>
                <c:pt idx="344">
                  <c:v>0.13193333333333335</c:v>
                </c:pt>
                <c:pt idx="345">
                  <c:v>0.13156666666666669</c:v>
                </c:pt>
                <c:pt idx="346">
                  <c:v>0.13118333333333335</c:v>
                </c:pt>
                <c:pt idx="347">
                  <c:v>0.13081666666666666</c:v>
                </c:pt>
                <c:pt idx="348">
                  <c:v>0.13041666666666665</c:v>
                </c:pt>
                <c:pt idx="349">
                  <c:v>0.13006666666666666</c:v>
                </c:pt>
                <c:pt idx="350">
                  <c:v>0.12971666666666667</c:v>
                </c:pt>
                <c:pt idx="351">
                  <c:v>0.12931666666666666</c:v>
                </c:pt>
                <c:pt idx="352">
                  <c:v>0.12898333333333334</c:v>
                </c:pt>
                <c:pt idx="353">
                  <c:v>0.12868333333333334</c:v>
                </c:pt>
                <c:pt idx="354">
                  <c:v>0.12833333333333333</c:v>
                </c:pt>
                <c:pt idx="355">
                  <c:v>0.12803333333333336</c:v>
                </c:pt>
                <c:pt idx="356">
                  <c:v>0.12768333333333334</c:v>
                </c:pt>
                <c:pt idx="357">
                  <c:v>0.12735000000000002</c:v>
                </c:pt>
                <c:pt idx="358">
                  <c:v>0.12703333333333333</c:v>
                </c:pt>
                <c:pt idx="359">
                  <c:v>0.12673333333333334</c:v>
                </c:pt>
                <c:pt idx="360">
                  <c:v>0.12648333333333331</c:v>
                </c:pt>
                <c:pt idx="361">
                  <c:v>0.12618333333333334</c:v>
                </c:pt>
                <c:pt idx="362">
                  <c:v>0.12593333333333334</c:v>
                </c:pt>
                <c:pt idx="363">
                  <c:v>0.12568333333333334</c:v>
                </c:pt>
                <c:pt idx="364">
                  <c:v>0.12538333333333332</c:v>
                </c:pt>
                <c:pt idx="365">
                  <c:v>0.12511666666666665</c:v>
                </c:pt>
                <c:pt idx="366">
                  <c:v>0.12486666666666667</c:v>
                </c:pt>
                <c:pt idx="367">
                  <c:v>0.12469999999999999</c:v>
                </c:pt>
                <c:pt idx="368">
                  <c:v>0.12446666666666667</c:v>
                </c:pt>
                <c:pt idx="369">
                  <c:v>0.12424999999999999</c:v>
                </c:pt>
                <c:pt idx="370">
                  <c:v>0.12406666666666667</c:v>
                </c:pt>
                <c:pt idx="371">
                  <c:v>0.12391666666666666</c:v>
                </c:pt>
                <c:pt idx="372">
                  <c:v>0.12378333333333334</c:v>
                </c:pt>
                <c:pt idx="373">
                  <c:v>0.1236</c:v>
                </c:pt>
                <c:pt idx="374">
                  <c:v>0.12351666666666666</c:v>
                </c:pt>
                <c:pt idx="375">
                  <c:v>0.12340000000000001</c:v>
                </c:pt>
                <c:pt idx="376">
                  <c:v>0.12325000000000001</c:v>
                </c:pt>
                <c:pt idx="377">
                  <c:v>0.12313333333333333</c:v>
                </c:pt>
                <c:pt idx="378">
                  <c:v>0.12295</c:v>
                </c:pt>
                <c:pt idx="379">
                  <c:v>0.12286666666666668</c:v>
                </c:pt>
                <c:pt idx="380">
                  <c:v>0.12274999999999998</c:v>
                </c:pt>
                <c:pt idx="381">
                  <c:v>0.12265</c:v>
                </c:pt>
                <c:pt idx="382">
                  <c:v>0.12261666666666667</c:v>
                </c:pt>
                <c:pt idx="383">
                  <c:v>0.12255000000000001</c:v>
                </c:pt>
                <c:pt idx="384">
                  <c:v>0.12250000000000001</c:v>
                </c:pt>
                <c:pt idx="385">
                  <c:v>0.12246666666666668</c:v>
                </c:pt>
                <c:pt idx="386">
                  <c:v>0.12241666666666666</c:v>
                </c:pt>
                <c:pt idx="387">
                  <c:v>0.12235</c:v>
                </c:pt>
                <c:pt idx="388">
                  <c:v>0.12233333333333334</c:v>
                </c:pt>
                <c:pt idx="389">
                  <c:v>0.12230000000000001</c:v>
                </c:pt>
                <c:pt idx="390">
                  <c:v>0.12228333333333334</c:v>
                </c:pt>
                <c:pt idx="391">
                  <c:v>0.12231666666666667</c:v>
                </c:pt>
                <c:pt idx="392">
                  <c:v>0.12231666666666667</c:v>
                </c:pt>
                <c:pt idx="393">
                  <c:v>0.12228333333333334</c:v>
                </c:pt>
                <c:pt idx="394">
                  <c:v>0.12226666666666668</c:v>
                </c:pt>
                <c:pt idx="395">
                  <c:v>0.12228333333333334</c:v>
                </c:pt>
                <c:pt idx="396">
                  <c:v>0.12228333333333334</c:v>
                </c:pt>
                <c:pt idx="397">
                  <c:v>0.12228333333333334</c:v>
                </c:pt>
                <c:pt idx="398">
                  <c:v>0.12228333333333334</c:v>
                </c:pt>
                <c:pt idx="399">
                  <c:v>0.12230000000000001</c:v>
                </c:pt>
                <c:pt idx="400">
                  <c:v>0.12230000000000001</c:v>
                </c:pt>
                <c:pt idx="401">
                  <c:v>0.12235</c:v>
                </c:pt>
                <c:pt idx="402">
                  <c:v>0.12236666666666667</c:v>
                </c:pt>
                <c:pt idx="403">
                  <c:v>0.12236666666666667</c:v>
                </c:pt>
                <c:pt idx="404">
                  <c:v>0.12231666666666667</c:v>
                </c:pt>
                <c:pt idx="405">
                  <c:v>0.12231666666666667</c:v>
                </c:pt>
                <c:pt idx="406">
                  <c:v>0.12233333333333334</c:v>
                </c:pt>
                <c:pt idx="407">
                  <c:v>0.12230000000000001</c:v>
                </c:pt>
                <c:pt idx="408">
                  <c:v>0.12230000000000001</c:v>
                </c:pt>
                <c:pt idx="409">
                  <c:v>0.12231666666666667</c:v>
                </c:pt>
                <c:pt idx="410">
                  <c:v>0.12233333333333334</c:v>
                </c:pt>
                <c:pt idx="411">
                  <c:v>0.12235</c:v>
                </c:pt>
                <c:pt idx="412">
                  <c:v>0.12228333333333334</c:v>
                </c:pt>
                <c:pt idx="413">
                  <c:v>0.12231666666666667</c:v>
                </c:pt>
                <c:pt idx="414">
                  <c:v>0.12223333333333335</c:v>
                </c:pt>
                <c:pt idx="415">
                  <c:v>0.12225000000000001</c:v>
                </c:pt>
                <c:pt idx="416">
                  <c:v>0.12220000000000002</c:v>
                </c:pt>
                <c:pt idx="417">
                  <c:v>0.12213333333333336</c:v>
                </c:pt>
                <c:pt idx="418">
                  <c:v>0.12210000000000003</c:v>
                </c:pt>
                <c:pt idx="419">
                  <c:v>0.12210000000000003</c:v>
                </c:pt>
                <c:pt idx="420">
                  <c:v>0.12205000000000001</c:v>
                </c:pt>
                <c:pt idx="421">
                  <c:v>0.12201666666666668</c:v>
                </c:pt>
                <c:pt idx="422">
                  <c:v>0.12193333333333334</c:v>
                </c:pt>
                <c:pt idx="423">
                  <c:v>0.12188333333333334</c:v>
                </c:pt>
                <c:pt idx="424">
                  <c:v>0.12185</c:v>
                </c:pt>
                <c:pt idx="425">
                  <c:v>0.12185</c:v>
                </c:pt>
                <c:pt idx="426">
                  <c:v>0.12174999999999998</c:v>
                </c:pt>
                <c:pt idx="427">
                  <c:v>0.12173333333333332</c:v>
                </c:pt>
                <c:pt idx="428">
                  <c:v>0.12163333333333332</c:v>
                </c:pt>
                <c:pt idx="429">
                  <c:v>0.12154999999999999</c:v>
                </c:pt>
                <c:pt idx="430">
                  <c:v>0.12148333333333333</c:v>
                </c:pt>
                <c:pt idx="431">
                  <c:v>0.12140000000000001</c:v>
                </c:pt>
                <c:pt idx="432">
                  <c:v>0.12131666666666668</c:v>
                </c:pt>
                <c:pt idx="433">
                  <c:v>0.12125000000000001</c:v>
                </c:pt>
                <c:pt idx="434">
                  <c:v>0.12116666666666669</c:v>
                </c:pt>
                <c:pt idx="435">
                  <c:v>0.12100000000000001</c:v>
                </c:pt>
                <c:pt idx="436">
                  <c:v>0.12090000000000001</c:v>
                </c:pt>
                <c:pt idx="437">
                  <c:v>0.12081666666666668</c:v>
                </c:pt>
                <c:pt idx="438">
                  <c:v>0.12071666666666668</c:v>
                </c:pt>
                <c:pt idx="439">
                  <c:v>0.12059999999999998</c:v>
                </c:pt>
                <c:pt idx="440">
                  <c:v>0.12051666666666666</c:v>
                </c:pt>
                <c:pt idx="441">
                  <c:v>0.12039999999999999</c:v>
                </c:pt>
                <c:pt idx="442">
                  <c:v>0.12021666666666665</c:v>
                </c:pt>
                <c:pt idx="443">
                  <c:v>0.12006666666666667</c:v>
                </c:pt>
                <c:pt idx="444">
                  <c:v>0.11993333333333334</c:v>
                </c:pt>
                <c:pt idx="445">
                  <c:v>0.11981666666666668</c:v>
                </c:pt>
                <c:pt idx="446">
                  <c:v>0.11968333333333335</c:v>
                </c:pt>
                <c:pt idx="447">
                  <c:v>0.11943333333333334</c:v>
                </c:pt>
                <c:pt idx="448">
                  <c:v>0.11928333333333334</c:v>
                </c:pt>
                <c:pt idx="449">
                  <c:v>0.11906666666666665</c:v>
                </c:pt>
                <c:pt idx="450">
                  <c:v>0.11883333333333335</c:v>
                </c:pt>
                <c:pt idx="451">
                  <c:v>0.11866666666666666</c:v>
                </c:pt>
                <c:pt idx="452">
                  <c:v>0.11846666666666666</c:v>
                </c:pt>
                <c:pt idx="453">
                  <c:v>0.11823333333333332</c:v>
                </c:pt>
                <c:pt idx="454">
                  <c:v>0.11791666666666666</c:v>
                </c:pt>
                <c:pt idx="455">
                  <c:v>0.11763333333333333</c:v>
                </c:pt>
                <c:pt idx="456">
                  <c:v>0.11735000000000001</c:v>
                </c:pt>
                <c:pt idx="457">
                  <c:v>0.11708333333333333</c:v>
                </c:pt>
                <c:pt idx="458">
                  <c:v>0.11668333333333332</c:v>
                </c:pt>
                <c:pt idx="459">
                  <c:v>0.11633333333333334</c:v>
                </c:pt>
                <c:pt idx="460">
                  <c:v>0.11591666666666667</c:v>
                </c:pt>
                <c:pt idx="461">
                  <c:v>0.11554999999999999</c:v>
                </c:pt>
                <c:pt idx="462">
                  <c:v>0.11516666666666668</c:v>
                </c:pt>
                <c:pt idx="463">
                  <c:v>0.11471666666666668</c:v>
                </c:pt>
                <c:pt idx="464">
                  <c:v>0.11431666666666666</c:v>
                </c:pt>
                <c:pt idx="465">
                  <c:v>0.1139</c:v>
                </c:pt>
                <c:pt idx="466">
                  <c:v>0.11348333333333332</c:v>
                </c:pt>
                <c:pt idx="467">
                  <c:v>0.11311666666666666</c:v>
                </c:pt>
                <c:pt idx="468">
                  <c:v>0.11268333333333334</c:v>
                </c:pt>
                <c:pt idx="469">
                  <c:v>0.11228333333333333</c:v>
                </c:pt>
                <c:pt idx="470">
                  <c:v>0.11188333333333333</c:v>
                </c:pt>
                <c:pt idx="471">
                  <c:v>0.1115</c:v>
                </c:pt>
                <c:pt idx="472">
                  <c:v>0.11111666666666668</c:v>
                </c:pt>
                <c:pt idx="473">
                  <c:v>0.11076666666666667</c:v>
                </c:pt>
                <c:pt idx="474">
                  <c:v>0.11036666666666667</c:v>
                </c:pt>
                <c:pt idx="475">
                  <c:v>0.10996666666666667</c:v>
                </c:pt>
                <c:pt idx="476">
                  <c:v>0.10963333333333332</c:v>
                </c:pt>
                <c:pt idx="477">
                  <c:v>0.10928333333333333</c:v>
                </c:pt>
                <c:pt idx="478">
                  <c:v>0.10895000000000001</c:v>
                </c:pt>
                <c:pt idx="479">
                  <c:v>0.10866666666666668</c:v>
                </c:pt>
                <c:pt idx="480">
                  <c:v>0.10823333333333333</c:v>
                </c:pt>
                <c:pt idx="481">
                  <c:v>0.10798333333333332</c:v>
                </c:pt>
                <c:pt idx="482">
                  <c:v>0.10761666666666668</c:v>
                </c:pt>
                <c:pt idx="483">
                  <c:v>0.10731666666666667</c:v>
                </c:pt>
                <c:pt idx="484">
                  <c:v>0.10708333333333335</c:v>
                </c:pt>
                <c:pt idx="485">
                  <c:v>0.10673333333333333</c:v>
                </c:pt>
                <c:pt idx="486">
                  <c:v>0.10645</c:v>
                </c:pt>
                <c:pt idx="487">
                  <c:v>0.10615000000000001</c:v>
                </c:pt>
                <c:pt idx="488">
                  <c:v>0.10581666666666667</c:v>
                </c:pt>
                <c:pt idx="489">
                  <c:v>0.10554999999999999</c:v>
                </c:pt>
                <c:pt idx="490">
                  <c:v>0.10528333333333334</c:v>
                </c:pt>
                <c:pt idx="491">
                  <c:v>0.10498333333333333</c:v>
                </c:pt>
                <c:pt idx="492">
                  <c:v>0.1047</c:v>
                </c:pt>
                <c:pt idx="493">
                  <c:v>0.10443333333333334</c:v>
                </c:pt>
                <c:pt idx="494">
                  <c:v>0.10413333333333336</c:v>
                </c:pt>
                <c:pt idx="495">
                  <c:v>0.10388333333333333</c:v>
                </c:pt>
                <c:pt idx="496">
                  <c:v>0.10354999999999999</c:v>
                </c:pt>
                <c:pt idx="497">
                  <c:v>0.10329999999999999</c:v>
                </c:pt>
                <c:pt idx="498">
                  <c:v>0.10304999999999999</c:v>
                </c:pt>
                <c:pt idx="499">
                  <c:v>0.10283333333333333</c:v>
                </c:pt>
                <c:pt idx="500">
                  <c:v>0.10254999999999999</c:v>
                </c:pt>
                <c:pt idx="501">
                  <c:v>0.10233333333333333</c:v>
                </c:pt>
                <c:pt idx="502">
                  <c:v>0.10213333333333334</c:v>
                </c:pt>
                <c:pt idx="503">
                  <c:v>0.10188333333333334</c:v>
                </c:pt>
                <c:pt idx="504">
                  <c:v>0.10158333333333336</c:v>
                </c:pt>
                <c:pt idx="505">
                  <c:v>0.10136666666666666</c:v>
                </c:pt>
                <c:pt idx="506">
                  <c:v>0.10111666666666665</c:v>
                </c:pt>
                <c:pt idx="507">
                  <c:v>0.10096666666666666</c:v>
                </c:pt>
                <c:pt idx="508">
                  <c:v>0.10085000000000001</c:v>
                </c:pt>
                <c:pt idx="509">
                  <c:v>0.10060000000000001</c:v>
                </c:pt>
                <c:pt idx="510">
                  <c:v>0.1004</c:v>
                </c:pt>
                <c:pt idx="511">
                  <c:v>0.10020000000000001</c:v>
                </c:pt>
                <c:pt idx="512">
                  <c:v>9.9949999999999997E-2</c:v>
                </c:pt>
                <c:pt idx="513">
                  <c:v>9.9783333333333335E-2</c:v>
                </c:pt>
                <c:pt idx="514">
                  <c:v>9.9566666666666651E-2</c:v>
                </c:pt>
                <c:pt idx="515">
                  <c:v>9.9333333333333329E-2</c:v>
                </c:pt>
                <c:pt idx="516">
                  <c:v>9.9183333333333332E-2</c:v>
                </c:pt>
                <c:pt idx="517">
                  <c:v>9.8966666666666689E-2</c:v>
                </c:pt>
                <c:pt idx="518">
                  <c:v>9.8750000000000004E-2</c:v>
                </c:pt>
                <c:pt idx="519">
                  <c:v>9.8516666666666683E-2</c:v>
                </c:pt>
                <c:pt idx="520">
                  <c:v>9.8266666666666669E-2</c:v>
                </c:pt>
                <c:pt idx="521">
                  <c:v>9.8083333333333342E-2</c:v>
                </c:pt>
                <c:pt idx="522">
                  <c:v>9.7916666666666666E-2</c:v>
                </c:pt>
                <c:pt idx="523">
                  <c:v>9.7766666666666668E-2</c:v>
                </c:pt>
                <c:pt idx="524">
                  <c:v>9.7666666666666679E-2</c:v>
                </c:pt>
                <c:pt idx="525">
                  <c:v>9.7500000000000017E-2</c:v>
                </c:pt>
                <c:pt idx="526">
                  <c:v>9.7233333333333338E-2</c:v>
                </c:pt>
                <c:pt idx="527">
                  <c:v>9.715E-2</c:v>
                </c:pt>
                <c:pt idx="528">
                  <c:v>9.6966666666666659E-2</c:v>
                </c:pt>
                <c:pt idx="529">
                  <c:v>9.6833333333333341E-2</c:v>
                </c:pt>
                <c:pt idx="530">
                  <c:v>9.6750000000000003E-2</c:v>
                </c:pt>
                <c:pt idx="531">
                  <c:v>9.6566666666666676E-2</c:v>
                </c:pt>
                <c:pt idx="532">
                  <c:v>9.6433333333333329E-2</c:v>
                </c:pt>
                <c:pt idx="533">
                  <c:v>9.6299999999999997E-2</c:v>
                </c:pt>
                <c:pt idx="534">
                  <c:v>9.6216666666666659E-2</c:v>
                </c:pt>
                <c:pt idx="535">
                  <c:v>9.6183333333333343E-2</c:v>
                </c:pt>
                <c:pt idx="536">
                  <c:v>9.605000000000001E-2</c:v>
                </c:pt>
                <c:pt idx="537">
                  <c:v>9.5933333333333329E-2</c:v>
                </c:pt>
                <c:pt idx="538">
                  <c:v>9.5849999999999991E-2</c:v>
                </c:pt>
                <c:pt idx="539">
                  <c:v>9.5700000000000007E-2</c:v>
                </c:pt>
                <c:pt idx="540">
                  <c:v>9.5616666666666669E-2</c:v>
                </c:pt>
                <c:pt idx="541">
                  <c:v>9.5566666666666675E-2</c:v>
                </c:pt>
                <c:pt idx="542">
                  <c:v>9.5500000000000015E-2</c:v>
                </c:pt>
                <c:pt idx="543">
                  <c:v>9.5449999999999993E-2</c:v>
                </c:pt>
                <c:pt idx="544">
                  <c:v>9.5399999999999999E-2</c:v>
                </c:pt>
                <c:pt idx="545">
                  <c:v>9.5350000000000004E-2</c:v>
                </c:pt>
                <c:pt idx="546">
                  <c:v>9.5316666666666661E-2</c:v>
                </c:pt>
                <c:pt idx="547">
                  <c:v>9.5266666666666666E-2</c:v>
                </c:pt>
                <c:pt idx="548">
                  <c:v>9.5216666666666672E-2</c:v>
                </c:pt>
                <c:pt idx="549">
                  <c:v>9.5133333333333348E-2</c:v>
                </c:pt>
                <c:pt idx="550">
                  <c:v>9.5083333333333353E-2</c:v>
                </c:pt>
                <c:pt idx="551">
                  <c:v>9.5000000000000015E-2</c:v>
                </c:pt>
                <c:pt idx="552">
                  <c:v>9.4949999999999993E-2</c:v>
                </c:pt>
                <c:pt idx="553">
                  <c:v>9.4916666666666663E-2</c:v>
                </c:pt>
                <c:pt idx="554">
                  <c:v>9.4833333333333339E-2</c:v>
                </c:pt>
                <c:pt idx="555">
                  <c:v>9.4783333333333331E-2</c:v>
                </c:pt>
                <c:pt idx="556">
                  <c:v>9.4766666666666666E-2</c:v>
                </c:pt>
                <c:pt idx="557">
                  <c:v>9.4700000000000006E-2</c:v>
                </c:pt>
                <c:pt idx="558">
                  <c:v>9.4649999999999998E-2</c:v>
                </c:pt>
                <c:pt idx="559">
                  <c:v>9.4566666666666674E-2</c:v>
                </c:pt>
                <c:pt idx="560">
                  <c:v>9.4533333333333316E-2</c:v>
                </c:pt>
                <c:pt idx="561">
                  <c:v>9.4483333333333322E-2</c:v>
                </c:pt>
                <c:pt idx="562">
                  <c:v>9.4399999999999998E-2</c:v>
                </c:pt>
                <c:pt idx="563">
                  <c:v>9.4383333333333333E-2</c:v>
                </c:pt>
                <c:pt idx="564">
                  <c:v>9.4350000000000003E-2</c:v>
                </c:pt>
                <c:pt idx="565">
                  <c:v>9.4283333333333344E-2</c:v>
                </c:pt>
                <c:pt idx="566">
                  <c:v>9.4266666666666665E-2</c:v>
                </c:pt>
                <c:pt idx="567">
                  <c:v>9.4200000000000006E-2</c:v>
                </c:pt>
                <c:pt idx="568">
                  <c:v>9.4149999999999998E-2</c:v>
                </c:pt>
                <c:pt idx="569">
                  <c:v>9.4083333333333338E-2</c:v>
                </c:pt>
                <c:pt idx="570">
                  <c:v>9.4049999999999981E-2</c:v>
                </c:pt>
                <c:pt idx="571">
                  <c:v>9.4033333333333316E-2</c:v>
                </c:pt>
                <c:pt idx="572">
                  <c:v>9.3999999999999986E-2</c:v>
                </c:pt>
                <c:pt idx="573">
                  <c:v>9.3899999999999997E-2</c:v>
                </c:pt>
                <c:pt idx="574">
                  <c:v>9.3883333333333333E-2</c:v>
                </c:pt>
                <c:pt idx="575">
                  <c:v>9.375E-2</c:v>
                </c:pt>
                <c:pt idx="576">
                  <c:v>9.3700000000000006E-2</c:v>
                </c:pt>
                <c:pt idx="577">
                  <c:v>9.3633333333333346E-2</c:v>
                </c:pt>
                <c:pt idx="578">
                  <c:v>9.3533333333333343E-2</c:v>
                </c:pt>
                <c:pt idx="579">
                  <c:v>9.3466666666666656E-2</c:v>
                </c:pt>
                <c:pt idx="580">
                  <c:v>9.3433333333333327E-2</c:v>
                </c:pt>
                <c:pt idx="581">
                  <c:v>9.3333333333333338E-2</c:v>
                </c:pt>
                <c:pt idx="582">
                  <c:v>9.321666666666667E-2</c:v>
                </c:pt>
                <c:pt idx="583">
                  <c:v>9.3100000000000002E-2</c:v>
                </c:pt>
                <c:pt idx="584">
                  <c:v>9.3016666666666678E-2</c:v>
                </c:pt>
                <c:pt idx="585">
                  <c:v>9.2883333333333332E-2</c:v>
                </c:pt>
                <c:pt idx="586">
                  <c:v>9.2850000000000002E-2</c:v>
                </c:pt>
                <c:pt idx="587">
                  <c:v>9.2716666666666669E-2</c:v>
                </c:pt>
                <c:pt idx="588">
                  <c:v>9.2583333333333337E-2</c:v>
                </c:pt>
                <c:pt idx="589">
                  <c:v>9.2466666666666655E-2</c:v>
                </c:pt>
                <c:pt idx="590">
                  <c:v>9.2283333333333328E-2</c:v>
                </c:pt>
                <c:pt idx="591">
                  <c:v>9.2200000000000004E-2</c:v>
                </c:pt>
                <c:pt idx="592">
                  <c:v>9.2116666666666666E-2</c:v>
                </c:pt>
                <c:pt idx="593">
                  <c:v>9.2033333333333342E-2</c:v>
                </c:pt>
                <c:pt idx="594">
                  <c:v>9.1883333333333331E-2</c:v>
                </c:pt>
                <c:pt idx="595">
                  <c:v>9.1700000000000004E-2</c:v>
                </c:pt>
                <c:pt idx="596">
                  <c:v>9.1550000000000006E-2</c:v>
                </c:pt>
                <c:pt idx="597">
                  <c:v>9.138333333333333E-2</c:v>
                </c:pt>
                <c:pt idx="598">
                  <c:v>9.116666666666666E-2</c:v>
                </c:pt>
                <c:pt idx="599">
                  <c:v>9.1066666666666671E-2</c:v>
                </c:pt>
                <c:pt idx="600">
                  <c:v>9.0899999999999995E-2</c:v>
                </c:pt>
                <c:pt idx="601">
                  <c:v>9.0683333333333324E-2</c:v>
                </c:pt>
                <c:pt idx="602">
                  <c:v>9.0500000000000011E-2</c:v>
                </c:pt>
                <c:pt idx="603">
                  <c:v>9.0333333333333335E-2</c:v>
                </c:pt>
                <c:pt idx="604">
                  <c:v>9.0200000000000002E-2</c:v>
                </c:pt>
                <c:pt idx="605">
                  <c:v>9.006666666666667E-2</c:v>
                </c:pt>
                <c:pt idx="606">
                  <c:v>8.9833333333333362E-2</c:v>
                </c:pt>
                <c:pt idx="607">
                  <c:v>8.9566666666666683E-2</c:v>
                </c:pt>
                <c:pt idx="608">
                  <c:v>8.9383333333333329E-2</c:v>
                </c:pt>
                <c:pt idx="609">
                  <c:v>8.9116666666666663E-2</c:v>
                </c:pt>
                <c:pt idx="610">
                  <c:v>8.8899999999999993E-2</c:v>
                </c:pt>
                <c:pt idx="611">
                  <c:v>8.8666666666666671E-2</c:v>
                </c:pt>
                <c:pt idx="612">
                  <c:v>8.8466666666666652E-2</c:v>
                </c:pt>
                <c:pt idx="613">
                  <c:v>8.8250000000000009E-2</c:v>
                </c:pt>
                <c:pt idx="614">
                  <c:v>8.8133333333333327E-2</c:v>
                </c:pt>
                <c:pt idx="615">
                  <c:v>8.7983333333333316E-2</c:v>
                </c:pt>
                <c:pt idx="616">
                  <c:v>8.7749999999999995E-2</c:v>
                </c:pt>
                <c:pt idx="617">
                  <c:v>8.7416666666666656E-2</c:v>
                </c:pt>
                <c:pt idx="618">
                  <c:v>8.7099999999999997E-2</c:v>
                </c:pt>
                <c:pt idx="619">
                  <c:v>8.6833333333333332E-2</c:v>
                </c:pt>
                <c:pt idx="620">
                  <c:v>8.6533333333333337E-2</c:v>
                </c:pt>
                <c:pt idx="621">
                  <c:v>8.6333333333333331E-2</c:v>
                </c:pt>
                <c:pt idx="622">
                  <c:v>8.6066666666666666E-2</c:v>
                </c:pt>
                <c:pt idx="623">
                  <c:v>8.5766666666666672E-2</c:v>
                </c:pt>
                <c:pt idx="624">
                  <c:v>8.5466666666666677E-2</c:v>
                </c:pt>
                <c:pt idx="625">
                  <c:v>8.5150000000000003E-2</c:v>
                </c:pt>
                <c:pt idx="626">
                  <c:v>8.4916666666666654E-2</c:v>
                </c:pt>
                <c:pt idx="627">
                  <c:v>8.4616666666666673E-2</c:v>
                </c:pt>
                <c:pt idx="628">
                  <c:v>8.4349999999999994E-2</c:v>
                </c:pt>
                <c:pt idx="629">
                  <c:v>8.405E-2</c:v>
                </c:pt>
                <c:pt idx="630">
                  <c:v>8.3750000000000005E-2</c:v>
                </c:pt>
                <c:pt idx="631">
                  <c:v>8.3466666666666675E-2</c:v>
                </c:pt>
                <c:pt idx="632">
                  <c:v>8.3150000000000002E-2</c:v>
                </c:pt>
                <c:pt idx="633">
                  <c:v>8.2816666666666677E-2</c:v>
                </c:pt>
                <c:pt idx="634">
                  <c:v>8.2400000000000015E-2</c:v>
                </c:pt>
                <c:pt idx="635">
                  <c:v>8.2100000000000006E-2</c:v>
                </c:pt>
                <c:pt idx="636">
                  <c:v>8.1766666666666668E-2</c:v>
                </c:pt>
                <c:pt idx="637">
                  <c:v>8.1483333333333338E-2</c:v>
                </c:pt>
                <c:pt idx="638">
                  <c:v>8.1250000000000003E-2</c:v>
                </c:pt>
                <c:pt idx="639">
                  <c:v>8.0850000000000005E-2</c:v>
                </c:pt>
                <c:pt idx="640">
                  <c:v>8.0500000000000002E-2</c:v>
                </c:pt>
                <c:pt idx="641">
                  <c:v>8.0266666666666667E-2</c:v>
                </c:pt>
                <c:pt idx="642">
                  <c:v>7.9799999999999996E-2</c:v>
                </c:pt>
                <c:pt idx="643">
                  <c:v>7.9466666666666672E-2</c:v>
                </c:pt>
                <c:pt idx="644">
                  <c:v>7.9149999999999984E-2</c:v>
                </c:pt>
                <c:pt idx="645">
                  <c:v>7.8816666666666674E-2</c:v>
                </c:pt>
                <c:pt idx="646">
                  <c:v>7.8516666666666665E-2</c:v>
                </c:pt>
                <c:pt idx="647">
                  <c:v>7.8199999999999992E-2</c:v>
                </c:pt>
                <c:pt idx="648">
                  <c:v>7.7983333333333335E-2</c:v>
                </c:pt>
                <c:pt idx="649">
                  <c:v>7.7599999999999988E-2</c:v>
                </c:pt>
                <c:pt idx="650">
                  <c:v>7.7249999999999999E-2</c:v>
                </c:pt>
                <c:pt idx="651">
                  <c:v>7.693333333333334E-2</c:v>
                </c:pt>
                <c:pt idx="652">
                  <c:v>7.6616666666666652E-2</c:v>
                </c:pt>
                <c:pt idx="653">
                  <c:v>7.6216666666666655E-2</c:v>
                </c:pt>
                <c:pt idx="654">
                  <c:v>7.6033333333333342E-2</c:v>
                </c:pt>
                <c:pt idx="655">
                  <c:v>7.5733333333333333E-2</c:v>
                </c:pt>
                <c:pt idx="656">
                  <c:v>7.535E-2</c:v>
                </c:pt>
                <c:pt idx="657">
                  <c:v>7.5116666666666651E-2</c:v>
                </c:pt>
                <c:pt idx="658">
                  <c:v>7.481666666666667E-2</c:v>
                </c:pt>
                <c:pt idx="659">
                  <c:v>7.4399999999999994E-2</c:v>
                </c:pt>
                <c:pt idx="660">
                  <c:v>7.4133333333333343E-2</c:v>
                </c:pt>
                <c:pt idx="661">
                  <c:v>7.3849999999999985E-2</c:v>
                </c:pt>
                <c:pt idx="662">
                  <c:v>7.3499999999999996E-2</c:v>
                </c:pt>
                <c:pt idx="663">
                  <c:v>7.3283333333333325E-2</c:v>
                </c:pt>
                <c:pt idx="664">
                  <c:v>7.301666666666666E-2</c:v>
                </c:pt>
                <c:pt idx="665">
                  <c:v>7.2749999999999995E-2</c:v>
                </c:pt>
                <c:pt idx="666">
                  <c:v>7.2466666666666665E-2</c:v>
                </c:pt>
                <c:pt idx="667">
                  <c:v>7.2216666666666665E-2</c:v>
                </c:pt>
                <c:pt idx="668">
                  <c:v>7.195E-2</c:v>
                </c:pt>
                <c:pt idx="669">
                  <c:v>7.1683333333333321E-2</c:v>
                </c:pt>
                <c:pt idx="670">
                  <c:v>7.1300000000000002E-2</c:v>
                </c:pt>
                <c:pt idx="671">
                  <c:v>7.0099999999999982E-2</c:v>
                </c:pt>
                <c:pt idx="672">
                  <c:v>6.8916666666666668E-2</c:v>
                </c:pt>
                <c:pt idx="673">
                  <c:v>6.7766666666666669E-2</c:v>
                </c:pt>
                <c:pt idx="674">
                  <c:v>6.671666666666666E-2</c:v>
                </c:pt>
                <c:pt idx="675">
                  <c:v>6.6500000000000004E-2</c:v>
                </c:pt>
                <c:pt idx="676">
                  <c:v>6.6266666666666682E-2</c:v>
                </c:pt>
                <c:pt idx="677">
                  <c:v>6.6016666666666668E-2</c:v>
                </c:pt>
                <c:pt idx="678">
                  <c:v>6.5766666666666682E-2</c:v>
                </c:pt>
                <c:pt idx="679">
                  <c:v>6.5533333333333346E-2</c:v>
                </c:pt>
                <c:pt idx="680">
                  <c:v>6.536666666666667E-2</c:v>
                </c:pt>
                <c:pt idx="681">
                  <c:v>6.5133333333333335E-2</c:v>
                </c:pt>
                <c:pt idx="682">
                  <c:v>6.5033333333333346E-2</c:v>
                </c:pt>
                <c:pt idx="683">
                  <c:v>6.4883333333333335E-2</c:v>
                </c:pt>
                <c:pt idx="684">
                  <c:v>6.4716666666666658E-2</c:v>
                </c:pt>
                <c:pt idx="685">
                  <c:v>6.4733333333333337E-2</c:v>
                </c:pt>
                <c:pt idx="686">
                  <c:v>6.4549999999999996E-2</c:v>
                </c:pt>
                <c:pt idx="687">
                  <c:v>6.4483333333333337E-2</c:v>
                </c:pt>
                <c:pt idx="688">
                  <c:v>6.433333333333334E-2</c:v>
                </c:pt>
                <c:pt idx="689">
                  <c:v>6.4100000000000004E-2</c:v>
                </c:pt>
                <c:pt idx="690">
                  <c:v>6.3850000000000004E-2</c:v>
                </c:pt>
                <c:pt idx="691">
                  <c:v>6.3633333333333333E-2</c:v>
                </c:pt>
                <c:pt idx="692">
                  <c:v>6.3516666666666666E-2</c:v>
                </c:pt>
                <c:pt idx="693">
                  <c:v>6.3450000000000006E-2</c:v>
                </c:pt>
                <c:pt idx="694">
                  <c:v>6.3450000000000006E-2</c:v>
                </c:pt>
                <c:pt idx="695">
                  <c:v>6.3399999999999998E-2</c:v>
                </c:pt>
                <c:pt idx="696">
                  <c:v>6.3250000000000015E-2</c:v>
                </c:pt>
                <c:pt idx="697">
                  <c:v>6.3116666666666668E-2</c:v>
                </c:pt>
                <c:pt idx="698">
                  <c:v>6.3000000000000014E-2</c:v>
                </c:pt>
                <c:pt idx="699">
                  <c:v>6.2816666666666673E-2</c:v>
                </c:pt>
                <c:pt idx="700">
                  <c:v>6.2766666666666679E-2</c:v>
                </c:pt>
                <c:pt idx="701">
                  <c:v>6.2783333333333344E-2</c:v>
                </c:pt>
                <c:pt idx="702">
                  <c:v>6.2716666666666671E-2</c:v>
                </c:pt>
                <c:pt idx="703">
                  <c:v>6.2683333333333341E-2</c:v>
                </c:pt>
                <c:pt idx="704">
                  <c:v>6.2783333333333344E-2</c:v>
                </c:pt>
                <c:pt idx="705">
                  <c:v>6.2549999999999994E-2</c:v>
                </c:pt>
                <c:pt idx="706">
                  <c:v>6.2349999999999996E-2</c:v>
                </c:pt>
                <c:pt idx="707">
                  <c:v>6.2300000000000001E-2</c:v>
                </c:pt>
                <c:pt idx="708">
                  <c:v>6.2133333333333339E-2</c:v>
                </c:pt>
                <c:pt idx="709">
                  <c:v>6.221666666666667E-2</c:v>
                </c:pt>
                <c:pt idx="710">
                  <c:v>6.221666666666667E-2</c:v>
                </c:pt>
                <c:pt idx="711">
                  <c:v>6.2166666666666669E-2</c:v>
                </c:pt>
                <c:pt idx="712">
                  <c:v>6.2116666666666674E-2</c:v>
                </c:pt>
                <c:pt idx="713">
                  <c:v>6.2050000000000015E-2</c:v>
                </c:pt>
                <c:pt idx="714">
                  <c:v>6.1883333333333339E-2</c:v>
                </c:pt>
                <c:pt idx="715">
                  <c:v>6.1849999999999995E-2</c:v>
                </c:pt>
                <c:pt idx="716">
                  <c:v>6.1849999999999995E-2</c:v>
                </c:pt>
                <c:pt idx="717">
                  <c:v>6.171666666666667E-2</c:v>
                </c:pt>
                <c:pt idx="718">
                  <c:v>6.1733333333333335E-2</c:v>
                </c:pt>
                <c:pt idx="719">
                  <c:v>6.1683333333333319E-2</c:v>
                </c:pt>
                <c:pt idx="720">
                  <c:v>6.1716666666666663E-2</c:v>
                </c:pt>
                <c:pt idx="721">
                  <c:v>6.1816666666666666E-2</c:v>
                </c:pt>
                <c:pt idx="722">
                  <c:v>6.1766666666666664E-2</c:v>
                </c:pt>
                <c:pt idx="723">
                  <c:v>6.1716666666666649E-2</c:v>
                </c:pt>
                <c:pt idx="724">
                  <c:v>6.1666666666666668E-2</c:v>
                </c:pt>
                <c:pt idx="725">
                  <c:v>6.1533333333333336E-2</c:v>
                </c:pt>
                <c:pt idx="726">
                  <c:v>6.1616666666666674E-2</c:v>
                </c:pt>
                <c:pt idx="727">
                  <c:v>6.1583333333333323E-2</c:v>
                </c:pt>
                <c:pt idx="728">
                  <c:v>6.1566666666666658E-2</c:v>
                </c:pt>
                <c:pt idx="729">
                  <c:v>6.1550000000000001E-2</c:v>
                </c:pt>
                <c:pt idx="730">
                  <c:v>6.1499999999999999E-2</c:v>
                </c:pt>
                <c:pt idx="731">
                  <c:v>6.1449999999999998E-2</c:v>
                </c:pt>
                <c:pt idx="732">
                  <c:v>6.1450000000000005E-2</c:v>
                </c:pt>
                <c:pt idx="733">
                  <c:v>6.1383333333333338E-2</c:v>
                </c:pt>
                <c:pt idx="734">
                  <c:v>6.1366666666666674E-2</c:v>
                </c:pt>
                <c:pt idx="735">
                  <c:v>6.1266666666666664E-2</c:v>
                </c:pt>
                <c:pt idx="736">
                  <c:v>6.1216666666666676E-2</c:v>
                </c:pt>
                <c:pt idx="737">
                  <c:v>6.1200000000000011E-2</c:v>
                </c:pt>
                <c:pt idx="738">
                  <c:v>6.1316666666666658E-2</c:v>
                </c:pt>
                <c:pt idx="739">
                  <c:v>6.1383333333333324E-2</c:v>
                </c:pt>
                <c:pt idx="740">
                  <c:v>6.136666666666666E-2</c:v>
                </c:pt>
                <c:pt idx="741">
                  <c:v>6.1283333333333335E-2</c:v>
                </c:pt>
                <c:pt idx="742">
                  <c:v>6.108333333333333E-2</c:v>
                </c:pt>
                <c:pt idx="743">
                  <c:v>6.1249999999999999E-2</c:v>
                </c:pt>
                <c:pt idx="744">
                  <c:v>6.133333333333333E-2</c:v>
                </c:pt>
                <c:pt idx="745">
                  <c:v>6.1283333333333335E-2</c:v>
                </c:pt>
                <c:pt idx="746">
                  <c:v>6.1299999999999993E-2</c:v>
                </c:pt>
                <c:pt idx="747">
                  <c:v>6.1133333333333338E-2</c:v>
                </c:pt>
                <c:pt idx="748">
                  <c:v>6.1016666666666663E-2</c:v>
                </c:pt>
                <c:pt idx="749">
                  <c:v>6.1033333333333335E-2</c:v>
                </c:pt>
                <c:pt idx="750">
                  <c:v>6.1099999999999995E-2</c:v>
                </c:pt>
                <c:pt idx="751">
                  <c:v>6.101666666666667E-2</c:v>
                </c:pt>
                <c:pt idx="752">
                  <c:v>6.1016666666666663E-2</c:v>
                </c:pt>
                <c:pt idx="753">
                  <c:v>6.0966666666666669E-2</c:v>
                </c:pt>
                <c:pt idx="754">
                  <c:v>6.0916666666666668E-2</c:v>
                </c:pt>
                <c:pt idx="755">
                  <c:v>6.0850000000000008E-2</c:v>
                </c:pt>
                <c:pt idx="756">
                  <c:v>6.0783333333333328E-2</c:v>
                </c:pt>
                <c:pt idx="757">
                  <c:v>6.0799999999999993E-2</c:v>
                </c:pt>
                <c:pt idx="758">
                  <c:v>6.0783333333333328E-2</c:v>
                </c:pt>
                <c:pt idx="759">
                  <c:v>6.0766666666666663E-2</c:v>
                </c:pt>
                <c:pt idx="760">
                  <c:v>6.0666666666666653E-2</c:v>
                </c:pt>
                <c:pt idx="761">
                  <c:v>6.0583333333333329E-2</c:v>
                </c:pt>
                <c:pt idx="762">
                  <c:v>6.0633333333333338E-2</c:v>
                </c:pt>
                <c:pt idx="763">
                  <c:v>6.0633333333333338E-2</c:v>
                </c:pt>
                <c:pt idx="764">
                  <c:v>6.0650000000000003E-2</c:v>
                </c:pt>
                <c:pt idx="765">
                  <c:v>6.0683333333333332E-2</c:v>
                </c:pt>
                <c:pt idx="766">
                  <c:v>6.0566666666666678E-2</c:v>
                </c:pt>
                <c:pt idx="767">
                  <c:v>6.0699999999999997E-2</c:v>
                </c:pt>
                <c:pt idx="768">
                  <c:v>6.0733333333333334E-2</c:v>
                </c:pt>
                <c:pt idx="769">
                  <c:v>6.0749999999999998E-2</c:v>
                </c:pt>
                <c:pt idx="770">
                  <c:v>6.0999999999999999E-2</c:v>
                </c:pt>
                <c:pt idx="771">
                  <c:v>6.0983333333333341E-2</c:v>
                </c:pt>
                <c:pt idx="772">
                  <c:v>6.1183333333333333E-2</c:v>
                </c:pt>
                <c:pt idx="773">
                  <c:v>6.1083333333333344E-2</c:v>
                </c:pt>
                <c:pt idx="774">
                  <c:v>6.1116666666666673E-2</c:v>
                </c:pt>
                <c:pt idx="775">
                  <c:v>6.13E-2</c:v>
                </c:pt>
                <c:pt idx="776">
                  <c:v>6.1316666666666665E-2</c:v>
                </c:pt>
                <c:pt idx="777">
                  <c:v>6.1416666666666675E-2</c:v>
                </c:pt>
                <c:pt idx="778">
                  <c:v>6.1533333333333329E-2</c:v>
                </c:pt>
                <c:pt idx="779">
                  <c:v>6.1533333333333336E-2</c:v>
                </c:pt>
                <c:pt idx="780">
                  <c:v>6.1749999999999992E-2</c:v>
                </c:pt>
                <c:pt idx="781">
                  <c:v>6.2116666666666674E-2</c:v>
                </c:pt>
                <c:pt idx="782">
                  <c:v>6.2166666666666655E-2</c:v>
                </c:pt>
                <c:pt idx="783">
                  <c:v>6.246666666666667E-2</c:v>
                </c:pt>
                <c:pt idx="784">
                  <c:v>6.2683333333333341E-2</c:v>
                </c:pt>
                <c:pt idx="785">
                  <c:v>6.2866666666666668E-2</c:v>
                </c:pt>
                <c:pt idx="786">
                  <c:v>6.3100000000000003E-2</c:v>
                </c:pt>
                <c:pt idx="787">
                  <c:v>6.3299999999999995E-2</c:v>
                </c:pt>
                <c:pt idx="788">
                  <c:v>6.3333333333333339E-2</c:v>
                </c:pt>
                <c:pt idx="789">
                  <c:v>6.348333333333335E-2</c:v>
                </c:pt>
                <c:pt idx="790">
                  <c:v>6.3783333333333331E-2</c:v>
                </c:pt>
                <c:pt idx="791">
                  <c:v>6.4066666666666675E-2</c:v>
                </c:pt>
                <c:pt idx="792">
                  <c:v>6.451666666666668E-2</c:v>
                </c:pt>
                <c:pt idx="793">
                  <c:v>6.4750000000000002E-2</c:v>
                </c:pt>
                <c:pt idx="794">
                  <c:v>6.511666666666667E-2</c:v>
                </c:pt>
                <c:pt idx="795">
                  <c:v>6.5466666666666659E-2</c:v>
                </c:pt>
                <c:pt idx="796">
                  <c:v>6.5833333333333327E-2</c:v>
                </c:pt>
                <c:pt idx="797">
                  <c:v>6.6166666666666665E-2</c:v>
                </c:pt>
                <c:pt idx="798">
                  <c:v>6.6549999999999998E-2</c:v>
                </c:pt>
                <c:pt idx="799">
                  <c:v>6.6983333333333325E-2</c:v>
                </c:pt>
                <c:pt idx="800">
                  <c:v>6.7416666666666666E-2</c:v>
                </c:pt>
                <c:pt idx="801">
                  <c:v>6.7699999999999996E-2</c:v>
                </c:pt>
                <c:pt idx="802">
                  <c:v>6.8049999999999999E-2</c:v>
                </c:pt>
                <c:pt idx="803">
                  <c:v>6.8233333333333326E-2</c:v>
                </c:pt>
                <c:pt idx="804">
                  <c:v>6.8416666666666681E-2</c:v>
                </c:pt>
                <c:pt idx="805">
                  <c:v>6.883333333333333E-2</c:v>
                </c:pt>
                <c:pt idx="806">
                  <c:v>6.9300000000000014E-2</c:v>
                </c:pt>
                <c:pt idx="807">
                  <c:v>6.9633333333333325E-2</c:v>
                </c:pt>
                <c:pt idx="808">
                  <c:v>6.9949999999999998E-2</c:v>
                </c:pt>
                <c:pt idx="809">
                  <c:v>7.0216666666666663E-2</c:v>
                </c:pt>
                <c:pt idx="810">
                  <c:v>7.0183333333333334E-2</c:v>
                </c:pt>
                <c:pt idx="811">
                  <c:v>7.063333333333334E-2</c:v>
                </c:pt>
                <c:pt idx="812">
                  <c:v>7.0716666666666664E-2</c:v>
                </c:pt>
                <c:pt idx="813">
                  <c:v>7.0966666666666664E-2</c:v>
                </c:pt>
                <c:pt idx="814">
                  <c:v>7.1400000000000005E-2</c:v>
                </c:pt>
                <c:pt idx="815">
                  <c:v>7.1400000000000005E-2</c:v>
                </c:pt>
                <c:pt idx="816">
                  <c:v>7.1549999999999989E-2</c:v>
                </c:pt>
                <c:pt idx="817">
                  <c:v>7.1750000000000022E-2</c:v>
                </c:pt>
                <c:pt idx="818">
                  <c:v>7.1783333333333338E-2</c:v>
                </c:pt>
                <c:pt idx="819">
                  <c:v>7.1999999999999995E-2</c:v>
                </c:pt>
                <c:pt idx="820">
                  <c:v>7.2066666666666668E-2</c:v>
                </c:pt>
                <c:pt idx="821">
                  <c:v>7.2000000000000008E-2</c:v>
                </c:pt>
                <c:pt idx="822">
                  <c:v>7.1833333333333332E-2</c:v>
                </c:pt>
                <c:pt idx="823">
                  <c:v>7.1749999999999994E-2</c:v>
                </c:pt>
                <c:pt idx="824">
                  <c:v>7.2050000000000003E-2</c:v>
                </c:pt>
                <c:pt idx="825">
                  <c:v>7.191666666666667E-2</c:v>
                </c:pt>
                <c:pt idx="826">
                  <c:v>7.191666666666667E-2</c:v>
                </c:pt>
                <c:pt idx="827">
                  <c:v>7.1816666666666668E-2</c:v>
                </c:pt>
                <c:pt idx="828">
                  <c:v>7.141666666666667E-2</c:v>
                </c:pt>
                <c:pt idx="829">
                  <c:v>7.1249999999999994E-2</c:v>
                </c:pt>
                <c:pt idx="830">
                  <c:v>7.1050000000000002E-2</c:v>
                </c:pt>
                <c:pt idx="831">
                  <c:v>7.0833333333333331E-2</c:v>
                </c:pt>
                <c:pt idx="832">
                  <c:v>7.0866666666666675E-2</c:v>
                </c:pt>
                <c:pt idx="833">
                  <c:v>7.0499999999999993E-2</c:v>
                </c:pt>
                <c:pt idx="834">
                  <c:v>7.0383333333333339E-2</c:v>
                </c:pt>
                <c:pt idx="835">
                  <c:v>6.9933333333333333E-2</c:v>
                </c:pt>
                <c:pt idx="836">
                  <c:v>6.9549999999999987E-2</c:v>
                </c:pt>
                <c:pt idx="837">
                  <c:v>6.9450000000000012E-2</c:v>
                </c:pt>
                <c:pt idx="838">
                  <c:v>6.8783333333333321E-2</c:v>
                </c:pt>
                <c:pt idx="839">
                  <c:v>6.8583333333333329E-2</c:v>
                </c:pt>
                <c:pt idx="840">
                  <c:v>6.8233333333333326E-2</c:v>
                </c:pt>
                <c:pt idx="841">
                  <c:v>6.7916666666666667E-2</c:v>
                </c:pt>
                <c:pt idx="842">
                  <c:v>6.8033333333333335E-2</c:v>
                </c:pt>
                <c:pt idx="843">
                  <c:v>6.7799999999999985E-2</c:v>
                </c:pt>
                <c:pt idx="844">
                  <c:v>6.7466666666666661E-2</c:v>
                </c:pt>
                <c:pt idx="845">
                  <c:v>6.7183333333333331E-2</c:v>
                </c:pt>
                <c:pt idx="846">
                  <c:v>6.6699999999999995E-2</c:v>
                </c:pt>
                <c:pt idx="847">
                  <c:v>6.6266666666666682E-2</c:v>
                </c:pt>
                <c:pt idx="848">
                  <c:v>6.6083333333333341E-2</c:v>
                </c:pt>
                <c:pt idx="849">
                  <c:v>6.6266666666666668E-2</c:v>
                </c:pt>
                <c:pt idx="850">
                  <c:v>6.6116666666666671E-2</c:v>
                </c:pt>
                <c:pt idx="851">
                  <c:v>6.6116666666666671E-2</c:v>
                </c:pt>
                <c:pt idx="852">
                  <c:v>6.5916666666666665E-2</c:v>
                </c:pt>
                <c:pt idx="853">
                  <c:v>6.5266666666666667E-2</c:v>
                </c:pt>
                <c:pt idx="854">
                  <c:v>6.511666666666667E-2</c:v>
                </c:pt>
                <c:pt idx="855">
                  <c:v>6.4949999999999994E-2</c:v>
                </c:pt>
                <c:pt idx="856">
                  <c:v>6.4783333333333332E-2</c:v>
                </c:pt>
                <c:pt idx="857">
                  <c:v>6.4733333333333337E-2</c:v>
                </c:pt>
                <c:pt idx="858">
                  <c:v>6.4433333333333329E-2</c:v>
                </c:pt>
                <c:pt idx="859">
                  <c:v>6.4250000000000002E-2</c:v>
                </c:pt>
                <c:pt idx="860">
                  <c:v>6.4149999999999999E-2</c:v>
                </c:pt>
                <c:pt idx="861">
                  <c:v>6.4283333333333345E-2</c:v>
                </c:pt>
                <c:pt idx="862">
                  <c:v>6.4316666666666675E-2</c:v>
                </c:pt>
                <c:pt idx="863">
                  <c:v>6.4016666666666666E-2</c:v>
                </c:pt>
                <c:pt idx="864">
                  <c:v>6.3916666666666677E-2</c:v>
                </c:pt>
                <c:pt idx="865">
                  <c:v>6.3666666666666663E-2</c:v>
                </c:pt>
                <c:pt idx="866">
                  <c:v>6.3450000000000006E-2</c:v>
                </c:pt>
                <c:pt idx="867">
                  <c:v>6.3783333333333345E-2</c:v>
                </c:pt>
                <c:pt idx="868">
                  <c:v>6.3633333333333333E-2</c:v>
                </c:pt>
                <c:pt idx="869">
                  <c:v>6.3416666666666663E-2</c:v>
                </c:pt>
                <c:pt idx="870">
                  <c:v>6.3316666666666674E-2</c:v>
                </c:pt>
                <c:pt idx="871">
                  <c:v>6.3149999999999998E-2</c:v>
                </c:pt>
                <c:pt idx="872">
                  <c:v>6.3450000000000006E-2</c:v>
                </c:pt>
                <c:pt idx="873">
                  <c:v>6.3583333333333325E-2</c:v>
                </c:pt>
                <c:pt idx="874">
                  <c:v>6.3649999999999998E-2</c:v>
                </c:pt>
                <c:pt idx="875">
                  <c:v>6.3899999999999998E-2</c:v>
                </c:pt>
                <c:pt idx="876">
                  <c:v>6.3633333333333333E-2</c:v>
                </c:pt>
                <c:pt idx="877">
                  <c:v>6.381666666666666E-2</c:v>
                </c:pt>
                <c:pt idx="878">
                  <c:v>6.3833333333333325E-2</c:v>
                </c:pt>
                <c:pt idx="879">
                  <c:v>6.3983333333333337E-2</c:v>
                </c:pt>
                <c:pt idx="880">
                  <c:v>6.4716666666666658E-2</c:v>
                </c:pt>
                <c:pt idx="881">
                  <c:v>6.4750000000000016E-2</c:v>
                </c:pt>
                <c:pt idx="882">
                  <c:v>6.515E-2</c:v>
                </c:pt>
                <c:pt idx="883">
                  <c:v>6.5033333333333332E-2</c:v>
                </c:pt>
                <c:pt idx="884">
                  <c:v>6.4600000000000005E-2</c:v>
                </c:pt>
                <c:pt idx="885">
                  <c:v>6.4983333333333324E-2</c:v>
                </c:pt>
                <c:pt idx="886">
                  <c:v>6.5033333333333346E-2</c:v>
                </c:pt>
                <c:pt idx="887">
                  <c:v>6.5116666666666656E-2</c:v>
                </c:pt>
                <c:pt idx="888">
                  <c:v>6.5233333333333324E-2</c:v>
                </c:pt>
                <c:pt idx="889">
                  <c:v>6.5100000000000005E-2</c:v>
                </c:pt>
                <c:pt idx="890">
                  <c:v>6.5316666666666676E-2</c:v>
                </c:pt>
                <c:pt idx="891">
                  <c:v>6.5449999999999994E-2</c:v>
                </c:pt>
                <c:pt idx="892">
                  <c:v>6.5666666666666665E-2</c:v>
                </c:pt>
                <c:pt idx="893">
                  <c:v>6.5783333333333333E-2</c:v>
                </c:pt>
                <c:pt idx="894">
                  <c:v>6.5633333333333335E-2</c:v>
                </c:pt>
                <c:pt idx="895">
                  <c:v>6.59E-2</c:v>
                </c:pt>
                <c:pt idx="896">
                  <c:v>6.5850000000000006E-2</c:v>
                </c:pt>
                <c:pt idx="897">
                  <c:v>6.5916666666666665E-2</c:v>
                </c:pt>
                <c:pt idx="898">
                  <c:v>6.6083333333333341E-2</c:v>
                </c:pt>
                <c:pt idx="899">
                  <c:v>6.6099999999999992E-2</c:v>
                </c:pt>
                <c:pt idx="900">
                  <c:v>6.6349999999999992E-2</c:v>
                </c:pt>
                <c:pt idx="901">
                  <c:v>6.6750000000000004E-2</c:v>
                </c:pt>
                <c:pt idx="902">
                  <c:v>6.6799999999999998E-2</c:v>
                </c:pt>
                <c:pt idx="903">
                  <c:v>6.6533333333333333E-2</c:v>
                </c:pt>
                <c:pt idx="904">
                  <c:v>6.6983333333333339E-2</c:v>
                </c:pt>
                <c:pt idx="905">
                  <c:v>6.6583333333333328E-2</c:v>
                </c:pt>
                <c:pt idx="906">
                  <c:v>6.674999999999999E-2</c:v>
                </c:pt>
                <c:pt idx="907">
                  <c:v>6.6933333333333331E-2</c:v>
                </c:pt>
                <c:pt idx="908">
                  <c:v>6.6533333333333319E-2</c:v>
                </c:pt>
                <c:pt idx="909">
                  <c:v>6.6233333333333338E-2</c:v>
                </c:pt>
                <c:pt idx="910">
                  <c:v>6.5949999999999995E-2</c:v>
                </c:pt>
                <c:pt idx="911">
                  <c:v>6.5766666666666668E-2</c:v>
                </c:pt>
                <c:pt idx="912">
                  <c:v>6.5533333333333332E-2</c:v>
                </c:pt>
                <c:pt idx="913">
                  <c:v>6.6049999999999998E-2</c:v>
                </c:pt>
                <c:pt idx="914">
                  <c:v>6.6233333333333325E-2</c:v>
                </c:pt>
                <c:pt idx="915">
                  <c:v>6.6450000000000009E-2</c:v>
                </c:pt>
                <c:pt idx="916">
                  <c:v>6.6516666666666668E-2</c:v>
                </c:pt>
                <c:pt idx="917">
                  <c:v>6.6633333333333336E-2</c:v>
                </c:pt>
                <c:pt idx="918">
                  <c:v>6.6350000000000006E-2</c:v>
                </c:pt>
                <c:pt idx="919">
                  <c:v>6.6166666666666665E-2</c:v>
                </c:pt>
                <c:pt idx="920">
                  <c:v>6.6733333333333339E-2</c:v>
                </c:pt>
                <c:pt idx="921">
                  <c:v>6.6566666666666677E-2</c:v>
                </c:pt>
                <c:pt idx="922">
                  <c:v>6.6916666666666666E-2</c:v>
                </c:pt>
                <c:pt idx="923">
                  <c:v>6.7133333333333337E-2</c:v>
                </c:pt>
                <c:pt idx="924">
                  <c:v>6.6666666666666666E-2</c:v>
                </c:pt>
                <c:pt idx="925">
                  <c:v>6.6616666666666671E-2</c:v>
                </c:pt>
                <c:pt idx="926">
                  <c:v>6.6483333333333339E-2</c:v>
                </c:pt>
                <c:pt idx="927">
                  <c:v>6.7866666666666672E-2</c:v>
                </c:pt>
                <c:pt idx="928">
                  <c:v>6.8866666666666673E-2</c:v>
                </c:pt>
                <c:pt idx="929">
                  <c:v>7.0083333333333331E-2</c:v>
                </c:pt>
                <c:pt idx="930">
                  <c:v>7.1683333333333335E-2</c:v>
                </c:pt>
                <c:pt idx="931">
                  <c:v>7.2050000000000003E-2</c:v>
                </c:pt>
                <c:pt idx="932">
                  <c:v>7.2299999999999989E-2</c:v>
                </c:pt>
                <c:pt idx="933">
                  <c:v>7.2616666666666677E-2</c:v>
                </c:pt>
                <c:pt idx="934">
                  <c:v>7.2249999999999995E-2</c:v>
                </c:pt>
                <c:pt idx="935">
                  <c:v>7.195E-2</c:v>
                </c:pt>
                <c:pt idx="936">
                  <c:v>7.1800000000000003E-2</c:v>
                </c:pt>
                <c:pt idx="937">
                  <c:v>7.1216666666666664E-2</c:v>
                </c:pt>
                <c:pt idx="938">
                  <c:v>7.1199999999999999E-2</c:v>
                </c:pt>
                <c:pt idx="939">
                  <c:v>7.1216666666666664E-2</c:v>
                </c:pt>
                <c:pt idx="940">
                  <c:v>7.1466666666666664E-2</c:v>
                </c:pt>
                <c:pt idx="941">
                  <c:v>7.2033333333333338E-2</c:v>
                </c:pt>
                <c:pt idx="942">
                  <c:v>7.2450000000000001E-2</c:v>
                </c:pt>
                <c:pt idx="943">
                  <c:v>7.2150000000000006E-2</c:v>
                </c:pt>
                <c:pt idx="944">
                  <c:v>7.2316666666666682E-2</c:v>
                </c:pt>
                <c:pt idx="945">
                  <c:v>7.2416666666666671E-2</c:v>
                </c:pt>
                <c:pt idx="946">
                  <c:v>7.1900000000000006E-2</c:v>
                </c:pt>
                <c:pt idx="947">
                  <c:v>7.2350000000000012E-2</c:v>
                </c:pt>
                <c:pt idx="948">
                  <c:v>7.198333333333333E-2</c:v>
                </c:pt>
                <c:pt idx="949">
                  <c:v>7.1833333333333332E-2</c:v>
                </c:pt>
                <c:pt idx="950">
                  <c:v>7.2133333333333341E-2</c:v>
                </c:pt>
                <c:pt idx="951">
                  <c:v>7.0283333333333337E-2</c:v>
                </c:pt>
                <c:pt idx="952">
                  <c:v>6.8749999999999992E-2</c:v>
                </c:pt>
                <c:pt idx="953">
                  <c:v>6.7366666666666672E-2</c:v>
                </c:pt>
                <c:pt idx="954">
                  <c:v>6.5433333333333343E-2</c:v>
                </c:pt>
                <c:pt idx="955">
                  <c:v>6.5650000000000014E-2</c:v>
                </c:pt>
                <c:pt idx="956">
                  <c:v>6.6016666666666654E-2</c:v>
                </c:pt>
                <c:pt idx="957">
                  <c:v>6.6199999999999995E-2</c:v>
                </c:pt>
                <c:pt idx="958">
                  <c:v>6.6933333333333331E-2</c:v>
                </c:pt>
                <c:pt idx="959">
                  <c:v>6.7183333333333331E-2</c:v>
                </c:pt>
                <c:pt idx="960">
                  <c:v>6.6883333333333336E-2</c:v>
                </c:pt>
                <c:pt idx="961">
                  <c:v>6.6850000000000007E-2</c:v>
                </c:pt>
                <c:pt idx="962">
                  <c:v>6.5850000000000006E-2</c:v>
                </c:pt>
                <c:pt idx="963">
                  <c:v>6.5950000000000009E-2</c:v>
                </c:pt>
                <c:pt idx="964">
                  <c:v>6.6133333333333336E-2</c:v>
                </c:pt>
                <c:pt idx="965">
                  <c:v>6.6650000000000001E-2</c:v>
                </c:pt>
                <c:pt idx="966">
                  <c:v>6.6883333333333336E-2</c:v>
                </c:pt>
                <c:pt idx="967">
                  <c:v>6.6199999999999995E-2</c:v>
                </c:pt>
                <c:pt idx="968">
                  <c:v>6.6033333333333319E-2</c:v>
                </c:pt>
                <c:pt idx="969">
                  <c:v>6.5716666666666659E-2</c:v>
                </c:pt>
                <c:pt idx="970">
                  <c:v>6.6549999999999998E-2</c:v>
                </c:pt>
                <c:pt idx="971">
                  <c:v>6.7033333333333334E-2</c:v>
                </c:pt>
                <c:pt idx="972">
                  <c:v>6.674999999999999E-2</c:v>
                </c:pt>
                <c:pt idx="973">
                  <c:v>6.6983333333333325E-2</c:v>
                </c:pt>
                <c:pt idx="974">
                  <c:v>6.696666666666666E-2</c:v>
                </c:pt>
                <c:pt idx="975">
                  <c:v>6.731666666666665E-2</c:v>
                </c:pt>
                <c:pt idx="976">
                  <c:v>6.8199999999999997E-2</c:v>
                </c:pt>
                <c:pt idx="977">
                  <c:v>6.7616666666666672E-2</c:v>
                </c:pt>
                <c:pt idx="978">
                  <c:v>6.7666666666666667E-2</c:v>
                </c:pt>
                <c:pt idx="979">
                  <c:v>6.6633333333333336E-2</c:v>
                </c:pt>
                <c:pt idx="980">
                  <c:v>6.6299999999999984E-2</c:v>
                </c:pt>
                <c:pt idx="981">
                  <c:v>6.6449999999999995E-2</c:v>
                </c:pt>
                <c:pt idx="982">
                  <c:v>6.6566666666666663E-2</c:v>
                </c:pt>
                <c:pt idx="983">
                  <c:v>6.7350000000000007E-2</c:v>
                </c:pt>
                <c:pt idx="984">
                  <c:v>6.7616666666666672E-2</c:v>
                </c:pt>
                <c:pt idx="985">
                  <c:v>6.7333333333333342E-2</c:v>
                </c:pt>
                <c:pt idx="986">
                  <c:v>6.724999999999999E-2</c:v>
                </c:pt>
                <c:pt idx="987">
                  <c:v>6.7750000000000005E-2</c:v>
                </c:pt>
                <c:pt idx="988">
                  <c:v>6.7650000000000002E-2</c:v>
                </c:pt>
                <c:pt idx="989">
                  <c:v>6.7833333333333329E-2</c:v>
                </c:pt>
                <c:pt idx="990">
                  <c:v>6.8683333333333332E-2</c:v>
                </c:pt>
                <c:pt idx="991">
                  <c:v>6.8483333333333327E-2</c:v>
                </c:pt>
                <c:pt idx="992">
                  <c:v>6.8850000000000008E-2</c:v>
                </c:pt>
                <c:pt idx="993">
                  <c:v>6.9449999999999998E-2</c:v>
                </c:pt>
                <c:pt idx="994">
                  <c:v>6.8800000000000014E-2</c:v>
                </c:pt>
                <c:pt idx="995">
                  <c:v>6.9433333333333333E-2</c:v>
                </c:pt>
                <c:pt idx="996">
                  <c:v>6.9749999999999993E-2</c:v>
                </c:pt>
                <c:pt idx="997">
                  <c:v>6.9533333333333336E-2</c:v>
                </c:pt>
                <c:pt idx="998">
                  <c:v>6.9966666666666677E-2</c:v>
                </c:pt>
                <c:pt idx="999">
                  <c:v>6.9983333333333328E-2</c:v>
                </c:pt>
                <c:pt idx="1000">
                  <c:v>7.0466666666666664E-2</c:v>
                </c:pt>
                <c:pt idx="1001">
                  <c:v>7.0466666666666664E-2</c:v>
                </c:pt>
                <c:pt idx="1002">
                  <c:v>7.0949999999999999E-2</c:v>
                </c:pt>
                <c:pt idx="1003">
                  <c:v>7.1333333333333332E-2</c:v>
                </c:pt>
                <c:pt idx="1004">
                  <c:v>7.113333333333334E-2</c:v>
                </c:pt>
                <c:pt idx="1005">
                  <c:v>7.2366666666666662E-2</c:v>
                </c:pt>
                <c:pt idx="1006">
                  <c:v>7.1716666666666665E-2</c:v>
                </c:pt>
                <c:pt idx="1007">
                  <c:v>7.2016666666666687E-2</c:v>
                </c:pt>
                <c:pt idx="1008">
                  <c:v>7.1516666666666673E-2</c:v>
                </c:pt>
                <c:pt idx="1009">
                  <c:v>7.088333333333334E-2</c:v>
                </c:pt>
                <c:pt idx="1010">
                  <c:v>7.091666666666667E-2</c:v>
                </c:pt>
                <c:pt idx="1011">
                  <c:v>7.1400000000000005E-2</c:v>
                </c:pt>
                <c:pt idx="1012">
                  <c:v>7.1766666666666659E-2</c:v>
                </c:pt>
                <c:pt idx="1013">
                  <c:v>7.2366666666666662E-2</c:v>
                </c:pt>
                <c:pt idx="1014">
                  <c:v>7.2533333333333325E-2</c:v>
                </c:pt>
                <c:pt idx="1015">
                  <c:v>7.1550000000000002E-2</c:v>
                </c:pt>
                <c:pt idx="1016">
                  <c:v>7.1333333333333346E-2</c:v>
                </c:pt>
                <c:pt idx="1017">
                  <c:v>7.1033333333333337E-2</c:v>
                </c:pt>
                <c:pt idx="1018">
                  <c:v>7.166666666666667E-2</c:v>
                </c:pt>
                <c:pt idx="1019">
                  <c:v>7.17E-2</c:v>
                </c:pt>
                <c:pt idx="1020">
                  <c:v>7.173333333333333E-2</c:v>
                </c:pt>
                <c:pt idx="1021">
                  <c:v>7.2416666666666671E-2</c:v>
                </c:pt>
                <c:pt idx="1022">
                  <c:v>7.1833333333333346E-2</c:v>
                </c:pt>
                <c:pt idx="1023">
                  <c:v>7.2316666666666668E-2</c:v>
                </c:pt>
                <c:pt idx="1024">
                  <c:v>7.3200000000000001E-2</c:v>
                </c:pt>
                <c:pt idx="1025">
                  <c:v>7.2816666666666682E-2</c:v>
                </c:pt>
                <c:pt idx="1026">
                  <c:v>7.3266666666666674E-2</c:v>
                </c:pt>
                <c:pt idx="1027">
                  <c:v>7.3400000000000007E-2</c:v>
                </c:pt>
                <c:pt idx="1028">
                  <c:v>7.3399999999999993E-2</c:v>
                </c:pt>
                <c:pt idx="1029">
                  <c:v>7.2816666666666668E-2</c:v>
                </c:pt>
                <c:pt idx="1030">
                  <c:v>7.3249999999999996E-2</c:v>
                </c:pt>
                <c:pt idx="1031">
                  <c:v>7.3283333333333339E-2</c:v>
                </c:pt>
                <c:pt idx="1032">
                  <c:v>7.3133333333333328E-2</c:v>
                </c:pt>
                <c:pt idx="1033">
                  <c:v>7.453333333333334E-2</c:v>
                </c:pt>
                <c:pt idx="1034">
                  <c:v>7.4099999999999985E-2</c:v>
                </c:pt>
                <c:pt idx="1035">
                  <c:v>7.4766666666666662E-2</c:v>
                </c:pt>
                <c:pt idx="1036">
                  <c:v>7.4833333333333335E-2</c:v>
                </c:pt>
                <c:pt idx="1037">
                  <c:v>7.4483333333333332E-2</c:v>
                </c:pt>
                <c:pt idx="1038">
                  <c:v>7.4799999999999991E-2</c:v>
                </c:pt>
                <c:pt idx="1039">
                  <c:v>7.4983333333333346E-2</c:v>
                </c:pt>
                <c:pt idx="1040">
                  <c:v>7.4749999999999997E-2</c:v>
                </c:pt>
                <c:pt idx="1041">
                  <c:v>7.4916666666666673E-2</c:v>
                </c:pt>
                <c:pt idx="1042">
                  <c:v>7.5399999999999995E-2</c:v>
                </c:pt>
                <c:pt idx="1043">
                  <c:v>7.5400000000000009E-2</c:v>
                </c:pt>
                <c:pt idx="1044">
                  <c:v>7.6300000000000007E-2</c:v>
                </c:pt>
                <c:pt idx="1045">
                  <c:v>7.5983333333333333E-2</c:v>
                </c:pt>
                <c:pt idx="1046">
                  <c:v>7.5683333333333339E-2</c:v>
                </c:pt>
                <c:pt idx="1047">
                  <c:v>7.5616666666666665E-2</c:v>
                </c:pt>
                <c:pt idx="1048">
                  <c:v>7.5733333333333333E-2</c:v>
                </c:pt>
                <c:pt idx="1049">
                  <c:v>7.6066666666666671E-2</c:v>
                </c:pt>
                <c:pt idx="1050">
                  <c:v>7.6683333333333339E-2</c:v>
                </c:pt>
                <c:pt idx="1051">
                  <c:v>7.7133333333333332E-2</c:v>
                </c:pt>
                <c:pt idx="1052">
                  <c:v>7.7483333333333335E-2</c:v>
                </c:pt>
                <c:pt idx="1053">
                  <c:v>7.7416666666666675E-2</c:v>
                </c:pt>
                <c:pt idx="1054">
                  <c:v>7.8083333333333338E-2</c:v>
                </c:pt>
                <c:pt idx="1055">
                  <c:v>7.7783333333333329E-2</c:v>
                </c:pt>
                <c:pt idx="1056">
                  <c:v>7.7849999999999989E-2</c:v>
                </c:pt>
                <c:pt idx="1057">
                  <c:v>7.85E-2</c:v>
                </c:pt>
                <c:pt idx="1058">
                  <c:v>7.803333333333333E-2</c:v>
                </c:pt>
                <c:pt idx="1059">
                  <c:v>7.853333333333333E-2</c:v>
                </c:pt>
                <c:pt idx="1060">
                  <c:v>7.8583333333333352E-2</c:v>
                </c:pt>
                <c:pt idx="1061">
                  <c:v>7.8966666666666671E-2</c:v>
                </c:pt>
                <c:pt idx="1062">
                  <c:v>7.9766666666666666E-2</c:v>
                </c:pt>
                <c:pt idx="1063">
                  <c:v>8.0116666666666669E-2</c:v>
                </c:pt>
                <c:pt idx="1064">
                  <c:v>8.0666666666666678E-2</c:v>
                </c:pt>
                <c:pt idx="1065">
                  <c:v>8.0633333333333321E-2</c:v>
                </c:pt>
                <c:pt idx="1066">
                  <c:v>7.9966666666666672E-2</c:v>
                </c:pt>
                <c:pt idx="1067">
                  <c:v>8.0216666666666658E-2</c:v>
                </c:pt>
                <c:pt idx="1068">
                  <c:v>8.0183333333333329E-2</c:v>
                </c:pt>
                <c:pt idx="1069">
                  <c:v>8.086666666666667E-2</c:v>
                </c:pt>
                <c:pt idx="1070">
                  <c:v>8.1649999999999986E-2</c:v>
                </c:pt>
                <c:pt idx="1071">
                  <c:v>8.1750000000000003E-2</c:v>
                </c:pt>
                <c:pt idx="1072">
                  <c:v>8.1650000000000014E-2</c:v>
                </c:pt>
                <c:pt idx="1073">
                  <c:v>8.1716666666666674E-2</c:v>
                </c:pt>
                <c:pt idx="1074">
                  <c:v>8.1949999999999995E-2</c:v>
                </c:pt>
                <c:pt idx="1075">
                  <c:v>8.1833333333333327E-2</c:v>
                </c:pt>
                <c:pt idx="1076">
                  <c:v>8.2250000000000004E-2</c:v>
                </c:pt>
                <c:pt idx="1077">
                  <c:v>8.216666666666668E-2</c:v>
                </c:pt>
                <c:pt idx="1078">
                  <c:v>8.2816666666666663E-2</c:v>
                </c:pt>
                <c:pt idx="1079">
                  <c:v>8.3799999999999999E-2</c:v>
                </c:pt>
                <c:pt idx="1080">
                  <c:v>8.3850000000000022E-2</c:v>
                </c:pt>
                <c:pt idx="1081">
                  <c:v>8.426666666666667E-2</c:v>
                </c:pt>
                <c:pt idx="1082">
                  <c:v>8.4216666666666662E-2</c:v>
                </c:pt>
                <c:pt idx="1083">
                  <c:v>8.4833333333333358E-2</c:v>
                </c:pt>
                <c:pt idx="1084">
                  <c:v>8.5916666666666683E-2</c:v>
                </c:pt>
                <c:pt idx="1085">
                  <c:v>8.6416666666666656E-2</c:v>
                </c:pt>
                <c:pt idx="1086">
                  <c:v>8.7216666666666665E-2</c:v>
                </c:pt>
                <c:pt idx="1087">
                  <c:v>8.6716666666666664E-2</c:v>
                </c:pt>
                <c:pt idx="1088">
                  <c:v>8.6616666666666675E-2</c:v>
                </c:pt>
                <c:pt idx="1089">
                  <c:v>8.7050000000000002E-2</c:v>
                </c:pt>
                <c:pt idx="1090">
                  <c:v>8.6883333333333354E-2</c:v>
                </c:pt>
                <c:pt idx="1091">
                  <c:v>8.7799999999999989E-2</c:v>
                </c:pt>
                <c:pt idx="1092">
                  <c:v>8.7749999999999995E-2</c:v>
                </c:pt>
                <c:pt idx="1093">
                  <c:v>8.8333333333333333E-2</c:v>
                </c:pt>
                <c:pt idx="1094">
                  <c:v>8.9016666666666674E-2</c:v>
                </c:pt>
                <c:pt idx="1095">
                  <c:v>8.9116666666666663E-2</c:v>
                </c:pt>
                <c:pt idx="1096">
                  <c:v>8.9716666666666667E-2</c:v>
                </c:pt>
                <c:pt idx="1097">
                  <c:v>8.9666666666666672E-2</c:v>
                </c:pt>
                <c:pt idx="1098">
                  <c:v>8.9866666666666664E-2</c:v>
                </c:pt>
                <c:pt idx="1099">
                  <c:v>8.9916666666666686E-2</c:v>
                </c:pt>
                <c:pt idx="1100">
                  <c:v>9.0466666666666654E-2</c:v>
                </c:pt>
                <c:pt idx="1101">
                  <c:v>9.113333333333333E-2</c:v>
                </c:pt>
                <c:pt idx="1102">
                  <c:v>9.169999999999999E-2</c:v>
                </c:pt>
                <c:pt idx="1103">
                  <c:v>9.2716666666666656E-2</c:v>
                </c:pt>
                <c:pt idx="1104">
                  <c:v>9.3466666666666684E-2</c:v>
                </c:pt>
                <c:pt idx="1105">
                  <c:v>9.3816666666666673E-2</c:v>
                </c:pt>
                <c:pt idx="1106">
                  <c:v>9.3883333333333319E-2</c:v>
                </c:pt>
                <c:pt idx="1107">
                  <c:v>9.431666666666666E-2</c:v>
                </c:pt>
                <c:pt idx="1108">
                  <c:v>9.4983333333333322E-2</c:v>
                </c:pt>
                <c:pt idx="1109">
                  <c:v>9.5049999999999982E-2</c:v>
                </c:pt>
                <c:pt idx="1110">
                  <c:v>9.5733333333333323E-2</c:v>
                </c:pt>
                <c:pt idx="1111">
                  <c:v>9.551666666666668E-2</c:v>
                </c:pt>
                <c:pt idx="1112">
                  <c:v>9.6133333333333335E-2</c:v>
                </c:pt>
                <c:pt idx="1113">
                  <c:v>9.743333333333333E-2</c:v>
                </c:pt>
                <c:pt idx="1114">
                  <c:v>9.8133333333333336E-2</c:v>
                </c:pt>
                <c:pt idx="1115">
                  <c:v>9.8966666666666661E-2</c:v>
                </c:pt>
                <c:pt idx="1116">
                  <c:v>9.9100000000000008E-2</c:v>
                </c:pt>
                <c:pt idx="1117">
                  <c:v>9.9499999999999991E-2</c:v>
                </c:pt>
                <c:pt idx="1118">
                  <c:v>0.10014999999999998</c:v>
                </c:pt>
                <c:pt idx="1119">
                  <c:v>0.10073333333333334</c:v>
                </c:pt>
                <c:pt idx="1120">
                  <c:v>0.10148333333333333</c:v>
                </c:pt>
                <c:pt idx="1121">
                  <c:v>0.10268333333333333</c:v>
                </c:pt>
                <c:pt idx="1122">
                  <c:v>0.10331666666666668</c:v>
                </c:pt>
                <c:pt idx="1123">
                  <c:v>0.10426666666666666</c:v>
                </c:pt>
                <c:pt idx="1124">
                  <c:v>0.10516666666666667</c:v>
                </c:pt>
                <c:pt idx="1125">
                  <c:v>0.10561666666666668</c:v>
                </c:pt>
                <c:pt idx="1126">
                  <c:v>0.10651666666666666</c:v>
                </c:pt>
                <c:pt idx="1127">
                  <c:v>0.10741666666666667</c:v>
                </c:pt>
                <c:pt idx="1128">
                  <c:v>0.10819999999999998</c:v>
                </c:pt>
                <c:pt idx="1129">
                  <c:v>0.10856666666666666</c:v>
                </c:pt>
                <c:pt idx="1130">
                  <c:v>0.10963333333333335</c:v>
                </c:pt>
                <c:pt idx="1131">
                  <c:v>0.11018333333333336</c:v>
                </c:pt>
                <c:pt idx="1132">
                  <c:v>0.11101666666666665</c:v>
                </c:pt>
                <c:pt idx="1133">
                  <c:v>0.11173333333333335</c:v>
                </c:pt>
                <c:pt idx="1134">
                  <c:v>0.11171666666666669</c:v>
                </c:pt>
                <c:pt idx="1135">
                  <c:v>0.11286666666666667</c:v>
                </c:pt>
                <c:pt idx="1136">
                  <c:v>0.11314999999999999</c:v>
                </c:pt>
                <c:pt idx="1137">
                  <c:v>0.11459999999999999</c:v>
                </c:pt>
                <c:pt idx="1138">
                  <c:v>0.11559999999999999</c:v>
                </c:pt>
                <c:pt idx="1139">
                  <c:v>0.11703333333333334</c:v>
                </c:pt>
                <c:pt idx="1140">
                  <c:v>0.11806666666666667</c:v>
                </c:pt>
                <c:pt idx="1141">
                  <c:v>0.11888333333333334</c:v>
                </c:pt>
                <c:pt idx="1142">
                  <c:v>0.11990000000000001</c:v>
                </c:pt>
                <c:pt idx="1143">
                  <c:v>0.11985000000000001</c:v>
                </c:pt>
                <c:pt idx="1144">
                  <c:v>0.12154999999999998</c:v>
                </c:pt>
                <c:pt idx="1145">
                  <c:v>0.12195</c:v>
                </c:pt>
                <c:pt idx="1146">
                  <c:v>0.12326666666666665</c:v>
                </c:pt>
                <c:pt idx="1147">
                  <c:v>0.12488333333333333</c:v>
                </c:pt>
                <c:pt idx="1148">
                  <c:v>0.12566666666666668</c:v>
                </c:pt>
                <c:pt idx="1149">
                  <c:v>0.12658333333333335</c:v>
                </c:pt>
                <c:pt idx="1150">
                  <c:v>0.12723333333333334</c:v>
                </c:pt>
                <c:pt idx="1151">
                  <c:v>0.12813333333333335</c:v>
                </c:pt>
                <c:pt idx="1152">
                  <c:v>0.12901666666666667</c:v>
                </c:pt>
                <c:pt idx="1153">
                  <c:v>0.13040000000000002</c:v>
                </c:pt>
                <c:pt idx="1154">
                  <c:v>0.13091666666666668</c:v>
                </c:pt>
                <c:pt idx="1155">
                  <c:v>0.13111666666666669</c:v>
                </c:pt>
                <c:pt idx="1156">
                  <c:v>0.13175000000000001</c:v>
                </c:pt>
                <c:pt idx="1157">
                  <c:v>0.13226666666666667</c:v>
                </c:pt>
                <c:pt idx="1158">
                  <c:v>0.1328</c:v>
                </c:pt>
                <c:pt idx="1159">
                  <c:v>0.13341666666666666</c:v>
                </c:pt>
                <c:pt idx="1160">
                  <c:v>0.1341</c:v>
                </c:pt>
                <c:pt idx="1161">
                  <c:v>0.1351</c:v>
                </c:pt>
                <c:pt idx="1162">
                  <c:v>0.13608333333333333</c:v>
                </c:pt>
                <c:pt idx="1163">
                  <c:v>0.13621666666666668</c:v>
                </c:pt>
                <c:pt idx="1164">
                  <c:v>0.13638333333333333</c:v>
                </c:pt>
                <c:pt idx="1165">
                  <c:v>0.13636666666666666</c:v>
                </c:pt>
                <c:pt idx="1166">
                  <c:v>0.13678333333333334</c:v>
                </c:pt>
                <c:pt idx="1167">
                  <c:v>0.13798333333333335</c:v>
                </c:pt>
                <c:pt idx="1168">
                  <c:v>0.13826666666666668</c:v>
                </c:pt>
                <c:pt idx="1169">
                  <c:v>0.13890000000000002</c:v>
                </c:pt>
                <c:pt idx="1170">
                  <c:v>0.13886666666666667</c:v>
                </c:pt>
                <c:pt idx="1171">
                  <c:v>0.13835</c:v>
                </c:pt>
                <c:pt idx="1172">
                  <c:v>0.13843333333333332</c:v>
                </c:pt>
                <c:pt idx="1173">
                  <c:v>0.13853333333333334</c:v>
                </c:pt>
                <c:pt idx="1174">
                  <c:v>0.13843333333333332</c:v>
                </c:pt>
                <c:pt idx="1175">
                  <c:v>0.13863333333333333</c:v>
                </c:pt>
                <c:pt idx="1176">
                  <c:v>0.13861666666666669</c:v>
                </c:pt>
                <c:pt idx="1177">
                  <c:v>0.13801666666666668</c:v>
                </c:pt>
                <c:pt idx="1178">
                  <c:v>0.13815</c:v>
                </c:pt>
                <c:pt idx="1179">
                  <c:v>0.13811666666666667</c:v>
                </c:pt>
                <c:pt idx="1180">
                  <c:v>0.13821666666666668</c:v>
                </c:pt>
                <c:pt idx="1181">
                  <c:v>0.13856666666666664</c:v>
                </c:pt>
                <c:pt idx="1182">
                  <c:v>0.13863333333333336</c:v>
                </c:pt>
                <c:pt idx="1183">
                  <c:v>0.13851666666666665</c:v>
                </c:pt>
                <c:pt idx="1184">
                  <c:v>0.13823333333333335</c:v>
                </c:pt>
                <c:pt idx="1185">
                  <c:v>0.13785</c:v>
                </c:pt>
                <c:pt idx="1186">
                  <c:v>0.13721666666666665</c:v>
                </c:pt>
                <c:pt idx="1187">
                  <c:v>0.13716666666666666</c:v>
                </c:pt>
                <c:pt idx="1188">
                  <c:v>0.13763333333333336</c:v>
                </c:pt>
                <c:pt idx="1189">
                  <c:v>0.13780000000000001</c:v>
                </c:pt>
                <c:pt idx="1190">
                  <c:v>0.13800000000000001</c:v>
                </c:pt>
                <c:pt idx="1191">
                  <c:v>0.13818333333333332</c:v>
                </c:pt>
                <c:pt idx="1192">
                  <c:v>0.13783333333333334</c:v>
                </c:pt>
                <c:pt idx="1193">
                  <c:v>0.13826666666666668</c:v>
                </c:pt>
                <c:pt idx="1194">
                  <c:v>0.13841666666666669</c:v>
                </c:pt>
                <c:pt idx="1195">
                  <c:v>0.13863333333333336</c:v>
                </c:pt>
                <c:pt idx="1196">
                  <c:v>0.13878333333333334</c:v>
                </c:pt>
                <c:pt idx="1197">
                  <c:v>0.13915</c:v>
                </c:pt>
                <c:pt idx="1198">
                  <c:v>0.13960000000000003</c:v>
                </c:pt>
                <c:pt idx="1199">
                  <c:v>0.14048333333333332</c:v>
                </c:pt>
                <c:pt idx="1200">
                  <c:v>0.14083333333333337</c:v>
                </c:pt>
                <c:pt idx="1201">
                  <c:v>0.14141666666666666</c:v>
                </c:pt>
                <c:pt idx="1202">
                  <c:v>0.14211666666666667</c:v>
                </c:pt>
                <c:pt idx="1203">
                  <c:v>0.14344999999999999</c:v>
                </c:pt>
                <c:pt idx="1204">
                  <c:v>0.1449</c:v>
                </c:pt>
                <c:pt idx="1205">
                  <c:v>0.14538333333333334</c:v>
                </c:pt>
                <c:pt idx="1206">
                  <c:v>0.14673333333333335</c:v>
                </c:pt>
                <c:pt idx="1207">
                  <c:v>0.14696666666666666</c:v>
                </c:pt>
                <c:pt idx="1208">
                  <c:v>0.14781666666666668</c:v>
                </c:pt>
                <c:pt idx="1209">
                  <c:v>0.14886666666666667</c:v>
                </c:pt>
                <c:pt idx="1210">
                  <c:v>0.14973333333333333</c:v>
                </c:pt>
                <c:pt idx="1211">
                  <c:v>0.15053333333333338</c:v>
                </c:pt>
                <c:pt idx="1212">
                  <c:v>0.15195</c:v>
                </c:pt>
                <c:pt idx="1213">
                  <c:v>0.15360000000000001</c:v>
                </c:pt>
                <c:pt idx="1214">
                  <c:v>0.15410000000000001</c:v>
                </c:pt>
                <c:pt idx="1215">
                  <c:v>0.15551666666666666</c:v>
                </c:pt>
                <c:pt idx="1216">
                  <c:v>0.15676666666666669</c:v>
                </c:pt>
                <c:pt idx="1217">
                  <c:v>0.15763333333333335</c:v>
                </c:pt>
                <c:pt idx="1218">
                  <c:v>0.15946666666666667</c:v>
                </c:pt>
                <c:pt idx="1219">
                  <c:v>0.16068333333333332</c:v>
                </c:pt>
                <c:pt idx="1220">
                  <c:v>0.16185000000000002</c:v>
                </c:pt>
                <c:pt idx="1221">
                  <c:v>0.16343333333333335</c:v>
                </c:pt>
                <c:pt idx="1222">
                  <c:v>0.16521666666666665</c:v>
                </c:pt>
                <c:pt idx="1223">
                  <c:v>0.16498333333333334</c:v>
                </c:pt>
                <c:pt idx="1224">
                  <c:v>0.16500000000000001</c:v>
                </c:pt>
                <c:pt idx="1225">
                  <c:v>0.16466666666666668</c:v>
                </c:pt>
                <c:pt idx="1226">
                  <c:v>0.16456666666666667</c:v>
                </c:pt>
                <c:pt idx="1227">
                  <c:v>0.1663</c:v>
                </c:pt>
                <c:pt idx="1228">
                  <c:v>0.16753333333333331</c:v>
                </c:pt>
                <c:pt idx="1229">
                  <c:v>0.16928333333333334</c:v>
                </c:pt>
                <c:pt idx="1230">
                  <c:v>0.17076666666666671</c:v>
                </c:pt>
                <c:pt idx="1231">
                  <c:v>0.1718166666666667</c:v>
                </c:pt>
                <c:pt idx="1232">
                  <c:v>0.17323333333333332</c:v>
                </c:pt>
                <c:pt idx="1233">
                  <c:v>0.17426666666666668</c:v>
                </c:pt>
                <c:pt idx="1234">
                  <c:v>0.17545000000000002</c:v>
                </c:pt>
                <c:pt idx="1235">
                  <c:v>0.17731666666666665</c:v>
                </c:pt>
                <c:pt idx="1236">
                  <c:v>0.1791666666666667</c:v>
                </c:pt>
                <c:pt idx="1237">
                  <c:v>0.18058333333333332</c:v>
                </c:pt>
                <c:pt idx="1238">
                  <c:v>0.18190000000000003</c:v>
                </c:pt>
                <c:pt idx="1239">
                  <c:v>0.18276666666666666</c:v>
                </c:pt>
                <c:pt idx="1240">
                  <c:v>0.18326666666666669</c:v>
                </c:pt>
                <c:pt idx="1241">
                  <c:v>0.18451666666666666</c:v>
                </c:pt>
                <c:pt idx="1242">
                  <c:v>0.18573333333333331</c:v>
                </c:pt>
                <c:pt idx="1243">
                  <c:v>0.18684999999999999</c:v>
                </c:pt>
                <c:pt idx="1244">
                  <c:v>0.18863333333333332</c:v>
                </c:pt>
                <c:pt idx="1245">
                  <c:v>0.18971666666666664</c:v>
                </c:pt>
                <c:pt idx="1246">
                  <c:v>0.19099999999999998</c:v>
                </c:pt>
                <c:pt idx="1247">
                  <c:v>0.19228333333333333</c:v>
                </c:pt>
                <c:pt idx="1248">
                  <c:v>0.19273333333333334</c:v>
                </c:pt>
                <c:pt idx="1249">
                  <c:v>0.19383333333333339</c:v>
                </c:pt>
                <c:pt idx="1250">
                  <c:v>0.19445000000000001</c:v>
                </c:pt>
                <c:pt idx="1251">
                  <c:v>0.19523333333333334</c:v>
                </c:pt>
                <c:pt idx="1252">
                  <c:v>0.19601666666666664</c:v>
                </c:pt>
                <c:pt idx="1253">
                  <c:v>0.19631666666666667</c:v>
                </c:pt>
              </c:numCache>
            </c:numRef>
          </c:yVal>
          <c:smooth val="1"/>
          <c:extLst>
            <c:ext xmlns:c16="http://schemas.microsoft.com/office/drawing/2014/chart" uri="{C3380CC4-5D6E-409C-BE32-E72D297353CC}">
              <c16:uniqueId val="{00000002-AA13-49CE-A792-B5AEE7BA5538}"/>
            </c:ext>
          </c:extLst>
        </c:ser>
        <c:ser>
          <c:idx val="5"/>
          <c:order val="3"/>
          <c:tx>
            <c:strRef>
              <c:f>Hoja1!$BY$1</c:f>
              <c:strCache>
                <c:ptCount val="1"/>
                <c:pt idx="0">
                  <c:v>6d</c:v>
                </c:pt>
              </c:strCache>
            </c:strRef>
          </c:tx>
          <c:spPr>
            <a:ln>
              <a:solidFill>
                <a:srgbClr val="4F81BD"/>
              </a:solidFill>
              <a:prstDash val="lgDash"/>
            </a:ln>
          </c:spPr>
          <c:marker>
            <c:symbol val="none"/>
          </c:marker>
          <c:xVal>
            <c:numRef>
              <c:f>Hoja1!$BS$2:$BS$1255</c:f>
              <c:numCache>
                <c:formatCode>General</c:formatCode>
                <c:ptCount val="1254"/>
                <c:pt idx="2" formatCode="h:mm">
                  <c:v>0.68125000000000002</c:v>
                </c:pt>
                <c:pt idx="3">
                  <c:v>550</c:v>
                </c:pt>
                <c:pt idx="4">
                  <c:v>549.79999999999995</c:v>
                </c:pt>
                <c:pt idx="5">
                  <c:v>549.6</c:v>
                </c:pt>
                <c:pt idx="6">
                  <c:v>549.4</c:v>
                </c:pt>
                <c:pt idx="7">
                  <c:v>549.20000000000005</c:v>
                </c:pt>
                <c:pt idx="8">
                  <c:v>549</c:v>
                </c:pt>
                <c:pt idx="9">
                  <c:v>548.79999999999995</c:v>
                </c:pt>
                <c:pt idx="10">
                  <c:v>548.6</c:v>
                </c:pt>
                <c:pt idx="11">
                  <c:v>548.4</c:v>
                </c:pt>
                <c:pt idx="12">
                  <c:v>548.20000000000005</c:v>
                </c:pt>
                <c:pt idx="13">
                  <c:v>548</c:v>
                </c:pt>
                <c:pt idx="14">
                  <c:v>547.79999999999995</c:v>
                </c:pt>
                <c:pt idx="15">
                  <c:v>547.6</c:v>
                </c:pt>
                <c:pt idx="16">
                  <c:v>547.4</c:v>
                </c:pt>
                <c:pt idx="17">
                  <c:v>547.20000000000005</c:v>
                </c:pt>
                <c:pt idx="18">
                  <c:v>547</c:v>
                </c:pt>
                <c:pt idx="19">
                  <c:v>546.79999999999995</c:v>
                </c:pt>
                <c:pt idx="20">
                  <c:v>546.6</c:v>
                </c:pt>
                <c:pt idx="21">
                  <c:v>546.4</c:v>
                </c:pt>
                <c:pt idx="22">
                  <c:v>546.20000000000005</c:v>
                </c:pt>
                <c:pt idx="23">
                  <c:v>546</c:v>
                </c:pt>
                <c:pt idx="24">
                  <c:v>545.79999999999995</c:v>
                </c:pt>
                <c:pt idx="25">
                  <c:v>545.6</c:v>
                </c:pt>
                <c:pt idx="26">
                  <c:v>545.4</c:v>
                </c:pt>
                <c:pt idx="27">
                  <c:v>545.20000000000005</c:v>
                </c:pt>
                <c:pt idx="28">
                  <c:v>545</c:v>
                </c:pt>
                <c:pt idx="29">
                  <c:v>544.79999999999995</c:v>
                </c:pt>
                <c:pt idx="30">
                  <c:v>544.6</c:v>
                </c:pt>
                <c:pt idx="31">
                  <c:v>544.4</c:v>
                </c:pt>
                <c:pt idx="32">
                  <c:v>544.20000000000005</c:v>
                </c:pt>
                <c:pt idx="33">
                  <c:v>544</c:v>
                </c:pt>
                <c:pt idx="34">
                  <c:v>543.79999999999995</c:v>
                </c:pt>
                <c:pt idx="35">
                  <c:v>543.6</c:v>
                </c:pt>
                <c:pt idx="36">
                  <c:v>543.4</c:v>
                </c:pt>
                <c:pt idx="37">
                  <c:v>543.20000000000005</c:v>
                </c:pt>
                <c:pt idx="38">
                  <c:v>543</c:v>
                </c:pt>
                <c:pt idx="39">
                  <c:v>542.79999999999995</c:v>
                </c:pt>
                <c:pt idx="40">
                  <c:v>542.6</c:v>
                </c:pt>
                <c:pt idx="41">
                  <c:v>542.4</c:v>
                </c:pt>
                <c:pt idx="42">
                  <c:v>542.20000000000005</c:v>
                </c:pt>
                <c:pt idx="43">
                  <c:v>542</c:v>
                </c:pt>
                <c:pt idx="44">
                  <c:v>541.79999999999995</c:v>
                </c:pt>
                <c:pt idx="45">
                  <c:v>541.6</c:v>
                </c:pt>
                <c:pt idx="46">
                  <c:v>541.4</c:v>
                </c:pt>
                <c:pt idx="47">
                  <c:v>541.20000000000005</c:v>
                </c:pt>
                <c:pt idx="48">
                  <c:v>541</c:v>
                </c:pt>
                <c:pt idx="49">
                  <c:v>540.79999999999995</c:v>
                </c:pt>
                <c:pt idx="50">
                  <c:v>540.6</c:v>
                </c:pt>
                <c:pt idx="51">
                  <c:v>540.4</c:v>
                </c:pt>
                <c:pt idx="52">
                  <c:v>540.20000000000005</c:v>
                </c:pt>
                <c:pt idx="53">
                  <c:v>540</c:v>
                </c:pt>
                <c:pt idx="54">
                  <c:v>539.79999999999995</c:v>
                </c:pt>
                <c:pt idx="55">
                  <c:v>539.6</c:v>
                </c:pt>
                <c:pt idx="56">
                  <c:v>539.4</c:v>
                </c:pt>
                <c:pt idx="57">
                  <c:v>539.20000000000005</c:v>
                </c:pt>
                <c:pt idx="58">
                  <c:v>539</c:v>
                </c:pt>
                <c:pt idx="59">
                  <c:v>538.79999999999995</c:v>
                </c:pt>
                <c:pt idx="60">
                  <c:v>538.6</c:v>
                </c:pt>
                <c:pt idx="61">
                  <c:v>538.4</c:v>
                </c:pt>
                <c:pt idx="62">
                  <c:v>538.20000000000005</c:v>
                </c:pt>
                <c:pt idx="63">
                  <c:v>538</c:v>
                </c:pt>
                <c:pt idx="64">
                  <c:v>537.79999999999995</c:v>
                </c:pt>
                <c:pt idx="65">
                  <c:v>537.6</c:v>
                </c:pt>
                <c:pt idx="66">
                  <c:v>537.4</c:v>
                </c:pt>
                <c:pt idx="67">
                  <c:v>537.20000000000005</c:v>
                </c:pt>
                <c:pt idx="68">
                  <c:v>537</c:v>
                </c:pt>
                <c:pt idx="69">
                  <c:v>536.79999999999995</c:v>
                </c:pt>
                <c:pt idx="70">
                  <c:v>536.6</c:v>
                </c:pt>
                <c:pt idx="71">
                  <c:v>536.4</c:v>
                </c:pt>
                <c:pt idx="72">
                  <c:v>536.20000000000005</c:v>
                </c:pt>
                <c:pt idx="73">
                  <c:v>536</c:v>
                </c:pt>
                <c:pt idx="74">
                  <c:v>535.79999999999995</c:v>
                </c:pt>
                <c:pt idx="75">
                  <c:v>535.6</c:v>
                </c:pt>
                <c:pt idx="76">
                  <c:v>535.4</c:v>
                </c:pt>
                <c:pt idx="77">
                  <c:v>535.20000000000005</c:v>
                </c:pt>
                <c:pt idx="78">
                  <c:v>535</c:v>
                </c:pt>
                <c:pt idx="79">
                  <c:v>534.79999999999995</c:v>
                </c:pt>
                <c:pt idx="80">
                  <c:v>534.6</c:v>
                </c:pt>
                <c:pt idx="81">
                  <c:v>534.4</c:v>
                </c:pt>
                <c:pt idx="82">
                  <c:v>534.20000000000005</c:v>
                </c:pt>
                <c:pt idx="83">
                  <c:v>534</c:v>
                </c:pt>
                <c:pt idx="84">
                  <c:v>533.79999999999995</c:v>
                </c:pt>
                <c:pt idx="85">
                  <c:v>533.6</c:v>
                </c:pt>
                <c:pt idx="86">
                  <c:v>533.4</c:v>
                </c:pt>
                <c:pt idx="87">
                  <c:v>533.20000000000005</c:v>
                </c:pt>
                <c:pt idx="88">
                  <c:v>533</c:v>
                </c:pt>
                <c:pt idx="89">
                  <c:v>532.79999999999995</c:v>
                </c:pt>
                <c:pt idx="90">
                  <c:v>532.6</c:v>
                </c:pt>
                <c:pt idx="91">
                  <c:v>532.4</c:v>
                </c:pt>
                <c:pt idx="92">
                  <c:v>532.20000000000005</c:v>
                </c:pt>
                <c:pt idx="93">
                  <c:v>532</c:v>
                </c:pt>
                <c:pt idx="94">
                  <c:v>531.79999999999995</c:v>
                </c:pt>
                <c:pt idx="95">
                  <c:v>531.6</c:v>
                </c:pt>
                <c:pt idx="96">
                  <c:v>531.4</c:v>
                </c:pt>
                <c:pt idx="97">
                  <c:v>531.20000000000005</c:v>
                </c:pt>
                <c:pt idx="98">
                  <c:v>531</c:v>
                </c:pt>
                <c:pt idx="99">
                  <c:v>530.79999999999995</c:v>
                </c:pt>
                <c:pt idx="100">
                  <c:v>530.6</c:v>
                </c:pt>
                <c:pt idx="101">
                  <c:v>530.4</c:v>
                </c:pt>
                <c:pt idx="102">
                  <c:v>530.20000000000005</c:v>
                </c:pt>
                <c:pt idx="103">
                  <c:v>530</c:v>
                </c:pt>
                <c:pt idx="104">
                  <c:v>529.79999999999995</c:v>
                </c:pt>
                <c:pt idx="105">
                  <c:v>529.6</c:v>
                </c:pt>
                <c:pt idx="106">
                  <c:v>529.4</c:v>
                </c:pt>
                <c:pt idx="107">
                  <c:v>529.20000000000005</c:v>
                </c:pt>
                <c:pt idx="108">
                  <c:v>529</c:v>
                </c:pt>
                <c:pt idx="109">
                  <c:v>528.79999999999995</c:v>
                </c:pt>
                <c:pt idx="110">
                  <c:v>528.6</c:v>
                </c:pt>
                <c:pt idx="111">
                  <c:v>528.4</c:v>
                </c:pt>
                <c:pt idx="112">
                  <c:v>528.20000000000005</c:v>
                </c:pt>
                <c:pt idx="113">
                  <c:v>528</c:v>
                </c:pt>
                <c:pt idx="114">
                  <c:v>527.79999999999995</c:v>
                </c:pt>
                <c:pt idx="115">
                  <c:v>527.6</c:v>
                </c:pt>
                <c:pt idx="116">
                  <c:v>527.4</c:v>
                </c:pt>
                <c:pt idx="117">
                  <c:v>527.20000000000005</c:v>
                </c:pt>
                <c:pt idx="118">
                  <c:v>527</c:v>
                </c:pt>
                <c:pt idx="119">
                  <c:v>526.79999999999995</c:v>
                </c:pt>
                <c:pt idx="120">
                  <c:v>526.6</c:v>
                </c:pt>
                <c:pt idx="121">
                  <c:v>526.4</c:v>
                </c:pt>
                <c:pt idx="122">
                  <c:v>526.20000000000005</c:v>
                </c:pt>
                <c:pt idx="123">
                  <c:v>526</c:v>
                </c:pt>
                <c:pt idx="124">
                  <c:v>525.79999999999995</c:v>
                </c:pt>
                <c:pt idx="125">
                  <c:v>525.6</c:v>
                </c:pt>
                <c:pt idx="126">
                  <c:v>525.4</c:v>
                </c:pt>
                <c:pt idx="127">
                  <c:v>525.20000000000005</c:v>
                </c:pt>
                <c:pt idx="128">
                  <c:v>525</c:v>
                </c:pt>
                <c:pt idx="129">
                  <c:v>524.79999999999995</c:v>
                </c:pt>
                <c:pt idx="130">
                  <c:v>524.6</c:v>
                </c:pt>
                <c:pt idx="131">
                  <c:v>524.4</c:v>
                </c:pt>
                <c:pt idx="132">
                  <c:v>524.20000000000005</c:v>
                </c:pt>
                <c:pt idx="133">
                  <c:v>524</c:v>
                </c:pt>
                <c:pt idx="134">
                  <c:v>523.79999999999995</c:v>
                </c:pt>
                <c:pt idx="135">
                  <c:v>523.6</c:v>
                </c:pt>
                <c:pt idx="136">
                  <c:v>523.4</c:v>
                </c:pt>
                <c:pt idx="137">
                  <c:v>523.20000000000005</c:v>
                </c:pt>
                <c:pt idx="138">
                  <c:v>523</c:v>
                </c:pt>
                <c:pt idx="139">
                  <c:v>522.79999999999995</c:v>
                </c:pt>
                <c:pt idx="140">
                  <c:v>522.6</c:v>
                </c:pt>
                <c:pt idx="141">
                  <c:v>522.4</c:v>
                </c:pt>
                <c:pt idx="142">
                  <c:v>522.20000000000005</c:v>
                </c:pt>
                <c:pt idx="143">
                  <c:v>522</c:v>
                </c:pt>
                <c:pt idx="144">
                  <c:v>521.79999999999995</c:v>
                </c:pt>
                <c:pt idx="145">
                  <c:v>521.6</c:v>
                </c:pt>
                <c:pt idx="146">
                  <c:v>521.4</c:v>
                </c:pt>
                <c:pt idx="147">
                  <c:v>521.20000000000005</c:v>
                </c:pt>
                <c:pt idx="148">
                  <c:v>521</c:v>
                </c:pt>
                <c:pt idx="149">
                  <c:v>520.79999999999995</c:v>
                </c:pt>
                <c:pt idx="150">
                  <c:v>520.6</c:v>
                </c:pt>
                <c:pt idx="151">
                  <c:v>520.4</c:v>
                </c:pt>
                <c:pt idx="152">
                  <c:v>520.20000000000005</c:v>
                </c:pt>
                <c:pt idx="153">
                  <c:v>520</c:v>
                </c:pt>
                <c:pt idx="154">
                  <c:v>519.79999999999995</c:v>
                </c:pt>
                <c:pt idx="155">
                  <c:v>519.6</c:v>
                </c:pt>
                <c:pt idx="156">
                  <c:v>519.4</c:v>
                </c:pt>
                <c:pt idx="157">
                  <c:v>519.20000000000005</c:v>
                </c:pt>
                <c:pt idx="158">
                  <c:v>519</c:v>
                </c:pt>
                <c:pt idx="159">
                  <c:v>518.79999999999995</c:v>
                </c:pt>
                <c:pt idx="160">
                  <c:v>518.6</c:v>
                </c:pt>
                <c:pt idx="161">
                  <c:v>518.4</c:v>
                </c:pt>
                <c:pt idx="162">
                  <c:v>518.20000000000005</c:v>
                </c:pt>
                <c:pt idx="163">
                  <c:v>518</c:v>
                </c:pt>
                <c:pt idx="164">
                  <c:v>517.79999999999995</c:v>
                </c:pt>
                <c:pt idx="165">
                  <c:v>517.6</c:v>
                </c:pt>
                <c:pt idx="166">
                  <c:v>517.4</c:v>
                </c:pt>
                <c:pt idx="167">
                  <c:v>517.20000000000005</c:v>
                </c:pt>
                <c:pt idx="168">
                  <c:v>517</c:v>
                </c:pt>
                <c:pt idx="169">
                  <c:v>516.79999999999995</c:v>
                </c:pt>
                <c:pt idx="170">
                  <c:v>516.6</c:v>
                </c:pt>
                <c:pt idx="171">
                  <c:v>516.4</c:v>
                </c:pt>
                <c:pt idx="172">
                  <c:v>516.20000000000005</c:v>
                </c:pt>
                <c:pt idx="173">
                  <c:v>516</c:v>
                </c:pt>
                <c:pt idx="174">
                  <c:v>515.79999999999995</c:v>
                </c:pt>
                <c:pt idx="175">
                  <c:v>515.6</c:v>
                </c:pt>
                <c:pt idx="176">
                  <c:v>515.4</c:v>
                </c:pt>
                <c:pt idx="177">
                  <c:v>515.20000000000005</c:v>
                </c:pt>
                <c:pt idx="178">
                  <c:v>515</c:v>
                </c:pt>
                <c:pt idx="179">
                  <c:v>514.79999999999995</c:v>
                </c:pt>
                <c:pt idx="180">
                  <c:v>514.6</c:v>
                </c:pt>
                <c:pt idx="181">
                  <c:v>514.4</c:v>
                </c:pt>
                <c:pt idx="182">
                  <c:v>514.20000000000005</c:v>
                </c:pt>
                <c:pt idx="183">
                  <c:v>514</c:v>
                </c:pt>
                <c:pt idx="184">
                  <c:v>513.79999999999995</c:v>
                </c:pt>
                <c:pt idx="185">
                  <c:v>513.6</c:v>
                </c:pt>
                <c:pt idx="186">
                  <c:v>513.4</c:v>
                </c:pt>
                <c:pt idx="187">
                  <c:v>513.20000000000005</c:v>
                </c:pt>
                <c:pt idx="188">
                  <c:v>513</c:v>
                </c:pt>
                <c:pt idx="189">
                  <c:v>512.79999999999995</c:v>
                </c:pt>
                <c:pt idx="190">
                  <c:v>512.6</c:v>
                </c:pt>
                <c:pt idx="191">
                  <c:v>512.4</c:v>
                </c:pt>
                <c:pt idx="192">
                  <c:v>512.20000000000005</c:v>
                </c:pt>
                <c:pt idx="193">
                  <c:v>512</c:v>
                </c:pt>
                <c:pt idx="194">
                  <c:v>511.8</c:v>
                </c:pt>
                <c:pt idx="195">
                  <c:v>511.6</c:v>
                </c:pt>
                <c:pt idx="196">
                  <c:v>511.4</c:v>
                </c:pt>
                <c:pt idx="197">
                  <c:v>511.2</c:v>
                </c:pt>
                <c:pt idx="198">
                  <c:v>511</c:v>
                </c:pt>
                <c:pt idx="199">
                  <c:v>510.8</c:v>
                </c:pt>
                <c:pt idx="200">
                  <c:v>510.6</c:v>
                </c:pt>
                <c:pt idx="201">
                  <c:v>510.4</c:v>
                </c:pt>
                <c:pt idx="202">
                  <c:v>510.2</c:v>
                </c:pt>
                <c:pt idx="203">
                  <c:v>510</c:v>
                </c:pt>
                <c:pt idx="204">
                  <c:v>509.8</c:v>
                </c:pt>
                <c:pt idx="205">
                  <c:v>509.6</c:v>
                </c:pt>
                <c:pt idx="206">
                  <c:v>509.4</c:v>
                </c:pt>
                <c:pt idx="207">
                  <c:v>509.2</c:v>
                </c:pt>
                <c:pt idx="208">
                  <c:v>509</c:v>
                </c:pt>
                <c:pt idx="209">
                  <c:v>508.8</c:v>
                </c:pt>
                <c:pt idx="210">
                  <c:v>508.6</c:v>
                </c:pt>
                <c:pt idx="211">
                  <c:v>508.4</c:v>
                </c:pt>
                <c:pt idx="212">
                  <c:v>508.2</c:v>
                </c:pt>
                <c:pt idx="213">
                  <c:v>508</c:v>
                </c:pt>
                <c:pt idx="214">
                  <c:v>507.8</c:v>
                </c:pt>
                <c:pt idx="215">
                  <c:v>507.6</c:v>
                </c:pt>
                <c:pt idx="216">
                  <c:v>507.4</c:v>
                </c:pt>
                <c:pt idx="217">
                  <c:v>507.2</c:v>
                </c:pt>
                <c:pt idx="218">
                  <c:v>507</c:v>
                </c:pt>
                <c:pt idx="219">
                  <c:v>506.8</c:v>
                </c:pt>
                <c:pt idx="220">
                  <c:v>506.6</c:v>
                </c:pt>
                <c:pt idx="221">
                  <c:v>506.4</c:v>
                </c:pt>
                <c:pt idx="222">
                  <c:v>506.2</c:v>
                </c:pt>
                <c:pt idx="223">
                  <c:v>506</c:v>
                </c:pt>
                <c:pt idx="224">
                  <c:v>505.8</c:v>
                </c:pt>
                <c:pt idx="225">
                  <c:v>505.6</c:v>
                </c:pt>
                <c:pt idx="226">
                  <c:v>505.4</c:v>
                </c:pt>
                <c:pt idx="227">
                  <c:v>505.2</c:v>
                </c:pt>
                <c:pt idx="228">
                  <c:v>505</c:v>
                </c:pt>
                <c:pt idx="229">
                  <c:v>504.8</c:v>
                </c:pt>
                <c:pt idx="230">
                  <c:v>504.6</c:v>
                </c:pt>
                <c:pt idx="231">
                  <c:v>504.4</c:v>
                </c:pt>
                <c:pt idx="232">
                  <c:v>504.2</c:v>
                </c:pt>
                <c:pt idx="233">
                  <c:v>504</c:v>
                </c:pt>
                <c:pt idx="234">
                  <c:v>503.8</c:v>
                </c:pt>
                <c:pt idx="235">
                  <c:v>503.6</c:v>
                </c:pt>
                <c:pt idx="236">
                  <c:v>503.4</c:v>
                </c:pt>
                <c:pt idx="237">
                  <c:v>503.2</c:v>
                </c:pt>
                <c:pt idx="238">
                  <c:v>503</c:v>
                </c:pt>
                <c:pt idx="239">
                  <c:v>502.8</c:v>
                </c:pt>
                <c:pt idx="240">
                  <c:v>502.6</c:v>
                </c:pt>
                <c:pt idx="241">
                  <c:v>502.4</c:v>
                </c:pt>
                <c:pt idx="242">
                  <c:v>502.2</c:v>
                </c:pt>
                <c:pt idx="243">
                  <c:v>502</c:v>
                </c:pt>
                <c:pt idx="244">
                  <c:v>501.8</c:v>
                </c:pt>
                <c:pt idx="245">
                  <c:v>501.6</c:v>
                </c:pt>
                <c:pt idx="246">
                  <c:v>501.4</c:v>
                </c:pt>
                <c:pt idx="247">
                  <c:v>501.2</c:v>
                </c:pt>
                <c:pt idx="248">
                  <c:v>501</c:v>
                </c:pt>
                <c:pt idx="249">
                  <c:v>500.8</c:v>
                </c:pt>
                <c:pt idx="250">
                  <c:v>500.6</c:v>
                </c:pt>
                <c:pt idx="251">
                  <c:v>500.4</c:v>
                </c:pt>
                <c:pt idx="252">
                  <c:v>500.2</c:v>
                </c:pt>
                <c:pt idx="253">
                  <c:v>500</c:v>
                </c:pt>
                <c:pt idx="254">
                  <c:v>499.8</c:v>
                </c:pt>
                <c:pt idx="255">
                  <c:v>499.6</c:v>
                </c:pt>
                <c:pt idx="256">
                  <c:v>499.4</c:v>
                </c:pt>
                <c:pt idx="257">
                  <c:v>499.2</c:v>
                </c:pt>
                <c:pt idx="258">
                  <c:v>499</c:v>
                </c:pt>
                <c:pt idx="259">
                  <c:v>498.8</c:v>
                </c:pt>
                <c:pt idx="260">
                  <c:v>498.6</c:v>
                </c:pt>
                <c:pt idx="261">
                  <c:v>498.4</c:v>
                </c:pt>
                <c:pt idx="262">
                  <c:v>498.2</c:v>
                </c:pt>
                <c:pt idx="263">
                  <c:v>498</c:v>
                </c:pt>
                <c:pt idx="264">
                  <c:v>497.8</c:v>
                </c:pt>
                <c:pt idx="265">
                  <c:v>497.6</c:v>
                </c:pt>
                <c:pt idx="266">
                  <c:v>497.4</c:v>
                </c:pt>
                <c:pt idx="267">
                  <c:v>497.2</c:v>
                </c:pt>
                <c:pt idx="268">
                  <c:v>497</c:v>
                </c:pt>
                <c:pt idx="269">
                  <c:v>496.8</c:v>
                </c:pt>
                <c:pt idx="270">
                  <c:v>496.6</c:v>
                </c:pt>
                <c:pt idx="271">
                  <c:v>496.4</c:v>
                </c:pt>
                <c:pt idx="272">
                  <c:v>496.2</c:v>
                </c:pt>
                <c:pt idx="273">
                  <c:v>496</c:v>
                </c:pt>
                <c:pt idx="274">
                  <c:v>495.8</c:v>
                </c:pt>
                <c:pt idx="275">
                  <c:v>495.6</c:v>
                </c:pt>
                <c:pt idx="276">
                  <c:v>495.4</c:v>
                </c:pt>
                <c:pt idx="277">
                  <c:v>495.2</c:v>
                </c:pt>
                <c:pt idx="278">
                  <c:v>495</c:v>
                </c:pt>
                <c:pt idx="279">
                  <c:v>494.8</c:v>
                </c:pt>
                <c:pt idx="280">
                  <c:v>494.6</c:v>
                </c:pt>
                <c:pt idx="281">
                  <c:v>494.4</c:v>
                </c:pt>
                <c:pt idx="282">
                  <c:v>494.2</c:v>
                </c:pt>
                <c:pt idx="283">
                  <c:v>494</c:v>
                </c:pt>
                <c:pt idx="284">
                  <c:v>493.8</c:v>
                </c:pt>
                <c:pt idx="285">
                  <c:v>493.6</c:v>
                </c:pt>
                <c:pt idx="286">
                  <c:v>493.4</c:v>
                </c:pt>
                <c:pt idx="287">
                  <c:v>493.2</c:v>
                </c:pt>
                <c:pt idx="288">
                  <c:v>493</c:v>
                </c:pt>
                <c:pt idx="289">
                  <c:v>492.8</c:v>
                </c:pt>
                <c:pt idx="290">
                  <c:v>492.6</c:v>
                </c:pt>
                <c:pt idx="291">
                  <c:v>492.4</c:v>
                </c:pt>
                <c:pt idx="292">
                  <c:v>492.2</c:v>
                </c:pt>
                <c:pt idx="293">
                  <c:v>492</c:v>
                </c:pt>
                <c:pt idx="294">
                  <c:v>491.8</c:v>
                </c:pt>
                <c:pt idx="295">
                  <c:v>491.6</c:v>
                </c:pt>
                <c:pt idx="296">
                  <c:v>491.4</c:v>
                </c:pt>
                <c:pt idx="297">
                  <c:v>491.2</c:v>
                </c:pt>
                <c:pt idx="298">
                  <c:v>491</c:v>
                </c:pt>
                <c:pt idx="299">
                  <c:v>490.8</c:v>
                </c:pt>
                <c:pt idx="300">
                  <c:v>490.6</c:v>
                </c:pt>
                <c:pt idx="301">
                  <c:v>490.4</c:v>
                </c:pt>
                <c:pt idx="302">
                  <c:v>490.2</c:v>
                </c:pt>
                <c:pt idx="303">
                  <c:v>490</c:v>
                </c:pt>
                <c:pt idx="304">
                  <c:v>489.8</c:v>
                </c:pt>
                <c:pt idx="305">
                  <c:v>489.6</c:v>
                </c:pt>
                <c:pt idx="306">
                  <c:v>489.4</c:v>
                </c:pt>
                <c:pt idx="307">
                  <c:v>489.2</c:v>
                </c:pt>
                <c:pt idx="308">
                  <c:v>489</c:v>
                </c:pt>
                <c:pt idx="309">
                  <c:v>488.8</c:v>
                </c:pt>
                <c:pt idx="310">
                  <c:v>488.6</c:v>
                </c:pt>
                <c:pt idx="311">
                  <c:v>488.4</c:v>
                </c:pt>
                <c:pt idx="312">
                  <c:v>488.2</c:v>
                </c:pt>
                <c:pt idx="313">
                  <c:v>488</c:v>
                </c:pt>
                <c:pt idx="314">
                  <c:v>487.8</c:v>
                </c:pt>
                <c:pt idx="315">
                  <c:v>487.6</c:v>
                </c:pt>
                <c:pt idx="316">
                  <c:v>487.4</c:v>
                </c:pt>
                <c:pt idx="317">
                  <c:v>487.2</c:v>
                </c:pt>
                <c:pt idx="318">
                  <c:v>487</c:v>
                </c:pt>
                <c:pt idx="319">
                  <c:v>486.8</c:v>
                </c:pt>
                <c:pt idx="320">
                  <c:v>486.6</c:v>
                </c:pt>
                <c:pt idx="321">
                  <c:v>486.4</c:v>
                </c:pt>
                <c:pt idx="322">
                  <c:v>486.2</c:v>
                </c:pt>
                <c:pt idx="323">
                  <c:v>486</c:v>
                </c:pt>
                <c:pt idx="324">
                  <c:v>485.8</c:v>
                </c:pt>
                <c:pt idx="325">
                  <c:v>485.6</c:v>
                </c:pt>
                <c:pt idx="326">
                  <c:v>485.4</c:v>
                </c:pt>
                <c:pt idx="327">
                  <c:v>485.2</c:v>
                </c:pt>
                <c:pt idx="328">
                  <c:v>485</c:v>
                </c:pt>
                <c:pt idx="329">
                  <c:v>484.8</c:v>
                </c:pt>
                <c:pt idx="330">
                  <c:v>484.6</c:v>
                </c:pt>
                <c:pt idx="331">
                  <c:v>484.4</c:v>
                </c:pt>
                <c:pt idx="332">
                  <c:v>484.2</c:v>
                </c:pt>
                <c:pt idx="333">
                  <c:v>484</c:v>
                </c:pt>
                <c:pt idx="334">
                  <c:v>483.8</c:v>
                </c:pt>
                <c:pt idx="335">
                  <c:v>483.6</c:v>
                </c:pt>
                <c:pt idx="336">
                  <c:v>483.4</c:v>
                </c:pt>
                <c:pt idx="337">
                  <c:v>483.2</c:v>
                </c:pt>
                <c:pt idx="338">
                  <c:v>483</c:v>
                </c:pt>
                <c:pt idx="339">
                  <c:v>482.8</c:v>
                </c:pt>
                <c:pt idx="340">
                  <c:v>482.6</c:v>
                </c:pt>
                <c:pt idx="341">
                  <c:v>482.4</c:v>
                </c:pt>
                <c:pt idx="342">
                  <c:v>482.2</c:v>
                </c:pt>
                <c:pt idx="343">
                  <c:v>482</c:v>
                </c:pt>
                <c:pt idx="344">
                  <c:v>481.8</c:v>
                </c:pt>
                <c:pt idx="345">
                  <c:v>481.6</c:v>
                </c:pt>
                <c:pt idx="346">
                  <c:v>481.4</c:v>
                </c:pt>
                <c:pt idx="347">
                  <c:v>481.2</c:v>
                </c:pt>
                <c:pt idx="348">
                  <c:v>481</c:v>
                </c:pt>
                <c:pt idx="349">
                  <c:v>480.8</c:v>
                </c:pt>
                <c:pt idx="350">
                  <c:v>480.6</c:v>
                </c:pt>
                <c:pt idx="351">
                  <c:v>480.4</c:v>
                </c:pt>
                <c:pt idx="352">
                  <c:v>480.2</c:v>
                </c:pt>
                <c:pt idx="353">
                  <c:v>480</c:v>
                </c:pt>
                <c:pt idx="354">
                  <c:v>479.8</c:v>
                </c:pt>
                <c:pt idx="355">
                  <c:v>479.6</c:v>
                </c:pt>
                <c:pt idx="356">
                  <c:v>479.4</c:v>
                </c:pt>
                <c:pt idx="357">
                  <c:v>479.2</c:v>
                </c:pt>
                <c:pt idx="358">
                  <c:v>479</c:v>
                </c:pt>
                <c:pt idx="359">
                  <c:v>478.8</c:v>
                </c:pt>
                <c:pt idx="360">
                  <c:v>478.6</c:v>
                </c:pt>
                <c:pt idx="361">
                  <c:v>478.4</c:v>
                </c:pt>
                <c:pt idx="362">
                  <c:v>478.2</c:v>
                </c:pt>
                <c:pt idx="363">
                  <c:v>478</c:v>
                </c:pt>
                <c:pt idx="364">
                  <c:v>477.8</c:v>
                </c:pt>
                <c:pt idx="365">
                  <c:v>477.6</c:v>
                </c:pt>
                <c:pt idx="366">
                  <c:v>477.4</c:v>
                </c:pt>
                <c:pt idx="367">
                  <c:v>477.2</c:v>
                </c:pt>
                <c:pt idx="368">
                  <c:v>477</c:v>
                </c:pt>
                <c:pt idx="369">
                  <c:v>476.8</c:v>
                </c:pt>
                <c:pt idx="370">
                  <c:v>476.6</c:v>
                </c:pt>
                <c:pt idx="371">
                  <c:v>476.4</c:v>
                </c:pt>
                <c:pt idx="372">
                  <c:v>476.2</c:v>
                </c:pt>
                <c:pt idx="373">
                  <c:v>476</c:v>
                </c:pt>
                <c:pt idx="374">
                  <c:v>475.8</c:v>
                </c:pt>
                <c:pt idx="375">
                  <c:v>475.6</c:v>
                </c:pt>
                <c:pt idx="376">
                  <c:v>475.4</c:v>
                </c:pt>
                <c:pt idx="377">
                  <c:v>475.2</c:v>
                </c:pt>
                <c:pt idx="378">
                  <c:v>475</c:v>
                </c:pt>
                <c:pt idx="379">
                  <c:v>474.8</c:v>
                </c:pt>
                <c:pt idx="380">
                  <c:v>474.6</c:v>
                </c:pt>
                <c:pt idx="381">
                  <c:v>474.4</c:v>
                </c:pt>
                <c:pt idx="382">
                  <c:v>474.2</c:v>
                </c:pt>
                <c:pt idx="383">
                  <c:v>474</c:v>
                </c:pt>
                <c:pt idx="384">
                  <c:v>473.8</c:v>
                </c:pt>
                <c:pt idx="385">
                  <c:v>473.6</c:v>
                </c:pt>
                <c:pt idx="386">
                  <c:v>473.4</c:v>
                </c:pt>
                <c:pt idx="387">
                  <c:v>473.2</c:v>
                </c:pt>
                <c:pt idx="388">
                  <c:v>473</c:v>
                </c:pt>
                <c:pt idx="389">
                  <c:v>472.8</c:v>
                </c:pt>
                <c:pt idx="390">
                  <c:v>472.6</c:v>
                </c:pt>
                <c:pt idx="391">
                  <c:v>472.4</c:v>
                </c:pt>
                <c:pt idx="392">
                  <c:v>472.2</c:v>
                </c:pt>
                <c:pt idx="393">
                  <c:v>472</c:v>
                </c:pt>
                <c:pt idx="394">
                  <c:v>471.8</c:v>
                </c:pt>
                <c:pt idx="395">
                  <c:v>471.6</c:v>
                </c:pt>
                <c:pt idx="396">
                  <c:v>471.4</c:v>
                </c:pt>
                <c:pt idx="397">
                  <c:v>471.2</c:v>
                </c:pt>
                <c:pt idx="398">
                  <c:v>471</c:v>
                </c:pt>
                <c:pt idx="399">
                  <c:v>470.8</c:v>
                </c:pt>
                <c:pt idx="400">
                  <c:v>470.6</c:v>
                </c:pt>
                <c:pt idx="401">
                  <c:v>470.4</c:v>
                </c:pt>
                <c:pt idx="402">
                  <c:v>470.2</c:v>
                </c:pt>
                <c:pt idx="403">
                  <c:v>470</c:v>
                </c:pt>
                <c:pt idx="404">
                  <c:v>469.8</c:v>
                </c:pt>
                <c:pt idx="405">
                  <c:v>469.6</c:v>
                </c:pt>
                <c:pt idx="406">
                  <c:v>469.4</c:v>
                </c:pt>
                <c:pt idx="407">
                  <c:v>469.2</c:v>
                </c:pt>
                <c:pt idx="408">
                  <c:v>469</c:v>
                </c:pt>
                <c:pt idx="409">
                  <c:v>468.8</c:v>
                </c:pt>
                <c:pt idx="410">
                  <c:v>468.6</c:v>
                </c:pt>
                <c:pt idx="411">
                  <c:v>468.4</c:v>
                </c:pt>
                <c:pt idx="412">
                  <c:v>468.2</c:v>
                </c:pt>
                <c:pt idx="413">
                  <c:v>468</c:v>
                </c:pt>
                <c:pt idx="414">
                  <c:v>467.8</c:v>
                </c:pt>
                <c:pt idx="415">
                  <c:v>467.6</c:v>
                </c:pt>
                <c:pt idx="416">
                  <c:v>467.4</c:v>
                </c:pt>
                <c:pt idx="417">
                  <c:v>467.2</c:v>
                </c:pt>
                <c:pt idx="418">
                  <c:v>467</c:v>
                </c:pt>
                <c:pt idx="419">
                  <c:v>466.8</c:v>
                </c:pt>
                <c:pt idx="420">
                  <c:v>466.6</c:v>
                </c:pt>
                <c:pt idx="421">
                  <c:v>466.4</c:v>
                </c:pt>
                <c:pt idx="422">
                  <c:v>466.2</c:v>
                </c:pt>
                <c:pt idx="423">
                  <c:v>466</c:v>
                </c:pt>
                <c:pt idx="424">
                  <c:v>465.8</c:v>
                </c:pt>
                <c:pt idx="425">
                  <c:v>465.6</c:v>
                </c:pt>
                <c:pt idx="426">
                  <c:v>465.4</c:v>
                </c:pt>
                <c:pt idx="427">
                  <c:v>465.2</c:v>
                </c:pt>
                <c:pt idx="428">
                  <c:v>465</c:v>
                </c:pt>
                <c:pt idx="429">
                  <c:v>464.8</c:v>
                </c:pt>
                <c:pt idx="430">
                  <c:v>464.6</c:v>
                </c:pt>
                <c:pt idx="431">
                  <c:v>464.4</c:v>
                </c:pt>
                <c:pt idx="432">
                  <c:v>464.2</c:v>
                </c:pt>
                <c:pt idx="433">
                  <c:v>464</c:v>
                </c:pt>
                <c:pt idx="434">
                  <c:v>463.8</c:v>
                </c:pt>
                <c:pt idx="435">
                  <c:v>463.6</c:v>
                </c:pt>
                <c:pt idx="436">
                  <c:v>463.4</c:v>
                </c:pt>
                <c:pt idx="437">
                  <c:v>463.2</c:v>
                </c:pt>
                <c:pt idx="438">
                  <c:v>463</c:v>
                </c:pt>
                <c:pt idx="439">
                  <c:v>462.8</c:v>
                </c:pt>
                <c:pt idx="440">
                  <c:v>462.6</c:v>
                </c:pt>
                <c:pt idx="441">
                  <c:v>462.4</c:v>
                </c:pt>
                <c:pt idx="442">
                  <c:v>462.2</c:v>
                </c:pt>
                <c:pt idx="443">
                  <c:v>462</c:v>
                </c:pt>
                <c:pt idx="444">
                  <c:v>461.8</c:v>
                </c:pt>
                <c:pt idx="445">
                  <c:v>461.6</c:v>
                </c:pt>
                <c:pt idx="446">
                  <c:v>461.4</c:v>
                </c:pt>
                <c:pt idx="447">
                  <c:v>461.2</c:v>
                </c:pt>
                <c:pt idx="448">
                  <c:v>461</c:v>
                </c:pt>
                <c:pt idx="449">
                  <c:v>460.8</c:v>
                </c:pt>
                <c:pt idx="450">
                  <c:v>460.6</c:v>
                </c:pt>
                <c:pt idx="451">
                  <c:v>460.4</c:v>
                </c:pt>
                <c:pt idx="452">
                  <c:v>460.2</c:v>
                </c:pt>
                <c:pt idx="453">
                  <c:v>460</c:v>
                </c:pt>
                <c:pt idx="454">
                  <c:v>459.8</c:v>
                </c:pt>
                <c:pt idx="455">
                  <c:v>459.6</c:v>
                </c:pt>
                <c:pt idx="456">
                  <c:v>459.4</c:v>
                </c:pt>
                <c:pt idx="457">
                  <c:v>459.2</c:v>
                </c:pt>
                <c:pt idx="458">
                  <c:v>459</c:v>
                </c:pt>
                <c:pt idx="459">
                  <c:v>458.8</c:v>
                </c:pt>
                <c:pt idx="460">
                  <c:v>458.6</c:v>
                </c:pt>
                <c:pt idx="461">
                  <c:v>458.4</c:v>
                </c:pt>
                <c:pt idx="462">
                  <c:v>458.2</c:v>
                </c:pt>
                <c:pt idx="463">
                  <c:v>458</c:v>
                </c:pt>
                <c:pt idx="464">
                  <c:v>457.8</c:v>
                </c:pt>
                <c:pt idx="465">
                  <c:v>457.6</c:v>
                </c:pt>
                <c:pt idx="466">
                  <c:v>457.4</c:v>
                </c:pt>
                <c:pt idx="467">
                  <c:v>457.2</c:v>
                </c:pt>
                <c:pt idx="468">
                  <c:v>457</c:v>
                </c:pt>
                <c:pt idx="469">
                  <c:v>456.8</c:v>
                </c:pt>
                <c:pt idx="470">
                  <c:v>456.6</c:v>
                </c:pt>
                <c:pt idx="471">
                  <c:v>456.4</c:v>
                </c:pt>
                <c:pt idx="472">
                  <c:v>456.2</c:v>
                </c:pt>
                <c:pt idx="473">
                  <c:v>456</c:v>
                </c:pt>
                <c:pt idx="474">
                  <c:v>455.8</c:v>
                </c:pt>
                <c:pt idx="475">
                  <c:v>455.6</c:v>
                </c:pt>
                <c:pt idx="476">
                  <c:v>455.4</c:v>
                </c:pt>
                <c:pt idx="477">
                  <c:v>455.2</c:v>
                </c:pt>
                <c:pt idx="478">
                  <c:v>455</c:v>
                </c:pt>
                <c:pt idx="479">
                  <c:v>454.8</c:v>
                </c:pt>
                <c:pt idx="480">
                  <c:v>454.6</c:v>
                </c:pt>
                <c:pt idx="481">
                  <c:v>454.4</c:v>
                </c:pt>
                <c:pt idx="482">
                  <c:v>454.2</c:v>
                </c:pt>
                <c:pt idx="483">
                  <c:v>454</c:v>
                </c:pt>
                <c:pt idx="484">
                  <c:v>453.8</c:v>
                </c:pt>
                <c:pt idx="485">
                  <c:v>453.6</c:v>
                </c:pt>
                <c:pt idx="486">
                  <c:v>453.4</c:v>
                </c:pt>
                <c:pt idx="487">
                  <c:v>453.2</c:v>
                </c:pt>
                <c:pt idx="488">
                  <c:v>453</c:v>
                </c:pt>
                <c:pt idx="489">
                  <c:v>452.8</c:v>
                </c:pt>
                <c:pt idx="490">
                  <c:v>452.6</c:v>
                </c:pt>
                <c:pt idx="491">
                  <c:v>452.4</c:v>
                </c:pt>
                <c:pt idx="492">
                  <c:v>452.2</c:v>
                </c:pt>
                <c:pt idx="493">
                  <c:v>452</c:v>
                </c:pt>
                <c:pt idx="494">
                  <c:v>451.8</c:v>
                </c:pt>
                <c:pt idx="495">
                  <c:v>451.6</c:v>
                </c:pt>
                <c:pt idx="496">
                  <c:v>451.4</c:v>
                </c:pt>
                <c:pt idx="497">
                  <c:v>451.2</c:v>
                </c:pt>
                <c:pt idx="498">
                  <c:v>451</c:v>
                </c:pt>
                <c:pt idx="499">
                  <c:v>450.8</c:v>
                </c:pt>
                <c:pt idx="500">
                  <c:v>450.6</c:v>
                </c:pt>
                <c:pt idx="501">
                  <c:v>450.4</c:v>
                </c:pt>
                <c:pt idx="502">
                  <c:v>450.2</c:v>
                </c:pt>
                <c:pt idx="503">
                  <c:v>450</c:v>
                </c:pt>
                <c:pt idx="504">
                  <c:v>449.8</c:v>
                </c:pt>
                <c:pt idx="505">
                  <c:v>449.6</c:v>
                </c:pt>
                <c:pt idx="506">
                  <c:v>449.4</c:v>
                </c:pt>
                <c:pt idx="507">
                  <c:v>449.2</c:v>
                </c:pt>
                <c:pt idx="508">
                  <c:v>449</c:v>
                </c:pt>
                <c:pt idx="509">
                  <c:v>448.8</c:v>
                </c:pt>
                <c:pt idx="510">
                  <c:v>448.6</c:v>
                </c:pt>
                <c:pt idx="511">
                  <c:v>448.4</c:v>
                </c:pt>
                <c:pt idx="512">
                  <c:v>448.2</c:v>
                </c:pt>
                <c:pt idx="513">
                  <c:v>448</c:v>
                </c:pt>
                <c:pt idx="514">
                  <c:v>447.8</c:v>
                </c:pt>
                <c:pt idx="515">
                  <c:v>447.6</c:v>
                </c:pt>
                <c:pt idx="516">
                  <c:v>447.4</c:v>
                </c:pt>
                <c:pt idx="517">
                  <c:v>447.2</c:v>
                </c:pt>
                <c:pt idx="518">
                  <c:v>447</c:v>
                </c:pt>
                <c:pt idx="519">
                  <c:v>446.8</c:v>
                </c:pt>
                <c:pt idx="520">
                  <c:v>446.6</c:v>
                </c:pt>
                <c:pt idx="521">
                  <c:v>446.4</c:v>
                </c:pt>
                <c:pt idx="522">
                  <c:v>446.2</c:v>
                </c:pt>
                <c:pt idx="523">
                  <c:v>446</c:v>
                </c:pt>
                <c:pt idx="524">
                  <c:v>445.8</c:v>
                </c:pt>
                <c:pt idx="525">
                  <c:v>445.6</c:v>
                </c:pt>
                <c:pt idx="526">
                  <c:v>445.4</c:v>
                </c:pt>
                <c:pt idx="527">
                  <c:v>445.2</c:v>
                </c:pt>
                <c:pt idx="528">
                  <c:v>445</c:v>
                </c:pt>
                <c:pt idx="529">
                  <c:v>444.8</c:v>
                </c:pt>
                <c:pt idx="530">
                  <c:v>444.6</c:v>
                </c:pt>
                <c:pt idx="531">
                  <c:v>444.4</c:v>
                </c:pt>
                <c:pt idx="532">
                  <c:v>444.2</c:v>
                </c:pt>
                <c:pt idx="533">
                  <c:v>444</c:v>
                </c:pt>
                <c:pt idx="534">
                  <c:v>443.8</c:v>
                </c:pt>
                <c:pt idx="535">
                  <c:v>443.6</c:v>
                </c:pt>
                <c:pt idx="536">
                  <c:v>443.4</c:v>
                </c:pt>
                <c:pt idx="537">
                  <c:v>443.2</c:v>
                </c:pt>
                <c:pt idx="538">
                  <c:v>443</c:v>
                </c:pt>
                <c:pt idx="539">
                  <c:v>442.8</c:v>
                </c:pt>
                <c:pt idx="540">
                  <c:v>442.6</c:v>
                </c:pt>
                <c:pt idx="541">
                  <c:v>442.4</c:v>
                </c:pt>
                <c:pt idx="542">
                  <c:v>442.2</c:v>
                </c:pt>
                <c:pt idx="543">
                  <c:v>442</c:v>
                </c:pt>
                <c:pt idx="544">
                  <c:v>441.8</c:v>
                </c:pt>
                <c:pt idx="545">
                  <c:v>441.6</c:v>
                </c:pt>
                <c:pt idx="546">
                  <c:v>441.4</c:v>
                </c:pt>
                <c:pt idx="547">
                  <c:v>441.2</c:v>
                </c:pt>
                <c:pt idx="548">
                  <c:v>441</c:v>
                </c:pt>
                <c:pt idx="549">
                  <c:v>440.8</c:v>
                </c:pt>
                <c:pt idx="550">
                  <c:v>440.6</c:v>
                </c:pt>
                <c:pt idx="551">
                  <c:v>440.4</c:v>
                </c:pt>
                <c:pt idx="552">
                  <c:v>440.2</c:v>
                </c:pt>
                <c:pt idx="553">
                  <c:v>440</c:v>
                </c:pt>
                <c:pt idx="554">
                  <c:v>439.8</c:v>
                </c:pt>
                <c:pt idx="555">
                  <c:v>439.6</c:v>
                </c:pt>
                <c:pt idx="556">
                  <c:v>439.4</c:v>
                </c:pt>
                <c:pt idx="557">
                  <c:v>439.2</c:v>
                </c:pt>
                <c:pt idx="558">
                  <c:v>439</c:v>
                </c:pt>
                <c:pt idx="559">
                  <c:v>438.8</c:v>
                </c:pt>
                <c:pt idx="560">
                  <c:v>438.6</c:v>
                </c:pt>
                <c:pt idx="561">
                  <c:v>438.4</c:v>
                </c:pt>
                <c:pt idx="562">
                  <c:v>438.2</c:v>
                </c:pt>
                <c:pt idx="563">
                  <c:v>438</c:v>
                </c:pt>
                <c:pt idx="564">
                  <c:v>437.8</c:v>
                </c:pt>
                <c:pt idx="565">
                  <c:v>437.6</c:v>
                </c:pt>
                <c:pt idx="566">
                  <c:v>437.4</c:v>
                </c:pt>
                <c:pt idx="567">
                  <c:v>437.2</c:v>
                </c:pt>
                <c:pt idx="568">
                  <c:v>437</c:v>
                </c:pt>
                <c:pt idx="569">
                  <c:v>436.8</c:v>
                </c:pt>
                <c:pt idx="570">
                  <c:v>436.6</c:v>
                </c:pt>
                <c:pt idx="571">
                  <c:v>436.4</c:v>
                </c:pt>
                <c:pt idx="572">
                  <c:v>436.2</c:v>
                </c:pt>
                <c:pt idx="573">
                  <c:v>436</c:v>
                </c:pt>
                <c:pt idx="574">
                  <c:v>435.8</c:v>
                </c:pt>
                <c:pt idx="575">
                  <c:v>435.6</c:v>
                </c:pt>
                <c:pt idx="576">
                  <c:v>435.4</c:v>
                </c:pt>
                <c:pt idx="577">
                  <c:v>435.2</c:v>
                </c:pt>
                <c:pt idx="578">
                  <c:v>435</c:v>
                </c:pt>
                <c:pt idx="579">
                  <c:v>434.8</c:v>
                </c:pt>
                <c:pt idx="580">
                  <c:v>434.6</c:v>
                </c:pt>
                <c:pt idx="581">
                  <c:v>434.4</c:v>
                </c:pt>
                <c:pt idx="582">
                  <c:v>434.2</c:v>
                </c:pt>
                <c:pt idx="583">
                  <c:v>434</c:v>
                </c:pt>
                <c:pt idx="584">
                  <c:v>433.8</c:v>
                </c:pt>
                <c:pt idx="585">
                  <c:v>433.6</c:v>
                </c:pt>
                <c:pt idx="586">
                  <c:v>433.4</c:v>
                </c:pt>
                <c:pt idx="587">
                  <c:v>433.2</c:v>
                </c:pt>
                <c:pt idx="588">
                  <c:v>433</c:v>
                </c:pt>
                <c:pt idx="589">
                  <c:v>432.8</c:v>
                </c:pt>
                <c:pt idx="590">
                  <c:v>432.6</c:v>
                </c:pt>
                <c:pt idx="591">
                  <c:v>432.4</c:v>
                </c:pt>
                <c:pt idx="592">
                  <c:v>432.2</c:v>
                </c:pt>
                <c:pt idx="593">
                  <c:v>432</c:v>
                </c:pt>
                <c:pt idx="594">
                  <c:v>431.8</c:v>
                </c:pt>
                <c:pt idx="595">
                  <c:v>431.6</c:v>
                </c:pt>
                <c:pt idx="596">
                  <c:v>431.4</c:v>
                </c:pt>
                <c:pt idx="597">
                  <c:v>431.2</c:v>
                </c:pt>
                <c:pt idx="598">
                  <c:v>431</c:v>
                </c:pt>
                <c:pt idx="599">
                  <c:v>430.8</c:v>
                </c:pt>
                <c:pt idx="600">
                  <c:v>430.6</c:v>
                </c:pt>
                <c:pt idx="601">
                  <c:v>430.4</c:v>
                </c:pt>
                <c:pt idx="602">
                  <c:v>430.2</c:v>
                </c:pt>
                <c:pt idx="603">
                  <c:v>430</c:v>
                </c:pt>
                <c:pt idx="604">
                  <c:v>429.8</c:v>
                </c:pt>
                <c:pt idx="605">
                  <c:v>429.6</c:v>
                </c:pt>
                <c:pt idx="606">
                  <c:v>429.4</c:v>
                </c:pt>
                <c:pt idx="607">
                  <c:v>429.2</c:v>
                </c:pt>
                <c:pt idx="608">
                  <c:v>429</c:v>
                </c:pt>
                <c:pt idx="609">
                  <c:v>428.8</c:v>
                </c:pt>
                <c:pt idx="610">
                  <c:v>428.6</c:v>
                </c:pt>
                <c:pt idx="611">
                  <c:v>428.4</c:v>
                </c:pt>
                <c:pt idx="612">
                  <c:v>428.2</c:v>
                </c:pt>
                <c:pt idx="613">
                  <c:v>428</c:v>
                </c:pt>
                <c:pt idx="614">
                  <c:v>427.8</c:v>
                </c:pt>
                <c:pt idx="615">
                  <c:v>427.6</c:v>
                </c:pt>
                <c:pt idx="616">
                  <c:v>427.4</c:v>
                </c:pt>
                <c:pt idx="617">
                  <c:v>427.2</c:v>
                </c:pt>
                <c:pt idx="618">
                  <c:v>427</c:v>
                </c:pt>
                <c:pt idx="619">
                  <c:v>426.8</c:v>
                </c:pt>
                <c:pt idx="620">
                  <c:v>426.6</c:v>
                </c:pt>
                <c:pt idx="621">
                  <c:v>426.4</c:v>
                </c:pt>
                <c:pt idx="622">
                  <c:v>426.2</c:v>
                </c:pt>
                <c:pt idx="623">
                  <c:v>426</c:v>
                </c:pt>
                <c:pt idx="624">
                  <c:v>425.8</c:v>
                </c:pt>
                <c:pt idx="625">
                  <c:v>425.6</c:v>
                </c:pt>
                <c:pt idx="626">
                  <c:v>425.4</c:v>
                </c:pt>
                <c:pt idx="627">
                  <c:v>425.2</c:v>
                </c:pt>
                <c:pt idx="628">
                  <c:v>425</c:v>
                </c:pt>
                <c:pt idx="629">
                  <c:v>424.8</c:v>
                </c:pt>
                <c:pt idx="630">
                  <c:v>424.6</c:v>
                </c:pt>
                <c:pt idx="631">
                  <c:v>424.4</c:v>
                </c:pt>
                <c:pt idx="632">
                  <c:v>424.2</c:v>
                </c:pt>
                <c:pt idx="633">
                  <c:v>424</c:v>
                </c:pt>
                <c:pt idx="634">
                  <c:v>423.8</c:v>
                </c:pt>
                <c:pt idx="635">
                  <c:v>423.6</c:v>
                </c:pt>
                <c:pt idx="636">
                  <c:v>423.4</c:v>
                </c:pt>
                <c:pt idx="637">
                  <c:v>423.2</c:v>
                </c:pt>
                <c:pt idx="638">
                  <c:v>423</c:v>
                </c:pt>
                <c:pt idx="639">
                  <c:v>422.8</c:v>
                </c:pt>
                <c:pt idx="640">
                  <c:v>422.6</c:v>
                </c:pt>
                <c:pt idx="641">
                  <c:v>422.4</c:v>
                </c:pt>
                <c:pt idx="642">
                  <c:v>422.2</c:v>
                </c:pt>
                <c:pt idx="643">
                  <c:v>422</c:v>
                </c:pt>
                <c:pt idx="644">
                  <c:v>421.8</c:v>
                </c:pt>
                <c:pt idx="645">
                  <c:v>421.6</c:v>
                </c:pt>
                <c:pt idx="646">
                  <c:v>421.4</c:v>
                </c:pt>
                <c:pt idx="647">
                  <c:v>421.2</c:v>
                </c:pt>
                <c:pt idx="648">
                  <c:v>421</c:v>
                </c:pt>
                <c:pt idx="649">
                  <c:v>420.8</c:v>
                </c:pt>
                <c:pt idx="650">
                  <c:v>420.6</c:v>
                </c:pt>
                <c:pt idx="651">
                  <c:v>420.4</c:v>
                </c:pt>
                <c:pt idx="652">
                  <c:v>420.2</c:v>
                </c:pt>
                <c:pt idx="653">
                  <c:v>420</c:v>
                </c:pt>
                <c:pt idx="654">
                  <c:v>419.8</c:v>
                </c:pt>
                <c:pt idx="655">
                  <c:v>419.6</c:v>
                </c:pt>
                <c:pt idx="656">
                  <c:v>419.4</c:v>
                </c:pt>
                <c:pt idx="657">
                  <c:v>419.2</c:v>
                </c:pt>
                <c:pt idx="658">
                  <c:v>419</c:v>
                </c:pt>
                <c:pt idx="659">
                  <c:v>418.8</c:v>
                </c:pt>
                <c:pt idx="660">
                  <c:v>418.6</c:v>
                </c:pt>
                <c:pt idx="661">
                  <c:v>418.4</c:v>
                </c:pt>
                <c:pt idx="662">
                  <c:v>418.2</c:v>
                </c:pt>
                <c:pt idx="663">
                  <c:v>418</c:v>
                </c:pt>
                <c:pt idx="664">
                  <c:v>417.8</c:v>
                </c:pt>
                <c:pt idx="665">
                  <c:v>417.6</c:v>
                </c:pt>
                <c:pt idx="666">
                  <c:v>417.4</c:v>
                </c:pt>
                <c:pt idx="667">
                  <c:v>417.2</c:v>
                </c:pt>
                <c:pt idx="668">
                  <c:v>417</c:v>
                </c:pt>
                <c:pt idx="669">
                  <c:v>416.8</c:v>
                </c:pt>
                <c:pt idx="670">
                  <c:v>416.6</c:v>
                </c:pt>
                <c:pt idx="671">
                  <c:v>416.4</c:v>
                </c:pt>
                <c:pt idx="672">
                  <c:v>416.2</c:v>
                </c:pt>
                <c:pt idx="673">
                  <c:v>416</c:v>
                </c:pt>
                <c:pt idx="674">
                  <c:v>415.8</c:v>
                </c:pt>
                <c:pt idx="675">
                  <c:v>415.6</c:v>
                </c:pt>
                <c:pt idx="676">
                  <c:v>415.4</c:v>
                </c:pt>
                <c:pt idx="677">
                  <c:v>415.2</c:v>
                </c:pt>
                <c:pt idx="678">
                  <c:v>415</c:v>
                </c:pt>
                <c:pt idx="679">
                  <c:v>414.8</c:v>
                </c:pt>
                <c:pt idx="680">
                  <c:v>414.6</c:v>
                </c:pt>
                <c:pt idx="681">
                  <c:v>414.4</c:v>
                </c:pt>
                <c:pt idx="682">
                  <c:v>414.2</c:v>
                </c:pt>
                <c:pt idx="683">
                  <c:v>414</c:v>
                </c:pt>
                <c:pt idx="684">
                  <c:v>413.8</c:v>
                </c:pt>
                <c:pt idx="685">
                  <c:v>413.6</c:v>
                </c:pt>
                <c:pt idx="686">
                  <c:v>413.4</c:v>
                </c:pt>
                <c:pt idx="687">
                  <c:v>413.2</c:v>
                </c:pt>
                <c:pt idx="688">
                  <c:v>413</c:v>
                </c:pt>
                <c:pt idx="689">
                  <c:v>412.8</c:v>
                </c:pt>
                <c:pt idx="690">
                  <c:v>412.6</c:v>
                </c:pt>
                <c:pt idx="691">
                  <c:v>412.4</c:v>
                </c:pt>
                <c:pt idx="692">
                  <c:v>412.2</c:v>
                </c:pt>
                <c:pt idx="693">
                  <c:v>412</c:v>
                </c:pt>
                <c:pt idx="694">
                  <c:v>411.8</c:v>
                </c:pt>
                <c:pt idx="695">
                  <c:v>411.6</c:v>
                </c:pt>
                <c:pt idx="696">
                  <c:v>411.4</c:v>
                </c:pt>
                <c:pt idx="697">
                  <c:v>411.2</c:v>
                </c:pt>
                <c:pt idx="698">
                  <c:v>411</c:v>
                </c:pt>
                <c:pt idx="699">
                  <c:v>410.8</c:v>
                </c:pt>
                <c:pt idx="700">
                  <c:v>410.6</c:v>
                </c:pt>
                <c:pt idx="701">
                  <c:v>410.4</c:v>
                </c:pt>
                <c:pt idx="702">
                  <c:v>410.2</c:v>
                </c:pt>
                <c:pt idx="703">
                  <c:v>410</c:v>
                </c:pt>
                <c:pt idx="704">
                  <c:v>409.8</c:v>
                </c:pt>
                <c:pt idx="705">
                  <c:v>409.6</c:v>
                </c:pt>
                <c:pt idx="706">
                  <c:v>409.4</c:v>
                </c:pt>
                <c:pt idx="707">
                  <c:v>409.2</c:v>
                </c:pt>
                <c:pt idx="708">
                  <c:v>409</c:v>
                </c:pt>
                <c:pt idx="709">
                  <c:v>408.8</c:v>
                </c:pt>
                <c:pt idx="710">
                  <c:v>408.6</c:v>
                </c:pt>
                <c:pt idx="711">
                  <c:v>408.4</c:v>
                </c:pt>
                <c:pt idx="712">
                  <c:v>408.2</c:v>
                </c:pt>
                <c:pt idx="713">
                  <c:v>408</c:v>
                </c:pt>
                <c:pt idx="714">
                  <c:v>407.8</c:v>
                </c:pt>
                <c:pt idx="715">
                  <c:v>407.6</c:v>
                </c:pt>
                <c:pt idx="716">
                  <c:v>407.4</c:v>
                </c:pt>
                <c:pt idx="717">
                  <c:v>407.2</c:v>
                </c:pt>
                <c:pt idx="718">
                  <c:v>407</c:v>
                </c:pt>
                <c:pt idx="719">
                  <c:v>406.8</c:v>
                </c:pt>
                <c:pt idx="720">
                  <c:v>406.6</c:v>
                </c:pt>
                <c:pt idx="721">
                  <c:v>406.4</c:v>
                </c:pt>
                <c:pt idx="722">
                  <c:v>406.2</c:v>
                </c:pt>
                <c:pt idx="723">
                  <c:v>406</c:v>
                </c:pt>
                <c:pt idx="724">
                  <c:v>405.8</c:v>
                </c:pt>
                <c:pt idx="725">
                  <c:v>405.6</c:v>
                </c:pt>
                <c:pt idx="726">
                  <c:v>405.4</c:v>
                </c:pt>
                <c:pt idx="727">
                  <c:v>405.2</c:v>
                </c:pt>
                <c:pt idx="728">
                  <c:v>405</c:v>
                </c:pt>
                <c:pt idx="729">
                  <c:v>404.8</c:v>
                </c:pt>
                <c:pt idx="730">
                  <c:v>404.6</c:v>
                </c:pt>
                <c:pt idx="731">
                  <c:v>404.4</c:v>
                </c:pt>
                <c:pt idx="732">
                  <c:v>404.2</c:v>
                </c:pt>
                <c:pt idx="733">
                  <c:v>404</c:v>
                </c:pt>
                <c:pt idx="734">
                  <c:v>403.8</c:v>
                </c:pt>
                <c:pt idx="735">
                  <c:v>403.6</c:v>
                </c:pt>
                <c:pt idx="736">
                  <c:v>403.4</c:v>
                </c:pt>
                <c:pt idx="737">
                  <c:v>403.2</c:v>
                </c:pt>
                <c:pt idx="738">
                  <c:v>403</c:v>
                </c:pt>
                <c:pt idx="739">
                  <c:v>402.8</c:v>
                </c:pt>
                <c:pt idx="740">
                  <c:v>402.6</c:v>
                </c:pt>
                <c:pt idx="741">
                  <c:v>402.4</c:v>
                </c:pt>
                <c:pt idx="742">
                  <c:v>402.2</c:v>
                </c:pt>
                <c:pt idx="743">
                  <c:v>402</c:v>
                </c:pt>
                <c:pt idx="744">
                  <c:v>401.8</c:v>
                </c:pt>
                <c:pt idx="745">
                  <c:v>401.6</c:v>
                </c:pt>
                <c:pt idx="746">
                  <c:v>401.4</c:v>
                </c:pt>
                <c:pt idx="747">
                  <c:v>401.2</c:v>
                </c:pt>
                <c:pt idx="748">
                  <c:v>401</c:v>
                </c:pt>
                <c:pt idx="749">
                  <c:v>400.8</c:v>
                </c:pt>
                <c:pt idx="750">
                  <c:v>400.6</c:v>
                </c:pt>
                <c:pt idx="751">
                  <c:v>400.4</c:v>
                </c:pt>
                <c:pt idx="752">
                  <c:v>400.2</c:v>
                </c:pt>
                <c:pt idx="753">
                  <c:v>400</c:v>
                </c:pt>
                <c:pt idx="754">
                  <c:v>399.8</c:v>
                </c:pt>
                <c:pt idx="755">
                  <c:v>399.6</c:v>
                </c:pt>
                <c:pt idx="756">
                  <c:v>399.4</c:v>
                </c:pt>
                <c:pt idx="757">
                  <c:v>399.2</c:v>
                </c:pt>
                <c:pt idx="758">
                  <c:v>399</c:v>
                </c:pt>
                <c:pt idx="759">
                  <c:v>398.8</c:v>
                </c:pt>
                <c:pt idx="760">
                  <c:v>398.6</c:v>
                </c:pt>
                <c:pt idx="761">
                  <c:v>398.4</c:v>
                </c:pt>
                <c:pt idx="762">
                  <c:v>398.2</c:v>
                </c:pt>
                <c:pt idx="763">
                  <c:v>398</c:v>
                </c:pt>
                <c:pt idx="764">
                  <c:v>397.8</c:v>
                </c:pt>
                <c:pt idx="765">
                  <c:v>397.6</c:v>
                </c:pt>
                <c:pt idx="766">
                  <c:v>397.4</c:v>
                </c:pt>
                <c:pt idx="767">
                  <c:v>397.2</c:v>
                </c:pt>
                <c:pt idx="768">
                  <c:v>397</c:v>
                </c:pt>
                <c:pt idx="769">
                  <c:v>396.8</c:v>
                </c:pt>
                <c:pt idx="770">
                  <c:v>396.6</c:v>
                </c:pt>
                <c:pt idx="771">
                  <c:v>396.4</c:v>
                </c:pt>
                <c:pt idx="772">
                  <c:v>396.2</c:v>
                </c:pt>
                <c:pt idx="773">
                  <c:v>396</c:v>
                </c:pt>
                <c:pt idx="774">
                  <c:v>395.8</c:v>
                </c:pt>
                <c:pt idx="775">
                  <c:v>395.6</c:v>
                </c:pt>
                <c:pt idx="776">
                  <c:v>395.4</c:v>
                </c:pt>
                <c:pt idx="777">
                  <c:v>395.2</c:v>
                </c:pt>
                <c:pt idx="778">
                  <c:v>395</c:v>
                </c:pt>
                <c:pt idx="779">
                  <c:v>394.8</c:v>
                </c:pt>
                <c:pt idx="780">
                  <c:v>394.6</c:v>
                </c:pt>
                <c:pt idx="781">
                  <c:v>394.4</c:v>
                </c:pt>
                <c:pt idx="782">
                  <c:v>394.2</c:v>
                </c:pt>
                <c:pt idx="783">
                  <c:v>394</c:v>
                </c:pt>
                <c:pt idx="784">
                  <c:v>393.8</c:v>
                </c:pt>
                <c:pt idx="785">
                  <c:v>393.6</c:v>
                </c:pt>
                <c:pt idx="786">
                  <c:v>393.4</c:v>
                </c:pt>
                <c:pt idx="787">
                  <c:v>393.2</c:v>
                </c:pt>
                <c:pt idx="788">
                  <c:v>393</c:v>
                </c:pt>
                <c:pt idx="789">
                  <c:v>392.8</c:v>
                </c:pt>
                <c:pt idx="790">
                  <c:v>392.6</c:v>
                </c:pt>
                <c:pt idx="791">
                  <c:v>392.4</c:v>
                </c:pt>
                <c:pt idx="792">
                  <c:v>392.2</c:v>
                </c:pt>
                <c:pt idx="793">
                  <c:v>392</c:v>
                </c:pt>
                <c:pt idx="794">
                  <c:v>391.8</c:v>
                </c:pt>
                <c:pt idx="795">
                  <c:v>391.6</c:v>
                </c:pt>
                <c:pt idx="796">
                  <c:v>391.4</c:v>
                </c:pt>
                <c:pt idx="797">
                  <c:v>391.2</c:v>
                </c:pt>
                <c:pt idx="798">
                  <c:v>391</c:v>
                </c:pt>
                <c:pt idx="799">
                  <c:v>390.8</c:v>
                </c:pt>
                <c:pt idx="800">
                  <c:v>390.6</c:v>
                </c:pt>
                <c:pt idx="801">
                  <c:v>390.4</c:v>
                </c:pt>
                <c:pt idx="802">
                  <c:v>390.2</c:v>
                </c:pt>
                <c:pt idx="803">
                  <c:v>390</c:v>
                </c:pt>
                <c:pt idx="804">
                  <c:v>389.8</c:v>
                </c:pt>
                <c:pt idx="805">
                  <c:v>389.6</c:v>
                </c:pt>
                <c:pt idx="806">
                  <c:v>389.4</c:v>
                </c:pt>
                <c:pt idx="807">
                  <c:v>389.2</c:v>
                </c:pt>
                <c:pt idx="808">
                  <c:v>389</c:v>
                </c:pt>
                <c:pt idx="809">
                  <c:v>388.8</c:v>
                </c:pt>
                <c:pt idx="810">
                  <c:v>388.6</c:v>
                </c:pt>
                <c:pt idx="811">
                  <c:v>388.4</c:v>
                </c:pt>
                <c:pt idx="812">
                  <c:v>388.2</c:v>
                </c:pt>
                <c:pt idx="813">
                  <c:v>388</c:v>
                </c:pt>
                <c:pt idx="814">
                  <c:v>387.8</c:v>
                </c:pt>
                <c:pt idx="815">
                  <c:v>387.6</c:v>
                </c:pt>
                <c:pt idx="816">
                  <c:v>387.4</c:v>
                </c:pt>
                <c:pt idx="817">
                  <c:v>387.2</c:v>
                </c:pt>
                <c:pt idx="818">
                  <c:v>387</c:v>
                </c:pt>
                <c:pt idx="819">
                  <c:v>386.8</c:v>
                </c:pt>
                <c:pt idx="820">
                  <c:v>386.6</c:v>
                </c:pt>
                <c:pt idx="821">
                  <c:v>386.4</c:v>
                </c:pt>
                <c:pt idx="822">
                  <c:v>386.2</c:v>
                </c:pt>
                <c:pt idx="823">
                  <c:v>386</c:v>
                </c:pt>
                <c:pt idx="824">
                  <c:v>385.8</c:v>
                </c:pt>
                <c:pt idx="825">
                  <c:v>385.6</c:v>
                </c:pt>
                <c:pt idx="826">
                  <c:v>385.4</c:v>
                </c:pt>
                <c:pt idx="827">
                  <c:v>385.2</c:v>
                </c:pt>
                <c:pt idx="828">
                  <c:v>385</c:v>
                </c:pt>
                <c:pt idx="829">
                  <c:v>384.8</c:v>
                </c:pt>
                <c:pt idx="830">
                  <c:v>384.6</c:v>
                </c:pt>
                <c:pt idx="831">
                  <c:v>384.4</c:v>
                </c:pt>
                <c:pt idx="832">
                  <c:v>384.2</c:v>
                </c:pt>
                <c:pt idx="833">
                  <c:v>384</c:v>
                </c:pt>
                <c:pt idx="834">
                  <c:v>383.8</c:v>
                </c:pt>
                <c:pt idx="835">
                  <c:v>383.6</c:v>
                </c:pt>
                <c:pt idx="836">
                  <c:v>383.4</c:v>
                </c:pt>
                <c:pt idx="837">
                  <c:v>383.2</c:v>
                </c:pt>
                <c:pt idx="838">
                  <c:v>383</c:v>
                </c:pt>
                <c:pt idx="839">
                  <c:v>382.8</c:v>
                </c:pt>
                <c:pt idx="840">
                  <c:v>382.6</c:v>
                </c:pt>
                <c:pt idx="841">
                  <c:v>382.4</c:v>
                </c:pt>
                <c:pt idx="842">
                  <c:v>382.2</c:v>
                </c:pt>
                <c:pt idx="843">
                  <c:v>382</c:v>
                </c:pt>
                <c:pt idx="844">
                  <c:v>381.8</c:v>
                </c:pt>
                <c:pt idx="845">
                  <c:v>381.6</c:v>
                </c:pt>
                <c:pt idx="846">
                  <c:v>381.4</c:v>
                </c:pt>
                <c:pt idx="847">
                  <c:v>381.2</c:v>
                </c:pt>
                <c:pt idx="848">
                  <c:v>381</c:v>
                </c:pt>
                <c:pt idx="849">
                  <c:v>380.8</c:v>
                </c:pt>
                <c:pt idx="850">
                  <c:v>380.6</c:v>
                </c:pt>
                <c:pt idx="851">
                  <c:v>380.4</c:v>
                </c:pt>
                <c:pt idx="852">
                  <c:v>380.2</c:v>
                </c:pt>
                <c:pt idx="853">
                  <c:v>380</c:v>
                </c:pt>
                <c:pt idx="854">
                  <c:v>379.8</c:v>
                </c:pt>
                <c:pt idx="855">
                  <c:v>379.6</c:v>
                </c:pt>
                <c:pt idx="856">
                  <c:v>379.4</c:v>
                </c:pt>
                <c:pt idx="857">
                  <c:v>379.2</c:v>
                </c:pt>
                <c:pt idx="858">
                  <c:v>379</c:v>
                </c:pt>
                <c:pt idx="859">
                  <c:v>378.8</c:v>
                </c:pt>
                <c:pt idx="860">
                  <c:v>378.6</c:v>
                </c:pt>
                <c:pt idx="861">
                  <c:v>378.4</c:v>
                </c:pt>
                <c:pt idx="862">
                  <c:v>378.2</c:v>
                </c:pt>
                <c:pt idx="863">
                  <c:v>378</c:v>
                </c:pt>
                <c:pt idx="864">
                  <c:v>377.8</c:v>
                </c:pt>
                <c:pt idx="865">
                  <c:v>377.6</c:v>
                </c:pt>
                <c:pt idx="866">
                  <c:v>377.4</c:v>
                </c:pt>
                <c:pt idx="867">
                  <c:v>377.2</c:v>
                </c:pt>
                <c:pt idx="868">
                  <c:v>377</c:v>
                </c:pt>
                <c:pt idx="869">
                  <c:v>376.8</c:v>
                </c:pt>
                <c:pt idx="870">
                  <c:v>376.6</c:v>
                </c:pt>
                <c:pt idx="871">
                  <c:v>376.4</c:v>
                </c:pt>
                <c:pt idx="872">
                  <c:v>376.2</c:v>
                </c:pt>
                <c:pt idx="873">
                  <c:v>376</c:v>
                </c:pt>
                <c:pt idx="874">
                  <c:v>375.8</c:v>
                </c:pt>
                <c:pt idx="875">
                  <c:v>375.6</c:v>
                </c:pt>
                <c:pt idx="876">
                  <c:v>375.4</c:v>
                </c:pt>
                <c:pt idx="877">
                  <c:v>375.2</c:v>
                </c:pt>
                <c:pt idx="878">
                  <c:v>375</c:v>
                </c:pt>
                <c:pt idx="879">
                  <c:v>374.8</c:v>
                </c:pt>
                <c:pt idx="880">
                  <c:v>374.6</c:v>
                </c:pt>
                <c:pt idx="881">
                  <c:v>374.4</c:v>
                </c:pt>
                <c:pt idx="882">
                  <c:v>374.2</c:v>
                </c:pt>
                <c:pt idx="883">
                  <c:v>374</c:v>
                </c:pt>
                <c:pt idx="884">
                  <c:v>373.8</c:v>
                </c:pt>
                <c:pt idx="885">
                  <c:v>373.6</c:v>
                </c:pt>
                <c:pt idx="886">
                  <c:v>373.4</c:v>
                </c:pt>
                <c:pt idx="887">
                  <c:v>373.2</c:v>
                </c:pt>
                <c:pt idx="888">
                  <c:v>373</c:v>
                </c:pt>
                <c:pt idx="889">
                  <c:v>372.8</c:v>
                </c:pt>
                <c:pt idx="890">
                  <c:v>372.6</c:v>
                </c:pt>
                <c:pt idx="891">
                  <c:v>372.4</c:v>
                </c:pt>
                <c:pt idx="892">
                  <c:v>372.2</c:v>
                </c:pt>
                <c:pt idx="893">
                  <c:v>372</c:v>
                </c:pt>
                <c:pt idx="894">
                  <c:v>371.8</c:v>
                </c:pt>
                <c:pt idx="895">
                  <c:v>371.6</c:v>
                </c:pt>
                <c:pt idx="896">
                  <c:v>371.4</c:v>
                </c:pt>
                <c:pt idx="897">
                  <c:v>371.2</c:v>
                </c:pt>
                <c:pt idx="898">
                  <c:v>371</c:v>
                </c:pt>
                <c:pt idx="899">
                  <c:v>370.8</c:v>
                </c:pt>
                <c:pt idx="900">
                  <c:v>370.6</c:v>
                </c:pt>
                <c:pt idx="901">
                  <c:v>370.4</c:v>
                </c:pt>
                <c:pt idx="902">
                  <c:v>370.2</c:v>
                </c:pt>
                <c:pt idx="903">
                  <c:v>370</c:v>
                </c:pt>
                <c:pt idx="904">
                  <c:v>369.8</c:v>
                </c:pt>
                <c:pt idx="905">
                  <c:v>369.6</c:v>
                </c:pt>
                <c:pt idx="906">
                  <c:v>369.4</c:v>
                </c:pt>
                <c:pt idx="907">
                  <c:v>369.2</c:v>
                </c:pt>
                <c:pt idx="908">
                  <c:v>369</c:v>
                </c:pt>
                <c:pt idx="909">
                  <c:v>368.8</c:v>
                </c:pt>
                <c:pt idx="910">
                  <c:v>368.6</c:v>
                </c:pt>
                <c:pt idx="911">
                  <c:v>368.4</c:v>
                </c:pt>
                <c:pt idx="912">
                  <c:v>368.2</c:v>
                </c:pt>
                <c:pt idx="913">
                  <c:v>368</c:v>
                </c:pt>
                <c:pt idx="914">
                  <c:v>367.8</c:v>
                </c:pt>
                <c:pt idx="915">
                  <c:v>367.6</c:v>
                </c:pt>
                <c:pt idx="916">
                  <c:v>367.4</c:v>
                </c:pt>
                <c:pt idx="917">
                  <c:v>367.2</c:v>
                </c:pt>
                <c:pt idx="918">
                  <c:v>367</c:v>
                </c:pt>
                <c:pt idx="919">
                  <c:v>366.8</c:v>
                </c:pt>
                <c:pt idx="920">
                  <c:v>366.6</c:v>
                </c:pt>
                <c:pt idx="921">
                  <c:v>366.4</c:v>
                </c:pt>
                <c:pt idx="922">
                  <c:v>366.2</c:v>
                </c:pt>
                <c:pt idx="923">
                  <c:v>366</c:v>
                </c:pt>
                <c:pt idx="924">
                  <c:v>365.8</c:v>
                </c:pt>
                <c:pt idx="925">
                  <c:v>365.6</c:v>
                </c:pt>
                <c:pt idx="926">
                  <c:v>365.4</c:v>
                </c:pt>
                <c:pt idx="927">
                  <c:v>365.2</c:v>
                </c:pt>
                <c:pt idx="928">
                  <c:v>365</c:v>
                </c:pt>
                <c:pt idx="929">
                  <c:v>364.8</c:v>
                </c:pt>
                <c:pt idx="930">
                  <c:v>364.6</c:v>
                </c:pt>
                <c:pt idx="931">
                  <c:v>364.4</c:v>
                </c:pt>
                <c:pt idx="932">
                  <c:v>364.2</c:v>
                </c:pt>
                <c:pt idx="933">
                  <c:v>364</c:v>
                </c:pt>
                <c:pt idx="934">
                  <c:v>363.8</c:v>
                </c:pt>
                <c:pt idx="935">
                  <c:v>363.6</c:v>
                </c:pt>
                <c:pt idx="936">
                  <c:v>363.4</c:v>
                </c:pt>
                <c:pt idx="937">
                  <c:v>363.2</c:v>
                </c:pt>
                <c:pt idx="938">
                  <c:v>363</c:v>
                </c:pt>
                <c:pt idx="939">
                  <c:v>362.8</c:v>
                </c:pt>
                <c:pt idx="940">
                  <c:v>362.6</c:v>
                </c:pt>
                <c:pt idx="941">
                  <c:v>362.4</c:v>
                </c:pt>
                <c:pt idx="942">
                  <c:v>362.2</c:v>
                </c:pt>
                <c:pt idx="943">
                  <c:v>362</c:v>
                </c:pt>
                <c:pt idx="944">
                  <c:v>361.8</c:v>
                </c:pt>
                <c:pt idx="945">
                  <c:v>361.6</c:v>
                </c:pt>
                <c:pt idx="946">
                  <c:v>361.4</c:v>
                </c:pt>
                <c:pt idx="947">
                  <c:v>361.2</c:v>
                </c:pt>
                <c:pt idx="948">
                  <c:v>361</c:v>
                </c:pt>
                <c:pt idx="949">
                  <c:v>360.8</c:v>
                </c:pt>
                <c:pt idx="950">
                  <c:v>360.6</c:v>
                </c:pt>
                <c:pt idx="951">
                  <c:v>360.4</c:v>
                </c:pt>
                <c:pt idx="952">
                  <c:v>360.2</c:v>
                </c:pt>
                <c:pt idx="953">
                  <c:v>360</c:v>
                </c:pt>
                <c:pt idx="954">
                  <c:v>359.8</c:v>
                </c:pt>
                <c:pt idx="955">
                  <c:v>359.6</c:v>
                </c:pt>
                <c:pt idx="956">
                  <c:v>359.4</c:v>
                </c:pt>
                <c:pt idx="957">
                  <c:v>359.2</c:v>
                </c:pt>
                <c:pt idx="958">
                  <c:v>359</c:v>
                </c:pt>
                <c:pt idx="959">
                  <c:v>358.8</c:v>
                </c:pt>
                <c:pt idx="960">
                  <c:v>358.6</c:v>
                </c:pt>
                <c:pt idx="961">
                  <c:v>358.4</c:v>
                </c:pt>
                <c:pt idx="962">
                  <c:v>358.2</c:v>
                </c:pt>
                <c:pt idx="963">
                  <c:v>358</c:v>
                </c:pt>
                <c:pt idx="964">
                  <c:v>357.8</c:v>
                </c:pt>
                <c:pt idx="965">
                  <c:v>357.6</c:v>
                </c:pt>
                <c:pt idx="966">
                  <c:v>357.4</c:v>
                </c:pt>
                <c:pt idx="967">
                  <c:v>357.2</c:v>
                </c:pt>
                <c:pt idx="968">
                  <c:v>357</c:v>
                </c:pt>
                <c:pt idx="969">
                  <c:v>356.8</c:v>
                </c:pt>
                <c:pt idx="970">
                  <c:v>356.6</c:v>
                </c:pt>
                <c:pt idx="971">
                  <c:v>356.4</c:v>
                </c:pt>
                <c:pt idx="972">
                  <c:v>356.2</c:v>
                </c:pt>
                <c:pt idx="973">
                  <c:v>356</c:v>
                </c:pt>
                <c:pt idx="974">
                  <c:v>355.8</c:v>
                </c:pt>
                <c:pt idx="975">
                  <c:v>355.6</c:v>
                </c:pt>
                <c:pt idx="976">
                  <c:v>355.4</c:v>
                </c:pt>
                <c:pt idx="977">
                  <c:v>355.2</c:v>
                </c:pt>
                <c:pt idx="978">
                  <c:v>355</c:v>
                </c:pt>
                <c:pt idx="979">
                  <c:v>354.8</c:v>
                </c:pt>
                <c:pt idx="980">
                  <c:v>354.6</c:v>
                </c:pt>
                <c:pt idx="981">
                  <c:v>354.4</c:v>
                </c:pt>
                <c:pt idx="982">
                  <c:v>354.2</c:v>
                </c:pt>
                <c:pt idx="983">
                  <c:v>354</c:v>
                </c:pt>
                <c:pt idx="984">
                  <c:v>353.8</c:v>
                </c:pt>
                <c:pt idx="985">
                  <c:v>353.6</c:v>
                </c:pt>
                <c:pt idx="986">
                  <c:v>353.4</c:v>
                </c:pt>
                <c:pt idx="987">
                  <c:v>353.2</c:v>
                </c:pt>
                <c:pt idx="988">
                  <c:v>353</c:v>
                </c:pt>
                <c:pt idx="989">
                  <c:v>352.8</c:v>
                </c:pt>
                <c:pt idx="990">
                  <c:v>352.6</c:v>
                </c:pt>
                <c:pt idx="991">
                  <c:v>352.4</c:v>
                </c:pt>
                <c:pt idx="992">
                  <c:v>352.2</c:v>
                </c:pt>
                <c:pt idx="993">
                  <c:v>352</c:v>
                </c:pt>
                <c:pt idx="994">
                  <c:v>351.8</c:v>
                </c:pt>
                <c:pt idx="995">
                  <c:v>351.6</c:v>
                </c:pt>
                <c:pt idx="996">
                  <c:v>351.4</c:v>
                </c:pt>
                <c:pt idx="997">
                  <c:v>351.2</c:v>
                </c:pt>
                <c:pt idx="998">
                  <c:v>351</c:v>
                </c:pt>
                <c:pt idx="999">
                  <c:v>350.8</c:v>
                </c:pt>
                <c:pt idx="1000">
                  <c:v>350.6</c:v>
                </c:pt>
                <c:pt idx="1001">
                  <c:v>350.4</c:v>
                </c:pt>
                <c:pt idx="1002">
                  <c:v>350.2</c:v>
                </c:pt>
                <c:pt idx="1003">
                  <c:v>350</c:v>
                </c:pt>
                <c:pt idx="1004">
                  <c:v>349.8</c:v>
                </c:pt>
                <c:pt idx="1005">
                  <c:v>349.6</c:v>
                </c:pt>
                <c:pt idx="1006">
                  <c:v>349.4</c:v>
                </c:pt>
                <c:pt idx="1007">
                  <c:v>349.2</c:v>
                </c:pt>
                <c:pt idx="1008">
                  <c:v>349</c:v>
                </c:pt>
                <c:pt idx="1009">
                  <c:v>348.8</c:v>
                </c:pt>
                <c:pt idx="1010">
                  <c:v>348.6</c:v>
                </c:pt>
                <c:pt idx="1011">
                  <c:v>348.4</c:v>
                </c:pt>
                <c:pt idx="1012">
                  <c:v>348.2</c:v>
                </c:pt>
                <c:pt idx="1013">
                  <c:v>348</c:v>
                </c:pt>
                <c:pt idx="1014">
                  <c:v>347.8</c:v>
                </c:pt>
                <c:pt idx="1015">
                  <c:v>347.6</c:v>
                </c:pt>
                <c:pt idx="1016">
                  <c:v>347.4</c:v>
                </c:pt>
                <c:pt idx="1017">
                  <c:v>347.2</c:v>
                </c:pt>
                <c:pt idx="1018">
                  <c:v>347</c:v>
                </c:pt>
                <c:pt idx="1019">
                  <c:v>346.8</c:v>
                </c:pt>
                <c:pt idx="1020">
                  <c:v>346.6</c:v>
                </c:pt>
                <c:pt idx="1021">
                  <c:v>346.4</c:v>
                </c:pt>
                <c:pt idx="1022">
                  <c:v>346.2</c:v>
                </c:pt>
                <c:pt idx="1023">
                  <c:v>346</c:v>
                </c:pt>
                <c:pt idx="1024">
                  <c:v>345.8</c:v>
                </c:pt>
                <c:pt idx="1025">
                  <c:v>345.6</c:v>
                </c:pt>
                <c:pt idx="1026">
                  <c:v>345.4</c:v>
                </c:pt>
                <c:pt idx="1027">
                  <c:v>345.2</c:v>
                </c:pt>
                <c:pt idx="1028">
                  <c:v>345</c:v>
                </c:pt>
                <c:pt idx="1029">
                  <c:v>344.8</c:v>
                </c:pt>
                <c:pt idx="1030">
                  <c:v>344.6</c:v>
                </c:pt>
                <c:pt idx="1031">
                  <c:v>344.4</c:v>
                </c:pt>
                <c:pt idx="1032">
                  <c:v>344.2</c:v>
                </c:pt>
                <c:pt idx="1033">
                  <c:v>344</c:v>
                </c:pt>
                <c:pt idx="1034">
                  <c:v>343.8</c:v>
                </c:pt>
                <c:pt idx="1035">
                  <c:v>343.6</c:v>
                </c:pt>
                <c:pt idx="1036">
                  <c:v>343.4</c:v>
                </c:pt>
                <c:pt idx="1037">
                  <c:v>343.2</c:v>
                </c:pt>
                <c:pt idx="1038">
                  <c:v>343</c:v>
                </c:pt>
                <c:pt idx="1039">
                  <c:v>342.8</c:v>
                </c:pt>
                <c:pt idx="1040">
                  <c:v>342.6</c:v>
                </c:pt>
                <c:pt idx="1041">
                  <c:v>342.4</c:v>
                </c:pt>
                <c:pt idx="1042">
                  <c:v>342.2</c:v>
                </c:pt>
                <c:pt idx="1043">
                  <c:v>342</c:v>
                </c:pt>
                <c:pt idx="1044">
                  <c:v>341.8</c:v>
                </c:pt>
                <c:pt idx="1045">
                  <c:v>341.6</c:v>
                </c:pt>
                <c:pt idx="1046">
                  <c:v>341.4</c:v>
                </c:pt>
                <c:pt idx="1047">
                  <c:v>341.2</c:v>
                </c:pt>
                <c:pt idx="1048">
                  <c:v>341</c:v>
                </c:pt>
                <c:pt idx="1049">
                  <c:v>340.8</c:v>
                </c:pt>
                <c:pt idx="1050">
                  <c:v>340.6</c:v>
                </c:pt>
                <c:pt idx="1051">
                  <c:v>340.4</c:v>
                </c:pt>
                <c:pt idx="1052">
                  <c:v>340.2</c:v>
                </c:pt>
                <c:pt idx="1053">
                  <c:v>340</c:v>
                </c:pt>
                <c:pt idx="1054">
                  <c:v>339.8</c:v>
                </c:pt>
                <c:pt idx="1055">
                  <c:v>339.6</c:v>
                </c:pt>
                <c:pt idx="1056">
                  <c:v>339.4</c:v>
                </c:pt>
                <c:pt idx="1057">
                  <c:v>339.2</c:v>
                </c:pt>
                <c:pt idx="1058">
                  <c:v>339</c:v>
                </c:pt>
                <c:pt idx="1059">
                  <c:v>338.8</c:v>
                </c:pt>
                <c:pt idx="1060">
                  <c:v>338.6</c:v>
                </c:pt>
                <c:pt idx="1061">
                  <c:v>338.4</c:v>
                </c:pt>
                <c:pt idx="1062">
                  <c:v>338.2</c:v>
                </c:pt>
                <c:pt idx="1063">
                  <c:v>338</c:v>
                </c:pt>
                <c:pt idx="1064">
                  <c:v>337.8</c:v>
                </c:pt>
                <c:pt idx="1065">
                  <c:v>337.6</c:v>
                </c:pt>
                <c:pt idx="1066">
                  <c:v>337.4</c:v>
                </c:pt>
                <c:pt idx="1067">
                  <c:v>337.2</c:v>
                </c:pt>
                <c:pt idx="1068">
                  <c:v>337</c:v>
                </c:pt>
                <c:pt idx="1069">
                  <c:v>336.8</c:v>
                </c:pt>
                <c:pt idx="1070">
                  <c:v>336.6</c:v>
                </c:pt>
                <c:pt idx="1071">
                  <c:v>336.4</c:v>
                </c:pt>
                <c:pt idx="1072">
                  <c:v>336.2</c:v>
                </c:pt>
                <c:pt idx="1073">
                  <c:v>336</c:v>
                </c:pt>
                <c:pt idx="1074">
                  <c:v>335.8</c:v>
                </c:pt>
                <c:pt idx="1075">
                  <c:v>335.6</c:v>
                </c:pt>
                <c:pt idx="1076">
                  <c:v>335.4</c:v>
                </c:pt>
                <c:pt idx="1077">
                  <c:v>335.2</c:v>
                </c:pt>
                <c:pt idx="1078">
                  <c:v>335</c:v>
                </c:pt>
                <c:pt idx="1079">
                  <c:v>334.8</c:v>
                </c:pt>
                <c:pt idx="1080">
                  <c:v>334.6</c:v>
                </c:pt>
                <c:pt idx="1081">
                  <c:v>334.4</c:v>
                </c:pt>
                <c:pt idx="1082">
                  <c:v>334.2</c:v>
                </c:pt>
                <c:pt idx="1083">
                  <c:v>334</c:v>
                </c:pt>
                <c:pt idx="1084">
                  <c:v>333.8</c:v>
                </c:pt>
                <c:pt idx="1085">
                  <c:v>333.6</c:v>
                </c:pt>
                <c:pt idx="1086">
                  <c:v>333.4</c:v>
                </c:pt>
                <c:pt idx="1087">
                  <c:v>333.2</c:v>
                </c:pt>
                <c:pt idx="1088">
                  <c:v>333</c:v>
                </c:pt>
                <c:pt idx="1089">
                  <c:v>332.8</c:v>
                </c:pt>
                <c:pt idx="1090">
                  <c:v>332.6</c:v>
                </c:pt>
                <c:pt idx="1091">
                  <c:v>332.4</c:v>
                </c:pt>
                <c:pt idx="1092">
                  <c:v>332.2</c:v>
                </c:pt>
                <c:pt idx="1093">
                  <c:v>332</c:v>
                </c:pt>
                <c:pt idx="1094">
                  <c:v>331.8</c:v>
                </c:pt>
                <c:pt idx="1095">
                  <c:v>331.6</c:v>
                </c:pt>
                <c:pt idx="1096">
                  <c:v>331.4</c:v>
                </c:pt>
                <c:pt idx="1097">
                  <c:v>331.2</c:v>
                </c:pt>
                <c:pt idx="1098">
                  <c:v>331</c:v>
                </c:pt>
                <c:pt idx="1099">
                  <c:v>330.8</c:v>
                </c:pt>
                <c:pt idx="1100">
                  <c:v>330.6</c:v>
                </c:pt>
                <c:pt idx="1101">
                  <c:v>330.4</c:v>
                </c:pt>
                <c:pt idx="1102">
                  <c:v>330.2</c:v>
                </c:pt>
                <c:pt idx="1103">
                  <c:v>330</c:v>
                </c:pt>
                <c:pt idx="1104">
                  <c:v>329.8</c:v>
                </c:pt>
                <c:pt idx="1105">
                  <c:v>329.6</c:v>
                </c:pt>
                <c:pt idx="1106">
                  <c:v>329.4</c:v>
                </c:pt>
                <c:pt idx="1107">
                  <c:v>329.2</c:v>
                </c:pt>
                <c:pt idx="1108">
                  <c:v>329</c:v>
                </c:pt>
                <c:pt idx="1109">
                  <c:v>328.8</c:v>
                </c:pt>
                <c:pt idx="1110">
                  <c:v>328.6</c:v>
                </c:pt>
                <c:pt idx="1111">
                  <c:v>328.4</c:v>
                </c:pt>
                <c:pt idx="1112">
                  <c:v>328.2</c:v>
                </c:pt>
                <c:pt idx="1113">
                  <c:v>328</c:v>
                </c:pt>
                <c:pt idx="1114">
                  <c:v>327.8</c:v>
                </c:pt>
                <c:pt idx="1115">
                  <c:v>327.60000000000002</c:v>
                </c:pt>
                <c:pt idx="1116">
                  <c:v>327.39999999999998</c:v>
                </c:pt>
                <c:pt idx="1117">
                  <c:v>327.2</c:v>
                </c:pt>
                <c:pt idx="1118">
                  <c:v>327</c:v>
                </c:pt>
                <c:pt idx="1119">
                  <c:v>326.8</c:v>
                </c:pt>
                <c:pt idx="1120">
                  <c:v>326.60000000000002</c:v>
                </c:pt>
                <c:pt idx="1121">
                  <c:v>326.39999999999998</c:v>
                </c:pt>
                <c:pt idx="1122">
                  <c:v>326.2</c:v>
                </c:pt>
                <c:pt idx="1123">
                  <c:v>326</c:v>
                </c:pt>
                <c:pt idx="1124">
                  <c:v>325.8</c:v>
                </c:pt>
                <c:pt idx="1125">
                  <c:v>325.60000000000002</c:v>
                </c:pt>
                <c:pt idx="1126">
                  <c:v>325.39999999999998</c:v>
                </c:pt>
                <c:pt idx="1127">
                  <c:v>325.2</c:v>
                </c:pt>
                <c:pt idx="1128">
                  <c:v>325</c:v>
                </c:pt>
                <c:pt idx="1129">
                  <c:v>324.8</c:v>
                </c:pt>
                <c:pt idx="1130">
                  <c:v>324.60000000000002</c:v>
                </c:pt>
                <c:pt idx="1131">
                  <c:v>324.39999999999998</c:v>
                </c:pt>
                <c:pt idx="1132">
                  <c:v>324.2</c:v>
                </c:pt>
                <c:pt idx="1133">
                  <c:v>324</c:v>
                </c:pt>
                <c:pt idx="1134">
                  <c:v>323.8</c:v>
                </c:pt>
                <c:pt idx="1135">
                  <c:v>323.60000000000002</c:v>
                </c:pt>
                <c:pt idx="1136">
                  <c:v>323.39999999999998</c:v>
                </c:pt>
                <c:pt idx="1137">
                  <c:v>323.2</c:v>
                </c:pt>
                <c:pt idx="1138">
                  <c:v>323</c:v>
                </c:pt>
                <c:pt idx="1139">
                  <c:v>322.8</c:v>
                </c:pt>
                <c:pt idx="1140">
                  <c:v>322.60000000000002</c:v>
                </c:pt>
                <c:pt idx="1141">
                  <c:v>322.39999999999998</c:v>
                </c:pt>
                <c:pt idx="1142">
                  <c:v>322.2</c:v>
                </c:pt>
                <c:pt idx="1143">
                  <c:v>322</c:v>
                </c:pt>
                <c:pt idx="1144">
                  <c:v>321.8</c:v>
                </c:pt>
                <c:pt idx="1145">
                  <c:v>321.60000000000002</c:v>
                </c:pt>
                <c:pt idx="1146">
                  <c:v>321.39999999999998</c:v>
                </c:pt>
                <c:pt idx="1147">
                  <c:v>321.2</c:v>
                </c:pt>
                <c:pt idx="1148">
                  <c:v>321</c:v>
                </c:pt>
                <c:pt idx="1149">
                  <c:v>320.8</c:v>
                </c:pt>
                <c:pt idx="1150">
                  <c:v>320.60000000000002</c:v>
                </c:pt>
                <c:pt idx="1151">
                  <c:v>320.39999999999998</c:v>
                </c:pt>
                <c:pt idx="1152">
                  <c:v>320.2</c:v>
                </c:pt>
                <c:pt idx="1153">
                  <c:v>320</c:v>
                </c:pt>
                <c:pt idx="1154">
                  <c:v>319.8</c:v>
                </c:pt>
                <c:pt idx="1155">
                  <c:v>319.60000000000002</c:v>
                </c:pt>
                <c:pt idx="1156">
                  <c:v>319.39999999999998</c:v>
                </c:pt>
                <c:pt idx="1157">
                  <c:v>319.2</c:v>
                </c:pt>
                <c:pt idx="1158">
                  <c:v>319</c:v>
                </c:pt>
                <c:pt idx="1159">
                  <c:v>318.8</c:v>
                </c:pt>
                <c:pt idx="1160">
                  <c:v>318.60000000000002</c:v>
                </c:pt>
                <c:pt idx="1161">
                  <c:v>318.39999999999998</c:v>
                </c:pt>
                <c:pt idx="1162">
                  <c:v>318.2</c:v>
                </c:pt>
                <c:pt idx="1163">
                  <c:v>318</c:v>
                </c:pt>
                <c:pt idx="1164">
                  <c:v>317.8</c:v>
                </c:pt>
                <c:pt idx="1165">
                  <c:v>317.60000000000002</c:v>
                </c:pt>
                <c:pt idx="1166">
                  <c:v>317.39999999999998</c:v>
                </c:pt>
                <c:pt idx="1167">
                  <c:v>317.2</c:v>
                </c:pt>
                <c:pt idx="1168">
                  <c:v>317</c:v>
                </c:pt>
                <c:pt idx="1169">
                  <c:v>316.8</c:v>
                </c:pt>
                <c:pt idx="1170">
                  <c:v>316.60000000000002</c:v>
                </c:pt>
                <c:pt idx="1171">
                  <c:v>316.39999999999998</c:v>
                </c:pt>
                <c:pt idx="1172">
                  <c:v>316.2</c:v>
                </c:pt>
                <c:pt idx="1173">
                  <c:v>316</c:v>
                </c:pt>
                <c:pt idx="1174">
                  <c:v>315.8</c:v>
                </c:pt>
                <c:pt idx="1175">
                  <c:v>315.60000000000002</c:v>
                </c:pt>
                <c:pt idx="1176">
                  <c:v>315.39999999999998</c:v>
                </c:pt>
                <c:pt idx="1177">
                  <c:v>315.2</c:v>
                </c:pt>
                <c:pt idx="1178">
                  <c:v>315</c:v>
                </c:pt>
                <c:pt idx="1179">
                  <c:v>314.8</c:v>
                </c:pt>
                <c:pt idx="1180">
                  <c:v>314.60000000000002</c:v>
                </c:pt>
                <c:pt idx="1181">
                  <c:v>314.39999999999998</c:v>
                </c:pt>
                <c:pt idx="1182">
                  <c:v>314.2</c:v>
                </c:pt>
                <c:pt idx="1183">
                  <c:v>314</c:v>
                </c:pt>
                <c:pt idx="1184">
                  <c:v>313.8</c:v>
                </c:pt>
                <c:pt idx="1185">
                  <c:v>313.60000000000002</c:v>
                </c:pt>
                <c:pt idx="1186">
                  <c:v>313.39999999999998</c:v>
                </c:pt>
                <c:pt idx="1187">
                  <c:v>313.2</c:v>
                </c:pt>
                <c:pt idx="1188">
                  <c:v>313</c:v>
                </c:pt>
                <c:pt idx="1189">
                  <c:v>312.8</c:v>
                </c:pt>
                <c:pt idx="1190">
                  <c:v>312.60000000000002</c:v>
                </c:pt>
                <c:pt idx="1191">
                  <c:v>312.39999999999998</c:v>
                </c:pt>
                <c:pt idx="1192">
                  <c:v>312.2</c:v>
                </c:pt>
                <c:pt idx="1193">
                  <c:v>312</c:v>
                </c:pt>
                <c:pt idx="1194">
                  <c:v>311.8</c:v>
                </c:pt>
                <c:pt idx="1195">
                  <c:v>311.60000000000002</c:v>
                </c:pt>
                <c:pt idx="1196">
                  <c:v>311.39999999999998</c:v>
                </c:pt>
                <c:pt idx="1197">
                  <c:v>311.2</c:v>
                </c:pt>
                <c:pt idx="1198">
                  <c:v>311</c:v>
                </c:pt>
                <c:pt idx="1199">
                  <c:v>310.8</c:v>
                </c:pt>
                <c:pt idx="1200">
                  <c:v>310.60000000000002</c:v>
                </c:pt>
                <c:pt idx="1201">
                  <c:v>310.39999999999998</c:v>
                </c:pt>
                <c:pt idx="1202">
                  <c:v>310.2</c:v>
                </c:pt>
                <c:pt idx="1203">
                  <c:v>310</c:v>
                </c:pt>
                <c:pt idx="1204">
                  <c:v>309.8</c:v>
                </c:pt>
                <c:pt idx="1205">
                  <c:v>309.60000000000002</c:v>
                </c:pt>
                <c:pt idx="1206">
                  <c:v>309.39999999999998</c:v>
                </c:pt>
                <c:pt idx="1207">
                  <c:v>309.2</c:v>
                </c:pt>
                <c:pt idx="1208">
                  <c:v>309</c:v>
                </c:pt>
                <c:pt idx="1209">
                  <c:v>308.8</c:v>
                </c:pt>
                <c:pt idx="1210">
                  <c:v>308.60000000000002</c:v>
                </c:pt>
                <c:pt idx="1211">
                  <c:v>308.39999999999998</c:v>
                </c:pt>
                <c:pt idx="1212">
                  <c:v>308.2</c:v>
                </c:pt>
                <c:pt idx="1213">
                  <c:v>308</c:v>
                </c:pt>
                <c:pt idx="1214">
                  <c:v>307.8</c:v>
                </c:pt>
                <c:pt idx="1215">
                  <c:v>307.60000000000002</c:v>
                </c:pt>
                <c:pt idx="1216">
                  <c:v>307.39999999999998</c:v>
                </c:pt>
                <c:pt idx="1217">
                  <c:v>307.2</c:v>
                </c:pt>
                <c:pt idx="1218">
                  <c:v>307</c:v>
                </c:pt>
                <c:pt idx="1219">
                  <c:v>306.8</c:v>
                </c:pt>
                <c:pt idx="1220">
                  <c:v>306.60000000000002</c:v>
                </c:pt>
                <c:pt idx="1221">
                  <c:v>306.39999999999998</c:v>
                </c:pt>
                <c:pt idx="1222">
                  <c:v>306.2</c:v>
                </c:pt>
                <c:pt idx="1223">
                  <c:v>306</c:v>
                </c:pt>
                <c:pt idx="1224">
                  <c:v>305.8</c:v>
                </c:pt>
                <c:pt idx="1225">
                  <c:v>305.60000000000002</c:v>
                </c:pt>
                <c:pt idx="1226">
                  <c:v>305.39999999999998</c:v>
                </c:pt>
                <c:pt idx="1227">
                  <c:v>305.2</c:v>
                </c:pt>
                <c:pt idx="1228">
                  <c:v>305</c:v>
                </c:pt>
                <c:pt idx="1229">
                  <c:v>304.8</c:v>
                </c:pt>
                <c:pt idx="1230">
                  <c:v>304.60000000000002</c:v>
                </c:pt>
                <c:pt idx="1231">
                  <c:v>304.39999999999998</c:v>
                </c:pt>
                <c:pt idx="1232">
                  <c:v>304.2</c:v>
                </c:pt>
                <c:pt idx="1233">
                  <c:v>304</c:v>
                </c:pt>
                <c:pt idx="1234">
                  <c:v>303.8</c:v>
                </c:pt>
                <c:pt idx="1235">
                  <c:v>303.60000000000002</c:v>
                </c:pt>
                <c:pt idx="1236">
                  <c:v>303.39999999999998</c:v>
                </c:pt>
                <c:pt idx="1237">
                  <c:v>303.2</c:v>
                </c:pt>
                <c:pt idx="1238">
                  <c:v>303</c:v>
                </c:pt>
                <c:pt idx="1239">
                  <c:v>302.8</c:v>
                </c:pt>
                <c:pt idx="1240">
                  <c:v>302.60000000000002</c:v>
                </c:pt>
                <c:pt idx="1241">
                  <c:v>302.39999999999998</c:v>
                </c:pt>
                <c:pt idx="1242">
                  <c:v>302.2</c:v>
                </c:pt>
                <c:pt idx="1243">
                  <c:v>302</c:v>
                </c:pt>
                <c:pt idx="1244">
                  <c:v>301.8</c:v>
                </c:pt>
                <c:pt idx="1245">
                  <c:v>301.60000000000002</c:v>
                </c:pt>
                <c:pt idx="1246">
                  <c:v>301.39999999999998</c:v>
                </c:pt>
                <c:pt idx="1247">
                  <c:v>301.2</c:v>
                </c:pt>
                <c:pt idx="1248">
                  <c:v>301</c:v>
                </c:pt>
                <c:pt idx="1249">
                  <c:v>300.8</c:v>
                </c:pt>
                <c:pt idx="1250">
                  <c:v>300.60000000000002</c:v>
                </c:pt>
                <c:pt idx="1251">
                  <c:v>300.39999999999998</c:v>
                </c:pt>
                <c:pt idx="1252">
                  <c:v>300.2</c:v>
                </c:pt>
                <c:pt idx="1253">
                  <c:v>300</c:v>
                </c:pt>
              </c:numCache>
            </c:numRef>
          </c:xVal>
          <c:yVal>
            <c:numRef>
              <c:f>Hoja1!$BY$2:$BY$1255</c:f>
              <c:numCache>
                <c:formatCode>General</c:formatCode>
                <c:ptCount val="1254"/>
                <c:pt idx="0">
                  <c:v>0</c:v>
                </c:pt>
                <c:pt idx="1">
                  <c:v>0</c:v>
                </c:pt>
                <c:pt idx="3">
                  <c:v>5.7166666666666659E-3</c:v>
                </c:pt>
                <c:pt idx="4">
                  <c:v>6.9000000000000034E-3</c:v>
                </c:pt>
                <c:pt idx="5">
                  <c:v>8.4500000000000061E-3</c:v>
                </c:pt>
                <c:pt idx="6">
                  <c:v>1.0266666666666672E-2</c:v>
                </c:pt>
                <c:pt idx="7">
                  <c:v>1.2133333333333336E-2</c:v>
                </c:pt>
                <c:pt idx="8">
                  <c:v>1.3850000000000001E-2</c:v>
                </c:pt>
                <c:pt idx="9">
                  <c:v>1.5716666666666667E-2</c:v>
                </c:pt>
                <c:pt idx="10">
                  <c:v>1.751666666666667E-2</c:v>
                </c:pt>
                <c:pt idx="11">
                  <c:v>1.9266666666666668E-2</c:v>
                </c:pt>
                <c:pt idx="12">
                  <c:v>2.1183333333333332E-2</c:v>
                </c:pt>
                <c:pt idx="13">
                  <c:v>2.303333333333334E-2</c:v>
                </c:pt>
                <c:pt idx="14">
                  <c:v>2.4899999999999995E-2</c:v>
                </c:pt>
                <c:pt idx="15">
                  <c:v>2.6800000000000004E-2</c:v>
                </c:pt>
                <c:pt idx="16">
                  <c:v>2.8783333333333338E-2</c:v>
                </c:pt>
                <c:pt idx="17">
                  <c:v>3.078333333333334E-2</c:v>
                </c:pt>
                <c:pt idx="18">
                  <c:v>3.2816666666666668E-2</c:v>
                </c:pt>
                <c:pt idx="19">
                  <c:v>3.5050000000000005E-2</c:v>
                </c:pt>
                <c:pt idx="20">
                  <c:v>3.7133333333333345E-2</c:v>
                </c:pt>
                <c:pt idx="21">
                  <c:v>3.9216666666666671E-2</c:v>
                </c:pt>
                <c:pt idx="22">
                  <c:v>4.1350000000000005E-2</c:v>
                </c:pt>
                <c:pt idx="23">
                  <c:v>4.3533333333333334E-2</c:v>
                </c:pt>
                <c:pt idx="24">
                  <c:v>4.5650000000000003E-2</c:v>
                </c:pt>
                <c:pt idx="25">
                  <c:v>4.7833333333333339E-2</c:v>
                </c:pt>
                <c:pt idx="26">
                  <c:v>5.0016666666666661E-2</c:v>
                </c:pt>
                <c:pt idx="27">
                  <c:v>5.2266666666666663E-2</c:v>
                </c:pt>
                <c:pt idx="28">
                  <c:v>5.4550000000000008E-2</c:v>
                </c:pt>
                <c:pt idx="29">
                  <c:v>5.6899999999999999E-2</c:v>
                </c:pt>
                <c:pt idx="30">
                  <c:v>5.9266666666666662E-2</c:v>
                </c:pt>
                <c:pt idx="31">
                  <c:v>6.1733333333333341E-2</c:v>
                </c:pt>
                <c:pt idx="32">
                  <c:v>6.4149999999999999E-2</c:v>
                </c:pt>
                <c:pt idx="33">
                  <c:v>6.6616666666666671E-2</c:v>
                </c:pt>
                <c:pt idx="34">
                  <c:v>6.9133333333333338E-2</c:v>
                </c:pt>
                <c:pt idx="35">
                  <c:v>7.1616666666666676E-2</c:v>
                </c:pt>
                <c:pt idx="36">
                  <c:v>7.4233333333333332E-2</c:v>
                </c:pt>
                <c:pt idx="37">
                  <c:v>7.6816666666666686E-2</c:v>
                </c:pt>
                <c:pt idx="38">
                  <c:v>7.9416666666666663E-2</c:v>
                </c:pt>
                <c:pt idx="39">
                  <c:v>8.2050000000000012E-2</c:v>
                </c:pt>
                <c:pt idx="40">
                  <c:v>8.4733333333333327E-2</c:v>
                </c:pt>
                <c:pt idx="41">
                  <c:v>8.7516666666666645E-2</c:v>
                </c:pt>
                <c:pt idx="42">
                  <c:v>9.0433333333333324E-2</c:v>
                </c:pt>
                <c:pt idx="43">
                  <c:v>9.3299999999999994E-2</c:v>
                </c:pt>
                <c:pt idx="44">
                  <c:v>9.611666666666667E-2</c:v>
                </c:pt>
                <c:pt idx="45">
                  <c:v>9.8916666666666667E-2</c:v>
                </c:pt>
                <c:pt idx="46">
                  <c:v>0.10173333333333334</c:v>
                </c:pt>
                <c:pt idx="47">
                  <c:v>0.10459999999999998</c:v>
                </c:pt>
                <c:pt idx="48">
                  <c:v>0.10743333333333334</c:v>
                </c:pt>
                <c:pt idx="49">
                  <c:v>0.11031666666666666</c:v>
                </c:pt>
                <c:pt idx="50">
                  <c:v>0.11323333333333334</c:v>
                </c:pt>
                <c:pt idx="51">
                  <c:v>0.11621666666666665</c:v>
                </c:pt>
                <c:pt idx="52">
                  <c:v>0.11926666666666667</c:v>
                </c:pt>
                <c:pt idx="53">
                  <c:v>0.12230000000000001</c:v>
                </c:pt>
                <c:pt idx="54">
                  <c:v>0.12533333333333332</c:v>
                </c:pt>
                <c:pt idx="55">
                  <c:v>0.12841666666666665</c:v>
                </c:pt>
                <c:pt idx="56">
                  <c:v>0.13139999999999999</c:v>
                </c:pt>
                <c:pt idx="57">
                  <c:v>0.13436666666666666</c:v>
                </c:pt>
                <c:pt idx="58">
                  <c:v>0.13733333333333334</c:v>
                </c:pt>
                <c:pt idx="59">
                  <c:v>0.14033333333333334</c:v>
                </c:pt>
                <c:pt idx="60">
                  <c:v>0.14335000000000001</c:v>
                </c:pt>
                <c:pt idx="61">
                  <c:v>0.14641666666666667</c:v>
                </c:pt>
                <c:pt idx="62">
                  <c:v>0.14948333333333333</c:v>
                </c:pt>
                <c:pt idx="63">
                  <c:v>0.15263333333333332</c:v>
                </c:pt>
                <c:pt idx="64">
                  <c:v>0.15578333333333336</c:v>
                </c:pt>
                <c:pt idx="65">
                  <c:v>0.15914999999999999</c:v>
                </c:pt>
                <c:pt idx="66">
                  <c:v>0.16244999999999998</c:v>
                </c:pt>
                <c:pt idx="67">
                  <c:v>0.1656</c:v>
                </c:pt>
                <c:pt idx="68">
                  <c:v>0.16876666666666665</c:v>
                </c:pt>
                <c:pt idx="69">
                  <c:v>0.17203333333333334</c:v>
                </c:pt>
                <c:pt idx="70">
                  <c:v>0.17521666666666666</c:v>
                </c:pt>
                <c:pt idx="71">
                  <c:v>0.17833333333333334</c:v>
                </c:pt>
                <c:pt idx="72">
                  <c:v>0.18136666666666668</c:v>
                </c:pt>
                <c:pt idx="73">
                  <c:v>0.18436666666666668</c:v>
                </c:pt>
                <c:pt idx="74">
                  <c:v>0.18735000000000002</c:v>
                </c:pt>
                <c:pt idx="75">
                  <c:v>0.19043333333333334</c:v>
                </c:pt>
                <c:pt idx="76">
                  <c:v>0.19368333333333335</c:v>
                </c:pt>
                <c:pt idx="77">
                  <c:v>0.19686666666666666</c:v>
                </c:pt>
                <c:pt idx="78">
                  <c:v>0.19996666666666665</c:v>
                </c:pt>
                <c:pt idx="79">
                  <c:v>0.20306666666666665</c:v>
                </c:pt>
                <c:pt idx="80">
                  <c:v>0.20606666666666665</c:v>
                </c:pt>
                <c:pt idx="81">
                  <c:v>0.2091166666666667</c:v>
                </c:pt>
                <c:pt idx="82">
                  <c:v>0.21216666666666664</c:v>
                </c:pt>
                <c:pt idx="83">
                  <c:v>0.21525000000000002</c:v>
                </c:pt>
                <c:pt idx="84">
                  <c:v>0.21831666666666663</c:v>
                </c:pt>
                <c:pt idx="85">
                  <c:v>0.22136666666666671</c:v>
                </c:pt>
                <c:pt idx="86">
                  <c:v>0.22443333333333329</c:v>
                </c:pt>
                <c:pt idx="87">
                  <c:v>0.22746666666666668</c:v>
                </c:pt>
                <c:pt idx="88">
                  <c:v>0.23064999999999999</c:v>
                </c:pt>
                <c:pt idx="89">
                  <c:v>0.23368333333333333</c:v>
                </c:pt>
                <c:pt idx="90">
                  <c:v>0.23656666666666668</c:v>
                </c:pt>
                <c:pt idx="91">
                  <c:v>0.23935000000000003</c:v>
                </c:pt>
                <c:pt idx="92">
                  <c:v>0.24213333333333331</c:v>
                </c:pt>
                <c:pt idx="93">
                  <c:v>0.24493333333333331</c:v>
                </c:pt>
                <c:pt idx="94">
                  <c:v>0.24776666666666672</c:v>
                </c:pt>
                <c:pt idx="95">
                  <c:v>0.25053333333333333</c:v>
                </c:pt>
                <c:pt idx="96">
                  <c:v>0.2532666666666667</c:v>
                </c:pt>
                <c:pt idx="97">
                  <c:v>0.25598333333333328</c:v>
                </c:pt>
                <c:pt idx="98">
                  <c:v>0.25864999999999999</c:v>
                </c:pt>
                <c:pt idx="99">
                  <c:v>0.26143333333333335</c:v>
                </c:pt>
                <c:pt idx="100">
                  <c:v>0.26408333333333334</c:v>
                </c:pt>
                <c:pt idx="101">
                  <c:v>0.26658333333333334</c:v>
                </c:pt>
                <c:pt idx="102">
                  <c:v>0.26903333333333335</c:v>
                </c:pt>
                <c:pt idx="103">
                  <c:v>0.27141666666666669</c:v>
                </c:pt>
                <c:pt idx="104">
                  <c:v>0.27376666666666666</c:v>
                </c:pt>
                <c:pt idx="105">
                  <c:v>0.27608333333333335</c:v>
                </c:pt>
                <c:pt idx="106">
                  <c:v>0.27848333333333336</c:v>
                </c:pt>
                <c:pt idx="107">
                  <c:v>0.28075</c:v>
                </c:pt>
                <c:pt idx="108">
                  <c:v>0.28281666666666666</c:v>
                </c:pt>
                <c:pt idx="109">
                  <c:v>0.28486666666666666</c:v>
                </c:pt>
                <c:pt idx="110">
                  <c:v>0.28689999999999999</c:v>
                </c:pt>
                <c:pt idx="111">
                  <c:v>0.28878333333333334</c:v>
                </c:pt>
                <c:pt idx="112">
                  <c:v>0.29076666666666667</c:v>
                </c:pt>
                <c:pt idx="113">
                  <c:v>0.29265000000000002</c:v>
                </c:pt>
                <c:pt idx="114">
                  <c:v>0.29441666666666672</c:v>
                </c:pt>
                <c:pt idx="115">
                  <c:v>0.29615000000000002</c:v>
                </c:pt>
                <c:pt idx="116">
                  <c:v>0.29771666666666668</c:v>
                </c:pt>
                <c:pt idx="117">
                  <c:v>0.29918333333333336</c:v>
                </c:pt>
                <c:pt idx="118">
                  <c:v>0.30063333333333331</c:v>
                </c:pt>
                <c:pt idx="119">
                  <c:v>0.30198333333333333</c:v>
                </c:pt>
                <c:pt idx="120">
                  <c:v>0.30335000000000001</c:v>
                </c:pt>
                <c:pt idx="121">
                  <c:v>0.30458333333333337</c:v>
                </c:pt>
                <c:pt idx="122">
                  <c:v>0.30573333333333336</c:v>
                </c:pt>
                <c:pt idx="123">
                  <c:v>0.30683333333333335</c:v>
                </c:pt>
                <c:pt idx="124">
                  <c:v>0.30781666666666668</c:v>
                </c:pt>
                <c:pt idx="125">
                  <c:v>0.30866666666666664</c:v>
                </c:pt>
                <c:pt idx="126">
                  <c:v>0.30950000000000005</c:v>
                </c:pt>
                <c:pt idx="127">
                  <c:v>0.31024999999999997</c:v>
                </c:pt>
                <c:pt idx="128">
                  <c:v>0.311</c:v>
                </c:pt>
                <c:pt idx="129">
                  <c:v>0.31164999999999998</c:v>
                </c:pt>
                <c:pt idx="130">
                  <c:v>0.31224999999999997</c:v>
                </c:pt>
                <c:pt idx="131">
                  <c:v>0.31281666666666663</c:v>
                </c:pt>
                <c:pt idx="132">
                  <c:v>0.31326666666666664</c:v>
                </c:pt>
                <c:pt idx="133">
                  <c:v>0.31360000000000005</c:v>
                </c:pt>
                <c:pt idx="134">
                  <c:v>0.31391666666666668</c:v>
                </c:pt>
                <c:pt idx="135">
                  <c:v>0.31416666666666665</c:v>
                </c:pt>
                <c:pt idx="136">
                  <c:v>0.31438333333333329</c:v>
                </c:pt>
                <c:pt idx="137">
                  <c:v>0.31446666666666667</c:v>
                </c:pt>
                <c:pt idx="138">
                  <c:v>0.31451666666666672</c:v>
                </c:pt>
                <c:pt idx="139">
                  <c:v>0.31450000000000006</c:v>
                </c:pt>
                <c:pt idx="140">
                  <c:v>0.31440000000000001</c:v>
                </c:pt>
                <c:pt idx="141">
                  <c:v>0.3142833333333333</c:v>
                </c:pt>
                <c:pt idx="142">
                  <c:v>0.31411666666666666</c:v>
                </c:pt>
                <c:pt idx="143">
                  <c:v>0.31381666666666669</c:v>
                </c:pt>
                <c:pt idx="144">
                  <c:v>0.31348333333333328</c:v>
                </c:pt>
                <c:pt idx="145">
                  <c:v>0.31306666666666666</c:v>
                </c:pt>
                <c:pt idx="146">
                  <c:v>0.31264999999999998</c:v>
                </c:pt>
                <c:pt idx="147">
                  <c:v>0.31223333333333336</c:v>
                </c:pt>
                <c:pt idx="148">
                  <c:v>0.31168333333333331</c:v>
                </c:pt>
                <c:pt idx="149">
                  <c:v>0.31113333333333332</c:v>
                </c:pt>
                <c:pt idx="150">
                  <c:v>0.31056666666666671</c:v>
                </c:pt>
                <c:pt idx="151">
                  <c:v>0.30990000000000001</c:v>
                </c:pt>
                <c:pt idx="152">
                  <c:v>0.30926666666666663</c:v>
                </c:pt>
                <c:pt idx="153">
                  <c:v>0.30850000000000005</c:v>
                </c:pt>
                <c:pt idx="154">
                  <c:v>0.30773333333333336</c:v>
                </c:pt>
                <c:pt idx="155">
                  <c:v>0.30701666666666666</c:v>
                </c:pt>
                <c:pt idx="156">
                  <c:v>0.30614999999999998</c:v>
                </c:pt>
                <c:pt idx="157">
                  <c:v>0.30535000000000007</c:v>
                </c:pt>
                <c:pt idx="158">
                  <c:v>0.30438333333333334</c:v>
                </c:pt>
                <c:pt idx="159">
                  <c:v>0.30345</c:v>
                </c:pt>
                <c:pt idx="160">
                  <c:v>0.30243333333333333</c:v>
                </c:pt>
                <c:pt idx="161">
                  <c:v>0.30158333333333337</c:v>
                </c:pt>
                <c:pt idx="162">
                  <c:v>0.30059999999999998</c:v>
                </c:pt>
                <c:pt idx="163">
                  <c:v>0.29974999999999996</c:v>
                </c:pt>
                <c:pt idx="164">
                  <c:v>0.29883333333333334</c:v>
                </c:pt>
                <c:pt idx="165">
                  <c:v>0.2979</c:v>
                </c:pt>
                <c:pt idx="166">
                  <c:v>0.29703333333333337</c:v>
                </c:pt>
                <c:pt idx="167">
                  <c:v>0.29613333333333336</c:v>
                </c:pt>
                <c:pt idx="168">
                  <c:v>0.29525000000000001</c:v>
                </c:pt>
                <c:pt idx="169">
                  <c:v>0.29436666666666667</c:v>
                </c:pt>
                <c:pt idx="170">
                  <c:v>0.29346666666666665</c:v>
                </c:pt>
                <c:pt idx="171">
                  <c:v>0.29265000000000002</c:v>
                </c:pt>
                <c:pt idx="172">
                  <c:v>0.29183333333333333</c:v>
                </c:pt>
                <c:pt idx="173">
                  <c:v>0.29106666666666664</c:v>
                </c:pt>
                <c:pt idx="174">
                  <c:v>0.29023333333333334</c:v>
                </c:pt>
                <c:pt idx="175">
                  <c:v>0.28939999999999999</c:v>
                </c:pt>
                <c:pt idx="176">
                  <c:v>0.28856666666666664</c:v>
                </c:pt>
                <c:pt idx="177">
                  <c:v>0.28773333333333329</c:v>
                </c:pt>
                <c:pt idx="178">
                  <c:v>0.28703333333333331</c:v>
                </c:pt>
                <c:pt idx="179">
                  <c:v>0.28635000000000005</c:v>
                </c:pt>
                <c:pt idx="180">
                  <c:v>0.28571666666666667</c:v>
                </c:pt>
                <c:pt idx="181">
                  <c:v>0.28513333333333329</c:v>
                </c:pt>
                <c:pt idx="182">
                  <c:v>0.28455000000000003</c:v>
                </c:pt>
                <c:pt idx="183">
                  <c:v>0.28400000000000003</c:v>
                </c:pt>
                <c:pt idx="184">
                  <c:v>0.28348333333333336</c:v>
                </c:pt>
                <c:pt idx="185">
                  <c:v>0.28301666666666669</c:v>
                </c:pt>
                <c:pt idx="186">
                  <c:v>0.28253333333333336</c:v>
                </c:pt>
                <c:pt idx="187">
                  <c:v>0.28211666666666674</c:v>
                </c:pt>
                <c:pt idx="188">
                  <c:v>0.28170000000000001</c:v>
                </c:pt>
                <c:pt idx="189">
                  <c:v>0.28136666666666665</c:v>
                </c:pt>
                <c:pt idx="190">
                  <c:v>0.28109999999999996</c:v>
                </c:pt>
                <c:pt idx="191">
                  <c:v>0.28084999999999999</c:v>
                </c:pt>
                <c:pt idx="192">
                  <c:v>0.28060000000000002</c:v>
                </c:pt>
                <c:pt idx="193">
                  <c:v>0.28043333333333337</c:v>
                </c:pt>
                <c:pt idx="194">
                  <c:v>0.28028333333333333</c:v>
                </c:pt>
                <c:pt idx="195">
                  <c:v>0.28018333333333334</c:v>
                </c:pt>
                <c:pt idx="196">
                  <c:v>0.28018333333333334</c:v>
                </c:pt>
                <c:pt idx="197">
                  <c:v>0.2801833333333334</c:v>
                </c:pt>
                <c:pt idx="198">
                  <c:v>0.28021666666666667</c:v>
                </c:pt>
                <c:pt idx="199">
                  <c:v>0.28033333333333338</c:v>
                </c:pt>
                <c:pt idx="200">
                  <c:v>0.28058333333333335</c:v>
                </c:pt>
                <c:pt idx="201">
                  <c:v>0.28076666666666666</c:v>
                </c:pt>
                <c:pt idx="202">
                  <c:v>0.28106666666666669</c:v>
                </c:pt>
                <c:pt idx="203">
                  <c:v>0.28138333333333332</c:v>
                </c:pt>
                <c:pt idx="204">
                  <c:v>0.28171666666666662</c:v>
                </c:pt>
                <c:pt idx="205">
                  <c:v>0.28220000000000001</c:v>
                </c:pt>
                <c:pt idx="206">
                  <c:v>0.28266666666666668</c:v>
                </c:pt>
                <c:pt idx="207">
                  <c:v>0.28318333333333334</c:v>
                </c:pt>
                <c:pt idx="208">
                  <c:v>0.28378333333333333</c:v>
                </c:pt>
                <c:pt idx="209">
                  <c:v>0.28443333333333326</c:v>
                </c:pt>
                <c:pt idx="210">
                  <c:v>0.28509999999999996</c:v>
                </c:pt>
                <c:pt idx="211">
                  <c:v>0.28586666666666666</c:v>
                </c:pt>
                <c:pt idx="212">
                  <c:v>0.28664999999999996</c:v>
                </c:pt>
                <c:pt idx="213">
                  <c:v>0.28749999999999998</c:v>
                </c:pt>
                <c:pt idx="214">
                  <c:v>0.28841666666666671</c:v>
                </c:pt>
                <c:pt idx="215">
                  <c:v>0.28935</c:v>
                </c:pt>
                <c:pt idx="216">
                  <c:v>0.29036666666666666</c:v>
                </c:pt>
                <c:pt idx="217">
                  <c:v>0.29135</c:v>
                </c:pt>
                <c:pt idx="218">
                  <c:v>0.29244999999999993</c:v>
                </c:pt>
                <c:pt idx="219">
                  <c:v>0.29363333333333336</c:v>
                </c:pt>
                <c:pt idx="220">
                  <c:v>0.29486666666666667</c:v>
                </c:pt>
                <c:pt idx="221">
                  <c:v>0.29603333333333332</c:v>
                </c:pt>
                <c:pt idx="222">
                  <c:v>0.29730000000000001</c:v>
                </c:pt>
                <c:pt idx="223">
                  <c:v>0.29854999999999998</c:v>
                </c:pt>
                <c:pt idx="224">
                  <c:v>0.29994999999999999</c:v>
                </c:pt>
                <c:pt idx="225">
                  <c:v>0.30135000000000001</c:v>
                </c:pt>
                <c:pt idx="226">
                  <c:v>0.30280000000000001</c:v>
                </c:pt>
                <c:pt idx="227">
                  <c:v>0.30428333333333335</c:v>
                </c:pt>
                <c:pt idx="228">
                  <c:v>0.30588333333333334</c:v>
                </c:pt>
                <c:pt idx="229">
                  <c:v>0.30754999999999999</c:v>
                </c:pt>
                <c:pt idx="230">
                  <c:v>0.3092833333333333</c:v>
                </c:pt>
                <c:pt idx="231">
                  <c:v>0.31113333333333343</c:v>
                </c:pt>
                <c:pt idx="232">
                  <c:v>0.31290000000000001</c:v>
                </c:pt>
                <c:pt idx="233">
                  <c:v>0.31461666666666666</c:v>
                </c:pt>
                <c:pt idx="234">
                  <c:v>0.31641666666666668</c:v>
                </c:pt>
                <c:pt idx="235">
                  <c:v>0.31813333333333332</c:v>
                </c:pt>
                <c:pt idx="236">
                  <c:v>0.31993333333333335</c:v>
                </c:pt>
                <c:pt idx="237">
                  <c:v>0.32171666666666665</c:v>
                </c:pt>
                <c:pt idx="238">
                  <c:v>0.32355000000000006</c:v>
                </c:pt>
                <c:pt idx="239">
                  <c:v>0.32545000000000002</c:v>
                </c:pt>
                <c:pt idx="240">
                  <c:v>0.3273166666666667</c:v>
                </c:pt>
                <c:pt idx="241">
                  <c:v>0.32921666666666666</c:v>
                </c:pt>
                <c:pt idx="242">
                  <c:v>0.33111666666666667</c:v>
                </c:pt>
                <c:pt idx="243">
                  <c:v>0.33301666666666668</c:v>
                </c:pt>
                <c:pt idx="244">
                  <c:v>0.33498333333333336</c:v>
                </c:pt>
                <c:pt idx="245">
                  <c:v>0.33698333333333336</c:v>
                </c:pt>
                <c:pt idx="246">
                  <c:v>0.3390333333333333</c:v>
                </c:pt>
                <c:pt idx="247">
                  <c:v>0.34106666666666663</c:v>
                </c:pt>
                <c:pt idx="248">
                  <c:v>0.3430333333333333</c:v>
                </c:pt>
                <c:pt idx="249">
                  <c:v>0.34506666666666663</c:v>
                </c:pt>
                <c:pt idx="250">
                  <c:v>0.34704999999999991</c:v>
                </c:pt>
                <c:pt idx="251">
                  <c:v>0.34911666666666669</c:v>
                </c:pt>
                <c:pt idx="252">
                  <c:v>0.35123333333333329</c:v>
                </c:pt>
                <c:pt idx="253">
                  <c:v>0.35321666666666673</c:v>
                </c:pt>
                <c:pt idx="254">
                  <c:v>0.35536666666666661</c:v>
                </c:pt>
                <c:pt idx="255">
                  <c:v>0.35741666666666666</c:v>
                </c:pt>
                <c:pt idx="256">
                  <c:v>0.35926666666666668</c:v>
                </c:pt>
                <c:pt idx="257">
                  <c:v>0.36130000000000001</c:v>
                </c:pt>
                <c:pt idx="258">
                  <c:v>0.36325000000000002</c:v>
                </c:pt>
                <c:pt idx="259">
                  <c:v>0.36521666666666669</c:v>
                </c:pt>
                <c:pt idx="260">
                  <c:v>0.36713333333333331</c:v>
                </c:pt>
                <c:pt idx="261">
                  <c:v>0.36896666666666672</c:v>
                </c:pt>
                <c:pt idx="262">
                  <c:v>0.3708833333333334</c:v>
                </c:pt>
                <c:pt idx="263">
                  <c:v>0.37271666666666664</c:v>
                </c:pt>
                <c:pt idx="264">
                  <c:v>0.37463333333333332</c:v>
                </c:pt>
                <c:pt idx="265">
                  <c:v>0.37651666666666661</c:v>
                </c:pt>
                <c:pt idx="266">
                  <c:v>0.37826666666666658</c:v>
                </c:pt>
                <c:pt idx="267">
                  <c:v>0.37995000000000001</c:v>
                </c:pt>
                <c:pt idx="268">
                  <c:v>0.38163333333333344</c:v>
                </c:pt>
                <c:pt idx="269">
                  <c:v>0.38330000000000003</c:v>
                </c:pt>
                <c:pt idx="270">
                  <c:v>0.38493333333333335</c:v>
                </c:pt>
                <c:pt idx="271">
                  <c:v>0.38650000000000001</c:v>
                </c:pt>
                <c:pt idx="272">
                  <c:v>0.38796666666666663</c:v>
                </c:pt>
                <c:pt idx="273">
                  <c:v>0.38946666666666663</c:v>
                </c:pt>
                <c:pt idx="274">
                  <c:v>0.39083333333333337</c:v>
                </c:pt>
                <c:pt idx="275">
                  <c:v>0.39230000000000004</c:v>
                </c:pt>
                <c:pt idx="276">
                  <c:v>0.39369999999999999</c:v>
                </c:pt>
                <c:pt idx="277">
                  <c:v>0.39508333333333329</c:v>
                </c:pt>
                <c:pt idx="278">
                  <c:v>0.3964833333333333</c:v>
                </c:pt>
                <c:pt idx="279">
                  <c:v>0.39766666666666661</c:v>
                </c:pt>
                <c:pt idx="280">
                  <c:v>0.39890000000000003</c:v>
                </c:pt>
                <c:pt idx="281">
                  <c:v>0.40008333333333335</c:v>
                </c:pt>
                <c:pt idx="282">
                  <c:v>0.40106666666666668</c:v>
                </c:pt>
                <c:pt idx="283">
                  <c:v>0.40211666666666668</c:v>
                </c:pt>
                <c:pt idx="284">
                  <c:v>0.40301666666666675</c:v>
                </c:pt>
                <c:pt idx="285">
                  <c:v>0.40388333333333337</c:v>
                </c:pt>
                <c:pt idx="286">
                  <c:v>0.40479999999999999</c:v>
                </c:pt>
                <c:pt idx="287">
                  <c:v>0.40561666666666668</c:v>
                </c:pt>
                <c:pt idx="288">
                  <c:v>0.40634999999999993</c:v>
                </c:pt>
                <c:pt idx="289">
                  <c:v>0.40706666666666669</c:v>
                </c:pt>
                <c:pt idx="290">
                  <c:v>0.40768333333333334</c:v>
                </c:pt>
                <c:pt idx="291">
                  <c:v>0.40821666666666667</c:v>
                </c:pt>
                <c:pt idx="292">
                  <c:v>0.40865000000000001</c:v>
                </c:pt>
                <c:pt idx="293">
                  <c:v>0.40911666666666663</c:v>
                </c:pt>
                <c:pt idx="294">
                  <c:v>0.40943333333333332</c:v>
                </c:pt>
                <c:pt idx="295">
                  <c:v>0.40978333333333333</c:v>
                </c:pt>
                <c:pt idx="296">
                  <c:v>0.41011666666666668</c:v>
                </c:pt>
                <c:pt idx="297">
                  <c:v>0.41030000000000005</c:v>
                </c:pt>
                <c:pt idx="298">
                  <c:v>0.41048333333333337</c:v>
                </c:pt>
                <c:pt idx="299">
                  <c:v>0.41058333333333336</c:v>
                </c:pt>
                <c:pt idx="300">
                  <c:v>0.41061666666666669</c:v>
                </c:pt>
                <c:pt idx="301">
                  <c:v>0.41056666666666669</c:v>
                </c:pt>
                <c:pt idx="302">
                  <c:v>0.4103666666666666</c:v>
                </c:pt>
                <c:pt idx="303">
                  <c:v>0.41023333333333339</c:v>
                </c:pt>
                <c:pt idx="304">
                  <c:v>0.40994999999999998</c:v>
                </c:pt>
                <c:pt idx="305">
                  <c:v>0.40965000000000007</c:v>
                </c:pt>
                <c:pt idx="306">
                  <c:v>0.40923333333333334</c:v>
                </c:pt>
                <c:pt idx="307">
                  <c:v>0.40891666666666665</c:v>
                </c:pt>
                <c:pt idx="308">
                  <c:v>0.40848333333333331</c:v>
                </c:pt>
                <c:pt idx="309">
                  <c:v>0.40796666666666664</c:v>
                </c:pt>
                <c:pt idx="310">
                  <c:v>0.40746666666666664</c:v>
                </c:pt>
                <c:pt idx="311">
                  <c:v>0.40691666666666665</c:v>
                </c:pt>
                <c:pt idx="312">
                  <c:v>0.40626666666666661</c:v>
                </c:pt>
                <c:pt idx="313">
                  <c:v>0.40555000000000008</c:v>
                </c:pt>
                <c:pt idx="314">
                  <c:v>0.40478333333333333</c:v>
                </c:pt>
                <c:pt idx="315">
                  <c:v>0.40394999999999998</c:v>
                </c:pt>
                <c:pt idx="316">
                  <c:v>0.40309999999999996</c:v>
                </c:pt>
                <c:pt idx="317">
                  <c:v>0.4021333333333334</c:v>
                </c:pt>
                <c:pt idx="318">
                  <c:v>0.40129999999999999</c:v>
                </c:pt>
                <c:pt idx="319">
                  <c:v>0.40028333333333332</c:v>
                </c:pt>
                <c:pt idx="320">
                  <c:v>0.39928333333333327</c:v>
                </c:pt>
                <c:pt idx="321">
                  <c:v>0.39815</c:v>
                </c:pt>
                <c:pt idx="322">
                  <c:v>0.39696666666666663</c:v>
                </c:pt>
                <c:pt idx="323">
                  <c:v>0.39571666666666666</c:v>
                </c:pt>
                <c:pt idx="324">
                  <c:v>0.39444999999999997</c:v>
                </c:pt>
                <c:pt idx="325">
                  <c:v>0.39318333333333327</c:v>
                </c:pt>
                <c:pt idx="326">
                  <c:v>0.39195000000000002</c:v>
                </c:pt>
                <c:pt idx="327">
                  <c:v>0.3907166666666666</c:v>
                </c:pt>
                <c:pt idx="328">
                  <c:v>0.38938333333333325</c:v>
                </c:pt>
                <c:pt idx="329">
                  <c:v>0.38809999999999995</c:v>
                </c:pt>
                <c:pt idx="330">
                  <c:v>0.38671666666666665</c:v>
                </c:pt>
                <c:pt idx="331">
                  <c:v>0.3853166666666667</c:v>
                </c:pt>
                <c:pt idx="332">
                  <c:v>0.38388333333333335</c:v>
                </c:pt>
                <c:pt idx="333">
                  <c:v>0.38258333333333333</c:v>
                </c:pt>
                <c:pt idx="334">
                  <c:v>0.38108333333333338</c:v>
                </c:pt>
                <c:pt idx="335">
                  <c:v>0.37964999999999999</c:v>
                </c:pt>
                <c:pt idx="336">
                  <c:v>0.37818333333333332</c:v>
                </c:pt>
                <c:pt idx="337">
                  <c:v>0.37671666666666664</c:v>
                </c:pt>
                <c:pt idx="338">
                  <c:v>0.37523333333333331</c:v>
                </c:pt>
                <c:pt idx="339">
                  <c:v>0.37365000000000004</c:v>
                </c:pt>
                <c:pt idx="340">
                  <c:v>0.3721666666666667</c:v>
                </c:pt>
                <c:pt idx="341">
                  <c:v>0.37056666666666666</c:v>
                </c:pt>
                <c:pt idx="342">
                  <c:v>0.36904999999999993</c:v>
                </c:pt>
                <c:pt idx="343">
                  <c:v>0.36764999999999998</c:v>
                </c:pt>
                <c:pt idx="344">
                  <c:v>0.36621666666666663</c:v>
                </c:pt>
                <c:pt idx="345">
                  <c:v>0.36466666666666669</c:v>
                </c:pt>
                <c:pt idx="346">
                  <c:v>0.36316666666666664</c:v>
                </c:pt>
                <c:pt idx="347">
                  <c:v>0.3616833333333333</c:v>
                </c:pt>
                <c:pt idx="348">
                  <c:v>0.36008333333333331</c:v>
                </c:pt>
                <c:pt idx="349">
                  <c:v>0.35866666666666669</c:v>
                </c:pt>
                <c:pt idx="350">
                  <c:v>0.35720000000000002</c:v>
                </c:pt>
                <c:pt idx="351">
                  <c:v>0.35580000000000006</c:v>
                </c:pt>
                <c:pt idx="352">
                  <c:v>0.35438333333333333</c:v>
                </c:pt>
                <c:pt idx="353">
                  <c:v>0.3530166666666667</c:v>
                </c:pt>
                <c:pt idx="354">
                  <c:v>0.35168333333333335</c:v>
                </c:pt>
                <c:pt idx="355">
                  <c:v>0.35018333333333335</c:v>
                </c:pt>
                <c:pt idx="356">
                  <c:v>0.3488</c:v>
                </c:pt>
                <c:pt idx="357">
                  <c:v>0.34749999999999998</c:v>
                </c:pt>
                <c:pt idx="358">
                  <c:v>0.34604999999999997</c:v>
                </c:pt>
                <c:pt idx="359">
                  <c:v>0.34481666666666672</c:v>
                </c:pt>
                <c:pt idx="360">
                  <c:v>0.34349999999999997</c:v>
                </c:pt>
                <c:pt idx="361">
                  <c:v>0.34225</c:v>
                </c:pt>
                <c:pt idx="362">
                  <c:v>0.34105000000000002</c:v>
                </c:pt>
                <c:pt idx="363">
                  <c:v>0.33983333333333338</c:v>
                </c:pt>
                <c:pt idx="364">
                  <c:v>0.33871666666666661</c:v>
                </c:pt>
                <c:pt idx="365">
                  <c:v>0.33758333333333335</c:v>
                </c:pt>
                <c:pt idx="366">
                  <c:v>0.33633333333333337</c:v>
                </c:pt>
                <c:pt idx="367">
                  <c:v>0.33529999999999999</c:v>
                </c:pt>
                <c:pt idx="368">
                  <c:v>0.33426666666666671</c:v>
                </c:pt>
                <c:pt idx="369">
                  <c:v>0.33326666666666666</c:v>
                </c:pt>
                <c:pt idx="370">
                  <c:v>0.33233333333333337</c:v>
                </c:pt>
                <c:pt idx="371">
                  <c:v>0.33138333333333331</c:v>
                </c:pt>
                <c:pt idx="372">
                  <c:v>0.33049999999999996</c:v>
                </c:pt>
                <c:pt idx="373">
                  <c:v>0.32958333333333328</c:v>
                </c:pt>
                <c:pt idx="374">
                  <c:v>0.32875000000000004</c:v>
                </c:pt>
                <c:pt idx="375">
                  <c:v>0.32793333333333335</c:v>
                </c:pt>
                <c:pt idx="376">
                  <c:v>0.32713333333333333</c:v>
                </c:pt>
                <c:pt idx="377">
                  <c:v>0.32648333333333335</c:v>
                </c:pt>
                <c:pt idx="378">
                  <c:v>0.32573333333333332</c:v>
                </c:pt>
                <c:pt idx="379">
                  <c:v>0.32508333333333328</c:v>
                </c:pt>
                <c:pt idx="380">
                  <c:v>0.32440000000000008</c:v>
                </c:pt>
                <c:pt idx="381">
                  <c:v>0.32376666666666665</c:v>
                </c:pt>
                <c:pt idx="382">
                  <c:v>0.3231666666666666</c:v>
                </c:pt>
                <c:pt idx="383">
                  <c:v>0.32258333333333333</c:v>
                </c:pt>
                <c:pt idx="384">
                  <c:v>0.32208333333333333</c:v>
                </c:pt>
                <c:pt idx="385">
                  <c:v>0.32163333333333327</c:v>
                </c:pt>
                <c:pt idx="386">
                  <c:v>0.32118333333333332</c:v>
                </c:pt>
                <c:pt idx="387">
                  <c:v>0.32066666666666666</c:v>
                </c:pt>
                <c:pt idx="388">
                  <c:v>0.3202166666666667</c:v>
                </c:pt>
                <c:pt idx="389">
                  <c:v>0.31980000000000003</c:v>
                </c:pt>
                <c:pt idx="390">
                  <c:v>0.31948333333333334</c:v>
                </c:pt>
                <c:pt idx="391">
                  <c:v>0.31913333333333332</c:v>
                </c:pt>
                <c:pt idx="392">
                  <c:v>0.31895000000000001</c:v>
                </c:pt>
                <c:pt idx="393">
                  <c:v>0.31864999999999999</c:v>
                </c:pt>
                <c:pt idx="394">
                  <c:v>0.31841666666666668</c:v>
                </c:pt>
                <c:pt idx="395">
                  <c:v>0.31818333333333332</c:v>
                </c:pt>
                <c:pt idx="396">
                  <c:v>0.31790000000000002</c:v>
                </c:pt>
                <c:pt idx="397">
                  <c:v>0.3177666666666667</c:v>
                </c:pt>
                <c:pt idx="398">
                  <c:v>0.31763333333333338</c:v>
                </c:pt>
                <c:pt idx="399">
                  <c:v>0.31759999999999994</c:v>
                </c:pt>
                <c:pt idx="400">
                  <c:v>0.31753333333333339</c:v>
                </c:pt>
                <c:pt idx="401">
                  <c:v>0.31753333333333339</c:v>
                </c:pt>
                <c:pt idx="402">
                  <c:v>0.31749999999999995</c:v>
                </c:pt>
                <c:pt idx="403">
                  <c:v>0.31745000000000001</c:v>
                </c:pt>
                <c:pt idx="404">
                  <c:v>0.31746666666666662</c:v>
                </c:pt>
                <c:pt idx="405">
                  <c:v>0.31748333333333334</c:v>
                </c:pt>
                <c:pt idx="406">
                  <c:v>0.31756666666666672</c:v>
                </c:pt>
                <c:pt idx="407">
                  <c:v>0.31763333333333332</c:v>
                </c:pt>
                <c:pt idx="408">
                  <c:v>0.31764999999999999</c:v>
                </c:pt>
                <c:pt idx="409">
                  <c:v>0.31773333333333337</c:v>
                </c:pt>
                <c:pt idx="410">
                  <c:v>0.31776666666666664</c:v>
                </c:pt>
                <c:pt idx="411">
                  <c:v>0.31786666666666669</c:v>
                </c:pt>
                <c:pt idx="412">
                  <c:v>0.31798333333333334</c:v>
                </c:pt>
                <c:pt idx="413">
                  <c:v>0.31805</c:v>
                </c:pt>
                <c:pt idx="414">
                  <c:v>0.31819999999999998</c:v>
                </c:pt>
                <c:pt idx="415">
                  <c:v>0.31829999999999997</c:v>
                </c:pt>
                <c:pt idx="416">
                  <c:v>0.31838333333333335</c:v>
                </c:pt>
                <c:pt idx="417">
                  <c:v>0.31851666666666673</c:v>
                </c:pt>
                <c:pt idx="418">
                  <c:v>0.31859999999999999</c:v>
                </c:pt>
                <c:pt idx="419">
                  <c:v>0.3187166666666667</c:v>
                </c:pt>
                <c:pt idx="420">
                  <c:v>0.31888333333333335</c:v>
                </c:pt>
                <c:pt idx="421">
                  <c:v>0.31898333333333334</c:v>
                </c:pt>
                <c:pt idx="422">
                  <c:v>0.31906666666666667</c:v>
                </c:pt>
                <c:pt idx="423">
                  <c:v>0.31918333333333337</c:v>
                </c:pt>
                <c:pt idx="424">
                  <c:v>0.31919999999999998</c:v>
                </c:pt>
                <c:pt idx="425">
                  <c:v>0.3192666666666667</c:v>
                </c:pt>
                <c:pt idx="426">
                  <c:v>0.31934999999999997</c:v>
                </c:pt>
                <c:pt idx="427">
                  <c:v>0.31935000000000002</c:v>
                </c:pt>
                <c:pt idx="428">
                  <c:v>0.31941666666666663</c:v>
                </c:pt>
                <c:pt idx="429">
                  <c:v>0.31941666666666674</c:v>
                </c:pt>
                <c:pt idx="430">
                  <c:v>0.31929999999999997</c:v>
                </c:pt>
                <c:pt idx="431">
                  <c:v>0.31928333333333331</c:v>
                </c:pt>
                <c:pt idx="432">
                  <c:v>0.31918333333333332</c:v>
                </c:pt>
                <c:pt idx="433">
                  <c:v>0.31896666666666668</c:v>
                </c:pt>
                <c:pt idx="434">
                  <c:v>0.31885000000000002</c:v>
                </c:pt>
                <c:pt idx="435">
                  <c:v>0.31870000000000004</c:v>
                </c:pt>
                <c:pt idx="436">
                  <c:v>0.31846666666666668</c:v>
                </c:pt>
                <c:pt idx="437">
                  <c:v>0.31833333333333336</c:v>
                </c:pt>
                <c:pt idx="438">
                  <c:v>0.31816666666666665</c:v>
                </c:pt>
                <c:pt idx="439">
                  <c:v>0.31793333333333335</c:v>
                </c:pt>
                <c:pt idx="440">
                  <c:v>0.31761666666666671</c:v>
                </c:pt>
                <c:pt idx="441">
                  <c:v>0.31728333333333331</c:v>
                </c:pt>
                <c:pt idx="442">
                  <c:v>0.317</c:v>
                </c:pt>
                <c:pt idx="443">
                  <c:v>0.31651666666666672</c:v>
                </c:pt>
                <c:pt idx="444">
                  <c:v>0.31618333333333332</c:v>
                </c:pt>
                <c:pt idx="445">
                  <c:v>0.31564999999999993</c:v>
                </c:pt>
                <c:pt idx="446">
                  <c:v>0.31516666666666665</c:v>
                </c:pt>
                <c:pt idx="447">
                  <c:v>0.31464999999999993</c:v>
                </c:pt>
                <c:pt idx="448">
                  <c:v>0.31406666666666666</c:v>
                </c:pt>
                <c:pt idx="449">
                  <c:v>0.31351666666666667</c:v>
                </c:pt>
                <c:pt idx="450">
                  <c:v>0.31290000000000001</c:v>
                </c:pt>
                <c:pt idx="451">
                  <c:v>0.31223333333333331</c:v>
                </c:pt>
                <c:pt idx="452">
                  <c:v>0.31158333333333338</c:v>
                </c:pt>
                <c:pt idx="453">
                  <c:v>0.31078333333333336</c:v>
                </c:pt>
                <c:pt idx="454">
                  <c:v>0.31004999999999999</c:v>
                </c:pt>
                <c:pt idx="455">
                  <c:v>0.30930000000000002</c:v>
                </c:pt>
                <c:pt idx="456">
                  <c:v>0.30841666666666662</c:v>
                </c:pt>
                <c:pt idx="457">
                  <c:v>0.30754999999999999</c:v>
                </c:pt>
                <c:pt idx="458">
                  <c:v>0.30670000000000003</c:v>
                </c:pt>
                <c:pt idx="459">
                  <c:v>0.30580000000000002</c:v>
                </c:pt>
                <c:pt idx="460">
                  <c:v>0.30481666666666668</c:v>
                </c:pt>
                <c:pt idx="461">
                  <c:v>0.3039</c:v>
                </c:pt>
                <c:pt idx="462">
                  <c:v>0.30285000000000006</c:v>
                </c:pt>
                <c:pt idx="463">
                  <c:v>0.30181666666666668</c:v>
                </c:pt>
                <c:pt idx="464">
                  <c:v>0.30076666666666663</c:v>
                </c:pt>
                <c:pt idx="465">
                  <c:v>0.29963333333333336</c:v>
                </c:pt>
                <c:pt idx="466">
                  <c:v>0.29846666666666666</c:v>
                </c:pt>
                <c:pt idx="467">
                  <c:v>0.29735000000000006</c:v>
                </c:pt>
                <c:pt idx="468">
                  <c:v>0.29616666666666663</c:v>
                </c:pt>
                <c:pt idx="469">
                  <c:v>0.29503333333333331</c:v>
                </c:pt>
                <c:pt idx="470">
                  <c:v>0.29386666666666666</c:v>
                </c:pt>
                <c:pt idx="471">
                  <c:v>0.29266666666666663</c:v>
                </c:pt>
                <c:pt idx="472">
                  <c:v>0.29153333333333337</c:v>
                </c:pt>
                <c:pt idx="473">
                  <c:v>0.29033333333333339</c:v>
                </c:pt>
                <c:pt idx="474">
                  <c:v>0.2891333333333333</c:v>
                </c:pt>
                <c:pt idx="475">
                  <c:v>0.28786666666666666</c:v>
                </c:pt>
                <c:pt idx="476">
                  <c:v>0.28664999999999996</c:v>
                </c:pt>
                <c:pt idx="477">
                  <c:v>0.28545000000000004</c:v>
                </c:pt>
                <c:pt idx="478">
                  <c:v>0.28423333333333339</c:v>
                </c:pt>
                <c:pt idx="479">
                  <c:v>0.2830333333333333</c:v>
                </c:pt>
                <c:pt idx="480">
                  <c:v>0.28173333333333339</c:v>
                </c:pt>
                <c:pt idx="481">
                  <c:v>0.2804666666666667</c:v>
                </c:pt>
                <c:pt idx="482">
                  <c:v>0.27916666666666662</c:v>
                </c:pt>
                <c:pt idx="483">
                  <c:v>0.27796666666666664</c:v>
                </c:pt>
                <c:pt idx="484">
                  <c:v>0.2767</c:v>
                </c:pt>
                <c:pt idx="485">
                  <c:v>0.27543333333333336</c:v>
                </c:pt>
                <c:pt idx="486">
                  <c:v>0.27415</c:v>
                </c:pt>
                <c:pt idx="487">
                  <c:v>0.27286666666666665</c:v>
                </c:pt>
                <c:pt idx="488">
                  <c:v>0.27158333333333334</c:v>
                </c:pt>
                <c:pt idx="489">
                  <c:v>0.27024999999999999</c:v>
                </c:pt>
                <c:pt idx="490">
                  <c:v>0.26903333333333329</c:v>
                </c:pt>
                <c:pt idx="491">
                  <c:v>0.26781666666666665</c:v>
                </c:pt>
                <c:pt idx="492">
                  <c:v>0.26656666666666667</c:v>
                </c:pt>
                <c:pt idx="493">
                  <c:v>0.26531666666666665</c:v>
                </c:pt>
                <c:pt idx="494">
                  <c:v>0.26396666666666668</c:v>
                </c:pt>
                <c:pt idx="495">
                  <c:v>0.26264999999999999</c:v>
                </c:pt>
                <c:pt idx="496">
                  <c:v>0.26136666666666669</c:v>
                </c:pt>
                <c:pt idx="497">
                  <c:v>0.26013333333333333</c:v>
                </c:pt>
                <c:pt idx="498">
                  <c:v>0.2588333333333333</c:v>
                </c:pt>
                <c:pt idx="499">
                  <c:v>0.25758333333333339</c:v>
                </c:pt>
                <c:pt idx="500">
                  <c:v>0.25628333333333331</c:v>
                </c:pt>
                <c:pt idx="501">
                  <c:v>0.25503333333333339</c:v>
                </c:pt>
                <c:pt idx="502">
                  <c:v>0.25381666666666669</c:v>
                </c:pt>
                <c:pt idx="503">
                  <c:v>0.25264999999999999</c:v>
                </c:pt>
                <c:pt idx="504">
                  <c:v>0.25143333333333334</c:v>
                </c:pt>
                <c:pt idx="505">
                  <c:v>0.25026666666666669</c:v>
                </c:pt>
                <c:pt idx="506">
                  <c:v>0.24908333333333332</c:v>
                </c:pt>
                <c:pt idx="507">
                  <c:v>0.24790000000000001</c:v>
                </c:pt>
                <c:pt idx="508">
                  <c:v>0.2467166666666667</c:v>
                </c:pt>
                <c:pt idx="509">
                  <c:v>0.24555000000000002</c:v>
                </c:pt>
                <c:pt idx="510">
                  <c:v>0.24434999999999998</c:v>
                </c:pt>
                <c:pt idx="511">
                  <c:v>0.24323333333333338</c:v>
                </c:pt>
                <c:pt idx="512">
                  <c:v>0.24204999999999999</c:v>
                </c:pt>
                <c:pt idx="513">
                  <c:v>0.24095</c:v>
                </c:pt>
                <c:pt idx="514">
                  <c:v>0.23986666666666667</c:v>
                </c:pt>
                <c:pt idx="515">
                  <c:v>0.23871666666666666</c:v>
                </c:pt>
                <c:pt idx="516">
                  <c:v>0.23763333333333334</c:v>
                </c:pt>
                <c:pt idx="517">
                  <c:v>0.2366</c:v>
                </c:pt>
                <c:pt idx="518">
                  <c:v>0.23555000000000001</c:v>
                </c:pt>
                <c:pt idx="519">
                  <c:v>0.23465000000000003</c:v>
                </c:pt>
                <c:pt idx="520">
                  <c:v>0.23373333333333335</c:v>
                </c:pt>
                <c:pt idx="521">
                  <c:v>0.23276666666666671</c:v>
                </c:pt>
                <c:pt idx="522">
                  <c:v>0.23185</c:v>
                </c:pt>
                <c:pt idx="523">
                  <c:v>0.23088333333333333</c:v>
                </c:pt>
                <c:pt idx="524">
                  <c:v>0.22991666666666666</c:v>
                </c:pt>
                <c:pt idx="525">
                  <c:v>0.22896666666666662</c:v>
                </c:pt>
                <c:pt idx="526">
                  <c:v>0.2281</c:v>
                </c:pt>
                <c:pt idx="527">
                  <c:v>0.22723333333333337</c:v>
                </c:pt>
                <c:pt idx="528">
                  <c:v>0.2263333333333333</c:v>
                </c:pt>
                <c:pt idx="529">
                  <c:v>0.22541666666666668</c:v>
                </c:pt>
                <c:pt idx="530">
                  <c:v>0.22450000000000001</c:v>
                </c:pt>
                <c:pt idx="531">
                  <c:v>0.22368333333333335</c:v>
                </c:pt>
                <c:pt idx="532">
                  <c:v>0.22280000000000003</c:v>
                </c:pt>
                <c:pt idx="533">
                  <c:v>0.22205</c:v>
                </c:pt>
                <c:pt idx="534">
                  <c:v>0.22133333333333335</c:v>
                </c:pt>
                <c:pt idx="535">
                  <c:v>0.22043333333333334</c:v>
                </c:pt>
                <c:pt idx="536">
                  <c:v>0.21968333333333331</c:v>
                </c:pt>
                <c:pt idx="537">
                  <c:v>0.21891666666666668</c:v>
                </c:pt>
                <c:pt idx="538">
                  <c:v>0.21808333333333332</c:v>
                </c:pt>
                <c:pt idx="539">
                  <c:v>0.21740000000000001</c:v>
                </c:pt>
                <c:pt idx="540">
                  <c:v>0.21678333333333333</c:v>
                </c:pt>
                <c:pt idx="541">
                  <c:v>0.21606666666666671</c:v>
                </c:pt>
                <c:pt idx="542">
                  <c:v>0.21541666666666667</c:v>
                </c:pt>
                <c:pt idx="543">
                  <c:v>0.2146666666666667</c:v>
                </c:pt>
                <c:pt idx="544">
                  <c:v>0.21399999999999997</c:v>
                </c:pt>
                <c:pt idx="545">
                  <c:v>0.21343333333333334</c:v>
                </c:pt>
                <c:pt idx="546">
                  <c:v>0.21281666666666665</c:v>
                </c:pt>
                <c:pt idx="547">
                  <c:v>0.21213333333333337</c:v>
                </c:pt>
                <c:pt idx="548">
                  <c:v>0.21149999999999999</c:v>
                </c:pt>
                <c:pt idx="549">
                  <c:v>0.2109</c:v>
                </c:pt>
                <c:pt idx="550">
                  <c:v>0.21021666666666669</c:v>
                </c:pt>
                <c:pt idx="551">
                  <c:v>0.20960000000000001</c:v>
                </c:pt>
                <c:pt idx="552">
                  <c:v>0.2089</c:v>
                </c:pt>
                <c:pt idx="553">
                  <c:v>0.20826666666666668</c:v>
                </c:pt>
                <c:pt idx="554">
                  <c:v>0.20761666666666667</c:v>
                </c:pt>
                <c:pt idx="555">
                  <c:v>0.20696666666666666</c:v>
                </c:pt>
                <c:pt idx="556">
                  <c:v>0.20633333333333334</c:v>
                </c:pt>
                <c:pt idx="557">
                  <c:v>0.20576666666666668</c:v>
                </c:pt>
                <c:pt idx="558">
                  <c:v>0.20508333333333337</c:v>
                </c:pt>
                <c:pt idx="559">
                  <c:v>0.20446666666666669</c:v>
                </c:pt>
                <c:pt idx="560">
                  <c:v>0.20388333333333331</c:v>
                </c:pt>
                <c:pt idx="561">
                  <c:v>0.20325000000000001</c:v>
                </c:pt>
                <c:pt idx="562">
                  <c:v>0.20263333333333336</c:v>
                </c:pt>
                <c:pt idx="563">
                  <c:v>0.20194999999999996</c:v>
                </c:pt>
                <c:pt idx="564">
                  <c:v>0.20130000000000001</c:v>
                </c:pt>
                <c:pt idx="565">
                  <c:v>0.20060000000000003</c:v>
                </c:pt>
                <c:pt idx="566">
                  <c:v>0.19998333333333332</c:v>
                </c:pt>
                <c:pt idx="567">
                  <c:v>0.19939999999999999</c:v>
                </c:pt>
                <c:pt idx="568">
                  <c:v>0.19873333333333335</c:v>
                </c:pt>
                <c:pt idx="569">
                  <c:v>0.19811666666666669</c:v>
                </c:pt>
                <c:pt idx="570">
                  <c:v>0.19750000000000001</c:v>
                </c:pt>
                <c:pt idx="571">
                  <c:v>0.1968</c:v>
                </c:pt>
                <c:pt idx="572">
                  <c:v>0.1960833333333333</c:v>
                </c:pt>
                <c:pt idx="573">
                  <c:v>0.19541666666666668</c:v>
                </c:pt>
                <c:pt idx="574">
                  <c:v>0.19471666666666665</c:v>
                </c:pt>
                <c:pt idx="575">
                  <c:v>0.19408333333333336</c:v>
                </c:pt>
                <c:pt idx="576">
                  <c:v>0.19350000000000001</c:v>
                </c:pt>
                <c:pt idx="577">
                  <c:v>0.19283333333333333</c:v>
                </c:pt>
                <c:pt idx="578">
                  <c:v>0.19203333333333336</c:v>
                </c:pt>
                <c:pt idx="579">
                  <c:v>0.19138333333333332</c:v>
                </c:pt>
                <c:pt idx="580">
                  <c:v>0.19064999999999999</c:v>
                </c:pt>
                <c:pt idx="581">
                  <c:v>0.18991666666666665</c:v>
                </c:pt>
                <c:pt idx="582">
                  <c:v>0.18916666666666668</c:v>
                </c:pt>
                <c:pt idx="583">
                  <c:v>0.18839999999999998</c:v>
                </c:pt>
                <c:pt idx="584">
                  <c:v>0.18759999999999999</c:v>
                </c:pt>
                <c:pt idx="585">
                  <c:v>0.18681666666666666</c:v>
                </c:pt>
                <c:pt idx="586">
                  <c:v>0.18610000000000002</c:v>
                </c:pt>
                <c:pt idx="587">
                  <c:v>0.18541666666666667</c:v>
                </c:pt>
                <c:pt idx="588">
                  <c:v>0.18464999999999998</c:v>
                </c:pt>
                <c:pt idx="589">
                  <c:v>0.18396666666666664</c:v>
                </c:pt>
                <c:pt idx="590">
                  <c:v>0.18321666666666667</c:v>
                </c:pt>
                <c:pt idx="591">
                  <c:v>0.18233333333333335</c:v>
                </c:pt>
                <c:pt idx="592">
                  <c:v>0.18153333333333332</c:v>
                </c:pt>
                <c:pt idx="593">
                  <c:v>0.18068333333333333</c:v>
                </c:pt>
                <c:pt idx="594">
                  <c:v>0.17976666666666666</c:v>
                </c:pt>
                <c:pt idx="595">
                  <c:v>0.17900000000000002</c:v>
                </c:pt>
                <c:pt idx="596">
                  <c:v>0.17816666666666667</c:v>
                </c:pt>
                <c:pt idx="597">
                  <c:v>0.17723333333333335</c:v>
                </c:pt>
                <c:pt idx="598">
                  <c:v>0.17653333333333332</c:v>
                </c:pt>
                <c:pt idx="599">
                  <c:v>0.17561666666666664</c:v>
                </c:pt>
                <c:pt idx="600">
                  <c:v>0.17469999999999999</c:v>
                </c:pt>
                <c:pt idx="601">
                  <c:v>0.17374999999999999</c:v>
                </c:pt>
                <c:pt idx="602">
                  <c:v>0.17276666666666665</c:v>
                </c:pt>
                <c:pt idx="603">
                  <c:v>0.17190000000000003</c:v>
                </c:pt>
                <c:pt idx="604">
                  <c:v>0.17098333333333335</c:v>
                </c:pt>
                <c:pt idx="605">
                  <c:v>0.17003333333333334</c:v>
                </c:pt>
                <c:pt idx="606">
                  <c:v>0.16914999999999999</c:v>
                </c:pt>
                <c:pt idx="607">
                  <c:v>0.16823333333333335</c:v>
                </c:pt>
                <c:pt idx="608">
                  <c:v>0.16728333333333334</c:v>
                </c:pt>
                <c:pt idx="609">
                  <c:v>0.16648333333333334</c:v>
                </c:pt>
                <c:pt idx="610">
                  <c:v>0.16548333333333332</c:v>
                </c:pt>
                <c:pt idx="611">
                  <c:v>0.16453333333333331</c:v>
                </c:pt>
                <c:pt idx="612">
                  <c:v>0.16373333333333334</c:v>
                </c:pt>
                <c:pt idx="613">
                  <c:v>0.16276666666666667</c:v>
                </c:pt>
                <c:pt idx="614">
                  <c:v>0.1617666666666667</c:v>
                </c:pt>
                <c:pt idx="615">
                  <c:v>0.16093333333333334</c:v>
                </c:pt>
                <c:pt idx="616">
                  <c:v>0.16003333333333333</c:v>
                </c:pt>
                <c:pt idx="617">
                  <c:v>0.15906666666666666</c:v>
                </c:pt>
                <c:pt idx="618">
                  <c:v>0.15810000000000002</c:v>
                </c:pt>
                <c:pt idx="619">
                  <c:v>0.15713333333333332</c:v>
                </c:pt>
                <c:pt idx="620">
                  <c:v>0.15608333333333335</c:v>
                </c:pt>
                <c:pt idx="621">
                  <c:v>0.15508333333333332</c:v>
                </c:pt>
                <c:pt idx="622">
                  <c:v>0.15408333333333332</c:v>
                </c:pt>
                <c:pt idx="623">
                  <c:v>0.15313333333333334</c:v>
                </c:pt>
                <c:pt idx="624">
                  <c:v>0.15218333333333334</c:v>
                </c:pt>
                <c:pt idx="625">
                  <c:v>0.15126666666666666</c:v>
                </c:pt>
                <c:pt idx="626">
                  <c:v>0.15033333333333332</c:v>
                </c:pt>
                <c:pt idx="627">
                  <c:v>0.14928333333333335</c:v>
                </c:pt>
                <c:pt idx="628">
                  <c:v>0.14836666666666667</c:v>
                </c:pt>
                <c:pt idx="629">
                  <c:v>0.14746666666666666</c:v>
                </c:pt>
                <c:pt idx="630">
                  <c:v>0.14651666666666671</c:v>
                </c:pt>
                <c:pt idx="631">
                  <c:v>0.14554999999999998</c:v>
                </c:pt>
                <c:pt idx="632">
                  <c:v>0.14460000000000003</c:v>
                </c:pt>
                <c:pt idx="633">
                  <c:v>0.14375000000000002</c:v>
                </c:pt>
                <c:pt idx="634">
                  <c:v>0.14276666666666668</c:v>
                </c:pt>
                <c:pt idx="635">
                  <c:v>0.1419</c:v>
                </c:pt>
                <c:pt idx="636">
                  <c:v>0.14105000000000001</c:v>
                </c:pt>
                <c:pt idx="637">
                  <c:v>0.14006666666666667</c:v>
                </c:pt>
                <c:pt idx="638">
                  <c:v>0.13925000000000001</c:v>
                </c:pt>
                <c:pt idx="639">
                  <c:v>0.13836666666666667</c:v>
                </c:pt>
                <c:pt idx="640">
                  <c:v>0.13748333333333332</c:v>
                </c:pt>
                <c:pt idx="641">
                  <c:v>0.13658333333333333</c:v>
                </c:pt>
                <c:pt idx="642">
                  <c:v>0.13560000000000003</c:v>
                </c:pt>
                <c:pt idx="643">
                  <c:v>0.13466666666666668</c:v>
                </c:pt>
                <c:pt idx="644">
                  <c:v>0.13370000000000001</c:v>
                </c:pt>
                <c:pt idx="645">
                  <c:v>0.13293333333333335</c:v>
                </c:pt>
                <c:pt idx="646">
                  <c:v>0.13213333333333335</c:v>
                </c:pt>
                <c:pt idx="647">
                  <c:v>0.13131666666666666</c:v>
                </c:pt>
                <c:pt idx="648">
                  <c:v>0.13055</c:v>
                </c:pt>
                <c:pt idx="649">
                  <c:v>0.12968333333333334</c:v>
                </c:pt>
                <c:pt idx="650">
                  <c:v>0.12886666666666668</c:v>
                </c:pt>
                <c:pt idx="651">
                  <c:v>0.12805</c:v>
                </c:pt>
                <c:pt idx="652">
                  <c:v>0.12721666666666664</c:v>
                </c:pt>
                <c:pt idx="653">
                  <c:v>0.1264666666666667</c:v>
                </c:pt>
                <c:pt idx="654">
                  <c:v>0.12570000000000001</c:v>
                </c:pt>
                <c:pt idx="655">
                  <c:v>0.12498333333333334</c:v>
                </c:pt>
                <c:pt idx="656">
                  <c:v>0.12421666666666666</c:v>
                </c:pt>
                <c:pt idx="657">
                  <c:v>0.12331666666666667</c:v>
                </c:pt>
                <c:pt idx="658">
                  <c:v>0.12255000000000001</c:v>
                </c:pt>
                <c:pt idx="659">
                  <c:v>0.12179999999999998</c:v>
                </c:pt>
                <c:pt idx="660">
                  <c:v>0.12106666666666667</c:v>
                </c:pt>
                <c:pt idx="661">
                  <c:v>0.12041666666666669</c:v>
                </c:pt>
                <c:pt idx="662">
                  <c:v>0.11963333333333333</c:v>
                </c:pt>
                <c:pt idx="663">
                  <c:v>0.11883333333333335</c:v>
                </c:pt>
                <c:pt idx="664">
                  <c:v>0.11815000000000002</c:v>
                </c:pt>
                <c:pt idx="665">
                  <c:v>0.1174</c:v>
                </c:pt>
                <c:pt idx="666">
                  <c:v>0.11668333333333332</c:v>
                </c:pt>
                <c:pt idx="667">
                  <c:v>0.11600000000000001</c:v>
                </c:pt>
                <c:pt idx="668">
                  <c:v>0.11533333333333334</c:v>
                </c:pt>
                <c:pt idx="669">
                  <c:v>0.11468333333333332</c:v>
                </c:pt>
                <c:pt idx="670">
                  <c:v>0.11395000000000001</c:v>
                </c:pt>
                <c:pt idx="671">
                  <c:v>0.11171666666666667</c:v>
                </c:pt>
                <c:pt idx="672">
                  <c:v>0.10951666666666665</c:v>
                </c:pt>
                <c:pt idx="673">
                  <c:v>0.10730000000000001</c:v>
                </c:pt>
                <c:pt idx="674">
                  <c:v>0.10523333333333333</c:v>
                </c:pt>
                <c:pt idx="675">
                  <c:v>0.10473333333333334</c:v>
                </c:pt>
                <c:pt idx="676">
                  <c:v>0.10396666666666667</c:v>
                </c:pt>
                <c:pt idx="677">
                  <c:v>0.10335000000000001</c:v>
                </c:pt>
                <c:pt idx="678">
                  <c:v>0.10261666666666668</c:v>
                </c:pt>
                <c:pt idx="679">
                  <c:v>0.10185000000000001</c:v>
                </c:pt>
                <c:pt idx="680">
                  <c:v>0.10123333333333333</c:v>
                </c:pt>
                <c:pt idx="681">
                  <c:v>0.10056666666666668</c:v>
                </c:pt>
                <c:pt idx="682">
                  <c:v>0.10000000000000002</c:v>
                </c:pt>
                <c:pt idx="683">
                  <c:v>9.9400000000000002E-2</c:v>
                </c:pt>
                <c:pt idx="684">
                  <c:v>9.8816666666666664E-2</c:v>
                </c:pt>
                <c:pt idx="685">
                  <c:v>9.8199999999999996E-2</c:v>
                </c:pt>
                <c:pt idx="686">
                  <c:v>9.7583333333333341E-2</c:v>
                </c:pt>
                <c:pt idx="687">
                  <c:v>9.715E-2</c:v>
                </c:pt>
                <c:pt idx="688">
                  <c:v>9.6499999999999989E-2</c:v>
                </c:pt>
                <c:pt idx="689">
                  <c:v>9.5966666666666686E-2</c:v>
                </c:pt>
                <c:pt idx="690">
                  <c:v>9.5333333333333339E-2</c:v>
                </c:pt>
                <c:pt idx="691">
                  <c:v>9.4666666666666663E-2</c:v>
                </c:pt>
                <c:pt idx="692">
                  <c:v>9.4100000000000003E-2</c:v>
                </c:pt>
                <c:pt idx="693">
                  <c:v>9.3500000000000014E-2</c:v>
                </c:pt>
                <c:pt idx="694">
                  <c:v>9.2849999999999988E-2</c:v>
                </c:pt>
                <c:pt idx="695">
                  <c:v>9.2249999999999999E-2</c:v>
                </c:pt>
                <c:pt idx="696">
                  <c:v>9.1649999999999995E-2</c:v>
                </c:pt>
                <c:pt idx="697">
                  <c:v>9.1100000000000014E-2</c:v>
                </c:pt>
                <c:pt idx="698">
                  <c:v>9.0666666666666673E-2</c:v>
                </c:pt>
                <c:pt idx="699">
                  <c:v>9.0083333333333349E-2</c:v>
                </c:pt>
                <c:pt idx="700">
                  <c:v>8.9583333333333334E-2</c:v>
                </c:pt>
                <c:pt idx="701">
                  <c:v>8.9066666666666669E-2</c:v>
                </c:pt>
                <c:pt idx="702">
                  <c:v>8.8483333333333317E-2</c:v>
                </c:pt>
                <c:pt idx="703">
                  <c:v>8.7816666666666668E-2</c:v>
                </c:pt>
                <c:pt idx="704">
                  <c:v>8.7233333333333329E-2</c:v>
                </c:pt>
                <c:pt idx="705">
                  <c:v>8.6566666666666667E-2</c:v>
                </c:pt>
                <c:pt idx="706">
                  <c:v>8.5983333333333314E-2</c:v>
                </c:pt>
                <c:pt idx="707">
                  <c:v>8.5500000000000007E-2</c:v>
                </c:pt>
                <c:pt idx="708">
                  <c:v>8.4950000000000012E-2</c:v>
                </c:pt>
                <c:pt idx="709">
                  <c:v>8.4399999999999989E-2</c:v>
                </c:pt>
                <c:pt idx="710">
                  <c:v>8.3866666666666687E-2</c:v>
                </c:pt>
                <c:pt idx="711">
                  <c:v>8.3383333333333323E-2</c:v>
                </c:pt>
                <c:pt idx="712">
                  <c:v>8.2883333333333351E-2</c:v>
                </c:pt>
                <c:pt idx="713">
                  <c:v>8.2283333333333333E-2</c:v>
                </c:pt>
                <c:pt idx="714">
                  <c:v>8.1783333333333333E-2</c:v>
                </c:pt>
                <c:pt idx="715">
                  <c:v>8.1233333333333338E-2</c:v>
                </c:pt>
                <c:pt idx="716">
                  <c:v>8.0849999999999991E-2</c:v>
                </c:pt>
                <c:pt idx="717">
                  <c:v>8.0266666666666667E-2</c:v>
                </c:pt>
                <c:pt idx="718">
                  <c:v>7.9866666666666655E-2</c:v>
                </c:pt>
                <c:pt idx="719">
                  <c:v>7.9150000000000012E-2</c:v>
                </c:pt>
                <c:pt idx="720">
                  <c:v>7.8633333333333347E-2</c:v>
                </c:pt>
                <c:pt idx="721">
                  <c:v>7.8133333333333346E-2</c:v>
                </c:pt>
                <c:pt idx="722">
                  <c:v>7.7766666666666664E-2</c:v>
                </c:pt>
                <c:pt idx="723">
                  <c:v>7.743333333333334E-2</c:v>
                </c:pt>
                <c:pt idx="724">
                  <c:v>7.6849999999999988E-2</c:v>
                </c:pt>
                <c:pt idx="725">
                  <c:v>7.6566666666666658E-2</c:v>
                </c:pt>
                <c:pt idx="726">
                  <c:v>7.6166666666666674E-2</c:v>
                </c:pt>
                <c:pt idx="727">
                  <c:v>7.5733333333333333E-2</c:v>
                </c:pt>
                <c:pt idx="728">
                  <c:v>7.5266666666666662E-2</c:v>
                </c:pt>
                <c:pt idx="729">
                  <c:v>7.4783333333333327E-2</c:v>
                </c:pt>
                <c:pt idx="730">
                  <c:v>7.4333333333333348E-2</c:v>
                </c:pt>
                <c:pt idx="731">
                  <c:v>7.3850000000000013E-2</c:v>
                </c:pt>
                <c:pt idx="732">
                  <c:v>7.3700000000000002E-2</c:v>
                </c:pt>
                <c:pt idx="733">
                  <c:v>7.3333333333333334E-2</c:v>
                </c:pt>
                <c:pt idx="734">
                  <c:v>7.3083333333333333E-2</c:v>
                </c:pt>
                <c:pt idx="735">
                  <c:v>7.2783333333333353E-2</c:v>
                </c:pt>
                <c:pt idx="736">
                  <c:v>7.2299999999999989E-2</c:v>
                </c:pt>
                <c:pt idx="737">
                  <c:v>7.2099999999999997E-2</c:v>
                </c:pt>
                <c:pt idx="738">
                  <c:v>7.1716666666666665E-2</c:v>
                </c:pt>
                <c:pt idx="739">
                  <c:v>7.1400000000000005E-2</c:v>
                </c:pt>
                <c:pt idx="740">
                  <c:v>7.1233333333333329E-2</c:v>
                </c:pt>
                <c:pt idx="741">
                  <c:v>7.0983333333333329E-2</c:v>
                </c:pt>
                <c:pt idx="742">
                  <c:v>7.0683333333333334E-2</c:v>
                </c:pt>
                <c:pt idx="743">
                  <c:v>7.0366666666666675E-2</c:v>
                </c:pt>
                <c:pt idx="744">
                  <c:v>7.0216666666666663E-2</c:v>
                </c:pt>
                <c:pt idx="745">
                  <c:v>6.9833333333333331E-2</c:v>
                </c:pt>
                <c:pt idx="746">
                  <c:v>6.975000000000002E-2</c:v>
                </c:pt>
                <c:pt idx="747">
                  <c:v>6.9666666666666668E-2</c:v>
                </c:pt>
                <c:pt idx="748">
                  <c:v>6.9366666666666674E-2</c:v>
                </c:pt>
                <c:pt idx="749">
                  <c:v>6.9383333333333339E-2</c:v>
                </c:pt>
                <c:pt idx="750">
                  <c:v>6.9283333333333336E-2</c:v>
                </c:pt>
                <c:pt idx="751">
                  <c:v>6.8966666666666662E-2</c:v>
                </c:pt>
                <c:pt idx="752">
                  <c:v>6.8966666666666662E-2</c:v>
                </c:pt>
                <c:pt idx="753">
                  <c:v>6.8816666666666651E-2</c:v>
                </c:pt>
                <c:pt idx="754">
                  <c:v>6.8833333333333316E-2</c:v>
                </c:pt>
                <c:pt idx="755">
                  <c:v>6.8766666666666684E-2</c:v>
                </c:pt>
                <c:pt idx="756">
                  <c:v>6.8633333333333338E-2</c:v>
                </c:pt>
                <c:pt idx="757">
                  <c:v>6.8616666666666659E-2</c:v>
                </c:pt>
                <c:pt idx="758">
                  <c:v>6.8500000000000005E-2</c:v>
                </c:pt>
                <c:pt idx="759">
                  <c:v>6.851666666666667E-2</c:v>
                </c:pt>
                <c:pt idx="760">
                  <c:v>6.8733333333333327E-2</c:v>
                </c:pt>
                <c:pt idx="761">
                  <c:v>6.8850000000000008E-2</c:v>
                </c:pt>
                <c:pt idx="762">
                  <c:v>6.928333333333335E-2</c:v>
                </c:pt>
                <c:pt idx="763">
                  <c:v>6.9550000000000015E-2</c:v>
                </c:pt>
                <c:pt idx="764">
                  <c:v>6.9699999999999998E-2</c:v>
                </c:pt>
                <c:pt idx="765">
                  <c:v>6.9900000000000004E-2</c:v>
                </c:pt>
                <c:pt idx="766">
                  <c:v>7.0033333333333322E-2</c:v>
                </c:pt>
                <c:pt idx="767">
                  <c:v>7.0116666666666674E-2</c:v>
                </c:pt>
                <c:pt idx="768">
                  <c:v>7.0733333333333329E-2</c:v>
                </c:pt>
                <c:pt idx="769">
                  <c:v>7.1050000000000002E-2</c:v>
                </c:pt>
                <c:pt idx="770">
                  <c:v>7.1516666666666687E-2</c:v>
                </c:pt>
                <c:pt idx="771">
                  <c:v>7.2083333333333333E-2</c:v>
                </c:pt>
                <c:pt idx="772">
                  <c:v>7.2350000000000012E-2</c:v>
                </c:pt>
                <c:pt idx="773">
                  <c:v>7.2883333333333328E-2</c:v>
                </c:pt>
                <c:pt idx="774">
                  <c:v>7.3249999999999996E-2</c:v>
                </c:pt>
                <c:pt idx="775">
                  <c:v>7.3950000000000002E-2</c:v>
                </c:pt>
                <c:pt idx="776">
                  <c:v>7.4433333333333337E-2</c:v>
                </c:pt>
                <c:pt idx="777">
                  <c:v>7.4983333333333346E-2</c:v>
                </c:pt>
                <c:pt idx="778">
                  <c:v>7.5816666666666657E-2</c:v>
                </c:pt>
                <c:pt idx="779">
                  <c:v>7.6349999999999987E-2</c:v>
                </c:pt>
                <c:pt idx="780">
                  <c:v>7.7416666666666675E-2</c:v>
                </c:pt>
                <c:pt idx="781">
                  <c:v>7.8416666666666676E-2</c:v>
                </c:pt>
                <c:pt idx="782">
                  <c:v>7.9233333333333336E-2</c:v>
                </c:pt>
                <c:pt idx="783">
                  <c:v>8.0266666666666667E-2</c:v>
                </c:pt>
                <c:pt idx="784">
                  <c:v>8.1099999999999992E-2</c:v>
                </c:pt>
                <c:pt idx="785">
                  <c:v>8.2000000000000003E-2</c:v>
                </c:pt>
                <c:pt idx="786">
                  <c:v>8.3000000000000004E-2</c:v>
                </c:pt>
                <c:pt idx="787">
                  <c:v>8.4066666666666678E-2</c:v>
                </c:pt>
                <c:pt idx="788">
                  <c:v>8.5183333333333319E-2</c:v>
                </c:pt>
                <c:pt idx="789">
                  <c:v>8.6266666666666672E-2</c:v>
                </c:pt>
                <c:pt idx="790">
                  <c:v>8.7500000000000008E-2</c:v>
                </c:pt>
                <c:pt idx="791">
                  <c:v>8.8666666666666671E-2</c:v>
                </c:pt>
                <c:pt idx="792">
                  <c:v>8.9716666666666653E-2</c:v>
                </c:pt>
                <c:pt idx="793">
                  <c:v>9.0966666666666682E-2</c:v>
                </c:pt>
                <c:pt idx="794">
                  <c:v>9.2116666666666666E-2</c:v>
                </c:pt>
                <c:pt idx="795">
                  <c:v>9.3383333333333332E-2</c:v>
                </c:pt>
                <c:pt idx="796">
                  <c:v>9.4700000000000006E-2</c:v>
                </c:pt>
                <c:pt idx="797">
                  <c:v>9.6000000000000016E-2</c:v>
                </c:pt>
                <c:pt idx="798">
                  <c:v>9.7250000000000003E-2</c:v>
                </c:pt>
                <c:pt idx="799">
                  <c:v>9.8449999999999996E-2</c:v>
                </c:pt>
                <c:pt idx="800">
                  <c:v>9.9666666666666681E-2</c:v>
                </c:pt>
                <c:pt idx="801">
                  <c:v>0.10075000000000001</c:v>
                </c:pt>
                <c:pt idx="802">
                  <c:v>0.10208333333333335</c:v>
                </c:pt>
                <c:pt idx="803">
                  <c:v>0.10315000000000001</c:v>
                </c:pt>
                <c:pt idx="804">
                  <c:v>0.10445</c:v>
                </c:pt>
                <c:pt idx="805">
                  <c:v>0.10580000000000001</c:v>
                </c:pt>
                <c:pt idx="806">
                  <c:v>0.10688333333333333</c:v>
                </c:pt>
                <c:pt idx="807">
                  <c:v>0.10828333333333334</c:v>
                </c:pt>
                <c:pt idx="808">
                  <c:v>0.10918333333333334</c:v>
                </c:pt>
                <c:pt idx="809">
                  <c:v>0.11003333333333336</c:v>
                </c:pt>
                <c:pt idx="810">
                  <c:v>0.11081666666666666</c:v>
                </c:pt>
                <c:pt idx="811">
                  <c:v>0.11123333333333334</c:v>
                </c:pt>
                <c:pt idx="812">
                  <c:v>0.11194999999999999</c:v>
                </c:pt>
                <c:pt idx="813">
                  <c:v>0.11259999999999999</c:v>
                </c:pt>
                <c:pt idx="814">
                  <c:v>0.11326666666666667</c:v>
                </c:pt>
                <c:pt idx="815">
                  <c:v>0.11381666666666668</c:v>
                </c:pt>
                <c:pt idx="816">
                  <c:v>0.11433333333333334</c:v>
                </c:pt>
                <c:pt idx="817">
                  <c:v>0.11468333333333332</c:v>
                </c:pt>
                <c:pt idx="818">
                  <c:v>0.11480000000000001</c:v>
                </c:pt>
                <c:pt idx="819">
                  <c:v>0.11503333333333333</c:v>
                </c:pt>
                <c:pt idx="820">
                  <c:v>0.11496666666666666</c:v>
                </c:pt>
                <c:pt idx="821">
                  <c:v>0.11506666666666666</c:v>
                </c:pt>
                <c:pt idx="822">
                  <c:v>0.11509999999999999</c:v>
                </c:pt>
                <c:pt idx="823">
                  <c:v>0.11485000000000001</c:v>
                </c:pt>
                <c:pt idx="824">
                  <c:v>0.1145</c:v>
                </c:pt>
                <c:pt idx="825">
                  <c:v>0.11406666666666666</c:v>
                </c:pt>
                <c:pt idx="826">
                  <c:v>0.11370000000000001</c:v>
                </c:pt>
                <c:pt idx="827">
                  <c:v>0.11333333333333334</c:v>
                </c:pt>
                <c:pt idx="828">
                  <c:v>0.11270000000000001</c:v>
                </c:pt>
                <c:pt idx="829">
                  <c:v>0.11194999999999999</c:v>
                </c:pt>
                <c:pt idx="830">
                  <c:v>0.11091666666666668</c:v>
                </c:pt>
                <c:pt idx="831">
                  <c:v>0.11013333333333335</c:v>
                </c:pt>
                <c:pt idx="832">
                  <c:v>0.10928333333333333</c:v>
                </c:pt>
                <c:pt idx="833">
                  <c:v>0.10850000000000003</c:v>
                </c:pt>
                <c:pt idx="834">
                  <c:v>0.10744999999999999</c:v>
                </c:pt>
                <c:pt idx="835">
                  <c:v>0.10596666666666665</c:v>
                </c:pt>
                <c:pt idx="836">
                  <c:v>0.10495</c:v>
                </c:pt>
                <c:pt idx="837">
                  <c:v>0.10376666666666667</c:v>
                </c:pt>
                <c:pt idx="838">
                  <c:v>0.10268333333333333</c:v>
                </c:pt>
                <c:pt idx="839">
                  <c:v>0.10183333333333335</c:v>
                </c:pt>
                <c:pt idx="840">
                  <c:v>0.10041666666666665</c:v>
                </c:pt>
                <c:pt idx="841">
                  <c:v>9.9133333333333337E-2</c:v>
                </c:pt>
                <c:pt idx="842">
                  <c:v>9.7933333333333331E-2</c:v>
                </c:pt>
                <c:pt idx="843">
                  <c:v>9.6750000000000017E-2</c:v>
                </c:pt>
                <c:pt idx="844">
                  <c:v>9.5750000000000002E-2</c:v>
                </c:pt>
                <c:pt idx="845">
                  <c:v>9.4516666666666679E-2</c:v>
                </c:pt>
                <c:pt idx="846">
                  <c:v>9.3166666666666675E-2</c:v>
                </c:pt>
                <c:pt idx="847">
                  <c:v>9.1716666666666669E-2</c:v>
                </c:pt>
                <c:pt idx="848">
                  <c:v>9.028333333333334E-2</c:v>
                </c:pt>
                <c:pt idx="849">
                  <c:v>8.8983333333333345E-2</c:v>
                </c:pt>
                <c:pt idx="850">
                  <c:v>8.8000000000000009E-2</c:v>
                </c:pt>
                <c:pt idx="851">
                  <c:v>8.7033333333333338E-2</c:v>
                </c:pt>
                <c:pt idx="852">
                  <c:v>8.5983333333333314E-2</c:v>
                </c:pt>
                <c:pt idx="853">
                  <c:v>8.5066666666666665E-2</c:v>
                </c:pt>
                <c:pt idx="854">
                  <c:v>8.405E-2</c:v>
                </c:pt>
                <c:pt idx="855">
                  <c:v>8.3049999999999999E-2</c:v>
                </c:pt>
                <c:pt idx="856">
                  <c:v>8.2533333333333334E-2</c:v>
                </c:pt>
                <c:pt idx="857">
                  <c:v>8.165E-2</c:v>
                </c:pt>
                <c:pt idx="858">
                  <c:v>8.09E-2</c:v>
                </c:pt>
                <c:pt idx="859">
                  <c:v>8.0599999999999991E-2</c:v>
                </c:pt>
                <c:pt idx="860">
                  <c:v>7.9733333333333323E-2</c:v>
                </c:pt>
                <c:pt idx="861">
                  <c:v>7.934999999999999E-2</c:v>
                </c:pt>
                <c:pt idx="862">
                  <c:v>7.878333333333333E-2</c:v>
                </c:pt>
                <c:pt idx="863">
                  <c:v>7.796666666666667E-2</c:v>
                </c:pt>
                <c:pt idx="864">
                  <c:v>7.7666666666666662E-2</c:v>
                </c:pt>
                <c:pt idx="865">
                  <c:v>7.721666666666667E-2</c:v>
                </c:pt>
                <c:pt idx="866">
                  <c:v>7.6833333333333323E-2</c:v>
                </c:pt>
                <c:pt idx="867">
                  <c:v>7.6549999999999993E-2</c:v>
                </c:pt>
                <c:pt idx="868">
                  <c:v>7.6216666666666669E-2</c:v>
                </c:pt>
                <c:pt idx="869">
                  <c:v>7.5999999999999998E-2</c:v>
                </c:pt>
                <c:pt idx="870">
                  <c:v>7.6083333333333336E-2</c:v>
                </c:pt>
                <c:pt idx="871">
                  <c:v>7.5866666666666679E-2</c:v>
                </c:pt>
                <c:pt idx="872">
                  <c:v>7.5766666666666663E-2</c:v>
                </c:pt>
                <c:pt idx="873">
                  <c:v>7.5683333333333352E-2</c:v>
                </c:pt>
                <c:pt idx="874">
                  <c:v>7.5533333333333327E-2</c:v>
                </c:pt>
                <c:pt idx="875">
                  <c:v>7.5850000000000001E-2</c:v>
                </c:pt>
                <c:pt idx="876">
                  <c:v>7.6216666666666669E-2</c:v>
                </c:pt>
                <c:pt idx="877">
                  <c:v>7.6216666666666655E-2</c:v>
                </c:pt>
                <c:pt idx="878">
                  <c:v>7.6466666666666669E-2</c:v>
                </c:pt>
                <c:pt idx="879">
                  <c:v>7.669999999999999E-2</c:v>
                </c:pt>
                <c:pt idx="880">
                  <c:v>7.7083333333333351E-2</c:v>
                </c:pt>
                <c:pt idx="881">
                  <c:v>7.7550000000000008E-2</c:v>
                </c:pt>
                <c:pt idx="882">
                  <c:v>7.7600000000000002E-2</c:v>
                </c:pt>
                <c:pt idx="883">
                  <c:v>7.7766666666666664E-2</c:v>
                </c:pt>
                <c:pt idx="884">
                  <c:v>7.7799999999999994E-2</c:v>
                </c:pt>
                <c:pt idx="885">
                  <c:v>7.8483333333333336E-2</c:v>
                </c:pt>
                <c:pt idx="886">
                  <c:v>7.8916666666666677E-2</c:v>
                </c:pt>
                <c:pt idx="887">
                  <c:v>7.9149999999999998E-2</c:v>
                </c:pt>
                <c:pt idx="888">
                  <c:v>7.9100000000000004E-2</c:v>
                </c:pt>
                <c:pt idx="889">
                  <c:v>7.9416666666666649E-2</c:v>
                </c:pt>
                <c:pt idx="890">
                  <c:v>7.9816666666666661E-2</c:v>
                </c:pt>
                <c:pt idx="891">
                  <c:v>8.0516666666666667E-2</c:v>
                </c:pt>
                <c:pt idx="892">
                  <c:v>8.1566666666666662E-2</c:v>
                </c:pt>
                <c:pt idx="893">
                  <c:v>8.1416666666666679E-2</c:v>
                </c:pt>
                <c:pt idx="894">
                  <c:v>8.1733333333333338E-2</c:v>
                </c:pt>
                <c:pt idx="895">
                  <c:v>8.1783333333333333E-2</c:v>
                </c:pt>
                <c:pt idx="896">
                  <c:v>8.1566666666666676E-2</c:v>
                </c:pt>
                <c:pt idx="897">
                  <c:v>8.1900000000000014E-2</c:v>
                </c:pt>
                <c:pt idx="898">
                  <c:v>8.2349999999999993E-2</c:v>
                </c:pt>
                <c:pt idx="899">
                  <c:v>8.2633333333333336E-2</c:v>
                </c:pt>
                <c:pt idx="900">
                  <c:v>8.3050000000000013E-2</c:v>
                </c:pt>
                <c:pt idx="901">
                  <c:v>8.3550000000000013E-2</c:v>
                </c:pt>
                <c:pt idx="902">
                  <c:v>8.3783333333333321E-2</c:v>
                </c:pt>
                <c:pt idx="903">
                  <c:v>8.3866666666666687E-2</c:v>
                </c:pt>
                <c:pt idx="904">
                  <c:v>8.4283333333333335E-2</c:v>
                </c:pt>
                <c:pt idx="905">
                  <c:v>8.4283333333333335E-2</c:v>
                </c:pt>
                <c:pt idx="906">
                  <c:v>8.4766666666666657E-2</c:v>
                </c:pt>
                <c:pt idx="907">
                  <c:v>8.5000000000000006E-2</c:v>
                </c:pt>
                <c:pt idx="908">
                  <c:v>8.5133333333333339E-2</c:v>
                </c:pt>
                <c:pt idx="909">
                  <c:v>8.4983333333333341E-2</c:v>
                </c:pt>
                <c:pt idx="910">
                  <c:v>8.4816666666666651E-2</c:v>
                </c:pt>
                <c:pt idx="911">
                  <c:v>8.4349999999999994E-2</c:v>
                </c:pt>
                <c:pt idx="912">
                  <c:v>8.4483333333333341E-2</c:v>
                </c:pt>
                <c:pt idx="913">
                  <c:v>8.4600000000000009E-2</c:v>
                </c:pt>
                <c:pt idx="914">
                  <c:v>8.4233333333333327E-2</c:v>
                </c:pt>
                <c:pt idx="915">
                  <c:v>8.4050000000000014E-2</c:v>
                </c:pt>
                <c:pt idx="916">
                  <c:v>8.3699999999999997E-2</c:v>
                </c:pt>
                <c:pt idx="917">
                  <c:v>8.3533333333333334E-2</c:v>
                </c:pt>
                <c:pt idx="918">
                  <c:v>8.316666666666668E-2</c:v>
                </c:pt>
                <c:pt idx="919">
                  <c:v>8.323333333333334E-2</c:v>
                </c:pt>
                <c:pt idx="920">
                  <c:v>8.3016666666666669E-2</c:v>
                </c:pt>
                <c:pt idx="921">
                  <c:v>8.2600000000000007E-2</c:v>
                </c:pt>
                <c:pt idx="922">
                  <c:v>8.2500000000000004E-2</c:v>
                </c:pt>
                <c:pt idx="923">
                  <c:v>8.1966666666666674E-2</c:v>
                </c:pt>
                <c:pt idx="924">
                  <c:v>8.111666666666667E-2</c:v>
                </c:pt>
                <c:pt idx="925">
                  <c:v>8.1400000000000014E-2</c:v>
                </c:pt>
                <c:pt idx="926">
                  <c:v>8.1033333333333332E-2</c:v>
                </c:pt>
                <c:pt idx="927">
                  <c:v>8.2783333333333334E-2</c:v>
                </c:pt>
                <c:pt idx="928">
                  <c:v>8.4566666666666679E-2</c:v>
                </c:pt>
                <c:pt idx="929">
                  <c:v>8.5483333333333342E-2</c:v>
                </c:pt>
                <c:pt idx="930">
                  <c:v>8.6616666666666675E-2</c:v>
                </c:pt>
                <c:pt idx="931">
                  <c:v>8.6016666666666672E-2</c:v>
                </c:pt>
                <c:pt idx="932">
                  <c:v>8.5583333333333345E-2</c:v>
                </c:pt>
                <c:pt idx="933">
                  <c:v>8.5416666666666655E-2</c:v>
                </c:pt>
                <c:pt idx="934">
                  <c:v>8.5533333333333336E-2</c:v>
                </c:pt>
                <c:pt idx="935">
                  <c:v>8.536666666666666E-2</c:v>
                </c:pt>
                <c:pt idx="936">
                  <c:v>8.5199999999999998E-2</c:v>
                </c:pt>
                <c:pt idx="937">
                  <c:v>8.4283333333333335E-2</c:v>
                </c:pt>
                <c:pt idx="938">
                  <c:v>8.376666666666667E-2</c:v>
                </c:pt>
                <c:pt idx="939">
                  <c:v>8.3366666666666658E-2</c:v>
                </c:pt>
                <c:pt idx="940">
                  <c:v>8.2733333333333339E-2</c:v>
                </c:pt>
                <c:pt idx="941">
                  <c:v>8.2233333333333325E-2</c:v>
                </c:pt>
                <c:pt idx="942">
                  <c:v>8.1733333333333325E-2</c:v>
                </c:pt>
                <c:pt idx="943">
                  <c:v>8.1133333333333335E-2</c:v>
                </c:pt>
                <c:pt idx="944">
                  <c:v>8.0683333333333343E-2</c:v>
                </c:pt>
                <c:pt idx="945">
                  <c:v>8.0450000000000008E-2</c:v>
                </c:pt>
                <c:pt idx="946">
                  <c:v>8.0116666666666669E-2</c:v>
                </c:pt>
                <c:pt idx="947">
                  <c:v>7.9633333333333334E-2</c:v>
                </c:pt>
                <c:pt idx="948">
                  <c:v>7.9299999999999995E-2</c:v>
                </c:pt>
                <c:pt idx="949">
                  <c:v>7.9200000000000007E-2</c:v>
                </c:pt>
                <c:pt idx="950">
                  <c:v>7.8583333333333338E-2</c:v>
                </c:pt>
                <c:pt idx="951">
                  <c:v>7.5716666666666668E-2</c:v>
                </c:pt>
                <c:pt idx="952">
                  <c:v>7.3800000000000004E-2</c:v>
                </c:pt>
                <c:pt idx="953">
                  <c:v>7.116666666666667E-2</c:v>
                </c:pt>
                <c:pt idx="954">
                  <c:v>6.8049999999999999E-2</c:v>
                </c:pt>
                <c:pt idx="955">
                  <c:v>6.8783333333333335E-2</c:v>
                </c:pt>
                <c:pt idx="956">
                  <c:v>6.8716666666666662E-2</c:v>
                </c:pt>
                <c:pt idx="957">
                  <c:v>6.8783333333333321E-2</c:v>
                </c:pt>
                <c:pt idx="958">
                  <c:v>6.9566666666666666E-2</c:v>
                </c:pt>
                <c:pt idx="959">
                  <c:v>6.9333333333333316E-2</c:v>
                </c:pt>
                <c:pt idx="960">
                  <c:v>6.798333333333334E-2</c:v>
                </c:pt>
                <c:pt idx="961">
                  <c:v>6.7566666666666664E-2</c:v>
                </c:pt>
                <c:pt idx="962">
                  <c:v>6.6233333333333338E-2</c:v>
                </c:pt>
                <c:pt idx="963">
                  <c:v>6.5233333333333324E-2</c:v>
                </c:pt>
                <c:pt idx="964">
                  <c:v>6.4900000000000013E-2</c:v>
                </c:pt>
                <c:pt idx="965">
                  <c:v>6.4583333333333326E-2</c:v>
                </c:pt>
                <c:pt idx="966">
                  <c:v>6.5349999999999991E-2</c:v>
                </c:pt>
                <c:pt idx="967">
                  <c:v>6.6416666666666666E-2</c:v>
                </c:pt>
                <c:pt idx="968">
                  <c:v>6.7083333333333342E-2</c:v>
                </c:pt>
                <c:pt idx="969">
                  <c:v>6.6283333333333333E-2</c:v>
                </c:pt>
                <c:pt idx="970">
                  <c:v>6.6466666666666674E-2</c:v>
                </c:pt>
                <c:pt idx="971">
                  <c:v>6.5850000000000006E-2</c:v>
                </c:pt>
                <c:pt idx="972">
                  <c:v>6.5999999999999989E-2</c:v>
                </c:pt>
                <c:pt idx="973">
                  <c:v>6.7716666666666661E-2</c:v>
                </c:pt>
                <c:pt idx="974">
                  <c:v>6.7866666666666672E-2</c:v>
                </c:pt>
                <c:pt idx="975">
                  <c:v>6.851666666666667E-2</c:v>
                </c:pt>
                <c:pt idx="976">
                  <c:v>6.8933333333333333E-2</c:v>
                </c:pt>
                <c:pt idx="977">
                  <c:v>6.8083333333333343E-2</c:v>
                </c:pt>
                <c:pt idx="978">
                  <c:v>6.8116666666666673E-2</c:v>
                </c:pt>
                <c:pt idx="979">
                  <c:v>6.7633333333333337E-2</c:v>
                </c:pt>
                <c:pt idx="980">
                  <c:v>6.7483333333333326E-2</c:v>
                </c:pt>
                <c:pt idx="981">
                  <c:v>6.8116666666666673E-2</c:v>
                </c:pt>
                <c:pt idx="982">
                  <c:v>6.8416666666666681E-2</c:v>
                </c:pt>
                <c:pt idx="983">
                  <c:v>6.9316666666666679E-2</c:v>
                </c:pt>
                <c:pt idx="984">
                  <c:v>6.9183333333333333E-2</c:v>
                </c:pt>
                <c:pt idx="985">
                  <c:v>6.8866666666666659E-2</c:v>
                </c:pt>
                <c:pt idx="986">
                  <c:v>6.9033333333333335E-2</c:v>
                </c:pt>
                <c:pt idx="987">
                  <c:v>6.8283333333333349E-2</c:v>
                </c:pt>
                <c:pt idx="988">
                  <c:v>6.9266666666666657E-2</c:v>
                </c:pt>
                <c:pt idx="989">
                  <c:v>6.9933333333333333E-2</c:v>
                </c:pt>
                <c:pt idx="990">
                  <c:v>6.9966666666666677E-2</c:v>
                </c:pt>
                <c:pt idx="991">
                  <c:v>7.1216666666666664E-2</c:v>
                </c:pt>
                <c:pt idx="992">
                  <c:v>7.0983333333333343E-2</c:v>
                </c:pt>
                <c:pt idx="993">
                  <c:v>7.0733333333333329E-2</c:v>
                </c:pt>
                <c:pt idx="994">
                  <c:v>7.0933333333333334E-2</c:v>
                </c:pt>
                <c:pt idx="995">
                  <c:v>7.0066666666666666E-2</c:v>
                </c:pt>
                <c:pt idx="996">
                  <c:v>6.9949999999999998E-2</c:v>
                </c:pt>
                <c:pt idx="997">
                  <c:v>7.0400000000000004E-2</c:v>
                </c:pt>
                <c:pt idx="998">
                  <c:v>7.0783333333333323E-2</c:v>
                </c:pt>
                <c:pt idx="999">
                  <c:v>7.0283333333333337E-2</c:v>
                </c:pt>
                <c:pt idx="1000">
                  <c:v>7.0199999999999999E-2</c:v>
                </c:pt>
                <c:pt idx="1001">
                  <c:v>7.0866666666666661E-2</c:v>
                </c:pt>
                <c:pt idx="1002">
                  <c:v>7.0583333333333345E-2</c:v>
                </c:pt>
                <c:pt idx="1003">
                  <c:v>7.0933333333333334E-2</c:v>
                </c:pt>
                <c:pt idx="1004">
                  <c:v>7.1316666666666681E-2</c:v>
                </c:pt>
                <c:pt idx="1005">
                  <c:v>7.1466666666666678E-2</c:v>
                </c:pt>
                <c:pt idx="1006">
                  <c:v>7.1249999999999994E-2</c:v>
                </c:pt>
                <c:pt idx="1007">
                  <c:v>7.2283333333333324E-2</c:v>
                </c:pt>
                <c:pt idx="1008">
                  <c:v>7.3200000000000001E-2</c:v>
                </c:pt>
                <c:pt idx="1009">
                  <c:v>7.1933333333333335E-2</c:v>
                </c:pt>
                <c:pt idx="1010">
                  <c:v>7.2666666666666671E-2</c:v>
                </c:pt>
                <c:pt idx="1011">
                  <c:v>7.2833333333333347E-2</c:v>
                </c:pt>
                <c:pt idx="1012">
                  <c:v>7.1566666666666667E-2</c:v>
                </c:pt>
                <c:pt idx="1013">
                  <c:v>7.1716666666666651E-2</c:v>
                </c:pt>
                <c:pt idx="1014">
                  <c:v>7.1466666666666678E-2</c:v>
                </c:pt>
                <c:pt idx="1015">
                  <c:v>7.1349999999999997E-2</c:v>
                </c:pt>
                <c:pt idx="1016">
                  <c:v>7.2283333333333352E-2</c:v>
                </c:pt>
                <c:pt idx="1017">
                  <c:v>7.2916666666666671E-2</c:v>
                </c:pt>
                <c:pt idx="1018">
                  <c:v>7.3116666666666677E-2</c:v>
                </c:pt>
                <c:pt idx="1019">
                  <c:v>7.2666666666666671E-2</c:v>
                </c:pt>
                <c:pt idx="1020">
                  <c:v>7.276666666666666E-2</c:v>
                </c:pt>
                <c:pt idx="1021">
                  <c:v>7.2116666666666676E-2</c:v>
                </c:pt>
                <c:pt idx="1022">
                  <c:v>7.2100000000000011E-2</c:v>
                </c:pt>
                <c:pt idx="1023">
                  <c:v>7.2333333333333319E-2</c:v>
                </c:pt>
                <c:pt idx="1024">
                  <c:v>7.1633333333333341E-2</c:v>
                </c:pt>
                <c:pt idx="1025">
                  <c:v>7.2000000000000008E-2</c:v>
                </c:pt>
                <c:pt idx="1026">
                  <c:v>7.2066666666666682E-2</c:v>
                </c:pt>
                <c:pt idx="1027">
                  <c:v>7.17E-2</c:v>
                </c:pt>
                <c:pt idx="1028">
                  <c:v>7.1366666666666662E-2</c:v>
                </c:pt>
                <c:pt idx="1029">
                  <c:v>7.2016666666666673E-2</c:v>
                </c:pt>
                <c:pt idx="1030">
                  <c:v>7.1849999999999983E-2</c:v>
                </c:pt>
                <c:pt idx="1031">
                  <c:v>7.2116666666666662E-2</c:v>
                </c:pt>
                <c:pt idx="1032">
                  <c:v>7.2800000000000004E-2</c:v>
                </c:pt>
                <c:pt idx="1033">
                  <c:v>7.1416666666666656E-2</c:v>
                </c:pt>
                <c:pt idx="1034">
                  <c:v>7.1883333333333341E-2</c:v>
                </c:pt>
                <c:pt idx="1035">
                  <c:v>7.1883333333333341E-2</c:v>
                </c:pt>
                <c:pt idx="1036">
                  <c:v>7.1433333333333335E-2</c:v>
                </c:pt>
                <c:pt idx="1037">
                  <c:v>7.2400000000000006E-2</c:v>
                </c:pt>
                <c:pt idx="1038">
                  <c:v>7.1366666666666675E-2</c:v>
                </c:pt>
                <c:pt idx="1039">
                  <c:v>7.1400000000000005E-2</c:v>
                </c:pt>
                <c:pt idx="1040">
                  <c:v>7.1666666666666656E-2</c:v>
                </c:pt>
                <c:pt idx="1041">
                  <c:v>7.1550000000000002E-2</c:v>
                </c:pt>
                <c:pt idx="1042">
                  <c:v>7.2816666666666682E-2</c:v>
                </c:pt>
                <c:pt idx="1043">
                  <c:v>7.3683333333333337E-2</c:v>
                </c:pt>
                <c:pt idx="1044">
                  <c:v>7.4183333333333323E-2</c:v>
                </c:pt>
                <c:pt idx="1045">
                  <c:v>7.4416666666666673E-2</c:v>
                </c:pt>
                <c:pt idx="1046">
                  <c:v>7.4283333333333326E-2</c:v>
                </c:pt>
                <c:pt idx="1047">
                  <c:v>7.3983333333333332E-2</c:v>
                </c:pt>
                <c:pt idx="1048">
                  <c:v>7.3416666666666672E-2</c:v>
                </c:pt>
                <c:pt idx="1049">
                  <c:v>7.3966666666666667E-2</c:v>
                </c:pt>
                <c:pt idx="1050">
                  <c:v>7.3399999999999979E-2</c:v>
                </c:pt>
                <c:pt idx="1051">
                  <c:v>7.4016666666666661E-2</c:v>
                </c:pt>
                <c:pt idx="1052">
                  <c:v>7.4450000000000002E-2</c:v>
                </c:pt>
                <c:pt idx="1053">
                  <c:v>7.4516666666666675E-2</c:v>
                </c:pt>
                <c:pt idx="1054">
                  <c:v>7.5250000000000011E-2</c:v>
                </c:pt>
                <c:pt idx="1055">
                  <c:v>7.4850000000000014E-2</c:v>
                </c:pt>
                <c:pt idx="1056">
                  <c:v>7.5266666666666676E-2</c:v>
                </c:pt>
                <c:pt idx="1057">
                  <c:v>7.5166666666666659E-2</c:v>
                </c:pt>
                <c:pt idx="1058">
                  <c:v>7.6050000000000006E-2</c:v>
                </c:pt>
                <c:pt idx="1059">
                  <c:v>7.7249999999999999E-2</c:v>
                </c:pt>
                <c:pt idx="1060">
                  <c:v>7.6983333333333334E-2</c:v>
                </c:pt>
                <c:pt idx="1061">
                  <c:v>7.7850000000000003E-2</c:v>
                </c:pt>
                <c:pt idx="1062">
                  <c:v>7.768333333333334E-2</c:v>
                </c:pt>
                <c:pt idx="1063">
                  <c:v>7.7766666666666664E-2</c:v>
                </c:pt>
                <c:pt idx="1064">
                  <c:v>7.8533333333333344E-2</c:v>
                </c:pt>
                <c:pt idx="1065">
                  <c:v>7.8899999999999998E-2</c:v>
                </c:pt>
                <c:pt idx="1066">
                  <c:v>7.9583333333333325E-2</c:v>
                </c:pt>
                <c:pt idx="1067">
                  <c:v>7.9716666666666672E-2</c:v>
                </c:pt>
                <c:pt idx="1068">
                  <c:v>8.0216666666666672E-2</c:v>
                </c:pt>
                <c:pt idx="1069">
                  <c:v>7.9799999999999996E-2</c:v>
                </c:pt>
                <c:pt idx="1070">
                  <c:v>7.9866666666666669E-2</c:v>
                </c:pt>
                <c:pt idx="1071">
                  <c:v>7.9949999999999993E-2</c:v>
                </c:pt>
                <c:pt idx="1072">
                  <c:v>8.0466666666666659E-2</c:v>
                </c:pt>
                <c:pt idx="1073">
                  <c:v>8.1550000000000011E-2</c:v>
                </c:pt>
                <c:pt idx="1074">
                  <c:v>8.2400000000000001E-2</c:v>
                </c:pt>
                <c:pt idx="1075">
                  <c:v>8.3250000000000005E-2</c:v>
                </c:pt>
                <c:pt idx="1076">
                  <c:v>8.3533333333333334E-2</c:v>
                </c:pt>
                <c:pt idx="1077">
                  <c:v>8.4616666666666673E-2</c:v>
                </c:pt>
                <c:pt idx="1078">
                  <c:v>8.4816666666666665E-2</c:v>
                </c:pt>
                <c:pt idx="1079">
                  <c:v>8.4849999999999995E-2</c:v>
                </c:pt>
                <c:pt idx="1080">
                  <c:v>8.5783333333333323E-2</c:v>
                </c:pt>
                <c:pt idx="1081">
                  <c:v>8.5800000000000001E-2</c:v>
                </c:pt>
                <c:pt idx="1082">
                  <c:v>8.6883333333333354E-2</c:v>
                </c:pt>
                <c:pt idx="1083">
                  <c:v>8.7400000000000019E-2</c:v>
                </c:pt>
                <c:pt idx="1084">
                  <c:v>8.8383333333333328E-2</c:v>
                </c:pt>
                <c:pt idx="1085">
                  <c:v>8.9316666666666669E-2</c:v>
                </c:pt>
                <c:pt idx="1086">
                  <c:v>8.9733333333333345E-2</c:v>
                </c:pt>
                <c:pt idx="1087">
                  <c:v>9.0399999999999994E-2</c:v>
                </c:pt>
                <c:pt idx="1088">
                  <c:v>9.1000000000000011E-2</c:v>
                </c:pt>
                <c:pt idx="1089">
                  <c:v>9.116666666666666E-2</c:v>
                </c:pt>
                <c:pt idx="1090">
                  <c:v>9.1433333333333325E-2</c:v>
                </c:pt>
                <c:pt idx="1091">
                  <c:v>9.2850000000000002E-2</c:v>
                </c:pt>
                <c:pt idx="1092">
                  <c:v>9.4416666666666663E-2</c:v>
                </c:pt>
                <c:pt idx="1093">
                  <c:v>9.5566666666666675E-2</c:v>
                </c:pt>
                <c:pt idx="1094">
                  <c:v>9.6499999999999989E-2</c:v>
                </c:pt>
                <c:pt idx="1095">
                  <c:v>9.6933333333333357E-2</c:v>
                </c:pt>
                <c:pt idx="1096">
                  <c:v>9.6716666666666673E-2</c:v>
                </c:pt>
                <c:pt idx="1097">
                  <c:v>9.7416666666666665E-2</c:v>
                </c:pt>
                <c:pt idx="1098">
                  <c:v>9.7816666666666677E-2</c:v>
                </c:pt>
                <c:pt idx="1099">
                  <c:v>9.8849999999999993E-2</c:v>
                </c:pt>
                <c:pt idx="1100">
                  <c:v>9.9566666666666678E-2</c:v>
                </c:pt>
                <c:pt idx="1101">
                  <c:v>0.10099999999999998</c:v>
                </c:pt>
                <c:pt idx="1102">
                  <c:v>0.10275000000000001</c:v>
                </c:pt>
                <c:pt idx="1103">
                  <c:v>0.10350000000000002</c:v>
                </c:pt>
                <c:pt idx="1104">
                  <c:v>0.10518333333333334</c:v>
                </c:pt>
                <c:pt idx="1105">
                  <c:v>0.10525000000000001</c:v>
                </c:pt>
                <c:pt idx="1106">
                  <c:v>0.10643333333333334</c:v>
                </c:pt>
                <c:pt idx="1107">
                  <c:v>0.10773333333333333</c:v>
                </c:pt>
                <c:pt idx="1108">
                  <c:v>0.10793333333333333</c:v>
                </c:pt>
                <c:pt idx="1109">
                  <c:v>0.11008333333333335</c:v>
                </c:pt>
                <c:pt idx="1110">
                  <c:v>0.11125</c:v>
                </c:pt>
                <c:pt idx="1111">
                  <c:v>0.11309999999999999</c:v>
                </c:pt>
                <c:pt idx="1112">
                  <c:v>0.1144</c:v>
                </c:pt>
                <c:pt idx="1113">
                  <c:v>0.11550000000000001</c:v>
                </c:pt>
                <c:pt idx="1114">
                  <c:v>0.11664999999999999</c:v>
                </c:pt>
                <c:pt idx="1115">
                  <c:v>0.11796666666666666</c:v>
                </c:pt>
                <c:pt idx="1116">
                  <c:v>0.11903333333333332</c:v>
                </c:pt>
                <c:pt idx="1117">
                  <c:v>0.12050000000000001</c:v>
                </c:pt>
                <c:pt idx="1118">
                  <c:v>0.12266666666666666</c:v>
                </c:pt>
                <c:pt idx="1119">
                  <c:v>0.12381666666666667</c:v>
                </c:pt>
                <c:pt idx="1120">
                  <c:v>0.12649999999999997</c:v>
                </c:pt>
                <c:pt idx="1121">
                  <c:v>0.12766666666666668</c:v>
                </c:pt>
                <c:pt idx="1122">
                  <c:v>0.12918333333333334</c:v>
                </c:pt>
                <c:pt idx="1123">
                  <c:v>0.13113333333333332</c:v>
                </c:pt>
                <c:pt idx="1124">
                  <c:v>0.1326</c:v>
                </c:pt>
                <c:pt idx="1125">
                  <c:v>0.13506666666666667</c:v>
                </c:pt>
                <c:pt idx="1126">
                  <c:v>0.13714999999999999</c:v>
                </c:pt>
                <c:pt idx="1127">
                  <c:v>0.13894999999999999</c:v>
                </c:pt>
                <c:pt idx="1128">
                  <c:v>0.14088333333333333</c:v>
                </c:pt>
                <c:pt idx="1129">
                  <c:v>0.14281666666666668</c:v>
                </c:pt>
                <c:pt idx="1130">
                  <c:v>0.14480000000000001</c:v>
                </c:pt>
                <c:pt idx="1131">
                  <c:v>0.14718333333333333</c:v>
                </c:pt>
                <c:pt idx="1132">
                  <c:v>0.14976666666666669</c:v>
                </c:pt>
                <c:pt idx="1133">
                  <c:v>0.15206666666666666</c:v>
                </c:pt>
                <c:pt idx="1134">
                  <c:v>0.15393333333333334</c:v>
                </c:pt>
                <c:pt idx="1135">
                  <c:v>0.15650000000000003</c:v>
                </c:pt>
                <c:pt idx="1136">
                  <c:v>0.15888333333333329</c:v>
                </c:pt>
                <c:pt idx="1137">
                  <c:v>0.16149999999999998</c:v>
                </c:pt>
                <c:pt idx="1138">
                  <c:v>0.16475000000000004</c:v>
                </c:pt>
                <c:pt idx="1139">
                  <c:v>0.16669999999999999</c:v>
                </c:pt>
                <c:pt idx="1140">
                  <c:v>0.16943333333333335</c:v>
                </c:pt>
                <c:pt idx="1141">
                  <c:v>0.17216666666666669</c:v>
                </c:pt>
                <c:pt idx="1142">
                  <c:v>0.17350000000000002</c:v>
                </c:pt>
                <c:pt idx="1143">
                  <c:v>0.17646666666666666</c:v>
                </c:pt>
                <c:pt idx="1144">
                  <c:v>0.17841666666666667</c:v>
                </c:pt>
                <c:pt idx="1145">
                  <c:v>0.18074999999999999</c:v>
                </c:pt>
                <c:pt idx="1146">
                  <c:v>0.18436666666666668</c:v>
                </c:pt>
                <c:pt idx="1147">
                  <c:v>0.18729999999999999</c:v>
                </c:pt>
                <c:pt idx="1148">
                  <c:v>0.19013333333333335</c:v>
                </c:pt>
                <c:pt idx="1149">
                  <c:v>0.19245000000000001</c:v>
                </c:pt>
                <c:pt idx="1150">
                  <c:v>0.1946</c:v>
                </c:pt>
                <c:pt idx="1151">
                  <c:v>0.19683333333333333</c:v>
                </c:pt>
                <c:pt idx="1152">
                  <c:v>0.19926666666666662</c:v>
                </c:pt>
                <c:pt idx="1153">
                  <c:v>0.20171666666666666</c:v>
                </c:pt>
                <c:pt idx="1154">
                  <c:v>0.20308333333333337</c:v>
                </c:pt>
                <c:pt idx="1155">
                  <c:v>0.20456666666666667</c:v>
                </c:pt>
                <c:pt idx="1156">
                  <c:v>0.20673333333333332</c:v>
                </c:pt>
                <c:pt idx="1157">
                  <c:v>0.20838333333333334</c:v>
                </c:pt>
                <c:pt idx="1158">
                  <c:v>0.21138333333333334</c:v>
                </c:pt>
                <c:pt idx="1159">
                  <c:v>0.21259999999999998</c:v>
                </c:pt>
                <c:pt idx="1160">
                  <c:v>0.21428333333333335</c:v>
                </c:pt>
                <c:pt idx="1161">
                  <c:v>0.21561666666666668</c:v>
                </c:pt>
                <c:pt idx="1162">
                  <c:v>0.21665000000000001</c:v>
                </c:pt>
                <c:pt idx="1163">
                  <c:v>0.21840000000000001</c:v>
                </c:pt>
                <c:pt idx="1164">
                  <c:v>0.21878333333333333</c:v>
                </c:pt>
                <c:pt idx="1165">
                  <c:v>0.21951666666666667</c:v>
                </c:pt>
                <c:pt idx="1166">
                  <c:v>0.21925000000000003</c:v>
                </c:pt>
                <c:pt idx="1167">
                  <c:v>0.21998333333333339</c:v>
                </c:pt>
                <c:pt idx="1168">
                  <c:v>0.22078333333333333</c:v>
                </c:pt>
                <c:pt idx="1169">
                  <c:v>0.22178333333333333</c:v>
                </c:pt>
                <c:pt idx="1170">
                  <c:v>0.22176666666666667</c:v>
                </c:pt>
                <c:pt idx="1171">
                  <c:v>0.22023333333333336</c:v>
                </c:pt>
                <c:pt idx="1172">
                  <c:v>0.21965000000000001</c:v>
                </c:pt>
                <c:pt idx="1173">
                  <c:v>0.21819999999999998</c:v>
                </c:pt>
                <c:pt idx="1174">
                  <c:v>0.21831666666666669</c:v>
                </c:pt>
                <c:pt idx="1175">
                  <c:v>0.21821666666666664</c:v>
                </c:pt>
                <c:pt idx="1176">
                  <c:v>0.21775000000000003</c:v>
                </c:pt>
                <c:pt idx="1177">
                  <c:v>0.21681666666666669</c:v>
                </c:pt>
                <c:pt idx="1178">
                  <c:v>0.21578333333333335</c:v>
                </c:pt>
                <c:pt idx="1179">
                  <c:v>0.21506666666666666</c:v>
                </c:pt>
                <c:pt idx="1180">
                  <c:v>0.21221666666666664</c:v>
                </c:pt>
                <c:pt idx="1181">
                  <c:v>0.21126666666666663</c:v>
                </c:pt>
                <c:pt idx="1182">
                  <c:v>0.20991666666666667</c:v>
                </c:pt>
                <c:pt idx="1183">
                  <c:v>0.20883333333333334</c:v>
                </c:pt>
                <c:pt idx="1184">
                  <c:v>0.20818333333333336</c:v>
                </c:pt>
                <c:pt idx="1185">
                  <c:v>0.20641666666666666</c:v>
                </c:pt>
                <c:pt idx="1186">
                  <c:v>0.20458333333333337</c:v>
                </c:pt>
                <c:pt idx="1187">
                  <c:v>0.20231666666666667</c:v>
                </c:pt>
                <c:pt idx="1188">
                  <c:v>0.20150000000000001</c:v>
                </c:pt>
                <c:pt idx="1189">
                  <c:v>0.20049999999999998</c:v>
                </c:pt>
                <c:pt idx="1190">
                  <c:v>0.19910000000000003</c:v>
                </c:pt>
                <c:pt idx="1191">
                  <c:v>0.19816666666666669</c:v>
                </c:pt>
                <c:pt idx="1192">
                  <c:v>0.19646666666666668</c:v>
                </c:pt>
                <c:pt idx="1193">
                  <c:v>0.19573333333333331</c:v>
                </c:pt>
                <c:pt idx="1194">
                  <c:v>0.19555</c:v>
                </c:pt>
                <c:pt idx="1195">
                  <c:v>0.19473333333333334</c:v>
                </c:pt>
                <c:pt idx="1196">
                  <c:v>0.19425000000000001</c:v>
                </c:pt>
                <c:pt idx="1197">
                  <c:v>0.19298333333333331</c:v>
                </c:pt>
                <c:pt idx="1198">
                  <c:v>0.19201666666666664</c:v>
                </c:pt>
                <c:pt idx="1199">
                  <c:v>0.19231666666666666</c:v>
                </c:pt>
                <c:pt idx="1200">
                  <c:v>0.19266666666666668</c:v>
                </c:pt>
                <c:pt idx="1201">
                  <c:v>0.19256666666666664</c:v>
                </c:pt>
                <c:pt idx="1202">
                  <c:v>0.19334999999999999</c:v>
                </c:pt>
                <c:pt idx="1203">
                  <c:v>0.19246666666666667</c:v>
                </c:pt>
                <c:pt idx="1204">
                  <c:v>0.19256666666666666</c:v>
                </c:pt>
                <c:pt idx="1205">
                  <c:v>0.19395000000000004</c:v>
                </c:pt>
                <c:pt idx="1206">
                  <c:v>0.19404999999999997</c:v>
                </c:pt>
                <c:pt idx="1207">
                  <c:v>0.19523333333333334</c:v>
                </c:pt>
                <c:pt idx="1208">
                  <c:v>0.19633333333333333</c:v>
                </c:pt>
                <c:pt idx="1209">
                  <c:v>0.19563333333333333</c:v>
                </c:pt>
                <c:pt idx="1210">
                  <c:v>0.19686666666666666</c:v>
                </c:pt>
                <c:pt idx="1211">
                  <c:v>0.19786666666666666</c:v>
                </c:pt>
                <c:pt idx="1212">
                  <c:v>0.19835</c:v>
                </c:pt>
                <c:pt idx="1213">
                  <c:v>0.20056666666666667</c:v>
                </c:pt>
                <c:pt idx="1214">
                  <c:v>0.20096666666666665</c:v>
                </c:pt>
                <c:pt idx="1215">
                  <c:v>0.20181666666666667</c:v>
                </c:pt>
                <c:pt idx="1216">
                  <c:v>0.20425000000000001</c:v>
                </c:pt>
                <c:pt idx="1217">
                  <c:v>0.20538333333333333</c:v>
                </c:pt>
                <c:pt idx="1218">
                  <c:v>0.20741666666666669</c:v>
                </c:pt>
                <c:pt idx="1219">
                  <c:v>0.20879999999999999</c:v>
                </c:pt>
                <c:pt idx="1220">
                  <c:v>0.20884999999999998</c:v>
                </c:pt>
                <c:pt idx="1221">
                  <c:v>0.21013333333333331</c:v>
                </c:pt>
                <c:pt idx="1222">
                  <c:v>0.21094999999999997</c:v>
                </c:pt>
                <c:pt idx="1223">
                  <c:v>0.2121666666666667</c:v>
                </c:pt>
                <c:pt idx="1224">
                  <c:v>0.21341666666666667</c:v>
                </c:pt>
                <c:pt idx="1225">
                  <c:v>0.21436666666666668</c:v>
                </c:pt>
                <c:pt idx="1226">
                  <c:v>0.21546666666666667</c:v>
                </c:pt>
                <c:pt idx="1227">
                  <c:v>0.21691666666666665</c:v>
                </c:pt>
                <c:pt idx="1228">
                  <c:v>0.21779999999999999</c:v>
                </c:pt>
                <c:pt idx="1229">
                  <c:v>0.21860000000000002</c:v>
                </c:pt>
                <c:pt idx="1230">
                  <c:v>0.21895000000000001</c:v>
                </c:pt>
                <c:pt idx="1231">
                  <c:v>0.21988333333333335</c:v>
                </c:pt>
                <c:pt idx="1232">
                  <c:v>0.22128333333333336</c:v>
                </c:pt>
                <c:pt idx="1233">
                  <c:v>0.22260000000000002</c:v>
                </c:pt>
                <c:pt idx="1234">
                  <c:v>0.22394999999999995</c:v>
                </c:pt>
                <c:pt idx="1235">
                  <c:v>0.22411666666666666</c:v>
                </c:pt>
                <c:pt idx="1236">
                  <c:v>0.22450000000000001</c:v>
                </c:pt>
                <c:pt idx="1237">
                  <c:v>0.22455000000000003</c:v>
                </c:pt>
                <c:pt idx="1238">
                  <c:v>0.22445000000000004</c:v>
                </c:pt>
                <c:pt idx="1239">
                  <c:v>0.22484999999999999</c:v>
                </c:pt>
                <c:pt idx="1240">
                  <c:v>0.22478333333333333</c:v>
                </c:pt>
                <c:pt idx="1241">
                  <c:v>0.22499999999999998</c:v>
                </c:pt>
                <c:pt idx="1242">
                  <c:v>0.22559999999999999</c:v>
                </c:pt>
                <c:pt idx="1243">
                  <c:v>0.22559999999999994</c:v>
                </c:pt>
                <c:pt idx="1244">
                  <c:v>0.22620000000000004</c:v>
                </c:pt>
                <c:pt idx="1245">
                  <c:v>0.22614999999999999</c:v>
                </c:pt>
                <c:pt idx="1246">
                  <c:v>0.2261</c:v>
                </c:pt>
                <c:pt idx="1247">
                  <c:v>0.22664999999999999</c:v>
                </c:pt>
                <c:pt idx="1248">
                  <c:v>0.22623333333333337</c:v>
                </c:pt>
                <c:pt idx="1249">
                  <c:v>0.22670000000000001</c:v>
                </c:pt>
                <c:pt idx="1250">
                  <c:v>0.22741666666666668</c:v>
                </c:pt>
                <c:pt idx="1251">
                  <c:v>0.22819999999999999</c:v>
                </c:pt>
                <c:pt idx="1252">
                  <c:v>0.22918333333333332</c:v>
                </c:pt>
                <c:pt idx="1253">
                  <c:v>0.22963333333333333</c:v>
                </c:pt>
              </c:numCache>
            </c:numRef>
          </c:yVal>
          <c:smooth val="1"/>
          <c:extLst>
            <c:ext xmlns:c16="http://schemas.microsoft.com/office/drawing/2014/chart" uri="{C3380CC4-5D6E-409C-BE32-E72D297353CC}">
              <c16:uniqueId val="{00000003-AA13-49CE-A792-B5AEE7BA5538}"/>
            </c:ext>
          </c:extLst>
        </c:ser>
        <c:ser>
          <c:idx val="7"/>
          <c:order val="4"/>
          <c:tx>
            <c:strRef>
              <c:f>Hoja1!$CA$1</c:f>
              <c:strCache>
                <c:ptCount val="1"/>
                <c:pt idx="0">
                  <c:v>8d</c:v>
                </c:pt>
              </c:strCache>
            </c:strRef>
          </c:tx>
          <c:spPr>
            <a:ln>
              <a:solidFill>
                <a:srgbClr val="00B050"/>
              </a:solidFill>
              <a:prstDash val="sysDot"/>
            </a:ln>
          </c:spPr>
          <c:marker>
            <c:symbol val="none"/>
          </c:marker>
          <c:xVal>
            <c:numRef>
              <c:f>Hoja1!$BS$2:$BS$1255</c:f>
              <c:numCache>
                <c:formatCode>General</c:formatCode>
                <c:ptCount val="1254"/>
                <c:pt idx="2" formatCode="h:mm">
                  <c:v>0.68125000000000002</c:v>
                </c:pt>
                <c:pt idx="3">
                  <c:v>550</c:v>
                </c:pt>
                <c:pt idx="4">
                  <c:v>549.79999999999995</c:v>
                </c:pt>
                <c:pt idx="5">
                  <c:v>549.6</c:v>
                </c:pt>
                <c:pt idx="6">
                  <c:v>549.4</c:v>
                </c:pt>
                <c:pt idx="7">
                  <c:v>549.20000000000005</c:v>
                </c:pt>
                <c:pt idx="8">
                  <c:v>549</c:v>
                </c:pt>
                <c:pt idx="9">
                  <c:v>548.79999999999995</c:v>
                </c:pt>
                <c:pt idx="10">
                  <c:v>548.6</c:v>
                </c:pt>
                <c:pt idx="11">
                  <c:v>548.4</c:v>
                </c:pt>
                <c:pt idx="12">
                  <c:v>548.20000000000005</c:v>
                </c:pt>
                <c:pt idx="13">
                  <c:v>548</c:v>
                </c:pt>
                <c:pt idx="14">
                  <c:v>547.79999999999995</c:v>
                </c:pt>
                <c:pt idx="15">
                  <c:v>547.6</c:v>
                </c:pt>
                <c:pt idx="16">
                  <c:v>547.4</c:v>
                </c:pt>
                <c:pt idx="17">
                  <c:v>547.20000000000005</c:v>
                </c:pt>
                <c:pt idx="18">
                  <c:v>547</c:v>
                </c:pt>
                <c:pt idx="19">
                  <c:v>546.79999999999995</c:v>
                </c:pt>
                <c:pt idx="20">
                  <c:v>546.6</c:v>
                </c:pt>
                <c:pt idx="21">
                  <c:v>546.4</c:v>
                </c:pt>
                <c:pt idx="22">
                  <c:v>546.20000000000005</c:v>
                </c:pt>
                <c:pt idx="23">
                  <c:v>546</c:v>
                </c:pt>
                <c:pt idx="24">
                  <c:v>545.79999999999995</c:v>
                </c:pt>
                <c:pt idx="25">
                  <c:v>545.6</c:v>
                </c:pt>
                <c:pt idx="26">
                  <c:v>545.4</c:v>
                </c:pt>
                <c:pt idx="27">
                  <c:v>545.20000000000005</c:v>
                </c:pt>
                <c:pt idx="28">
                  <c:v>545</c:v>
                </c:pt>
                <c:pt idx="29">
                  <c:v>544.79999999999995</c:v>
                </c:pt>
                <c:pt idx="30">
                  <c:v>544.6</c:v>
                </c:pt>
                <c:pt idx="31">
                  <c:v>544.4</c:v>
                </c:pt>
                <c:pt idx="32">
                  <c:v>544.20000000000005</c:v>
                </c:pt>
                <c:pt idx="33">
                  <c:v>544</c:v>
                </c:pt>
                <c:pt idx="34">
                  <c:v>543.79999999999995</c:v>
                </c:pt>
                <c:pt idx="35">
                  <c:v>543.6</c:v>
                </c:pt>
                <c:pt idx="36">
                  <c:v>543.4</c:v>
                </c:pt>
                <c:pt idx="37">
                  <c:v>543.20000000000005</c:v>
                </c:pt>
                <c:pt idx="38">
                  <c:v>543</c:v>
                </c:pt>
                <c:pt idx="39">
                  <c:v>542.79999999999995</c:v>
                </c:pt>
                <c:pt idx="40">
                  <c:v>542.6</c:v>
                </c:pt>
                <c:pt idx="41">
                  <c:v>542.4</c:v>
                </c:pt>
                <c:pt idx="42">
                  <c:v>542.20000000000005</c:v>
                </c:pt>
                <c:pt idx="43">
                  <c:v>542</c:v>
                </c:pt>
                <c:pt idx="44">
                  <c:v>541.79999999999995</c:v>
                </c:pt>
                <c:pt idx="45">
                  <c:v>541.6</c:v>
                </c:pt>
                <c:pt idx="46">
                  <c:v>541.4</c:v>
                </c:pt>
                <c:pt idx="47">
                  <c:v>541.20000000000005</c:v>
                </c:pt>
                <c:pt idx="48">
                  <c:v>541</c:v>
                </c:pt>
                <c:pt idx="49">
                  <c:v>540.79999999999995</c:v>
                </c:pt>
                <c:pt idx="50">
                  <c:v>540.6</c:v>
                </c:pt>
                <c:pt idx="51">
                  <c:v>540.4</c:v>
                </c:pt>
                <c:pt idx="52">
                  <c:v>540.20000000000005</c:v>
                </c:pt>
                <c:pt idx="53">
                  <c:v>540</c:v>
                </c:pt>
                <c:pt idx="54">
                  <c:v>539.79999999999995</c:v>
                </c:pt>
                <c:pt idx="55">
                  <c:v>539.6</c:v>
                </c:pt>
                <c:pt idx="56">
                  <c:v>539.4</c:v>
                </c:pt>
                <c:pt idx="57">
                  <c:v>539.20000000000005</c:v>
                </c:pt>
                <c:pt idx="58">
                  <c:v>539</c:v>
                </c:pt>
                <c:pt idx="59">
                  <c:v>538.79999999999995</c:v>
                </c:pt>
                <c:pt idx="60">
                  <c:v>538.6</c:v>
                </c:pt>
                <c:pt idx="61">
                  <c:v>538.4</c:v>
                </c:pt>
                <c:pt idx="62">
                  <c:v>538.20000000000005</c:v>
                </c:pt>
                <c:pt idx="63">
                  <c:v>538</c:v>
                </c:pt>
                <c:pt idx="64">
                  <c:v>537.79999999999995</c:v>
                </c:pt>
                <c:pt idx="65">
                  <c:v>537.6</c:v>
                </c:pt>
                <c:pt idx="66">
                  <c:v>537.4</c:v>
                </c:pt>
                <c:pt idx="67">
                  <c:v>537.20000000000005</c:v>
                </c:pt>
                <c:pt idx="68">
                  <c:v>537</c:v>
                </c:pt>
                <c:pt idx="69">
                  <c:v>536.79999999999995</c:v>
                </c:pt>
                <c:pt idx="70">
                  <c:v>536.6</c:v>
                </c:pt>
                <c:pt idx="71">
                  <c:v>536.4</c:v>
                </c:pt>
                <c:pt idx="72">
                  <c:v>536.20000000000005</c:v>
                </c:pt>
                <c:pt idx="73">
                  <c:v>536</c:v>
                </c:pt>
                <c:pt idx="74">
                  <c:v>535.79999999999995</c:v>
                </c:pt>
                <c:pt idx="75">
                  <c:v>535.6</c:v>
                </c:pt>
                <c:pt idx="76">
                  <c:v>535.4</c:v>
                </c:pt>
                <c:pt idx="77">
                  <c:v>535.20000000000005</c:v>
                </c:pt>
                <c:pt idx="78">
                  <c:v>535</c:v>
                </c:pt>
                <c:pt idx="79">
                  <c:v>534.79999999999995</c:v>
                </c:pt>
                <c:pt idx="80">
                  <c:v>534.6</c:v>
                </c:pt>
                <c:pt idx="81">
                  <c:v>534.4</c:v>
                </c:pt>
                <c:pt idx="82">
                  <c:v>534.20000000000005</c:v>
                </c:pt>
                <c:pt idx="83">
                  <c:v>534</c:v>
                </c:pt>
                <c:pt idx="84">
                  <c:v>533.79999999999995</c:v>
                </c:pt>
                <c:pt idx="85">
                  <c:v>533.6</c:v>
                </c:pt>
                <c:pt idx="86">
                  <c:v>533.4</c:v>
                </c:pt>
                <c:pt idx="87">
                  <c:v>533.20000000000005</c:v>
                </c:pt>
                <c:pt idx="88">
                  <c:v>533</c:v>
                </c:pt>
                <c:pt idx="89">
                  <c:v>532.79999999999995</c:v>
                </c:pt>
                <c:pt idx="90">
                  <c:v>532.6</c:v>
                </c:pt>
                <c:pt idx="91">
                  <c:v>532.4</c:v>
                </c:pt>
                <c:pt idx="92">
                  <c:v>532.20000000000005</c:v>
                </c:pt>
                <c:pt idx="93">
                  <c:v>532</c:v>
                </c:pt>
                <c:pt idx="94">
                  <c:v>531.79999999999995</c:v>
                </c:pt>
                <c:pt idx="95">
                  <c:v>531.6</c:v>
                </c:pt>
                <c:pt idx="96">
                  <c:v>531.4</c:v>
                </c:pt>
                <c:pt idx="97">
                  <c:v>531.20000000000005</c:v>
                </c:pt>
                <c:pt idx="98">
                  <c:v>531</c:v>
                </c:pt>
                <c:pt idx="99">
                  <c:v>530.79999999999995</c:v>
                </c:pt>
                <c:pt idx="100">
                  <c:v>530.6</c:v>
                </c:pt>
                <c:pt idx="101">
                  <c:v>530.4</c:v>
                </c:pt>
                <c:pt idx="102">
                  <c:v>530.20000000000005</c:v>
                </c:pt>
                <c:pt idx="103">
                  <c:v>530</c:v>
                </c:pt>
                <c:pt idx="104">
                  <c:v>529.79999999999995</c:v>
                </c:pt>
                <c:pt idx="105">
                  <c:v>529.6</c:v>
                </c:pt>
                <c:pt idx="106">
                  <c:v>529.4</c:v>
                </c:pt>
                <c:pt idx="107">
                  <c:v>529.20000000000005</c:v>
                </c:pt>
                <c:pt idx="108">
                  <c:v>529</c:v>
                </c:pt>
                <c:pt idx="109">
                  <c:v>528.79999999999995</c:v>
                </c:pt>
                <c:pt idx="110">
                  <c:v>528.6</c:v>
                </c:pt>
                <c:pt idx="111">
                  <c:v>528.4</c:v>
                </c:pt>
                <c:pt idx="112">
                  <c:v>528.20000000000005</c:v>
                </c:pt>
                <c:pt idx="113">
                  <c:v>528</c:v>
                </c:pt>
                <c:pt idx="114">
                  <c:v>527.79999999999995</c:v>
                </c:pt>
                <c:pt idx="115">
                  <c:v>527.6</c:v>
                </c:pt>
                <c:pt idx="116">
                  <c:v>527.4</c:v>
                </c:pt>
                <c:pt idx="117">
                  <c:v>527.20000000000005</c:v>
                </c:pt>
                <c:pt idx="118">
                  <c:v>527</c:v>
                </c:pt>
                <c:pt idx="119">
                  <c:v>526.79999999999995</c:v>
                </c:pt>
                <c:pt idx="120">
                  <c:v>526.6</c:v>
                </c:pt>
                <c:pt idx="121">
                  <c:v>526.4</c:v>
                </c:pt>
                <c:pt idx="122">
                  <c:v>526.20000000000005</c:v>
                </c:pt>
                <c:pt idx="123">
                  <c:v>526</c:v>
                </c:pt>
                <c:pt idx="124">
                  <c:v>525.79999999999995</c:v>
                </c:pt>
                <c:pt idx="125">
                  <c:v>525.6</c:v>
                </c:pt>
                <c:pt idx="126">
                  <c:v>525.4</c:v>
                </c:pt>
                <c:pt idx="127">
                  <c:v>525.20000000000005</c:v>
                </c:pt>
                <c:pt idx="128">
                  <c:v>525</c:v>
                </c:pt>
                <c:pt idx="129">
                  <c:v>524.79999999999995</c:v>
                </c:pt>
                <c:pt idx="130">
                  <c:v>524.6</c:v>
                </c:pt>
                <c:pt idx="131">
                  <c:v>524.4</c:v>
                </c:pt>
                <c:pt idx="132">
                  <c:v>524.20000000000005</c:v>
                </c:pt>
                <c:pt idx="133">
                  <c:v>524</c:v>
                </c:pt>
                <c:pt idx="134">
                  <c:v>523.79999999999995</c:v>
                </c:pt>
                <c:pt idx="135">
                  <c:v>523.6</c:v>
                </c:pt>
                <c:pt idx="136">
                  <c:v>523.4</c:v>
                </c:pt>
                <c:pt idx="137">
                  <c:v>523.20000000000005</c:v>
                </c:pt>
                <c:pt idx="138">
                  <c:v>523</c:v>
                </c:pt>
                <c:pt idx="139">
                  <c:v>522.79999999999995</c:v>
                </c:pt>
                <c:pt idx="140">
                  <c:v>522.6</c:v>
                </c:pt>
                <c:pt idx="141">
                  <c:v>522.4</c:v>
                </c:pt>
                <c:pt idx="142">
                  <c:v>522.20000000000005</c:v>
                </c:pt>
                <c:pt idx="143">
                  <c:v>522</c:v>
                </c:pt>
                <c:pt idx="144">
                  <c:v>521.79999999999995</c:v>
                </c:pt>
                <c:pt idx="145">
                  <c:v>521.6</c:v>
                </c:pt>
                <c:pt idx="146">
                  <c:v>521.4</c:v>
                </c:pt>
                <c:pt idx="147">
                  <c:v>521.20000000000005</c:v>
                </c:pt>
                <c:pt idx="148">
                  <c:v>521</c:v>
                </c:pt>
                <c:pt idx="149">
                  <c:v>520.79999999999995</c:v>
                </c:pt>
                <c:pt idx="150">
                  <c:v>520.6</c:v>
                </c:pt>
                <c:pt idx="151">
                  <c:v>520.4</c:v>
                </c:pt>
                <c:pt idx="152">
                  <c:v>520.20000000000005</c:v>
                </c:pt>
                <c:pt idx="153">
                  <c:v>520</c:v>
                </c:pt>
                <c:pt idx="154">
                  <c:v>519.79999999999995</c:v>
                </c:pt>
                <c:pt idx="155">
                  <c:v>519.6</c:v>
                </c:pt>
                <c:pt idx="156">
                  <c:v>519.4</c:v>
                </c:pt>
                <c:pt idx="157">
                  <c:v>519.20000000000005</c:v>
                </c:pt>
                <c:pt idx="158">
                  <c:v>519</c:v>
                </c:pt>
                <c:pt idx="159">
                  <c:v>518.79999999999995</c:v>
                </c:pt>
                <c:pt idx="160">
                  <c:v>518.6</c:v>
                </c:pt>
                <c:pt idx="161">
                  <c:v>518.4</c:v>
                </c:pt>
                <c:pt idx="162">
                  <c:v>518.20000000000005</c:v>
                </c:pt>
                <c:pt idx="163">
                  <c:v>518</c:v>
                </c:pt>
                <c:pt idx="164">
                  <c:v>517.79999999999995</c:v>
                </c:pt>
                <c:pt idx="165">
                  <c:v>517.6</c:v>
                </c:pt>
                <c:pt idx="166">
                  <c:v>517.4</c:v>
                </c:pt>
                <c:pt idx="167">
                  <c:v>517.20000000000005</c:v>
                </c:pt>
                <c:pt idx="168">
                  <c:v>517</c:v>
                </c:pt>
                <c:pt idx="169">
                  <c:v>516.79999999999995</c:v>
                </c:pt>
                <c:pt idx="170">
                  <c:v>516.6</c:v>
                </c:pt>
                <c:pt idx="171">
                  <c:v>516.4</c:v>
                </c:pt>
                <c:pt idx="172">
                  <c:v>516.20000000000005</c:v>
                </c:pt>
                <c:pt idx="173">
                  <c:v>516</c:v>
                </c:pt>
                <c:pt idx="174">
                  <c:v>515.79999999999995</c:v>
                </c:pt>
                <c:pt idx="175">
                  <c:v>515.6</c:v>
                </c:pt>
                <c:pt idx="176">
                  <c:v>515.4</c:v>
                </c:pt>
                <c:pt idx="177">
                  <c:v>515.20000000000005</c:v>
                </c:pt>
                <c:pt idx="178">
                  <c:v>515</c:v>
                </c:pt>
                <c:pt idx="179">
                  <c:v>514.79999999999995</c:v>
                </c:pt>
                <c:pt idx="180">
                  <c:v>514.6</c:v>
                </c:pt>
                <c:pt idx="181">
                  <c:v>514.4</c:v>
                </c:pt>
                <c:pt idx="182">
                  <c:v>514.20000000000005</c:v>
                </c:pt>
                <c:pt idx="183">
                  <c:v>514</c:v>
                </c:pt>
                <c:pt idx="184">
                  <c:v>513.79999999999995</c:v>
                </c:pt>
                <c:pt idx="185">
                  <c:v>513.6</c:v>
                </c:pt>
                <c:pt idx="186">
                  <c:v>513.4</c:v>
                </c:pt>
                <c:pt idx="187">
                  <c:v>513.20000000000005</c:v>
                </c:pt>
                <c:pt idx="188">
                  <c:v>513</c:v>
                </c:pt>
                <c:pt idx="189">
                  <c:v>512.79999999999995</c:v>
                </c:pt>
                <c:pt idx="190">
                  <c:v>512.6</c:v>
                </c:pt>
                <c:pt idx="191">
                  <c:v>512.4</c:v>
                </c:pt>
                <c:pt idx="192">
                  <c:v>512.20000000000005</c:v>
                </c:pt>
                <c:pt idx="193">
                  <c:v>512</c:v>
                </c:pt>
                <c:pt idx="194">
                  <c:v>511.8</c:v>
                </c:pt>
                <c:pt idx="195">
                  <c:v>511.6</c:v>
                </c:pt>
                <c:pt idx="196">
                  <c:v>511.4</c:v>
                </c:pt>
                <c:pt idx="197">
                  <c:v>511.2</c:v>
                </c:pt>
                <c:pt idx="198">
                  <c:v>511</c:v>
                </c:pt>
                <c:pt idx="199">
                  <c:v>510.8</c:v>
                </c:pt>
                <c:pt idx="200">
                  <c:v>510.6</c:v>
                </c:pt>
                <c:pt idx="201">
                  <c:v>510.4</c:v>
                </c:pt>
                <c:pt idx="202">
                  <c:v>510.2</c:v>
                </c:pt>
                <c:pt idx="203">
                  <c:v>510</c:v>
                </c:pt>
                <c:pt idx="204">
                  <c:v>509.8</c:v>
                </c:pt>
                <c:pt idx="205">
                  <c:v>509.6</c:v>
                </c:pt>
                <c:pt idx="206">
                  <c:v>509.4</c:v>
                </c:pt>
                <c:pt idx="207">
                  <c:v>509.2</c:v>
                </c:pt>
                <c:pt idx="208">
                  <c:v>509</c:v>
                </c:pt>
                <c:pt idx="209">
                  <c:v>508.8</c:v>
                </c:pt>
                <c:pt idx="210">
                  <c:v>508.6</c:v>
                </c:pt>
                <c:pt idx="211">
                  <c:v>508.4</c:v>
                </c:pt>
                <c:pt idx="212">
                  <c:v>508.2</c:v>
                </c:pt>
                <c:pt idx="213">
                  <c:v>508</c:v>
                </c:pt>
                <c:pt idx="214">
                  <c:v>507.8</c:v>
                </c:pt>
                <c:pt idx="215">
                  <c:v>507.6</c:v>
                </c:pt>
                <c:pt idx="216">
                  <c:v>507.4</c:v>
                </c:pt>
                <c:pt idx="217">
                  <c:v>507.2</c:v>
                </c:pt>
                <c:pt idx="218">
                  <c:v>507</c:v>
                </c:pt>
                <c:pt idx="219">
                  <c:v>506.8</c:v>
                </c:pt>
                <c:pt idx="220">
                  <c:v>506.6</c:v>
                </c:pt>
                <c:pt idx="221">
                  <c:v>506.4</c:v>
                </c:pt>
                <c:pt idx="222">
                  <c:v>506.2</c:v>
                </c:pt>
                <c:pt idx="223">
                  <c:v>506</c:v>
                </c:pt>
                <c:pt idx="224">
                  <c:v>505.8</c:v>
                </c:pt>
                <c:pt idx="225">
                  <c:v>505.6</c:v>
                </c:pt>
                <c:pt idx="226">
                  <c:v>505.4</c:v>
                </c:pt>
                <c:pt idx="227">
                  <c:v>505.2</c:v>
                </c:pt>
                <c:pt idx="228">
                  <c:v>505</c:v>
                </c:pt>
                <c:pt idx="229">
                  <c:v>504.8</c:v>
                </c:pt>
                <c:pt idx="230">
                  <c:v>504.6</c:v>
                </c:pt>
                <c:pt idx="231">
                  <c:v>504.4</c:v>
                </c:pt>
                <c:pt idx="232">
                  <c:v>504.2</c:v>
                </c:pt>
                <c:pt idx="233">
                  <c:v>504</c:v>
                </c:pt>
                <c:pt idx="234">
                  <c:v>503.8</c:v>
                </c:pt>
                <c:pt idx="235">
                  <c:v>503.6</c:v>
                </c:pt>
                <c:pt idx="236">
                  <c:v>503.4</c:v>
                </c:pt>
                <c:pt idx="237">
                  <c:v>503.2</c:v>
                </c:pt>
                <c:pt idx="238">
                  <c:v>503</c:v>
                </c:pt>
                <c:pt idx="239">
                  <c:v>502.8</c:v>
                </c:pt>
                <c:pt idx="240">
                  <c:v>502.6</c:v>
                </c:pt>
                <c:pt idx="241">
                  <c:v>502.4</c:v>
                </c:pt>
                <c:pt idx="242">
                  <c:v>502.2</c:v>
                </c:pt>
                <c:pt idx="243">
                  <c:v>502</c:v>
                </c:pt>
                <c:pt idx="244">
                  <c:v>501.8</c:v>
                </c:pt>
                <c:pt idx="245">
                  <c:v>501.6</c:v>
                </c:pt>
                <c:pt idx="246">
                  <c:v>501.4</c:v>
                </c:pt>
                <c:pt idx="247">
                  <c:v>501.2</c:v>
                </c:pt>
                <c:pt idx="248">
                  <c:v>501</c:v>
                </c:pt>
                <c:pt idx="249">
                  <c:v>500.8</c:v>
                </c:pt>
                <c:pt idx="250">
                  <c:v>500.6</c:v>
                </c:pt>
                <c:pt idx="251">
                  <c:v>500.4</c:v>
                </c:pt>
                <c:pt idx="252">
                  <c:v>500.2</c:v>
                </c:pt>
                <c:pt idx="253">
                  <c:v>500</c:v>
                </c:pt>
                <c:pt idx="254">
                  <c:v>499.8</c:v>
                </c:pt>
                <c:pt idx="255">
                  <c:v>499.6</c:v>
                </c:pt>
                <c:pt idx="256">
                  <c:v>499.4</c:v>
                </c:pt>
                <c:pt idx="257">
                  <c:v>499.2</c:v>
                </c:pt>
                <c:pt idx="258">
                  <c:v>499</c:v>
                </c:pt>
                <c:pt idx="259">
                  <c:v>498.8</c:v>
                </c:pt>
                <c:pt idx="260">
                  <c:v>498.6</c:v>
                </c:pt>
                <c:pt idx="261">
                  <c:v>498.4</c:v>
                </c:pt>
                <c:pt idx="262">
                  <c:v>498.2</c:v>
                </c:pt>
                <c:pt idx="263">
                  <c:v>498</c:v>
                </c:pt>
                <c:pt idx="264">
                  <c:v>497.8</c:v>
                </c:pt>
                <c:pt idx="265">
                  <c:v>497.6</c:v>
                </c:pt>
                <c:pt idx="266">
                  <c:v>497.4</c:v>
                </c:pt>
                <c:pt idx="267">
                  <c:v>497.2</c:v>
                </c:pt>
                <c:pt idx="268">
                  <c:v>497</c:v>
                </c:pt>
                <c:pt idx="269">
                  <c:v>496.8</c:v>
                </c:pt>
                <c:pt idx="270">
                  <c:v>496.6</c:v>
                </c:pt>
                <c:pt idx="271">
                  <c:v>496.4</c:v>
                </c:pt>
                <c:pt idx="272">
                  <c:v>496.2</c:v>
                </c:pt>
                <c:pt idx="273">
                  <c:v>496</c:v>
                </c:pt>
                <c:pt idx="274">
                  <c:v>495.8</c:v>
                </c:pt>
                <c:pt idx="275">
                  <c:v>495.6</c:v>
                </c:pt>
                <c:pt idx="276">
                  <c:v>495.4</c:v>
                </c:pt>
                <c:pt idx="277">
                  <c:v>495.2</c:v>
                </c:pt>
                <c:pt idx="278">
                  <c:v>495</c:v>
                </c:pt>
                <c:pt idx="279">
                  <c:v>494.8</c:v>
                </c:pt>
                <c:pt idx="280">
                  <c:v>494.6</c:v>
                </c:pt>
                <c:pt idx="281">
                  <c:v>494.4</c:v>
                </c:pt>
                <c:pt idx="282">
                  <c:v>494.2</c:v>
                </c:pt>
                <c:pt idx="283">
                  <c:v>494</c:v>
                </c:pt>
                <c:pt idx="284">
                  <c:v>493.8</c:v>
                </c:pt>
                <c:pt idx="285">
                  <c:v>493.6</c:v>
                </c:pt>
                <c:pt idx="286">
                  <c:v>493.4</c:v>
                </c:pt>
                <c:pt idx="287">
                  <c:v>493.2</c:v>
                </c:pt>
                <c:pt idx="288">
                  <c:v>493</c:v>
                </c:pt>
                <c:pt idx="289">
                  <c:v>492.8</c:v>
                </c:pt>
                <c:pt idx="290">
                  <c:v>492.6</c:v>
                </c:pt>
                <c:pt idx="291">
                  <c:v>492.4</c:v>
                </c:pt>
                <c:pt idx="292">
                  <c:v>492.2</c:v>
                </c:pt>
                <c:pt idx="293">
                  <c:v>492</c:v>
                </c:pt>
                <c:pt idx="294">
                  <c:v>491.8</c:v>
                </c:pt>
                <c:pt idx="295">
                  <c:v>491.6</c:v>
                </c:pt>
                <c:pt idx="296">
                  <c:v>491.4</c:v>
                </c:pt>
                <c:pt idx="297">
                  <c:v>491.2</c:v>
                </c:pt>
                <c:pt idx="298">
                  <c:v>491</c:v>
                </c:pt>
                <c:pt idx="299">
                  <c:v>490.8</c:v>
                </c:pt>
                <c:pt idx="300">
                  <c:v>490.6</c:v>
                </c:pt>
                <c:pt idx="301">
                  <c:v>490.4</c:v>
                </c:pt>
                <c:pt idx="302">
                  <c:v>490.2</c:v>
                </c:pt>
                <c:pt idx="303">
                  <c:v>490</c:v>
                </c:pt>
                <c:pt idx="304">
                  <c:v>489.8</c:v>
                </c:pt>
                <c:pt idx="305">
                  <c:v>489.6</c:v>
                </c:pt>
                <c:pt idx="306">
                  <c:v>489.4</c:v>
                </c:pt>
                <c:pt idx="307">
                  <c:v>489.2</c:v>
                </c:pt>
                <c:pt idx="308">
                  <c:v>489</c:v>
                </c:pt>
                <c:pt idx="309">
                  <c:v>488.8</c:v>
                </c:pt>
                <c:pt idx="310">
                  <c:v>488.6</c:v>
                </c:pt>
                <c:pt idx="311">
                  <c:v>488.4</c:v>
                </c:pt>
                <c:pt idx="312">
                  <c:v>488.2</c:v>
                </c:pt>
                <c:pt idx="313">
                  <c:v>488</c:v>
                </c:pt>
                <c:pt idx="314">
                  <c:v>487.8</c:v>
                </c:pt>
                <c:pt idx="315">
                  <c:v>487.6</c:v>
                </c:pt>
                <c:pt idx="316">
                  <c:v>487.4</c:v>
                </c:pt>
                <c:pt idx="317">
                  <c:v>487.2</c:v>
                </c:pt>
                <c:pt idx="318">
                  <c:v>487</c:v>
                </c:pt>
                <c:pt idx="319">
                  <c:v>486.8</c:v>
                </c:pt>
                <c:pt idx="320">
                  <c:v>486.6</c:v>
                </c:pt>
                <c:pt idx="321">
                  <c:v>486.4</c:v>
                </c:pt>
                <c:pt idx="322">
                  <c:v>486.2</c:v>
                </c:pt>
                <c:pt idx="323">
                  <c:v>486</c:v>
                </c:pt>
                <c:pt idx="324">
                  <c:v>485.8</c:v>
                </c:pt>
                <c:pt idx="325">
                  <c:v>485.6</c:v>
                </c:pt>
                <c:pt idx="326">
                  <c:v>485.4</c:v>
                </c:pt>
                <c:pt idx="327">
                  <c:v>485.2</c:v>
                </c:pt>
                <c:pt idx="328">
                  <c:v>485</c:v>
                </c:pt>
                <c:pt idx="329">
                  <c:v>484.8</c:v>
                </c:pt>
                <c:pt idx="330">
                  <c:v>484.6</c:v>
                </c:pt>
                <c:pt idx="331">
                  <c:v>484.4</c:v>
                </c:pt>
                <c:pt idx="332">
                  <c:v>484.2</c:v>
                </c:pt>
                <c:pt idx="333">
                  <c:v>484</c:v>
                </c:pt>
                <c:pt idx="334">
                  <c:v>483.8</c:v>
                </c:pt>
                <c:pt idx="335">
                  <c:v>483.6</c:v>
                </c:pt>
                <c:pt idx="336">
                  <c:v>483.4</c:v>
                </c:pt>
                <c:pt idx="337">
                  <c:v>483.2</c:v>
                </c:pt>
                <c:pt idx="338">
                  <c:v>483</c:v>
                </c:pt>
                <c:pt idx="339">
                  <c:v>482.8</c:v>
                </c:pt>
                <c:pt idx="340">
                  <c:v>482.6</c:v>
                </c:pt>
                <c:pt idx="341">
                  <c:v>482.4</c:v>
                </c:pt>
                <c:pt idx="342">
                  <c:v>482.2</c:v>
                </c:pt>
                <c:pt idx="343">
                  <c:v>482</c:v>
                </c:pt>
                <c:pt idx="344">
                  <c:v>481.8</c:v>
                </c:pt>
                <c:pt idx="345">
                  <c:v>481.6</c:v>
                </c:pt>
                <c:pt idx="346">
                  <c:v>481.4</c:v>
                </c:pt>
                <c:pt idx="347">
                  <c:v>481.2</c:v>
                </c:pt>
                <c:pt idx="348">
                  <c:v>481</c:v>
                </c:pt>
                <c:pt idx="349">
                  <c:v>480.8</c:v>
                </c:pt>
                <c:pt idx="350">
                  <c:v>480.6</c:v>
                </c:pt>
                <c:pt idx="351">
                  <c:v>480.4</c:v>
                </c:pt>
                <c:pt idx="352">
                  <c:v>480.2</c:v>
                </c:pt>
                <c:pt idx="353">
                  <c:v>480</c:v>
                </c:pt>
                <c:pt idx="354">
                  <c:v>479.8</c:v>
                </c:pt>
                <c:pt idx="355">
                  <c:v>479.6</c:v>
                </c:pt>
                <c:pt idx="356">
                  <c:v>479.4</c:v>
                </c:pt>
                <c:pt idx="357">
                  <c:v>479.2</c:v>
                </c:pt>
                <c:pt idx="358">
                  <c:v>479</c:v>
                </c:pt>
                <c:pt idx="359">
                  <c:v>478.8</c:v>
                </c:pt>
                <c:pt idx="360">
                  <c:v>478.6</c:v>
                </c:pt>
                <c:pt idx="361">
                  <c:v>478.4</c:v>
                </c:pt>
                <c:pt idx="362">
                  <c:v>478.2</c:v>
                </c:pt>
                <c:pt idx="363">
                  <c:v>478</c:v>
                </c:pt>
                <c:pt idx="364">
                  <c:v>477.8</c:v>
                </c:pt>
                <c:pt idx="365">
                  <c:v>477.6</c:v>
                </c:pt>
                <c:pt idx="366">
                  <c:v>477.4</c:v>
                </c:pt>
                <c:pt idx="367">
                  <c:v>477.2</c:v>
                </c:pt>
                <c:pt idx="368">
                  <c:v>477</c:v>
                </c:pt>
                <c:pt idx="369">
                  <c:v>476.8</c:v>
                </c:pt>
                <c:pt idx="370">
                  <c:v>476.6</c:v>
                </c:pt>
                <c:pt idx="371">
                  <c:v>476.4</c:v>
                </c:pt>
                <c:pt idx="372">
                  <c:v>476.2</c:v>
                </c:pt>
                <c:pt idx="373">
                  <c:v>476</c:v>
                </c:pt>
                <c:pt idx="374">
                  <c:v>475.8</c:v>
                </c:pt>
                <c:pt idx="375">
                  <c:v>475.6</c:v>
                </c:pt>
                <c:pt idx="376">
                  <c:v>475.4</c:v>
                </c:pt>
                <c:pt idx="377">
                  <c:v>475.2</c:v>
                </c:pt>
                <c:pt idx="378">
                  <c:v>475</c:v>
                </c:pt>
                <c:pt idx="379">
                  <c:v>474.8</c:v>
                </c:pt>
                <c:pt idx="380">
                  <c:v>474.6</c:v>
                </c:pt>
                <c:pt idx="381">
                  <c:v>474.4</c:v>
                </c:pt>
                <c:pt idx="382">
                  <c:v>474.2</c:v>
                </c:pt>
                <c:pt idx="383">
                  <c:v>474</c:v>
                </c:pt>
                <c:pt idx="384">
                  <c:v>473.8</c:v>
                </c:pt>
                <c:pt idx="385">
                  <c:v>473.6</c:v>
                </c:pt>
                <c:pt idx="386">
                  <c:v>473.4</c:v>
                </c:pt>
                <c:pt idx="387">
                  <c:v>473.2</c:v>
                </c:pt>
                <c:pt idx="388">
                  <c:v>473</c:v>
                </c:pt>
                <c:pt idx="389">
                  <c:v>472.8</c:v>
                </c:pt>
                <c:pt idx="390">
                  <c:v>472.6</c:v>
                </c:pt>
                <c:pt idx="391">
                  <c:v>472.4</c:v>
                </c:pt>
                <c:pt idx="392">
                  <c:v>472.2</c:v>
                </c:pt>
                <c:pt idx="393">
                  <c:v>472</c:v>
                </c:pt>
                <c:pt idx="394">
                  <c:v>471.8</c:v>
                </c:pt>
                <c:pt idx="395">
                  <c:v>471.6</c:v>
                </c:pt>
                <c:pt idx="396">
                  <c:v>471.4</c:v>
                </c:pt>
                <c:pt idx="397">
                  <c:v>471.2</c:v>
                </c:pt>
                <c:pt idx="398">
                  <c:v>471</c:v>
                </c:pt>
                <c:pt idx="399">
                  <c:v>470.8</c:v>
                </c:pt>
                <c:pt idx="400">
                  <c:v>470.6</c:v>
                </c:pt>
                <c:pt idx="401">
                  <c:v>470.4</c:v>
                </c:pt>
                <c:pt idx="402">
                  <c:v>470.2</c:v>
                </c:pt>
                <c:pt idx="403">
                  <c:v>470</c:v>
                </c:pt>
                <c:pt idx="404">
                  <c:v>469.8</c:v>
                </c:pt>
                <c:pt idx="405">
                  <c:v>469.6</c:v>
                </c:pt>
                <c:pt idx="406">
                  <c:v>469.4</c:v>
                </c:pt>
                <c:pt idx="407">
                  <c:v>469.2</c:v>
                </c:pt>
                <c:pt idx="408">
                  <c:v>469</c:v>
                </c:pt>
                <c:pt idx="409">
                  <c:v>468.8</c:v>
                </c:pt>
                <c:pt idx="410">
                  <c:v>468.6</c:v>
                </c:pt>
                <c:pt idx="411">
                  <c:v>468.4</c:v>
                </c:pt>
                <c:pt idx="412">
                  <c:v>468.2</c:v>
                </c:pt>
                <c:pt idx="413">
                  <c:v>468</c:v>
                </c:pt>
                <c:pt idx="414">
                  <c:v>467.8</c:v>
                </c:pt>
                <c:pt idx="415">
                  <c:v>467.6</c:v>
                </c:pt>
                <c:pt idx="416">
                  <c:v>467.4</c:v>
                </c:pt>
                <c:pt idx="417">
                  <c:v>467.2</c:v>
                </c:pt>
                <c:pt idx="418">
                  <c:v>467</c:v>
                </c:pt>
                <c:pt idx="419">
                  <c:v>466.8</c:v>
                </c:pt>
                <c:pt idx="420">
                  <c:v>466.6</c:v>
                </c:pt>
                <c:pt idx="421">
                  <c:v>466.4</c:v>
                </c:pt>
                <c:pt idx="422">
                  <c:v>466.2</c:v>
                </c:pt>
                <c:pt idx="423">
                  <c:v>466</c:v>
                </c:pt>
                <c:pt idx="424">
                  <c:v>465.8</c:v>
                </c:pt>
                <c:pt idx="425">
                  <c:v>465.6</c:v>
                </c:pt>
                <c:pt idx="426">
                  <c:v>465.4</c:v>
                </c:pt>
                <c:pt idx="427">
                  <c:v>465.2</c:v>
                </c:pt>
                <c:pt idx="428">
                  <c:v>465</c:v>
                </c:pt>
                <c:pt idx="429">
                  <c:v>464.8</c:v>
                </c:pt>
                <c:pt idx="430">
                  <c:v>464.6</c:v>
                </c:pt>
                <c:pt idx="431">
                  <c:v>464.4</c:v>
                </c:pt>
                <c:pt idx="432">
                  <c:v>464.2</c:v>
                </c:pt>
                <c:pt idx="433">
                  <c:v>464</c:v>
                </c:pt>
                <c:pt idx="434">
                  <c:v>463.8</c:v>
                </c:pt>
                <c:pt idx="435">
                  <c:v>463.6</c:v>
                </c:pt>
                <c:pt idx="436">
                  <c:v>463.4</c:v>
                </c:pt>
                <c:pt idx="437">
                  <c:v>463.2</c:v>
                </c:pt>
                <c:pt idx="438">
                  <c:v>463</c:v>
                </c:pt>
                <c:pt idx="439">
                  <c:v>462.8</c:v>
                </c:pt>
                <c:pt idx="440">
                  <c:v>462.6</c:v>
                </c:pt>
                <c:pt idx="441">
                  <c:v>462.4</c:v>
                </c:pt>
                <c:pt idx="442">
                  <c:v>462.2</c:v>
                </c:pt>
                <c:pt idx="443">
                  <c:v>462</c:v>
                </c:pt>
                <c:pt idx="444">
                  <c:v>461.8</c:v>
                </c:pt>
                <c:pt idx="445">
                  <c:v>461.6</c:v>
                </c:pt>
                <c:pt idx="446">
                  <c:v>461.4</c:v>
                </c:pt>
                <c:pt idx="447">
                  <c:v>461.2</c:v>
                </c:pt>
                <c:pt idx="448">
                  <c:v>461</c:v>
                </c:pt>
                <c:pt idx="449">
                  <c:v>460.8</c:v>
                </c:pt>
                <c:pt idx="450">
                  <c:v>460.6</c:v>
                </c:pt>
                <c:pt idx="451">
                  <c:v>460.4</c:v>
                </c:pt>
                <c:pt idx="452">
                  <c:v>460.2</c:v>
                </c:pt>
                <c:pt idx="453">
                  <c:v>460</c:v>
                </c:pt>
                <c:pt idx="454">
                  <c:v>459.8</c:v>
                </c:pt>
                <c:pt idx="455">
                  <c:v>459.6</c:v>
                </c:pt>
                <c:pt idx="456">
                  <c:v>459.4</c:v>
                </c:pt>
                <c:pt idx="457">
                  <c:v>459.2</c:v>
                </c:pt>
                <c:pt idx="458">
                  <c:v>459</c:v>
                </c:pt>
                <c:pt idx="459">
                  <c:v>458.8</c:v>
                </c:pt>
                <c:pt idx="460">
                  <c:v>458.6</c:v>
                </c:pt>
                <c:pt idx="461">
                  <c:v>458.4</c:v>
                </c:pt>
                <c:pt idx="462">
                  <c:v>458.2</c:v>
                </c:pt>
                <c:pt idx="463">
                  <c:v>458</c:v>
                </c:pt>
                <c:pt idx="464">
                  <c:v>457.8</c:v>
                </c:pt>
                <c:pt idx="465">
                  <c:v>457.6</c:v>
                </c:pt>
                <c:pt idx="466">
                  <c:v>457.4</c:v>
                </c:pt>
                <c:pt idx="467">
                  <c:v>457.2</c:v>
                </c:pt>
                <c:pt idx="468">
                  <c:v>457</c:v>
                </c:pt>
                <c:pt idx="469">
                  <c:v>456.8</c:v>
                </c:pt>
                <c:pt idx="470">
                  <c:v>456.6</c:v>
                </c:pt>
                <c:pt idx="471">
                  <c:v>456.4</c:v>
                </c:pt>
                <c:pt idx="472">
                  <c:v>456.2</c:v>
                </c:pt>
                <c:pt idx="473">
                  <c:v>456</c:v>
                </c:pt>
                <c:pt idx="474">
                  <c:v>455.8</c:v>
                </c:pt>
                <c:pt idx="475">
                  <c:v>455.6</c:v>
                </c:pt>
                <c:pt idx="476">
                  <c:v>455.4</c:v>
                </c:pt>
                <c:pt idx="477">
                  <c:v>455.2</c:v>
                </c:pt>
                <c:pt idx="478">
                  <c:v>455</c:v>
                </c:pt>
                <c:pt idx="479">
                  <c:v>454.8</c:v>
                </c:pt>
                <c:pt idx="480">
                  <c:v>454.6</c:v>
                </c:pt>
                <c:pt idx="481">
                  <c:v>454.4</c:v>
                </c:pt>
                <c:pt idx="482">
                  <c:v>454.2</c:v>
                </c:pt>
                <c:pt idx="483">
                  <c:v>454</c:v>
                </c:pt>
                <c:pt idx="484">
                  <c:v>453.8</c:v>
                </c:pt>
                <c:pt idx="485">
                  <c:v>453.6</c:v>
                </c:pt>
                <c:pt idx="486">
                  <c:v>453.4</c:v>
                </c:pt>
                <c:pt idx="487">
                  <c:v>453.2</c:v>
                </c:pt>
                <c:pt idx="488">
                  <c:v>453</c:v>
                </c:pt>
                <c:pt idx="489">
                  <c:v>452.8</c:v>
                </c:pt>
                <c:pt idx="490">
                  <c:v>452.6</c:v>
                </c:pt>
                <c:pt idx="491">
                  <c:v>452.4</c:v>
                </c:pt>
                <c:pt idx="492">
                  <c:v>452.2</c:v>
                </c:pt>
                <c:pt idx="493">
                  <c:v>452</c:v>
                </c:pt>
                <c:pt idx="494">
                  <c:v>451.8</c:v>
                </c:pt>
                <c:pt idx="495">
                  <c:v>451.6</c:v>
                </c:pt>
                <c:pt idx="496">
                  <c:v>451.4</c:v>
                </c:pt>
                <c:pt idx="497">
                  <c:v>451.2</c:v>
                </c:pt>
                <c:pt idx="498">
                  <c:v>451</c:v>
                </c:pt>
                <c:pt idx="499">
                  <c:v>450.8</c:v>
                </c:pt>
                <c:pt idx="500">
                  <c:v>450.6</c:v>
                </c:pt>
                <c:pt idx="501">
                  <c:v>450.4</c:v>
                </c:pt>
                <c:pt idx="502">
                  <c:v>450.2</c:v>
                </c:pt>
                <c:pt idx="503">
                  <c:v>450</c:v>
                </c:pt>
                <c:pt idx="504">
                  <c:v>449.8</c:v>
                </c:pt>
                <c:pt idx="505">
                  <c:v>449.6</c:v>
                </c:pt>
                <c:pt idx="506">
                  <c:v>449.4</c:v>
                </c:pt>
                <c:pt idx="507">
                  <c:v>449.2</c:v>
                </c:pt>
                <c:pt idx="508">
                  <c:v>449</c:v>
                </c:pt>
                <c:pt idx="509">
                  <c:v>448.8</c:v>
                </c:pt>
                <c:pt idx="510">
                  <c:v>448.6</c:v>
                </c:pt>
                <c:pt idx="511">
                  <c:v>448.4</c:v>
                </c:pt>
                <c:pt idx="512">
                  <c:v>448.2</c:v>
                </c:pt>
                <c:pt idx="513">
                  <c:v>448</c:v>
                </c:pt>
                <c:pt idx="514">
                  <c:v>447.8</c:v>
                </c:pt>
                <c:pt idx="515">
                  <c:v>447.6</c:v>
                </c:pt>
                <c:pt idx="516">
                  <c:v>447.4</c:v>
                </c:pt>
                <c:pt idx="517">
                  <c:v>447.2</c:v>
                </c:pt>
                <c:pt idx="518">
                  <c:v>447</c:v>
                </c:pt>
                <c:pt idx="519">
                  <c:v>446.8</c:v>
                </c:pt>
                <c:pt idx="520">
                  <c:v>446.6</c:v>
                </c:pt>
                <c:pt idx="521">
                  <c:v>446.4</c:v>
                </c:pt>
                <c:pt idx="522">
                  <c:v>446.2</c:v>
                </c:pt>
                <c:pt idx="523">
                  <c:v>446</c:v>
                </c:pt>
                <c:pt idx="524">
                  <c:v>445.8</c:v>
                </c:pt>
                <c:pt idx="525">
                  <c:v>445.6</c:v>
                </c:pt>
                <c:pt idx="526">
                  <c:v>445.4</c:v>
                </c:pt>
                <c:pt idx="527">
                  <c:v>445.2</c:v>
                </c:pt>
                <c:pt idx="528">
                  <c:v>445</c:v>
                </c:pt>
                <c:pt idx="529">
                  <c:v>444.8</c:v>
                </c:pt>
                <c:pt idx="530">
                  <c:v>444.6</c:v>
                </c:pt>
                <c:pt idx="531">
                  <c:v>444.4</c:v>
                </c:pt>
                <c:pt idx="532">
                  <c:v>444.2</c:v>
                </c:pt>
                <c:pt idx="533">
                  <c:v>444</c:v>
                </c:pt>
                <c:pt idx="534">
                  <c:v>443.8</c:v>
                </c:pt>
                <c:pt idx="535">
                  <c:v>443.6</c:v>
                </c:pt>
                <c:pt idx="536">
                  <c:v>443.4</c:v>
                </c:pt>
                <c:pt idx="537">
                  <c:v>443.2</c:v>
                </c:pt>
                <c:pt idx="538">
                  <c:v>443</c:v>
                </c:pt>
                <c:pt idx="539">
                  <c:v>442.8</c:v>
                </c:pt>
                <c:pt idx="540">
                  <c:v>442.6</c:v>
                </c:pt>
                <c:pt idx="541">
                  <c:v>442.4</c:v>
                </c:pt>
                <c:pt idx="542">
                  <c:v>442.2</c:v>
                </c:pt>
                <c:pt idx="543">
                  <c:v>442</c:v>
                </c:pt>
                <c:pt idx="544">
                  <c:v>441.8</c:v>
                </c:pt>
                <c:pt idx="545">
                  <c:v>441.6</c:v>
                </c:pt>
                <c:pt idx="546">
                  <c:v>441.4</c:v>
                </c:pt>
                <c:pt idx="547">
                  <c:v>441.2</c:v>
                </c:pt>
                <c:pt idx="548">
                  <c:v>441</c:v>
                </c:pt>
                <c:pt idx="549">
                  <c:v>440.8</c:v>
                </c:pt>
                <c:pt idx="550">
                  <c:v>440.6</c:v>
                </c:pt>
                <c:pt idx="551">
                  <c:v>440.4</c:v>
                </c:pt>
                <c:pt idx="552">
                  <c:v>440.2</c:v>
                </c:pt>
                <c:pt idx="553">
                  <c:v>440</c:v>
                </c:pt>
                <c:pt idx="554">
                  <c:v>439.8</c:v>
                </c:pt>
                <c:pt idx="555">
                  <c:v>439.6</c:v>
                </c:pt>
                <c:pt idx="556">
                  <c:v>439.4</c:v>
                </c:pt>
                <c:pt idx="557">
                  <c:v>439.2</c:v>
                </c:pt>
                <c:pt idx="558">
                  <c:v>439</c:v>
                </c:pt>
                <c:pt idx="559">
                  <c:v>438.8</c:v>
                </c:pt>
                <c:pt idx="560">
                  <c:v>438.6</c:v>
                </c:pt>
                <c:pt idx="561">
                  <c:v>438.4</c:v>
                </c:pt>
                <c:pt idx="562">
                  <c:v>438.2</c:v>
                </c:pt>
                <c:pt idx="563">
                  <c:v>438</c:v>
                </c:pt>
                <c:pt idx="564">
                  <c:v>437.8</c:v>
                </c:pt>
                <c:pt idx="565">
                  <c:v>437.6</c:v>
                </c:pt>
                <c:pt idx="566">
                  <c:v>437.4</c:v>
                </c:pt>
                <c:pt idx="567">
                  <c:v>437.2</c:v>
                </c:pt>
                <c:pt idx="568">
                  <c:v>437</c:v>
                </c:pt>
                <c:pt idx="569">
                  <c:v>436.8</c:v>
                </c:pt>
                <c:pt idx="570">
                  <c:v>436.6</c:v>
                </c:pt>
                <c:pt idx="571">
                  <c:v>436.4</c:v>
                </c:pt>
                <c:pt idx="572">
                  <c:v>436.2</c:v>
                </c:pt>
                <c:pt idx="573">
                  <c:v>436</c:v>
                </c:pt>
                <c:pt idx="574">
                  <c:v>435.8</c:v>
                </c:pt>
                <c:pt idx="575">
                  <c:v>435.6</c:v>
                </c:pt>
                <c:pt idx="576">
                  <c:v>435.4</c:v>
                </c:pt>
                <c:pt idx="577">
                  <c:v>435.2</c:v>
                </c:pt>
                <c:pt idx="578">
                  <c:v>435</c:v>
                </c:pt>
                <c:pt idx="579">
                  <c:v>434.8</c:v>
                </c:pt>
                <c:pt idx="580">
                  <c:v>434.6</c:v>
                </c:pt>
                <c:pt idx="581">
                  <c:v>434.4</c:v>
                </c:pt>
                <c:pt idx="582">
                  <c:v>434.2</c:v>
                </c:pt>
                <c:pt idx="583">
                  <c:v>434</c:v>
                </c:pt>
                <c:pt idx="584">
                  <c:v>433.8</c:v>
                </c:pt>
                <c:pt idx="585">
                  <c:v>433.6</c:v>
                </c:pt>
                <c:pt idx="586">
                  <c:v>433.4</c:v>
                </c:pt>
                <c:pt idx="587">
                  <c:v>433.2</c:v>
                </c:pt>
                <c:pt idx="588">
                  <c:v>433</c:v>
                </c:pt>
                <c:pt idx="589">
                  <c:v>432.8</c:v>
                </c:pt>
                <c:pt idx="590">
                  <c:v>432.6</c:v>
                </c:pt>
                <c:pt idx="591">
                  <c:v>432.4</c:v>
                </c:pt>
                <c:pt idx="592">
                  <c:v>432.2</c:v>
                </c:pt>
                <c:pt idx="593">
                  <c:v>432</c:v>
                </c:pt>
                <c:pt idx="594">
                  <c:v>431.8</c:v>
                </c:pt>
                <c:pt idx="595">
                  <c:v>431.6</c:v>
                </c:pt>
                <c:pt idx="596">
                  <c:v>431.4</c:v>
                </c:pt>
                <c:pt idx="597">
                  <c:v>431.2</c:v>
                </c:pt>
                <c:pt idx="598">
                  <c:v>431</c:v>
                </c:pt>
                <c:pt idx="599">
                  <c:v>430.8</c:v>
                </c:pt>
                <c:pt idx="600">
                  <c:v>430.6</c:v>
                </c:pt>
                <c:pt idx="601">
                  <c:v>430.4</c:v>
                </c:pt>
                <c:pt idx="602">
                  <c:v>430.2</c:v>
                </c:pt>
                <c:pt idx="603">
                  <c:v>430</c:v>
                </c:pt>
                <c:pt idx="604">
                  <c:v>429.8</c:v>
                </c:pt>
                <c:pt idx="605">
                  <c:v>429.6</c:v>
                </c:pt>
                <c:pt idx="606">
                  <c:v>429.4</c:v>
                </c:pt>
                <c:pt idx="607">
                  <c:v>429.2</c:v>
                </c:pt>
                <c:pt idx="608">
                  <c:v>429</c:v>
                </c:pt>
                <c:pt idx="609">
                  <c:v>428.8</c:v>
                </c:pt>
                <c:pt idx="610">
                  <c:v>428.6</c:v>
                </c:pt>
                <c:pt idx="611">
                  <c:v>428.4</c:v>
                </c:pt>
                <c:pt idx="612">
                  <c:v>428.2</c:v>
                </c:pt>
                <c:pt idx="613">
                  <c:v>428</c:v>
                </c:pt>
                <c:pt idx="614">
                  <c:v>427.8</c:v>
                </c:pt>
                <c:pt idx="615">
                  <c:v>427.6</c:v>
                </c:pt>
                <c:pt idx="616">
                  <c:v>427.4</c:v>
                </c:pt>
                <c:pt idx="617">
                  <c:v>427.2</c:v>
                </c:pt>
                <c:pt idx="618">
                  <c:v>427</c:v>
                </c:pt>
                <c:pt idx="619">
                  <c:v>426.8</c:v>
                </c:pt>
                <c:pt idx="620">
                  <c:v>426.6</c:v>
                </c:pt>
                <c:pt idx="621">
                  <c:v>426.4</c:v>
                </c:pt>
                <c:pt idx="622">
                  <c:v>426.2</c:v>
                </c:pt>
                <c:pt idx="623">
                  <c:v>426</c:v>
                </c:pt>
                <c:pt idx="624">
                  <c:v>425.8</c:v>
                </c:pt>
                <c:pt idx="625">
                  <c:v>425.6</c:v>
                </c:pt>
                <c:pt idx="626">
                  <c:v>425.4</c:v>
                </c:pt>
                <c:pt idx="627">
                  <c:v>425.2</c:v>
                </c:pt>
                <c:pt idx="628">
                  <c:v>425</c:v>
                </c:pt>
                <c:pt idx="629">
                  <c:v>424.8</c:v>
                </c:pt>
                <c:pt idx="630">
                  <c:v>424.6</c:v>
                </c:pt>
                <c:pt idx="631">
                  <c:v>424.4</c:v>
                </c:pt>
                <c:pt idx="632">
                  <c:v>424.2</c:v>
                </c:pt>
                <c:pt idx="633">
                  <c:v>424</c:v>
                </c:pt>
                <c:pt idx="634">
                  <c:v>423.8</c:v>
                </c:pt>
                <c:pt idx="635">
                  <c:v>423.6</c:v>
                </c:pt>
                <c:pt idx="636">
                  <c:v>423.4</c:v>
                </c:pt>
                <c:pt idx="637">
                  <c:v>423.2</c:v>
                </c:pt>
                <c:pt idx="638">
                  <c:v>423</c:v>
                </c:pt>
                <c:pt idx="639">
                  <c:v>422.8</c:v>
                </c:pt>
                <c:pt idx="640">
                  <c:v>422.6</c:v>
                </c:pt>
                <c:pt idx="641">
                  <c:v>422.4</c:v>
                </c:pt>
                <c:pt idx="642">
                  <c:v>422.2</c:v>
                </c:pt>
                <c:pt idx="643">
                  <c:v>422</c:v>
                </c:pt>
                <c:pt idx="644">
                  <c:v>421.8</c:v>
                </c:pt>
                <c:pt idx="645">
                  <c:v>421.6</c:v>
                </c:pt>
                <c:pt idx="646">
                  <c:v>421.4</c:v>
                </c:pt>
                <c:pt idx="647">
                  <c:v>421.2</c:v>
                </c:pt>
                <c:pt idx="648">
                  <c:v>421</c:v>
                </c:pt>
                <c:pt idx="649">
                  <c:v>420.8</c:v>
                </c:pt>
                <c:pt idx="650">
                  <c:v>420.6</c:v>
                </c:pt>
                <c:pt idx="651">
                  <c:v>420.4</c:v>
                </c:pt>
                <c:pt idx="652">
                  <c:v>420.2</c:v>
                </c:pt>
                <c:pt idx="653">
                  <c:v>420</c:v>
                </c:pt>
                <c:pt idx="654">
                  <c:v>419.8</c:v>
                </c:pt>
                <c:pt idx="655">
                  <c:v>419.6</c:v>
                </c:pt>
                <c:pt idx="656">
                  <c:v>419.4</c:v>
                </c:pt>
                <c:pt idx="657">
                  <c:v>419.2</c:v>
                </c:pt>
                <c:pt idx="658">
                  <c:v>419</c:v>
                </c:pt>
                <c:pt idx="659">
                  <c:v>418.8</c:v>
                </c:pt>
                <c:pt idx="660">
                  <c:v>418.6</c:v>
                </c:pt>
                <c:pt idx="661">
                  <c:v>418.4</c:v>
                </c:pt>
                <c:pt idx="662">
                  <c:v>418.2</c:v>
                </c:pt>
                <c:pt idx="663">
                  <c:v>418</c:v>
                </c:pt>
                <c:pt idx="664">
                  <c:v>417.8</c:v>
                </c:pt>
                <c:pt idx="665">
                  <c:v>417.6</c:v>
                </c:pt>
                <c:pt idx="666">
                  <c:v>417.4</c:v>
                </c:pt>
                <c:pt idx="667">
                  <c:v>417.2</c:v>
                </c:pt>
                <c:pt idx="668">
                  <c:v>417</c:v>
                </c:pt>
                <c:pt idx="669">
                  <c:v>416.8</c:v>
                </c:pt>
                <c:pt idx="670">
                  <c:v>416.6</c:v>
                </c:pt>
                <c:pt idx="671">
                  <c:v>416.4</c:v>
                </c:pt>
                <c:pt idx="672">
                  <c:v>416.2</c:v>
                </c:pt>
                <c:pt idx="673">
                  <c:v>416</c:v>
                </c:pt>
                <c:pt idx="674">
                  <c:v>415.8</c:v>
                </c:pt>
                <c:pt idx="675">
                  <c:v>415.6</c:v>
                </c:pt>
                <c:pt idx="676">
                  <c:v>415.4</c:v>
                </c:pt>
                <c:pt idx="677">
                  <c:v>415.2</c:v>
                </c:pt>
                <c:pt idx="678">
                  <c:v>415</c:v>
                </c:pt>
                <c:pt idx="679">
                  <c:v>414.8</c:v>
                </c:pt>
                <c:pt idx="680">
                  <c:v>414.6</c:v>
                </c:pt>
                <c:pt idx="681">
                  <c:v>414.4</c:v>
                </c:pt>
                <c:pt idx="682">
                  <c:v>414.2</c:v>
                </c:pt>
                <c:pt idx="683">
                  <c:v>414</c:v>
                </c:pt>
                <c:pt idx="684">
                  <c:v>413.8</c:v>
                </c:pt>
                <c:pt idx="685">
                  <c:v>413.6</c:v>
                </c:pt>
                <c:pt idx="686">
                  <c:v>413.4</c:v>
                </c:pt>
                <c:pt idx="687">
                  <c:v>413.2</c:v>
                </c:pt>
                <c:pt idx="688">
                  <c:v>413</c:v>
                </c:pt>
                <c:pt idx="689">
                  <c:v>412.8</c:v>
                </c:pt>
                <c:pt idx="690">
                  <c:v>412.6</c:v>
                </c:pt>
                <c:pt idx="691">
                  <c:v>412.4</c:v>
                </c:pt>
                <c:pt idx="692">
                  <c:v>412.2</c:v>
                </c:pt>
                <c:pt idx="693">
                  <c:v>412</c:v>
                </c:pt>
                <c:pt idx="694">
                  <c:v>411.8</c:v>
                </c:pt>
                <c:pt idx="695">
                  <c:v>411.6</c:v>
                </c:pt>
                <c:pt idx="696">
                  <c:v>411.4</c:v>
                </c:pt>
                <c:pt idx="697">
                  <c:v>411.2</c:v>
                </c:pt>
                <c:pt idx="698">
                  <c:v>411</c:v>
                </c:pt>
                <c:pt idx="699">
                  <c:v>410.8</c:v>
                </c:pt>
                <c:pt idx="700">
                  <c:v>410.6</c:v>
                </c:pt>
                <c:pt idx="701">
                  <c:v>410.4</c:v>
                </c:pt>
                <c:pt idx="702">
                  <c:v>410.2</c:v>
                </c:pt>
                <c:pt idx="703">
                  <c:v>410</c:v>
                </c:pt>
                <c:pt idx="704">
                  <c:v>409.8</c:v>
                </c:pt>
                <c:pt idx="705">
                  <c:v>409.6</c:v>
                </c:pt>
                <c:pt idx="706">
                  <c:v>409.4</c:v>
                </c:pt>
                <c:pt idx="707">
                  <c:v>409.2</c:v>
                </c:pt>
                <c:pt idx="708">
                  <c:v>409</c:v>
                </c:pt>
                <c:pt idx="709">
                  <c:v>408.8</c:v>
                </c:pt>
                <c:pt idx="710">
                  <c:v>408.6</c:v>
                </c:pt>
                <c:pt idx="711">
                  <c:v>408.4</c:v>
                </c:pt>
                <c:pt idx="712">
                  <c:v>408.2</c:v>
                </c:pt>
                <c:pt idx="713">
                  <c:v>408</c:v>
                </c:pt>
                <c:pt idx="714">
                  <c:v>407.8</c:v>
                </c:pt>
                <c:pt idx="715">
                  <c:v>407.6</c:v>
                </c:pt>
                <c:pt idx="716">
                  <c:v>407.4</c:v>
                </c:pt>
                <c:pt idx="717">
                  <c:v>407.2</c:v>
                </c:pt>
                <c:pt idx="718">
                  <c:v>407</c:v>
                </c:pt>
                <c:pt idx="719">
                  <c:v>406.8</c:v>
                </c:pt>
                <c:pt idx="720">
                  <c:v>406.6</c:v>
                </c:pt>
                <c:pt idx="721">
                  <c:v>406.4</c:v>
                </c:pt>
                <c:pt idx="722">
                  <c:v>406.2</c:v>
                </c:pt>
                <c:pt idx="723">
                  <c:v>406</c:v>
                </c:pt>
                <c:pt idx="724">
                  <c:v>405.8</c:v>
                </c:pt>
                <c:pt idx="725">
                  <c:v>405.6</c:v>
                </c:pt>
                <c:pt idx="726">
                  <c:v>405.4</c:v>
                </c:pt>
                <c:pt idx="727">
                  <c:v>405.2</c:v>
                </c:pt>
                <c:pt idx="728">
                  <c:v>405</c:v>
                </c:pt>
                <c:pt idx="729">
                  <c:v>404.8</c:v>
                </c:pt>
                <c:pt idx="730">
                  <c:v>404.6</c:v>
                </c:pt>
                <c:pt idx="731">
                  <c:v>404.4</c:v>
                </c:pt>
                <c:pt idx="732">
                  <c:v>404.2</c:v>
                </c:pt>
                <c:pt idx="733">
                  <c:v>404</c:v>
                </c:pt>
                <c:pt idx="734">
                  <c:v>403.8</c:v>
                </c:pt>
                <c:pt idx="735">
                  <c:v>403.6</c:v>
                </c:pt>
                <c:pt idx="736">
                  <c:v>403.4</c:v>
                </c:pt>
                <c:pt idx="737">
                  <c:v>403.2</c:v>
                </c:pt>
                <c:pt idx="738">
                  <c:v>403</c:v>
                </c:pt>
                <c:pt idx="739">
                  <c:v>402.8</c:v>
                </c:pt>
                <c:pt idx="740">
                  <c:v>402.6</c:v>
                </c:pt>
                <c:pt idx="741">
                  <c:v>402.4</c:v>
                </c:pt>
                <c:pt idx="742">
                  <c:v>402.2</c:v>
                </c:pt>
                <c:pt idx="743">
                  <c:v>402</c:v>
                </c:pt>
                <c:pt idx="744">
                  <c:v>401.8</c:v>
                </c:pt>
                <c:pt idx="745">
                  <c:v>401.6</c:v>
                </c:pt>
                <c:pt idx="746">
                  <c:v>401.4</c:v>
                </c:pt>
                <c:pt idx="747">
                  <c:v>401.2</c:v>
                </c:pt>
                <c:pt idx="748">
                  <c:v>401</c:v>
                </c:pt>
                <c:pt idx="749">
                  <c:v>400.8</c:v>
                </c:pt>
                <c:pt idx="750">
                  <c:v>400.6</c:v>
                </c:pt>
                <c:pt idx="751">
                  <c:v>400.4</c:v>
                </c:pt>
                <c:pt idx="752">
                  <c:v>400.2</c:v>
                </c:pt>
                <c:pt idx="753">
                  <c:v>400</c:v>
                </c:pt>
                <c:pt idx="754">
                  <c:v>399.8</c:v>
                </c:pt>
                <c:pt idx="755">
                  <c:v>399.6</c:v>
                </c:pt>
                <c:pt idx="756">
                  <c:v>399.4</c:v>
                </c:pt>
                <c:pt idx="757">
                  <c:v>399.2</c:v>
                </c:pt>
                <c:pt idx="758">
                  <c:v>399</c:v>
                </c:pt>
                <c:pt idx="759">
                  <c:v>398.8</c:v>
                </c:pt>
                <c:pt idx="760">
                  <c:v>398.6</c:v>
                </c:pt>
                <c:pt idx="761">
                  <c:v>398.4</c:v>
                </c:pt>
                <c:pt idx="762">
                  <c:v>398.2</c:v>
                </c:pt>
                <c:pt idx="763">
                  <c:v>398</c:v>
                </c:pt>
                <c:pt idx="764">
                  <c:v>397.8</c:v>
                </c:pt>
                <c:pt idx="765">
                  <c:v>397.6</c:v>
                </c:pt>
                <c:pt idx="766">
                  <c:v>397.4</c:v>
                </c:pt>
                <c:pt idx="767">
                  <c:v>397.2</c:v>
                </c:pt>
                <c:pt idx="768">
                  <c:v>397</c:v>
                </c:pt>
                <c:pt idx="769">
                  <c:v>396.8</c:v>
                </c:pt>
                <c:pt idx="770">
                  <c:v>396.6</c:v>
                </c:pt>
                <c:pt idx="771">
                  <c:v>396.4</c:v>
                </c:pt>
                <c:pt idx="772">
                  <c:v>396.2</c:v>
                </c:pt>
                <c:pt idx="773">
                  <c:v>396</c:v>
                </c:pt>
                <c:pt idx="774">
                  <c:v>395.8</c:v>
                </c:pt>
                <c:pt idx="775">
                  <c:v>395.6</c:v>
                </c:pt>
                <c:pt idx="776">
                  <c:v>395.4</c:v>
                </c:pt>
                <c:pt idx="777">
                  <c:v>395.2</c:v>
                </c:pt>
                <c:pt idx="778">
                  <c:v>395</c:v>
                </c:pt>
                <c:pt idx="779">
                  <c:v>394.8</c:v>
                </c:pt>
                <c:pt idx="780">
                  <c:v>394.6</c:v>
                </c:pt>
                <c:pt idx="781">
                  <c:v>394.4</c:v>
                </c:pt>
                <c:pt idx="782">
                  <c:v>394.2</c:v>
                </c:pt>
                <c:pt idx="783">
                  <c:v>394</c:v>
                </c:pt>
                <c:pt idx="784">
                  <c:v>393.8</c:v>
                </c:pt>
                <c:pt idx="785">
                  <c:v>393.6</c:v>
                </c:pt>
                <c:pt idx="786">
                  <c:v>393.4</c:v>
                </c:pt>
                <c:pt idx="787">
                  <c:v>393.2</c:v>
                </c:pt>
                <c:pt idx="788">
                  <c:v>393</c:v>
                </c:pt>
                <c:pt idx="789">
                  <c:v>392.8</c:v>
                </c:pt>
                <c:pt idx="790">
                  <c:v>392.6</c:v>
                </c:pt>
                <c:pt idx="791">
                  <c:v>392.4</c:v>
                </c:pt>
                <c:pt idx="792">
                  <c:v>392.2</c:v>
                </c:pt>
                <c:pt idx="793">
                  <c:v>392</c:v>
                </c:pt>
                <c:pt idx="794">
                  <c:v>391.8</c:v>
                </c:pt>
                <c:pt idx="795">
                  <c:v>391.6</c:v>
                </c:pt>
                <c:pt idx="796">
                  <c:v>391.4</c:v>
                </c:pt>
                <c:pt idx="797">
                  <c:v>391.2</c:v>
                </c:pt>
                <c:pt idx="798">
                  <c:v>391</c:v>
                </c:pt>
                <c:pt idx="799">
                  <c:v>390.8</c:v>
                </c:pt>
                <c:pt idx="800">
                  <c:v>390.6</c:v>
                </c:pt>
                <c:pt idx="801">
                  <c:v>390.4</c:v>
                </c:pt>
                <c:pt idx="802">
                  <c:v>390.2</c:v>
                </c:pt>
                <c:pt idx="803">
                  <c:v>390</c:v>
                </c:pt>
                <c:pt idx="804">
                  <c:v>389.8</c:v>
                </c:pt>
                <c:pt idx="805">
                  <c:v>389.6</c:v>
                </c:pt>
                <c:pt idx="806">
                  <c:v>389.4</c:v>
                </c:pt>
                <c:pt idx="807">
                  <c:v>389.2</c:v>
                </c:pt>
                <c:pt idx="808">
                  <c:v>389</c:v>
                </c:pt>
                <c:pt idx="809">
                  <c:v>388.8</c:v>
                </c:pt>
                <c:pt idx="810">
                  <c:v>388.6</c:v>
                </c:pt>
                <c:pt idx="811">
                  <c:v>388.4</c:v>
                </c:pt>
                <c:pt idx="812">
                  <c:v>388.2</c:v>
                </c:pt>
                <c:pt idx="813">
                  <c:v>388</c:v>
                </c:pt>
                <c:pt idx="814">
                  <c:v>387.8</c:v>
                </c:pt>
                <c:pt idx="815">
                  <c:v>387.6</c:v>
                </c:pt>
                <c:pt idx="816">
                  <c:v>387.4</c:v>
                </c:pt>
                <c:pt idx="817">
                  <c:v>387.2</c:v>
                </c:pt>
                <c:pt idx="818">
                  <c:v>387</c:v>
                </c:pt>
                <c:pt idx="819">
                  <c:v>386.8</c:v>
                </c:pt>
                <c:pt idx="820">
                  <c:v>386.6</c:v>
                </c:pt>
                <c:pt idx="821">
                  <c:v>386.4</c:v>
                </c:pt>
                <c:pt idx="822">
                  <c:v>386.2</c:v>
                </c:pt>
                <c:pt idx="823">
                  <c:v>386</c:v>
                </c:pt>
                <c:pt idx="824">
                  <c:v>385.8</c:v>
                </c:pt>
                <c:pt idx="825">
                  <c:v>385.6</c:v>
                </c:pt>
                <c:pt idx="826">
                  <c:v>385.4</c:v>
                </c:pt>
                <c:pt idx="827">
                  <c:v>385.2</c:v>
                </c:pt>
                <c:pt idx="828">
                  <c:v>385</c:v>
                </c:pt>
                <c:pt idx="829">
                  <c:v>384.8</c:v>
                </c:pt>
                <c:pt idx="830">
                  <c:v>384.6</c:v>
                </c:pt>
                <c:pt idx="831">
                  <c:v>384.4</c:v>
                </c:pt>
                <c:pt idx="832">
                  <c:v>384.2</c:v>
                </c:pt>
                <c:pt idx="833">
                  <c:v>384</c:v>
                </c:pt>
                <c:pt idx="834">
                  <c:v>383.8</c:v>
                </c:pt>
                <c:pt idx="835">
                  <c:v>383.6</c:v>
                </c:pt>
                <c:pt idx="836">
                  <c:v>383.4</c:v>
                </c:pt>
                <c:pt idx="837">
                  <c:v>383.2</c:v>
                </c:pt>
                <c:pt idx="838">
                  <c:v>383</c:v>
                </c:pt>
                <c:pt idx="839">
                  <c:v>382.8</c:v>
                </c:pt>
                <c:pt idx="840">
                  <c:v>382.6</c:v>
                </c:pt>
                <c:pt idx="841">
                  <c:v>382.4</c:v>
                </c:pt>
                <c:pt idx="842">
                  <c:v>382.2</c:v>
                </c:pt>
                <c:pt idx="843">
                  <c:v>382</c:v>
                </c:pt>
                <c:pt idx="844">
                  <c:v>381.8</c:v>
                </c:pt>
                <c:pt idx="845">
                  <c:v>381.6</c:v>
                </c:pt>
                <c:pt idx="846">
                  <c:v>381.4</c:v>
                </c:pt>
                <c:pt idx="847">
                  <c:v>381.2</c:v>
                </c:pt>
                <c:pt idx="848">
                  <c:v>381</c:v>
                </c:pt>
                <c:pt idx="849">
                  <c:v>380.8</c:v>
                </c:pt>
                <c:pt idx="850">
                  <c:v>380.6</c:v>
                </c:pt>
                <c:pt idx="851">
                  <c:v>380.4</c:v>
                </c:pt>
                <c:pt idx="852">
                  <c:v>380.2</c:v>
                </c:pt>
                <c:pt idx="853">
                  <c:v>380</c:v>
                </c:pt>
                <c:pt idx="854">
                  <c:v>379.8</c:v>
                </c:pt>
                <c:pt idx="855">
                  <c:v>379.6</c:v>
                </c:pt>
                <c:pt idx="856">
                  <c:v>379.4</c:v>
                </c:pt>
                <c:pt idx="857">
                  <c:v>379.2</c:v>
                </c:pt>
                <c:pt idx="858">
                  <c:v>379</c:v>
                </c:pt>
                <c:pt idx="859">
                  <c:v>378.8</c:v>
                </c:pt>
                <c:pt idx="860">
                  <c:v>378.6</c:v>
                </c:pt>
                <c:pt idx="861">
                  <c:v>378.4</c:v>
                </c:pt>
                <c:pt idx="862">
                  <c:v>378.2</c:v>
                </c:pt>
                <c:pt idx="863">
                  <c:v>378</c:v>
                </c:pt>
                <c:pt idx="864">
                  <c:v>377.8</c:v>
                </c:pt>
                <c:pt idx="865">
                  <c:v>377.6</c:v>
                </c:pt>
                <c:pt idx="866">
                  <c:v>377.4</c:v>
                </c:pt>
                <c:pt idx="867">
                  <c:v>377.2</c:v>
                </c:pt>
                <c:pt idx="868">
                  <c:v>377</c:v>
                </c:pt>
                <c:pt idx="869">
                  <c:v>376.8</c:v>
                </c:pt>
                <c:pt idx="870">
                  <c:v>376.6</c:v>
                </c:pt>
                <c:pt idx="871">
                  <c:v>376.4</c:v>
                </c:pt>
                <c:pt idx="872">
                  <c:v>376.2</c:v>
                </c:pt>
                <c:pt idx="873">
                  <c:v>376</c:v>
                </c:pt>
                <c:pt idx="874">
                  <c:v>375.8</c:v>
                </c:pt>
                <c:pt idx="875">
                  <c:v>375.6</c:v>
                </c:pt>
                <c:pt idx="876">
                  <c:v>375.4</c:v>
                </c:pt>
                <c:pt idx="877">
                  <c:v>375.2</c:v>
                </c:pt>
                <c:pt idx="878">
                  <c:v>375</c:v>
                </c:pt>
                <c:pt idx="879">
                  <c:v>374.8</c:v>
                </c:pt>
                <c:pt idx="880">
                  <c:v>374.6</c:v>
                </c:pt>
                <c:pt idx="881">
                  <c:v>374.4</c:v>
                </c:pt>
                <c:pt idx="882">
                  <c:v>374.2</c:v>
                </c:pt>
                <c:pt idx="883">
                  <c:v>374</c:v>
                </c:pt>
                <c:pt idx="884">
                  <c:v>373.8</c:v>
                </c:pt>
                <c:pt idx="885">
                  <c:v>373.6</c:v>
                </c:pt>
                <c:pt idx="886">
                  <c:v>373.4</c:v>
                </c:pt>
                <c:pt idx="887">
                  <c:v>373.2</c:v>
                </c:pt>
                <c:pt idx="888">
                  <c:v>373</c:v>
                </c:pt>
                <c:pt idx="889">
                  <c:v>372.8</c:v>
                </c:pt>
                <c:pt idx="890">
                  <c:v>372.6</c:v>
                </c:pt>
                <c:pt idx="891">
                  <c:v>372.4</c:v>
                </c:pt>
                <c:pt idx="892">
                  <c:v>372.2</c:v>
                </c:pt>
                <c:pt idx="893">
                  <c:v>372</c:v>
                </c:pt>
                <c:pt idx="894">
                  <c:v>371.8</c:v>
                </c:pt>
                <c:pt idx="895">
                  <c:v>371.6</c:v>
                </c:pt>
                <c:pt idx="896">
                  <c:v>371.4</c:v>
                </c:pt>
                <c:pt idx="897">
                  <c:v>371.2</c:v>
                </c:pt>
                <c:pt idx="898">
                  <c:v>371</c:v>
                </c:pt>
                <c:pt idx="899">
                  <c:v>370.8</c:v>
                </c:pt>
                <c:pt idx="900">
                  <c:v>370.6</c:v>
                </c:pt>
                <c:pt idx="901">
                  <c:v>370.4</c:v>
                </c:pt>
                <c:pt idx="902">
                  <c:v>370.2</c:v>
                </c:pt>
                <c:pt idx="903">
                  <c:v>370</c:v>
                </c:pt>
                <c:pt idx="904">
                  <c:v>369.8</c:v>
                </c:pt>
                <c:pt idx="905">
                  <c:v>369.6</c:v>
                </c:pt>
                <c:pt idx="906">
                  <c:v>369.4</c:v>
                </c:pt>
                <c:pt idx="907">
                  <c:v>369.2</c:v>
                </c:pt>
                <c:pt idx="908">
                  <c:v>369</c:v>
                </c:pt>
                <c:pt idx="909">
                  <c:v>368.8</c:v>
                </c:pt>
                <c:pt idx="910">
                  <c:v>368.6</c:v>
                </c:pt>
                <c:pt idx="911">
                  <c:v>368.4</c:v>
                </c:pt>
                <c:pt idx="912">
                  <c:v>368.2</c:v>
                </c:pt>
                <c:pt idx="913">
                  <c:v>368</c:v>
                </c:pt>
                <c:pt idx="914">
                  <c:v>367.8</c:v>
                </c:pt>
                <c:pt idx="915">
                  <c:v>367.6</c:v>
                </c:pt>
                <c:pt idx="916">
                  <c:v>367.4</c:v>
                </c:pt>
                <c:pt idx="917">
                  <c:v>367.2</c:v>
                </c:pt>
                <c:pt idx="918">
                  <c:v>367</c:v>
                </c:pt>
                <c:pt idx="919">
                  <c:v>366.8</c:v>
                </c:pt>
                <c:pt idx="920">
                  <c:v>366.6</c:v>
                </c:pt>
                <c:pt idx="921">
                  <c:v>366.4</c:v>
                </c:pt>
                <c:pt idx="922">
                  <c:v>366.2</c:v>
                </c:pt>
                <c:pt idx="923">
                  <c:v>366</c:v>
                </c:pt>
                <c:pt idx="924">
                  <c:v>365.8</c:v>
                </c:pt>
                <c:pt idx="925">
                  <c:v>365.6</c:v>
                </c:pt>
                <c:pt idx="926">
                  <c:v>365.4</c:v>
                </c:pt>
                <c:pt idx="927">
                  <c:v>365.2</c:v>
                </c:pt>
                <c:pt idx="928">
                  <c:v>365</c:v>
                </c:pt>
                <c:pt idx="929">
                  <c:v>364.8</c:v>
                </c:pt>
                <c:pt idx="930">
                  <c:v>364.6</c:v>
                </c:pt>
                <c:pt idx="931">
                  <c:v>364.4</c:v>
                </c:pt>
                <c:pt idx="932">
                  <c:v>364.2</c:v>
                </c:pt>
                <c:pt idx="933">
                  <c:v>364</c:v>
                </c:pt>
                <c:pt idx="934">
                  <c:v>363.8</c:v>
                </c:pt>
                <c:pt idx="935">
                  <c:v>363.6</c:v>
                </c:pt>
                <c:pt idx="936">
                  <c:v>363.4</c:v>
                </c:pt>
                <c:pt idx="937">
                  <c:v>363.2</c:v>
                </c:pt>
                <c:pt idx="938">
                  <c:v>363</c:v>
                </c:pt>
                <c:pt idx="939">
                  <c:v>362.8</c:v>
                </c:pt>
                <c:pt idx="940">
                  <c:v>362.6</c:v>
                </c:pt>
                <c:pt idx="941">
                  <c:v>362.4</c:v>
                </c:pt>
                <c:pt idx="942">
                  <c:v>362.2</c:v>
                </c:pt>
                <c:pt idx="943">
                  <c:v>362</c:v>
                </c:pt>
                <c:pt idx="944">
                  <c:v>361.8</c:v>
                </c:pt>
                <c:pt idx="945">
                  <c:v>361.6</c:v>
                </c:pt>
                <c:pt idx="946">
                  <c:v>361.4</c:v>
                </c:pt>
                <c:pt idx="947">
                  <c:v>361.2</c:v>
                </c:pt>
                <c:pt idx="948">
                  <c:v>361</c:v>
                </c:pt>
                <c:pt idx="949">
                  <c:v>360.8</c:v>
                </c:pt>
                <c:pt idx="950">
                  <c:v>360.6</c:v>
                </c:pt>
                <c:pt idx="951">
                  <c:v>360.4</c:v>
                </c:pt>
                <c:pt idx="952">
                  <c:v>360.2</c:v>
                </c:pt>
                <c:pt idx="953">
                  <c:v>360</c:v>
                </c:pt>
                <c:pt idx="954">
                  <c:v>359.8</c:v>
                </c:pt>
                <c:pt idx="955">
                  <c:v>359.6</c:v>
                </c:pt>
                <c:pt idx="956">
                  <c:v>359.4</c:v>
                </c:pt>
                <c:pt idx="957">
                  <c:v>359.2</c:v>
                </c:pt>
                <c:pt idx="958">
                  <c:v>359</c:v>
                </c:pt>
                <c:pt idx="959">
                  <c:v>358.8</c:v>
                </c:pt>
                <c:pt idx="960">
                  <c:v>358.6</c:v>
                </c:pt>
                <c:pt idx="961">
                  <c:v>358.4</c:v>
                </c:pt>
                <c:pt idx="962">
                  <c:v>358.2</c:v>
                </c:pt>
                <c:pt idx="963">
                  <c:v>358</c:v>
                </c:pt>
                <c:pt idx="964">
                  <c:v>357.8</c:v>
                </c:pt>
                <c:pt idx="965">
                  <c:v>357.6</c:v>
                </c:pt>
                <c:pt idx="966">
                  <c:v>357.4</c:v>
                </c:pt>
                <c:pt idx="967">
                  <c:v>357.2</c:v>
                </c:pt>
                <c:pt idx="968">
                  <c:v>357</c:v>
                </c:pt>
                <c:pt idx="969">
                  <c:v>356.8</c:v>
                </c:pt>
                <c:pt idx="970">
                  <c:v>356.6</c:v>
                </c:pt>
                <c:pt idx="971">
                  <c:v>356.4</c:v>
                </c:pt>
                <c:pt idx="972">
                  <c:v>356.2</c:v>
                </c:pt>
                <c:pt idx="973">
                  <c:v>356</c:v>
                </c:pt>
                <c:pt idx="974">
                  <c:v>355.8</c:v>
                </c:pt>
                <c:pt idx="975">
                  <c:v>355.6</c:v>
                </c:pt>
                <c:pt idx="976">
                  <c:v>355.4</c:v>
                </c:pt>
                <c:pt idx="977">
                  <c:v>355.2</c:v>
                </c:pt>
                <c:pt idx="978">
                  <c:v>355</c:v>
                </c:pt>
                <c:pt idx="979">
                  <c:v>354.8</c:v>
                </c:pt>
                <c:pt idx="980">
                  <c:v>354.6</c:v>
                </c:pt>
                <c:pt idx="981">
                  <c:v>354.4</c:v>
                </c:pt>
                <c:pt idx="982">
                  <c:v>354.2</c:v>
                </c:pt>
                <c:pt idx="983">
                  <c:v>354</c:v>
                </c:pt>
                <c:pt idx="984">
                  <c:v>353.8</c:v>
                </c:pt>
                <c:pt idx="985">
                  <c:v>353.6</c:v>
                </c:pt>
                <c:pt idx="986">
                  <c:v>353.4</c:v>
                </c:pt>
                <c:pt idx="987">
                  <c:v>353.2</c:v>
                </c:pt>
                <c:pt idx="988">
                  <c:v>353</c:v>
                </c:pt>
                <c:pt idx="989">
                  <c:v>352.8</c:v>
                </c:pt>
                <c:pt idx="990">
                  <c:v>352.6</c:v>
                </c:pt>
                <c:pt idx="991">
                  <c:v>352.4</c:v>
                </c:pt>
                <c:pt idx="992">
                  <c:v>352.2</c:v>
                </c:pt>
                <c:pt idx="993">
                  <c:v>352</c:v>
                </c:pt>
                <c:pt idx="994">
                  <c:v>351.8</c:v>
                </c:pt>
                <c:pt idx="995">
                  <c:v>351.6</c:v>
                </c:pt>
                <c:pt idx="996">
                  <c:v>351.4</c:v>
                </c:pt>
                <c:pt idx="997">
                  <c:v>351.2</c:v>
                </c:pt>
                <c:pt idx="998">
                  <c:v>351</c:v>
                </c:pt>
                <c:pt idx="999">
                  <c:v>350.8</c:v>
                </c:pt>
                <c:pt idx="1000">
                  <c:v>350.6</c:v>
                </c:pt>
                <c:pt idx="1001">
                  <c:v>350.4</c:v>
                </c:pt>
                <c:pt idx="1002">
                  <c:v>350.2</c:v>
                </c:pt>
                <c:pt idx="1003">
                  <c:v>350</c:v>
                </c:pt>
                <c:pt idx="1004">
                  <c:v>349.8</c:v>
                </c:pt>
                <c:pt idx="1005">
                  <c:v>349.6</c:v>
                </c:pt>
                <c:pt idx="1006">
                  <c:v>349.4</c:v>
                </c:pt>
                <c:pt idx="1007">
                  <c:v>349.2</c:v>
                </c:pt>
                <c:pt idx="1008">
                  <c:v>349</c:v>
                </c:pt>
                <c:pt idx="1009">
                  <c:v>348.8</c:v>
                </c:pt>
                <c:pt idx="1010">
                  <c:v>348.6</c:v>
                </c:pt>
                <c:pt idx="1011">
                  <c:v>348.4</c:v>
                </c:pt>
                <c:pt idx="1012">
                  <c:v>348.2</c:v>
                </c:pt>
                <c:pt idx="1013">
                  <c:v>348</c:v>
                </c:pt>
                <c:pt idx="1014">
                  <c:v>347.8</c:v>
                </c:pt>
                <c:pt idx="1015">
                  <c:v>347.6</c:v>
                </c:pt>
                <c:pt idx="1016">
                  <c:v>347.4</c:v>
                </c:pt>
                <c:pt idx="1017">
                  <c:v>347.2</c:v>
                </c:pt>
                <c:pt idx="1018">
                  <c:v>347</c:v>
                </c:pt>
                <c:pt idx="1019">
                  <c:v>346.8</c:v>
                </c:pt>
                <c:pt idx="1020">
                  <c:v>346.6</c:v>
                </c:pt>
                <c:pt idx="1021">
                  <c:v>346.4</c:v>
                </c:pt>
                <c:pt idx="1022">
                  <c:v>346.2</c:v>
                </c:pt>
                <c:pt idx="1023">
                  <c:v>346</c:v>
                </c:pt>
                <c:pt idx="1024">
                  <c:v>345.8</c:v>
                </c:pt>
                <c:pt idx="1025">
                  <c:v>345.6</c:v>
                </c:pt>
                <c:pt idx="1026">
                  <c:v>345.4</c:v>
                </c:pt>
                <c:pt idx="1027">
                  <c:v>345.2</c:v>
                </c:pt>
                <c:pt idx="1028">
                  <c:v>345</c:v>
                </c:pt>
                <c:pt idx="1029">
                  <c:v>344.8</c:v>
                </c:pt>
                <c:pt idx="1030">
                  <c:v>344.6</c:v>
                </c:pt>
                <c:pt idx="1031">
                  <c:v>344.4</c:v>
                </c:pt>
                <c:pt idx="1032">
                  <c:v>344.2</c:v>
                </c:pt>
                <c:pt idx="1033">
                  <c:v>344</c:v>
                </c:pt>
                <c:pt idx="1034">
                  <c:v>343.8</c:v>
                </c:pt>
                <c:pt idx="1035">
                  <c:v>343.6</c:v>
                </c:pt>
                <c:pt idx="1036">
                  <c:v>343.4</c:v>
                </c:pt>
                <c:pt idx="1037">
                  <c:v>343.2</c:v>
                </c:pt>
                <c:pt idx="1038">
                  <c:v>343</c:v>
                </c:pt>
                <c:pt idx="1039">
                  <c:v>342.8</c:v>
                </c:pt>
                <c:pt idx="1040">
                  <c:v>342.6</c:v>
                </c:pt>
                <c:pt idx="1041">
                  <c:v>342.4</c:v>
                </c:pt>
                <c:pt idx="1042">
                  <c:v>342.2</c:v>
                </c:pt>
                <c:pt idx="1043">
                  <c:v>342</c:v>
                </c:pt>
                <c:pt idx="1044">
                  <c:v>341.8</c:v>
                </c:pt>
                <c:pt idx="1045">
                  <c:v>341.6</c:v>
                </c:pt>
                <c:pt idx="1046">
                  <c:v>341.4</c:v>
                </c:pt>
                <c:pt idx="1047">
                  <c:v>341.2</c:v>
                </c:pt>
                <c:pt idx="1048">
                  <c:v>341</c:v>
                </c:pt>
                <c:pt idx="1049">
                  <c:v>340.8</c:v>
                </c:pt>
                <c:pt idx="1050">
                  <c:v>340.6</c:v>
                </c:pt>
                <c:pt idx="1051">
                  <c:v>340.4</c:v>
                </c:pt>
                <c:pt idx="1052">
                  <c:v>340.2</c:v>
                </c:pt>
                <c:pt idx="1053">
                  <c:v>340</c:v>
                </c:pt>
                <c:pt idx="1054">
                  <c:v>339.8</c:v>
                </c:pt>
                <c:pt idx="1055">
                  <c:v>339.6</c:v>
                </c:pt>
                <c:pt idx="1056">
                  <c:v>339.4</c:v>
                </c:pt>
                <c:pt idx="1057">
                  <c:v>339.2</c:v>
                </c:pt>
                <c:pt idx="1058">
                  <c:v>339</c:v>
                </c:pt>
                <c:pt idx="1059">
                  <c:v>338.8</c:v>
                </c:pt>
                <c:pt idx="1060">
                  <c:v>338.6</c:v>
                </c:pt>
                <c:pt idx="1061">
                  <c:v>338.4</c:v>
                </c:pt>
                <c:pt idx="1062">
                  <c:v>338.2</c:v>
                </c:pt>
                <c:pt idx="1063">
                  <c:v>338</c:v>
                </c:pt>
                <c:pt idx="1064">
                  <c:v>337.8</c:v>
                </c:pt>
                <c:pt idx="1065">
                  <c:v>337.6</c:v>
                </c:pt>
                <c:pt idx="1066">
                  <c:v>337.4</c:v>
                </c:pt>
                <c:pt idx="1067">
                  <c:v>337.2</c:v>
                </c:pt>
                <c:pt idx="1068">
                  <c:v>337</c:v>
                </c:pt>
                <c:pt idx="1069">
                  <c:v>336.8</c:v>
                </c:pt>
                <c:pt idx="1070">
                  <c:v>336.6</c:v>
                </c:pt>
                <c:pt idx="1071">
                  <c:v>336.4</c:v>
                </c:pt>
                <c:pt idx="1072">
                  <c:v>336.2</c:v>
                </c:pt>
                <c:pt idx="1073">
                  <c:v>336</c:v>
                </c:pt>
                <c:pt idx="1074">
                  <c:v>335.8</c:v>
                </c:pt>
                <c:pt idx="1075">
                  <c:v>335.6</c:v>
                </c:pt>
                <c:pt idx="1076">
                  <c:v>335.4</c:v>
                </c:pt>
                <c:pt idx="1077">
                  <c:v>335.2</c:v>
                </c:pt>
                <c:pt idx="1078">
                  <c:v>335</c:v>
                </c:pt>
                <c:pt idx="1079">
                  <c:v>334.8</c:v>
                </c:pt>
                <c:pt idx="1080">
                  <c:v>334.6</c:v>
                </c:pt>
                <c:pt idx="1081">
                  <c:v>334.4</c:v>
                </c:pt>
                <c:pt idx="1082">
                  <c:v>334.2</c:v>
                </c:pt>
                <c:pt idx="1083">
                  <c:v>334</c:v>
                </c:pt>
                <c:pt idx="1084">
                  <c:v>333.8</c:v>
                </c:pt>
                <c:pt idx="1085">
                  <c:v>333.6</c:v>
                </c:pt>
                <c:pt idx="1086">
                  <c:v>333.4</c:v>
                </c:pt>
                <c:pt idx="1087">
                  <c:v>333.2</c:v>
                </c:pt>
                <c:pt idx="1088">
                  <c:v>333</c:v>
                </c:pt>
                <c:pt idx="1089">
                  <c:v>332.8</c:v>
                </c:pt>
                <c:pt idx="1090">
                  <c:v>332.6</c:v>
                </c:pt>
                <c:pt idx="1091">
                  <c:v>332.4</c:v>
                </c:pt>
                <c:pt idx="1092">
                  <c:v>332.2</c:v>
                </c:pt>
                <c:pt idx="1093">
                  <c:v>332</c:v>
                </c:pt>
                <c:pt idx="1094">
                  <c:v>331.8</c:v>
                </c:pt>
                <c:pt idx="1095">
                  <c:v>331.6</c:v>
                </c:pt>
                <c:pt idx="1096">
                  <c:v>331.4</c:v>
                </c:pt>
                <c:pt idx="1097">
                  <c:v>331.2</c:v>
                </c:pt>
                <c:pt idx="1098">
                  <c:v>331</c:v>
                </c:pt>
                <c:pt idx="1099">
                  <c:v>330.8</c:v>
                </c:pt>
                <c:pt idx="1100">
                  <c:v>330.6</c:v>
                </c:pt>
                <c:pt idx="1101">
                  <c:v>330.4</c:v>
                </c:pt>
                <c:pt idx="1102">
                  <c:v>330.2</c:v>
                </c:pt>
                <c:pt idx="1103">
                  <c:v>330</c:v>
                </c:pt>
                <c:pt idx="1104">
                  <c:v>329.8</c:v>
                </c:pt>
                <c:pt idx="1105">
                  <c:v>329.6</c:v>
                </c:pt>
                <c:pt idx="1106">
                  <c:v>329.4</c:v>
                </c:pt>
                <c:pt idx="1107">
                  <c:v>329.2</c:v>
                </c:pt>
                <c:pt idx="1108">
                  <c:v>329</c:v>
                </c:pt>
                <c:pt idx="1109">
                  <c:v>328.8</c:v>
                </c:pt>
                <c:pt idx="1110">
                  <c:v>328.6</c:v>
                </c:pt>
                <c:pt idx="1111">
                  <c:v>328.4</c:v>
                </c:pt>
                <c:pt idx="1112">
                  <c:v>328.2</c:v>
                </c:pt>
                <c:pt idx="1113">
                  <c:v>328</c:v>
                </c:pt>
                <c:pt idx="1114">
                  <c:v>327.8</c:v>
                </c:pt>
                <c:pt idx="1115">
                  <c:v>327.60000000000002</c:v>
                </c:pt>
                <c:pt idx="1116">
                  <c:v>327.39999999999998</c:v>
                </c:pt>
                <c:pt idx="1117">
                  <c:v>327.2</c:v>
                </c:pt>
                <c:pt idx="1118">
                  <c:v>327</c:v>
                </c:pt>
                <c:pt idx="1119">
                  <c:v>326.8</c:v>
                </c:pt>
                <c:pt idx="1120">
                  <c:v>326.60000000000002</c:v>
                </c:pt>
                <c:pt idx="1121">
                  <c:v>326.39999999999998</c:v>
                </c:pt>
                <c:pt idx="1122">
                  <c:v>326.2</c:v>
                </c:pt>
                <c:pt idx="1123">
                  <c:v>326</c:v>
                </c:pt>
                <c:pt idx="1124">
                  <c:v>325.8</c:v>
                </c:pt>
                <c:pt idx="1125">
                  <c:v>325.60000000000002</c:v>
                </c:pt>
                <c:pt idx="1126">
                  <c:v>325.39999999999998</c:v>
                </c:pt>
                <c:pt idx="1127">
                  <c:v>325.2</c:v>
                </c:pt>
                <c:pt idx="1128">
                  <c:v>325</c:v>
                </c:pt>
                <c:pt idx="1129">
                  <c:v>324.8</c:v>
                </c:pt>
                <c:pt idx="1130">
                  <c:v>324.60000000000002</c:v>
                </c:pt>
                <c:pt idx="1131">
                  <c:v>324.39999999999998</c:v>
                </c:pt>
                <c:pt idx="1132">
                  <c:v>324.2</c:v>
                </c:pt>
                <c:pt idx="1133">
                  <c:v>324</c:v>
                </c:pt>
                <c:pt idx="1134">
                  <c:v>323.8</c:v>
                </c:pt>
                <c:pt idx="1135">
                  <c:v>323.60000000000002</c:v>
                </c:pt>
                <c:pt idx="1136">
                  <c:v>323.39999999999998</c:v>
                </c:pt>
                <c:pt idx="1137">
                  <c:v>323.2</c:v>
                </c:pt>
                <c:pt idx="1138">
                  <c:v>323</c:v>
                </c:pt>
                <c:pt idx="1139">
                  <c:v>322.8</c:v>
                </c:pt>
                <c:pt idx="1140">
                  <c:v>322.60000000000002</c:v>
                </c:pt>
                <c:pt idx="1141">
                  <c:v>322.39999999999998</c:v>
                </c:pt>
                <c:pt idx="1142">
                  <c:v>322.2</c:v>
                </c:pt>
                <c:pt idx="1143">
                  <c:v>322</c:v>
                </c:pt>
                <c:pt idx="1144">
                  <c:v>321.8</c:v>
                </c:pt>
                <c:pt idx="1145">
                  <c:v>321.60000000000002</c:v>
                </c:pt>
                <c:pt idx="1146">
                  <c:v>321.39999999999998</c:v>
                </c:pt>
                <c:pt idx="1147">
                  <c:v>321.2</c:v>
                </c:pt>
                <c:pt idx="1148">
                  <c:v>321</c:v>
                </c:pt>
                <c:pt idx="1149">
                  <c:v>320.8</c:v>
                </c:pt>
                <c:pt idx="1150">
                  <c:v>320.60000000000002</c:v>
                </c:pt>
                <c:pt idx="1151">
                  <c:v>320.39999999999998</c:v>
                </c:pt>
                <c:pt idx="1152">
                  <c:v>320.2</c:v>
                </c:pt>
                <c:pt idx="1153">
                  <c:v>320</c:v>
                </c:pt>
                <c:pt idx="1154">
                  <c:v>319.8</c:v>
                </c:pt>
                <c:pt idx="1155">
                  <c:v>319.60000000000002</c:v>
                </c:pt>
                <c:pt idx="1156">
                  <c:v>319.39999999999998</c:v>
                </c:pt>
                <c:pt idx="1157">
                  <c:v>319.2</c:v>
                </c:pt>
                <c:pt idx="1158">
                  <c:v>319</c:v>
                </c:pt>
                <c:pt idx="1159">
                  <c:v>318.8</c:v>
                </c:pt>
                <c:pt idx="1160">
                  <c:v>318.60000000000002</c:v>
                </c:pt>
                <c:pt idx="1161">
                  <c:v>318.39999999999998</c:v>
                </c:pt>
                <c:pt idx="1162">
                  <c:v>318.2</c:v>
                </c:pt>
                <c:pt idx="1163">
                  <c:v>318</c:v>
                </c:pt>
                <c:pt idx="1164">
                  <c:v>317.8</c:v>
                </c:pt>
                <c:pt idx="1165">
                  <c:v>317.60000000000002</c:v>
                </c:pt>
                <c:pt idx="1166">
                  <c:v>317.39999999999998</c:v>
                </c:pt>
                <c:pt idx="1167">
                  <c:v>317.2</c:v>
                </c:pt>
                <c:pt idx="1168">
                  <c:v>317</c:v>
                </c:pt>
                <c:pt idx="1169">
                  <c:v>316.8</c:v>
                </c:pt>
                <c:pt idx="1170">
                  <c:v>316.60000000000002</c:v>
                </c:pt>
                <c:pt idx="1171">
                  <c:v>316.39999999999998</c:v>
                </c:pt>
                <c:pt idx="1172">
                  <c:v>316.2</c:v>
                </c:pt>
                <c:pt idx="1173">
                  <c:v>316</c:v>
                </c:pt>
                <c:pt idx="1174">
                  <c:v>315.8</c:v>
                </c:pt>
                <c:pt idx="1175">
                  <c:v>315.60000000000002</c:v>
                </c:pt>
                <c:pt idx="1176">
                  <c:v>315.39999999999998</c:v>
                </c:pt>
                <c:pt idx="1177">
                  <c:v>315.2</c:v>
                </c:pt>
                <c:pt idx="1178">
                  <c:v>315</c:v>
                </c:pt>
                <c:pt idx="1179">
                  <c:v>314.8</c:v>
                </c:pt>
                <c:pt idx="1180">
                  <c:v>314.60000000000002</c:v>
                </c:pt>
                <c:pt idx="1181">
                  <c:v>314.39999999999998</c:v>
                </c:pt>
                <c:pt idx="1182">
                  <c:v>314.2</c:v>
                </c:pt>
                <c:pt idx="1183">
                  <c:v>314</c:v>
                </c:pt>
                <c:pt idx="1184">
                  <c:v>313.8</c:v>
                </c:pt>
                <c:pt idx="1185">
                  <c:v>313.60000000000002</c:v>
                </c:pt>
                <c:pt idx="1186">
                  <c:v>313.39999999999998</c:v>
                </c:pt>
                <c:pt idx="1187">
                  <c:v>313.2</c:v>
                </c:pt>
                <c:pt idx="1188">
                  <c:v>313</c:v>
                </c:pt>
                <c:pt idx="1189">
                  <c:v>312.8</c:v>
                </c:pt>
                <c:pt idx="1190">
                  <c:v>312.60000000000002</c:v>
                </c:pt>
                <c:pt idx="1191">
                  <c:v>312.39999999999998</c:v>
                </c:pt>
                <c:pt idx="1192">
                  <c:v>312.2</c:v>
                </c:pt>
                <c:pt idx="1193">
                  <c:v>312</c:v>
                </c:pt>
                <c:pt idx="1194">
                  <c:v>311.8</c:v>
                </c:pt>
                <c:pt idx="1195">
                  <c:v>311.60000000000002</c:v>
                </c:pt>
                <c:pt idx="1196">
                  <c:v>311.39999999999998</c:v>
                </c:pt>
                <c:pt idx="1197">
                  <c:v>311.2</c:v>
                </c:pt>
                <c:pt idx="1198">
                  <c:v>311</c:v>
                </c:pt>
                <c:pt idx="1199">
                  <c:v>310.8</c:v>
                </c:pt>
                <c:pt idx="1200">
                  <c:v>310.60000000000002</c:v>
                </c:pt>
                <c:pt idx="1201">
                  <c:v>310.39999999999998</c:v>
                </c:pt>
                <c:pt idx="1202">
                  <c:v>310.2</c:v>
                </c:pt>
                <c:pt idx="1203">
                  <c:v>310</c:v>
                </c:pt>
                <c:pt idx="1204">
                  <c:v>309.8</c:v>
                </c:pt>
                <c:pt idx="1205">
                  <c:v>309.60000000000002</c:v>
                </c:pt>
                <c:pt idx="1206">
                  <c:v>309.39999999999998</c:v>
                </c:pt>
                <c:pt idx="1207">
                  <c:v>309.2</c:v>
                </c:pt>
                <c:pt idx="1208">
                  <c:v>309</c:v>
                </c:pt>
                <c:pt idx="1209">
                  <c:v>308.8</c:v>
                </c:pt>
                <c:pt idx="1210">
                  <c:v>308.60000000000002</c:v>
                </c:pt>
                <c:pt idx="1211">
                  <c:v>308.39999999999998</c:v>
                </c:pt>
                <c:pt idx="1212">
                  <c:v>308.2</c:v>
                </c:pt>
                <c:pt idx="1213">
                  <c:v>308</c:v>
                </c:pt>
                <c:pt idx="1214">
                  <c:v>307.8</c:v>
                </c:pt>
                <c:pt idx="1215">
                  <c:v>307.60000000000002</c:v>
                </c:pt>
                <c:pt idx="1216">
                  <c:v>307.39999999999998</c:v>
                </c:pt>
                <c:pt idx="1217">
                  <c:v>307.2</c:v>
                </c:pt>
                <c:pt idx="1218">
                  <c:v>307</c:v>
                </c:pt>
                <c:pt idx="1219">
                  <c:v>306.8</c:v>
                </c:pt>
                <c:pt idx="1220">
                  <c:v>306.60000000000002</c:v>
                </c:pt>
                <c:pt idx="1221">
                  <c:v>306.39999999999998</c:v>
                </c:pt>
                <c:pt idx="1222">
                  <c:v>306.2</c:v>
                </c:pt>
                <c:pt idx="1223">
                  <c:v>306</c:v>
                </c:pt>
                <c:pt idx="1224">
                  <c:v>305.8</c:v>
                </c:pt>
                <c:pt idx="1225">
                  <c:v>305.60000000000002</c:v>
                </c:pt>
                <c:pt idx="1226">
                  <c:v>305.39999999999998</c:v>
                </c:pt>
                <c:pt idx="1227">
                  <c:v>305.2</c:v>
                </c:pt>
                <c:pt idx="1228">
                  <c:v>305</c:v>
                </c:pt>
                <c:pt idx="1229">
                  <c:v>304.8</c:v>
                </c:pt>
                <c:pt idx="1230">
                  <c:v>304.60000000000002</c:v>
                </c:pt>
                <c:pt idx="1231">
                  <c:v>304.39999999999998</c:v>
                </c:pt>
                <c:pt idx="1232">
                  <c:v>304.2</c:v>
                </c:pt>
                <c:pt idx="1233">
                  <c:v>304</c:v>
                </c:pt>
                <c:pt idx="1234">
                  <c:v>303.8</c:v>
                </c:pt>
                <c:pt idx="1235">
                  <c:v>303.60000000000002</c:v>
                </c:pt>
                <c:pt idx="1236">
                  <c:v>303.39999999999998</c:v>
                </c:pt>
                <c:pt idx="1237">
                  <c:v>303.2</c:v>
                </c:pt>
                <c:pt idx="1238">
                  <c:v>303</c:v>
                </c:pt>
                <c:pt idx="1239">
                  <c:v>302.8</c:v>
                </c:pt>
                <c:pt idx="1240">
                  <c:v>302.60000000000002</c:v>
                </c:pt>
                <c:pt idx="1241">
                  <c:v>302.39999999999998</c:v>
                </c:pt>
                <c:pt idx="1242">
                  <c:v>302.2</c:v>
                </c:pt>
                <c:pt idx="1243">
                  <c:v>302</c:v>
                </c:pt>
                <c:pt idx="1244">
                  <c:v>301.8</c:v>
                </c:pt>
                <c:pt idx="1245">
                  <c:v>301.60000000000002</c:v>
                </c:pt>
                <c:pt idx="1246">
                  <c:v>301.39999999999998</c:v>
                </c:pt>
                <c:pt idx="1247">
                  <c:v>301.2</c:v>
                </c:pt>
                <c:pt idx="1248">
                  <c:v>301</c:v>
                </c:pt>
                <c:pt idx="1249">
                  <c:v>300.8</c:v>
                </c:pt>
                <c:pt idx="1250">
                  <c:v>300.60000000000002</c:v>
                </c:pt>
                <c:pt idx="1251">
                  <c:v>300.39999999999998</c:v>
                </c:pt>
                <c:pt idx="1252">
                  <c:v>300.2</c:v>
                </c:pt>
                <c:pt idx="1253">
                  <c:v>300</c:v>
                </c:pt>
              </c:numCache>
            </c:numRef>
          </c:xVal>
          <c:yVal>
            <c:numRef>
              <c:f>Hoja1!$CA$2:$CA$1255</c:f>
              <c:numCache>
                <c:formatCode>General</c:formatCode>
                <c:ptCount val="1254"/>
                <c:pt idx="0">
                  <c:v>0</c:v>
                </c:pt>
                <c:pt idx="1">
                  <c:v>0</c:v>
                </c:pt>
                <c:pt idx="3">
                  <c:v>5.4999999999999979E-3</c:v>
                </c:pt>
                <c:pt idx="4">
                  <c:v>6.7499999999999991E-3</c:v>
                </c:pt>
                <c:pt idx="5">
                  <c:v>8.5499999999999951E-3</c:v>
                </c:pt>
                <c:pt idx="6">
                  <c:v>1.0500000000000002E-2</c:v>
                </c:pt>
                <c:pt idx="7">
                  <c:v>1.2549999999999999E-2</c:v>
                </c:pt>
                <c:pt idx="8">
                  <c:v>1.4450000000000005E-2</c:v>
                </c:pt>
                <c:pt idx="9">
                  <c:v>1.6500000000000001E-2</c:v>
                </c:pt>
                <c:pt idx="10">
                  <c:v>1.8500000000000003E-2</c:v>
                </c:pt>
                <c:pt idx="11">
                  <c:v>2.0449999999999996E-2</c:v>
                </c:pt>
                <c:pt idx="12">
                  <c:v>2.2500000000000006E-2</c:v>
                </c:pt>
                <c:pt idx="13">
                  <c:v>2.4650000000000005E-2</c:v>
                </c:pt>
                <c:pt idx="14">
                  <c:v>2.6749999999999996E-2</c:v>
                </c:pt>
                <c:pt idx="15">
                  <c:v>2.8699999999999989E-2</c:v>
                </c:pt>
                <c:pt idx="16">
                  <c:v>3.0950000000000005E-2</c:v>
                </c:pt>
                <c:pt idx="17">
                  <c:v>3.3199999999999993E-2</c:v>
                </c:pt>
                <c:pt idx="18">
                  <c:v>3.5400000000000001E-2</c:v>
                </c:pt>
                <c:pt idx="19">
                  <c:v>3.7750000000000006E-2</c:v>
                </c:pt>
                <c:pt idx="20">
                  <c:v>4.0100000000000011E-2</c:v>
                </c:pt>
                <c:pt idx="21">
                  <c:v>4.2399999999999993E-2</c:v>
                </c:pt>
                <c:pt idx="22">
                  <c:v>4.4749999999999998E-2</c:v>
                </c:pt>
                <c:pt idx="23">
                  <c:v>4.7099999999999989E-2</c:v>
                </c:pt>
                <c:pt idx="24">
                  <c:v>4.9449999999999994E-2</c:v>
                </c:pt>
                <c:pt idx="25">
                  <c:v>5.1799999999999999E-2</c:v>
                </c:pt>
                <c:pt idx="26">
                  <c:v>5.4199999999999998E-2</c:v>
                </c:pt>
                <c:pt idx="27">
                  <c:v>5.6650000000000006E-2</c:v>
                </c:pt>
                <c:pt idx="28">
                  <c:v>5.9249999999999997E-2</c:v>
                </c:pt>
                <c:pt idx="29">
                  <c:v>6.1899999999999997E-2</c:v>
                </c:pt>
                <c:pt idx="30">
                  <c:v>6.4549999999999996E-2</c:v>
                </c:pt>
                <c:pt idx="31">
                  <c:v>6.7150000000000001E-2</c:v>
                </c:pt>
                <c:pt idx="32">
                  <c:v>6.9849999999999995E-2</c:v>
                </c:pt>
                <c:pt idx="33">
                  <c:v>7.2599999999999998E-2</c:v>
                </c:pt>
                <c:pt idx="34">
                  <c:v>7.535E-2</c:v>
                </c:pt>
                <c:pt idx="35">
                  <c:v>7.8049999999999994E-2</c:v>
                </c:pt>
                <c:pt idx="36">
                  <c:v>8.0949999999999994E-2</c:v>
                </c:pt>
                <c:pt idx="37">
                  <c:v>8.3849999999999994E-2</c:v>
                </c:pt>
                <c:pt idx="38">
                  <c:v>8.6800000000000002E-2</c:v>
                </c:pt>
                <c:pt idx="39">
                  <c:v>8.9599999999999999E-2</c:v>
                </c:pt>
                <c:pt idx="40">
                  <c:v>9.2600000000000002E-2</c:v>
                </c:pt>
                <c:pt idx="41">
                  <c:v>9.5699999999999993E-2</c:v>
                </c:pt>
                <c:pt idx="42">
                  <c:v>9.8849999999999993E-2</c:v>
                </c:pt>
                <c:pt idx="43">
                  <c:v>0.10195</c:v>
                </c:pt>
                <c:pt idx="44">
                  <c:v>0.105</c:v>
                </c:pt>
                <c:pt idx="45">
                  <c:v>0.10805000000000001</c:v>
                </c:pt>
                <c:pt idx="46">
                  <c:v>0.11120000000000001</c:v>
                </c:pt>
                <c:pt idx="47">
                  <c:v>0.11425</c:v>
                </c:pt>
                <c:pt idx="48">
                  <c:v>0.11735000000000001</c:v>
                </c:pt>
                <c:pt idx="49">
                  <c:v>0.12054999999999999</c:v>
                </c:pt>
                <c:pt idx="50">
                  <c:v>0.12380000000000002</c:v>
                </c:pt>
                <c:pt idx="51">
                  <c:v>0.12705</c:v>
                </c:pt>
                <c:pt idx="52">
                  <c:v>0.1303</c:v>
                </c:pt>
                <c:pt idx="53">
                  <c:v>0.13355</c:v>
                </c:pt>
                <c:pt idx="54">
                  <c:v>0.1368</c:v>
                </c:pt>
                <c:pt idx="55">
                  <c:v>0.1401</c:v>
                </c:pt>
                <c:pt idx="56">
                  <c:v>0.14344999999999999</c:v>
                </c:pt>
                <c:pt idx="57">
                  <c:v>0.14665</c:v>
                </c:pt>
                <c:pt idx="58">
                  <c:v>0.14995000000000003</c:v>
                </c:pt>
                <c:pt idx="59">
                  <c:v>0.1532</c:v>
                </c:pt>
                <c:pt idx="60">
                  <c:v>0.1565</c:v>
                </c:pt>
                <c:pt idx="61">
                  <c:v>0.15980000000000003</c:v>
                </c:pt>
                <c:pt idx="62">
                  <c:v>0.16310000000000002</c:v>
                </c:pt>
                <c:pt idx="63">
                  <c:v>0.16655000000000003</c:v>
                </c:pt>
                <c:pt idx="64">
                  <c:v>0.16995000000000002</c:v>
                </c:pt>
                <c:pt idx="65">
                  <c:v>0.17365</c:v>
                </c:pt>
                <c:pt idx="66">
                  <c:v>0.17715</c:v>
                </c:pt>
                <c:pt idx="67">
                  <c:v>0.18065000000000001</c:v>
                </c:pt>
                <c:pt idx="68">
                  <c:v>0.18410000000000001</c:v>
                </c:pt>
                <c:pt idx="69">
                  <c:v>0.18755000000000002</c:v>
                </c:pt>
                <c:pt idx="70">
                  <c:v>0.19095000000000001</c:v>
                </c:pt>
                <c:pt idx="71">
                  <c:v>0.19420000000000001</c:v>
                </c:pt>
                <c:pt idx="72">
                  <c:v>0.19745000000000001</c:v>
                </c:pt>
                <c:pt idx="73">
                  <c:v>0.20060000000000003</c:v>
                </c:pt>
                <c:pt idx="74">
                  <c:v>0.20385</c:v>
                </c:pt>
                <c:pt idx="75">
                  <c:v>0.20715</c:v>
                </c:pt>
                <c:pt idx="76">
                  <c:v>0.21050000000000002</c:v>
                </c:pt>
                <c:pt idx="77">
                  <c:v>0.21385000000000001</c:v>
                </c:pt>
                <c:pt idx="78">
                  <c:v>0.2172</c:v>
                </c:pt>
                <c:pt idx="79">
                  <c:v>0.22045000000000001</c:v>
                </c:pt>
                <c:pt idx="80">
                  <c:v>0.22380000000000003</c:v>
                </c:pt>
                <c:pt idx="81">
                  <c:v>0.22705</c:v>
                </c:pt>
                <c:pt idx="82">
                  <c:v>0.2303</c:v>
                </c:pt>
                <c:pt idx="83">
                  <c:v>0.2336</c:v>
                </c:pt>
                <c:pt idx="84">
                  <c:v>0.23675000000000002</c:v>
                </c:pt>
                <c:pt idx="85">
                  <c:v>0.24000000000000002</c:v>
                </c:pt>
                <c:pt idx="86">
                  <c:v>0.24330000000000002</c:v>
                </c:pt>
                <c:pt idx="87">
                  <c:v>0.2465</c:v>
                </c:pt>
                <c:pt idx="88">
                  <c:v>0.24985000000000002</c:v>
                </c:pt>
                <c:pt idx="89">
                  <c:v>0.25290000000000001</c:v>
                </c:pt>
                <c:pt idx="90">
                  <c:v>0.25590000000000002</c:v>
                </c:pt>
                <c:pt idx="91">
                  <c:v>0.25880000000000003</c:v>
                </c:pt>
                <c:pt idx="92">
                  <c:v>0.26180000000000003</c:v>
                </c:pt>
                <c:pt idx="93">
                  <c:v>0.26485000000000003</c:v>
                </c:pt>
                <c:pt idx="94">
                  <c:v>0.26775000000000004</c:v>
                </c:pt>
                <c:pt idx="95">
                  <c:v>0.27060000000000006</c:v>
                </c:pt>
                <c:pt idx="96">
                  <c:v>0.27339999999999998</c:v>
                </c:pt>
                <c:pt idx="97">
                  <c:v>0.27625</c:v>
                </c:pt>
                <c:pt idx="98">
                  <c:v>0.27895000000000003</c:v>
                </c:pt>
                <c:pt idx="99">
                  <c:v>0.28200000000000003</c:v>
                </c:pt>
                <c:pt idx="100">
                  <c:v>0.28470000000000001</c:v>
                </c:pt>
                <c:pt idx="101">
                  <c:v>0.28725000000000001</c:v>
                </c:pt>
                <c:pt idx="102">
                  <c:v>0.28985000000000005</c:v>
                </c:pt>
                <c:pt idx="103">
                  <c:v>0.29225000000000001</c:v>
                </c:pt>
                <c:pt idx="104">
                  <c:v>0.29480000000000001</c:v>
                </c:pt>
                <c:pt idx="105">
                  <c:v>0.29710000000000003</c:v>
                </c:pt>
                <c:pt idx="106">
                  <c:v>0.29960000000000003</c:v>
                </c:pt>
                <c:pt idx="107">
                  <c:v>0.3019</c:v>
                </c:pt>
                <c:pt idx="108">
                  <c:v>0.30410000000000004</c:v>
                </c:pt>
                <c:pt idx="109">
                  <c:v>0.30615000000000003</c:v>
                </c:pt>
                <c:pt idx="110">
                  <c:v>0.30815000000000003</c:v>
                </c:pt>
                <c:pt idx="111">
                  <c:v>0.31010000000000004</c:v>
                </c:pt>
                <c:pt idx="112">
                  <c:v>0.31190000000000001</c:v>
                </c:pt>
                <c:pt idx="113">
                  <c:v>0.31390000000000001</c:v>
                </c:pt>
                <c:pt idx="114">
                  <c:v>0.31564999999999999</c:v>
                </c:pt>
                <c:pt idx="115">
                  <c:v>0.31730000000000003</c:v>
                </c:pt>
                <c:pt idx="116">
                  <c:v>0.31889999999999996</c:v>
                </c:pt>
                <c:pt idx="117">
                  <c:v>0.32040000000000002</c:v>
                </c:pt>
                <c:pt idx="118">
                  <c:v>0.32179999999999997</c:v>
                </c:pt>
                <c:pt idx="119">
                  <c:v>0.32315000000000005</c:v>
                </c:pt>
                <c:pt idx="120">
                  <c:v>0.32450000000000001</c:v>
                </c:pt>
                <c:pt idx="121">
                  <c:v>0.3256</c:v>
                </c:pt>
                <c:pt idx="122">
                  <c:v>0.32679999999999998</c:v>
                </c:pt>
                <c:pt idx="123">
                  <c:v>0.32765</c:v>
                </c:pt>
                <c:pt idx="124">
                  <c:v>0.32855000000000001</c:v>
                </c:pt>
                <c:pt idx="125">
                  <c:v>0.32930000000000004</c:v>
                </c:pt>
                <c:pt idx="126">
                  <c:v>0.33010000000000006</c:v>
                </c:pt>
                <c:pt idx="127">
                  <c:v>0.33084999999999998</c:v>
                </c:pt>
                <c:pt idx="128">
                  <c:v>0.33155000000000001</c:v>
                </c:pt>
                <c:pt idx="129">
                  <c:v>0.33210000000000001</c:v>
                </c:pt>
                <c:pt idx="130">
                  <c:v>0.33255000000000001</c:v>
                </c:pt>
                <c:pt idx="131">
                  <c:v>0.33305000000000001</c:v>
                </c:pt>
                <c:pt idx="132">
                  <c:v>0.33340000000000003</c:v>
                </c:pt>
                <c:pt idx="133">
                  <c:v>0.33360000000000001</c:v>
                </c:pt>
                <c:pt idx="134">
                  <c:v>0.33365</c:v>
                </c:pt>
                <c:pt idx="135">
                  <c:v>0.33374999999999999</c:v>
                </c:pt>
                <c:pt idx="136">
                  <c:v>0.33384999999999998</c:v>
                </c:pt>
                <c:pt idx="137">
                  <c:v>0.33390000000000003</c:v>
                </c:pt>
                <c:pt idx="138">
                  <c:v>0.33385000000000004</c:v>
                </c:pt>
                <c:pt idx="139">
                  <c:v>0.33374999999999999</c:v>
                </c:pt>
                <c:pt idx="140">
                  <c:v>0.33360000000000001</c:v>
                </c:pt>
                <c:pt idx="141">
                  <c:v>0.33330000000000004</c:v>
                </c:pt>
                <c:pt idx="142">
                  <c:v>0.33299999999999996</c:v>
                </c:pt>
                <c:pt idx="143">
                  <c:v>0.33255000000000001</c:v>
                </c:pt>
                <c:pt idx="144">
                  <c:v>0.33210000000000001</c:v>
                </c:pt>
                <c:pt idx="145">
                  <c:v>0.33160000000000001</c:v>
                </c:pt>
                <c:pt idx="146">
                  <c:v>0.33095000000000002</c:v>
                </c:pt>
                <c:pt idx="147">
                  <c:v>0.33050000000000002</c:v>
                </c:pt>
                <c:pt idx="148">
                  <c:v>0.32974999999999999</c:v>
                </c:pt>
                <c:pt idx="149">
                  <c:v>0.3291</c:v>
                </c:pt>
                <c:pt idx="150">
                  <c:v>0.32830000000000004</c:v>
                </c:pt>
                <c:pt idx="151">
                  <c:v>0.3276</c:v>
                </c:pt>
                <c:pt idx="152">
                  <c:v>0.32674999999999998</c:v>
                </c:pt>
                <c:pt idx="153">
                  <c:v>0.32600000000000001</c:v>
                </c:pt>
                <c:pt idx="154">
                  <c:v>0.32520000000000004</c:v>
                </c:pt>
                <c:pt idx="155">
                  <c:v>0.32435000000000003</c:v>
                </c:pt>
                <c:pt idx="156">
                  <c:v>0.32340000000000002</c:v>
                </c:pt>
                <c:pt idx="157">
                  <c:v>0.32245000000000001</c:v>
                </c:pt>
                <c:pt idx="158">
                  <c:v>0.32145000000000001</c:v>
                </c:pt>
                <c:pt idx="159">
                  <c:v>0.32040000000000002</c:v>
                </c:pt>
                <c:pt idx="160">
                  <c:v>0.31940000000000002</c:v>
                </c:pt>
                <c:pt idx="161">
                  <c:v>0.31830000000000003</c:v>
                </c:pt>
                <c:pt idx="162">
                  <c:v>0.31740000000000002</c:v>
                </c:pt>
                <c:pt idx="163">
                  <c:v>0.31635000000000002</c:v>
                </c:pt>
                <c:pt idx="164">
                  <c:v>0.31530000000000002</c:v>
                </c:pt>
                <c:pt idx="165">
                  <c:v>0.31440000000000001</c:v>
                </c:pt>
                <c:pt idx="166">
                  <c:v>0.31335000000000002</c:v>
                </c:pt>
                <c:pt idx="167">
                  <c:v>0.31235000000000002</c:v>
                </c:pt>
                <c:pt idx="168">
                  <c:v>0.31145</c:v>
                </c:pt>
                <c:pt idx="169">
                  <c:v>0.3105</c:v>
                </c:pt>
                <c:pt idx="170">
                  <c:v>0.30954999999999999</c:v>
                </c:pt>
                <c:pt idx="171">
                  <c:v>0.30865000000000004</c:v>
                </c:pt>
                <c:pt idx="172">
                  <c:v>0.30780000000000002</c:v>
                </c:pt>
                <c:pt idx="173">
                  <c:v>0.30695</c:v>
                </c:pt>
                <c:pt idx="174">
                  <c:v>0.30610000000000004</c:v>
                </c:pt>
                <c:pt idx="175">
                  <c:v>0.30535000000000001</c:v>
                </c:pt>
                <c:pt idx="176">
                  <c:v>0.30459999999999998</c:v>
                </c:pt>
                <c:pt idx="177">
                  <c:v>0.30395</c:v>
                </c:pt>
                <c:pt idx="178">
                  <c:v>0.30325000000000002</c:v>
                </c:pt>
                <c:pt idx="179">
                  <c:v>0.30265000000000003</c:v>
                </c:pt>
                <c:pt idx="180">
                  <c:v>0.30205000000000004</c:v>
                </c:pt>
                <c:pt idx="181">
                  <c:v>0.3014</c:v>
                </c:pt>
                <c:pt idx="182">
                  <c:v>0.30090000000000006</c:v>
                </c:pt>
                <c:pt idx="183">
                  <c:v>0.30035000000000001</c:v>
                </c:pt>
                <c:pt idx="184">
                  <c:v>0.29990000000000006</c:v>
                </c:pt>
                <c:pt idx="185">
                  <c:v>0.29944999999999999</c:v>
                </c:pt>
                <c:pt idx="186">
                  <c:v>0.29905000000000004</c:v>
                </c:pt>
                <c:pt idx="187">
                  <c:v>0.29875000000000002</c:v>
                </c:pt>
                <c:pt idx="188">
                  <c:v>0.29844999999999999</c:v>
                </c:pt>
                <c:pt idx="189">
                  <c:v>0.29825000000000002</c:v>
                </c:pt>
                <c:pt idx="190">
                  <c:v>0.29800000000000004</c:v>
                </c:pt>
                <c:pt idx="191">
                  <c:v>0.29790000000000005</c:v>
                </c:pt>
                <c:pt idx="192">
                  <c:v>0.29780000000000001</c:v>
                </c:pt>
                <c:pt idx="193">
                  <c:v>0.29770000000000002</c:v>
                </c:pt>
                <c:pt idx="194">
                  <c:v>0.29775000000000001</c:v>
                </c:pt>
                <c:pt idx="195">
                  <c:v>0.29785000000000006</c:v>
                </c:pt>
                <c:pt idx="196">
                  <c:v>0.29800000000000004</c:v>
                </c:pt>
                <c:pt idx="197">
                  <c:v>0.29815000000000003</c:v>
                </c:pt>
                <c:pt idx="198">
                  <c:v>0.2984</c:v>
                </c:pt>
                <c:pt idx="199">
                  <c:v>0.29860000000000003</c:v>
                </c:pt>
                <c:pt idx="200">
                  <c:v>0.29894999999999999</c:v>
                </c:pt>
                <c:pt idx="201">
                  <c:v>0.29925000000000002</c:v>
                </c:pt>
                <c:pt idx="202">
                  <c:v>0.29970000000000002</c:v>
                </c:pt>
                <c:pt idx="203">
                  <c:v>0.30020000000000002</c:v>
                </c:pt>
                <c:pt idx="204">
                  <c:v>0.30070000000000002</c:v>
                </c:pt>
                <c:pt idx="205">
                  <c:v>0.3014</c:v>
                </c:pt>
                <c:pt idx="206">
                  <c:v>0.30205000000000004</c:v>
                </c:pt>
                <c:pt idx="207">
                  <c:v>0.30275000000000002</c:v>
                </c:pt>
                <c:pt idx="208">
                  <c:v>0.30354999999999999</c:v>
                </c:pt>
                <c:pt idx="209">
                  <c:v>0.30449999999999999</c:v>
                </c:pt>
                <c:pt idx="210">
                  <c:v>0.3054</c:v>
                </c:pt>
                <c:pt idx="211">
                  <c:v>0.30640000000000001</c:v>
                </c:pt>
                <c:pt idx="212">
                  <c:v>0.30735000000000001</c:v>
                </c:pt>
                <c:pt idx="213">
                  <c:v>0.30840000000000001</c:v>
                </c:pt>
                <c:pt idx="214">
                  <c:v>0.30954999999999999</c:v>
                </c:pt>
                <c:pt idx="215">
                  <c:v>0.31069999999999998</c:v>
                </c:pt>
                <c:pt idx="216">
                  <c:v>0.31190000000000007</c:v>
                </c:pt>
                <c:pt idx="217">
                  <c:v>0.31315000000000004</c:v>
                </c:pt>
                <c:pt idx="218">
                  <c:v>0.31445000000000001</c:v>
                </c:pt>
                <c:pt idx="219">
                  <c:v>0.31590000000000001</c:v>
                </c:pt>
                <c:pt idx="220">
                  <c:v>0.31730000000000003</c:v>
                </c:pt>
                <c:pt idx="221">
                  <c:v>0.31885000000000002</c:v>
                </c:pt>
                <c:pt idx="222">
                  <c:v>0.32045000000000001</c:v>
                </c:pt>
                <c:pt idx="223">
                  <c:v>0.32189999999999996</c:v>
                </c:pt>
                <c:pt idx="224">
                  <c:v>0.32355</c:v>
                </c:pt>
                <c:pt idx="225">
                  <c:v>0.32510000000000006</c:v>
                </c:pt>
                <c:pt idx="226">
                  <c:v>0.32674999999999998</c:v>
                </c:pt>
                <c:pt idx="227">
                  <c:v>0.32850000000000001</c:v>
                </c:pt>
                <c:pt idx="228">
                  <c:v>0.33025000000000004</c:v>
                </c:pt>
                <c:pt idx="229">
                  <c:v>0.33210000000000001</c:v>
                </c:pt>
                <c:pt idx="230">
                  <c:v>0.33400000000000002</c:v>
                </c:pt>
                <c:pt idx="231">
                  <c:v>0.33605000000000002</c:v>
                </c:pt>
                <c:pt idx="232">
                  <c:v>0.33794999999999997</c:v>
                </c:pt>
                <c:pt idx="233">
                  <c:v>0.33994999999999997</c:v>
                </c:pt>
                <c:pt idx="234">
                  <c:v>0.34200000000000003</c:v>
                </c:pt>
                <c:pt idx="235">
                  <c:v>0.34395000000000003</c:v>
                </c:pt>
                <c:pt idx="236">
                  <c:v>0.34605000000000002</c:v>
                </c:pt>
                <c:pt idx="237">
                  <c:v>0.34810000000000002</c:v>
                </c:pt>
                <c:pt idx="238">
                  <c:v>0.35009999999999997</c:v>
                </c:pt>
                <c:pt idx="239">
                  <c:v>0.35220000000000001</c:v>
                </c:pt>
                <c:pt idx="240">
                  <c:v>0.35420000000000001</c:v>
                </c:pt>
                <c:pt idx="241">
                  <c:v>0.35639999999999999</c:v>
                </c:pt>
                <c:pt idx="242">
                  <c:v>0.35855000000000004</c:v>
                </c:pt>
                <c:pt idx="243">
                  <c:v>0.36085</c:v>
                </c:pt>
                <c:pt idx="244">
                  <c:v>0.36304999999999998</c:v>
                </c:pt>
                <c:pt idx="245">
                  <c:v>0.36515000000000003</c:v>
                </c:pt>
                <c:pt idx="246">
                  <c:v>0.36725000000000002</c:v>
                </c:pt>
                <c:pt idx="247">
                  <c:v>0.36945</c:v>
                </c:pt>
                <c:pt idx="248">
                  <c:v>0.37160000000000004</c:v>
                </c:pt>
                <c:pt idx="249">
                  <c:v>0.37385000000000002</c:v>
                </c:pt>
                <c:pt idx="250">
                  <c:v>0.37614999999999998</c:v>
                </c:pt>
                <c:pt idx="251">
                  <c:v>0.37819999999999998</c:v>
                </c:pt>
                <c:pt idx="252">
                  <c:v>0.38040000000000002</c:v>
                </c:pt>
                <c:pt idx="253">
                  <c:v>0.38260000000000005</c:v>
                </c:pt>
                <c:pt idx="254">
                  <c:v>0.38485000000000003</c:v>
                </c:pt>
                <c:pt idx="255">
                  <c:v>0.38705000000000001</c:v>
                </c:pt>
                <c:pt idx="256">
                  <c:v>0.3891</c:v>
                </c:pt>
                <c:pt idx="257">
                  <c:v>0.39125000000000004</c:v>
                </c:pt>
                <c:pt idx="258">
                  <c:v>0.39329999999999998</c:v>
                </c:pt>
                <c:pt idx="259">
                  <c:v>0.39524999999999999</c:v>
                </c:pt>
                <c:pt idx="260">
                  <c:v>0.39734999999999998</c:v>
                </c:pt>
                <c:pt idx="261">
                  <c:v>0.39939999999999998</c:v>
                </c:pt>
                <c:pt idx="262">
                  <c:v>0.40145000000000003</c:v>
                </c:pt>
                <c:pt idx="263">
                  <c:v>0.40335000000000004</c:v>
                </c:pt>
                <c:pt idx="264">
                  <c:v>0.4052</c:v>
                </c:pt>
                <c:pt idx="265">
                  <c:v>0.40704999999999997</c:v>
                </c:pt>
                <c:pt idx="266">
                  <c:v>0.4088</c:v>
                </c:pt>
                <c:pt idx="267">
                  <c:v>0.41050000000000003</c:v>
                </c:pt>
                <c:pt idx="268">
                  <c:v>0.41225000000000006</c:v>
                </c:pt>
                <c:pt idx="269">
                  <c:v>0.41399999999999998</c:v>
                </c:pt>
                <c:pt idx="270">
                  <c:v>0.41555000000000003</c:v>
                </c:pt>
                <c:pt idx="271">
                  <c:v>0.41719999999999996</c:v>
                </c:pt>
                <c:pt idx="272">
                  <c:v>0.41880000000000001</c:v>
                </c:pt>
                <c:pt idx="273">
                  <c:v>0.42025000000000001</c:v>
                </c:pt>
                <c:pt idx="274">
                  <c:v>0.42170000000000002</c:v>
                </c:pt>
                <c:pt idx="275">
                  <c:v>0.42315000000000003</c:v>
                </c:pt>
                <c:pt idx="276">
                  <c:v>0.42455000000000004</c:v>
                </c:pt>
                <c:pt idx="277">
                  <c:v>0.42585000000000001</c:v>
                </c:pt>
                <c:pt idx="278">
                  <c:v>0.42725000000000002</c:v>
                </c:pt>
                <c:pt idx="279">
                  <c:v>0.4284</c:v>
                </c:pt>
                <c:pt idx="280">
                  <c:v>0.42954999999999999</c:v>
                </c:pt>
                <c:pt idx="281">
                  <c:v>0.43059999999999998</c:v>
                </c:pt>
                <c:pt idx="282">
                  <c:v>0.43175000000000002</c:v>
                </c:pt>
                <c:pt idx="283">
                  <c:v>0.43269999999999997</c:v>
                </c:pt>
                <c:pt idx="284">
                  <c:v>0.43359999999999999</c:v>
                </c:pt>
                <c:pt idx="285">
                  <c:v>0.43440000000000001</c:v>
                </c:pt>
                <c:pt idx="286">
                  <c:v>0.43510000000000004</c:v>
                </c:pt>
                <c:pt idx="287">
                  <c:v>0.43575000000000003</c:v>
                </c:pt>
                <c:pt idx="288">
                  <c:v>0.43640000000000001</c:v>
                </c:pt>
                <c:pt idx="289">
                  <c:v>0.43690000000000001</c:v>
                </c:pt>
                <c:pt idx="290">
                  <c:v>0.43745000000000001</c:v>
                </c:pt>
                <c:pt idx="291">
                  <c:v>0.43795000000000001</c:v>
                </c:pt>
                <c:pt idx="292">
                  <c:v>0.43845000000000001</c:v>
                </c:pt>
                <c:pt idx="293">
                  <c:v>0.43890000000000001</c:v>
                </c:pt>
                <c:pt idx="294">
                  <c:v>0.43909999999999999</c:v>
                </c:pt>
                <c:pt idx="295">
                  <c:v>0.43924999999999997</c:v>
                </c:pt>
                <c:pt idx="296">
                  <c:v>0.43934999999999996</c:v>
                </c:pt>
                <c:pt idx="297">
                  <c:v>0.43934999999999996</c:v>
                </c:pt>
                <c:pt idx="298">
                  <c:v>0.43934999999999996</c:v>
                </c:pt>
                <c:pt idx="299">
                  <c:v>0.43929999999999997</c:v>
                </c:pt>
                <c:pt idx="300">
                  <c:v>0.43905</c:v>
                </c:pt>
                <c:pt idx="301">
                  <c:v>0.43890000000000001</c:v>
                </c:pt>
                <c:pt idx="302">
                  <c:v>0.43864999999999998</c:v>
                </c:pt>
                <c:pt idx="303">
                  <c:v>0.43840000000000001</c:v>
                </c:pt>
                <c:pt idx="304">
                  <c:v>0.43805000000000005</c:v>
                </c:pt>
                <c:pt idx="305">
                  <c:v>0.43759999999999999</c:v>
                </c:pt>
                <c:pt idx="306">
                  <c:v>0.43715000000000004</c:v>
                </c:pt>
                <c:pt idx="307">
                  <c:v>0.43659999999999999</c:v>
                </c:pt>
                <c:pt idx="308">
                  <c:v>0.43595</c:v>
                </c:pt>
                <c:pt idx="309">
                  <c:v>0.43535000000000001</c:v>
                </c:pt>
                <c:pt idx="310">
                  <c:v>0.43465000000000004</c:v>
                </c:pt>
                <c:pt idx="311">
                  <c:v>0.43395</c:v>
                </c:pt>
                <c:pt idx="312">
                  <c:v>0.43315000000000003</c:v>
                </c:pt>
                <c:pt idx="313">
                  <c:v>0.43225000000000002</c:v>
                </c:pt>
                <c:pt idx="314">
                  <c:v>0.43124999999999997</c:v>
                </c:pt>
                <c:pt idx="315">
                  <c:v>0.43025000000000002</c:v>
                </c:pt>
                <c:pt idx="316">
                  <c:v>0.42925000000000002</c:v>
                </c:pt>
                <c:pt idx="317">
                  <c:v>0.42814999999999998</c:v>
                </c:pt>
                <c:pt idx="318">
                  <c:v>0.42699999999999999</c:v>
                </c:pt>
                <c:pt idx="319">
                  <c:v>0.4259</c:v>
                </c:pt>
                <c:pt idx="320">
                  <c:v>0.42460000000000003</c:v>
                </c:pt>
                <c:pt idx="321">
                  <c:v>0.42344999999999999</c:v>
                </c:pt>
                <c:pt idx="322">
                  <c:v>0.42215000000000003</c:v>
                </c:pt>
                <c:pt idx="323">
                  <c:v>0.42070000000000002</c:v>
                </c:pt>
                <c:pt idx="324">
                  <c:v>0.41915000000000002</c:v>
                </c:pt>
                <c:pt idx="325">
                  <c:v>0.41775000000000001</c:v>
                </c:pt>
                <c:pt idx="326">
                  <c:v>0.4163</c:v>
                </c:pt>
                <c:pt idx="327">
                  <c:v>0.41490000000000005</c:v>
                </c:pt>
                <c:pt idx="328">
                  <c:v>0.41354999999999997</c:v>
                </c:pt>
                <c:pt idx="329">
                  <c:v>0.41215000000000002</c:v>
                </c:pt>
                <c:pt idx="330">
                  <c:v>0.41075</c:v>
                </c:pt>
                <c:pt idx="331">
                  <c:v>0.4093</c:v>
                </c:pt>
                <c:pt idx="332">
                  <c:v>0.40775</c:v>
                </c:pt>
                <c:pt idx="333">
                  <c:v>0.40620000000000001</c:v>
                </c:pt>
                <c:pt idx="334">
                  <c:v>0.40455000000000002</c:v>
                </c:pt>
                <c:pt idx="335">
                  <c:v>0.40289999999999998</c:v>
                </c:pt>
                <c:pt idx="336">
                  <c:v>0.40125000000000005</c:v>
                </c:pt>
                <c:pt idx="337">
                  <c:v>0.39965000000000001</c:v>
                </c:pt>
                <c:pt idx="338">
                  <c:v>0.39810000000000001</c:v>
                </c:pt>
                <c:pt idx="339">
                  <c:v>0.39650000000000002</c:v>
                </c:pt>
                <c:pt idx="340">
                  <c:v>0.39490000000000003</c:v>
                </c:pt>
                <c:pt idx="341">
                  <c:v>0.39325000000000004</c:v>
                </c:pt>
                <c:pt idx="342">
                  <c:v>0.39165000000000005</c:v>
                </c:pt>
                <c:pt idx="343">
                  <c:v>0.3901</c:v>
                </c:pt>
                <c:pt idx="344">
                  <c:v>0.38860000000000006</c:v>
                </c:pt>
                <c:pt idx="345">
                  <c:v>0.38714999999999999</c:v>
                </c:pt>
                <c:pt idx="346">
                  <c:v>0.38550000000000006</c:v>
                </c:pt>
                <c:pt idx="347">
                  <c:v>0.38385000000000002</c:v>
                </c:pt>
                <c:pt idx="348">
                  <c:v>0.38219999999999998</c:v>
                </c:pt>
                <c:pt idx="349">
                  <c:v>0.38055000000000005</c:v>
                </c:pt>
                <c:pt idx="350">
                  <c:v>0.379</c:v>
                </c:pt>
                <c:pt idx="351">
                  <c:v>0.37755</c:v>
                </c:pt>
                <c:pt idx="352">
                  <c:v>0.37605</c:v>
                </c:pt>
                <c:pt idx="353">
                  <c:v>0.37460000000000004</c:v>
                </c:pt>
                <c:pt idx="354">
                  <c:v>0.37314999999999998</c:v>
                </c:pt>
                <c:pt idx="355">
                  <c:v>0.37170000000000003</c:v>
                </c:pt>
                <c:pt idx="356">
                  <c:v>0.37029999999999996</c:v>
                </c:pt>
                <c:pt idx="357">
                  <c:v>0.36899999999999999</c:v>
                </c:pt>
                <c:pt idx="358">
                  <c:v>0.36765000000000003</c:v>
                </c:pt>
                <c:pt idx="359">
                  <c:v>0.36640000000000006</c:v>
                </c:pt>
                <c:pt idx="360">
                  <c:v>0.36514999999999997</c:v>
                </c:pt>
                <c:pt idx="361">
                  <c:v>0.36395</c:v>
                </c:pt>
                <c:pt idx="362">
                  <c:v>0.36280000000000001</c:v>
                </c:pt>
                <c:pt idx="363">
                  <c:v>0.36150000000000004</c:v>
                </c:pt>
                <c:pt idx="364">
                  <c:v>0.36040000000000005</c:v>
                </c:pt>
                <c:pt idx="365">
                  <c:v>0.35930000000000001</c:v>
                </c:pt>
                <c:pt idx="366">
                  <c:v>0.35809999999999997</c:v>
                </c:pt>
                <c:pt idx="367">
                  <c:v>0.35719999999999996</c:v>
                </c:pt>
                <c:pt idx="368">
                  <c:v>0.35619999999999996</c:v>
                </c:pt>
                <c:pt idx="369">
                  <c:v>0.35519999999999996</c:v>
                </c:pt>
                <c:pt idx="370">
                  <c:v>0.35425000000000001</c:v>
                </c:pt>
                <c:pt idx="371">
                  <c:v>0.35325000000000001</c:v>
                </c:pt>
                <c:pt idx="372">
                  <c:v>0.35240000000000005</c:v>
                </c:pt>
                <c:pt idx="373">
                  <c:v>0.35145000000000004</c:v>
                </c:pt>
                <c:pt idx="374">
                  <c:v>0.35075000000000001</c:v>
                </c:pt>
                <c:pt idx="375">
                  <c:v>0.35004999999999997</c:v>
                </c:pt>
                <c:pt idx="376">
                  <c:v>0.34935000000000005</c:v>
                </c:pt>
                <c:pt idx="377">
                  <c:v>0.34870000000000001</c:v>
                </c:pt>
                <c:pt idx="378">
                  <c:v>0.34799999999999998</c:v>
                </c:pt>
                <c:pt idx="379">
                  <c:v>0.34735000000000005</c:v>
                </c:pt>
                <c:pt idx="380">
                  <c:v>0.34665000000000001</c:v>
                </c:pt>
                <c:pt idx="381">
                  <c:v>0.34609999999999996</c:v>
                </c:pt>
                <c:pt idx="382">
                  <c:v>0.34550000000000003</c:v>
                </c:pt>
                <c:pt idx="383">
                  <c:v>0.34499999999999997</c:v>
                </c:pt>
                <c:pt idx="384">
                  <c:v>0.34460000000000002</c:v>
                </c:pt>
                <c:pt idx="385">
                  <c:v>0.34420000000000001</c:v>
                </c:pt>
                <c:pt idx="386">
                  <c:v>0.34384999999999999</c:v>
                </c:pt>
                <c:pt idx="387">
                  <c:v>0.34340000000000004</c:v>
                </c:pt>
                <c:pt idx="388">
                  <c:v>0.34305000000000002</c:v>
                </c:pt>
                <c:pt idx="389">
                  <c:v>0.3427</c:v>
                </c:pt>
                <c:pt idx="390">
                  <c:v>0.34240000000000004</c:v>
                </c:pt>
                <c:pt idx="391">
                  <c:v>0.34215000000000001</c:v>
                </c:pt>
                <c:pt idx="392">
                  <c:v>0.34199999999999997</c:v>
                </c:pt>
                <c:pt idx="393">
                  <c:v>0.34189999999999998</c:v>
                </c:pt>
                <c:pt idx="394">
                  <c:v>0.34179999999999999</c:v>
                </c:pt>
                <c:pt idx="395">
                  <c:v>0.34160000000000001</c:v>
                </c:pt>
                <c:pt idx="396">
                  <c:v>0.34140000000000004</c:v>
                </c:pt>
                <c:pt idx="397">
                  <c:v>0.34135000000000004</c:v>
                </c:pt>
                <c:pt idx="398">
                  <c:v>0.34125000000000005</c:v>
                </c:pt>
                <c:pt idx="399">
                  <c:v>0.34130000000000005</c:v>
                </c:pt>
                <c:pt idx="400">
                  <c:v>0.34135000000000004</c:v>
                </c:pt>
                <c:pt idx="401">
                  <c:v>0.34135000000000004</c:v>
                </c:pt>
                <c:pt idx="402">
                  <c:v>0.34140000000000004</c:v>
                </c:pt>
                <c:pt idx="403">
                  <c:v>0.3412</c:v>
                </c:pt>
                <c:pt idx="404">
                  <c:v>0.3412</c:v>
                </c:pt>
                <c:pt idx="405">
                  <c:v>0.3412</c:v>
                </c:pt>
                <c:pt idx="406">
                  <c:v>0.34135000000000004</c:v>
                </c:pt>
                <c:pt idx="407">
                  <c:v>0.34155000000000002</c:v>
                </c:pt>
                <c:pt idx="408">
                  <c:v>0.34165000000000001</c:v>
                </c:pt>
                <c:pt idx="409">
                  <c:v>0.34179999999999999</c:v>
                </c:pt>
                <c:pt idx="410">
                  <c:v>0.34189999999999998</c:v>
                </c:pt>
                <c:pt idx="411">
                  <c:v>0.34204999999999997</c:v>
                </c:pt>
                <c:pt idx="412">
                  <c:v>0.34215000000000001</c:v>
                </c:pt>
                <c:pt idx="413">
                  <c:v>0.3422</c:v>
                </c:pt>
                <c:pt idx="414">
                  <c:v>0.34234999999999999</c:v>
                </c:pt>
                <c:pt idx="415">
                  <c:v>0.34245000000000003</c:v>
                </c:pt>
                <c:pt idx="416">
                  <c:v>0.34265000000000001</c:v>
                </c:pt>
                <c:pt idx="417">
                  <c:v>0.34265000000000001</c:v>
                </c:pt>
                <c:pt idx="418">
                  <c:v>0.3427</c:v>
                </c:pt>
                <c:pt idx="419">
                  <c:v>0.34275</c:v>
                </c:pt>
                <c:pt idx="420">
                  <c:v>0.34275</c:v>
                </c:pt>
                <c:pt idx="421">
                  <c:v>0.34284999999999999</c:v>
                </c:pt>
                <c:pt idx="422">
                  <c:v>0.34284999999999999</c:v>
                </c:pt>
                <c:pt idx="423">
                  <c:v>0.34299999999999997</c:v>
                </c:pt>
                <c:pt idx="424">
                  <c:v>0.34299999999999997</c:v>
                </c:pt>
                <c:pt idx="425">
                  <c:v>0.34304999999999997</c:v>
                </c:pt>
                <c:pt idx="426">
                  <c:v>0.34304999999999997</c:v>
                </c:pt>
                <c:pt idx="427">
                  <c:v>0.34299999999999997</c:v>
                </c:pt>
                <c:pt idx="428">
                  <c:v>0.34299999999999997</c:v>
                </c:pt>
                <c:pt idx="429">
                  <c:v>0.34289999999999998</c:v>
                </c:pt>
                <c:pt idx="430">
                  <c:v>0.34279999999999999</c:v>
                </c:pt>
                <c:pt idx="431">
                  <c:v>0.3427</c:v>
                </c:pt>
                <c:pt idx="432">
                  <c:v>0.34250000000000003</c:v>
                </c:pt>
                <c:pt idx="433">
                  <c:v>0.34240000000000004</c:v>
                </c:pt>
                <c:pt idx="434">
                  <c:v>0.3422</c:v>
                </c:pt>
                <c:pt idx="435">
                  <c:v>0.34194999999999998</c:v>
                </c:pt>
                <c:pt idx="436">
                  <c:v>0.34165000000000001</c:v>
                </c:pt>
                <c:pt idx="437">
                  <c:v>0.34140000000000004</c:v>
                </c:pt>
                <c:pt idx="438">
                  <c:v>0.34110000000000001</c:v>
                </c:pt>
                <c:pt idx="439">
                  <c:v>0.34075</c:v>
                </c:pt>
                <c:pt idx="440">
                  <c:v>0.34035000000000004</c:v>
                </c:pt>
                <c:pt idx="441">
                  <c:v>0.33989999999999998</c:v>
                </c:pt>
                <c:pt idx="442">
                  <c:v>0.33945000000000003</c:v>
                </c:pt>
                <c:pt idx="443">
                  <c:v>0.33884999999999998</c:v>
                </c:pt>
                <c:pt idx="444">
                  <c:v>0.33825000000000005</c:v>
                </c:pt>
                <c:pt idx="445">
                  <c:v>0.33765000000000001</c:v>
                </c:pt>
                <c:pt idx="446">
                  <c:v>0.33705000000000002</c:v>
                </c:pt>
                <c:pt idx="447">
                  <c:v>0.33645000000000003</c:v>
                </c:pt>
                <c:pt idx="448">
                  <c:v>0.33595000000000003</c:v>
                </c:pt>
                <c:pt idx="449">
                  <c:v>0.33525000000000005</c:v>
                </c:pt>
                <c:pt idx="450">
                  <c:v>0.33450000000000002</c:v>
                </c:pt>
                <c:pt idx="451">
                  <c:v>0.33379999999999999</c:v>
                </c:pt>
                <c:pt idx="452">
                  <c:v>0.33295000000000002</c:v>
                </c:pt>
                <c:pt idx="453">
                  <c:v>0.33205000000000001</c:v>
                </c:pt>
                <c:pt idx="454">
                  <c:v>0.33130000000000004</c:v>
                </c:pt>
                <c:pt idx="455">
                  <c:v>0.3301</c:v>
                </c:pt>
                <c:pt idx="456">
                  <c:v>0.32915000000000005</c:v>
                </c:pt>
                <c:pt idx="457">
                  <c:v>0.32805000000000006</c:v>
                </c:pt>
                <c:pt idx="458">
                  <c:v>0.32689999999999997</c:v>
                </c:pt>
                <c:pt idx="459">
                  <c:v>0.32584999999999997</c:v>
                </c:pt>
                <c:pt idx="460">
                  <c:v>0.32474999999999998</c:v>
                </c:pt>
                <c:pt idx="461">
                  <c:v>0.3236</c:v>
                </c:pt>
                <c:pt idx="462">
                  <c:v>0.32235000000000003</c:v>
                </c:pt>
                <c:pt idx="463">
                  <c:v>0.32100000000000001</c:v>
                </c:pt>
                <c:pt idx="464">
                  <c:v>0.31980000000000003</c:v>
                </c:pt>
                <c:pt idx="465">
                  <c:v>0.31845000000000001</c:v>
                </c:pt>
                <c:pt idx="466">
                  <c:v>0.31710000000000005</c:v>
                </c:pt>
                <c:pt idx="467">
                  <c:v>0.31569999999999998</c:v>
                </c:pt>
                <c:pt idx="468">
                  <c:v>0.31440000000000001</c:v>
                </c:pt>
                <c:pt idx="469">
                  <c:v>0.31295000000000006</c:v>
                </c:pt>
                <c:pt idx="470">
                  <c:v>0.31154999999999999</c:v>
                </c:pt>
                <c:pt idx="471">
                  <c:v>0.31010000000000004</c:v>
                </c:pt>
                <c:pt idx="472">
                  <c:v>0.30870000000000003</c:v>
                </c:pt>
                <c:pt idx="473">
                  <c:v>0.30740000000000001</c:v>
                </c:pt>
                <c:pt idx="474">
                  <c:v>0.30590000000000001</c:v>
                </c:pt>
                <c:pt idx="475">
                  <c:v>0.30454999999999999</c:v>
                </c:pt>
                <c:pt idx="476">
                  <c:v>0.30315000000000003</c:v>
                </c:pt>
                <c:pt idx="477">
                  <c:v>0.30165000000000003</c:v>
                </c:pt>
                <c:pt idx="478">
                  <c:v>0.30025000000000002</c:v>
                </c:pt>
                <c:pt idx="479">
                  <c:v>0.29890000000000005</c:v>
                </c:pt>
                <c:pt idx="480">
                  <c:v>0.29744999999999999</c:v>
                </c:pt>
                <c:pt idx="481">
                  <c:v>0.29610000000000003</c:v>
                </c:pt>
                <c:pt idx="482">
                  <c:v>0.29464999999999997</c:v>
                </c:pt>
                <c:pt idx="483">
                  <c:v>0.29325000000000001</c:v>
                </c:pt>
                <c:pt idx="484">
                  <c:v>0.29190000000000005</c:v>
                </c:pt>
                <c:pt idx="485">
                  <c:v>0.29049999999999998</c:v>
                </c:pt>
                <c:pt idx="486">
                  <c:v>0.28905000000000003</c:v>
                </c:pt>
                <c:pt idx="487">
                  <c:v>0.28765000000000002</c:v>
                </c:pt>
                <c:pt idx="488">
                  <c:v>0.28615000000000002</c:v>
                </c:pt>
                <c:pt idx="489">
                  <c:v>0.28470000000000001</c:v>
                </c:pt>
                <c:pt idx="490">
                  <c:v>0.28325</c:v>
                </c:pt>
                <c:pt idx="491">
                  <c:v>0.28180000000000005</c:v>
                </c:pt>
                <c:pt idx="492">
                  <c:v>0.28039999999999998</c:v>
                </c:pt>
                <c:pt idx="493">
                  <c:v>0.27900000000000003</c:v>
                </c:pt>
                <c:pt idx="494">
                  <c:v>0.27760000000000001</c:v>
                </c:pt>
                <c:pt idx="495">
                  <c:v>0.27634999999999998</c:v>
                </c:pt>
                <c:pt idx="496">
                  <c:v>0.27495000000000003</c:v>
                </c:pt>
                <c:pt idx="497">
                  <c:v>0.27355000000000002</c:v>
                </c:pt>
                <c:pt idx="498">
                  <c:v>0.2722</c:v>
                </c:pt>
                <c:pt idx="499">
                  <c:v>0.27075000000000005</c:v>
                </c:pt>
                <c:pt idx="500">
                  <c:v>0.26939999999999997</c:v>
                </c:pt>
                <c:pt idx="501">
                  <c:v>0.26805000000000001</c:v>
                </c:pt>
                <c:pt idx="502">
                  <c:v>0.26665</c:v>
                </c:pt>
                <c:pt idx="503">
                  <c:v>0.26545000000000002</c:v>
                </c:pt>
                <c:pt idx="504">
                  <c:v>0.26415</c:v>
                </c:pt>
                <c:pt idx="505">
                  <c:v>0.26275000000000004</c:v>
                </c:pt>
                <c:pt idx="506">
                  <c:v>0.26155</c:v>
                </c:pt>
                <c:pt idx="507">
                  <c:v>0.26030000000000003</c:v>
                </c:pt>
                <c:pt idx="508">
                  <c:v>0.25900000000000001</c:v>
                </c:pt>
                <c:pt idx="509">
                  <c:v>0.25790000000000002</c:v>
                </c:pt>
                <c:pt idx="510">
                  <c:v>0.25670000000000004</c:v>
                </c:pt>
                <c:pt idx="511">
                  <c:v>0.2555</c:v>
                </c:pt>
                <c:pt idx="512">
                  <c:v>0.25419999999999998</c:v>
                </c:pt>
                <c:pt idx="513">
                  <c:v>0.25295000000000001</c:v>
                </c:pt>
                <c:pt idx="514">
                  <c:v>0.25185000000000002</c:v>
                </c:pt>
                <c:pt idx="515">
                  <c:v>0.25065000000000004</c:v>
                </c:pt>
                <c:pt idx="516">
                  <c:v>0.24955000000000002</c:v>
                </c:pt>
                <c:pt idx="517">
                  <c:v>0.24850000000000003</c:v>
                </c:pt>
                <c:pt idx="518">
                  <c:v>0.24740000000000004</c:v>
                </c:pt>
                <c:pt idx="519">
                  <c:v>0.24640000000000004</c:v>
                </c:pt>
                <c:pt idx="520">
                  <c:v>0.24525</c:v>
                </c:pt>
                <c:pt idx="521">
                  <c:v>0.2442</c:v>
                </c:pt>
                <c:pt idx="522">
                  <c:v>0.2432</c:v>
                </c:pt>
                <c:pt idx="523">
                  <c:v>0.24210000000000001</c:v>
                </c:pt>
                <c:pt idx="524">
                  <c:v>0.24105000000000001</c:v>
                </c:pt>
                <c:pt idx="525">
                  <c:v>0.24010000000000001</c:v>
                </c:pt>
                <c:pt idx="526">
                  <c:v>0.23910000000000001</c:v>
                </c:pt>
                <c:pt idx="527">
                  <c:v>0.23815000000000003</c:v>
                </c:pt>
                <c:pt idx="528">
                  <c:v>0.2374</c:v>
                </c:pt>
                <c:pt idx="529">
                  <c:v>0.23650000000000002</c:v>
                </c:pt>
                <c:pt idx="530">
                  <c:v>0.23560000000000003</c:v>
                </c:pt>
                <c:pt idx="531">
                  <c:v>0.23475000000000001</c:v>
                </c:pt>
                <c:pt idx="532">
                  <c:v>0.23380000000000001</c:v>
                </c:pt>
                <c:pt idx="533">
                  <c:v>0.23294999999999999</c:v>
                </c:pt>
                <c:pt idx="534">
                  <c:v>0.23210000000000003</c:v>
                </c:pt>
                <c:pt idx="535">
                  <c:v>0.23120000000000002</c:v>
                </c:pt>
                <c:pt idx="536">
                  <c:v>0.23044999999999999</c:v>
                </c:pt>
                <c:pt idx="537">
                  <c:v>0.22950000000000001</c:v>
                </c:pt>
                <c:pt idx="538">
                  <c:v>0.22875000000000001</c:v>
                </c:pt>
                <c:pt idx="539">
                  <c:v>0.22795000000000001</c:v>
                </c:pt>
                <c:pt idx="540">
                  <c:v>0.22710000000000002</c:v>
                </c:pt>
                <c:pt idx="541">
                  <c:v>0.2263</c:v>
                </c:pt>
                <c:pt idx="542">
                  <c:v>0.22570000000000001</c:v>
                </c:pt>
                <c:pt idx="543">
                  <c:v>0.22500000000000003</c:v>
                </c:pt>
                <c:pt idx="544">
                  <c:v>0.22434999999999999</c:v>
                </c:pt>
                <c:pt idx="545">
                  <c:v>0.22370000000000001</c:v>
                </c:pt>
                <c:pt idx="546">
                  <c:v>0.22305000000000003</c:v>
                </c:pt>
                <c:pt idx="547">
                  <c:v>0.22250000000000003</c:v>
                </c:pt>
                <c:pt idx="548">
                  <c:v>0.22184999999999999</c:v>
                </c:pt>
                <c:pt idx="549">
                  <c:v>0.22110000000000002</c:v>
                </c:pt>
                <c:pt idx="550">
                  <c:v>0.22030000000000002</c:v>
                </c:pt>
                <c:pt idx="551">
                  <c:v>0.21955000000000002</c:v>
                </c:pt>
                <c:pt idx="552">
                  <c:v>0.21885000000000002</c:v>
                </c:pt>
                <c:pt idx="553">
                  <c:v>0.21810000000000002</c:v>
                </c:pt>
                <c:pt idx="554">
                  <c:v>0.21745</c:v>
                </c:pt>
                <c:pt idx="555">
                  <c:v>0.21685000000000001</c:v>
                </c:pt>
                <c:pt idx="556">
                  <c:v>0.21630000000000002</c:v>
                </c:pt>
                <c:pt idx="557">
                  <c:v>0.2155</c:v>
                </c:pt>
                <c:pt idx="558">
                  <c:v>0.21475000000000002</c:v>
                </c:pt>
                <c:pt idx="559">
                  <c:v>0.21420000000000003</c:v>
                </c:pt>
                <c:pt idx="560">
                  <c:v>0.21345</c:v>
                </c:pt>
                <c:pt idx="561">
                  <c:v>0.21285000000000001</c:v>
                </c:pt>
                <c:pt idx="562">
                  <c:v>0.21225000000000002</c:v>
                </c:pt>
                <c:pt idx="563">
                  <c:v>0.21160000000000004</c:v>
                </c:pt>
                <c:pt idx="564">
                  <c:v>0.21085000000000001</c:v>
                </c:pt>
                <c:pt idx="565">
                  <c:v>0.21015000000000003</c:v>
                </c:pt>
                <c:pt idx="566">
                  <c:v>0.2094</c:v>
                </c:pt>
                <c:pt idx="567">
                  <c:v>0.20860000000000004</c:v>
                </c:pt>
                <c:pt idx="568">
                  <c:v>0.20780000000000001</c:v>
                </c:pt>
                <c:pt idx="569">
                  <c:v>0.20710000000000001</c:v>
                </c:pt>
                <c:pt idx="570">
                  <c:v>0.20645000000000002</c:v>
                </c:pt>
                <c:pt idx="571">
                  <c:v>0.20575000000000002</c:v>
                </c:pt>
                <c:pt idx="572">
                  <c:v>0.20520000000000002</c:v>
                </c:pt>
                <c:pt idx="573">
                  <c:v>0.20430000000000001</c:v>
                </c:pt>
                <c:pt idx="574">
                  <c:v>0.2034</c:v>
                </c:pt>
                <c:pt idx="575">
                  <c:v>0.20270000000000002</c:v>
                </c:pt>
                <c:pt idx="576">
                  <c:v>0.20195000000000002</c:v>
                </c:pt>
                <c:pt idx="577">
                  <c:v>0.20125000000000001</c:v>
                </c:pt>
                <c:pt idx="578">
                  <c:v>0.20045000000000002</c:v>
                </c:pt>
                <c:pt idx="579">
                  <c:v>0.1996</c:v>
                </c:pt>
                <c:pt idx="580">
                  <c:v>0.1988</c:v>
                </c:pt>
                <c:pt idx="581">
                  <c:v>0.19795000000000001</c:v>
                </c:pt>
                <c:pt idx="582">
                  <c:v>0.19715000000000002</c:v>
                </c:pt>
                <c:pt idx="583">
                  <c:v>0.19625000000000001</c:v>
                </c:pt>
                <c:pt idx="584">
                  <c:v>0.19545000000000001</c:v>
                </c:pt>
                <c:pt idx="585">
                  <c:v>0.19465000000000002</c:v>
                </c:pt>
                <c:pt idx="586">
                  <c:v>0.19375000000000001</c:v>
                </c:pt>
                <c:pt idx="587">
                  <c:v>0.19284999999999999</c:v>
                </c:pt>
                <c:pt idx="588">
                  <c:v>0.19180000000000003</c:v>
                </c:pt>
                <c:pt idx="589">
                  <c:v>0.19090000000000001</c:v>
                </c:pt>
                <c:pt idx="590">
                  <c:v>0.18990000000000001</c:v>
                </c:pt>
                <c:pt idx="591">
                  <c:v>0.189</c:v>
                </c:pt>
                <c:pt idx="592">
                  <c:v>0.18810000000000002</c:v>
                </c:pt>
                <c:pt idx="593">
                  <c:v>0.18715000000000001</c:v>
                </c:pt>
                <c:pt idx="594">
                  <c:v>0.18635000000000002</c:v>
                </c:pt>
                <c:pt idx="595">
                  <c:v>0.18535000000000001</c:v>
                </c:pt>
                <c:pt idx="596">
                  <c:v>0.18430000000000002</c:v>
                </c:pt>
                <c:pt idx="597">
                  <c:v>0.18325</c:v>
                </c:pt>
                <c:pt idx="598">
                  <c:v>0.18245</c:v>
                </c:pt>
                <c:pt idx="599">
                  <c:v>0.18145000000000003</c:v>
                </c:pt>
                <c:pt idx="600">
                  <c:v>0.18045000000000003</c:v>
                </c:pt>
                <c:pt idx="601">
                  <c:v>0.17935000000000004</c:v>
                </c:pt>
                <c:pt idx="602">
                  <c:v>0.1782</c:v>
                </c:pt>
                <c:pt idx="603">
                  <c:v>0.17725000000000002</c:v>
                </c:pt>
                <c:pt idx="604">
                  <c:v>0.17625000000000002</c:v>
                </c:pt>
                <c:pt idx="605">
                  <c:v>0.17520000000000002</c:v>
                </c:pt>
                <c:pt idx="606">
                  <c:v>0.17425000000000002</c:v>
                </c:pt>
                <c:pt idx="607">
                  <c:v>0.17315</c:v>
                </c:pt>
                <c:pt idx="608">
                  <c:v>0.17205000000000001</c:v>
                </c:pt>
                <c:pt idx="609">
                  <c:v>0.17105000000000001</c:v>
                </c:pt>
                <c:pt idx="610">
                  <c:v>0.16995000000000002</c:v>
                </c:pt>
                <c:pt idx="611">
                  <c:v>0.16890000000000002</c:v>
                </c:pt>
                <c:pt idx="612">
                  <c:v>0.16780000000000003</c:v>
                </c:pt>
                <c:pt idx="613">
                  <c:v>0.16675000000000001</c:v>
                </c:pt>
                <c:pt idx="614">
                  <c:v>0.16550000000000001</c:v>
                </c:pt>
                <c:pt idx="615">
                  <c:v>0.16445000000000001</c:v>
                </c:pt>
                <c:pt idx="616">
                  <c:v>0.16355000000000003</c:v>
                </c:pt>
                <c:pt idx="617">
                  <c:v>0.16240000000000002</c:v>
                </c:pt>
                <c:pt idx="618">
                  <c:v>0.16135000000000002</c:v>
                </c:pt>
                <c:pt idx="619">
                  <c:v>0.16030000000000003</c:v>
                </c:pt>
                <c:pt idx="620">
                  <c:v>0.15935000000000002</c:v>
                </c:pt>
                <c:pt idx="621">
                  <c:v>0.15840000000000001</c:v>
                </c:pt>
                <c:pt idx="622">
                  <c:v>0.15735000000000002</c:v>
                </c:pt>
                <c:pt idx="623">
                  <c:v>0.15620000000000001</c:v>
                </c:pt>
                <c:pt idx="624">
                  <c:v>0.15490000000000001</c:v>
                </c:pt>
                <c:pt idx="625">
                  <c:v>0.15375</c:v>
                </c:pt>
                <c:pt idx="626">
                  <c:v>0.15255000000000002</c:v>
                </c:pt>
                <c:pt idx="627">
                  <c:v>0.15165000000000001</c:v>
                </c:pt>
                <c:pt idx="628">
                  <c:v>0.15055000000000002</c:v>
                </c:pt>
                <c:pt idx="629">
                  <c:v>0.14965000000000001</c:v>
                </c:pt>
                <c:pt idx="630">
                  <c:v>0.14885000000000001</c:v>
                </c:pt>
                <c:pt idx="631">
                  <c:v>0.14765000000000003</c:v>
                </c:pt>
                <c:pt idx="632">
                  <c:v>0.14675000000000002</c:v>
                </c:pt>
                <c:pt idx="633">
                  <c:v>0.14575000000000002</c:v>
                </c:pt>
                <c:pt idx="634">
                  <c:v>0.14460000000000003</c:v>
                </c:pt>
                <c:pt idx="635">
                  <c:v>0.14375000000000002</c:v>
                </c:pt>
                <c:pt idx="636">
                  <c:v>0.14270000000000002</c:v>
                </c:pt>
                <c:pt idx="637">
                  <c:v>0.14165000000000003</c:v>
                </c:pt>
                <c:pt idx="638">
                  <c:v>0.14085</c:v>
                </c:pt>
                <c:pt idx="639">
                  <c:v>0.13994999999999999</c:v>
                </c:pt>
                <c:pt idx="640">
                  <c:v>0.13894999999999999</c:v>
                </c:pt>
                <c:pt idx="641">
                  <c:v>0.13789999999999999</c:v>
                </c:pt>
                <c:pt idx="642">
                  <c:v>0.1368</c:v>
                </c:pt>
                <c:pt idx="643">
                  <c:v>0.13575000000000001</c:v>
                </c:pt>
                <c:pt idx="644">
                  <c:v>0.13489999999999999</c:v>
                </c:pt>
                <c:pt idx="645">
                  <c:v>0.13404999999999997</c:v>
                </c:pt>
                <c:pt idx="646">
                  <c:v>0.13314999999999999</c:v>
                </c:pt>
                <c:pt idx="647">
                  <c:v>0.13235</c:v>
                </c:pt>
                <c:pt idx="648">
                  <c:v>0.13144999999999998</c:v>
                </c:pt>
                <c:pt idx="649">
                  <c:v>0.13064999999999999</c:v>
                </c:pt>
                <c:pt idx="650">
                  <c:v>0.12969999999999998</c:v>
                </c:pt>
                <c:pt idx="651">
                  <c:v>0.12890000000000001</c:v>
                </c:pt>
                <c:pt idx="652">
                  <c:v>0.12814999999999999</c:v>
                </c:pt>
                <c:pt idx="653">
                  <c:v>0.12719999999999998</c:v>
                </c:pt>
                <c:pt idx="654">
                  <c:v>0.12645000000000001</c:v>
                </c:pt>
                <c:pt idx="655">
                  <c:v>0.12555000000000002</c:v>
                </c:pt>
                <c:pt idx="656">
                  <c:v>0.12465000000000001</c:v>
                </c:pt>
                <c:pt idx="657">
                  <c:v>0.12395</c:v>
                </c:pt>
                <c:pt idx="658">
                  <c:v>0.12315</c:v>
                </c:pt>
                <c:pt idx="659">
                  <c:v>0.1225</c:v>
                </c:pt>
                <c:pt idx="660">
                  <c:v>0.12175000000000001</c:v>
                </c:pt>
                <c:pt idx="661">
                  <c:v>0.12090000000000001</c:v>
                </c:pt>
                <c:pt idx="662">
                  <c:v>0.12015000000000001</c:v>
                </c:pt>
                <c:pt idx="663">
                  <c:v>0.11929999999999999</c:v>
                </c:pt>
                <c:pt idx="664">
                  <c:v>0.11850000000000001</c:v>
                </c:pt>
                <c:pt idx="665">
                  <c:v>0.11785</c:v>
                </c:pt>
                <c:pt idx="666">
                  <c:v>0.11725000000000001</c:v>
                </c:pt>
                <c:pt idx="667">
                  <c:v>0.11649999999999999</c:v>
                </c:pt>
                <c:pt idx="668">
                  <c:v>0.1158</c:v>
                </c:pt>
                <c:pt idx="669">
                  <c:v>0.1148</c:v>
                </c:pt>
                <c:pt idx="670">
                  <c:v>0.11399999999999999</c:v>
                </c:pt>
                <c:pt idx="671">
                  <c:v>0.11175</c:v>
                </c:pt>
                <c:pt idx="672">
                  <c:v>0.10975</c:v>
                </c:pt>
                <c:pt idx="673">
                  <c:v>0.10754999999999999</c:v>
                </c:pt>
                <c:pt idx="674">
                  <c:v>0.10529999999999999</c:v>
                </c:pt>
                <c:pt idx="675">
                  <c:v>0.1047</c:v>
                </c:pt>
                <c:pt idx="676">
                  <c:v>0.10395</c:v>
                </c:pt>
                <c:pt idx="677">
                  <c:v>0.10335</c:v>
                </c:pt>
                <c:pt idx="678">
                  <c:v>0.10265000000000001</c:v>
                </c:pt>
                <c:pt idx="679">
                  <c:v>0.1018</c:v>
                </c:pt>
                <c:pt idx="680">
                  <c:v>0.10099999999999999</c:v>
                </c:pt>
                <c:pt idx="681">
                  <c:v>0.10014999999999999</c:v>
                </c:pt>
                <c:pt idx="682">
                  <c:v>9.9599999999999994E-2</c:v>
                </c:pt>
                <c:pt idx="683">
                  <c:v>9.8949999999999996E-2</c:v>
                </c:pt>
                <c:pt idx="684">
                  <c:v>9.8449999999999996E-2</c:v>
                </c:pt>
                <c:pt idx="685">
                  <c:v>9.7799999999999998E-2</c:v>
                </c:pt>
                <c:pt idx="686">
                  <c:v>9.7100000000000006E-2</c:v>
                </c:pt>
                <c:pt idx="687">
                  <c:v>9.6549999999999997E-2</c:v>
                </c:pt>
                <c:pt idx="688">
                  <c:v>9.6049999999999996E-2</c:v>
                </c:pt>
                <c:pt idx="689">
                  <c:v>9.5549999999999996E-2</c:v>
                </c:pt>
                <c:pt idx="690">
                  <c:v>9.5049999999999996E-2</c:v>
                </c:pt>
                <c:pt idx="691">
                  <c:v>9.4350000000000003E-2</c:v>
                </c:pt>
                <c:pt idx="692">
                  <c:v>9.3700000000000006E-2</c:v>
                </c:pt>
                <c:pt idx="693">
                  <c:v>9.3300000000000008E-2</c:v>
                </c:pt>
                <c:pt idx="694">
                  <c:v>9.2699999999999991E-2</c:v>
                </c:pt>
                <c:pt idx="695">
                  <c:v>9.2249999999999999E-2</c:v>
                </c:pt>
                <c:pt idx="696">
                  <c:v>9.1600000000000001E-2</c:v>
                </c:pt>
                <c:pt idx="697">
                  <c:v>9.0700000000000003E-2</c:v>
                </c:pt>
                <c:pt idx="698">
                  <c:v>9.01E-2</c:v>
                </c:pt>
                <c:pt idx="699">
                  <c:v>8.9249999999999996E-2</c:v>
                </c:pt>
                <c:pt idx="700">
                  <c:v>8.8550000000000004E-2</c:v>
                </c:pt>
                <c:pt idx="701">
                  <c:v>8.8049999999999989E-2</c:v>
                </c:pt>
                <c:pt idx="702">
                  <c:v>8.7649999999999992E-2</c:v>
                </c:pt>
                <c:pt idx="703">
                  <c:v>8.695E-2</c:v>
                </c:pt>
                <c:pt idx="704">
                  <c:v>8.6599999999999996E-2</c:v>
                </c:pt>
                <c:pt idx="705">
                  <c:v>8.5900000000000004E-2</c:v>
                </c:pt>
                <c:pt idx="706">
                  <c:v>8.5100000000000009E-2</c:v>
                </c:pt>
                <c:pt idx="707">
                  <c:v>8.4599999999999995E-2</c:v>
                </c:pt>
                <c:pt idx="708">
                  <c:v>8.3799999999999999E-2</c:v>
                </c:pt>
                <c:pt idx="709">
                  <c:v>8.3150000000000002E-2</c:v>
                </c:pt>
                <c:pt idx="710">
                  <c:v>8.2549999999999998E-2</c:v>
                </c:pt>
                <c:pt idx="711">
                  <c:v>8.1799999999999998E-2</c:v>
                </c:pt>
                <c:pt idx="712">
                  <c:v>8.1299999999999997E-2</c:v>
                </c:pt>
                <c:pt idx="713">
                  <c:v>8.0849999999999991E-2</c:v>
                </c:pt>
                <c:pt idx="714">
                  <c:v>8.0449999999999994E-2</c:v>
                </c:pt>
                <c:pt idx="715">
                  <c:v>7.9699999999999993E-2</c:v>
                </c:pt>
                <c:pt idx="716">
                  <c:v>7.9149999999999998E-2</c:v>
                </c:pt>
                <c:pt idx="717">
                  <c:v>7.85E-2</c:v>
                </c:pt>
                <c:pt idx="718">
                  <c:v>7.8100000000000003E-2</c:v>
                </c:pt>
                <c:pt idx="719">
                  <c:v>7.7600000000000002E-2</c:v>
                </c:pt>
                <c:pt idx="720">
                  <c:v>7.6999999999999999E-2</c:v>
                </c:pt>
                <c:pt idx="721">
                  <c:v>7.6350000000000001E-2</c:v>
                </c:pt>
                <c:pt idx="722">
                  <c:v>7.5799999999999992E-2</c:v>
                </c:pt>
                <c:pt idx="723">
                  <c:v>7.5449999999999989E-2</c:v>
                </c:pt>
                <c:pt idx="724">
                  <c:v>7.4800000000000005E-2</c:v>
                </c:pt>
                <c:pt idx="725">
                  <c:v>7.4300000000000005E-2</c:v>
                </c:pt>
                <c:pt idx="726">
                  <c:v>7.375000000000001E-2</c:v>
                </c:pt>
                <c:pt idx="727">
                  <c:v>7.3150000000000007E-2</c:v>
                </c:pt>
                <c:pt idx="728">
                  <c:v>7.2750000000000009E-2</c:v>
                </c:pt>
                <c:pt idx="729">
                  <c:v>7.2500000000000009E-2</c:v>
                </c:pt>
                <c:pt idx="730">
                  <c:v>7.1849999999999997E-2</c:v>
                </c:pt>
                <c:pt idx="731">
                  <c:v>7.1750000000000008E-2</c:v>
                </c:pt>
                <c:pt idx="732">
                  <c:v>7.1199999999999999E-2</c:v>
                </c:pt>
                <c:pt idx="733">
                  <c:v>7.0699999999999999E-2</c:v>
                </c:pt>
                <c:pt idx="734">
                  <c:v>7.0400000000000004E-2</c:v>
                </c:pt>
                <c:pt idx="735">
                  <c:v>6.9549999999999987E-2</c:v>
                </c:pt>
                <c:pt idx="736">
                  <c:v>6.9199999999999998E-2</c:v>
                </c:pt>
                <c:pt idx="737">
                  <c:v>6.905E-2</c:v>
                </c:pt>
                <c:pt idx="738">
                  <c:v>6.8650000000000003E-2</c:v>
                </c:pt>
                <c:pt idx="739">
                  <c:v>6.8349999999999994E-2</c:v>
                </c:pt>
                <c:pt idx="740">
                  <c:v>6.8099999999999994E-2</c:v>
                </c:pt>
                <c:pt idx="741">
                  <c:v>6.7549999999999999E-2</c:v>
                </c:pt>
                <c:pt idx="742">
                  <c:v>6.7350000000000007E-2</c:v>
                </c:pt>
                <c:pt idx="743">
                  <c:v>6.7000000000000004E-2</c:v>
                </c:pt>
                <c:pt idx="744">
                  <c:v>6.6650000000000001E-2</c:v>
                </c:pt>
                <c:pt idx="745">
                  <c:v>6.6250000000000003E-2</c:v>
                </c:pt>
                <c:pt idx="746">
                  <c:v>6.5950000000000009E-2</c:v>
                </c:pt>
                <c:pt idx="747">
                  <c:v>6.565E-2</c:v>
                </c:pt>
                <c:pt idx="748">
                  <c:v>6.54E-2</c:v>
                </c:pt>
                <c:pt idx="749">
                  <c:v>6.5500000000000003E-2</c:v>
                </c:pt>
                <c:pt idx="750">
                  <c:v>6.5199999999999994E-2</c:v>
                </c:pt>
                <c:pt idx="751">
                  <c:v>6.5049999999999997E-2</c:v>
                </c:pt>
                <c:pt idx="752">
                  <c:v>6.4850000000000005E-2</c:v>
                </c:pt>
                <c:pt idx="753">
                  <c:v>6.4449999999999993E-2</c:v>
                </c:pt>
                <c:pt idx="754">
                  <c:v>6.430000000000001E-2</c:v>
                </c:pt>
                <c:pt idx="755">
                  <c:v>6.409999999999999E-2</c:v>
                </c:pt>
                <c:pt idx="756">
                  <c:v>6.4149999999999999E-2</c:v>
                </c:pt>
                <c:pt idx="757">
                  <c:v>6.4199999999999993E-2</c:v>
                </c:pt>
                <c:pt idx="758">
                  <c:v>6.4149999999999999E-2</c:v>
                </c:pt>
                <c:pt idx="759">
                  <c:v>6.409999999999999E-2</c:v>
                </c:pt>
                <c:pt idx="760">
                  <c:v>6.430000000000001E-2</c:v>
                </c:pt>
                <c:pt idx="761">
                  <c:v>6.4250000000000002E-2</c:v>
                </c:pt>
                <c:pt idx="762">
                  <c:v>6.4149999999999999E-2</c:v>
                </c:pt>
                <c:pt idx="763">
                  <c:v>6.4349999999999991E-2</c:v>
                </c:pt>
                <c:pt idx="764">
                  <c:v>6.4349999999999991E-2</c:v>
                </c:pt>
                <c:pt idx="765">
                  <c:v>6.4549999999999996E-2</c:v>
                </c:pt>
                <c:pt idx="766">
                  <c:v>6.5000000000000002E-2</c:v>
                </c:pt>
                <c:pt idx="767">
                  <c:v>6.5299999999999997E-2</c:v>
                </c:pt>
                <c:pt idx="768">
                  <c:v>6.5750000000000003E-2</c:v>
                </c:pt>
                <c:pt idx="769">
                  <c:v>6.615E-2</c:v>
                </c:pt>
                <c:pt idx="770">
                  <c:v>6.6500000000000004E-2</c:v>
                </c:pt>
                <c:pt idx="771">
                  <c:v>6.6900000000000001E-2</c:v>
                </c:pt>
                <c:pt idx="772">
                  <c:v>6.7150000000000001E-2</c:v>
                </c:pt>
                <c:pt idx="773">
                  <c:v>6.7549999999999999E-2</c:v>
                </c:pt>
                <c:pt idx="774">
                  <c:v>6.7899999999999988E-2</c:v>
                </c:pt>
                <c:pt idx="775">
                  <c:v>6.8399999999999989E-2</c:v>
                </c:pt>
                <c:pt idx="776">
                  <c:v>6.9000000000000006E-2</c:v>
                </c:pt>
                <c:pt idx="777">
                  <c:v>6.9650000000000004E-2</c:v>
                </c:pt>
                <c:pt idx="778">
                  <c:v>7.0349999999999996E-2</c:v>
                </c:pt>
                <c:pt idx="779">
                  <c:v>7.1099999999999997E-2</c:v>
                </c:pt>
                <c:pt idx="780">
                  <c:v>7.195E-2</c:v>
                </c:pt>
                <c:pt idx="781">
                  <c:v>7.2700000000000001E-2</c:v>
                </c:pt>
                <c:pt idx="782">
                  <c:v>7.3450000000000001E-2</c:v>
                </c:pt>
                <c:pt idx="783">
                  <c:v>7.4450000000000002E-2</c:v>
                </c:pt>
                <c:pt idx="784">
                  <c:v>7.5499999999999998E-2</c:v>
                </c:pt>
                <c:pt idx="785">
                  <c:v>7.6700000000000004E-2</c:v>
                </c:pt>
                <c:pt idx="786">
                  <c:v>7.7800000000000008E-2</c:v>
                </c:pt>
                <c:pt idx="787">
                  <c:v>7.9000000000000001E-2</c:v>
                </c:pt>
                <c:pt idx="788">
                  <c:v>7.9949999999999993E-2</c:v>
                </c:pt>
                <c:pt idx="789">
                  <c:v>8.1250000000000003E-2</c:v>
                </c:pt>
                <c:pt idx="790">
                  <c:v>8.2500000000000004E-2</c:v>
                </c:pt>
                <c:pt idx="791">
                  <c:v>8.3399999999999988E-2</c:v>
                </c:pt>
                <c:pt idx="792">
                  <c:v>8.48E-2</c:v>
                </c:pt>
                <c:pt idx="793">
                  <c:v>8.5900000000000004E-2</c:v>
                </c:pt>
                <c:pt idx="794">
                  <c:v>8.7100000000000011E-2</c:v>
                </c:pt>
                <c:pt idx="795">
                  <c:v>8.8350000000000012E-2</c:v>
                </c:pt>
                <c:pt idx="796">
                  <c:v>8.950000000000001E-2</c:v>
                </c:pt>
                <c:pt idx="797">
                  <c:v>9.0749999999999997E-2</c:v>
                </c:pt>
                <c:pt idx="798">
                  <c:v>9.1999999999999998E-2</c:v>
                </c:pt>
                <c:pt idx="799">
                  <c:v>9.3350000000000002E-2</c:v>
                </c:pt>
                <c:pt idx="800">
                  <c:v>9.4450000000000006E-2</c:v>
                </c:pt>
                <c:pt idx="801">
                  <c:v>9.5549999999999996E-2</c:v>
                </c:pt>
                <c:pt idx="802">
                  <c:v>9.7049999999999997E-2</c:v>
                </c:pt>
                <c:pt idx="803">
                  <c:v>9.8199999999999996E-2</c:v>
                </c:pt>
                <c:pt idx="804">
                  <c:v>9.9399999999999988E-2</c:v>
                </c:pt>
                <c:pt idx="805">
                  <c:v>0.10055</c:v>
                </c:pt>
                <c:pt idx="806">
                  <c:v>0.1013</c:v>
                </c:pt>
                <c:pt idx="807">
                  <c:v>0.1027</c:v>
                </c:pt>
                <c:pt idx="808">
                  <c:v>0.1037</c:v>
                </c:pt>
                <c:pt idx="809">
                  <c:v>0.10465000000000001</c:v>
                </c:pt>
                <c:pt idx="810">
                  <c:v>0.10575000000000001</c:v>
                </c:pt>
                <c:pt idx="811">
                  <c:v>0.10654999999999999</c:v>
                </c:pt>
                <c:pt idx="812">
                  <c:v>0.10704999999999999</c:v>
                </c:pt>
                <c:pt idx="813">
                  <c:v>0.10784999999999999</c:v>
                </c:pt>
                <c:pt idx="814">
                  <c:v>0.1081</c:v>
                </c:pt>
                <c:pt idx="815">
                  <c:v>0.10854999999999999</c:v>
                </c:pt>
                <c:pt idx="816">
                  <c:v>0.10925</c:v>
                </c:pt>
                <c:pt idx="817">
                  <c:v>0.10985</c:v>
                </c:pt>
                <c:pt idx="818">
                  <c:v>0.11074999999999999</c:v>
                </c:pt>
                <c:pt idx="819">
                  <c:v>0.11085</c:v>
                </c:pt>
                <c:pt idx="820">
                  <c:v>0.11105000000000001</c:v>
                </c:pt>
                <c:pt idx="821">
                  <c:v>0.11055</c:v>
                </c:pt>
                <c:pt idx="822">
                  <c:v>0.1106</c:v>
                </c:pt>
                <c:pt idx="823">
                  <c:v>0.11035</c:v>
                </c:pt>
                <c:pt idx="824">
                  <c:v>0.1096</c:v>
                </c:pt>
                <c:pt idx="825">
                  <c:v>0.10925</c:v>
                </c:pt>
                <c:pt idx="826">
                  <c:v>0.10804999999999999</c:v>
                </c:pt>
                <c:pt idx="827">
                  <c:v>0.10765</c:v>
                </c:pt>
                <c:pt idx="828">
                  <c:v>0.10685</c:v>
                </c:pt>
                <c:pt idx="829">
                  <c:v>0.1061</c:v>
                </c:pt>
                <c:pt idx="830">
                  <c:v>0.1053</c:v>
                </c:pt>
                <c:pt idx="831">
                  <c:v>0.1041</c:v>
                </c:pt>
                <c:pt idx="832">
                  <c:v>0.10349999999999999</c:v>
                </c:pt>
                <c:pt idx="833">
                  <c:v>0.10274999999999999</c:v>
                </c:pt>
                <c:pt idx="834">
                  <c:v>0.1018</c:v>
                </c:pt>
                <c:pt idx="835">
                  <c:v>0.10085</c:v>
                </c:pt>
                <c:pt idx="836">
                  <c:v>9.98E-2</c:v>
                </c:pt>
                <c:pt idx="837">
                  <c:v>9.8350000000000007E-2</c:v>
                </c:pt>
                <c:pt idx="838">
                  <c:v>9.7100000000000006E-2</c:v>
                </c:pt>
                <c:pt idx="839">
                  <c:v>9.6049999999999996E-2</c:v>
                </c:pt>
                <c:pt idx="840">
                  <c:v>9.4899999999999998E-2</c:v>
                </c:pt>
                <c:pt idx="841">
                  <c:v>9.3799999999999994E-2</c:v>
                </c:pt>
                <c:pt idx="842">
                  <c:v>9.2249999999999999E-2</c:v>
                </c:pt>
                <c:pt idx="843">
                  <c:v>9.0499999999999997E-2</c:v>
                </c:pt>
                <c:pt idx="844">
                  <c:v>8.8950000000000001E-2</c:v>
                </c:pt>
                <c:pt idx="845">
                  <c:v>8.7149999999999991E-2</c:v>
                </c:pt>
                <c:pt idx="846">
                  <c:v>8.5700000000000012E-2</c:v>
                </c:pt>
                <c:pt idx="847">
                  <c:v>8.43E-2</c:v>
                </c:pt>
                <c:pt idx="848">
                  <c:v>8.2900000000000001E-2</c:v>
                </c:pt>
                <c:pt idx="849">
                  <c:v>8.2199999999999995E-2</c:v>
                </c:pt>
                <c:pt idx="850">
                  <c:v>8.1049999999999997E-2</c:v>
                </c:pt>
                <c:pt idx="851">
                  <c:v>7.9850000000000004E-2</c:v>
                </c:pt>
                <c:pt idx="852">
                  <c:v>7.8600000000000003E-2</c:v>
                </c:pt>
                <c:pt idx="853">
                  <c:v>7.7299999999999994E-2</c:v>
                </c:pt>
                <c:pt idx="854">
                  <c:v>7.6100000000000001E-2</c:v>
                </c:pt>
                <c:pt idx="855">
                  <c:v>7.51E-2</c:v>
                </c:pt>
                <c:pt idx="856">
                  <c:v>7.3999999999999996E-2</c:v>
                </c:pt>
                <c:pt idx="857">
                  <c:v>7.2950000000000001E-2</c:v>
                </c:pt>
                <c:pt idx="858">
                  <c:v>7.2000000000000008E-2</c:v>
                </c:pt>
                <c:pt idx="859">
                  <c:v>7.1099999999999997E-2</c:v>
                </c:pt>
                <c:pt idx="860">
                  <c:v>7.0699999999999999E-2</c:v>
                </c:pt>
                <c:pt idx="861">
                  <c:v>7.0250000000000007E-2</c:v>
                </c:pt>
                <c:pt idx="862">
                  <c:v>6.9849999999999995E-2</c:v>
                </c:pt>
                <c:pt idx="863">
                  <c:v>6.9449999999999998E-2</c:v>
                </c:pt>
                <c:pt idx="864">
                  <c:v>6.8749999999999992E-2</c:v>
                </c:pt>
                <c:pt idx="865">
                  <c:v>6.8349999999999994E-2</c:v>
                </c:pt>
                <c:pt idx="866">
                  <c:v>6.7799999999999999E-2</c:v>
                </c:pt>
                <c:pt idx="867">
                  <c:v>6.7299999999999999E-2</c:v>
                </c:pt>
                <c:pt idx="868">
                  <c:v>6.745000000000001E-2</c:v>
                </c:pt>
                <c:pt idx="869">
                  <c:v>6.6850000000000007E-2</c:v>
                </c:pt>
                <c:pt idx="870">
                  <c:v>6.6450000000000009E-2</c:v>
                </c:pt>
                <c:pt idx="871">
                  <c:v>6.6449999999999995E-2</c:v>
                </c:pt>
                <c:pt idx="872">
                  <c:v>6.5500000000000003E-2</c:v>
                </c:pt>
                <c:pt idx="873">
                  <c:v>6.6049999999999998E-2</c:v>
                </c:pt>
                <c:pt idx="874">
                  <c:v>6.5799999999999997E-2</c:v>
                </c:pt>
                <c:pt idx="875">
                  <c:v>6.5550000000000011E-2</c:v>
                </c:pt>
                <c:pt idx="876">
                  <c:v>6.5799999999999997E-2</c:v>
                </c:pt>
                <c:pt idx="877">
                  <c:v>6.5300000000000011E-2</c:v>
                </c:pt>
                <c:pt idx="878">
                  <c:v>6.59E-2</c:v>
                </c:pt>
                <c:pt idx="879">
                  <c:v>6.6049999999999998E-2</c:v>
                </c:pt>
                <c:pt idx="880">
                  <c:v>6.6299999999999998E-2</c:v>
                </c:pt>
                <c:pt idx="881">
                  <c:v>6.695000000000001E-2</c:v>
                </c:pt>
                <c:pt idx="882">
                  <c:v>6.7349999999999993E-2</c:v>
                </c:pt>
                <c:pt idx="883">
                  <c:v>6.7999999999999991E-2</c:v>
                </c:pt>
                <c:pt idx="884">
                  <c:v>6.8650000000000003E-2</c:v>
                </c:pt>
                <c:pt idx="885">
                  <c:v>6.88E-2</c:v>
                </c:pt>
                <c:pt idx="886">
                  <c:v>6.9149999999999989E-2</c:v>
                </c:pt>
                <c:pt idx="887">
                  <c:v>6.9199999999999998E-2</c:v>
                </c:pt>
                <c:pt idx="888">
                  <c:v>6.9099999999999995E-2</c:v>
                </c:pt>
                <c:pt idx="889">
                  <c:v>6.9999999999999993E-2</c:v>
                </c:pt>
                <c:pt idx="890">
                  <c:v>7.0199999999999999E-2</c:v>
                </c:pt>
                <c:pt idx="891">
                  <c:v>7.1000000000000008E-2</c:v>
                </c:pt>
                <c:pt idx="892">
                  <c:v>7.1849999999999997E-2</c:v>
                </c:pt>
                <c:pt idx="893">
                  <c:v>7.2249999999999995E-2</c:v>
                </c:pt>
                <c:pt idx="894">
                  <c:v>7.22E-2</c:v>
                </c:pt>
                <c:pt idx="895">
                  <c:v>7.2650000000000006E-2</c:v>
                </c:pt>
                <c:pt idx="896">
                  <c:v>7.3300000000000004E-2</c:v>
                </c:pt>
                <c:pt idx="897">
                  <c:v>7.3099999999999998E-2</c:v>
                </c:pt>
                <c:pt idx="898">
                  <c:v>7.350000000000001E-2</c:v>
                </c:pt>
                <c:pt idx="899">
                  <c:v>7.3650000000000007E-2</c:v>
                </c:pt>
                <c:pt idx="900">
                  <c:v>7.3450000000000001E-2</c:v>
                </c:pt>
                <c:pt idx="901">
                  <c:v>7.4049999999999991E-2</c:v>
                </c:pt>
                <c:pt idx="902">
                  <c:v>7.4450000000000002E-2</c:v>
                </c:pt>
                <c:pt idx="903">
                  <c:v>7.5149999999999995E-2</c:v>
                </c:pt>
                <c:pt idx="904">
                  <c:v>7.5799999999999992E-2</c:v>
                </c:pt>
                <c:pt idx="905">
                  <c:v>7.5649999999999995E-2</c:v>
                </c:pt>
                <c:pt idx="906">
                  <c:v>7.6049999999999993E-2</c:v>
                </c:pt>
                <c:pt idx="907">
                  <c:v>7.5649999999999995E-2</c:v>
                </c:pt>
                <c:pt idx="908">
                  <c:v>7.535E-2</c:v>
                </c:pt>
                <c:pt idx="909">
                  <c:v>7.5450000000000003E-2</c:v>
                </c:pt>
                <c:pt idx="910">
                  <c:v>7.5300000000000006E-2</c:v>
                </c:pt>
                <c:pt idx="911">
                  <c:v>7.4649999999999994E-2</c:v>
                </c:pt>
                <c:pt idx="912">
                  <c:v>7.5399999999999995E-2</c:v>
                </c:pt>
                <c:pt idx="913">
                  <c:v>7.51E-2</c:v>
                </c:pt>
                <c:pt idx="914">
                  <c:v>7.5400000000000009E-2</c:v>
                </c:pt>
                <c:pt idx="915">
                  <c:v>7.535E-2</c:v>
                </c:pt>
                <c:pt idx="916">
                  <c:v>7.485E-2</c:v>
                </c:pt>
                <c:pt idx="917">
                  <c:v>7.4799999999999991E-2</c:v>
                </c:pt>
                <c:pt idx="918">
                  <c:v>7.4149999999999994E-2</c:v>
                </c:pt>
                <c:pt idx="919">
                  <c:v>7.4650000000000008E-2</c:v>
                </c:pt>
                <c:pt idx="920">
                  <c:v>7.4150000000000008E-2</c:v>
                </c:pt>
                <c:pt idx="921">
                  <c:v>7.3800000000000004E-2</c:v>
                </c:pt>
                <c:pt idx="922">
                  <c:v>7.3650000000000007E-2</c:v>
                </c:pt>
                <c:pt idx="923">
                  <c:v>7.2650000000000006E-2</c:v>
                </c:pt>
                <c:pt idx="924">
                  <c:v>7.22E-2</c:v>
                </c:pt>
                <c:pt idx="925">
                  <c:v>7.145E-2</c:v>
                </c:pt>
                <c:pt idx="926">
                  <c:v>7.1399999999999991E-2</c:v>
                </c:pt>
                <c:pt idx="927">
                  <c:v>7.3300000000000004E-2</c:v>
                </c:pt>
                <c:pt idx="928">
                  <c:v>7.4899999999999994E-2</c:v>
                </c:pt>
                <c:pt idx="929">
                  <c:v>7.6600000000000001E-2</c:v>
                </c:pt>
                <c:pt idx="930">
                  <c:v>7.7949999999999992E-2</c:v>
                </c:pt>
                <c:pt idx="931">
                  <c:v>7.7499999999999999E-2</c:v>
                </c:pt>
                <c:pt idx="932">
                  <c:v>7.6749999999999999E-2</c:v>
                </c:pt>
                <c:pt idx="933">
                  <c:v>7.6749999999999999E-2</c:v>
                </c:pt>
                <c:pt idx="934">
                  <c:v>7.6849999999999988E-2</c:v>
                </c:pt>
                <c:pt idx="935">
                  <c:v>7.6299999999999993E-2</c:v>
                </c:pt>
                <c:pt idx="936">
                  <c:v>7.6050000000000006E-2</c:v>
                </c:pt>
                <c:pt idx="937">
                  <c:v>7.5000000000000011E-2</c:v>
                </c:pt>
                <c:pt idx="938">
                  <c:v>7.3999999999999996E-2</c:v>
                </c:pt>
                <c:pt idx="939">
                  <c:v>7.2800000000000004E-2</c:v>
                </c:pt>
                <c:pt idx="940">
                  <c:v>7.2500000000000009E-2</c:v>
                </c:pt>
                <c:pt idx="941">
                  <c:v>7.1999999999999995E-2</c:v>
                </c:pt>
                <c:pt idx="942">
                  <c:v>7.1549999999999989E-2</c:v>
                </c:pt>
                <c:pt idx="943">
                  <c:v>7.17E-2</c:v>
                </c:pt>
                <c:pt idx="944">
                  <c:v>7.145E-2</c:v>
                </c:pt>
                <c:pt idx="945">
                  <c:v>7.1150000000000005E-2</c:v>
                </c:pt>
                <c:pt idx="946">
                  <c:v>7.0050000000000001E-2</c:v>
                </c:pt>
                <c:pt idx="947">
                  <c:v>6.9550000000000001E-2</c:v>
                </c:pt>
                <c:pt idx="948">
                  <c:v>6.8650000000000003E-2</c:v>
                </c:pt>
                <c:pt idx="949">
                  <c:v>6.7949999999999997E-2</c:v>
                </c:pt>
                <c:pt idx="950">
                  <c:v>6.7799999999999999E-2</c:v>
                </c:pt>
                <c:pt idx="951">
                  <c:v>6.3549999999999995E-2</c:v>
                </c:pt>
                <c:pt idx="952">
                  <c:v>6.1499999999999999E-2</c:v>
                </c:pt>
                <c:pt idx="953">
                  <c:v>5.8050000000000004E-2</c:v>
                </c:pt>
                <c:pt idx="954">
                  <c:v>5.5399999999999991E-2</c:v>
                </c:pt>
                <c:pt idx="955">
                  <c:v>5.62E-2</c:v>
                </c:pt>
                <c:pt idx="956">
                  <c:v>5.5399999999999991E-2</c:v>
                </c:pt>
                <c:pt idx="957">
                  <c:v>5.5599999999999997E-2</c:v>
                </c:pt>
                <c:pt idx="958">
                  <c:v>5.7499999999999996E-2</c:v>
                </c:pt>
                <c:pt idx="959">
                  <c:v>5.7099999999999998E-2</c:v>
                </c:pt>
                <c:pt idx="960">
                  <c:v>5.8199999999999988E-2</c:v>
                </c:pt>
                <c:pt idx="961">
                  <c:v>5.935E-2</c:v>
                </c:pt>
                <c:pt idx="962">
                  <c:v>5.8099999999999999E-2</c:v>
                </c:pt>
                <c:pt idx="963">
                  <c:v>5.9749999999999998E-2</c:v>
                </c:pt>
                <c:pt idx="964">
                  <c:v>0.06</c:v>
                </c:pt>
                <c:pt idx="965">
                  <c:v>5.9249999999999997E-2</c:v>
                </c:pt>
                <c:pt idx="966">
                  <c:v>5.8999999999999997E-2</c:v>
                </c:pt>
                <c:pt idx="967">
                  <c:v>5.8900000000000008E-2</c:v>
                </c:pt>
                <c:pt idx="968">
                  <c:v>5.6749999999999995E-2</c:v>
                </c:pt>
                <c:pt idx="969">
                  <c:v>5.7400000000000007E-2</c:v>
                </c:pt>
                <c:pt idx="970">
                  <c:v>5.7400000000000007E-2</c:v>
                </c:pt>
                <c:pt idx="971">
                  <c:v>5.8399999999999994E-2</c:v>
                </c:pt>
                <c:pt idx="972">
                  <c:v>5.9700000000000003E-2</c:v>
                </c:pt>
                <c:pt idx="973">
                  <c:v>5.9499999999999997E-2</c:v>
                </c:pt>
                <c:pt idx="974">
                  <c:v>5.9649999999999995E-2</c:v>
                </c:pt>
                <c:pt idx="975">
                  <c:v>5.729999999999999E-2</c:v>
                </c:pt>
                <c:pt idx="976">
                  <c:v>5.7149999999999992E-2</c:v>
                </c:pt>
                <c:pt idx="977">
                  <c:v>5.6249999999999994E-2</c:v>
                </c:pt>
                <c:pt idx="978">
                  <c:v>5.5649999999999991E-2</c:v>
                </c:pt>
                <c:pt idx="979">
                  <c:v>5.5850000000000011E-2</c:v>
                </c:pt>
                <c:pt idx="980">
                  <c:v>5.6800000000000003E-2</c:v>
                </c:pt>
                <c:pt idx="981">
                  <c:v>5.7550000000000004E-2</c:v>
                </c:pt>
                <c:pt idx="982">
                  <c:v>5.9049999999999991E-2</c:v>
                </c:pt>
                <c:pt idx="983">
                  <c:v>5.9550000000000006E-2</c:v>
                </c:pt>
                <c:pt idx="984">
                  <c:v>5.9399999999999994E-2</c:v>
                </c:pt>
                <c:pt idx="985">
                  <c:v>6.0450000000000004E-2</c:v>
                </c:pt>
                <c:pt idx="986">
                  <c:v>5.8599999999999999E-2</c:v>
                </c:pt>
                <c:pt idx="987">
                  <c:v>6.0299999999999992E-2</c:v>
                </c:pt>
                <c:pt idx="988">
                  <c:v>6.1199999999999991E-2</c:v>
                </c:pt>
                <c:pt idx="989">
                  <c:v>6.1199999999999991E-2</c:v>
                </c:pt>
                <c:pt idx="990">
                  <c:v>6.3350000000000004E-2</c:v>
                </c:pt>
                <c:pt idx="991">
                  <c:v>6.2399999999999997E-2</c:v>
                </c:pt>
                <c:pt idx="992">
                  <c:v>6.0150000000000009E-2</c:v>
                </c:pt>
                <c:pt idx="993">
                  <c:v>6.0249999999999998E-2</c:v>
                </c:pt>
                <c:pt idx="994">
                  <c:v>5.96E-2</c:v>
                </c:pt>
                <c:pt idx="995">
                  <c:v>6.0300000000000006E-2</c:v>
                </c:pt>
                <c:pt idx="996">
                  <c:v>6.2199999999999991E-2</c:v>
                </c:pt>
                <c:pt idx="997">
                  <c:v>6.225E-2</c:v>
                </c:pt>
                <c:pt idx="998">
                  <c:v>6.4549999999999996E-2</c:v>
                </c:pt>
                <c:pt idx="999">
                  <c:v>6.4149999999999999E-2</c:v>
                </c:pt>
                <c:pt idx="1000">
                  <c:v>6.2799999999999995E-2</c:v>
                </c:pt>
                <c:pt idx="1001">
                  <c:v>6.3299999999999995E-2</c:v>
                </c:pt>
                <c:pt idx="1002">
                  <c:v>6.0799999999999993E-2</c:v>
                </c:pt>
                <c:pt idx="1003">
                  <c:v>6.1100000000000002E-2</c:v>
                </c:pt>
                <c:pt idx="1004">
                  <c:v>6.2550000000000008E-2</c:v>
                </c:pt>
                <c:pt idx="1005">
                  <c:v>6.2699999999999992E-2</c:v>
                </c:pt>
                <c:pt idx="1006">
                  <c:v>6.2699999999999992E-2</c:v>
                </c:pt>
                <c:pt idx="1007">
                  <c:v>6.3199999999999992E-2</c:v>
                </c:pt>
                <c:pt idx="1008">
                  <c:v>6.2699999999999992E-2</c:v>
                </c:pt>
                <c:pt idx="1009">
                  <c:v>6.3350000000000004E-2</c:v>
                </c:pt>
                <c:pt idx="1010">
                  <c:v>6.4399999999999999E-2</c:v>
                </c:pt>
                <c:pt idx="1011">
                  <c:v>6.4700000000000008E-2</c:v>
                </c:pt>
                <c:pt idx="1012">
                  <c:v>6.5250000000000002E-2</c:v>
                </c:pt>
                <c:pt idx="1013">
                  <c:v>6.4349999999999991E-2</c:v>
                </c:pt>
                <c:pt idx="1014">
                  <c:v>6.3750000000000001E-2</c:v>
                </c:pt>
                <c:pt idx="1015">
                  <c:v>6.2800000000000009E-2</c:v>
                </c:pt>
                <c:pt idx="1016">
                  <c:v>6.2099999999999989E-2</c:v>
                </c:pt>
                <c:pt idx="1017">
                  <c:v>6.3200000000000006E-2</c:v>
                </c:pt>
                <c:pt idx="1018">
                  <c:v>6.3450000000000006E-2</c:v>
                </c:pt>
                <c:pt idx="1019">
                  <c:v>6.2849999999999989E-2</c:v>
                </c:pt>
                <c:pt idx="1020">
                  <c:v>6.4799999999999996E-2</c:v>
                </c:pt>
                <c:pt idx="1021">
                  <c:v>6.4250000000000002E-2</c:v>
                </c:pt>
                <c:pt idx="1022">
                  <c:v>6.3600000000000004E-2</c:v>
                </c:pt>
                <c:pt idx="1023">
                  <c:v>6.4100000000000004E-2</c:v>
                </c:pt>
                <c:pt idx="1024">
                  <c:v>6.3049999999999995E-2</c:v>
                </c:pt>
                <c:pt idx="1025">
                  <c:v>6.1649999999999996E-2</c:v>
                </c:pt>
                <c:pt idx="1026">
                  <c:v>6.2400000000000011E-2</c:v>
                </c:pt>
                <c:pt idx="1027">
                  <c:v>6.3500000000000001E-2</c:v>
                </c:pt>
                <c:pt idx="1028">
                  <c:v>6.225E-2</c:v>
                </c:pt>
                <c:pt idx="1029">
                  <c:v>6.3550000000000009E-2</c:v>
                </c:pt>
                <c:pt idx="1030">
                  <c:v>6.3850000000000004E-2</c:v>
                </c:pt>
                <c:pt idx="1031">
                  <c:v>6.3E-2</c:v>
                </c:pt>
                <c:pt idx="1032">
                  <c:v>6.3250000000000001E-2</c:v>
                </c:pt>
                <c:pt idx="1033">
                  <c:v>6.1899999999999997E-2</c:v>
                </c:pt>
                <c:pt idx="1034">
                  <c:v>6.1350000000000002E-2</c:v>
                </c:pt>
                <c:pt idx="1035">
                  <c:v>6.1800000000000008E-2</c:v>
                </c:pt>
                <c:pt idx="1036">
                  <c:v>6.2899999999999998E-2</c:v>
                </c:pt>
                <c:pt idx="1037">
                  <c:v>6.4449999999999993E-2</c:v>
                </c:pt>
                <c:pt idx="1038">
                  <c:v>6.4899999999999999E-2</c:v>
                </c:pt>
                <c:pt idx="1039">
                  <c:v>6.4299999999999996E-2</c:v>
                </c:pt>
                <c:pt idx="1040">
                  <c:v>6.3500000000000001E-2</c:v>
                </c:pt>
                <c:pt idx="1041">
                  <c:v>6.3E-2</c:v>
                </c:pt>
                <c:pt idx="1042">
                  <c:v>6.3200000000000006E-2</c:v>
                </c:pt>
                <c:pt idx="1043">
                  <c:v>6.3200000000000006E-2</c:v>
                </c:pt>
                <c:pt idx="1044">
                  <c:v>6.3750000000000001E-2</c:v>
                </c:pt>
                <c:pt idx="1045">
                  <c:v>6.2299999999999994E-2</c:v>
                </c:pt>
                <c:pt idx="1046">
                  <c:v>6.2900000000000011E-2</c:v>
                </c:pt>
                <c:pt idx="1047">
                  <c:v>6.3100000000000003E-2</c:v>
                </c:pt>
                <c:pt idx="1048">
                  <c:v>6.3699999999999993E-2</c:v>
                </c:pt>
                <c:pt idx="1049">
                  <c:v>6.6250000000000003E-2</c:v>
                </c:pt>
                <c:pt idx="1050">
                  <c:v>6.5350000000000005E-2</c:v>
                </c:pt>
                <c:pt idx="1051">
                  <c:v>6.5100000000000005E-2</c:v>
                </c:pt>
                <c:pt idx="1052">
                  <c:v>6.5349999999999991E-2</c:v>
                </c:pt>
                <c:pt idx="1053">
                  <c:v>6.4350000000000004E-2</c:v>
                </c:pt>
                <c:pt idx="1054">
                  <c:v>6.5200000000000008E-2</c:v>
                </c:pt>
                <c:pt idx="1055">
                  <c:v>6.6049999999999998E-2</c:v>
                </c:pt>
                <c:pt idx="1056">
                  <c:v>6.6149999999999987E-2</c:v>
                </c:pt>
                <c:pt idx="1057">
                  <c:v>6.6299999999999998E-2</c:v>
                </c:pt>
                <c:pt idx="1058">
                  <c:v>6.6250000000000003E-2</c:v>
                </c:pt>
                <c:pt idx="1059">
                  <c:v>6.8049999999999999E-2</c:v>
                </c:pt>
                <c:pt idx="1060">
                  <c:v>6.7949999999999997E-2</c:v>
                </c:pt>
                <c:pt idx="1061">
                  <c:v>6.8899999999999989E-2</c:v>
                </c:pt>
                <c:pt idx="1062">
                  <c:v>6.9749999999999993E-2</c:v>
                </c:pt>
                <c:pt idx="1063">
                  <c:v>6.8350000000000008E-2</c:v>
                </c:pt>
                <c:pt idx="1064">
                  <c:v>6.8449999999999997E-2</c:v>
                </c:pt>
                <c:pt idx="1065">
                  <c:v>6.905E-2</c:v>
                </c:pt>
                <c:pt idx="1066">
                  <c:v>6.8849999999999995E-2</c:v>
                </c:pt>
                <c:pt idx="1067">
                  <c:v>6.9749999999999993E-2</c:v>
                </c:pt>
                <c:pt idx="1068">
                  <c:v>7.0499999999999993E-2</c:v>
                </c:pt>
                <c:pt idx="1069">
                  <c:v>7.0099999999999996E-2</c:v>
                </c:pt>
                <c:pt idx="1070">
                  <c:v>7.0649999999999991E-2</c:v>
                </c:pt>
                <c:pt idx="1071">
                  <c:v>7.2149999999999992E-2</c:v>
                </c:pt>
                <c:pt idx="1072">
                  <c:v>7.2050000000000003E-2</c:v>
                </c:pt>
                <c:pt idx="1073">
                  <c:v>7.354999999999999E-2</c:v>
                </c:pt>
                <c:pt idx="1074">
                  <c:v>7.4949999999999989E-2</c:v>
                </c:pt>
                <c:pt idx="1075">
                  <c:v>7.3849999999999999E-2</c:v>
                </c:pt>
                <c:pt idx="1076">
                  <c:v>7.5049999999999992E-2</c:v>
                </c:pt>
                <c:pt idx="1077">
                  <c:v>7.6149999999999995E-2</c:v>
                </c:pt>
                <c:pt idx="1078">
                  <c:v>7.5749999999999998E-2</c:v>
                </c:pt>
                <c:pt idx="1079">
                  <c:v>7.6649999999999996E-2</c:v>
                </c:pt>
                <c:pt idx="1080">
                  <c:v>7.6850000000000002E-2</c:v>
                </c:pt>
                <c:pt idx="1081">
                  <c:v>7.6399999999999996E-2</c:v>
                </c:pt>
                <c:pt idx="1082">
                  <c:v>7.6149999999999995E-2</c:v>
                </c:pt>
                <c:pt idx="1083">
                  <c:v>7.6700000000000004E-2</c:v>
                </c:pt>
                <c:pt idx="1084">
                  <c:v>7.9149999999999998E-2</c:v>
                </c:pt>
                <c:pt idx="1085">
                  <c:v>7.984999999999999E-2</c:v>
                </c:pt>
                <c:pt idx="1086">
                  <c:v>8.1050000000000011E-2</c:v>
                </c:pt>
                <c:pt idx="1087">
                  <c:v>8.2150000000000001E-2</c:v>
                </c:pt>
                <c:pt idx="1088">
                  <c:v>8.1350000000000006E-2</c:v>
                </c:pt>
                <c:pt idx="1089">
                  <c:v>8.295000000000001E-2</c:v>
                </c:pt>
                <c:pt idx="1090">
                  <c:v>8.3400000000000002E-2</c:v>
                </c:pt>
                <c:pt idx="1091">
                  <c:v>8.3799999999999999E-2</c:v>
                </c:pt>
                <c:pt idx="1092">
                  <c:v>8.5100000000000009E-2</c:v>
                </c:pt>
                <c:pt idx="1093">
                  <c:v>8.5249999999999992E-2</c:v>
                </c:pt>
                <c:pt idx="1094">
                  <c:v>8.6050000000000001E-2</c:v>
                </c:pt>
                <c:pt idx="1095">
                  <c:v>8.7300000000000003E-2</c:v>
                </c:pt>
                <c:pt idx="1096">
                  <c:v>8.8200000000000001E-2</c:v>
                </c:pt>
                <c:pt idx="1097">
                  <c:v>8.8950000000000001E-2</c:v>
                </c:pt>
                <c:pt idx="1098">
                  <c:v>9.0399999999999994E-2</c:v>
                </c:pt>
                <c:pt idx="1099">
                  <c:v>9.0400000000000008E-2</c:v>
                </c:pt>
                <c:pt idx="1100">
                  <c:v>9.1050000000000006E-2</c:v>
                </c:pt>
                <c:pt idx="1101">
                  <c:v>9.2149999999999996E-2</c:v>
                </c:pt>
                <c:pt idx="1102">
                  <c:v>9.2999999999999999E-2</c:v>
                </c:pt>
                <c:pt idx="1103">
                  <c:v>9.4949999999999993E-2</c:v>
                </c:pt>
                <c:pt idx="1104">
                  <c:v>9.5750000000000002E-2</c:v>
                </c:pt>
                <c:pt idx="1105">
                  <c:v>9.6250000000000002E-2</c:v>
                </c:pt>
                <c:pt idx="1106">
                  <c:v>9.8549999999999999E-2</c:v>
                </c:pt>
                <c:pt idx="1107">
                  <c:v>9.9049999999999999E-2</c:v>
                </c:pt>
                <c:pt idx="1108">
                  <c:v>9.9449999999999997E-2</c:v>
                </c:pt>
                <c:pt idx="1109">
                  <c:v>9.9949999999999997E-2</c:v>
                </c:pt>
                <c:pt idx="1110">
                  <c:v>0.10035000000000001</c:v>
                </c:pt>
                <c:pt idx="1111">
                  <c:v>0.10200000000000001</c:v>
                </c:pt>
                <c:pt idx="1112">
                  <c:v>0.10439999999999999</c:v>
                </c:pt>
                <c:pt idx="1113">
                  <c:v>0.106</c:v>
                </c:pt>
                <c:pt idx="1114">
                  <c:v>0.10815000000000001</c:v>
                </c:pt>
                <c:pt idx="1115">
                  <c:v>0.10994999999999999</c:v>
                </c:pt>
                <c:pt idx="1116">
                  <c:v>0.1109</c:v>
                </c:pt>
                <c:pt idx="1117">
                  <c:v>0.11265</c:v>
                </c:pt>
                <c:pt idx="1118">
                  <c:v>0.1142</c:v>
                </c:pt>
                <c:pt idx="1119">
                  <c:v>0.11605</c:v>
                </c:pt>
                <c:pt idx="1120">
                  <c:v>0.11804999999999999</c:v>
                </c:pt>
                <c:pt idx="1121">
                  <c:v>0.12035</c:v>
                </c:pt>
                <c:pt idx="1122">
                  <c:v>0.12185</c:v>
                </c:pt>
                <c:pt idx="1123">
                  <c:v>0.12250000000000003</c:v>
                </c:pt>
                <c:pt idx="1124">
                  <c:v>0.12404999999999999</c:v>
                </c:pt>
                <c:pt idx="1125">
                  <c:v>0.12564999999999998</c:v>
                </c:pt>
                <c:pt idx="1126">
                  <c:v>0.12670000000000001</c:v>
                </c:pt>
                <c:pt idx="1127">
                  <c:v>0.13034999999999999</c:v>
                </c:pt>
                <c:pt idx="1128">
                  <c:v>0.13225000000000001</c:v>
                </c:pt>
                <c:pt idx="1129">
                  <c:v>0.13505</c:v>
                </c:pt>
                <c:pt idx="1130">
                  <c:v>0.13819999999999999</c:v>
                </c:pt>
                <c:pt idx="1131">
                  <c:v>0.14040000000000002</c:v>
                </c:pt>
                <c:pt idx="1132">
                  <c:v>0.14320000000000002</c:v>
                </c:pt>
                <c:pt idx="1133">
                  <c:v>0.14510000000000001</c:v>
                </c:pt>
                <c:pt idx="1134">
                  <c:v>0.14720000000000003</c:v>
                </c:pt>
                <c:pt idx="1135">
                  <c:v>0.14910000000000001</c:v>
                </c:pt>
                <c:pt idx="1136">
                  <c:v>0.15245000000000003</c:v>
                </c:pt>
                <c:pt idx="1137">
                  <c:v>0.15625000000000003</c:v>
                </c:pt>
                <c:pt idx="1138">
                  <c:v>0.15955000000000003</c:v>
                </c:pt>
                <c:pt idx="1139">
                  <c:v>0.16255</c:v>
                </c:pt>
                <c:pt idx="1140">
                  <c:v>0.16520000000000001</c:v>
                </c:pt>
                <c:pt idx="1141">
                  <c:v>0.16675000000000001</c:v>
                </c:pt>
                <c:pt idx="1142">
                  <c:v>0.16905000000000001</c:v>
                </c:pt>
                <c:pt idx="1143">
                  <c:v>0.17050000000000001</c:v>
                </c:pt>
                <c:pt idx="1144">
                  <c:v>0.17200000000000001</c:v>
                </c:pt>
                <c:pt idx="1145">
                  <c:v>0.17610000000000003</c:v>
                </c:pt>
                <c:pt idx="1146">
                  <c:v>0.1792</c:v>
                </c:pt>
                <c:pt idx="1147">
                  <c:v>0.18395000000000003</c:v>
                </c:pt>
                <c:pt idx="1148">
                  <c:v>0.18675000000000003</c:v>
                </c:pt>
                <c:pt idx="1149">
                  <c:v>0.18850000000000003</c:v>
                </c:pt>
                <c:pt idx="1150">
                  <c:v>0.1915</c:v>
                </c:pt>
                <c:pt idx="1151">
                  <c:v>0.19195000000000001</c:v>
                </c:pt>
                <c:pt idx="1152">
                  <c:v>0.19670000000000001</c:v>
                </c:pt>
                <c:pt idx="1153">
                  <c:v>0.20020000000000002</c:v>
                </c:pt>
                <c:pt idx="1154">
                  <c:v>0.20170000000000002</c:v>
                </c:pt>
                <c:pt idx="1155">
                  <c:v>0.20460000000000003</c:v>
                </c:pt>
                <c:pt idx="1156">
                  <c:v>0.20420000000000002</c:v>
                </c:pt>
                <c:pt idx="1157">
                  <c:v>0.20515</c:v>
                </c:pt>
                <c:pt idx="1158">
                  <c:v>0.20695000000000002</c:v>
                </c:pt>
                <c:pt idx="1159">
                  <c:v>0.20930000000000001</c:v>
                </c:pt>
                <c:pt idx="1160">
                  <c:v>0.21235000000000001</c:v>
                </c:pt>
                <c:pt idx="1161">
                  <c:v>0.21440000000000001</c:v>
                </c:pt>
                <c:pt idx="1162">
                  <c:v>0.2167</c:v>
                </c:pt>
                <c:pt idx="1163">
                  <c:v>0.21754999999999999</c:v>
                </c:pt>
                <c:pt idx="1164">
                  <c:v>0.21975000000000003</c:v>
                </c:pt>
                <c:pt idx="1165">
                  <c:v>0.21965000000000001</c:v>
                </c:pt>
                <c:pt idx="1166">
                  <c:v>0.22025000000000003</c:v>
                </c:pt>
                <c:pt idx="1167">
                  <c:v>0.22055</c:v>
                </c:pt>
                <c:pt idx="1168">
                  <c:v>0.21935000000000002</c:v>
                </c:pt>
                <c:pt idx="1169">
                  <c:v>0.22110000000000002</c:v>
                </c:pt>
                <c:pt idx="1170">
                  <c:v>0.21990000000000001</c:v>
                </c:pt>
                <c:pt idx="1171">
                  <c:v>0.22075</c:v>
                </c:pt>
                <c:pt idx="1172">
                  <c:v>0.22005000000000002</c:v>
                </c:pt>
                <c:pt idx="1173">
                  <c:v>0.21895000000000003</c:v>
                </c:pt>
                <c:pt idx="1174">
                  <c:v>0.22075000000000003</c:v>
                </c:pt>
                <c:pt idx="1175">
                  <c:v>0.22040000000000001</c:v>
                </c:pt>
                <c:pt idx="1176">
                  <c:v>0.22020000000000001</c:v>
                </c:pt>
                <c:pt idx="1177">
                  <c:v>0.2185</c:v>
                </c:pt>
                <c:pt idx="1178">
                  <c:v>0.21585000000000001</c:v>
                </c:pt>
                <c:pt idx="1179">
                  <c:v>0.21360000000000001</c:v>
                </c:pt>
                <c:pt idx="1180">
                  <c:v>0.21125000000000002</c:v>
                </c:pt>
                <c:pt idx="1181">
                  <c:v>0.21224999999999999</c:v>
                </c:pt>
                <c:pt idx="1182">
                  <c:v>0.20900000000000002</c:v>
                </c:pt>
                <c:pt idx="1183">
                  <c:v>0.20610000000000001</c:v>
                </c:pt>
                <c:pt idx="1184">
                  <c:v>0.20600000000000002</c:v>
                </c:pt>
                <c:pt idx="1185">
                  <c:v>0.20190000000000002</c:v>
                </c:pt>
                <c:pt idx="1186">
                  <c:v>0.2026</c:v>
                </c:pt>
                <c:pt idx="1187">
                  <c:v>0.20180000000000001</c:v>
                </c:pt>
                <c:pt idx="1188">
                  <c:v>0.19995000000000002</c:v>
                </c:pt>
                <c:pt idx="1189">
                  <c:v>0.19935</c:v>
                </c:pt>
                <c:pt idx="1190">
                  <c:v>0.19595000000000001</c:v>
                </c:pt>
                <c:pt idx="1191">
                  <c:v>0.19515000000000002</c:v>
                </c:pt>
                <c:pt idx="1192">
                  <c:v>0.19389999999999999</c:v>
                </c:pt>
                <c:pt idx="1193">
                  <c:v>0.19145000000000001</c:v>
                </c:pt>
                <c:pt idx="1194">
                  <c:v>0.19084999999999999</c:v>
                </c:pt>
                <c:pt idx="1195">
                  <c:v>0.1895</c:v>
                </c:pt>
                <c:pt idx="1196">
                  <c:v>0.18990000000000001</c:v>
                </c:pt>
                <c:pt idx="1197">
                  <c:v>0.18985000000000002</c:v>
                </c:pt>
                <c:pt idx="1198">
                  <c:v>0.18930000000000002</c:v>
                </c:pt>
                <c:pt idx="1199">
                  <c:v>0.18945000000000004</c:v>
                </c:pt>
                <c:pt idx="1200">
                  <c:v>0.18775000000000003</c:v>
                </c:pt>
                <c:pt idx="1201">
                  <c:v>0.18705000000000002</c:v>
                </c:pt>
                <c:pt idx="1202">
                  <c:v>0.18575000000000003</c:v>
                </c:pt>
                <c:pt idx="1203">
                  <c:v>0.18635000000000002</c:v>
                </c:pt>
                <c:pt idx="1204">
                  <c:v>0.18635000000000002</c:v>
                </c:pt>
                <c:pt idx="1205">
                  <c:v>0.18615000000000001</c:v>
                </c:pt>
                <c:pt idx="1206">
                  <c:v>0.18880000000000002</c:v>
                </c:pt>
                <c:pt idx="1207">
                  <c:v>0.18855</c:v>
                </c:pt>
                <c:pt idx="1208">
                  <c:v>0.18890000000000001</c:v>
                </c:pt>
                <c:pt idx="1209">
                  <c:v>0.1903</c:v>
                </c:pt>
                <c:pt idx="1210">
                  <c:v>0.19084999999999999</c:v>
                </c:pt>
                <c:pt idx="1211">
                  <c:v>0.19090000000000001</c:v>
                </c:pt>
                <c:pt idx="1212">
                  <c:v>0.19245000000000001</c:v>
                </c:pt>
                <c:pt idx="1213">
                  <c:v>0.19345000000000001</c:v>
                </c:pt>
                <c:pt idx="1214">
                  <c:v>0.19330000000000003</c:v>
                </c:pt>
                <c:pt idx="1215">
                  <c:v>0.19525000000000001</c:v>
                </c:pt>
                <c:pt idx="1216">
                  <c:v>0.19539999999999999</c:v>
                </c:pt>
                <c:pt idx="1217">
                  <c:v>0.19675000000000004</c:v>
                </c:pt>
                <c:pt idx="1218">
                  <c:v>0.1988</c:v>
                </c:pt>
                <c:pt idx="1219">
                  <c:v>0.19920000000000002</c:v>
                </c:pt>
                <c:pt idx="1220">
                  <c:v>0.20005000000000001</c:v>
                </c:pt>
                <c:pt idx="1221">
                  <c:v>0.2016</c:v>
                </c:pt>
                <c:pt idx="1222">
                  <c:v>0.20305000000000004</c:v>
                </c:pt>
                <c:pt idx="1223">
                  <c:v>0.20415</c:v>
                </c:pt>
                <c:pt idx="1224">
                  <c:v>0.20495000000000002</c:v>
                </c:pt>
                <c:pt idx="1225">
                  <c:v>0.20585000000000001</c:v>
                </c:pt>
                <c:pt idx="1226">
                  <c:v>0.20585000000000001</c:v>
                </c:pt>
                <c:pt idx="1227">
                  <c:v>0.20645000000000002</c:v>
                </c:pt>
                <c:pt idx="1228">
                  <c:v>0.20750000000000002</c:v>
                </c:pt>
                <c:pt idx="1229">
                  <c:v>0.20690000000000003</c:v>
                </c:pt>
                <c:pt idx="1230">
                  <c:v>0.20735000000000003</c:v>
                </c:pt>
                <c:pt idx="1231">
                  <c:v>0.20805000000000001</c:v>
                </c:pt>
                <c:pt idx="1232">
                  <c:v>0.20860000000000001</c:v>
                </c:pt>
                <c:pt idx="1233">
                  <c:v>0.21035000000000001</c:v>
                </c:pt>
                <c:pt idx="1234">
                  <c:v>0.21130000000000002</c:v>
                </c:pt>
                <c:pt idx="1235">
                  <c:v>0.21185000000000001</c:v>
                </c:pt>
                <c:pt idx="1236">
                  <c:v>0.21270000000000003</c:v>
                </c:pt>
                <c:pt idx="1237">
                  <c:v>0.21210000000000001</c:v>
                </c:pt>
                <c:pt idx="1238">
                  <c:v>0.21190000000000001</c:v>
                </c:pt>
                <c:pt idx="1239">
                  <c:v>0.21140000000000003</c:v>
                </c:pt>
                <c:pt idx="1240">
                  <c:v>0.21135000000000004</c:v>
                </c:pt>
                <c:pt idx="1241">
                  <c:v>0.21165000000000003</c:v>
                </c:pt>
                <c:pt idx="1242">
                  <c:v>0.21245</c:v>
                </c:pt>
                <c:pt idx="1243">
                  <c:v>0.21304999999999999</c:v>
                </c:pt>
                <c:pt idx="1244">
                  <c:v>0.21215000000000001</c:v>
                </c:pt>
                <c:pt idx="1245">
                  <c:v>0.21204999999999999</c:v>
                </c:pt>
                <c:pt idx="1246">
                  <c:v>0.21099999999999999</c:v>
                </c:pt>
                <c:pt idx="1247">
                  <c:v>0.21104999999999999</c:v>
                </c:pt>
                <c:pt idx="1248">
                  <c:v>0.21170000000000003</c:v>
                </c:pt>
                <c:pt idx="1249">
                  <c:v>0.21150000000000002</c:v>
                </c:pt>
                <c:pt idx="1250">
                  <c:v>0.21175000000000002</c:v>
                </c:pt>
                <c:pt idx="1251">
                  <c:v>0.21130000000000002</c:v>
                </c:pt>
                <c:pt idx="1252">
                  <c:v>0.21074999999999999</c:v>
                </c:pt>
                <c:pt idx="1253">
                  <c:v>0.21049999999999999</c:v>
                </c:pt>
              </c:numCache>
            </c:numRef>
          </c:yVal>
          <c:smooth val="1"/>
          <c:extLst>
            <c:ext xmlns:c16="http://schemas.microsoft.com/office/drawing/2014/chart" uri="{C3380CC4-5D6E-409C-BE32-E72D297353CC}">
              <c16:uniqueId val="{00000004-AA13-49CE-A792-B5AEE7BA5538}"/>
            </c:ext>
          </c:extLst>
        </c:ser>
        <c:dLbls>
          <c:showLegendKey val="0"/>
          <c:showVal val="0"/>
          <c:showCatName val="0"/>
          <c:showSerName val="0"/>
          <c:showPercent val="0"/>
          <c:showBubbleSize val="0"/>
        </c:dLbls>
        <c:axId val="109520768"/>
        <c:axId val="109535232"/>
      </c:scatterChart>
      <c:valAx>
        <c:axId val="109520768"/>
        <c:scaling>
          <c:orientation val="minMax"/>
          <c:max val="550"/>
          <c:min val="300"/>
        </c:scaling>
        <c:delete val="0"/>
        <c:axPos val="b"/>
        <c:title>
          <c:tx>
            <c:rich>
              <a:bodyPr/>
              <a:lstStyle/>
              <a:p>
                <a:pPr>
                  <a:defRPr/>
                </a:pPr>
                <a:r>
                  <a:rPr lang="en-US" dirty="0"/>
                  <a:t>Wavelength (nm)</a:t>
                </a:r>
              </a:p>
            </c:rich>
          </c:tx>
          <c:overlay val="0"/>
        </c:title>
        <c:numFmt formatCode="General" sourceLinked="1"/>
        <c:majorTickMark val="out"/>
        <c:minorTickMark val="none"/>
        <c:tickLblPos val="nextTo"/>
        <c:txPr>
          <a:bodyPr rot="0" vert="horz"/>
          <a:lstStyle/>
          <a:p>
            <a:pPr>
              <a:defRPr b="0"/>
            </a:pPr>
            <a:endParaRPr lang="en-US"/>
          </a:p>
        </c:txPr>
        <c:crossAx val="109535232"/>
        <c:crosses val="autoZero"/>
        <c:crossBetween val="midCat"/>
      </c:valAx>
      <c:valAx>
        <c:axId val="109535232"/>
        <c:scaling>
          <c:orientation val="minMax"/>
          <c:max val="0.5"/>
          <c:min val="0"/>
        </c:scaling>
        <c:delete val="0"/>
        <c:axPos val="l"/>
        <c:title>
          <c:tx>
            <c:rich>
              <a:bodyPr rot="-5400000" vert="horz"/>
              <a:lstStyle/>
              <a:p>
                <a:pPr>
                  <a:defRPr/>
                </a:pPr>
                <a:r>
                  <a:rPr lang="en-US" dirty="0"/>
                  <a:t>Absorbance (620 nm)</a:t>
                </a:r>
              </a:p>
            </c:rich>
          </c:tx>
          <c:overlay val="0"/>
        </c:title>
        <c:numFmt formatCode="#,##0.0" sourceLinked="0"/>
        <c:majorTickMark val="out"/>
        <c:minorTickMark val="none"/>
        <c:tickLblPos val="nextTo"/>
        <c:txPr>
          <a:bodyPr/>
          <a:lstStyle/>
          <a:p>
            <a:pPr>
              <a:defRPr b="0"/>
            </a:pPr>
            <a:endParaRPr lang="en-US"/>
          </a:p>
        </c:txPr>
        <c:crossAx val="109520768"/>
        <c:crosses val="autoZero"/>
        <c:crossBetween val="midCat"/>
        <c:majorUnit val="0.1"/>
      </c:valAx>
      <c:spPr>
        <a:ln w="25400">
          <a:noFill/>
        </a:ln>
      </c:spPr>
    </c:plotArea>
    <c:legend>
      <c:legendPos val="t"/>
      <c:layout>
        <c:manualLayout>
          <c:xMode val="edge"/>
          <c:yMode val="edge"/>
          <c:x val="0.15603960671036551"/>
          <c:y val="5.7133714407319375E-2"/>
          <c:w val="0.50834477987294335"/>
          <c:h val="4.7587631108280612E-2"/>
        </c:manualLayout>
      </c:layout>
      <c:overlay val="0"/>
      <c:txPr>
        <a:bodyPr/>
        <a:lstStyle/>
        <a:p>
          <a:pPr>
            <a:defRPr spc="100" baseline="0"/>
          </a:pPr>
          <a:endParaRPr lang="en-US"/>
        </a:p>
      </c:txPr>
    </c:legend>
    <c:plotVisOnly val="1"/>
    <c:dispBlanksAs val="gap"/>
    <c:showDLblsOverMax val="0"/>
  </c:chart>
  <c:txPr>
    <a:bodyPr/>
    <a:lstStyle/>
    <a:p>
      <a:pPr>
        <a:defRPr sz="1200" b="1">
          <a:latin typeface="Times New Roman" panose="02020603050405020304" pitchFamily="18" charset="0"/>
          <a:ea typeface="Tahoma" panose="020B0604030504040204" pitchFamily="34" charset="0"/>
          <a:cs typeface="Times New Roman" panose="02020603050405020304" pitchFamily="18" charset="0"/>
        </a:defRPr>
      </a:pPr>
      <a:endParaRPr lang="en-US"/>
    </a:p>
  </c:txPr>
  <c:externalData r:id="rId2">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A913596-884E-44C1-B5EE-C3D46BE3B660}" type="datetimeFigureOut">
              <a:rPr lang="en-US" smtClean="0"/>
              <a:t>11-Feb-20</a:t>
            </a:fld>
            <a:endParaRPr lang="en-US"/>
          </a:p>
        </p:txBody>
      </p:sp>
      <p:sp>
        <p:nvSpPr>
          <p:cNvPr id="4" name="Marcador de imagen de diapositiva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A6E6FE3-6346-41D7-8BBD-D06C00B2ABBF}" type="slidenum">
              <a:rPr lang="en-US" smtClean="0"/>
              <a:t>‹Nº›</a:t>
            </a:fld>
            <a:endParaRPr lang="en-US"/>
          </a:p>
        </p:txBody>
      </p:sp>
    </p:spTree>
    <p:extLst>
      <p:ext uri="{BB962C8B-B14F-4D97-AF65-F5344CB8AC3E}">
        <p14:creationId xmlns:p14="http://schemas.microsoft.com/office/powerpoint/2010/main" val="235049538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_tradnl" dirty="0"/>
          </a:p>
        </p:txBody>
      </p:sp>
      <p:sp>
        <p:nvSpPr>
          <p:cNvPr id="4" name="Marcador de número de diapositiva 3"/>
          <p:cNvSpPr>
            <a:spLocks noGrp="1"/>
          </p:cNvSpPr>
          <p:nvPr>
            <p:ph type="sldNum" sz="quarter" idx="10"/>
          </p:nvPr>
        </p:nvSpPr>
        <p:spPr/>
        <p:txBody>
          <a:bodyPr/>
          <a:lstStyle/>
          <a:p>
            <a:fld id="{789F25F0-48F9-2742-BFF6-416332E5B7FB}" type="slidenum">
              <a:rPr lang="es-ES_tradnl" smtClean="0"/>
              <a:t>14</a:t>
            </a:fld>
            <a:endParaRPr lang="es-ES_tradnl" dirty="0"/>
          </a:p>
        </p:txBody>
      </p:sp>
    </p:spTree>
    <p:extLst>
      <p:ext uri="{BB962C8B-B14F-4D97-AF65-F5344CB8AC3E}">
        <p14:creationId xmlns:p14="http://schemas.microsoft.com/office/powerpoint/2010/main" val="38991966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1 Título"/>
          <p:cNvSpPr>
            <a:spLocks noGrp="1"/>
          </p:cNvSpPr>
          <p:nvPr>
            <p:ph type="ctrTitle"/>
          </p:nvPr>
        </p:nvSpPr>
        <p:spPr>
          <a:xfrm>
            <a:off x="685800" y="2130427"/>
            <a:ext cx="7772400" cy="1470025"/>
          </a:xfrm>
        </p:spPr>
        <p:txBody>
          <a:bodyPr/>
          <a:lstStyle/>
          <a:p>
            <a:r>
              <a:rPr lang="es-ES"/>
              <a:t>Haga clic para modificar el estilo de título del patrón</a:t>
            </a:r>
            <a:endParaRPr lang="es-CL"/>
          </a:p>
        </p:txBody>
      </p:sp>
      <p:sp>
        <p:nvSpPr>
          <p:cNvPr id="3" name="2 Subtítulo"/>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s-ES"/>
              <a:t>Haga clic para modificar el estilo de subtítulo del patrón</a:t>
            </a:r>
            <a:endParaRPr lang="es-CL"/>
          </a:p>
        </p:txBody>
      </p:sp>
      <p:sp>
        <p:nvSpPr>
          <p:cNvPr id="4" name="3 Marcador de fecha"/>
          <p:cNvSpPr>
            <a:spLocks noGrp="1"/>
          </p:cNvSpPr>
          <p:nvPr>
            <p:ph type="dt" sz="half" idx="10"/>
          </p:nvPr>
        </p:nvSpPr>
        <p:spPr/>
        <p:txBody>
          <a:bodyPr/>
          <a:lstStyle/>
          <a:p>
            <a:fld id="{82D41842-7D50-45E9-8CF0-98CF31D486F2}" type="datetimeFigureOut">
              <a:rPr lang="es-CL" smtClean="0"/>
              <a:t>11-02-2020</a:t>
            </a:fld>
            <a:endParaRPr lang="es-CL"/>
          </a:p>
        </p:txBody>
      </p:sp>
      <p:sp>
        <p:nvSpPr>
          <p:cNvPr id="5" name="4 Marcador de pie de página"/>
          <p:cNvSpPr>
            <a:spLocks noGrp="1"/>
          </p:cNvSpPr>
          <p:nvPr>
            <p:ph type="ftr" sz="quarter" idx="11"/>
          </p:nvPr>
        </p:nvSpPr>
        <p:spPr/>
        <p:txBody>
          <a:bodyPr/>
          <a:lstStyle/>
          <a:p>
            <a:endParaRPr lang="es-CL"/>
          </a:p>
        </p:txBody>
      </p:sp>
      <p:sp>
        <p:nvSpPr>
          <p:cNvPr id="6" name="5 Marcador de número de diapositiva"/>
          <p:cNvSpPr>
            <a:spLocks noGrp="1"/>
          </p:cNvSpPr>
          <p:nvPr>
            <p:ph type="sldNum" sz="quarter" idx="12"/>
          </p:nvPr>
        </p:nvSpPr>
        <p:spPr/>
        <p:txBody>
          <a:bodyPr/>
          <a:lstStyle/>
          <a:p>
            <a:fld id="{E27B2540-0353-4C4B-8D4B-ADFE2B64C0ED}" type="slidenum">
              <a:rPr lang="es-CL" smtClean="0"/>
              <a:t>‹Nº›</a:t>
            </a:fld>
            <a:endParaRPr lang="es-CL"/>
          </a:p>
        </p:txBody>
      </p:sp>
    </p:spTree>
    <p:extLst>
      <p:ext uri="{BB962C8B-B14F-4D97-AF65-F5344CB8AC3E}">
        <p14:creationId xmlns:p14="http://schemas.microsoft.com/office/powerpoint/2010/main" val="16401957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endParaRPr lang="es-CL"/>
          </a:p>
        </p:txBody>
      </p:sp>
      <p:sp>
        <p:nvSpPr>
          <p:cNvPr id="3" name="2 Marcador de texto vertical"/>
          <p:cNvSpPr>
            <a:spLocks noGrp="1"/>
          </p:cNvSpPr>
          <p:nvPr>
            <p:ph type="body" orient="vert" idx="1"/>
          </p:nvPr>
        </p:nvSpPr>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s-CL"/>
          </a:p>
        </p:txBody>
      </p:sp>
      <p:sp>
        <p:nvSpPr>
          <p:cNvPr id="4" name="3 Marcador de fecha"/>
          <p:cNvSpPr>
            <a:spLocks noGrp="1"/>
          </p:cNvSpPr>
          <p:nvPr>
            <p:ph type="dt" sz="half" idx="10"/>
          </p:nvPr>
        </p:nvSpPr>
        <p:spPr/>
        <p:txBody>
          <a:bodyPr/>
          <a:lstStyle/>
          <a:p>
            <a:fld id="{82D41842-7D50-45E9-8CF0-98CF31D486F2}" type="datetimeFigureOut">
              <a:rPr lang="es-CL" smtClean="0"/>
              <a:t>11-02-2020</a:t>
            </a:fld>
            <a:endParaRPr lang="es-CL"/>
          </a:p>
        </p:txBody>
      </p:sp>
      <p:sp>
        <p:nvSpPr>
          <p:cNvPr id="5" name="4 Marcador de pie de página"/>
          <p:cNvSpPr>
            <a:spLocks noGrp="1"/>
          </p:cNvSpPr>
          <p:nvPr>
            <p:ph type="ftr" sz="quarter" idx="11"/>
          </p:nvPr>
        </p:nvSpPr>
        <p:spPr/>
        <p:txBody>
          <a:bodyPr/>
          <a:lstStyle/>
          <a:p>
            <a:endParaRPr lang="es-CL"/>
          </a:p>
        </p:txBody>
      </p:sp>
      <p:sp>
        <p:nvSpPr>
          <p:cNvPr id="6" name="5 Marcador de número de diapositiva"/>
          <p:cNvSpPr>
            <a:spLocks noGrp="1"/>
          </p:cNvSpPr>
          <p:nvPr>
            <p:ph type="sldNum" sz="quarter" idx="12"/>
          </p:nvPr>
        </p:nvSpPr>
        <p:spPr/>
        <p:txBody>
          <a:bodyPr/>
          <a:lstStyle/>
          <a:p>
            <a:fld id="{E27B2540-0353-4C4B-8D4B-ADFE2B64C0ED}" type="slidenum">
              <a:rPr lang="es-CL" smtClean="0"/>
              <a:t>‹Nº›</a:t>
            </a:fld>
            <a:endParaRPr lang="es-CL"/>
          </a:p>
        </p:txBody>
      </p:sp>
    </p:spTree>
    <p:extLst>
      <p:ext uri="{BB962C8B-B14F-4D97-AF65-F5344CB8AC3E}">
        <p14:creationId xmlns:p14="http://schemas.microsoft.com/office/powerpoint/2010/main" val="41723306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1 Título vertical"/>
          <p:cNvSpPr>
            <a:spLocks noGrp="1"/>
          </p:cNvSpPr>
          <p:nvPr>
            <p:ph type="title" orient="vert"/>
          </p:nvPr>
        </p:nvSpPr>
        <p:spPr>
          <a:xfrm>
            <a:off x="6629400" y="274640"/>
            <a:ext cx="2057400" cy="5851525"/>
          </a:xfrm>
        </p:spPr>
        <p:txBody>
          <a:bodyPr vert="eaVert"/>
          <a:lstStyle/>
          <a:p>
            <a:r>
              <a:rPr lang="es-ES"/>
              <a:t>Haga clic para modificar el estilo de título del patrón</a:t>
            </a:r>
            <a:endParaRPr lang="es-CL"/>
          </a:p>
        </p:txBody>
      </p:sp>
      <p:sp>
        <p:nvSpPr>
          <p:cNvPr id="3" name="2 Marcador de texto vertical"/>
          <p:cNvSpPr>
            <a:spLocks noGrp="1"/>
          </p:cNvSpPr>
          <p:nvPr>
            <p:ph type="body" orient="vert" idx="1"/>
          </p:nvPr>
        </p:nvSpPr>
        <p:spPr>
          <a:xfrm>
            <a:off x="457200" y="274640"/>
            <a:ext cx="6019800" cy="5851525"/>
          </a:xfrm>
        </p:spPr>
        <p:txBody>
          <a:bodyPr vert="eaVert"/>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s-CL"/>
          </a:p>
        </p:txBody>
      </p:sp>
      <p:sp>
        <p:nvSpPr>
          <p:cNvPr id="4" name="3 Marcador de fecha"/>
          <p:cNvSpPr>
            <a:spLocks noGrp="1"/>
          </p:cNvSpPr>
          <p:nvPr>
            <p:ph type="dt" sz="half" idx="10"/>
          </p:nvPr>
        </p:nvSpPr>
        <p:spPr/>
        <p:txBody>
          <a:bodyPr/>
          <a:lstStyle/>
          <a:p>
            <a:fld id="{82D41842-7D50-45E9-8CF0-98CF31D486F2}" type="datetimeFigureOut">
              <a:rPr lang="es-CL" smtClean="0"/>
              <a:t>11-02-2020</a:t>
            </a:fld>
            <a:endParaRPr lang="es-CL"/>
          </a:p>
        </p:txBody>
      </p:sp>
      <p:sp>
        <p:nvSpPr>
          <p:cNvPr id="5" name="4 Marcador de pie de página"/>
          <p:cNvSpPr>
            <a:spLocks noGrp="1"/>
          </p:cNvSpPr>
          <p:nvPr>
            <p:ph type="ftr" sz="quarter" idx="11"/>
          </p:nvPr>
        </p:nvSpPr>
        <p:spPr/>
        <p:txBody>
          <a:bodyPr/>
          <a:lstStyle/>
          <a:p>
            <a:endParaRPr lang="es-CL"/>
          </a:p>
        </p:txBody>
      </p:sp>
      <p:sp>
        <p:nvSpPr>
          <p:cNvPr id="6" name="5 Marcador de número de diapositiva"/>
          <p:cNvSpPr>
            <a:spLocks noGrp="1"/>
          </p:cNvSpPr>
          <p:nvPr>
            <p:ph type="sldNum" sz="quarter" idx="12"/>
          </p:nvPr>
        </p:nvSpPr>
        <p:spPr/>
        <p:txBody>
          <a:bodyPr/>
          <a:lstStyle/>
          <a:p>
            <a:fld id="{E27B2540-0353-4C4B-8D4B-ADFE2B64C0ED}" type="slidenum">
              <a:rPr lang="es-CL" smtClean="0"/>
              <a:t>‹Nº›</a:t>
            </a:fld>
            <a:endParaRPr lang="es-CL"/>
          </a:p>
        </p:txBody>
      </p:sp>
    </p:spTree>
    <p:extLst>
      <p:ext uri="{BB962C8B-B14F-4D97-AF65-F5344CB8AC3E}">
        <p14:creationId xmlns:p14="http://schemas.microsoft.com/office/powerpoint/2010/main" val="14339984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endParaRPr lang="es-CL"/>
          </a:p>
        </p:txBody>
      </p:sp>
      <p:sp>
        <p:nvSpPr>
          <p:cNvPr id="3" name="2 Marcador de contenido"/>
          <p:cNvSpPr>
            <a:spLocks noGrp="1"/>
          </p:cNvSpPr>
          <p:nvPr>
            <p:ph idx="1"/>
          </p:nvPr>
        </p:nvSpPr>
        <p:spPr/>
        <p:txBody>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s-CL"/>
          </a:p>
        </p:txBody>
      </p:sp>
      <p:sp>
        <p:nvSpPr>
          <p:cNvPr id="4" name="3 Marcador de fecha"/>
          <p:cNvSpPr>
            <a:spLocks noGrp="1"/>
          </p:cNvSpPr>
          <p:nvPr>
            <p:ph type="dt" sz="half" idx="10"/>
          </p:nvPr>
        </p:nvSpPr>
        <p:spPr/>
        <p:txBody>
          <a:bodyPr/>
          <a:lstStyle/>
          <a:p>
            <a:fld id="{82D41842-7D50-45E9-8CF0-98CF31D486F2}" type="datetimeFigureOut">
              <a:rPr lang="es-CL" smtClean="0"/>
              <a:t>11-02-2020</a:t>
            </a:fld>
            <a:endParaRPr lang="es-CL"/>
          </a:p>
        </p:txBody>
      </p:sp>
      <p:sp>
        <p:nvSpPr>
          <p:cNvPr id="5" name="4 Marcador de pie de página"/>
          <p:cNvSpPr>
            <a:spLocks noGrp="1"/>
          </p:cNvSpPr>
          <p:nvPr>
            <p:ph type="ftr" sz="quarter" idx="11"/>
          </p:nvPr>
        </p:nvSpPr>
        <p:spPr/>
        <p:txBody>
          <a:bodyPr/>
          <a:lstStyle/>
          <a:p>
            <a:endParaRPr lang="es-CL"/>
          </a:p>
        </p:txBody>
      </p:sp>
      <p:sp>
        <p:nvSpPr>
          <p:cNvPr id="6" name="5 Marcador de número de diapositiva"/>
          <p:cNvSpPr>
            <a:spLocks noGrp="1"/>
          </p:cNvSpPr>
          <p:nvPr>
            <p:ph type="sldNum" sz="quarter" idx="12"/>
          </p:nvPr>
        </p:nvSpPr>
        <p:spPr/>
        <p:txBody>
          <a:bodyPr/>
          <a:lstStyle/>
          <a:p>
            <a:fld id="{E27B2540-0353-4C4B-8D4B-ADFE2B64C0ED}" type="slidenum">
              <a:rPr lang="es-CL" smtClean="0"/>
              <a:t>‹Nº›</a:t>
            </a:fld>
            <a:endParaRPr lang="es-CL"/>
          </a:p>
        </p:txBody>
      </p:sp>
    </p:spTree>
    <p:extLst>
      <p:ext uri="{BB962C8B-B14F-4D97-AF65-F5344CB8AC3E}">
        <p14:creationId xmlns:p14="http://schemas.microsoft.com/office/powerpoint/2010/main" val="41843787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1 Título"/>
          <p:cNvSpPr>
            <a:spLocks noGrp="1"/>
          </p:cNvSpPr>
          <p:nvPr>
            <p:ph type="title"/>
          </p:nvPr>
        </p:nvSpPr>
        <p:spPr>
          <a:xfrm>
            <a:off x="722313" y="4406902"/>
            <a:ext cx="7772400" cy="1362075"/>
          </a:xfrm>
        </p:spPr>
        <p:txBody>
          <a:bodyPr anchor="t"/>
          <a:lstStyle>
            <a:lvl1pPr algn="l">
              <a:defRPr sz="4000" b="1" cap="all"/>
            </a:lvl1pPr>
          </a:lstStyle>
          <a:p>
            <a:r>
              <a:rPr lang="es-ES"/>
              <a:t>Haga clic para modificar el estilo de título del patrón</a:t>
            </a:r>
            <a:endParaRPr lang="es-CL"/>
          </a:p>
        </p:txBody>
      </p:sp>
      <p:sp>
        <p:nvSpPr>
          <p:cNvPr id="3" name="2 Marcador de texto"/>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s-ES"/>
              <a:t>Haga clic para modificar el estilo de texto del patrón</a:t>
            </a:r>
          </a:p>
        </p:txBody>
      </p:sp>
      <p:sp>
        <p:nvSpPr>
          <p:cNvPr id="4" name="3 Marcador de fecha"/>
          <p:cNvSpPr>
            <a:spLocks noGrp="1"/>
          </p:cNvSpPr>
          <p:nvPr>
            <p:ph type="dt" sz="half" idx="10"/>
          </p:nvPr>
        </p:nvSpPr>
        <p:spPr/>
        <p:txBody>
          <a:bodyPr/>
          <a:lstStyle/>
          <a:p>
            <a:fld id="{82D41842-7D50-45E9-8CF0-98CF31D486F2}" type="datetimeFigureOut">
              <a:rPr lang="es-CL" smtClean="0"/>
              <a:t>11-02-2020</a:t>
            </a:fld>
            <a:endParaRPr lang="es-CL"/>
          </a:p>
        </p:txBody>
      </p:sp>
      <p:sp>
        <p:nvSpPr>
          <p:cNvPr id="5" name="4 Marcador de pie de página"/>
          <p:cNvSpPr>
            <a:spLocks noGrp="1"/>
          </p:cNvSpPr>
          <p:nvPr>
            <p:ph type="ftr" sz="quarter" idx="11"/>
          </p:nvPr>
        </p:nvSpPr>
        <p:spPr/>
        <p:txBody>
          <a:bodyPr/>
          <a:lstStyle/>
          <a:p>
            <a:endParaRPr lang="es-CL"/>
          </a:p>
        </p:txBody>
      </p:sp>
      <p:sp>
        <p:nvSpPr>
          <p:cNvPr id="6" name="5 Marcador de número de diapositiva"/>
          <p:cNvSpPr>
            <a:spLocks noGrp="1"/>
          </p:cNvSpPr>
          <p:nvPr>
            <p:ph type="sldNum" sz="quarter" idx="12"/>
          </p:nvPr>
        </p:nvSpPr>
        <p:spPr/>
        <p:txBody>
          <a:bodyPr/>
          <a:lstStyle/>
          <a:p>
            <a:fld id="{E27B2540-0353-4C4B-8D4B-ADFE2B64C0ED}" type="slidenum">
              <a:rPr lang="es-CL" smtClean="0"/>
              <a:t>‹Nº›</a:t>
            </a:fld>
            <a:endParaRPr lang="es-CL"/>
          </a:p>
        </p:txBody>
      </p:sp>
    </p:spTree>
    <p:extLst>
      <p:ext uri="{BB962C8B-B14F-4D97-AF65-F5344CB8AC3E}">
        <p14:creationId xmlns:p14="http://schemas.microsoft.com/office/powerpoint/2010/main" val="17163243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endParaRPr lang="es-CL"/>
          </a:p>
        </p:txBody>
      </p:sp>
      <p:sp>
        <p:nvSpPr>
          <p:cNvPr id="3" name="2 Marcador de contenido"/>
          <p:cNvSpPr>
            <a:spLocks noGrp="1"/>
          </p:cNvSpPr>
          <p:nvPr>
            <p:ph sz="half" idx="1"/>
          </p:nvPr>
        </p:nvSpPr>
        <p:spPr>
          <a:xfrm>
            <a:off x="457200" y="1600202"/>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s-CL"/>
          </a:p>
        </p:txBody>
      </p:sp>
      <p:sp>
        <p:nvSpPr>
          <p:cNvPr id="4" name="3 Marcador de contenido"/>
          <p:cNvSpPr>
            <a:spLocks noGrp="1"/>
          </p:cNvSpPr>
          <p:nvPr>
            <p:ph sz="half" idx="2"/>
          </p:nvPr>
        </p:nvSpPr>
        <p:spPr>
          <a:xfrm>
            <a:off x="4648200" y="1600202"/>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s-CL"/>
          </a:p>
        </p:txBody>
      </p:sp>
      <p:sp>
        <p:nvSpPr>
          <p:cNvPr id="5" name="4 Marcador de fecha"/>
          <p:cNvSpPr>
            <a:spLocks noGrp="1"/>
          </p:cNvSpPr>
          <p:nvPr>
            <p:ph type="dt" sz="half" idx="10"/>
          </p:nvPr>
        </p:nvSpPr>
        <p:spPr/>
        <p:txBody>
          <a:bodyPr/>
          <a:lstStyle/>
          <a:p>
            <a:fld id="{82D41842-7D50-45E9-8CF0-98CF31D486F2}" type="datetimeFigureOut">
              <a:rPr lang="es-CL" smtClean="0"/>
              <a:t>11-02-2020</a:t>
            </a:fld>
            <a:endParaRPr lang="es-CL"/>
          </a:p>
        </p:txBody>
      </p:sp>
      <p:sp>
        <p:nvSpPr>
          <p:cNvPr id="6" name="5 Marcador de pie de página"/>
          <p:cNvSpPr>
            <a:spLocks noGrp="1"/>
          </p:cNvSpPr>
          <p:nvPr>
            <p:ph type="ftr" sz="quarter" idx="11"/>
          </p:nvPr>
        </p:nvSpPr>
        <p:spPr/>
        <p:txBody>
          <a:bodyPr/>
          <a:lstStyle/>
          <a:p>
            <a:endParaRPr lang="es-CL"/>
          </a:p>
        </p:txBody>
      </p:sp>
      <p:sp>
        <p:nvSpPr>
          <p:cNvPr id="7" name="6 Marcador de número de diapositiva"/>
          <p:cNvSpPr>
            <a:spLocks noGrp="1"/>
          </p:cNvSpPr>
          <p:nvPr>
            <p:ph type="sldNum" sz="quarter" idx="12"/>
          </p:nvPr>
        </p:nvSpPr>
        <p:spPr/>
        <p:txBody>
          <a:bodyPr/>
          <a:lstStyle/>
          <a:p>
            <a:fld id="{E27B2540-0353-4C4B-8D4B-ADFE2B64C0ED}" type="slidenum">
              <a:rPr lang="es-CL" smtClean="0"/>
              <a:t>‹Nº›</a:t>
            </a:fld>
            <a:endParaRPr lang="es-CL"/>
          </a:p>
        </p:txBody>
      </p:sp>
    </p:spTree>
    <p:extLst>
      <p:ext uri="{BB962C8B-B14F-4D97-AF65-F5344CB8AC3E}">
        <p14:creationId xmlns:p14="http://schemas.microsoft.com/office/powerpoint/2010/main" val="95166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lvl1pPr>
              <a:defRPr/>
            </a:lvl1pPr>
          </a:lstStyle>
          <a:p>
            <a:r>
              <a:rPr lang="es-ES"/>
              <a:t>Haga clic para modificar el estilo de título del patrón</a:t>
            </a:r>
            <a:endParaRPr lang="es-CL"/>
          </a:p>
        </p:txBody>
      </p:sp>
      <p:sp>
        <p:nvSpPr>
          <p:cNvPr id="3" name="2 Marcador de texto"/>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el estilo de texto del patrón</a:t>
            </a:r>
          </a:p>
        </p:txBody>
      </p:sp>
      <p:sp>
        <p:nvSpPr>
          <p:cNvPr id="4" name="3 Marcador de contenido"/>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s-CL"/>
          </a:p>
        </p:txBody>
      </p:sp>
      <p:sp>
        <p:nvSpPr>
          <p:cNvPr id="5" name="4 Marcador de texto"/>
          <p:cNvSpPr>
            <a:spLocks noGrp="1"/>
          </p:cNvSpPr>
          <p:nvPr>
            <p:ph type="body" sz="quarter" idx="3"/>
          </p:nvPr>
        </p:nvSpPr>
        <p:spPr>
          <a:xfrm>
            <a:off x="4645026"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el estilo de texto del patrón</a:t>
            </a:r>
          </a:p>
        </p:txBody>
      </p:sp>
      <p:sp>
        <p:nvSpPr>
          <p:cNvPr id="6" name="5 Marcador de contenido"/>
          <p:cNvSpPr>
            <a:spLocks noGrp="1"/>
          </p:cNvSpPr>
          <p:nvPr>
            <p:ph sz="quarter" idx="4"/>
          </p:nvPr>
        </p:nvSpPr>
        <p:spPr>
          <a:xfrm>
            <a:off x="4645026"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s-CL"/>
          </a:p>
        </p:txBody>
      </p:sp>
      <p:sp>
        <p:nvSpPr>
          <p:cNvPr id="7" name="6 Marcador de fecha"/>
          <p:cNvSpPr>
            <a:spLocks noGrp="1"/>
          </p:cNvSpPr>
          <p:nvPr>
            <p:ph type="dt" sz="half" idx="10"/>
          </p:nvPr>
        </p:nvSpPr>
        <p:spPr/>
        <p:txBody>
          <a:bodyPr/>
          <a:lstStyle/>
          <a:p>
            <a:fld id="{82D41842-7D50-45E9-8CF0-98CF31D486F2}" type="datetimeFigureOut">
              <a:rPr lang="es-CL" smtClean="0"/>
              <a:t>11-02-2020</a:t>
            </a:fld>
            <a:endParaRPr lang="es-CL"/>
          </a:p>
        </p:txBody>
      </p:sp>
      <p:sp>
        <p:nvSpPr>
          <p:cNvPr id="8" name="7 Marcador de pie de página"/>
          <p:cNvSpPr>
            <a:spLocks noGrp="1"/>
          </p:cNvSpPr>
          <p:nvPr>
            <p:ph type="ftr" sz="quarter" idx="11"/>
          </p:nvPr>
        </p:nvSpPr>
        <p:spPr/>
        <p:txBody>
          <a:bodyPr/>
          <a:lstStyle/>
          <a:p>
            <a:endParaRPr lang="es-CL"/>
          </a:p>
        </p:txBody>
      </p:sp>
      <p:sp>
        <p:nvSpPr>
          <p:cNvPr id="9" name="8 Marcador de número de diapositiva"/>
          <p:cNvSpPr>
            <a:spLocks noGrp="1"/>
          </p:cNvSpPr>
          <p:nvPr>
            <p:ph type="sldNum" sz="quarter" idx="12"/>
          </p:nvPr>
        </p:nvSpPr>
        <p:spPr/>
        <p:txBody>
          <a:bodyPr/>
          <a:lstStyle/>
          <a:p>
            <a:fld id="{E27B2540-0353-4C4B-8D4B-ADFE2B64C0ED}" type="slidenum">
              <a:rPr lang="es-CL" smtClean="0"/>
              <a:t>‹Nº›</a:t>
            </a:fld>
            <a:endParaRPr lang="es-CL"/>
          </a:p>
        </p:txBody>
      </p:sp>
    </p:spTree>
    <p:extLst>
      <p:ext uri="{BB962C8B-B14F-4D97-AF65-F5344CB8AC3E}">
        <p14:creationId xmlns:p14="http://schemas.microsoft.com/office/powerpoint/2010/main" val="5136184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lo el título">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a:t>Haga clic para modificar el estilo de título del patrón</a:t>
            </a:r>
            <a:endParaRPr lang="es-CL"/>
          </a:p>
        </p:txBody>
      </p:sp>
      <p:sp>
        <p:nvSpPr>
          <p:cNvPr id="3" name="2 Marcador de fecha"/>
          <p:cNvSpPr>
            <a:spLocks noGrp="1"/>
          </p:cNvSpPr>
          <p:nvPr>
            <p:ph type="dt" sz="half" idx="10"/>
          </p:nvPr>
        </p:nvSpPr>
        <p:spPr/>
        <p:txBody>
          <a:bodyPr/>
          <a:lstStyle/>
          <a:p>
            <a:fld id="{82D41842-7D50-45E9-8CF0-98CF31D486F2}" type="datetimeFigureOut">
              <a:rPr lang="es-CL" smtClean="0"/>
              <a:t>11-02-2020</a:t>
            </a:fld>
            <a:endParaRPr lang="es-CL"/>
          </a:p>
        </p:txBody>
      </p:sp>
      <p:sp>
        <p:nvSpPr>
          <p:cNvPr id="4" name="3 Marcador de pie de página"/>
          <p:cNvSpPr>
            <a:spLocks noGrp="1"/>
          </p:cNvSpPr>
          <p:nvPr>
            <p:ph type="ftr" sz="quarter" idx="11"/>
          </p:nvPr>
        </p:nvSpPr>
        <p:spPr/>
        <p:txBody>
          <a:bodyPr/>
          <a:lstStyle/>
          <a:p>
            <a:endParaRPr lang="es-CL"/>
          </a:p>
        </p:txBody>
      </p:sp>
      <p:sp>
        <p:nvSpPr>
          <p:cNvPr id="5" name="4 Marcador de número de diapositiva"/>
          <p:cNvSpPr>
            <a:spLocks noGrp="1"/>
          </p:cNvSpPr>
          <p:nvPr>
            <p:ph type="sldNum" sz="quarter" idx="12"/>
          </p:nvPr>
        </p:nvSpPr>
        <p:spPr/>
        <p:txBody>
          <a:bodyPr/>
          <a:lstStyle/>
          <a:p>
            <a:fld id="{E27B2540-0353-4C4B-8D4B-ADFE2B64C0ED}" type="slidenum">
              <a:rPr lang="es-CL" smtClean="0"/>
              <a:t>‹Nº›</a:t>
            </a:fld>
            <a:endParaRPr lang="es-CL"/>
          </a:p>
        </p:txBody>
      </p:sp>
    </p:spTree>
    <p:extLst>
      <p:ext uri="{BB962C8B-B14F-4D97-AF65-F5344CB8AC3E}">
        <p14:creationId xmlns:p14="http://schemas.microsoft.com/office/powerpoint/2010/main" val="36506827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1 Marcador de fecha"/>
          <p:cNvSpPr>
            <a:spLocks noGrp="1"/>
          </p:cNvSpPr>
          <p:nvPr>
            <p:ph type="dt" sz="half" idx="10"/>
          </p:nvPr>
        </p:nvSpPr>
        <p:spPr/>
        <p:txBody>
          <a:bodyPr/>
          <a:lstStyle/>
          <a:p>
            <a:fld id="{82D41842-7D50-45E9-8CF0-98CF31D486F2}" type="datetimeFigureOut">
              <a:rPr lang="es-CL" smtClean="0"/>
              <a:t>11-02-2020</a:t>
            </a:fld>
            <a:endParaRPr lang="es-CL"/>
          </a:p>
        </p:txBody>
      </p:sp>
      <p:sp>
        <p:nvSpPr>
          <p:cNvPr id="3" name="2 Marcador de pie de página"/>
          <p:cNvSpPr>
            <a:spLocks noGrp="1"/>
          </p:cNvSpPr>
          <p:nvPr>
            <p:ph type="ftr" sz="quarter" idx="11"/>
          </p:nvPr>
        </p:nvSpPr>
        <p:spPr/>
        <p:txBody>
          <a:bodyPr/>
          <a:lstStyle/>
          <a:p>
            <a:endParaRPr lang="es-CL"/>
          </a:p>
        </p:txBody>
      </p:sp>
      <p:sp>
        <p:nvSpPr>
          <p:cNvPr id="4" name="3 Marcador de número de diapositiva"/>
          <p:cNvSpPr>
            <a:spLocks noGrp="1"/>
          </p:cNvSpPr>
          <p:nvPr>
            <p:ph type="sldNum" sz="quarter" idx="12"/>
          </p:nvPr>
        </p:nvSpPr>
        <p:spPr/>
        <p:txBody>
          <a:bodyPr/>
          <a:lstStyle/>
          <a:p>
            <a:fld id="{E27B2540-0353-4C4B-8D4B-ADFE2B64C0ED}" type="slidenum">
              <a:rPr lang="es-CL" smtClean="0"/>
              <a:t>‹Nº›</a:t>
            </a:fld>
            <a:endParaRPr lang="es-CL"/>
          </a:p>
        </p:txBody>
      </p:sp>
    </p:spTree>
    <p:extLst>
      <p:ext uri="{BB962C8B-B14F-4D97-AF65-F5344CB8AC3E}">
        <p14:creationId xmlns:p14="http://schemas.microsoft.com/office/powerpoint/2010/main" val="40646383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457201" y="273050"/>
            <a:ext cx="3008313" cy="1162050"/>
          </a:xfrm>
        </p:spPr>
        <p:txBody>
          <a:bodyPr anchor="b"/>
          <a:lstStyle>
            <a:lvl1pPr algn="l">
              <a:defRPr sz="2000" b="1"/>
            </a:lvl1pPr>
          </a:lstStyle>
          <a:p>
            <a:r>
              <a:rPr lang="es-ES"/>
              <a:t>Haga clic para modificar el estilo de título del patrón</a:t>
            </a:r>
            <a:endParaRPr lang="es-CL"/>
          </a:p>
        </p:txBody>
      </p:sp>
      <p:sp>
        <p:nvSpPr>
          <p:cNvPr id="3" name="2 Marcador de contenido"/>
          <p:cNvSpPr>
            <a:spLocks noGrp="1"/>
          </p:cNvSpPr>
          <p:nvPr>
            <p:ph idx="1"/>
          </p:nvPr>
        </p:nvSpPr>
        <p:spPr>
          <a:xfrm>
            <a:off x="3575050" y="273052"/>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s-CL"/>
          </a:p>
        </p:txBody>
      </p:sp>
      <p:sp>
        <p:nvSpPr>
          <p:cNvPr id="4" name="3 Marcador de texto"/>
          <p:cNvSpPr>
            <a:spLocks noGrp="1"/>
          </p:cNvSpPr>
          <p:nvPr>
            <p:ph type="body" sz="half" idx="2"/>
          </p:nvPr>
        </p:nvSpPr>
        <p:spPr>
          <a:xfrm>
            <a:off x="457201" y="1435102"/>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a:t>Haga clic para modificar el estilo de texto del patrón</a:t>
            </a:r>
          </a:p>
        </p:txBody>
      </p:sp>
      <p:sp>
        <p:nvSpPr>
          <p:cNvPr id="5" name="4 Marcador de fecha"/>
          <p:cNvSpPr>
            <a:spLocks noGrp="1"/>
          </p:cNvSpPr>
          <p:nvPr>
            <p:ph type="dt" sz="half" idx="10"/>
          </p:nvPr>
        </p:nvSpPr>
        <p:spPr/>
        <p:txBody>
          <a:bodyPr/>
          <a:lstStyle/>
          <a:p>
            <a:fld id="{82D41842-7D50-45E9-8CF0-98CF31D486F2}" type="datetimeFigureOut">
              <a:rPr lang="es-CL" smtClean="0"/>
              <a:t>11-02-2020</a:t>
            </a:fld>
            <a:endParaRPr lang="es-CL"/>
          </a:p>
        </p:txBody>
      </p:sp>
      <p:sp>
        <p:nvSpPr>
          <p:cNvPr id="6" name="5 Marcador de pie de página"/>
          <p:cNvSpPr>
            <a:spLocks noGrp="1"/>
          </p:cNvSpPr>
          <p:nvPr>
            <p:ph type="ftr" sz="quarter" idx="11"/>
          </p:nvPr>
        </p:nvSpPr>
        <p:spPr/>
        <p:txBody>
          <a:bodyPr/>
          <a:lstStyle/>
          <a:p>
            <a:endParaRPr lang="es-CL"/>
          </a:p>
        </p:txBody>
      </p:sp>
      <p:sp>
        <p:nvSpPr>
          <p:cNvPr id="7" name="6 Marcador de número de diapositiva"/>
          <p:cNvSpPr>
            <a:spLocks noGrp="1"/>
          </p:cNvSpPr>
          <p:nvPr>
            <p:ph type="sldNum" sz="quarter" idx="12"/>
          </p:nvPr>
        </p:nvSpPr>
        <p:spPr/>
        <p:txBody>
          <a:bodyPr/>
          <a:lstStyle/>
          <a:p>
            <a:fld id="{E27B2540-0353-4C4B-8D4B-ADFE2B64C0ED}" type="slidenum">
              <a:rPr lang="es-CL" smtClean="0"/>
              <a:t>‹Nº›</a:t>
            </a:fld>
            <a:endParaRPr lang="es-CL"/>
          </a:p>
        </p:txBody>
      </p:sp>
    </p:spTree>
    <p:extLst>
      <p:ext uri="{BB962C8B-B14F-4D97-AF65-F5344CB8AC3E}">
        <p14:creationId xmlns:p14="http://schemas.microsoft.com/office/powerpoint/2010/main" val="6185742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1792288" y="4800600"/>
            <a:ext cx="5486400" cy="566738"/>
          </a:xfrm>
        </p:spPr>
        <p:txBody>
          <a:bodyPr anchor="b"/>
          <a:lstStyle>
            <a:lvl1pPr algn="l">
              <a:defRPr sz="2000" b="1"/>
            </a:lvl1pPr>
          </a:lstStyle>
          <a:p>
            <a:r>
              <a:rPr lang="es-ES"/>
              <a:t>Haga clic para modificar el estilo de título del patrón</a:t>
            </a:r>
            <a:endParaRPr lang="es-CL"/>
          </a:p>
        </p:txBody>
      </p:sp>
      <p:sp>
        <p:nvSpPr>
          <p:cNvPr id="3" name="2 Marcador de posición de imagen"/>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CL"/>
          </a:p>
        </p:txBody>
      </p:sp>
      <p:sp>
        <p:nvSpPr>
          <p:cNvPr id="4" name="3 Marcador de texto"/>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s-ES"/>
              <a:t>Haga clic para modificar el estilo de texto del patrón</a:t>
            </a:r>
          </a:p>
        </p:txBody>
      </p:sp>
      <p:sp>
        <p:nvSpPr>
          <p:cNvPr id="5" name="4 Marcador de fecha"/>
          <p:cNvSpPr>
            <a:spLocks noGrp="1"/>
          </p:cNvSpPr>
          <p:nvPr>
            <p:ph type="dt" sz="half" idx="10"/>
          </p:nvPr>
        </p:nvSpPr>
        <p:spPr/>
        <p:txBody>
          <a:bodyPr/>
          <a:lstStyle/>
          <a:p>
            <a:fld id="{82D41842-7D50-45E9-8CF0-98CF31D486F2}" type="datetimeFigureOut">
              <a:rPr lang="es-CL" smtClean="0"/>
              <a:t>11-02-2020</a:t>
            </a:fld>
            <a:endParaRPr lang="es-CL"/>
          </a:p>
        </p:txBody>
      </p:sp>
      <p:sp>
        <p:nvSpPr>
          <p:cNvPr id="6" name="5 Marcador de pie de página"/>
          <p:cNvSpPr>
            <a:spLocks noGrp="1"/>
          </p:cNvSpPr>
          <p:nvPr>
            <p:ph type="ftr" sz="quarter" idx="11"/>
          </p:nvPr>
        </p:nvSpPr>
        <p:spPr/>
        <p:txBody>
          <a:bodyPr/>
          <a:lstStyle/>
          <a:p>
            <a:endParaRPr lang="es-CL"/>
          </a:p>
        </p:txBody>
      </p:sp>
      <p:sp>
        <p:nvSpPr>
          <p:cNvPr id="7" name="6 Marcador de número de diapositiva"/>
          <p:cNvSpPr>
            <a:spLocks noGrp="1"/>
          </p:cNvSpPr>
          <p:nvPr>
            <p:ph type="sldNum" sz="quarter" idx="12"/>
          </p:nvPr>
        </p:nvSpPr>
        <p:spPr/>
        <p:txBody>
          <a:bodyPr/>
          <a:lstStyle/>
          <a:p>
            <a:fld id="{E27B2540-0353-4C4B-8D4B-ADFE2B64C0ED}" type="slidenum">
              <a:rPr lang="es-CL" smtClean="0"/>
              <a:t>‹Nº›</a:t>
            </a:fld>
            <a:endParaRPr lang="es-CL"/>
          </a:p>
        </p:txBody>
      </p:sp>
    </p:spTree>
    <p:extLst>
      <p:ext uri="{BB962C8B-B14F-4D97-AF65-F5344CB8AC3E}">
        <p14:creationId xmlns:p14="http://schemas.microsoft.com/office/powerpoint/2010/main" val="15737669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título"/>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s-ES"/>
              <a:t>Haga clic para modificar el estilo de título del patrón</a:t>
            </a:r>
            <a:endParaRPr lang="es-CL"/>
          </a:p>
        </p:txBody>
      </p:sp>
      <p:sp>
        <p:nvSpPr>
          <p:cNvPr id="3" name="2 Marcador de texto"/>
          <p:cNvSpPr>
            <a:spLocks noGrp="1"/>
          </p:cNvSpPr>
          <p:nvPr>
            <p:ph type="body" idx="1"/>
          </p:nvPr>
        </p:nvSpPr>
        <p:spPr>
          <a:xfrm>
            <a:off x="457200" y="1600202"/>
            <a:ext cx="8229600" cy="4525963"/>
          </a:xfrm>
          <a:prstGeom prst="rect">
            <a:avLst/>
          </a:prstGeom>
        </p:spPr>
        <p:txBody>
          <a:bodyPr vert="horz" lIns="91440" tIns="45720" rIns="91440" bIns="45720" rtlCol="0">
            <a:normAutofit/>
          </a:bodyPr>
          <a:lstStyle/>
          <a:p>
            <a:pPr lvl="0"/>
            <a:r>
              <a:rPr lang="es-ES"/>
              <a:t>Haga clic para modificar el estilo de texto del patrón</a:t>
            </a:r>
          </a:p>
          <a:p>
            <a:pPr lvl="1"/>
            <a:r>
              <a:rPr lang="es-ES"/>
              <a:t>Segundo nivel</a:t>
            </a:r>
          </a:p>
          <a:p>
            <a:pPr lvl="2"/>
            <a:r>
              <a:rPr lang="es-ES"/>
              <a:t>Tercer nivel</a:t>
            </a:r>
          </a:p>
          <a:p>
            <a:pPr lvl="3"/>
            <a:r>
              <a:rPr lang="es-ES"/>
              <a:t>Cuarto nivel</a:t>
            </a:r>
          </a:p>
          <a:p>
            <a:pPr lvl="4"/>
            <a:r>
              <a:rPr lang="es-ES"/>
              <a:t>Quinto nivel</a:t>
            </a:r>
            <a:endParaRPr lang="es-CL"/>
          </a:p>
        </p:txBody>
      </p:sp>
      <p:sp>
        <p:nvSpPr>
          <p:cNvPr id="4" name="3 Marcador de fecha"/>
          <p:cNvSpPr>
            <a:spLocks noGrp="1"/>
          </p:cNvSpPr>
          <p:nvPr>
            <p:ph type="dt" sz="half" idx="2"/>
          </p:nvPr>
        </p:nvSpPr>
        <p:spPr>
          <a:xfrm>
            <a:off x="457200" y="6356352"/>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2D41842-7D50-45E9-8CF0-98CF31D486F2}" type="datetimeFigureOut">
              <a:rPr lang="es-CL" smtClean="0"/>
              <a:t>11-02-2020</a:t>
            </a:fld>
            <a:endParaRPr lang="es-CL"/>
          </a:p>
        </p:txBody>
      </p:sp>
      <p:sp>
        <p:nvSpPr>
          <p:cNvPr id="5" name="4 Marcador de pie de página"/>
          <p:cNvSpPr>
            <a:spLocks noGrp="1"/>
          </p:cNvSpPr>
          <p:nvPr>
            <p:ph type="ftr" sz="quarter" idx="3"/>
          </p:nvPr>
        </p:nvSpPr>
        <p:spPr>
          <a:xfrm>
            <a:off x="3124200" y="6356352"/>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CL"/>
          </a:p>
        </p:txBody>
      </p:sp>
      <p:sp>
        <p:nvSpPr>
          <p:cNvPr id="6" name="5 Marcador de número de diapositiva"/>
          <p:cNvSpPr>
            <a:spLocks noGrp="1"/>
          </p:cNvSpPr>
          <p:nvPr>
            <p:ph type="sldNum" sz="quarter" idx="4"/>
          </p:nvPr>
        </p:nvSpPr>
        <p:spPr>
          <a:xfrm>
            <a:off x="6553200" y="6356352"/>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27B2540-0353-4C4B-8D4B-ADFE2B64C0ED}" type="slidenum">
              <a:rPr lang="es-CL" smtClean="0"/>
              <a:t>‹Nº›</a:t>
            </a:fld>
            <a:endParaRPr lang="es-CL"/>
          </a:p>
        </p:txBody>
      </p:sp>
    </p:spTree>
    <p:extLst>
      <p:ext uri="{BB962C8B-B14F-4D97-AF65-F5344CB8AC3E}">
        <p14:creationId xmlns:p14="http://schemas.microsoft.com/office/powerpoint/2010/main" val="59374680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s-C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benito.gomez@uantof.cl" TargetMode="Externa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image" Target="../media/image9.emf"/><Relationship Id="rId1" Type="http://schemas.openxmlformats.org/officeDocument/2006/relationships/slideLayout" Target="../slideLayouts/slideLayout7.xml"/><Relationship Id="rId4" Type="http://schemas.openxmlformats.org/officeDocument/2006/relationships/image" Target="../media/image13.emf"/></Relationships>
</file>

<file path=ppt/slides/_rels/slide11.xml.rels><?xml version="1.0" encoding="UTF-8" standalone="yes"?>
<Relationships xmlns="http://schemas.openxmlformats.org/package/2006/relationships"><Relationship Id="rId3" Type="http://schemas.openxmlformats.org/officeDocument/2006/relationships/image" Target="../media/image15.emf"/><Relationship Id="rId2" Type="http://schemas.openxmlformats.org/officeDocument/2006/relationships/image" Target="../media/image14.emf"/><Relationship Id="rId1" Type="http://schemas.openxmlformats.org/officeDocument/2006/relationships/slideLayout" Target="../slideLayouts/slideLayout7.xml"/><Relationship Id="rId4" Type="http://schemas.openxmlformats.org/officeDocument/2006/relationships/image" Target="../media/image16.emf"/></Relationships>
</file>

<file path=ppt/slides/_rels/slide12.x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image" Target="../media/image14.emf"/><Relationship Id="rId1" Type="http://schemas.openxmlformats.org/officeDocument/2006/relationships/slideLayout" Target="../slideLayouts/slideLayout7.xml"/><Relationship Id="rId4" Type="http://schemas.openxmlformats.org/officeDocument/2006/relationships/image" Target="../media/image18.emf"/></Relationships>
</file>

<file path=ppt/slides/_rels/slide13.xml.rels><?xml version="1.0" encoding="UTF-8" standalone="yes"?>
<Relationships xmlns="http://schemas.openxmlformats.org/package/2006/relationships"><Relationship Id="rId3" Type="http://schemas.openxmlformats.org/officeDocument/2006/relationships/image" Target="../media/image20.emf"/><Relationship Id="rId2" Type="http://schemas.openxmlformats.org/officeDocument/2006/relationships/image" Target="../media/image19.emf"/><Relationship Id="rId1" Type="http://schemas.openxmlformats.org/officeDocument/2006/relationships/slideLayout" Target="../slideLayouts/slideLayout7.xml"/><Relationship Id="rId4" Type="http://schemas.openxmlformats.org/officeDocument/2006/relationships/image" Target="../media/image21.emf"/></Relationships>
</file>

<file path=ppt/slides/_rels/slide14.xml.rels><?xml version="1.0" encoding="UTF-8" standalone="yes"?>
<Relationships xmlns="http://schemas.openxmlformats.org/package/2006/relationships"><Relationship Id="rId3" Type="http://schemas.openxmlformats.org/officeDocument/2006/relationships/image" Target="../media/image22.tif"/><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7.xml"/><Relationship Id="rId4" Type="http://schemas.openxmlformats.org/officeDocument/2006/relationships/image" Target="../media/image4.png"/></Relationships>
</file>

<file path=ppt/slides/_rels/slide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5.em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image" Target="../media/image6.emf"/><Relationship Id="rId1" Type="http://schemas.openxmlformats.org/officeDocument/2006/relationships/slideLayout" Target="../slideLayouts/slideLayout7.xml"/><Relationship Id="rId4" Type="http://schemas.openxmlformats.org/officeDocument/2006/relationships/image" Target="../media/image8.emf"/></Relationships>
</file>

<file path=ppt/slides/_rels/slide9.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image" Target="../media/image9.emf"/><Relationship Id="rId1" Type="http://schemas.openxmlformats.org/officeDocument/2006/relationships/slideLayout" Target="../slideLayouts/slideLayout7.xml"/><Relationship Id="rId4" Type="http://schemas.openxmlformats.org/officeDocument/2006/relationships/image" Target="../media/image1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1 CuadroTexto"/>
          <p:cNvSpPr txBox="1"/>
          <p:nvPr/>
        </p:nvSpPr>
        <p:spPr>
          <a:xfrm>
            <a:off x="1691680" y="332656"/>
            <a:ext cx="5832648" cy="400110"/>
          </a:xfrm>
          <a:prstGeom prst="rect">
            <a:avLst/>
          </a:prstGeom>
          <a:noFill/>
        </p:spPr>
        <p:txBody>
          <a:bodyPr wrap="square" rtlCol="0">
            <a:spAutoFit/>
          </a:bodyPr>
          <a:lstStyle/>
          <a:p>
            <a:pPr algn="ctr"/>
            <a:r>
              <a:rPr lang="es-CL" sz="2000" b="1" u="sng" dirty="0"/>
              <a:t>SUPPORTING INFORMATION</a:t>
            </a:r>
          </a:p>
        </p:txBody>
      </p:sp>
      <p:sp>
        <p:nvSpPr>
          <p:cNvPr id="3" name="2 CuadroTexto"/>
          <p:cNvSpPr txBox="1"/>
          <p:nvPr/>
        </p:nvSpPr>
        <p:spPr>
          <a:xfrm>
            <a:off x="251520" y="1174102"/>
            <a:ext cx="8640960" cy="3600986"/>
          </a:xfrm>
          <a:prstGeom prst="rect">
            <a:avLst/>
          </a:prstGeom>
          <a:noFill/>
        </p:spPr>
        <p:txBody>
          <a:bodyPr wrap="square" rtlCol="0">
            <a:spAutoFit/>
          </a:bodyPr>
          <a:lstStyle/>
          <a:p>
            <a:pPr algn="ctr"/>
            <a:r>
              <a:rPr lang="en-US" sz="1200" b="1" i="1" dirty="0">
                <a:latin typeface="Times New Roman" panose="02020603050405020304" pitchFamily="18" charset="0"/>
                <a:cs typeface="Times New Roman" panose="02020603050405020304" pitchFamily="18" charset="0"/>
              </a:rPr>
              <a:t>HALOTERRIGENA</a:t>
            </a:r>
            <a:r>
              <a:rPr lang="en-US" sz="1200" b="1" dirty="0">
                <a:latin typeface="Times New Roman" panose="02020603050405020304" pitchFamily="18" charset="0"/>
                <a:cs typeface="Times New Roman" panose="02020603050405020304" pitchFamily="18" charset="0"/>
              </a:rPr>
              <a:t> SP. STRAIN SGH1, A BACTERIORUBERIN-RICH, PERCHLORATE-TOLERANT HALOPHILIC ARCHAEON ISOLATED FROM HALITES MICROBIAL COMMUNITIES, ATACAMA DESERT, CHILE.</a:t>
            </a:r>
          </a:p>
          <a:p>
            <a:endParaRPr lang="es-CL" sz="1200" dirty="0">
              <a:latin typeface="Times New Roman" panose="02020603050405020304" pitchFamily="18" charset="0"/>
              <a:cs typeface="Times New Roman" panose="02020603050405020304" pitchFamily="18" charset="0"/>
            </a:endParaRPr>
          </a:p>
          <a:p>
            <a:r>
              <a:rPr lang="es-CL" sz="1200" b="1" dirty="0">
                <a:latin typeface="Times New Roman" panose="02020603050405020304" pitchFamily="18" charset="0"/>
                <a:cs typeface="Times New Roman" panose="02020603050405020304" pitchFamily="18" charset="0"/>
              </a:rPr>
              <a:t>Nataly Flores</a:t>
            </a:r>
            <a:r>
              <a:rPr lang="es-CL" sz="1200" b="1" baseline="30000" dirty="0">
                <a:latin typeface="Times New Roman" panose="02020603050405020304" pitchFamily="18" charset="0"/>
                <a:cs typeface="Times New Roman" panose="02020603050405020304" pitchFamily="18" charset="0"/>
              </a:rPr>
              <a:t>1</a:t>
            </a:r>
            <a:r>
              <a:rPr lang="es-CL" sz="1200" b="1" dirty="0">
                <a:latin typeface="Times New Roman" panose="02020603050405020304" pitchFamily="18" charset="0"/>
                <a:cs typeface="Times New Roman" panose="02020603050405020304" pitchFamily="18" charset="0"/>
              </a:rPr>
              <a:t>, Sebastián Hoyos</a:t>
            </a:r>
            <a:r>
              <a:rPr lang="es-CL" sz="1200" b="1" baseline="30000" dirty="0">
                <a:latin typeface="Times New Roman" panose="02020603050405020304" pitchFamily="18" charset="0"/>
                <a:cs typeface="Times New Roman" panose="02020603050405020304" pitchFamily="18" charset="0"/>
              </a:rPr>
              <a:t>1</a:t>
            </a:r>
            <a:r>
              <a:rPr lang="es-CL" sz="1200" b="1" dirty="0">
                <a:latin typeface="Times New Roman" panose="02020603050405020304" pitchFamily="18" charset="0"/>
                <a:cs typeface="Times New Roman" panose="02020603050405020304" pitchFamily="18" charset="0"/>
              </a:rPr>
              <a:t>, Mauricio Venegas</a:t>
            </a:r>
            <a:r>
              <a:rPr lang="es-CL" sz="1200" b="1" baseline="30000" dirty="0">
                <a:latin typeface="Times New Roman" panose="02020603050405020304" pitchFamily="18" charset="0"/>
                <a:cs typeface="Times New Roman" panose="02020603050405020304" pitchFamily="18" charset="0"/>
              </a:rPr>
              <a:t>1</a:t>
            </a:r>
            <a:r>
              <a:rPr lang="es-CL" sz="1200" b="1" dirty="0">
                <a:latin typeface="Times New Roman" panose="02020603050405020304" pitchFamily="18" charset="0"/>
                <a:cs typeface="Times New Roman" panose="02020603050405020304" pitchFamily="18" charset="0"/>
              </a:rPr>
              <a:t>, Alexandra Galetović</a:t>
            </a:r>
            <a:r>
              <a:rPr lang="es-CL" sz="1200" b="1" baseline="30000" dirty="0">
                <a:latin typeface="Times New Roman" panose="02020603050405020304" pitchFamily="18" charset="0"/>
                <a:cs typeface="Times New Roman" panose="02020603050405020304" pitchFamily="18" charset="0"/>
              </a:rPr>
              <a:t>1</a:t>
            </a:r>
            <a:r>
              <a:rPr lang="es-CL" sz="1200" b="1" dirty="0">
                <a:latin typeface="Times New Roman" panose="02020603050405020304" pitchFamily="18" charset="0"/>
                <a:cs typeface="Times New Roman" panose="02020603050405020304" pitchFamily="18" charset="0"/>
              </a:rPr>
              <a:t>, Lidia M. Zúñiga</a:t>
            </a:r>
            <a:r>
              <a:rPr lang="es-CL" sz="1200" b="1" baseline="30000" dirty="0">
                <a:latin typeface="Times New Roman" panose="02020603050405020304" pitchFamily="18" charset="0"/>
                <a:cs typeface="Times New Roman" panose="02020603050405020304" pitchFamily="18" charset="0"/>
              </a:rPr>
              <a:t>1</a:t>
            </a:r>
            <a:r>
              <a:rPr lang="es-CL" sz="1200" b="1" dirty="0">
                <a:latin typeface="Times New Roman" panose="02020603050405020304" pitchFamily="18" charset="0"/>
                <a:cs typeface="Times New Roman" panose="02020603050405020304" pitchFamily="18" charset="0"/>
              </a:rPr>
              <a:t>, Francisca Fábrega</a:t>
            </a:r>
            <a:r>
              <a:rPr lang="es-CL" sz="1200" b="1" baseline="30000" dirty="0">
                <a:latin typeface="Times New Roman" panose="02020603050405020304" pitchFamily="18" charset="0"/>
                <a:cs typeface="Times New Roman" panose="02020603050405020304" pitchFamily="18" charset="0"/>
              </a:rPr>
              <a:t>1</a:t>
            </a:r>
            <a:r>
              <a:rPr lang="es-CL" sz="1200" b="1" dirty="0">
                <a:latin typeface="Times New Roman" panose="02020603050405020304" pitchFamily="18" charset="0"/>
                <a:cs typeface="Times New Roman" panose="02020603050405020304" pitchFamily="18" charset="0"/>
              </a:rPr>
              <a:t>, Bernardo Paredes</a:t>
            </a:r>
            <a:r>
              <a:rPr lang="es-CL" sz="1200" b="1" baseline="30000" dirty="0">
                <a:latin typeface="Times New Roman" panose="02020603050405020304" pitchFamily="18" charset="0"/>
                <a:cs typeface="Times New Roman" panose="02020603050405020304" pitchFamily="18" charset="0"/>
              </a:rPr>
              <a:t>1</a:t>
            </a:r>
            <a:r>
              <a:rPr lang="es-CL" sz="1200" b="1" dirty="0">
                <a:latin typeface="Times New Roman" panose="02020603050405020304" pitchFamily="18" charset="0"/>
                <a:cs typeface="Times New Roman" panose="02020603050405020304" pitchFamily="18" charset="0"/>
              </a:rPr>
              <a:t>, Camila Salazar-Ardiles</a:t>
            </a:r>
            <a:r>
              <a:rPr lang="es-CL" sz="1200" b="1" baseline="30000" dirty="0">
                <a:latin typeface="Times New Roman" panose="02020603050405020304" pitchFamily="18" charset="0"/>
                <a:cs typeface="Times New Roman" panose="02020603050405020304" pitchFamily="18" charset="0"/>
              </a:rPr>
              <a:t>1</a:t>
            </a:r>
            <a:r>
              <a:rPr lang="es-CL" sz="1200" b="1" dirty="0">
                <a:latin typeface="Times New Roman" panose="02020603050405020304" pitchFamily="18" charset="0"/>
                <a:cs typeface="Times New Roman" panose="02020603050405020304" pitchFamily="18" charset="0"/>
              </a:rPr>
              <a:t>, Claudia Vilo</a:t>
            </a:r>
            <a:r>
              <a:rPr lang="es-CL" sz="1200" b="1" baseline="30000" dirty="0">
                <a:latin typeface="Times New Roman" panose="02020603050405020304" pitchFamily="18" charset="0"/>
                <a:cs typeface="Times New Roman" panose="02020603050405020304" pitchFamily="18" charset="0"/>
              </a:rPr>
              <a:t>1</a:t>
            </a:r>
            <a:r>
              <a:rPr lang="es-CL" sz="1200" b="1" dirty="0">
                <a:latin typeface="Times New Roman" panose="02020603050405020304" pitchFamily="18" charset="0"/>
                <a:cs typeface="Times New Roman" panose="02020603050405020304" pitchFamily="18" charset="0"/>
              </a:rPr>
              <a:t>, Carmen Ascaso</a:t>
            </a:r>
            <a:r>
              <a:rPr lang="es-CL" sz="1200" b="1" baseline="30000" dirty="0">
                <a:latin typeface="Times New Roman" panose="02020603050405020304" pitchFamily="18" charset="0"/>
                <a:cs typeface="Times New Roman" panose="02020603050405020304" pitchFamily="18" charset="0"/>
              </a:rPr>
              <a:t>3</a:t>
            </a:r>
            <a:r>
              <a:rPr lang="es-CL" sz="1200" b="1" dirty="0">
                <a:latin typeface="Times New Roman" panose="02020603050405020304" pitchFamily="18" charset="0"/>
                <a:cs typeface="Times New Roman" panose="02020603050405020304" pitchFamily="18" charset="0"/>
              </a:rPr>
              <a:t>, Jacek Wierzchos</a:t>
            </a:r>
            <a:r>
              <a:rPr lang="es-CL" sz="1200" b="1" baseline="30000" dirty="0">
                <a:latin typeface="Times New Roman" panose="02020603050405020304" pitchFamily="18" charset="0"/>
                <a:cs typeface="Times New Roman" panose="02020603050405020304" pitchFamily="18" charset="0"/>
              </a:rPr>
              <a:t>3</a:t>
            </a:r>
            <a:r>
              <a:rPr lang="es-CL" sz="1200" b="1" dirty="0">
                <a:latin typeface="Times New Roman" panose="02020603050405020304" pitchFamily="18" charset="0"/>
                <a:cs typeface="Times New Roman" panose="02020603050405020304" pitchFamily="18" charset="0"/>
              </a:rPr>
              <a:t>, Virginia Souza-Egipsy</a:t>
            </a:r>
            <a:r>
              <a:rPr lang="es-CL" sz="1200" b="1" baseline="30000" dirty="0">
                <a:latin typeface="Times New Roman" panose="02020603050405020304" pitchFamily="18" charset="0"/>
                <a:cs typeface="Times New Roman" panose="02020603050405020304" pitchFamily="18" charset="0"/>
              </a:rPr>
              <a:t>4</a:t>
            </a:r>
            <a:r>
              <a:rPr lang="es-CL" sz="1200" b="1" dirty="0">
                <a:latin typeface="Times New Roman" panose="02020603050405020304" pitchFamily="18" charset="0"/>
                <a:cs typeface="Times New Roman" panose="02020603050405020304" pitchFamily="18" charset="0"/>
              </a:rPr>
              <a:t>, Jorge E. Araya</a:t>
            </a:r>
            <a:r>
              <a:rPr lang="es-CL" sz="1200" b="1" baseline="30000" dirty="0">
                <a:latin typeface="Times New Roman" panose="02020603050405020304" pitchFamily="18" charset="0"/>
                <a:cs typeface="Times New Roman" panose="02020603050405020304" pitchFamily="18" charset="0"/>
              </a:rPr>
              <a:t>2</a:t>
            </a:r>
            <a:r>
              <a:rPr lang="es-CL" sz="1200" b="1" dirty="0">
                <a:latin typeface="Times New Roman" panose="02020603050405020304" pitchFamily="18" charset="0"/>
                <a:cs typeface="Times New Roman" panose="02020603050405020304" pitchFamily="18" charset="0"/>
              </a:rPr>
              <a:t>, Ramón Alberto Batista García</a:t>
            </a:r>
            <a:r>
              <a:rPr lang="es-CL" sz="1200" b="1" baseline="30000" dirty="0">
                <a:latin typeface="Times New Roman" panose="02020603050405020304" pitchFamily="18" charset="0"/>
                <a:cs typeface="Times New Roman" panose="02020603050405020304" pitchFamily="18" charset="0"/>
              </a:rPr>
              <a:t>5</a:t>
            </a:r>
            <a:r>
              <a:rPr lang="es-CL" sz="1200" b="1" dirty="0">
                <a:latin typeface="Times New Roman" panose="02020603050405020304" pitchFamily="18" charset="0"/>
                <a:cs typeface="Times New Roman" panose="02020603050405020304" pitchFamily="18" charset="0"/>
              </a:rPr>
              <a:t>, Benito Gómez-Silva</a:t>
            </a:r>
            <a:r>
              <a:rPr lang="es-CL" sz="1200" b="1" baseline="30000" dirty="0">
                <a:latin typeface="Times New Roman" panose="02020603050405020304" pitchFamily="18" charset="0"/>
                <a:cs typeface="Times New Roman" panose="02020603050405020304" pitchFamily="18" charset="0"/>
              </a:rPr>
              <a:t>1</a:t>
            </a:r>
            <a:r>
              <a:rPr lang="es-CL" sz="1200" b="1" dirty="0">
                <a:latin typeface="Times New Roman" panose="02020603050405020304" pitchFamily="18" charset="0"/>
                <a:cs typeface="Times New Roman" panose="02020603050405020304" pitchFamily="18" charset="0"/>
              </a:rPr>
              <a:t>*</a:t>
            </a:r>
            <a:endParaRPr lang="en-US" sz="1200" b="1" dirty="0">
              <a:latin typeface="Times New Roman" panose="02020603050405020304" pitchFamily="18" charset="0"/>
              <a:cs typeface="Times New Roman" panose="02020603050405020304" pitchFamily="18" charset="0"/>
            </a:endParaRPr>
          </a:p>
          <a:p>
            <a:r>
              <a:rPr lang="es-CL" sz="1200" dirty="0">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a:p>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Laboratory of Biochemistry, Biomedical Department, and Centre for Biotechnology and Bioengineering, CeBiB, Universidad de Antofagasta, Antofagasta, Chile.</a:t>
            </a:r>
          </a:p>
          <a:p>
            <a:r>
              <a:rPr lang="en-US" sz="1200" baseline="30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Laboratory of Molecular Parasitology, Department of Medical Technology, and Centre for Biotechnology and Bioengineering, CeBiB, Universidad de Antofagasta, Antofagasta, Chile.</a:t>
            </a:r>
          </a:p>
          <a:p>
            <a:r>
              <a:rPr lang="en-US" sz="1200" baseline="30000"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Dept. Biogeochemistry and Microbial Ecology, National Museum of Natural Sciences - CSIC, Madrid, Spain.</a:t>
            </a:r>
          </a:p>
          <a:p>
            <a:r>
              <a:rPr lang="en-US" sz="1200" baseline="30000" dirty="0">
                <a:latin typeface="Times New Roman" panose="02020603050405020304" pitchFamily="18" charset="0"/>
                <a:cs typeface="Times New Roman" panose="02020603050405020304" pitchFamily="18" charset="0"/>
              </a:rPr>
              <a:t>4</a:t>
            </a:r>
            <a:r>
              <a:rPr lang="en-US" sz="1200" dirty="0">
                <a:latin typeface="Times New Roman" panose="02020603050405020304" pitchFamily="18" charset="0"/>
                <a:cs typeface="Times New Roman" panose="02020603050405020304" pitchFamily="18" charset="0"/>
              </a:rPr>
              <a:t>Dept. of Macromolecular Physics, Institute of Material Structure - CSIC, Madrid, Spain.</a:t>
            </a:r>
          </a:p>
          <a:p>
            <a:r>
              <a:rPr lang="es-CL" sz="1200" baseline="30000" dirty="0">
                <a:latin typeface="Times New Roman" panose="02020603050405020304" pitchFamily="18" charset="0"/>
                <a:cs typeface="Times New Roman" panose="02020603050405020304" pitchFamily="18" charset="0"/>
              </a:rPr>
              <a:t>5</a:t>
            </a:r>
            <a:r>
              <a:rPr lang="es-CL" sz="1200" dirty="0">
                <a:latin typeface="Times New Roman" panose="02020603050405020304" pitchFamily="18" charset="0"/>
                <a:cs typeface="Times New Roman" panose="02020603050405020304" pitchFamily="18" charset="0"/>
              </a:rPr>
              <a:t>Centro de Investigación en Dinámica Celular, Instituto de Investigaciones en Ciencias Básicas y Aplicadas, Universidad Autónoma del Estado de Morelos, Cuernavaca, Morelos, </a:t>
            </a:r>
            <a:r>
              <a:rPr lang="es-CL" sz="1200" dirty="0" err="1">
                <a:latin typeface="Times New Roman" panose="02020603050405020304" pitchFamily="18" charset="0"/>
                <a:cs typeface="Times New Roman" panose="02020603050405020304" pitchFamily="18" charset="0"/>
              </a:rPr>
              <a:t>Mexico</a:t>
            </a:r>
            <a:r>
              <a:rPr lang="es-CL" sz="1200" dirty="0">
                <a:latin typeface="Times New Roman" panose="02020603050405020304" pitchFamily="18" charset="0"/>
                <a:cs typeface="Times New Roman" panose="02020603050405020304" pitchFamily="18" charset="0"/>
              </a:rPr>
              <a:t>.</a:t>
            </a:r>
            <a:endParaRPr lang="en-US" sz="1200" dirty="0">
              <a:latin typeface="Times New Roman" panose="02020603050405020304" pitchFamily="18" charset="0"/>
              <a:cs typeface="Times New Roman" panose="02020603050405020304" pitchFamily="18" charset="0"/>
            </a:endParaRPr>
          </a:p>
          <a:p>
            <a:r>
              <a:rPr lang="en-US" sz="1200" b="1" dirty="0">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a:p>
            <a:r>
              <a:rPr lang="es-CL" sz="1200" b="1" dirty="0">
                <a:latin typeface="Times New Roman" panose="02020603050405020304" pitchFamily="18" charset="0"/>
                <a:cs typeface="Times New Roman" panose="02020603050405020304" pitchFamily="18" charset="0"/>
              </a:rPr>
              <a:t>* Correspondence: </a:t>
            </a:r>
            <a:br>
              <a:rPr lang="es-CL" sz="1200" b="1" dirty="0">
                <a:latin typeface="Times New Roman" panose="02020603050405020304" pitchFamily="18" charset="0"/>
                <a:cs typeface="Times New Roman" panose="02020603050405020304" pitchFamily="18" charset="0"/>
              </a:rPr>
            </a:br>
            <a:r>
              <a:rPr lang="es-CL" sz="1200" dirty="0">
                <a:latin typeface="Times New Roman" panose="02020603050405020304" pitchFamily="18" charset="0"/>
                <a:cs typeface="Times New Roman" panose="02020603050405020304" pitchFamily="18" charset="0"/>
              </a:rPr>
              <a:t>Benito Gómez-Silva</a:t>
            </a:r>
            <a:br>
              <a:rPr lang="es-CL" sz="1200" dirty="0">
                <a:latin typeface="Times New Roman" panose="02020603050405020304" pitchFamily="18" charset="0"/>
                <a:cs typeface="Times New Roman" panose="02020603050405020304" pitchFamily="18" charset="0"/>
              </a:rPr>
            </a:br>
            <a:r>
              <a:rPr lang="es-CL" sz="1200" u="sng" dirty="0">
                <a:latin typeface="Times New Roman" panose="02020603050405020304" pitchFamily="18" charset="0"/>
                <a:cs typeface="Times New Roman" panose="02020603050405020304" pitchFamily="18" charset="0"/>
                <a:hlinkClick r:id="rId2"/>
              </a:rPr>
              <a:t>benito.gomez@uantof.cl</a:t>
            </a:r>
            <a:r>
              <a:rPr lang="es-CL" sz="1200" dirty="0">
                <a:latin typeface="Times New Roman" panose="02020603050405020304" pitchFamily="18" charset="0"/>
                <a:cs typeface="Times New Roman" panose="02020603050405020304" pitchFamily="18" charset="0"/>
              </a:rPr>
              <a:t> </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8871559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1 Imagen"/>
          <p:cNvPicPr/>
          <p:nvPr/>
        </p:nvPicPr>
        <p:blipFill rotWithShape="1">
          <a:blip r:embed="rId2">
            <a:extLst>
              <a:ext uri="{28A0092B-C50C-407E-A947-70E740481C1C}">
                <a14:useLocalDpi xmlns:a14="http://schemas.microsoft.com/office/drawing/2010/main" val="0"/>
              </a:ext>
            </a:extLst>
          </a:blip>
          <a:srcRect r="6551"/>
          <a:stretch/>
        </p:blipFill>
        <p:spPr bwMode="auto">
          <a:xfrm>
            <a:off x="255332" y="908720"/>
            <a:ext cx="7128792" cy="2808312"/>
          </a:xfrm>
          <a:prstGeom prst="rect">
            <a:avLst/>
          </a:prstGeom>
          <a:noFill/>
          <a:ln>
            <a:noFill/>
          </a:ln>
          <a:extLst>
            <a:ext uri="{53640926-AAD7-44D8-BBD7-CCE9431645EC}">
              <a14:shadowObscured xmlns:a14="http://schemas.microsoft.com/office/drawing/2010/main"/>
            </a:ext>
          </a:extLst>
        </p:spPr>
      </p:pic>
      <p:pic>
        <p:nvPicPr>
          <p:cNvPr id="3" name="2 Imagen"/>
          <p:cNvPicPr/>
          <p:nvPr/>
        </p:nvPicPr>
        <p:blipFill rotWithShape="1">
          <a:blip r:embed="rId3" cstate="print">
            <a:extLst>
              <a:ext uri="{28A0092B-C50C-407E-A947-70E740481C1C}">
                <a14:useLocalDpi xmlns:a14="http://schemas.microsoft.com/office/drawing/2010/main" val="0"/>
              </a:ext>
            </a:extLst>
          </a:blip>
          <a:srcRect t="19360" r="14559"/>
          <a:stretch/>
        </p:blipFill>
        <p:spPr bwMode="auto">
          <a:xfrm>
            <a:off x="5580112" y="836712"/>
            <a:ext cx="3252202" cy="2232248"/>
          </a:xfrm>
          <a:prstGeom prst="rect">
            <a:avLst/>
          </a:prstGeom>
          <a:solidFill>
            <a:schemeClr val="bg1"/>
          </a:solidFill>
          <a:ln>
            <a:noFill/>
          </a:ln>
          <a:extLst>
            <a:ext uri="{53640926-AAD7-44D8-BBD7-CCE9431645EC}">
              <a14:shadowObscured xmlns:a14="http://schemas.microsoft.com/office/drawing/2010/main"/>
            </a:ext>
          </a:extLst>
        </p:spPr>
      </p:pic>
      <p:pic>
        <p:nvPicPr>
          <p:cNvPr id="4" name="3 Imagen"/>
          <p:cNvPicPr/>
          <p:nvPr/>
        </p:nvPicPr>
        <p:blipFill rotWithShape="1">
          <a:blip r:embed="rId4">
            <a:extLst>
              <a:ext uri="{28A0092B-C50C-407E-A947-70E740481C1C}">
                <a14:useLocalDpi xmlns:a14="http://schemas.microsoft.com/office/drawing/2010/main" val="0"/>
              </a:ext>
            </a:extLst>
          </a:blip>
          <a:srcRect l="-1" t="11667" r="10785"/>
          <a:stretch/>
        </p:blipFill>
        <p:spPr bwMode="auto">
          <a:xfrm>
            <a:off x="251520" y="3789040"/>
            <a:ext cx="7992888" cy="2664296"/>
          </a:xfrm>
          <a:prstGeom prst="rect">
            <a:avLst/>
          </a:prstGeom>
          <a:noFill/>
          <a:ln>
            <a:noFill/>
          </a:ln>
          <a:extLst>
            <a:ext uri="{53640926-AAD7-44D8-BBD7-CCE9431645EC}">
              <a14:shadowObscured xmlns:a14="http://schemas.microsoft.com/office/drawing/2010/main"/>
            </a:ext>
          </a:extLst>
        </p:spPr>
      </p:pic>
      <p:sp>
        <p:nvSpPr>
          <p:cNvPr id="6" name="5 CuadroTexto"/>
          <p:cNvSpPr txBox="1"/>
          <p:nvPr/>
        </p:nvSpPr>
        <p:spPr>
          <a:xfrm>
            <a:off x="251520" y="260650"/>
            <a:ext cx="8640960" cy="461665"/>
          </a:xfrm>
          <a:prstGeom prst="rect">
            <a:avLst/>
          </a:prstGeom>
          <a:noFill/>
        </p:spPr>
        <p:txBody>
          <a:bodyPr wrap="square" rtlCol="0">
            <a:spAutoFit/>
          </a:bodyPr>
          <a:lstStyle/>
          <a:p>
            <a:pPr algn="just"/>
            <a:r>
              <a:rPr lang="es-CL" sz="1200" b="1" dirty="0">
                <a:latin typeface="Times New Roman" pitchFamily="18" charset="0"/>
                <a:cs typeface="Times New Roman" pitchFamily="18" charset="0"/>
              </a:rPr>
              <a:t>Supporting information Figure S4 E. </a:t>
            </a:r>
            <a:r>
              <a:rPr lang="es-CL" sz="1200" dirty="0">
                <a:latin typeface="Times New Roman" pitchFamily="18" charset="0"/>
                <a:cs typeface="Times New Roman" pitchFamily="18" charset="0"/>
              </a:rPr>
              <a:t>Chromatographic and spectrometric analyses of Subfraction FIII-2 (retention time: 11.71 min) from methanolic extracts of </a:t>
            </a:r>
            <a:r>
              <a:rPr lang="en-US" sz="1200" i="1" dirty="0">
                <a:latin typeface="Times New Roman" pitchFamily="18" charset="0"/>
                <a:cs typeface="Times New Roman" pitchFamily="18" charset="0"/>
              </a:rPr>
              <a:t>Haloterrigena</a:t>
            </a:r>
            <a:r>
              <a:rPr lang="en-US" sz="1200" dirty="0">
                <a:latin typeface="Times New Roman" pitchFamily="18" charset="0"/>
                <a:cs typeface="Times New Roman" pitchFamily="18" charset="0"/>
              </a:rPr>
              <a:t> sp. strain SGH1. </a:t>
            </a:r>
          </a:p>
        </p:txBody>
      </p:sp>
    </p:spTree>
    <p:extLst>
      <p:ext uri="{BB962C8B-B14F-4D97-AF65-F5344CB8AC3E}">
        <p14:creationId xmlns:p14="http://schemas.microsoft.com/office/powerpoint/2010/main" val="247971079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1 Imagen"/>
          <p:cNvPicPr/>
          <p:nvPr/>
        </p:nvPicPr>
        <p:blipFill rotWithShape="1">
          <a:blip r:embed="rId2">
            <a:extLst>
              <a:ext uri="{28A0092B-C50C-407E-A947-70E740481C1C}">
                <a14:useLocalDpi xmlns:a14="http://schemas.microsoft.com/office/drawing/2010/main" val="0"/>
              </a:ext>
            </a:extLst>
          </a:blip>
          <a:srcRect r="9307"/>
          <a:stretch/>
        </p:blipFill>
        <p:spPr bwMode="auto">
          <a:xfrm>
            <a:off x="333324" y="1052736"/>
            <a:ext cx="6787753" cy="2692896"/>
          </a:xfrm>
          <a:prstGeom prst="rect">
            <a:avLst/>
          </a:prstGeom>
          <a:noFill/>
          <a:ln>
            <a:noFill/>
          </a:ln>
          <a:extLst>
            <a:ext uri="{53640926-AAD7-44D8-BBD7-CCE9431645EC}">
              <a14:shadowObscured xmlns:a14="http://schemas.microsoft.com/office/drawing/2010/main"/>
            </a:ext>
          </a:extLst>
        </p:spPr>
      </p:pic>
      <p:pic>
        <p:nvPicPr>
          <p:cNvPr id="5" name="4 Imagen"/>
          <p:cNvPicPr/>
          <p:nvPr/>
        </p:nvPicPr>
        <p:blipFill rotWithShape="1">
          <a:blip r:embed="rId3" cstate="print">
            <a:extLst>
              <a:ext uri="{28A0092B-C50C-407E-A947-70E740481C1C}">
                <a14:useLocalDpi xmlns:a14="http://schemas.microsoft.com/office/drawing/2010/main" val="0"/>
              </a:ext>
            </a:extLst>
          </a:blip>
          <a:srcRect t="18905"/>
          <a:stretch/>
        </p:blipFill>
        <p:spPr bwMode="auto">
          <a:xfrm>
            <a:off x="5652120" y="1196752"/>
            <a:ext cx="3240360" cy="2016224"/>
          </a:xfrm>
          <a:prstGeom prst="rect">
            <a:avLst/>
          </a:prstGeom>
          <a:noFill/>
          <a:ln>
            <a:noFill/>
          </a:ln>
          <a:extLst>
            <a:ext uri="{53640926-AAD7-44D8-BBD7-CCE9431645EC}">
              <a14:shadowObscured xmlns:a14="http://schemas.microsoft.com/office/drawing/2010/main"/>
            </a:ext>
          </a:extLst>
        </p:spPr>
      </p:pic>
      <p:pic>
        <p:nvPicPr>
          <p:cNvPr id="6" name="5 Imagen"/>
          <p:cNvPicPr/>
          <p:nvPr/>
        </p:nvPicPr>
        <p:blipFill rotWithShape="1">
          <a:blip r:embed="rId4">
            <a:extLst>
              <a:ext uri="{28A0092B-C50C-407E-A947-70E740481C1C}">
                <a14:useLocalDpi xmlns:a14="http://schemas.microsoft.com/office/drawing/2010/main" val="0"/>
              </a:ext>
            </a:extLst>
          </a:blip>
          <a:srcRect t="6058" r="6395" b="-1"/>
          <a:stretch/>
        </p:blipFill>
        <p:spPr bwMode="auto">
          <a:xfrm>
            <a:off x="427282" y="3933056"/>
            <a:ext cx="7961143" cy="2470150"/>
          </a:xfrm>
          <a:prstGeom prst="rect">
            <a:avLst/>
          </a:prstGeom>
          <a:noFill/>
          <a:ln>
            <a:noFill/>
          </a:ln>
          <a:extLst>
            <a:ext uri="{53640926-AAD7-44D8-BBD7-CCE9431645EC}">
              <a14:shadowObscured xmlns:a14="http://schemas.microsoft.com/office/drawing/2010/main"/>
            </a:ext>
          </a:extLst>
        </p:spPr>
      </p:pic>
      <p:sp>
        <p:nvSpPr>
          <p:cNvPr id="9" name="8 CuadroTexto"/>
          <p:cNvSpPr txBox="1"/>
          <p:nvPr/>
        </p:nvSpPr>
        <p:spPr>
          <a:xfrm>
            <a:off x="251520" y="260650"/>
            <a:ext cx="8640960" cy="461665"/>
          </a:xfrm>
          <a:prstGeom prst="rect">
            <a:avLst/>
          </a:prstGeom>
          <a:noFill/>
        </p:spPr>
        <p:txBody>
          <a:bodyPr wrap="square" rtlCol="0">
            <a:spAutoFit/>
          </a:bodyPr>
          <a:lstStyle/>
          <a:p>
            <a:pPr algn="just"/>
            <a:r>
              <a:rPr lang="es-CL" sz="1200" b="1" dirty="0">
                <a:latin typeface="Times New Roman" pitchFamily="18" charset="0"/>
                <a:cs typeface="Times New Roman" pitchFamily="18" charset="0"/>
              </a:rPr>
              <a:t>Supporting information Figure S4 F. </a:t>
            </a:r>
            <a:r>
              <a:rPr lang="es-CL" sz="1200" dirty="0">
                <a:latin typeface="Times New Roman" pitchFamily="18" charset="0"/>
                <a:cs typeface="Times New Roman" pitchFamily="18" charset="0"/>
              </a:rPr>
              <a:t>Chromatographic and spectrometric analyses of Subfraction FIV-1 (retention time: 10.40 min) from methanolic extracts of </a:t>
            </a:r>
            <a:r>
              <a:rPr lang="en-US" sz="1200" i="1" dirty="0">
                <a:latin typeface="Times New Roman" pitchFamily="18" charset="0"/>
                <a:cs typeface="Times New Roman" pitchFamily="18" charset="0"/>
              </a:rPr>
              <a:t>Haloterrigena</a:t>
            </a:r>
            <a:r>
              <a:rPr lang="en-US" sz="1200" dirty="0">
                <a:latin typeface="Times New Roman" pitchFamily="18" charset="0"/>
                <a:cs typeface="Times New Roman" pitchFamily="18" charset="0"/>
              </a:rPr>
              <a:t> sp. strain SGH1. </a:t>
            </a:r>
          </a:p>
        </p:txBody>
      </p:sp>
    </p:spTree>
    <p:extLst>
      <p:ext uri="{BB962C8B-B14F-4D97-AF65-F5344CB8AC3E}">
        <p14:creationId xmlns:p14="http://schemas.microsoft.com/office/powerpoint/2010/main" val="281781581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1 Imagen"/>
          <p:cNvPicPr/>
          <p:nvPr/>
        </p:nvPicPr>
        <p:blipFill rotWithShape="1">
          <a:blip r:embed="rId2">
            <a:extLst>
              <a:ext uri="{28A0092B-C50C-407E-A947-70E740481C1C}">
                <a14:useLocalDpi xmlns:a14="http://schemas.microsoft.com/office/drawing/2010/main" val="0"/>
              </a:ext>
            </a:extLst>
          </a:blip>
          <a:srcRect r="9307"/>
          <a:stretch/>
        </p:blipFill>
        <p:spPr bwMode="auto">
          <a:xfrm>
            <a:off x="323528" y="980728"/>
            <a:ext cx="7529746" cy="2548880"/>
          </a:xfrm>
          <a:prstGeom prst="rect">
            <a:avLst/>
          </a:prstGeom>
          <a:noFill/>
          <a:ln>
            <a:noFill/>
          </a:ln>
          <a:extLst>
            <a:ext uri="{53640926-AAD7-44D8-BBD7-CCE9431645EC}">
              <a14:shadowObscured xmlns:a14="http://schemas.microsoft.com/office/drawing/2010/main"/>
            </a:ext>
          </a:extLst>
        </p:spPr>
      </p:pic>
      <p:pic>
        <p:nvPicPr>
          <p:cNvPr id="4" name="3 Imagen"/>
          <p:cNvPicPr/>
          <p:nvPr/>
        </p:nvPicPr>
        <p:blipFill rotWithShape="1">
          <a:blip r:embed="rId3" cstate="print">
            <a:extLst>
              <a:ext uri="{28A0092B-C50C-407E-A947-70E740481C1C}">
                <a14:useLocalDpi xmlns:a14="http://schemas.microsoft.com/office/drawing/2010/main" val="0"/>
              </a:ext>
            </a:extLst>
          </a:blip>
          <a:srcRect t="21661" r="3146"/>
          <a:stretch/>
        </p:blipFill>
        <p:spPr bwMode="auto">
          <a:xfrm>
            <a:off x="5580112" y="1052736"/>
            <a:ext cx="3312368" cy="2016224"/>
          </a:xfrm>
          <a:prstGeom prst="rect">
            <a:avLst/>
          </a:prstGeom>
          <a:noFill/>
          <a:ln>
            <a:noFill/>
          </a:ln>
          <a:extLst>
            <a:ext uri="{53640926-AAD7-44D8-BBD7-CCE9431645EC}">
              <a14:shadowObscured xmlns:a14="http://schemas.microsoft.com/office/drawing/2010/main"/>
            </a:ext>
          </a:extLst>
        </p:spPr>
      </p:pic>
      <p:pic>
        <p:nvPicPr>
          <p:cNvPr id="5" name="4 Imagen"/>
          <p:cNvPicPr/>
          <p:nvPr/>
        </p:nvPicPr>
        <p:blipFill rotWithShape="1">
          <a:blip r:embed="rId4">
            <a:extLst>
              <a:ext uri="{28A0092B-C50C-407E-A947-70E740481C1C}">
                <a14:useLocalDpi xmlns:a14="http://schemas.microsoft.com/office/drawing/2010/main" val="0"/>
              </a:ext>
            </a:extLst>
          </a:blip>
          <a:srcRect t="12511" r="11423"/>
          <a:stretch/>
        </p:blipFill>
        <p:spPr bwMode="auto">
          <a:xfrm>
            <a:off x="426630" y="3861050"/>
            <a:ext cx="8177818" cy="2583681"/>
          </a:xfrm>
          <a:prstGeom prst="rect">
            <a:avLst/>
          </a:prstGeom>
          <a:noFill/>
          <a:ln>
            <a:noFill/>
          </a:ln>
          <a:extLst>
            <a:ext uri="{53640926-AAD7-44D8-BBD7-CCE9431645EC}">
              <a14:shadowObscured xmlns:a14="http://schemas.microsoft.com/office/drawing/2010/main"/>
            </a:ext>
          </a:extLst>
        </p:spPr>
      </p:pic>
      <p:sp>
        <p:nvSpPr>
          <p:cNvPr id="6" name="5 CuadroTexto"/>
          <p:cNvSpPr txBox="1"/>
          <p:nvPr/>
        </p:nvSpPr>
        <p:spPr>
          <a:xfrm>
            <a:off x="251520" y="260650"/>
            <a:ext cx="8640960" cy="461665"/>
          </a:xfrm>
          <a:prstGeom prst="rect">
            <a:avLst/>
          </a:prstGeom>
          <a:noFill/>
        </p:spPr>
        <p:txBody>
          <a:bodyPr wrap="square" rtlCol="0">
            <a:spAutoFit/>
          </a:bodyPr>
          <a:lstStyle/>
          <a:p>
            <a:pPr algn="just"/>
            <a:r>
              <a:rPr lang="es-CL" sz="1200" b="1" dirty="0">
                <a:latin typeface="Times New Roman" pitchFamily="18" charset="0"/>
                <a:cs typeface="Times New Roman" pitchFamily="18" charset="0"/>
              </a:rPr>
              <a:t>Supporting information Figure S4 G. </a:t>
            </a:r>
            <a:r>
              <a:rPr lang="es-CL" sz="1200" dirty="0">
                <a:latin typeface="Times New Roman" pitchFamily="18" charset="0"/>
                <a:cs typeface="Times New Roman" pitchFamily="18" charset="0"/>
              </a:rPr>
              <a:t>Chromatographic and spectrometric analyses of Subfraction FIV-2 (retention time: 12.12 min) from methanolic extracts of </a:t>
            </a:r>
            <a:r>
              <a:rPr lang="en-US" sz="1200" i="1" dirty="0">
                <a:latin typeface="Times New Roman" pitchFamily="18" charset="0"/>
                <a:cs typeface="Times New Roman" pitchFamily="18" charset="0"/>
              </a:rPr>
              <a:t>Haloterrigena</a:t>
            </a:r>
            <a:r>
              <a:rPr lang="en-US" sz="1200" dirty="0">
                <a:latin typeface="Times New Roman" pitchFamily="18" charset="0"/>
                <a:cs typeface="Times New Roman" pitchFamily="18" charset="0"/>
              </a:rPr>
              <a:t> sp. strain SGH1. </a:t>
            </a:r>
          </a:p>
        </p:txBody>
      </p:sp>
    </p:spTree>
    <p:extLst>
      <p:ext uri="{BB962C8B-B14F-4D97-AF65-F5344CB8AC3E}">
        <p14:creationId xmlns:p14="http://schemas.microsoft.com/office/powerpoint/2010/main" val="68734998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1 Imagen"/>
          <p:cNvPicPr/>
          <p:nvPr/>
        </p:nvPicPr>
        <p:blipFill rotWithShape="1">
          <a:blip r:embed="rId2">
            <a:extLst>
              <a:ext uri="{28A0092B-C50C-407E-A947-70E740481C1C}">
                <a14:useLocalDpi xmlns:a14="http://schemas.microsoft.com/office/drawing/2010/main" val="0"/>
              </a:ext>
            </a:extLst>
          </a:blip>
          <a:srcRect r="7526"/>
          <a:stretch/>
        </p:blipFill>
        <p:spPr bwMode="auto">
          <a:xfrm>
            <a:off x="395538" y="890907"/>
            <a:ext cx="6057265" cy="2538095"/>
          </a:xfrm>
          <a:prstGeom prst="rect">
            <a:avLst/>
          </a:prstGeom>
          <a:noFill/>
          <a:ln>
            <a:noFill/>
          </a:ln>
          <a:extLst>
            <a:ext uri="{53640926-AAD7-44D8-BBD7-CCE9431645EC}">
              <a14:shadowObscured xmlns:a14="http://schemas.microsoft.com/office/drawing/2010/main"/>
            </a:ext>
          </a:extLst>
        </p:spPr>
      </p:pic>
      <p:pic>
        <p:nvPicPr>
          <p:cNvPr id="3" name="2 Imagen"/>
          <p:cNvPicPr/>
          <p:nvPr/>
        </p:nvPicPr>
        <p:blipFill rotWithShape="1">
          <a:blip r:embed="rId3" cstate="print">
            <a:extLst>
              <a:ext uri="{28A0092B-C50C-407E-A947-70E740481C1C}">
                <a14:useLocalDpi xmlns:a14="http://schemas.microsoft.com/office/drawing/2010/main" val="0"/>
              </a:ext>
            </a:extLst>
          </a:blip>
          <a:srcRect t="11981" r="1687"/>
          <a:stretch/>
        </p:blipFill>
        <p:spPr bwMode="auto">
          <a:xfrm>
            <a:off x="5364088" y="864549"/>
            <a:ext cx="3384376" cy="2272744"/>
          </a:xfrm>
          <a:prstGeom prst="rect">
            <a:avLst/>
          </a:prstGeom>
          <a:noFill/>
          <a:ln>
            <a:noFill/>
          </a:ln>
          <a:extLst>
            <a:ext uri="{53640926-AAD7-44D8-BBD7-CCE9431645EC}">
              <a14:shadowObscured xmlns:a14="http://schemas.microsoft.com/office/drawing/2010/main"/>
            </a:ext>
          </a:extLst>
        </p:spPr>
      </p:pic>
      <p:pic>
        <p:nvPicPr>
          <p:cNvPr id="4" name="3 Imagen"/>
          <p:cNvPicPr/>
          <p:nvPr/>
        </p:nvPicPr>
        <p:blipFill rotWithShape="1">
          <a:blip r:embed="rId4">
            <a:extLst>
              <a:ext uri="{28A0092B-C50C-407E-A947-70E740481C1C}">
                <a14:useLocalDpi xmlns:a14="http://schemas.microsoft.com/office/drawing/2010/main" val="0"/>
              </a:ext>
            </a:extLst>
          </a:blip>
          <a:srcRect t="6327" r="14279"/>
          <a:stretch/>
        </p:blipFill>
        <p:spPr bwMode="auto">
          <a:xfrm>
            <a:off x="381004" y="3477599"/>
            <a:ext cx="7935412" cy="3119755"/>
          </a:xfrm>
          <a:prstGeom prst="rect">
            <a:avLst/>
          </a:prstGeom>
          <a:noFill/>
          <a:ln>
            <a:noFill/>
          </a:ln>
          <a:extLst>
            <a:ext uri="{53640926-AAD7-44D8-BBD7-CCE9431645EC}">
              <a14:shadowObscured xmlns:a14="http://schemas.microsoft.com/office/drawing/2010/main"/>
            </a:ext>
          </a:extLst>
        </p:spPr>
      </p:pic>
      <p:sp>
        <p:nvSpPr>
          <p:cNvPr id="7" name="6 CuadroTexto"/>
          <p:cNvSpPr txBox="1"/>
          <p:nvPr/>
        </p:nvSpPr>
        <p:spPr>
          <a:xfrm>
            <a:off x="251520" y="260650"/>
            <a:ext cx="8640960" cy="461665"/>
          </a:xfrm>
          <a:prstGeom prst="rect">
            <a:avLst/>
          </a:prstGeom>
          <a:noFill/>
        </p:spPr>
        <p:txBody>
          <a:bodyPr wrap="square" rtlCol="0">
            <a:spAutoFit/>
          </a:bodyPr>
          <a:lstStyle/>
          <a:p>
            <a:pPr algn="just"/>
            <a:r>
              <a:rPr lang="es-CL" sz="1200" b="1" dirty="0">
                <a:latin typeface="Times New Roman" pitchFamily="18" charset="0"/>
                <a:cs typeface="Times New Roman" pitchFamily="18" charset="0"/>
              </a:rPr>
              <a:t>Supporting information Figure S4 H. </a:t>
            </a:r>
            <a:r>
              <a:rPr lang="es-CL" sz="1200" dirty="0">
                <a:latin typeface="Times New Roman" pitchFamily="18" charset="0"/>
                <a:cs typeface="Times New Roman" pitchFamily="18" charset="0"/>
              </a:rPr>
              <a:t>Chromatographic and spectrometric analyses of Subfraction FV-1 (retention time: 12.44 min) from methanolic extracts of </a:t>
            </a:r>
            <a:r>
              <a:rPr lang="en-US" sz="1200" i="1" dirty="0">
                <a:latin typeface="Times New Roman" pitchFamily="18" charset="0"/>
                <a:cs typeface="Times New Roman" pitchFamily="18" charset="0"/>
              </a:rPr>
              <a:t>Haloterrigena</a:t>
            </a:r>
            <a:r>
              <a:rPr lang="en-US" sz="1200" dirty="0">
                <a:latin typeface="Times New Roman" pitchFamily="18" charset="0"/>
                <a:cs typeface="Times New Roman" pitchFamily="18" charset="0"/>
              </a:rPr>
              <a:t> sp. strain SGH1. </a:t>
            </a:r>
          </a:p>
        </p:txBody>
      </p:sp>
    </p:spTree>
    <p:extLst>
      <p:ext uri="{BB962C8B-B14F-4D97-AF65-F5344CB8AC3E}">
        <p14:creationId xmlns:p14="http://schemas.microsoft.com/office/powerpoint/2010/main" val="12030351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n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934325" y="1001089"/>
            <a:ext cx="6037289" cy="4853507"/>
          </a:xfrm>
          <a:prstGeom prst="rect">
            <a:avLst/>
          </a:prstGeom>
        </p:spPr>
      </p:pic>
      <p:sp>
        <p:nvSpPr>
          <p:cNvPr id="5" name="CuadroTexto 4"/>
          <p:cNvSpPr txBox="1"/>
          <p:nvPr/>
        </p:nvSpPr>
        <p:spPr>
          <a:xfrm>
            <a:off x="101184" y="332656"/>
            <a:ext cx="2608289" cy="6370975"/>
          </a:xfrm>
          <a:prstGeom prst="rect">
            <a:avLst/>
          </a:prstGeom>
          <a:noFill/>
        </p:spPr>
        <p:txBody>
          <a:bodyPr wrap="square" rtlCol="0">
            <a:spAutoFit/>
          </a:bodyPr>
          <a:lstStyle/>
          <a:p>
            <a:pPr algn="just"/>
            <a:r>
              <a:rPr lang="en-US" sz="1200" b="1" dirty="0">
                <a:latin typeface="Times New Roman" charset="0"/>
                <a:ea typeface="Times New Roman" charset="0"/>
                <a:cs typeface="Times New Roman" charset="0"/>
              </a:rPr>
              <a:t>Supplementary Figure S5. </a:t>
            </a:r>
            <a:r>
              <a:rPr lang="en-US" sz="1200" dirty="0">
                <a:latin typeface="Times New Roman" charset="0"/>
                <a:ea typeface="Times New Roman" charset="0"/>
                <a:cs typeface="Times New Roman" charset="0"/>
              </a:rPr>
              <a:t>Cellular toxicity against THP-1 cells of carotenoids from isolate </a:t>
            </a:r>
            <a:r>
              <a:rPr lang="en-US" sz="1200" i="1" dirty="0">
                <a:latin typeface="Times New Roman" charset="0"/>
                <a:ea typeface="Times New Roman" charset="0"/>
                <a:cs typeface="Times New Roman" charset="0"/>
              </a:rPr>
              <a:t>Haloterrigena </a:t>
            </a:r>
            <a:r>
              <a:rPr lang="en-US" sz="1200" dirty="0">
                <a:latin typeface="Times New Roman" charset="0"/>
                <a:ea typeface="Times New Roman" charset="0"/>
                <a:cs typeface="Times New Roman" charset="0"/>
              </a:rPr>
              <a:t>sp. strain SGH1. The methanolic extract (SGH1 Extract) and purified Fractions I, II, III, IV and V (500 </a:t>
            </a:r>
            <a:r>
              <a:rPr lang="en-US" sz="1200" dirty="0">
                <a:latin typeface="Symbol" panose="05050102010706020507" pitchFamily="18" charset="2"/>
                <a:ea typeface="Times New Roman" charset="0"/>
                <a:cs typeface="Times New Roman" charset="0"/>
              </a:rPr>
              <a:t></a:t>
            </a:r>
            <a:r>
              <a:rPr lang="en-US" sz="1200" dirty="0">
                <a:latin typeface="Times New Roman" charset="0"/>
                <a:ea typeface="Times New Roman" charset="0"/>
                <a:cs typeface="Times New Roman" charset="0"/>
              </a:rPr>
              <a:t>g/mL of each as final concentrations in the assays), were incubated with THP-1 cells for 18 hours. After that, cells were incubated with MitoStatus Red (MTRed) by 15 min and cells with different intensities of fluorescence were quantified by flow cytometry. Methanol (MeOH) was used as negative control and 50 </a:t>
            </a:r>
            <a:r>
              <a:rPr lang="en-US" sz="1200" dirty="0">
                <a:latin typeface="Symbol" panose="05050102010706020507" pitchFamily="18" charset="2"/>
                <a:ea typeface="Times New Roman" charset="0"/>
                <a:cs typeface="Times New Roman" charset="0"/>
              </a:rPr>
              <a:t>M </a:t>
            </a:r>
            <a:r>
              <a:rPr lang="en-US" sz="1200" dirty="0">
                <a:latin typeface="Times New Roman" charset="0"/>
                <a:ea typeface="Times New Roman" charset="0"/>
                <a:cs typeface="Times New Roman" charset="0"/>
              </a:rPr>
              <a:t>Antimycin A, diluted in Ethanol (EtOH), was used as positive control. SSC vs FSC dot plot of unstained THP-1 cells was used to select the analyzed population. This unstained cells did not emit any florescence at 660 nm (Histogram plot). After incubation with MTRed, cells emitted fluorescence at 660 nm and we could identify three well defined populations, which had three different intensities. The MTRed intensity of </a:t>
            </a:r>
            <a:r>
              <a:rPr lang="en-US" sz="1200">
                <a:latin typeface="Times New Roman" charset="0"/>
                <a:ea typeface="Times New Roman" charset="0"/>
                <a:cs typeface="Times New Roman" charset="0"/>
              </a:rPr>
              <a:t>fluorescence was </a:t>
            </a:r>
            <a:r>
              <a:rPr lang="en-US" sz="1200" dirty="0">
                <a:latin typeface="Times New Roman" charset="0"/>
                <a:ea typeface="Times New Roman" charset="0"/>
                <a:cs typeface="Times New Roman" charset="0"/>
              </a:rPr>
              <a:t>directly correlated with the level of mitochondrial membrane potential in cells, in consequence we could detect population with Low, Middle and High mitochondrial membrane potential. Dot plot and histograms are representatives of one experiment.</a:t>
            </a:r>
          </a:p>
        </p:txBody>
      </p:sp>
    </p:spTree>
    <p:extLst>
      <p:ext uri="{BB962C8B-B14F-4D97-AF65-F5344CB8AC3E}">
        <p14:creationId xmlns:p14="http://schemas.microsoft.com/office/powerpoint/2010/main" val="171894333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3 Imagen" descr="E:\ARQUEAS\Imagenes\albina1y coloreadas.jpg"/>
          <p:cNvPicPr/>
          <p:nvPr/>
        </p:nvPicPr>
        <p:blipFill rotWithShape="1">
          <a:blip r:embed="rId2" cstate="print">
            <a:extLst>
              <a:ext uri="{28A0092B-C50C-407E-A947-70E740481C1C}">
                <a14:useLocalDpi xmlns:a14="http://schemas.microsoft.com/office/drawing/2010/main" val="0"/>
              </a:ext>
            </a:extLst>
          </a:blip>
          <a:srcRect l="11183" t="6484" r="16370" b="10371"/>
          <a:stretch/>
        </p:blipFill>
        <p:spPr bwMode="auto">
          <a:xfrm flipH="1">
            <a:off x="1547666" y="1916832"/>
            <a:ext cx="6048671" cy="4392488"/>
          </a:xfrm>
          <a:prstGeom prst="rect">
            <a:avLst/>
          </a:prstGeom>
          <a:noFill/>
          <a:ln>
            <a:noFill/>
          </a:ln>
          <a:scene3d>
            <a:camera prst="orthographicFront">
              <a:rot lat="21299999" lon="21299997" rev="0"/>
            </a:camera>
            <a:lightRig rig="threePt" dir="t"/>
          </a:scene3d>
          <a:extLst>
            <a:ext uri="{53640926-AAD7-44D8-BBD7-CCE9431645EC}">
              <a14:shadowObscured xmlns:a14="http://schemas.microsoft.com/office/drawing/2010/main"/>
            </a:ext>
          </a:extLst>
        </p:spPr>
      </p:pic>
      <p:sp>
        <p:nvSpPr>
          <p:cNvPr id="8" name="7 CuadroTexto"/>
          <p:cNvSpPr txBox="1"/>
          <p:nvPr/>
        </p:nvSpPr>
        <p:spPr>
          <a:xfrm>
            <a:off x="2987824" y="3645024"/>
            <a:ext cx="504056" cy="369332"/>
          </a:xfrm>
          <a:prstGeom prst="rect">
            <a:avLst/>
          </a:prstGeom>
          <a:noFill/>
        </p:spPr>
        <p:txBody>
          <a:bodyPr wrap="square" rtlCol="0">
            <a:spAutoFit/>
          </a:bodyPr>
          <a:lstStyle/>
          <a:p>
            <a:pPr algn="ctr"/>
            <a:r>
              <a:rPr lang="es-CL" b="1" dirty="0">
                <a:latin typeface="Times New Roman" pitchFamily="18" charset="0"/>
                <a:cs typeface="Times New Roman" pitchFamily="18" charset="0"/>
              </a:rPr>
              <a:t>A</a:t>
            </a:r>
          </a:p>
        </p:txBody>
      </p:sp>
      <p:sp>
        <p:nvSpPr>
          <p:cNvPr id="9" name="8 CuadroTexto"/>
          <p:cNvSpPr txBox="1"/>
          <p:nvPr/>
        </p:nvSpPr>
        <p:spPr>
          <a:xfrm>
            <a:off x="6444208" y="3579677"/>
            <a:ext cx="504056" cy="369332"/>
          </a:xfrm>
          <a:prstGeom prst="rect">
            <a:avLst/>
          </a:prstGeom>
          <a:noFill/>
        </p:spPr>
        <p:txBody>
          <a:bodyPr wrap="square" rtlCol="0">
            <a:spAutoFit/>
          </a:bodyPr>
          <a:lstStyle/>
          <a:p>
            <a:pPr algn="ctr"/>
            <a:r>
              <a:rPr lang="es-CL" b="1" dirty="0">
                <a:latin typeface="Times New Roman" pitchFamily="18" charset="0"/>
                <a:cs typeface="Times New Roman" pitchFamily="18" charset="0"/>
              </a:rPr>
              <a:t>B</a:t>
            </a:r>
          </a:p>
        </p:txBody>
      </p:sp>
      <p:sp>
        <p:nvSpPr>
          <p:cNvPr id="5" name="4 CuadroTexto"/>
          <p:cNvSpPr txBox="1"/>
          <p:nvPr/>
        </p:nvSpPr>
        <p:spPr>
          <a:xfrm>
            <a:off x="251520" y="188642"/>
            <a:ext cx="8640960" cy="830997"/>
          </a:xfrm>
          <a:prstGeom prst="rect">
            <a:avLst/>
          </a:prstGeom>
          <a:noFill/>
        </p:spPr>
        <p:txBody>
          <a:bodyPr wrap="square" rtlCol="0">
            <a:spAutoFit/>
          </a:bodyPr>
          <a:lstStyle/>
          <a:p>
            <a:pPr algn="just"/>
            <a:r>
              <a:rPr lang="es-CL" sz="1200" b="1" dirty="0">
                <a:latin typeface="Times New Roman" pitchFamily="18" charset="0"/>
                <a:cs typeface="Times New Roman" pitchFamily="18" charset="0"/>
              </a:rPr>
              <a:t>Supporting information Figure S1. </a:t>
            </a:r>
          </a:p>
          <a:p>
            <a:pPr algn="just"/>
            <a:endParaRPr lang="es-CL" sz="1200" b="1" dirty="0">
              <a:latin typeface="Times New Roman" pitchFamily="18" charset="0"/>
              <a:cs typeface="Times New Roman" pitchFamily="18" charset="0"/>
            </a:endParaRPr>
          </a:p>
          <a:p>
            <a:pPr algn="just"/>
            <a:r>
              <a:rPr lang="es-CL" sz="1200" dirty="0">
                <a:latin typeface="Times New Roman" pitchFamily="18" charset="0"/>
                <a:cs typeface="Times New Roman" pitchFamily="18" charset="0"/>
              </a:rPr>
              <a:t>Effect of salinity on carotenoid content in </a:t>
            </a:r>
            <a:r>
              <a:rPr lang="es-CL" sz="1200" i="1" dirty="0">
                <a:latin typeface="Times New Roman" pitchFamily="18" charset="0"/>
                <a:cs typeface="Times New Roman" pitchFamily="18" charset="0"/>
              </a:rPr>
              <a:t>Haloterrigena</a:t>
            </a:r>
            <a:r>
              <a:rPr lang="es-CL" sz="1200" dirty="0">
                <a:latin typeface="Times New Roman" pitchFamily="18" charset="0"/>
                <a:cs typeface="Times New Roman" pitchFamily="18" charset="0"/>
              </a:rPr>
              <a:t> sp. strain SGH1. Cells were grown during 96 h at 35°C under </a:t>
            </a:r>
            <a:r>
              <a:rPr lang="es-CL" sz="1200" dirty="0" err="1">
                <a:latin typeface="Times New Roman" pitchFamily="18" charset="0"/>
                <a:cs typeface="Times New Roman" pitchFamily="18" charset="0"/>
              </a:rPr>
              <a:t>continuous</a:t>
            </a:r>
            <a:r>
              <a:rPr lang="es-CL" sz="1200" dirty="0">
                <a:latin typeface="Times New Roman" pitchFamily="18" charset="0"/>
                <a:cs typeface="Times New Roman" pitchFamily="18" charset="0"/>
              </a:rPr>
              <a:t> </a:t>
            </a:r>
            <a:r>
              <a:rPr lang="es-CL" sz="1200" dirty="0" err="1">
                <a:latin typeface="Times New Roman" pitchFamily="18" charset="0"/>
                <a:cs typeface="Times New Roman" pitchFamily="18" charset="0"/>
              </a:rPr>
              <a:t>white</a:t>
            </a:r>
            <a:r>
              <a:rPr lang="es-CL" sz="1200" dirty="0">
                <a:latin typeface="Times New Roman" pitchFamily="18" charset="0"/>
                <a:cs typeface="Times New Roman" pitchFamily="18" charset="0"/>
              </a:rPr>
              <a:t> light (150 W m</a:t>
            </a:r>
            <a:r>
              <a:rPr lang="es-CL" sz="1200" baseline="30000" dirty="0">
                <a:latin typeface="Times New Roman" pitchFamily="18" charset="0"/>
                <a:cs typeface="Times New Roman" pitchFamily="18" charset="0"/>
              </a:rPr>
              <a:t>-2</a:t>
            </a:r>
            <a:r>
              <a:rPr lang="es-CL" sz="1200" dirty="0">
                <a:latin typeface="Times New Roman" pitchFamily="18" charset="0"/>
                <a:cs typeface="Times New Roman" pitchFamily="18" charset="0"/>
              </a:rPr>
              <a:t> ) and </a:t>
            </a:r>
            <a:r>
              <a:rPr lang="es-CL" sz="1200" dirty="0" err="1">
                <a:latin typeface="Times New Roman" pitchFamily="18" charset="0"/>
                <a:cs typeface="Times New Roman" pitchFamily="18" charset="0"/>
              </a:rPr>
              <a:t>constant</a:t>
            </a:r>
            <a:r>
              <a:rPr lang="es-CL" sz="1200" dirty="0">
                <a:latin typeface="Times New Roman" pitchFamily="18" charset="0"/>
                <a:cs typeface="Times New Roman" pitchFamily="18" charset="0"/>
              </a:rPr>
              <a:t> </a:t>
            </a:r>
            <a:r>
              <a:rPr lang="es-CL" sz="1200" dirty="0" err="1">
                <a:latin typeface="Times New Roman" pitchFamily="18" charset="0"/>
                <a:cs typeface="Times New Roman" pitchFamily="18" charset="0"/>
              </a:rPr>
              <a:t>rotation</a:t>
            </a:r>
            <a:r>
              <a:rPr lang="es-CL" sz="1200" dirty="0">
                <a:latin typeface="Times New Roman" pitchFamily="18" charset="0"/>
                <a:cs typeface="Times New Roman" pitchFamily="18" charset="0"/>
              </a:rPr>
              <a:t> (120 rpm) in Z8-MOD medium </a:t>
            </a:r>
            <a:r>
              <a:rPr lang="es-CL" sz="1200" dirty="0" err="1">
                <a:latin typeface="Times New Roman" pitchFamily="18" charset="0"/>
                <a:cs typeface="Times New Roman" pitchFamily="18" charset="0"/>
              </a:rPr>
              <a:t>containing</a:t>
            </a:r>
            <a:r>
              <a:rPr lang="es-CL" sz="1200" dirty="0">
                <a:latin typeface="Times New Roman" pitchFamily="18" charset="0"/>
                <a:cs typeface="Times New Roman" pitchFamily="18" charset="0"/>
              </a:rPr>
              <a:t> 15% (w/v) NaCl (</a:t>
            </a:r>
            <a:r>
              <a:rPr lang="es-CL" sz="1200" b="1" dirty="0">
                <a:latin typeface="Times New Roman" pitchFamily="18" charset="0"/>
                <a:cs typeface="Times New Roman" pitchFamily="18" charset="0"/>
              </a:rPr>
              <a:t>A</a:t>
            </a:r>
            <a:r>
              <a:rPr lang="es-CL" sz="1200" dirty="0">
                <a:latin typeface="Times New Roman" pitchFamily="18" charset="0"/>
                <a:cs typeface="Times New Roman" pitchFamily="18" charset="0"/>
              </a:rPr>
              <a:t>) or  25% (w/v) NaCl (</a:t>
            </a:r>
            <a:r>
              <a:rPr lang="es-CL" sz="1200" b="1" dirty="0">
                <a:latin typeface="Times New Roman" pitchFamily="18" charset="0"/>
                <a:cs typeface="Times New Roman" pitchFamily="18" charset="0"/>
              </a:rPr>
              <a:t>B</a:t>
            </a:r>
            <a:r>
              <a:rPr lang="es-CL" sz="1200" dirty="0">
                <a:latin typeface="Times New Roman" pitchFamily="18" charset="0"/>
                <a:cs typeface="Times New Roman" pitchFamily="18" charset="0"/>
              </a:rPr>
              <a:t>). </a:t>
            </a:r>
          </a:p>
        </p:txBody>
      </p:sp>
    </p:spTree>
    <p:extLst>
      <p:ext uri="{BB962C8B-B14F-4D97-AF65-F5344CB8AC3E}">
        <p14:creationId xmlns:p14="http://schemas.microsoft.com/office/powerpoint/2010/main" val="11847178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3 Gráfico"/>
          <p:cNvGraphicFramePr/>
          <p:nvPr>
            <p:extLst>
              <p:ext uri="{D42A27DB-BD31-4B8C-83A1-F6EECF244321}">
                <p14:modId xmlns:p14="http://schemas.microsoft.com/office/powerpoint/2010/main" val="1682819164"/>
              </p:ext>
            </p:extLst>
          </p:nvPr>
        </p:nvGraphicFramePr>
        <p:xfrm>
          <a:off x="1043608" y="1700810"/>
          <a:ext cx="6840760" cy="4824537"/>
        </p:xfrm>
        <a:graphic>
          <a:graphicData uri="http://schemas.openxmlformats.org/drawingml/2006/chart">
            <c:chart xmlns:c="http://schemas.openxmlformats.org/drawingml/2006/chart" xmlns:r="http://schemas.openxmlformats.org/officeDocument/2006/relationships" r:id="rId2"/>
          </a:graphicData>
        </a:graphic>
      </p:graphicFrame>
      <p:sp>
        <p:nvSpPr>
          <p:cNvPr id="5" name="4 CuadroTexto"/>
          <p:cNvSpPr txBox="1"/>
          <p:nvPr/>
        </p:nvSpPr>
        <p:spPr>
          <a:xfrm>
            <a:off x="251520" y="332658"/>
            <a:ext cx="8640960" cy="1200329"/>
          </a:xfrm>
          <a:prstGeom prst="rect">
            <a:avLst/>
          </a:prstGeom>
          <a:noFill/>
        </p:spPr>
        <p:txBody>
          <a:bodyPr wrap="square" rtlCol="0">
            <a:spAutoFit/>
          </a:bodyPr>
          <a:lstStyle/>
          <a:p>
            <a:r>
              <a:rPr lang="es-CL" sz="1200" b="1" dirty="0">
                <a:latin typeface="Times New Roman" pitchFamily="18" charset="0"/>
                <a:cs typeface="Times New Roman" pitchFamily="18" charset="0"/>
              </a:rPr>
              <a:t>Supporting information Figure S2. </a:t>
            </a:r>
          </a:p>
          <a:p>
            <a:endParaRPr lang="es-CL" sz="1200" b="1" dirty="0">
              <a:latin typeface="Times New Roman" pitchFamily="18" charset="0"/>
              <a:cs typeface="Times New Roman" pitchFamily="18" charset="0"/>
            </a:endParaRPr>
          </a:p>
          <a:p>
            <a:r>
              <a:rPr lang="es-CL" sz="1200" dirty="0">
                <a:latin typeface="Times New Roman" pitchFamily="18" charset="0"/>
                <a:cs typeface="Times New Roman" pitchFamily="18" charset="0"/>
              </a:rPr>
              <a:t>Carotenoid content </a:t>
            </a:r>
            <a:r>
              <a:rPr lang="en-US" sz="1200" dirty="0">
                <a:latin typeface="Times New Roman" pitchFamily="18" charset="0"/>
                <a:cs typeface="Times New Roman" pitchFamily="18" charset="0"/>
              </a:rPr>
              <a:t>in </a:t>
            </a:r>
            <a:r>
              <a:rPr lang="en-US" sz="1200" i="1" dirty="0">
                <a:latin typeface="Times New Roman" pitchFamily="18" charset="0"/>
                <a:cs typeface="Times New Roman" pitchFamily="18" charset="0"/>
              </a:rPr>
              <a:t>Haloterrigena</a:t>
            </a:r>
            <a:r>
              <a:rPr lang="en-US" sz="1200" dirty="0">
                <a:latin typeface="Times New Roman" pitchFamily="18" charset="0"/>
                <a:cs typeface="Times New Roman" pitchFamily="18" charset="0"/>
              </a:rPr>
              <a:t> sp. strain SGH1 is reversibly modulated by salt concentration.</a:t>
            </a:r>
          </a:p>
          <a:p>
            <a:pPr algn="just"/>
            <a:r>
              <a:rPr lang="en-US" sz="1200" dirty="0">
                <a:latin typeface="Times New Roman" pitchFamily="18" charset="0"/>
                <a:cs typeface="Times New Roman" pitchFamily="18" charset="0"/>
              </a:rPr>
              <a:t>Non-pigmented SGH1 cells adapted to grow at 15% NaCl were inoculated and cultured in triplicate in fresh Z8-MOD medium at a final NaCl concentration of  15%, 25% or 30%, during 8 days at 35°C. Methanolic extracts were obtained every 48 h to measure total carotenoid content. Results are shown as mean ± standard deviation (n=6). </a:t>
            </a:r>
            <a:endParaRPr lang="es-CL" sz="1200" dirty="0">
              <a:latin typeface="Times New Roman" pitchFamily="18" charset="0"/>
              <a:cs typeface="Times New Roman" pitchFamily="18" charset="0"/>
            </a:endParaRPr>
          </a:p>
        </p:txBody>
      </p:sp>
    </p:spTree>
    <p:extLst>
      <p:ext uri="{BB962C8B-B14F-4D97-AF65-F5344CB8AC3E}">
        <p14:creationId xmlns:p14="http://schemas.microsoft.com/office/powerpoint/2010/main" val="321682707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3 Gráfico"/>
          <p:cNvGraphicFramePr/>
          <p:nvPr>
            <p:extLst>
              <p:ext uri="{D42A27DB-BD31-4B8C-83A1-F6EECF244321}">
                <p14:modId xmlns:p14="http://schemas.microsoft.com/office/powerpoint/2010/main" val="2600213635"/>
              </p:ext>
            </p:extLst>
          </p:nvPr>
        </p:nvGraphicFramePr>
        <p:xfrm>
          <a:off x="611560" y="1484784"/>
          <a:ext cx="7920880" cy="5112568"/>
        </p:xfrm>
        <a:graphic>
          <a:graphicData uri="http://schemas.openxmlformats.org/drawingml/2006/chart">
            <c:chart xmlns:c="http://schemas.openxmlformats.org/drawingml/2006/chart" xmlns:r="http://schemas.openxmlformats.org/officeDocument/2006/relationships" r:id="rId2"/>
          </a:graphicData>
        </a:graphic>
      </p:graphicFrame>
      <p:sp>
        <p:nvSpPr>
          <p:cNvPr id="3" name="2 CuadroTexto"/>
          <p:cNvSpPr txBox="1"/>
          <p:nvPr/>
        </p:nvSpPr>
        <p:spPr>
          <a:xfrm>
            <a:off x="251520" y="188642"/>
            <a:ext cx="8640960" cy="1015663"/>
          </a:xfrm>
          <a:prstGeom prst="rect">
            <a:avLst/>
          </a:prstGeom>
          <a:noFill/>
        </p:spPr>
        <p:txBody>
          <a:bodyPr wrap="square" rtlCol="0">
            <a:spAutoFit/>
          </a:bodyPr>
          <a:lstStyle/>
          <a:p>
            <a:r>
              <a:rPr lang="es-CL" sz="1200" b="1" dirty="0">
                <a:latin typeface="Times New Roman" pitchFamily="18" charset="0"/>
                <a:cs typeface="Times New Roman" pitchFamily="18" charset="0"/>
              </a:rPr>
              <a:t>Supporting information Figure S3. </a:t>
            </a:r>
          </a:p>
          <a:p>
            <a:endParaRPr lang="es-CL" sz="1200" b="1" dirty="0">
              <a:latin typeface="Times New Roman" pitchFamily="18" charset="0"/>
              <a:cs typeface="Times New Roman" pitchFamily="18" charset="0"/>
            </a:endParaRPr>
          </a:p>
          <a:p>
            <a:r>
              <a:rPr lang="es-CL" sz="1200" dirty="0">
                <a:latin typeface="Times New Roman" pitchFamily="18" charset="0"/>
                <a:cs typeface="Times New Roman" pitchFamily="18" charset="0"/>
              </a:rPr>
              <a:t>Carotenoid content </a:t>
            </a:r>
            <a:r>
              <a:rPr lang="en-US" sz="1200" dirty="0">
                <a:latin typeface="Times New Roman" pitchFamily="18" charset="0"/>
                <a:cs typeface="Times New Roman" pitchFamily="18" charset="0"/>
              </a:rPr>
              <a:t>in </a:t>
            </a:r>
            <a:r>
              <a:rPr lang="en-US" sz="1200" i="1" dirty="0">
                <a:latin typeface="Times New Roman" pitchFamily="18" charset="0"/>
                <a:cs typeface="Times New Roman" pitchFamily="18" charset="0"/>
              </a:rPr>
              <a:t>Haloterrigena</a:t>
            </a:r>
            <a:r>
              <a:rPr lang="en-US" sz="1200" dirty="0">
                <a:latin typeface="Times New Roman" pitchFamily="18" charset="0"/>
                <a:cs typeface="Times New Roman" pitchFamily="18" charset="0"/>
              </a:rPr>
              <a:t> sp. strain SGH1 is a reversible salt-dependent process.</a:t>
            </a:r>
          </a:p>
          <a:p>
            <a:pPr algn="just"/>
            <a:r>
              <a:rPr lang="en-US" sz="1200" dirty="0">
                <a:latin typeface="Times New Roman" pitchFamily="18" charset="0"/>
                <a:cs typeface="Times New Roman" pitchFamily="18" charset="0"/>
              </a:rPr>
              <a:t>Non-pigmented SGH1 cells adapted to grow at 15% NaCl were inoculated in fresh Z8-MOD medium at a final NaCl concentration of 25% (w/v) during 8 days at 35°C. Methanolic extracts were used to obtain the absorption spectrum every 48 h. </a:t>
            </a:r>
            <a:endParaRPr lang="es-CL" sz="1200" dirty="0">
              <a:latin typeface="Times New Roman" pitchFamily="18" charset="0"/>
              <a:cs typeface="Times New Roman" pitchFamily="18" charset="0"/>
            </a:endParaRPr>
          </a:p>
        </p:txBody>
      </p:sp>
    </p:spTree>
    <p:extLst>
      <p:ext uri="{BB962C8B-B14F-4D97-AF65-F5344CB8AC3E}">
        <p14:creationId xmlns:p14="http://schemas.microsoft.com/office/powerpoint/2010/main" val="17494091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1 CuadroTexto"/>
          <p:cNvSpPr txBox="1"/>
          <p:nvPr/>
        </p:nvSpPr>
        <p:spPr>
          <a:xfrm>
            <a:off x="251520" y="764704"/>
            <a:ext cx="8640960" cy="3785652"/>
          </a:xfrm>
          <a:prstGeom prst="rect">
            <a:avLst/>
          </a:prstGeom>
          <a:noFill/>
        </p:spPr>
        <p:txBody>
          <a:bodyPr wrap="square" rtlCol="0">
            <a:spAutoFit/>
          </a:bodyPr>
          <a:lstStyle/>
          <a:p>
            <a:pPr algn="just"/>
            <a:r>
              <a:rPr lang="es-CL" sz="1200" b="1" dirty="0">
                <a:latin typeface="Times New Roman" pitchFamily="18" charset="0"/>
                <a:cs typeface="Times New Roman" pitchFamily="18" charset="0"/>
              </a:rPr>
              <a:t>Supporting information Figure S4 A to H. </a:t>
            </a:r>
          </a:p>
          <a:p>
            <a:pPr algn="just"/>
            <a:endParaRPr lang="es-CL" sz="1200" dirty="0">
              <a:latin typeface="Times New Roman" pitchFamily="18" charset="0"/>
              <a:cs typeface="Times New Roman" pitchFamily="18" charset="0"/>
            </a:endParaRPr>
          </a:p>
          <a:p>
            <a:pPr algn="just"/>
            <a:r>
              <a:rPr lang="es-CL" sz="1200" dirty="0">
                <a:latin typeface="Times New Roman" pitchFamily="18" charset="0"/>
                <a:cs typeface="Times New Roman" pitchFamily="18" charset="0"/>
              </a:rPr>
              <a:t>Chromatographic and spectrometric analyses of methanolic extracts of </a:t>
            </a:r>
            <a:r>
              <a:rPr lang="en-US" sz="1200" i="1" dirty="0">
                <a:latin typeface="Times New Roman" pitchFamily="18" charset="0"/>
                <a:cs typeface="Times New Roman" pitchFamily="18" charset="0"/>
              </a:rPr>
              <a:t>Haloterrigena</a:t>
            </a:r>
            <a:r>
              <a:rPr lang="en-US" sz="1200" dirty="0">
                <a:latin typeface="Times New Roman" pitchFamily="18" charset="0"/>
                <a:cs typeface="Times New Roman" pitchFamily="18" charset="0"/>
              </a:rPr>
              <a:t> sp. strain SGH1. </a:t>
            </a:r>
          </a:p>
          <a:p>
            <a:pPr algn="just"/>
            <a:endParaRPr lang="en-US" sz="1200" dirty="0">
              <a:latin typeface="Times New Roman" pitchFamily="18" charset="0"/>
              <a:cs typeface="Times New Roman" pitchFamily="18" charset="0"/>
            </a:endParaRPr>
          </a:p>
          <a:p>
            <a:pPr algn="just"/>
            <a:r>
              <a:rPr lang="en-US" sz="1200" dirty="0">
                <a:latin typeface="Times New Roman" pitchFamily="18" charset="0"/>
                <a:cs typeface="Times New Roman" pitchFamily="18" charset="0"/>
              </a:rPr>
              <a:t>The methanolic extract from cells grown in Z8-MOD medium at 25% (w/v) NaCl was separated into five major fractions (FI to FV) in a HPLC system (Shimatzu Hitachi LC-2A; reverse phase C18 column). Each HPLC fractions was recovered and injected in a UHPLC system (Thermo Sci. Dionex Ultimate 3000; reverse phase C18 Ultra AQ) coupled to a mass spectrometer (Thermo Fischer Sci. Q Exactive). Each major fraction was resolved into the following corresponding subfractions: FI-1, FI-2 and FI-3; FII-1; FIII-1, FIII-2 and FIII-3; FIV-1 and FIV-2; and FV-1. </a:t>
            </a:r>
          </a:p>
          <a:p>
            <a:pPr algn="just"/>
            <a:endParaRPr lang="en-US" sz="1200" dirty="0">
              <a:latin typeface="Times New Roman" pitchFamily="18" charset="0"/>
              <a:cs typeface="Times New Roman" pitchFamily="18" charset="0"/>
            </a:endParaRPr>
          </a:p>
          <a:p>
            <a:pPr algn="just"/>
            <a:r>
              <a:rPr lang="en-US" sz="1200" dirty="0">
                <a:latin typeface="Times New Roman" pitchFamily="18" charset="0"/>
                <a:cs typeface="Times New Roman" pitchFamily="18" charset="0"/>
              </a:rPr>
              <a:t>The following sets of figures show the UHPLC chromatogram/absorption spectrum/mass spectrogram of:</a:t>
            </a:r>
          </a:p>
          <a:p>
            <a:pPr algn="just"/>
            <a:r>
              <a:rPr lang="en-US" sz="1200" dirty="0">
                <a:latin typeface="Times New Roman" pitchFamily="18" charset="0"/>
                <a:cs typeface="Times New Roman" pitchFamily="18" charset="0"/>
              </a:rPr>
              <a:t>A: Subfraction FI-2.</a:t>
            </a:r>
          </a:p>
          <a:p>
            <a:pPr algn="just"/>
            <a:r>
              <a:rPr lang="en-US" sz="1200" dirty="0">
                <a:latin typeface="Times New Roman" pitchFamily="18" charset="0"/>
                <a:cs typeface="Times New Roman" pitchFamily="18" charset="0"/>
              </a:rPr>
              <a:t>B: Subfraction FI-3.</a:t>
            </a:r>
          </a:p>
          <a:p>
            <a:pPr algn="just"/>
            <a:r>
              <a:rPr lang="en-US" sz="1200" dirty="0">
                <a:latin typeface="Times New Roman" pitchFamily="18" charset="0"/>
                <a:cs typeface="Times New Roman" pitchFamily="18" charset="0"/>
              </a:rPr>
              <a:t>C: Subfraction FII-1.</a:t>
            </a:r>
          </a:p>
          <a:p>
            <a:pPr algn="just"/>
            <a:r>
              <a:rPr lang="en-US" sz="1200" dirty="0">
                <a:latin typeface="Times New Roman" pitchFamily="18" charset="0"/>
                <a:cs typeface="Times New Roman" pitchFamily="18" charset="0"/>
              </a:rPr>
              <a:t>D: Subfraction FIII-1.</a:t>
            </a:r>
          </a:p>
          <a:p>
            <a:pPr algn="just"/>
            <a:r>
              <a:rPr lang="en-US" sz="1200" dirty="0">
                <a:latin typeface="Times New Roman" pitchFamily="18" charset="0"/>
                <a:cs typeface="Times New Roman" pitchFamily="18" charset="0"/>
              </a:rPr>
              <a:t>E: Subfraction FIII-2.</a:t>
            </a:r>
          </a:p>
          <a:p>
            <a:pPr algn="just"/>
            <a:r>
              <a:rPr lang="en-US" sz="1200" dirty="0">
                <a:latin typeface="Times New Roman" pitchFamily="18" charset="0"/>
                <a:cs typeface="Times New Roman" pitchFamily="18" charset="0"/>
              </a:rPr>
              <a:t>F: Subfraction FIV-1.</a:t>
            </a:r>
          </a:p>
          <a:p>
            <a:pPr algn="just"/>
            <a:r>
              <a:rPr lang="en-US" sz="1200" dirty="0">
                <a:latin typeface="Times New Roman" pitchFamily="18" charset="0"/>
                <a:cs typeface="Times New Roman" pitchFamily="18" charset="0"/>
              </a:rPr>
              <a:t>G: Subfraction FIV-2.</a:t>
            </a:r>
          </a:p>
          <a:p>
            <a:pPr algn="just"/>
            <a:r>
              <a:rPr lang="en-US" sz="1200" dirty="0">
                <a:latin typeface="Times New Roman" pitchFamily="18" charset="0"/>
                <a:cs typeface="Times New Roman" pitchFamily="18" charset="0"/>
              </a:rPr>
              <a:t>H:  Subfraction FV-1.    </a:t>
            </a:r>
          </a:p>
          <a:p>
            <a:endParaRPr lang="es-CL" sz="1200" dirty="0">
              <a:latin typeface="Times New Roman" pitchFamily="18" charset="0"/>
              <a:cs typeface="Times New Roman" pitchFamily="18" charset="0"/>
            </a:endParaRPr>
          </a:p>
        </p:txBody>
      </p:sp>
    </p:spTree>
    <p:extLst>
      <p:ext uri="{BB962C8B-B14F-4D97-AF65-F5344CB8AC3E}">
        <p14:creationId xmlns:p14="http://schemas.microsoft.com/office/powerpoint/2010/main" val="54384907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4 CuadroTexto"/>
          <p:cNvSpPr txBox="1"/>
          <p:nvPr/>
        </p:nvSpPr>
        <p:spPr>
          <a:xfrm>
            <a:off x="251520" y="260650"/>
            <a:ext cx="8640960" cy="461665"/>
          </a:xfrm>
          <a:prstGeom prst="rect">
            <a:avLst/>
          </a:prstGeom>
          <a:noFill/>
        </p:spPr>
        <p:txBody>
          <a:bodyPr wrap="square" rtlCol="0">
            <a:spAutoFit/>
          </a:bodyPr>
          <a:lstStyle/>
          <a:p>
            <a:pPr algn="just"/>
            <a:r>
              <a:rPr lang="es-CL" sz="1200" b="1" dirty="0">
                <a:latin typeface="Times New Roman" pitchFamily="18" charset="0"/>
                <a:cs typeface="Times New Roman" pitchFamily="18" charset="0"/>
              </a:rPr>
              <a:t>Supporting information Figure S4 A. </a:t>
            </a:r>
            <a:r>
              <a:rPr lang="es-CL" sz="1200" dirty="0">
                <a:latin typeface="Times New Roman" pitchFamily="18" charset="0"/>
                <a:cs typeface="Times New Roman" pitchFamily="18" charset="0"/>
              </a:rPr>
              <a:t>Chromatographic and spectrometric analyses of Subfraction FI-2 (retention time: 11.7 min) from methanolic extracts of </a:t>
            </a:r>
            <a:r>
              <a:rPr lang="en-US" sz="1200" i="1" dirty="0">
                <a:latin typeface="Times New Roman" pitchFamily="18" charset="0"/>
                <a:cs typeface="Times New Roman" pitchFamily="18" charset="0"/>
              </a:rPr>
              <a:t>Haloterrigena</a:t>
            </a:r>
            <a:r>
              <a:rPr lang="en-US" sz="1200" dirty="0">
                <a:latin typeface="Times New Roman" pitchFamily="18" charset="0"/>
                <a:cs typeface="Times New Roman" pitchFamily="18" charset="0"/>
              </a:rPr>
              <a:t> sp. strain SGH1. </a:t>
            </a:r>
          </a:p>
        </p:txBody>
      </p:sp>
      <p:grpSp>
        <p:nvGrpSpPr>
          <p:cNvPr id="7" name="6 Grupo"/>
          <p:cNvGrpSpPr/>
          <p:nvPr/>
        </p:nvGrpSpPr>
        <p:grpSpPr>
          <a:xfrm>
            <a:off x="539552" y="764704"/>
            <a:ext cx="7920880" cy="5760640"/>
            <a:chOff x="827584" y="404664"/>
            <a:chExt cx="7920880" cy="5760640"/>
          </a:xfrm>
        </p:grpSpPr>
        <p:grpSp>
          <p:nvGrpSpPr>
            <p:cNvPr id="4" name="3 Grupo"/>
            <p:cNvGrpSpPr/>
            <p:nvPr/>
          </p:nvGrpSpPr>
          <p:grpSpPr>
            <a:xfrm>
              <a:off x="1115616" y="404664"/>
              <a:ext cx="7632848" cy="5760640"/>
              <a:chOff x="1037177" y="-51115"/>
              <a:chExt cx="7253287" cy="5542563"/>
            </a:xfrm>
          </p:grpSpPr>
          <p:pic>
            <p:nvPicPr>
              <p:cNvPr id="2" name="1 Imagen"/>
              <p:cNvPicPr/>
              <p:nvPr/>
            </p:nvPicPr>
            <p:blipFill rotWithShape="1">
              <a:blip r:embed="rId2">
                <a:extLst>
                  <a:ext uri="{28A0092B-C50C-407E-A947-70E740481C1C}">
                    <a14:useLocalDpi xmlns:a14="http://schemas.microsoft.com/office/drawing/2010/main" val="0"/>
                  </a:ext>
                </a:extLst>
              </a:blip>
              <a:srcRect t="9625"/>
              <a:stretch/>
            </p:blipFill>
            <p:spPr bwMode="auto">
              <a:xfrm>
                <a:off x="1037177" y="1831194"/>
                <a:ext cx="7253287" cy="3660254"/>
              </a:xfrm>
              <a:prstGeom prst="rect">
                <a:avLst/>
              </a:prstGeom>
              <a:noFill/>
              <a:ln>
                <a:noFill/>
              </a:ln>
              <a:extLst>
                <a:ext uri="{53640926-AAD7-44D8-BBD7-CCE9431645EC}">
                  <a14:shadowObscured xmlns:a14="http://schemas.microsoft.com/office/drawing/2010/main"/>
                </a:ext>
              </a:extLst>
            </p:spPr>
          </p:pic>
          <p:pic>
            <p:nvPicPr>
              <p:cNvPr id="3" name="2 Imagen"/>
              <p:cNvPicPr/>
              <p:nvPr/>
            </p:nvPicPr>
            <p:blipFill rotWithShape="1">
              <a:blip r:embed="rId3" cstate="print">
                <a:extLst>
                  <a:ext uri="{28A0092B-C50C-407E-A947-70E740481C1C}">
                    <a14:useLocalDpi xmlns:a14="http://schemas.microsoft.com/office/drawing/2010/main" val="0"/>
                  </a:ext>
                </a:extLst>
              </a:blip>
              <a:srcRect t="7146" r="11647"/>
              <a:stretch/>
            </p:blipFill>
            <p:spPr bwMode="auto">
              <a:xfrm>
                <a:off x="5005958" y="-51115"/>
                <a:ext cx="3284506" cy="2078990"/>
              </a:xfrm>
              <a:prstGeom prst="rect">
                <a:avLst/>
              </a:prstGeom>
              <a:noFill/>
              <a:ln>
                <a:noFill/>
              </a:ln>
              <a:extLst>
                <a:ext uri="{53640926-AAD7-44D8-BBD7-CCE9431645EC}">
                  <a14:shadowObscured xmlns:a14="http://schemas.microsoft.com/office/drawing/2010/main"/>
                </a:ext>
              </a:extLst>
            </p:spPr>
          </p:pic>
        </p:grpSp>
        <p:pic>
          <p:nvPicPr>
            <p:cNvPr id="6" name="5 Imagen"/>
            <p:cNvPicPr/>
            <p:nvPr/>
          </p:nvPicPr>
          <p:blipFill rotWithShape="1">
            <a:blip r:embed="rId4"/>
            <a:srcRect l="18854" t="10730" r="7693" b="12277"/>
            <a:stretch/>
          </p:blipFill>
          <p:spPr bwMode="auto">
            <a:xfrm>
              <a:off x="827584" y="506289"/>
              <a:ext cx="3555978" cy="2088232"/>
            </a:xfrm>
            <a:prstGeom prst="rect">
              <a:avLst/>
            </a:prstGeom>
            <a:ln>
              <a:noFill/>
            </a:ln>
            <a:extLst>
              <a:ext uri="{53640926-AAD7-44D8-BBD7-CCE9431645EC}">
                <a14:shadowObscured xmlns:a14="http://schemas.microsoft.com/office/drawing/2010/main"/>
              </a:ext>
            </a:extLst>
          </p:spPr>
        </p:pic>
      </p:grpSp>
    </p:spTree>
    <p:extLst>
      <p:ext uri="{BB962C8B-B14F-4D97-AF65-F5344CB8AC3E}">
        <p14:creationId xmlns:p14="http://schemas.microsoft.com/office/powerpoint/2010/main" val="34860011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 name="204 Imagen"/>
          <p:cNvPicPr/>
          <p:nvPr/>
        </p:nvPicPr>
        <p:blipFill rotWithShape="1">
          <a:blip r:embed="rId2">
            <a:extLst>
              <a:ext uri="{28A0092B-C50C-407E-A947-70E740481C1C}">
                <a14:useLocalDpi xmlns:a14="http://schemas.microsoft.com/office/drawing/2010/main" val="0"/>
              </a:ext>
            </a:extLst>
          </a:blip>
          <a:srcRect t="11984"/>
          <a:stretch/>
        </p:blipFill>
        <p:spPr bwMode="auto">
          <a:xfrm>
            <a:off x="510558" y="2197961"/>
            <a:ext cx="8280920" cy="4176464"/>
          </a:xfrm>
          <a:prstGeom prst="rect">
            <a:avLst/>
          </a:prstGeom>
          <a:noFill/>
          <a:ln>
            <a:noFill/>
          </a:ln>
          <a:extLst>
            <a:ext uri="{53640926-AAD7-44D8-BBD7-CCE9431645EC}">
              <a14:shadowObscured xmlns:a14="http://schemas.microsoft.com/office/drawing/2010/main"/>
            </a:ext>
          </a:extLst>
        </p:spPr>
      </p:pic>
      <p:grpSp>
        <p:nvGrpSpPr>
          <p:cNvPr id="1024" name="1023 Grupo"/>
          <p:cNvGrpSpPr/>
          <p:nvPr/>
        </p:nvGrpSpPr>
        <p:grpSpPr>
          <a:xfrm>
            <a:off x="5218127" y="938767"/>
            <a:ext cx="3573353" cy="2274211"/>
            <a:chOff x="3450644" y="836712"/>
            <a:chExt cx="1954173" cy="1185767"/>
          </a:xfrm>
        </p:grpSpPr>
        <p:grpSp>
          <p:nvGrpSpPr>
            <p:cNvPr id="209" name="Group 410"/>
            <p:cNvGrpSpPr>
              <a:grpSpLocks/>
            </p:cNvGrpSpPr>
            <p:nvPr/>
          </p:nvGrpSpPr>
          <p:grpSpPr bwMode="auto">
            <a:xfrm>
              <a:off x="3630411" y="836712"/>
              <a:ext cx="1681881" cy="1185767"/>
              <a:chOff x="336" y="-205"/>
              <a:chExt cx="3890" cy="3365"/>
            </a:xfrm>
          </p:grpSpPr>
          <p:sp>
            <p:nvSpPr>
              <p:cNvPr id="263" name="Rectangle 211"/>
              <p:cNvSpPr>
                <a:spLocks noChangeArrowheads="1"/>
              </p:cNvSpPr>
              <p:nvPr/>
            </p:nvSpPr>
            <p:spPr bwMode="auto">
              <a:xfrm>
                <a:off x="1015" y="-205"/>
                <a:ext cx="32" cy="2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s-CL" sz="700">
                    <a:solidFill>
                      <a:srgbClr val="000000"/>
                    </a:solidFill>
                    <a:latin typeface="Arial"/>
                    <a:ea typeface="Calibri"/>
                  </a:rPr>
                  <a:t> </a:t>
                </a:r>
                <a:endParaRPr lang="es-CL">
                  <a:latin typeface="Times New Roman"/>
                  <a:ea typeface="Calibri"/>
                </a:endParaRPr>
              </a:p>
            </p:txBody>
          </p:sp>
          <p:cxnSp>
            <p:nvCxnSpPr>
              <p:cNvPr id="273" name="Line 221"/>
              <p:cNvCxnSpPr/>
              <p:nvPr/>
            </p:nvCxnSpPr>
            <p:spPr bwMode="auto">
              <a:xfrm>
                <a:off x="371" y="2787"/>
                <a:ext cx="3833"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74" name="Line 222"/>
              <p:cNvCxnSpPr/>
              <p:nvPr/>
            </p:nvCxnSpPr>
            <p:spPr bwMode="auto">
              <a:xfrm>
                <a:off x="483"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75" name="Line 223"/>
              <p:cNvCxnSpPr/>
              <p:nvPr/>
            </p:nvCxnSpPr>
            <p:spPr bwMode="auto">
              <a:xfrm>
                <a:off x="612"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76" name="Line 224"/>
              <p:cNvCxnSpPr/>
              <p:nvPr/>
            </p:nvCxnSpPr>
            <p:spPr bwMode="auto">
              <a:xfrm>
                <a:off x="736"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77" name="Line 225"/>
              <p:cNvCxnSpPr/>
              <p:nvPr/>
            </p:nvCxnSpPr>
            <p:spPr bwMode="auto">
              <a:xfrm>
                <a:off x="866"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78" name="Line 226"/>
              <p:cNvCxnSpPr/>
              <p:nvPr/>
            </p:nvCxnSpPr>
            <p:spPr bwMode="auto">
              <a:xfrm>
                <a:off x="1119"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79" name="Line 227"/>
              <p:cNvCxnSpPr/>
              <p:nvPr/>
            </p:nvCxnSpPr>
            <p:spPr bwMode="auto">
              <a:xfrm>
                <a:off x="1242"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80" name="Line 228"/>
              <p:cNvCxnSpPr/>
              <p:nvPr/>
            </p:nvCxnSpPr>
            <p:spPr bwMode="auto">
              <a:xfrm>
                <a:off x="1372"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81" name="Line 229"/>
              <p:cNvCxnSpPr/>
              <p:nvPr/>
            </p:nvCxnSpPr>
            <p:spPr bwMode="auto">
              <a:xfrm>
                <a:off x="1501"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82" name="Line 230"/>
              <p:cNvCxnSpPr/>
              <p:nvPr/>
            </p:nvCxnSpPr>
            <p:spPr bwMode="auto">
              <a:xfrm>
                <a:off x="1755"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83" name="Line 231"/>
              <p:cNvCxnSpPr/>
              <p:nvPr/>
            </p:nvCxnSpPr>
            <p:spPr bwMode="auto">
              <a:xfrm>
                <a:off x="1878"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84" name="Line 232"/>
              <p:cNvCxnSpPr/>
              <p:nvPr/>
            </p:nvCxnSpPr>
            <p:spPr bwMode="auto">
              <a:xfrm>
                <a:off x="2008"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85" name="Line 233"/>
              <p:cNvCxnSpPr/>
              <p:nvPr/>
            </p:nvCxnSpPr>
            <p:spPr bwMode="auto">
              <a:xfrm>
                <a:off x="2131"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86" name="Line 234"/>
              <p:cNvCxnSpPr/>
              <p:nvPr/>
            </p:nvCxnSpPr>
            <p:spPr bwMode="auto">
              <a:xfrm>
                <a:off x="2391"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87" name="Line 235"/>
              <p:cNvCxnSpPr/>
              <p:nvPr/>
            </p:nvCxnSpPr>
            <p:spPr bwMode="auto">
              <a:xfrm>
                <a:off x="2514"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88" name="Line 236"/>
              <p:cNvCxnSpPr/>
              <p:nvPr/>
            </p:nvCxnSpPr>
            <p:spPr bwMode="auto">
              <a:xfrm>
                <a:off x="2644"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89" name="Line 237"/>
              <p:cNvCxnSpPr/>
              <p:nvPr/>
            </p:nvCxnSpPr>
            <p:spPr bwMode="auto">
              <a:xfrm>
                <a:off x="2767"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90" name="Line 238"/>
              <p:cNvCxnSpPr/>
              <p:nvPr/>
            </p:nvCxnSpPr>
            <p:spPr bwMode="auto">
              <a:xfrm>
                <a:off x="3021"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91" name="Line 239"/>
              <p:cNvCxnSpPr/>
              <p:nvPr/>
            </p:nvCxnSpPr>
            <p:spPr bwMode="auto">
              <a:xfrm>
                <a:off x="3150"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92" name="Line 240"/>
              <p:cNvCxnSpPr/>
              <p:nvPr/>
            </p:nvCxnSpPr>
            <p:spPr bwMode="auto">
              <a:xfrm>
                <a:off x="3280"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93" name="Line 241"/>
              <p:cNvCxnSpPr/>
              <p:nvPr/>
            </p:nvCxnSpPr>
            <p:spPr bwMode="auto">
              <a:xfrm>
                <a:off x="3403"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94" name="Line 242"/>
              <p:cNvCxnSpPr/>
              <p:nvPr/>
            </p:nvCxnSpPr>
            <p:spPr bwMode="auto">
              <a:xfrm>
                <a:off x="3656"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95" name="Line 243"/>
              <p:cNvCxnSpPr/>
              <p:nvPr/>
            </p:nvCxnSpPr>
            <p:spPr bwMode="auto">
              <a:xfrm>
                <a:off x="3786"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96" name="Line 244"/>
              <p:cNvCxnSpPr/>
              <p:nvPr/>
            </p:nvCxnSpPr>
            <p:spPr bwMode="auto">
              <a:xfrm>
                <a:off x="3910"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97" name="Line 245"/>
              <p:cNvCxnSpPr/>
              <p:nvPr/>
            </p:nvCxnSpPr>
            <p:spPr bwMode="auto">
              <a:xfrm>
                <a:off x="4039" y="2787"/>
                <a:ext cx="0" cy="3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98" name="Line 246"/>
              <p:cNvCxnSpPr/>
              <p:nvPr/>
            </p:nvCxnSpPr>
            <p:spPr bwMode="auto">
              <a:xfrm>
                <a:off x="383"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99" name="Line 247"/>
              <p:cNvCxnSpPr/>
              <p:nvPr/>
            </p:nvCxnSpPr>
            <p:spPr bwMode="auto">
              <a:xfrm>
                <a:off x="406"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00" name="Line 248"/>
              <p:cNvCxnSpPr/>
              <p:nvPr/>
            </p:nvCxnSpPr>
            <p:spPr bwMode="auto">
              <a:xfrm>
                <a:off x="430"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01" name="Line 249"/>
              <p:cNvCxnSpPr/>
              <p:nvPr/>
            </p:nvCxnSpPr>
            <p:spPr bwMode="auto">
              <a:xfrm>
                <a:off x="459"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02" name="Line 250"/>
              <p:cNvCxnSpPr/>
              <p:nvPr/>
            </p:nvCxnSpPr>
            <p:spPr bwMode="auto">
              <a:xfrm>
                <a:off x="506"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03" name="Line 251"/>
              <p:cNvCxnSpPr/>
              <p:nvPr/>
            </p:nvCxnSpPr>
            <p:spPr bwMode="auto">
              <a:xfrm>
                <a:off x="536"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04" name="Line 252"/>
              <p:cNvCxnSpPr/>
              <p:nvPr/>
            </p:nvCxnSpPr>
            <p:spPr bwMode="auto">
              <a:xfrm>
                <a:off x="559"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05" name="Line 253"/>
              <p:cNvCxnSpPr/>
              <p:nvPr/>
            </p:nvCxnSpPr>
            <p:spPr bwMode="auto">
              <a:xfrm>
                <a:off x="583"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06" name="Line 254"/>
              <p:cNvCxnSpPr/>
              <p:nvPr/>
            </p:nvCxnSpPr>
            <p:spPr bwMode="auto">
              <a:xfrm>
                <a:off x="636"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07" name="Line 255"/>
              <p:cNvCxnSpPr/>
              <p:nvPr/>
            </p:nvCxnSpPr>
            <p:spPr bwMode="auto">
              <a:xfrm>
                <a:off x="659"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08" name="Line 256"/>
              <p:cNvCxnSpPr/>
              <p:nvPr/>
            </p:nvCxnSpPr>
            <p:spPr bwMode="auto">
              <a:xfrm>
                <a:off x="689"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09" name="Line 257"/>
              <p:cNvCxnSpPr/>
              <p:nvPr/>
            </p:nvCxnSpPr>
            <p:spPr bwMode="auto">
              <a:xfrm>
                <a:off x="712"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10" name="Line 258"/>
              <p:cNvCxnSpPr/>
              <p:nvPr/>
            </p:nvCxnSpPr>
            <p:spPr bwMode="auto">
              <a:xfrm>
                <a:off x="760"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11" name="Line 259"/>
              <p:cNvCxnSpPr/>
              <p:nvPr/>
            </p:nvCxnSpPr>
            <p:spPr bwMode="auto">
              <a:xfrm>
                <a:off x="789"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12" name="Line 260"/>
              <p:cNvCxnSpPr/>
              <p:nvPr/>
            </p:nvCxnSpPr>
            <p:spPr bwMode="auto">
              <a:xfrm>
                <a:off x="813"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13" name="Line 261"/>
              <p:cNvCxnSpPr/>
              <p:nvPr/>
            </p:nvCxnSpPr>
            <p:spPr bwMode="auto">
              <a:xfrm>
                <a:off x="836"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14" name="Line 262"/>
              <p:cNvCxnSpPr/>
              <p:nvPr/>
            </p:nvCxnSpPr>
            <p:spPr bwMode="auto">
              <a:xfrm>
                <a:off x="889"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15" name="Line 263"/>
              <p:cNvCxnSpPr/>
              <p:nvPr/>
            </p:nvCxnSpPr>
            <p:spPr bwMode="auto">
              <a:xfrm>
                <a:off x="913"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16" name="Line 264"/>
              <p:cNvCxnSpPr/>
              <p:nvPr/>
            </p:nvCxnSpPr>
            <p:spPr bwMode="auto">
              <a:xfrm>
                <a:off x="942"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17" name="Line 265"/>
              <p:cNvCxnSpPr/>
              <p:nvPr/>
            </p:nvCxnSpPr>
            <p:spPr bwMode="auto">
              <a:xfrm>
                <a:off x="966"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18" name="Line 266"/>
              <p:cNvCxnSpPr/>
              <p:nvPr/>
            </p:nvCxnSpPr>
            <p:spPr bwMode="auto">
              <a:xfrm>
                <a:off x="1019"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19" name="Line 267"/>
              <p:cNvCxnSpPr/>
              <p:nvPr/>
            </p:nvCxnSpPr>
            <p:spPr bwMode="auto">
              <a:xfrm>
                <a:off x="1042"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20" name="Line 268"/>
              <p:cNvCxnSpPr/>
              <p:nvPr/>
            </p:nvCxnSpPr>
            <p:spPr bwMode="auto">
              <a:xfrm>
                <a:off x="1066"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21" name="Line 269"/>
              <p:cNvCxnSpPr/>
              <p:nvPr/>
            </p:nvCxnSpPr>
            <p:spPr bwMode="auto">
              <a:xfrm>
                <a:off x="1095"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22" name="Line 270"/>
              <p:cNvCxnSpPr/>
              <p:nvPr/>
            </p:nvCxnSpPr>
            <p:spPr bwMode="auto">
              <a:xfrm>
                <a:off x="1142"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23" name="Line 271"/>
              <p:cNvCxnSpPr/>
              <p:nvPr/>
            </p:nvCxnSpPr>
            <p:spPr bwMode="auto">
              <a:xfrm>
                <a:off x="1166"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24" name="Line 272"/>
              <p:cNvCxnSpPr/>
              <p:nvPr/>
            </p:nvCxnSpPr>
            <p:spPr bwMode="auto">
              <a:xfrm>
                <a:off x="1195"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25" name="Line 273"/>
              <p:cNvCxnSpPr/>
              <p:nvPr/>
            </p:nvCxnSpPr>
            <p:spPr bwMode="auto">
              <a:xfrm>
                <a:off x="1219"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26" name="Line 274"/>
              <p:cNvCxnSpPr/>
              <p:nvPr/>
            </p:nvCxnSpPr>
            <p:spPr bwMode="auto">
              <a:xfrm>
                <a:off x="1272"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27" name="Line 275"/>
              <p:cNvCxnSpPr/>
              <p:nvPr/>
            </p:nvCxnSpPr>
            <p:spPr bwMode="auto">
              <a:xfrm>
                <a:off x="1295"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28" name="Line 276"/>
              <p:cNvCxnSpPr/>
              <p:nvPr/>
            </p:nvCxnSpPr>
            <p:spPr bwMode="auto">
              <a:xfrm>
                <a:off x="1319"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29" name="Line 277"/>
              <p:cNvCxnSpPr/>
              <p:nvPr/>
            </p:nvCxnSpPr>
            <p:spPr bwMode="auto">
              <a:xfrm>
                <a:off x="1348"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30" name="Line 278"/>
              <p:cNvCxnSpPr/>
              <p:nvPr/>
            </p:nvCxnSpPr>
            <p:spPr bwMode="auto">
              <a:xfrm>
                <a:off x="1395"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31" name="Line 279"/>
              <p:cNvCxnSpPr/>
              <p:nvPr/>
            </p:nvCxnSpPr>
            <p:spPr bwMode="auto">
              <a:xfrm>
                <a:off x="1425"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32" name="Line 280"/>
              <p:cNvCxnSpPr/>
              <p:nvPr/>
            </p:nvCxnSpPr>
            <p:spPr bwMode="auto">
              <a:xfrm>
                <a:off x="1448"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33" name="Line 281"/>
              <p:cNvCxnSpPr/>
              <p:nvPr/>
            </p:nvCxnSpPr>
            <p:spPr bwMode="auto">
              <a:xfrm>
                <a:off x="1472"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34" name="Line 282"/>
              <p:cNvCxnSpPr/>
              <p:nvPr/>
            </p:nvCxnSpPr>
            <p:spPr bwMode="auto">
              <a:xfrm>
                <a:off x="1525"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35" name="Line 283"/>
              <p:cNvCxnSpPr/>
              <p:nvPr/>
            </p:nvCxnSpPr>
            <p:spPr bwMode="auto">
              <a:xfrm>
                <a:off x="1549"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36" name="Line 284"/>
              <p:cNvCxnSpPr/>
              <p:nvPr/>
            </p:nvCxnSpPr>
            <p:spPr bwMode="auto">
              <a:xfrm>
                <a:off x="1578"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37" name="Line 285"/>
              <p:cNvCxnSpPr/>
              <p:nvPr/>
            </p:nvCxnSpPr>
            <p:spPr bwMode="auto">
              <a:xfrm>
                <a:off x="1602"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38" name="Line 286"/>
              <p:cNvCxnSpPr/>
              <p:nvPr/>
            </p:nvCxnSpPr>
            <p:spPr bwMode="auto">
              <a:xfrm>
                <a:off x="1649"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39" name="Line 287"/>
              <p:cNvCxnSpPr/>
              <p:nvPr/>
            </p:nvCxnSpPr>
            <p:spPr bwMode="auto">
              <a:xfrm>
                <a:off x="1678"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40" name="Line 288"/>
              <p:cNvCxnSpPr/>
              <p:nvPr/>
            </p:nvCxnSpPr>
            <p:spPr bwMode="auto">
              <a:xfrm>
                <a:off x="1702"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41" name="Line 289"/>
              <p:cNvCxnSpPr/>
              <p:nvPr/>
            </p:nvCxnSpPr>
            <p:spPr bwMode="auto">
              <a:xfrm>
                <a:off x="1725"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42" name="Line 290"/>
              <p:cNvCxnSpPr/>
              <p:nvPr/>
            </p:nvCxnSpPr>
            <p:spPr bwMode="auto">
              <a:xfrm>
                <a:off x="1778"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43" name="Line 291"/>
              <p:cNvCxnSpPr/>
              <p:nvPr/>
            </p:nvCxnSpPr>
            <p:spPr bwMode="auto">
              <a:xfrm>
                <a:off x="1802"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44" name="Line 292"/>
              <p:cNvCxnSpPr/>
              <p:nvPr/>
            </p:nvCxnSpPr>
            <p:spPr bwMode="auto">
              <a:xfrm>
                <a:off x="1831"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45" name="Line 293"/>
              <p:cNvCxnSpPr/>
              <p:nvPr/>
            </p:nvCxnSpPr>
            <p:spPr bwMode="auto">
              <a:xfrm>
                <a:off x="1855"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46" name="Line 294"/>
              <p:cNvCxnSpPr/>
              <p:nvPr/>
            </p:nvCxnSpPr>
            <p:spPr bwMode="auto">
              <a:xfrm>
                <a:off x="1908"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47" name="Line 295"/>
              <p:cNvCxnSpPr/>
              <p:nvPr/>
            </p:nvCxnSpPr>
            <p:spPr bwMode="auto">
              <a:xfrm>
                <a:off x="1931"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48" name="Line 296"/>
              <p:cNvCxnSpPr/>
              <p:nvPr/>
            </p:nvCxnSpPr>
            <p:spPr bwMode="auto">
              <a:xfrm>
                <a:off x="1955"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49" name="Line 297"/>
              <p:cNvCxnSpPr/>
              <p:nvPr/>
            </p:nvCxnSpPr>
            <p:spPr bwMode="auto">
              <a:xfrm>
                <a:off x="1984"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50" name="Line 298"/>
              <p:cNvCxnSpPr/>
              <p:nvPr/>
            </p:nvCxnSpPr>
            <p:spPr bwMode="auto">
              <a:xfrm>
                <a:off x="2031"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51" name="Line 299"/>
              <p:cNvCxnSpPr/>
              <p:nvPr/>
            </p:nvCxnSpPr>
            <p:spPr bwMode="auto">
              <a:xfrm>
                <a:off x="2061"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52" name="Line 300"/>
              <p:cNvCxnSpPr/>
              <p:nvPr/>
            </p:nvCxnSpPr>
            <p:spPr bwMode="auto">
              <a:xfrm>
                <a:off x="2084"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53" name="Line 301"/>
              <p:cNvCxnSpPr/>
              <p:nvPr/>
            </p:nvCxnSpPr>
            <p:spPr bwMode="auto">
              <a:xfrm>
                <a:off x="2108"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54" name="Line 302"/>
              <p:cNvCxnSpPr/>
              <p:nvPr/>
            </p:nvCxnSpPr>
            <p:spPr bwMode="auto">
              <a:xfrm>
                <a:off x="2161"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55" name="Line 303"/>
              <p:cNvCxnSpPr/>
              <p:nvPr/>
            </p:nvCxnSpPr>
            <p:spPr bwMode="auto">
              <a:xfrm>
                <a:off x="2184"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56" name="Line 304"/>
              <p:cNvCxnSpPr/>
              <p:nvPr/>
            </p:nvCxnSpPr>
            <p:spPr bwMode="auto">
              <a:xfrm>
                <a:off x="2208"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57" name="Line 305"/>
              <p:cNvCxnSpPr/>
              <p:nvPr/>
            </p:nvCxnSpPr>
            <p:spPr bwMode="auto">
              <a:xfrm>
                <a:off x="2237"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58" name="Line 306"/>
              <p:cNvCxnSpPr/>
              <p:nvPr/>
            </p:nvCxnSpPr>
            <p:spPr bwMode="auto">
              <a:xfrm>
                <a:off x="2285"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59" name="Line 307"/>
              <p:cNvCxnSpPr/>
              <p:nvPr/>
            </p:nvCxnSpPr>
            <p:spPr bwMode="auto">
              <a:xfrm>
                <a:off x="2314"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60" name="Line 308"/>
              <p:cNvCxnSpPr/>
              <p:nvPr/>
            </p:nvCxnSpPr>
            <p:spPr bwMode="auto">
              <a:xfrm>
                <a:off x="2338"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61" name="Line 309"/>
              <p:cNvCxnSpPr/>
              <p:nvPr/>
            </p:nvCxnSpPr>
            <p:spPr bwMode="auto">
              <a:xfrm>
                <a:off x="2361"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62" name="Line 310"/>
              <p:cNvCxnSpPr/>
              <p:nvPr/>
            </p:nvCxnSpPr>
            <p:spPr bwMode="auto">
              <a:xfrm>
                <a:off x="2414"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63" name="Line 311"/>
              <p:cNvCxnSpPr/>
              <p:nvPr/>
            </p:nvCxnSpPr>
            <p:spPr bwMode="auto">
              <a:xfrm>
                <a:off x="2438"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64" name="Line 312"/>
              <p:cNvCxnSpPr/>
              <p:nvPr/>
            </p:nvCxnSpPr>
            <p:spPr bwMode="auto">
              <a:xfrm>
                <a:off x="2467"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65" name="Line 313"/>
              <p:cNvCxnSpPr/>
              <p:nvPr/>
            </p:nvCxnSpPr>
            <p:spPr bwMode="auto">
              <a:xfrm>
                <a:off x="2491"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66" name="Line 314"/>
              <p:cNvCxnSpPr/>
              <p:nvPr/>
            </p:nvCxnSpPr>
            <p:spPr bwMode="auto">
              <a:xfrm>
                <a:off x="2538"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67" name="Line 315"/>
              <p:cNvCxnSpPr/>
              <p:nvPr/>
            </p:nvCxnSpPr>
            <p:spPr bwMode="auto">
              <a:xfrm>
                <a:off x="2567"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68" name="Line 316"/>
              <p:cNvCxnSpPr/>
              <p:nvPr/>
            </p:nvCxnSpPr>
            <p:spPr bwMode="auto">
              <a:xfrm>
                <a:off x="2591"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69" name="Line 317"/>
              <p:cNvCxnSpPr/>
              <p:nvPr/>
            </p:nvCxnSpPr>
            <p:spPr bwMode="auto">
              <a:xfrm>
                <a:off x="2614"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70" name="Line 318"/>
              <p:cNvCxnSpPr/>
              <p:nvPr/>
            </p:nvCxnSpPr>
            <p:spPr bwMode="auto">
              <a:xfrm>
                <a:off x="2667"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71" name="Line 319"/>
              <p:cNvCxnSpPr/>
              <p:nvPr/>
            </p:nvCxnSpPr>
            <p:spPr bwMode="auto">
              <a:xfrm>
                <a:off x="2691"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72" name="Line 320"/>
              <p:cNvCxnSpPr/>
              <p:nvPr/>
            </p:nvCxnSpPr>
            <p:spPr bwMode="auto">
              <a:xfrm>
                <a:off x="2720"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73" name="Line 321"/>
              <p:cNvCxnSpPr/>
              <p:nvPr/>
            </p:nvCxnSpPr>
            <p:spPr bwMode="auto">
              <a:xfrm>
                <a:off x="2744"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74" name="Line 322"/>
              <p:cNvCxnSpPr/>
              <p:nvPr/>
            </p:nvCxnSpPr>
            <p:spPr bwMode="auto">
              <a:xfrm>
                <a:off x="2797"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75" name="Line 323"/>
              <p:cNvCxnSpPr/>
              <p:nvPr/>
            </p:nvCxnSpPr>
            <p:spPr bwMode="auto">
              <a:xfrm>
                <a:off x="2820"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76" name="Line 324"/>
              <p:cNvCxnSpPr/>
              <p:nvPr/>
            </p:nvCxnSpPr>
            <p:spPr bwMode="auto">
              <a:xfrm>
                <a:off x="2844"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77" name="Line 325"/>
              <p:cNvCxnSpPr/>
              <p:nvPr/>
            </p:nvCxnSpPr>
            <p:spPr bwMode="auto">
              <a:xfrm>
                <a:off x="2873"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78" name="Line 326"/>
              <p:cNvCxnSpPr/>
              <p:nvPr/>
            </p:nvCxnSpPr>
            <p:spPr bwMode="auto">
              <a:xfrm>
                <a:off x="2920"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79" name="Line 327"/>
              <p:cNvCxnSpPr/>
              <p:nvPr/>
            </p:nvCxnSpPr>
            <p:spPr bwMode="auto">
              <a:xfrm>
                <a:off x="2950"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80" name="Line 328"/>
              <p:cNvCxnSpPr/>
              <p:nvPr/>
            </p:nvCxnSpPr>
            <p:spPr bwMode="auto">
              <a:xfrm>
                <a:off x="2973"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81" name="Line 329"/>
              <p:cNvCxnSpPr/>
              <p:nvPr/>
            </p:nvCxnSpPr>
            <p:spPr bwMode="auto">
              <a:xfrm>
                <a:off x="2997"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82" name="Line 330"/>
              <p:cNvCxnSpPr/>
              <p:nvPr/>
            </p:nvCxnSpPr>
            <p:spPr bwMode="auto">
              <a:xfrm>
                <a:off x="3050"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83" name="Line 331"/>
              <p:cNvCxnSpPr/>
              <p:nvPr/>
            </p:nvCxnSpPr>
            <p:spPr bwMode="auto">
              <a:xfrm>
                <a:off x="3074"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84" name="Line 332"/>
              <p:cNvCxnSpPr/>
              <p:nvPr/>
            </p:nvCxnSpPr>
            <p:spPr bwMode="auto">
              <a:xfrm>
                <a:off x="3097"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85" name="Line 333"/>
              <p:cNvCxnSpPr/>
              <p:nvPr/>
            </p:nvCxnSpPr>
            <p:spPr bwMode="auto">
              <a:xfrm>
                <a:off x="3127"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86" name="Line 334"/>
              <p:cNvCxnSpPr/>
              <p:nvPr/>
            </p:nvCxnSpPr>
            <p:spPr bwMode="auto">
              <a:xfrm>
                <a:off x="3174"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87" name="Line 335"/>
              <p:cNvCxnSpPr/>
              <p:nvPr/>
            </p:nvCxnSpPr>
            <p:spPr bwMode="auto">
              <a:xfrm>
                <a:off x="3203"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88" name="Line 336"/>
              <p:cNvCxnSpPr/>
              <p:nvPr/>
            </p:nvCxnSpPr>
            <p:spPr bwMode="auto">
              <a:xfrm>
                <a:off x="3227"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89" name="Line 337"/>
              <p:cNvCxnSpPr/>
              <p:nvPr/>
            </p:nvCxnSpPr>
            <p:spPr bwMode="auto">
              <a:xfrm>
                <a:off x="3250"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90" name="Line 338"/>
              <p:cNvCxnSpPr/>
              <p:nvPr/>
            </p:nvCxnSpPr>
            <p:spPr bwMode="auto">
              <a:xfrm>
                <a:off x="3303"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91" name="Line 339"/>
              <p:cNvCxnSpPr/>
              <p:nvPr/>
            </p:nvCxnSpPr>
            <p:spPr bwMode="auto">
              <a:xfrm>
                <a:off x="3327"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92" name="Line 340"/>
              <p:cNvCxnSpPr/>
              <p:nvPr/>
            </p:nvCxnSpPr>
            <p:spPr bwMode="auto">
              <a:xfrm>
                <a:off x="3356"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93" name="Line 341"/>
              <p:cNvCxnSpPr/>
              <p:nvPr/>
            </p:nvCxnSpPr>
            <p:spPr bwMode="auto">
              <a:xfrm>
                <a:off x="3380"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94" name="Line 342"/>
              <p:cNvCxnSpPr/>
              <p:nvPr/>
            </p:nvCxnSpPr>
            <p:spPr bwMode="auto">
              <a:xfrm>
                <a:off x="3433"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95" name="Line 343"/>
              <p:cNvCxnSpPr/>
              <p:nvPr/>
            </p:nvCxnSpPr>
            <p:spPr bwMode="auto">
              <a:xfrm>
                <a:off x="3456"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96" name="Line 344"/>
              <p:cNvCxnSpPr/>
              <p:nvPr/>
            </p:nvCxnSpPr>
            <p:spPr bwMode="auto">
              <a:xfrm>
                <a:off x="3480"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97" name="Line 345"/>
              <p:cNvCxnSpPr/>
              <p:nvPr/>
            </p:nvCxnSpPr>
            <p:spPr bwMode="auto">
              <a:xfrm>
                <a:off x="3503"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98" name="Line 346"/>
              <p:cNvCxnSpPr/>
              <p:nvPr/>
            </p:nvCxnSpPr>
            <p:spPr bwMode="auto">
              <a:xfrm>
                <a:off x="3556"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399" name="Line 347"/>
              <p:cNvCxnSpPr/>
              <p:nvPr/>
            </p:nvCxnSpPr>
            <p:spPr bwMode="auto">
              <a:xfrm>
                <a:off x="3580"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00" name="Line 348"/>
              <p:cNvCxnSpPr/>
              <p:nvPr/>
            </p:nvCxnSpPr>
            <p:spPr bwMode="auto">
              <a:xfrm>
                <a:off x="3609"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01" name="Line 349"/>
              <p:cNvCxnSpPr/>
              <p:nvPr/>
            </p:nvCxnSpPr>
            <p:spPr bwMode="auto">
              <a:xfrm>
                <a:off x="3633"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02" name="Line 350"/>
              <p:cNvCxnSpPr/>
              <p:nvPr/>
            </p:nvCxnSpPr>
            <p:spPr bwMode="auto">
              <a:xfrm>
                <a:off x="3686"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03" name="Line 351"/>
              <p:cNvCxnSpPr/>
              <p:nvPr/>
            </p:nvCxnSpPr>
            <p:spPr bwMode="auto">
              <a:xfrm>
                <a:off x="3709"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04" name="Line 352"/>
              <p:cNvCxnSpPr/>
              <p:nvPr/>
            </p:nvCxnSpPr>
            <p:spPr bwMode="auto">
              <a:xfrm>
                <a:off x="3733"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05" name="Line 353"/>
              <p:cNvCxnSpPr/>
              <p:nvPr/>
            </p:nvCxnSpPr>
            <p:spPr bwMode="auto">
              <a:xfrm>
                <a:off x="3762"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06" name="Line 354"/>
              <p:cNvCxnSpPr/>
              <p:nvPr/>
            </p:nvCxnSpPr>
            <p:spPr bwMode="auto">
              <a:xfrm>
                <a:off x="3810"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07" name="Line 355"/>
              <p:cNvCxnSpPr/>
              <p:nvPr/>
            </p:nvCxnSpPr>
            <p:spPr bwMode="auto">
              <a:xfrm>
                <a:off x="3839"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08" name="Line 356"/>
              <p:cNvCxnSpPr/>
              <p:nvPr/>
            </p:nvCxnSpPr>
            <p:spPr bwMode="auto">
              <a:xfrm>
                <a:off x="3863"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09" name="Line 357"/>
              <p:cNvCxnSpPr/>
              <p:nvPr/>
            </p:nvCxnSpPr>
            <p:spPr bwMode="auto">
              <a:xfrm>
                <a:off x="3886"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10" name="Line 358"/>
              <p:cNvCxnSpPr/>
              <p:nvPr/>
            </p:nvCxnSpPr>
            <p:spPr bwMode="auto">
              <a:xfrm>
                <a:off x="3939"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11" name="Line 359"/>
              <p:cNvCxnSpPr/>
              <p:nvPr/>
            </p:nvCxnSpPr>
            <p:spPr bwMode="auto">
              <a:xfrm>
                <a:off x="3963"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12" name="Line 360"/>
              <p:cNvCxnSpPr/>
              <p:nvPr/>
            </p:nvCxnSpPr>
            <p:spPr bwMode="auto">
              <a:xfrm>
                <a:off x="3986"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13" name="Line 361"/>
              <p:cNvCxnSpPr/>
              <p:nvPr/>
            </p:nvCxnSpPr>
            <p:spPr bwMode="auto">
              <a:xfrm>
                <a:off x="4016"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14" name="Line 362"/>
              <p:cNvCxnSpPr/>
              <p:nvPr/>
            </p:nvCxnSpPr>
            <p:spPr bwMode="auto">
              <a:xfrm>
                <a:off x="4063"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15" name="Line 363"/>
              <p:cNvCxnSpPr/>
              <p:nvPr/>
            </p:nvCxnSpPr>
            <p:spPr bwMode="auto">
              <a:xfrm>
                <a:off x="4092"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16" name="Line 364"/>
              <p:cNvCxnSpPr/>
              <p:nvPr/>
            </p:nvCxnSpPr>
            <p:spPr bwMode="auto">
              <a:xfrm>
                <a:off x="4116"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17" name="Line 365"/>
              <p:cNvCxnSpPr/>
              <p:nvPr/>
            </p:nvCxnSpPr>
            <p:spPr bwMode="auto">
              <a:xfrm>
                <a:off x="4139"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18" name="Line 366"/>
              <p:cNvCxnSpPr/>
              <p:nvPr/>
            </p:nvCxnSpPr>
            <p:spPr bwMode="auto">
              <a:xfrm>
                <a:off x="4192" y="2787"/>
                <a:ext cx="0" cy="1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19" name="Line 367"/>
              <p:cNvCxnSpPr/>
              <p:nvPr/>
            </p:nvCxnSpPr>
            <p:spPr bwMode="auto">
              <a:xfrm>
                <a:off x="989" y="2787"/>
                <a:ext cx="0" cy="5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sp>
            <p:nvSpPr>
              <p:cNvPr id="420" name="Rectangle 368"/>
              <p:cNvSpPr>
                <a:spLocks noChangeArrowheads="1"/>
              </p:cNvSpPr>
              <p:nvPr/>
            </p:nvSpPr>
            <p:spPr bwMode="auto">
              <a:xfrm>
                <a:off x="857" y="2843"/>
                <a:ext cx="189" cy="2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a:solidFill>
                      <a:srgbClr val="000000"/>
                    </a:solidFill>
                    <a:latin typeface="Arial"/>
                    <a:ea typeface="Calibri"/>
                  </a:rPr>
                  <a:t>350</a:t>
                </a:r>
                <a:endParaRPr lang="es-CL">
                  <a:latin typeface="Times New Roman"/>
                  <a:ea typeface="Calibri"/>
                </a:endParaRPr>
              </a:p>
            </p:txBody>
          </p:sp>
          <p:cxnSp>
            <p:nvCxnSpPr>
              <p:cNvPr id="421" name="Line 369"/>
              <p:cNvCxnSpPr/>
              <p:nvPr/>
            </p:nvCxnSpPr>
            <p:spPr bwMode="auto">
              <a:xfrm>
                <a:off x="1625" y="2787"/>
                <a:ext cx="0" cy="5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sp>
            <p:nvSpPr>
              <p:cNvPr id="422" name="Rectangle 370"/>
              <p:cNvSpPr>
                <a:spLocks noChangeArrowheads="1"/>
              </p:cNvSpPr>
              <p:nvPr/>
            </p:nvSpPr>
            <p:spPr bwMode="auto">
              <a:xfrm>
                <a:off x="1493" y="2843"/>
                <a:ext cx="189" cy="2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dirty="0">
                    <a:solidFill>
                      <a:srgbClr val="000000"/>
                    </a:solidFill>
                    <a:latin typeface="Arial"/>
                    <a:ea typeface="Calibri"/>
                  </a:rPr>
                  <a:t>400</a:t>
                </a:r>
                <a:endParaRPr lang="es-CL" dirty="0">
                  <a:latin typeface="Times New Roman"/>
                  <a:ea typeface="Calibri"/>
                </a:endParaRPr>
              </a:p>
            </p:txBody>
          </p:sp>
          <p:cxnSp>
            <p:nvCxnSpPr>
              <p:cNvPr id="423" name="Line 371"/>
              <p:cNvCxnSpPr/>
              <p:nvPr/>
            </p:nvCxnSpPr>
            <p:spPr bwMode="auto">
              <a:xfrm>
                <a:off x="2261" y="2787"/>
                <a:ext cx="0" cy="5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sp>
            <p:nvSpPr>
              <p:cNvPr id="424" name="Rectangle 372"/>
              <p:cNvSpPr>
                <a:spLocks noChangeArrowheads="1"/>
              </p:cNvSpPr>
              <p:nvPr/>
            </p:nvSpPr>
            <p:spPr bwMode="auto">
              <a:xfrm>
                <a:off x="2129" y="2843"/>
                <a:ext cx="189" cy="2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a:solidFill>
                      <a:srgbClr val="000000"/>
                    </a:solidFill>
                    <a:latin typeface="Arial"/>
                    <a:ea typeface="Calibri"/>
                  </a:rPr>
                  <a:t>450</a:t>
                </a:r>
                <a:endParaRPr lang="es-CL">
                  <a:latin typeface="Times New Roman"/>
                  <a:ea typeface="Calibri"/>
                </a:endParaRPr>
              </a:p>
            </p:txBody>
          </p:sp>
          <p:cxnSp>
            <p:nvCxnSpPr>
              <p:cNvPr id="425" name="Line 373"/>
              <p:cNvCxnSpPr/>
              <p:nvPr/>
            </p:nvCxnSpPr>
            <p:spPr bwMode="auto">
              <a:xfrm>
                <a:off x="2897" y="2787"/>
                <a:ext cx="0" cy="5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sp>
            <p:nvSpPr>
              <p:cNvPr id="426" name="Rectangle 374"/>
              <p:cNvSpPr>
                <a:spLocks noChangeArrowheads="1"/>
              </p:cNvSpPr>
              <p:nvPr/>
            </p:nvSpPr>
            <p:spPr bwMode="auto">
              <a:xfrm>
                <a:off x="2765" y="2843"/>
                <a:ext cx="189" cy="2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a:solidFill>
                      <a:srgbClr val="000000"/>
                    </a:solidFill>
                    <a:latin typeface="Arial"/>
                    <a:ea typeface="Calibri"/>
                  </a:rPr>
                  <a:t>500</a:t>
                </a:r>
                <a:endParaRPr lang="es-CL">
                  <a:latin typeface="Times New Roman"/>
                  <a:ea typeface="Calibri"/>
                </a:endParaRPr>
              </a:p>
            </p:txBody>
          </p:sp>
          <p:cxnSp>
            <p:nvCxnSpPr>
              <p:cNvPr id="427" name="Line 375"/>
              <p:cNvCxnSpPr/>
              <p:nvPr/>
            </p:nvCxnSpPr>
            <p:spPr bwMode="auto">
              <a:xfrm>
                <a:off x="3533" y="2787"/>
                <a:ext cx="0" cy="5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sp>
            <p:nvSpPr>
              <p:cNvPr id="428" name="Rectangle 376"/>
              <p:cNvSpPr>
                <a:spLocks noChangeArrowheads="1"/>
              </p:cNvSpPr>
              <p:nvPr/>
            </p:nvSpPr>
            <p:spPr bwMode="auto">
              <a:xfrm>
                <a:off x="3401" y="2843"/>
                <a:ext cx="189" cy="2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a:solidFill>
                      <a:srgbClr val="000000"/>
                    </a:solidFill>
                    <a:latin typeface="Arial"/>
                    <a:ea typeface="Calibri"/>
                  </a:rPr>
                  <a:t>550</a:t>
                </a:r>
                <a:endParaRPr lang="es-CL">
                  <a:latin typeface="Times New Roman"/>
                  <a:ea typeface="Calibri"/>
                </a:endParaRPr>
              </a:p>
            </p:txBody>
          </p:sp>
          <p:cxnSp>
            <p:nvCxnSpPr>
              <p:cNvPr id="429" name="Line 377"/>
              <p:cNvCxnSpPr/>
              <p:nvPr/>
            </p:nvCxnSpPr>
            <p:spPr bwMode="auto">
              <a:xfrm>
                <a:off x="4169" y="2787"/>
                <a:ext cx="0" cy="56"/>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sp>
            <p:nvSpPr>
              <p:cNvPr id="430" name="Rectangle 378"/>
              <p:cNvSpPr>
                <a:spLocks noChangeArrowheads="1"/>
              </p:cNvSpPr>
              <p:nvPr/>
            </p:nvSpPr>
            <p:spPr bwMode="auto">
              <a:xfrm>
                <a:off x="4037" y="2843"/>
                <a:ext cx="189" cy="2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a:solidFill>
                      <a:srgbClr val="000000"/>
                    </a:solidFill>
                    <a:latin typeface="Arial"/>
                    <a:ea typeface="Calibri"/>
                  </a:rPr>
                  <a:t>600</a:t>
                </a:r>
                <a:endParaRPr lang="es-CL">
                  <a:latin typeface="Times New Roman"/>
                  <a:ea typeface="Calibri"/>
                </a:endParaRPr>
              </a:p>
            </p:txBody>
          </p:sp>
          <p:sp>
            <p:nvSpPr>
              <p:cNvPr id="431" name="Rectangle 379"/>
              <p:cNvSpPr>
                <a:spLocks noChangeArrowheads="1"/>
              </p:cNvSpPr>
              <p:nvPr/>
            </p:nvSpPr>
            <p:spPr bwMode="auto">
              <a:xfrm>
                <a:off x="1776" y="2950"/>
                <a:ext cx="839" cy="2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a:solidFill>
                      <a:srgbClr val="000000"/>
                    </a:solidFill>
                    <a:latin typeface="Arial"/>
                    <a:ea typeface="Calibri"/>
                  </a:rPr>
                  <a:t>wavelength (nm)</a:t>
                </a:r>
                <a:endParaRPr lang="es-CL">
                  <a:latin typeface="Times New Roman"/>
                  <a:ea typeface="Calibri"/>
                </a:endParaRPr>
              </a:p>
            </p:txBody>
          </p:sp>
          <p:cxnSp>
            <p:nvCxnSpPr>
              <p:cNvPr id="432" name="Line 380"/>
              <p:cNvCxnSpPr/>
              <p:nvPr/>
            </p:nvCxnSpPr>
            <p:spPr bwMode="auto">
              <a:xfrm flipV="1">
                <a:off x="371" y="88"/>
                <a:ext cx="0" cy="2693"/>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33" name="Line 381"/>
              <p:cNvCxnSpPr/>
              <p:nvPr/>
            </p:nvCxnSpPr>
            <p:spPr bwMode="auto">
              <a:xfrm flipH="1">
                <a:off x="336" y="2736"/>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34" name="Line 382"/>
              <p:cNvCxnSpPr/>
              <p:nvPr/>
            </p:nvCxnSpPr>
            <p:spPr bwMode="auto">
              <a:xfrm flipH="1">
                <a:off x="336" y="2691"/>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35" name="Line 383"/>
              <p:cNvCxnSpPr/>
              <p:nvPr/>
            </p:nvCxnSpPr>
            <p:spPr bwMode="auto">
              <a:xfrm flipH="1">
                <a:off x="336" y="2646"/>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36" name="Line 384"/>
              <p:cNvCxnSpPr/>
              <p:nvPr/>
            </p:nvCxnSpPr>
            <p:spPr bwMode="auto">
              <a:xfrm flipH="1">
                <a:off x="336" y="2601"/>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37" name="Line 385"/>
              <p:cNvCxnSpPr/>
              <p:nvPr/>
            </p:nvCxnSpPr>
            <p:spPr bwMode="auto">
              <a:xfrm flipH="1">
                <a:off x="336" y="2505"/>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38" name="Line 386"/>
              <p:cNvCxnSpPr/>
              <p:nvPr/>
            </p:nvCxnSpPr>
            <p:spPr bwMode="auto">
              <a:xfrm flipH="1">
                <a:off x="336" y="2460"/>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39" name="Line 387"/>
              <p:cNvCxnSpPr/>
              <p:nvPr/>
            </p:nvCxnSpPr>
            <p:spPr bwMode="auto">
              <a:xfrm flipH="1">
                <a:off x="336" y="2415"/>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40" name="Line 388"/>
              <p:cNvCxnSpPr/>
              <p:nvPr/>
            </p:nvCxnSpPr>
            <p:spPr bwMode="auto">
              <a:xfrm flipH="1">
                <a:off x="336" y="2370"/>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41" name="Line 389"/>
              <p:cNvCxnSpPr/>
              <p:nvPr/>
            </p:nvCxnSpPr>
            <p:spPr bwMode="auto">
              <a:xfrm flipH="1">
                <a:off x="336" y="2274"/>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42" name="Line 390"/>
              <p:cNvCxnSpPr/>
              <p:nvPr/>
            </p:nvCxnSpPr>
            <p:spPr bwMode="auto">
              <a:xfrm flipH="1">
                <a:off x="336" y="2229"/>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43" name="Line 391"/>
              <p:cNvCxnSpPr/>
              <p:nvPr/>
            </p:nvCxnSpPr>
            <p:spPr bwMode="auto">
              <a:xfrm flipH="1">
                <a:off x="336" y="2184"/>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44" name="Line 392"/>
              <p:cNvCxnSpPr/>
              <p:nvPr/>
            </p:nvCxnSpPr>
            <p:spPr bwMode="auto">
              <a:xfrm flipH="1">
                <a:off x="336" y="2139"/>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45" name="Line 393"/>
              <p:cNvCxnSpPr/>
              <p:nvPr/>
            </p:nvCxnSpPr>
            <p:spPr bwMode="auto">
              <a:xfrm flipH="1">
                <a:off x="336" y="2043"/>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46" name="Line 394"/>
              <p:cNvCxnSpPr/>
              <p:nvPr/>
            </p:nvCxnSpPr>
            <p:spPr bwMode="auto">
              <a:xfrm flipH="1">
                <a:off x="336" y="1998"/>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47" name="Line 395"/>
              <p:cNvCxnSpPr/>
              <p:nvPr/>
            </p:nvCxnSpPr>
            <p:spPr bwMode="auto">
              <a:xfrm flipH="1">
                <a:off x="336" y="1953"/>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48" name="Line 396"/>
              <p:cNvCxnSpPr/>
              <p:nvPr/>
            </p:nvCxnSpPr>
            <p:spPr bwMode="auto">
              <a:xfrm flipH="1">
                <a:off x="336" y="1908"/>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49" name="Line 397"/>
              <p:cNvCxnSpPr/>
              <p:nvPr/>
            </p:nvCxnSpPr>
            <p:spPr bwMode="auto">
              <a:xfrm flipH="1">
                <a:off x="336" y="1812"/>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50" name="Line 398"/>
              <p:cNvCxnSpPr/>
              <p:nvPr/>
            </p:nvCxnSpPr>
            <p:spPr bwMode="auto">
              <a:xfrm flipH="1">
                <a:off x="336" y="1767"/>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51" name="Line 399"/>
              <p:cNvCxnSpPr/>
              <p:nvPr/>
            </p:nvCxnSpPr>
            <p:spPr bwMode="auto">
              <a:xfrm flipH="1">
                <a:off x="336" y="1722"/>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52" name="Line 400"/>
              <p:cNvCxnSpPr/>
              <p:nvPr/>
            </p:nvCxnSpPr>
            <p:spPr bwMode="auto">
              <a:xfrm flipH="1">
                <a:off x="336" y="1677"/>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53" name="Line 401"/>
              <p:cNvCxnSpPr/>
              <p:nvPr/>
            </p:nvCxnSpPr>
            <p:spPr bwMode="auto">
              <a:xfrm flipH="1">
                <a:off x="336" y="1581"/>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54" name="Line 402"/>
              <p:cNvCxnSpPr/>
              <p:nvPr/>
            </p:nvCxnSpPr>
            <p:spPr bwMode="auto">
              <a:xfrm flipH="1">
                <a:off x="336" y="1536"/>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55" name="Line 403"/>
              <p:cNvCxnSpPr/>
              <p:nvPr/>
            </p:nvCxnSpPr>
            <p:spPr bwMode="auto">
              <a:xfrm flipH="1">
                <a:off x="336" y="1491"/>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56" name="Line 404"/>
              <p:cNvCxnSpPr/>
              <p:nvPr/>
            </p:nvCxnSpPr>
            <p:spPr bwMode="auto">
              <a:xfrm flipH="1">
                <a:off x="336" y="1446"/>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57" name="Line 405"/>
              <p:cNvCxnSpPr/>
              <p:nvPr/>
            </p:nvCxnSpPr>
            <p:spPr bwMode="auto">
              <a:xfrm flipH="1">
                <a:off x="336" y="1350"/>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58" name="Line 406"/>
              <p:cNvCxnSpPr/>
              <p:nvPr/>
            </p:nvCxnSpPr>
            <p:spPr bwMode="auto">
              <a:xfrm flipH="1">
                <a:off x="336" y="1305"/>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59" name="Line 407"/>
              <p:cNvCxnSpPr/>
              <p:nvPr/>
            </p:nvCxnSpPr>
            <p:spPr bwMode="auto">
              <a:xfrm flipH="1">
                <a:off x="336" y="1260"/>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60" name="Line 408"/>
              <p:cNvCxnSpPr/>
              <p:nvPr/>
            </p:nvCxnSpPr>
            <p:spPr bwMode="auto">
              <a:xfrm flipH="1">
                <a:off x="336" y="1215"/>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461" name="Line 409"/>
              <p:cNvCxnSpPr/>
              <p:nvPr/>
            </p:nvCxnSpPr>
            <p:spPr bwMode="auto">
              <a:xfrm flipH="1">
                <a:off x="336" y="1119"/>
                <a:ext cx="35"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grpSp>
        <p:cxnSp>
          <p:nvCxnSpPr>
            <p:cNvPr id="210" name="Line 411"/>
            <p:cNvCxnSpPr/>
            <p:nvPr/>
          </p:nvCxnSpPr>
          <p:spPr bwMode="auto">
            <a:xfrm flipH="1">
              <a:off x="3630410" y="1287410"/>
              <a:ext cx="15133"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11" name="Line 412"/>
            <p:cNvCxnSpPr/>
            <p:nvPr/>
          </p:nvCxnSpPr>
          <p:spPr bwMode="auto">
            <a:xfrm flipH="1">
              <a:off x="3630410" y="1271553"/>
              <a:ext cx="15133"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12" name="Line 413"/>
            <p:cNvCxnSpPr/>
            <p:nvPr/>
          </p:nvCxnSpPr>
          <p:spPr bwMode="auto">
            <a:xfrm flipH="1">
              <a:off x="3630410" y="1255696"/>
              <a:ext cx="15133"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13" name="Line 414"/>
            <p:cNvCxnSpPr/>
            <p:nvPr/>
          </p:nvCxnSpPr>
          <p:spPr bwMode="auto">
            <a:xfrm flipH="1">
              <a:off x="3630410" y="1223981"/>
              <a:ext cx="15133"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14" name="Line 415"/>
            <p:cNvCxnSpPr/>
            <p:nvPr/>
          </p:nvCxnSpPr>
          <p:spPr bwMode="auto">
            <a:xfrm flipH="1">
              <a:off x="3630410" y="1206009"/>
              <a:ext cx="15133"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15" name="Line 416"/>
            <p:cNvCxnSpPr/>
            <p:nvPr/>
          </p:nvCxnSpPr>
          <p:spPr bwMode="auto">
            <a:xfrm flipH="1">
              <a:off x="3630410" y="1190152"/>
              <a:ext cx="15133"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16" name="Line 417"/>
            <p:cNvCxnSpPr/>
            <p:nvPr/>
          </p:nvCxnSpPr>
          <p:spPr bwMode="auto">
            <a:xfrm flipH="1">
              <a:off x="3630410" y="1174295"/>
              <a:ext cx="15133"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17" name="Line 418"/>
            <p:cNvCxnSpPr/>
            <p:nvPr/>
          </p:nvCxnSpPr>
          <p:spPr bwMode="auto">
            <a:xfrm flipH="1">
              <a:off x="3630410" y="1142580"/>
              <a:ext cx="15133"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18" name="Line 419"/>
            <p:cNvCxnSpPr/>
            <p:nvPr/>
          </p:nvCxnSpPr>
          <p:spPr bwMode="auto">
            <a:xfrm flipH="1">
              <a:off x="3630410" y="1124609"/>
              <a:ext cx="15133"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19" name="Line 420"/>
            <p:cNvCxnSpPr/>
            <p:nvPr/>
          </p:nvCxnSpPr>
          <p:spPr bwMode="auto">
            <a:xfrm flipH="1">
              <a:off x="3630410" y="1108752"/>
              <a:ext cx="15133"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20" name="Line 421"/>
            <p:cNvCxnSpPr/>
            <p:nvPr/>
          </p:nvCxnSpPr>
          <p:spPr bwMode="auto">
            <a:xfrm flipH="1">
              <a:off x="3630410" y="1092895"/>
              <a:ext cx="15133"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21" name="Line 422"/>
            <p:cNvCxnSpPr/>
            <p:nvPr/>
          </p:nvCxnSpPr>
          <p:spPr bwMode="auto">
            <a:xfrm flipH="1">
              <a:off x="3630410" y="1061180"/>
              <a:ext cx="15133"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22" name="Line 423"/>
            <p:cNvCxnSpPr/>
            <p:nvPr/>
          </p:nvCxnSpPr>
          <p:spPr bwMode="auto">
            <a:xfrm flipH="1">
              <a:off x="3630410" y="1043208"/>
              <a:ext cx="15133"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23" name="Line 424"/>
            <p:cNvCxnSpPr/>
            <p:nvPr/>
          </p:nvCxnSpPr>
          <p:spPr bwMode="auto">
            <a:xfrm flipH="1">
              <a:off x="3630410" y="1027351"/>
              <a:ext cx="15133"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24" name="Line 425"/>
            <p:cNvCxnSpPr/>
            <p:nvPr/>
          </p:nvCxnSpPr>
          <p:spPr bwMode="auto">
            <a:xfrm flipH="1">
              <a:off x="3630410" y="1011494"/>
              <a:ext cx="15133"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25" name="Line 426"/>
            <p:cNvCxnSpPr/>
            <p:nvPr/>
          </p:nvCxnSpPr>
          <p:spPr bwMode="auto">
            <a:xfrm flipH="1">
              <a:off x="3630410" y="979780"/>
              <a:ext cx="15133"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26" name="Line 427"/>
            <p:cNvCxnSpPr/>
            <p:nvPr/>
          </p:nvCxnSpPr>
          <p:spPr bwMode="auto">
            <a:xfrm flipH="1">
              <a:off x="3630410" y="961808"/>
              <a:ext cx="15133"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27" name="Line 428"/>
            <p:cNvCxnSpPr/>
            <p:nvPr/>
          </p:nvCxnSpPr>
          <p:spPr bwMode="auto">
            <a:xfrm flipH="1">
              <a:off x="3630410" y="945951"/>
              <a:ext cx="15133"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cxnSp>
          <p:nvCxnSpPr>
            <p:cNvPr id="228" name="Line 429"/>
            <p:cNvCxnSpPr/>
            <p:nvPr/>
          </p:nvCxnSpPr>
          <p:spPr bwMode="auto">
            <a:xfrm flipH="1">
              <a:off x="3620034" y="1888928"/>
              <a:ext cx="25509"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sp>
          <p:nvSpPr>
            <p:cNvPr id="229" name="Rectangle 430"/>
            <p:cNvSpPr>
              <a:spLocks noChangeArrowheads="1"/>
            </p:cNvSpPr>
            <p:nvPr/>
          </p:nvSpPr>
          <p:spPr bwMode="auto">
            <a:xfrm>
              <a:off x="3571208" y="1870956"/>
              <a:ext cx="27176" cy="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a:solidFill>
                    <a:srgbClr val="000000"/>
                  </a:solidFill>
                  <a:latin typeface="Arial"/>
                  <a:ea typeface="Calibri"/>
                </a:rPr>
                <a:t>0</a:t>
              </a:r>
              <a:endParaRPr lang="es-CL">
                <a:latin typeface="Times New Roman"/>
                <a:ea typeface="Calibri"/>
              </a:endParaRPr>
            </a:p>
          </p:txBody>
        </p:sp>
        <p:cxnSp>
          <p:nvCxnSpPr>
            <p:cNvPr id="230" name="Line 431"/>
            <p:cNvCxnSpPr/>
            <p:nvPr/>
          </p:nvCxnSpPr>
          <p:spPr bwMode="auto">
            <a:xfrm flipH="1">
              <a:off x="3620034" y="1809641"/>
              <a:ext cx="25509"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sp>
          <p:nvSpPr>
            <p:cNvPr id="231" name="Rectangle 432"/>
            <p:cNvSpPr>
              <a:spLocks noChangeArrowheads="1"/>
            </p:cNvSpPr>
            <p:nvPr/>
          </p:nvSpPr>
          <p:spPr bwMode="auto">
            <a:xfrm>
              <a:off x="3542705" y="1791670"/>
              <a:ext cx="54352" cy="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a:solidFill>
                    <a:srgbClr val="000000"/>
                  </a:solidFill>
                  <a:latin typeface="Arial"/>
                  <a:ea typeface="Calibri"/>
                </a:rPr>
                <a:t>10</a:t>
              </a:r>
              <a:endParaRPr lang="es-CL">
                <a:latin typeface="Times New Roman"/>
                <a:ea typeface="Calibri"/>
              </a:endParaRPr>
            </a:p>
          </p:txBody>
        </p:sp>
        <p:cxnSp>
          <p:nvCxnSpPr>
            <p:cNvPr id="232" name="Line 433"/>
            <p:cNvCxnSpPr/>
            <p:nvPr/>
          </p:nvCxnSpPr>
          <p:spPr bwMode="auto">
            <a:xfrm flipH="1">
              <a:off x="3620034" y="1728241"/>
              <a:ext cx="25509"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sp>
          <p:nvSpPr>
            <p:cNvPr id="233" name="Rectangle 434"/>
            <p:cNvSpPr>
              <a:spLocks noChangeArrowheads="1"/>
            </p:cNvSpPr>
            <p:nvPr/>
          </p:nvSpPr>
          <p:spPr bwMode="auto">
            <a:xfrm>
              <a:off x="3542705" y="1710269"/>
              <a:ext cx="54352" cy="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a:solidFill>
                    <a:srgbClr val="000000"/>
                  </a:solidFill>
                  <a:latin typeface="Arial"/>
                  <a:ea typeface="Calibri"/>
                </a:rPr>
                <a:t>20</a:t>
              </a:r>
              <a:endParaRPr lang="es-CL">
                <a:latin typeface="Times New Roman"/>
                <a:ea typeface="Calibri"/>
              </a:endParaRPr>
            </a:p>
          </p:txBody>
        </p:sp>
        <p:cxnSp>
          <p:nvCxnSpPr>
            <p:cNvPr id="234" name="Line 435"/>
            <p:cNvCxnSpPr/>
            <p:nvPr/>
          </p:nvCxnSpPr>
          <p:spPr bwMode="auto">
            <a:xfrm flipH="1">
              <a:off x="3620034" y="1646840"/>
              <a:ext cx="25509"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sp>
          <p:nvSpPr>
            <p:cNvPr id="235" name="Rectangle 436"/>
            <p:cNvSpPr>
              <a:spLocks noChangeArrowheads="1"/>
            </p:cNvSpPr>
            <p:nvPr/>
          </p:nvSpPr>
          <p:spPr bwMode="auto">
            <a:xfrm>
              <a:off x="3542705" y="1628869"/>
              <a:ext cx="54352" cy="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a:solidFill>
                    <a:srgbClr val="000000"/>
                  </a:solidFill>
                  <a:latin typeface="Arial"/>
                  <a:ea typeface="Calibri"/>
                </a:rPr>
                <a:t>30</a:t>
              </a:r>
              <a:endParaRPr lang="es-CL">
                <a:latin typeface="Times New Roman"/>
                <a:ea typeface="Calibri"/>
              </a:endParaRPr>
            </a:p>
          </p:txBody>
        </p:sp>
        <p:cxnSp>
          <p:nvCxnSpPr>
            <p:cNvPr id="236" name="Line 437"/>
            <p:cNvCxnSpPr/>
            <p:nvPr/>
          </p:nvCxnSpPr>
          <p:spPr bwMode="auto">
            <a:xfrm flipH="1">
              <a:off x="3620034" y="1565440"/>
              <a:ext cx="25509"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sp>
          <p:nvSpPr>
            <p:cNvPr id="237" name="Rectangle 438"/>
            <p:cNvSpPr>
              <a:spLocks noChangeArrowheads="1"/>
            </p:cNvSpPr>
            <p:nvPr/>
          </p:nvSpPr>
          <p:spPr bwMode="auto">
            <a:xfrm>
              <a:off x="3542705" y="1547469"/>
              <a:ext cx="54352" cy="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a:solidFill>
                    <a:srgbClr val="000000"/>
                  </a:solidFill>
                  <a:latin typeface="Arial"/>
                  <a:ea typeface="Calibri"/>
                </a:rPr>
                <a:t>40</a:t>
              </a:r>
              <a:endParaRPr lang="es-CL">
                <a:latin typeface="Times New Roman"/>
                <a:ea typeface="Calibri"/>
              </a:endParaRPr>
            </a:p>
          </p:txBody>
        </p:sp>
        <p:cxnSp>
          <p:nvCxnSpPr>
            <p:cNvPr id="238" name="Line 439"/>
            <p:cNvCxnSpPr/>
            <p:nvPr/>
          </p:nvCxnSpPr>
          <p:spPr bwMode="auto">
            <a:xfrm flipH="1">
              <a:off x="3620034" y="1484040"/>
              <a:ext cx="25509"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sp>
          <p:nvSpPr>
            <p:cNvPr id="239" name="Rectangle 440"/>
            <p:cNvSpPr>
              <a:spLocks noChangeArrowheads="1"/>
            </p:cNvSpPr>
            <p:nvPr/>
          </p:nvSpPr>
          <p:spPr bwMode="auto">
            <a:xfrm>
              <a:off x="3542705" y="1466068"/>
              <a:ext cx="54352" cy="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a:solidFill>
                    <a:srgbClr val="000000"/>
                  </a:solidFill>
                  <a:latin typeface="Arial"/>
                  <a:ea typeface="Calibri"/>
                </a:rPr>
                <a:t>50</a:t>
              </a:r>
              <a:endParaRPr lang="es-CL">
                <a:latin typeface="Times New Roman"/>
                <a:ea typeface="Calibri"/>
              </a:endParaRPr>
            </a:p>
          </p:txBody>
        </p:sp>
        <p:cxnSp>
          <p:nvCxnSpPr>
            <p:cNvPr id="240" name="Line 441"/>
            <p:cNvCxnSpPr/>
            <p:nvPr/>
          </p:nvCxnSpPr>
          <p:spPr bwMode="auto">
            <a:xfrm flipH="1">
              <a:off x="3620034" y="1402639"/>
              <a:ext cx="25509"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sp>
          <p:nvSpPr>
            <p:cNvPr id="241" name="Rectangle 442"/>
            <p:cNvSpPr>
              <a:spLocks noChangeArrowheads="1"/>
            </p:cNvSpPr>
            <p:nvPr/>
          </p:nvSpPr>
          <p:spPr bwMode="auto">
            <a:xfrm>
              <a:off x="3542705" y="1384668"/>
              <a:ext cx="54352" cy="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a:solidFill>
                    <a:srgbClr val="000000"/>
                  </a:solidFill>
                  <a:latin typeface="Arial"/>
                  <a:ea typeface="Calibri"/>
                </a:rPr>
                <a:t>60</a:t>
              </a:r>
              <a:endParaRPr lang="es-CL">
                <a:latin typeface="Times New Roman"/>
                <a:ea typeface="Calibri"/>
              </a:endParaRPr>
            </a:p>
          </p:txBody>
        </p:sp>
        <p:cxnSp>
          <p:nvCxnSpPr>
            <p:cNvPr id="242" name="Line 443"/>
            <p:cNvCxnSpPr/>
            <p:nvPr/>
          </p:nvCxnSpPr>
          <p:spPr bwMode="auto">
            <a:xfrm flipH="1">
              <a:off x="3620034" y="1321239"/>
              <a:ext cx="25509"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sp>
          <p:nvSpPr>
            <p:cNvPr id="243" name="Rectangle 444"/>
            <p:cNvSpPr>
              <a:spLocks noChangeArrowheads="1"/>
            </p:cNvSpPr>
            <p:nvPr/>
          </p:nvSpPr>
          <p:spPr bwMode="auto">
            <a:xfrm>
              <a:off x="3542705" y="1303267"/>
              <a:ext cx="54352" cy="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a:solidFill>
                    <a:srgbClr val="000000"/>
                  </a:solidFill>
                  <a:latin typeface="Arial"/>
                  <a:ea typeface="Calibri"/>
                </a:rPr>
                <a:t>70</a:t>
              </a:r>
              <a:endParaRPr lang="es-CL">
                <a:latin typeface="Times New Roman"/>
                <a:ea typeface="Calibri"/>
              </a:endParaRPr>
            </a:p>
          </p:txBody>
        </p:sp>
        <p:cxnSp>
          <p:nvCxnSpPr>
            <p:cNvPr id="244" name="Line 445"/>
            <p:cNvCxnSpPr/>
            <p:nvPr/>
          </p:nvCxnSpPr>
          <p:spPr bwMode="auto">
            <a:xfrm flipH="1">
              <a:off x="3620034" y="1239838"/>
              <a:ext cx="25509"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sp>
          <p:nvSpPr>
            <p:cNvPr id="245" name="Rectangle 446"/>
            <p:cNvSpPr>
              <a:spLocks noChangeArrowheads="1"/>
            </p:cNvSpPr>
            <p:nvPr/>
          </p:nvSpPr>
          <p:spPr bwMode="auto">
            <a:xfrm>
              <a:off x="3542705" y="1221867"/>
              <a:ext cx="54352" cy="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a:solidFill>
                    <a:srgbClr val="000000"/>
                  </a:solidFill>
                  <a:latin typeface="Arial"/>
                  <a:ea typeface="Calibri"/>
                </a:rPr>
                <a:t>80</a:t>
              </a:r>
              <a:endParaRPr lang="es-CL">
                <a:latin typeface="Times New Roman"/>
                <a:ea typeface="Calibri"/>
              </a:endParaRPr>
            </a:p>
          </p:txBody>
        </p:sp>
        <p:cxnSp>
          <p:nvCxnSpPr>
            <p:cNvPr id="246" name="Line 447"/>
            <p:cNvCxnSpPr/>
            <p:nvPr/>
          </p:nvCxnSpPr>
          <p:spPr bwMode="auto">
            <a:xfrm flipH="1">
              <a:off x="3620034" y="1158438"/>
              <a:ext cx="25509"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sp>
          <p:nvSpPr>
            <p:cNvPr id="247" name="Rectangle 448"/>
            <p:cNvSpPr>
              <a:spLocks noChangeArrowheads="1"/>
            </p:cNvSpPr>
            <p:nvPr/>
          </p:nvSpPr>
          <p:spPr bwMode="auto">
            <a:xfrm>
              <a:off x="3542705" y="1140466"/>
              <a:ext cx="54352" cy="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a:solidFill>
                    <a:srgbClr val="000000"/>
                  </a:solidFill>
                  <a:latin typeface="Arial"/>
                  <a:ea typeface="Calibri"/>
                </a:rPr>
                <a:t>90</a:t>
              </a:r>
              <a:endParaRPr lang="es-CL">
                <a:latin typeface="Times New Roman"/>
                <a:ea typeface="Calibri"/>
              </a:endParaRPr>
            </a:p>
          </p:txBody>
        </p:sp>
        <p:cxnSp>
          <p:nvCxnSpPr>
            <p:cNvPr id="248" name="Line 449"/>
            <p:cNvCxnSpPr/>
            <p:nvPr/>
          </p:nvCxnSpPr>
          <p:spPr bwMode="auto">
            <a:xfrm flipH="1">
              <a:off x="3620034" y="1077037"/>
              <a:ext cx="25509"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sp>
          <p:nvSpPr>
            <p:cNvPr id="249" name="Rectangle 450"/>
            <p:cNvSpPr>
              <a:spLocks noChangeArrowheads="1"/>
            </p:cNvSpPr>
            <p:nvPr/>
          </p:nvSpPr>
          <p:spPr bwMode="auto">
            <a:xfrm>
              <a:off x="3514199" y="1059066"/>
              <a:ext cx="81528" cy="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a:solidFill>
                    <a:srgbClr val="000000"/>
                  </a:solidFill>
                  <a:latin typeface="Arial"/>
                  <a:ea typeface="Calibri"/>
                </a:rPr>
                <a:t>100</a:t>
              </a:r>
              <a:endParaRPr lang="es-CL">
                <a:latin typeface="Times New Roman"/>
                <a:ea typeface="Calibri"/>
              </a:endParaRPr>
            </a:p>
          </p:txBody>
        </p:sp>
        <p:cxnSp>
          <p:nvCxnSpPr>
            <p:cNvPr id="250" name="Line 451"/>
            <p:cNvCxnSpPr/>
            <p:nvPr/>
          </p:nvCxnSpPr>
          <p:spPr bwMode="auto">
            <a:xfrm flipH="1">
              <a:off x="3620034" y="995637"/>
              <a:ext cx="25509" cy="0"/>
            </a:xfrm>
            <a:prstGeom prst="line">
              <a:avLst/>
            </a:prstGeom>
            <a:noFill/>
            <a:ln w="0">
              <a:solidFill>
                <a:srgbClr val="000000"/>
              </a:solidFill>
              <a:prstDash val="solid"/>
              <a:round/>
              <a:headEnd/>
              <a:tailEnd/>
            </a:ln>
            <a:extLst>
              <a:ext uri="{909E8E84-426E-40DD-AFC4-6F175D3DCCD1}">
                <a14:hiddenFill xmlns:a14="http://schemas.microsoft.com/office/drawing/2010/main">
                  <a:noFill/>
                </a14:hiddenFill>
              </a:ext>
            </a:extLst>
          </p:spPr>
        </p:cxnSp>
        <p:sp>
          <p:nvSpPr>
            <p:cNvPr id="251" name="Rectangle 452"/>
            <p:cNvSpPr>
              <a:spLocks noChangeArrowheads="1"/>
            </p:cNvSpPr>
            <p:nvPr/>
          </p:nvSpPr>
          <p:spPr bwMode="auto">
            <a:xfrm>
              <a:off x="3514199" y="977665"/>
              <a:ext cx="81528" cy="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a:solidFill>
                    <a:srgbClr val="000000"/>
                  </a:solidFill>
                  <a:latin typeface="Arial"/>
                  <a:ea typeface="Calibri"/>
                </a:rPr>
                <a:t>110</a:t>
              </a:r>
              <a:endParaRPr lang="es-CL">
                <a:latin typeface="Times New Roman"/>
                <a:ea typeface="Calibri"/>
              </a:endParaRPr>
            </a:p>
          </p:txBody>
        </p:sp>
        <p:sp>
          <p:nvSpPr>
            <p:cNvPr id="252" name="Rectangle 453"/>
            <p:cNvSpPr>
              <a:spLocks noChangeArrowheads="1"/>
            </p:cNvSpPr>
            <p:nvPr/>
          </p:nvSpPr>
          <p:spPr bwMode="auto">
            <a:xfrm rot="16200000">
              <a:off x="3274278" y="1264413"/>
              <a:ext cx="430438" cy="777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dirty="0">
                  <a:solidFill>
                    <a:srgbClr val="000000"/>
                  </a:solidFill>
                  <a:latin typeface="Arial"/>
                  <a:ea typeface="Calibri"/>
                </a:rPr>
                <a:t>Relative Absorbance</a:t>
              </a:r>
              <a:endParaRPr lang="es-CL" dirty="0">
                <a:latin typeface="Times New Roman"/>
                <a:ea typeface="Calibri"/>
              </a:endParaRPr>
            </a:p>
          </p:txBody>
        </p:sp>
        <p:sp>
          <p:nvSpPr>
            <p:cNvPr id="253" name="Freeform 454"/>
            <p:cNvSpPr>
              <a:spLocks/>
            </p:cNvSpPr>
            <p:nvPr/>
          </p:nvSpPr>
          <p:spPr bwMode="auto">
            <a:xfrm>
              <a:off x="3645543" y="1029603"/>
              <a:ext cx="1759274" cy="853472"/>
            </a:xfrm>
            <a:custGeom>
              <a:avLst/>
              <a:gdLst>
                <a:gd name="T0" fmla="*/ 6 w 691"/>
                <a:gd name="T1" fmla="*/ 337 h 430"/>
                <a:gd name="T2" fmla="*/ 17 w 691"/>
                <a:gd name="T3" fmla="*/ 333 h 430"/>
                <a:gd name="T4" fmla="*/ 28 w 691"/>
                <a:gd name="T5" fmla="*/ 326 h 430"/>
                <a:gd name="T6" fmla="*/ 38 w 691"/>
                <a:gd name="T7" fmla="*/ 321 h 430"/>
                <a:gd name="T8" fmla="*/ 49 w 691"/>
                <a:gd name="T9" fmla="*/ 354 h 430"/>
                <a:gd name="T10" fmla="*/ 60 w 691"/>
                <a:gd name="T11" fmla="*/ 381 h 430"/>
                <a:gd name="T12" fmla="*/ 71 w 691"/>
                <a:gd name="T13" fmla="*/ 391 h 430"/>
                <a:gd name="T14" fmla="*/ 82 w 691"/>
                <a:gd name="T15" fmla="*/ 389 h 430"/>
                <a:gd name="T16" fmla="*/ 92 w 691"/>
                <a:gd name="T17" fmla="*/ 376 h 430"/>
                <a:gd name="T18" fmla="*/ 103 w 691"/>
                <a:gd name="T19" fmla="*/ 353 h 430"/>
                <a:gd name="T20" fmla="*/ 114 w 691"/>
                <a:gd name="T21" fmla="*/ 332 h 430"/>
                <a:gd name="T22" fmla="*/ 125 w 691"/>
                <a:gd name="T23" fmla="*/ 311 h 430"/>
                <a:gd name="T24" fmla="*/ 135 w 691"/>
                <a:gd name="T25" fmla="*/ 272 h 430"/>
                <a:gd name="T26" fmla="*/ 146 w 691"/>
                <a:gd name="T27" fmla="*/ 271 h 430"/>
                <a:gd name="T28" fmla="*/ 157 w 691"/>
                <a:gd name="T29" fmla="*/ 238 h 430"/>
                <a:gd name="T30" fmla="*/ 168 w 691"/>
                <a:gd name="T31" fmla="*/ 222 h 430"/>
                <a:gd name="T32" fmla="*/ 179 w 691"/>
                <a:gd name="T33" fmla="*/ 203 h 430"/>
                <a:gd name="T34" fmla="*/ 189 w 691"/>
                <a:gd name="T35" fmla="*/ 190 h 430"/>
                <a:gd name="T36" fmla="*/ 200 w 691"/>
                <a:gd name="T37" fmla="*/ 272 h 430"/>
                <a:gd name="T38" fmla="*/ 211 w 691"/>
                <a:gd name="T39" fmla="*/ 319 h 430"/>
                <a:gd name="T40" fmla="*/ 222 w 691"/>
                <a:gd name="T41" fmla="*/ 327 h 430"/>
                <a:gd name="T42" fmla="*/ 233 w 691"/>
                <a:gd name="T43" fmla="*/ 321 h 430"/>
                <a:gd name="T44" fmla="*/ 243 w 691"/>
                <a:gd name="T45" fmla="*/ 310 h 430"/>
                <a:gd name="T46" fmla="*/ 254 w 691"/>
                <a:gd name="T47" fmla="*/ 301 h 430"/>
                <a:gd name="T48" fmla="*/ 265 w 691"/>
                <a:gd name="T49" fmla="*/ 282 h 430"/>
                <a:gd name="T50" fmla="*/ 276 w 691"/>
                <a:gd name="T51" fmla="*/ 264 h 430"/>
                <a:gd name="T52" fmla="*/ 287 w 691"/>
                <a:gd name="T53" fmla="*/ 245 h 430"/>
                <a:gd name="T54" fmla="*/ 297 w 691"/>
                <a:gd name="T55" fmla="*/ 231 h 430"/>
                <a:gd name="T56" fmla="*/ 308 w 691"/>
                <a:gd name="T57" fmla="*/ 209 h 430"/>
                <a:gd name="T58" fmla="*/ 319 w 691"/>
                <a:gd name="T59" fmla="*/ 176 h 430"/>
                <a:gd name="T60" fmla="*/ 330 w 691"/>
                <a:gd name="T61" fmla="*/ 139 h 430"/>
                <a:gd name="T62" fmla="*/ 340 w 691"/>
                <a:gd name="T63" fmla="*/ 113 h 430"/>
                <a:gd name="T64" fmla="*/ 351 w 691"/>
                <a:gd name="T65" fmla="*/ 105 h 430"/>
                <a:gd name="T66" fmla="*/ 362 w 691"/>
                <a:gd name="T67" fmla="*/ 106 h 430"/>
                <a:gd name="T68" fmla="*/ 373 w 691"/>
                <a:gd name="T69" fmla="*/ 94 h 430"/>
                <a:gd name="T70" fmla="*/ 384 w 691"/>
                <a:gd name="T71" fmla="*/ 62 h 430"/>
                <a:gd name="T72" fmla="*/ 394 w 691"/>
                <a:gd name="T73" fmla="*/ 21 h 430"/>
                <a:gd name="T74" fmla="*/ 405 w 691"/>
                <a:gd name="T75" fmla="*/ 0 h 430"/>
                <a:gd name="T76" fmla="*/ 416 w 691"/>
                <a:gd name="T77" fmla="*/ 20 h 430"/>
                <a:gd name="T78" fmla="*/ 427 w 691"/>
                <a:gd name="T79" fmla="*/ 64 h 430"/>
                <a:gd name="T80" fmla="*/ 438 w 691"/>
                <a:gd name="T81" fmla="*/ 105 h 430"/>
                <a:gd name="T82" fmla="*/ 448 w 691"/>
                <a:gd name="T83" fmla="*/ 122 h 430"/>
                <a:gd name="T84" fmla="*/ 459 w 691"/>
                <a:gd name="T85" fmla="*/ 108 h 430"/>
                <a:gd name="T86" fmla="*/ 470 w 691"/>
                <a:gd name="T87" fmla="*/ 86 h 430"/>
                <a:gd name="T88" fmla="*/ 481 w 691"/>
                <a:gd name="T89" fmla="*/ 91 h 430"/>
                <a:gd name="T90" fmla="*/ 491 w 691"/>
                <a:gd name="T91" fmla="*/ 130 h 430"/>
                <a:gd name="T92" fmla="*/ 502 w 691"/>
                <a:gd name="T93" fmla="*/ 196 h 430"/>
                <a:gd name="T94" fmla="*/ 513 w 691"/>
                <a:gd name="T95" fmla="*/ 262 h 430"/>
                <a:gd name="T96" fmla="*/ 524 w 691"/>
                <a:gd name="T97" fmla="*/ 317 h 430"/>
                <a:gd name="T98" fmla="*/ 535 w 691"/>
                <a:gd name="T99" fmla="*/ 354 h 430"/>
                <a:gd name="T100" fmla="*/ 545 w 691"/>
                <a:gd name="T101" fmla="*/ 376 h 430"/>
                <a:gd name="T102" fmla="*/ 556 w 691"/>
                <a:gd name="T103" fmla="*/ 392 h 430"/>
                <a:gd name="T104" fmla="*/ 567 w 691"/>
                <a:gd name="T105" fmla="*/ 400 h 430"/>
                <a:gd name="T106" fmla="*/ 578 w 691"/>
                <a:gd name="T107" fmla="*/ 406 h 430"/>
                <a:gd name="T108" fmla="*/ 589 w 691"/>
                <a:gd name="T109" fmla="*/ 410 h 430"/>
                <a:gd name="T110" fmla="*/ 599 w 691"/>
                <a:gd name="T111" fmla="*/ 412 h 430"/>
                <a:gd name="T112" fmla="*/ 610 w 691"/>
                <a:gd name="T113" fmla="*/ 416 h 430"/>
                <a:gd name="T114" fmla="*/ 621 w 691"/>
                <a:gd name="T115" fmla="*/ 419 h 430"/>
                <a:gd name="T116" fmla="*/ 632 w 691"/>
                <a:gd name="T117" fmla="*/ 422 h 430"/>
                <a:gd name="T118" fmla="*/ 642 w 691"/>
                <a:gd name="T119" fmla="*/ 428 h 43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 ang="0">
                  <a:pos x="T68" y="T69"/>
                </a:cxn>
                <a:cxn ang="0">
                  <a:pos x="T70" y="T71"/>
                </a:cxn>
                <a:cxn ang="0">
                  <a:pos x="T72" y="T73"/>
                </a:cxn>
                <a:cxn ang="0">
                  <a:pos x="T74" y="T75"/>
                </a:cxn>
                <a:cxn ang="0">
                  <a:pos x="T76" y="T77"/>
                </a:cxn>
                <a:cxn ang="0">
                  <a:pos x="T78" y="T79"/>
                </a:cxn>
                <a:cxn ang="0">
                  <a:pos x="T80" y="T81"/>
                </a:cxn>
                <a:cxn ang="0">
                  <a:pos x="T82" y="T83"/>
                </a:cxn>
                <a:cxn ang="0">
                  <a:pos x="T84" y="T85"/>
                </a:cxn>
                <a:cxn ang="0">
                  <a:pos x="T86" y="T87"/>
                </a:cxn>
                <a:cxn ang="0">
                  <a:pos x="T88" y="T89"/>
                </a:cxn>
                <a:cxn ang="0">
                  <a:pos x="T90" y="T91"/>
                </a:cxn>
                <a:cxn ang="0">
                  <a:pos x="T92" y="T93"/>
                </a:cxn>
                <a:cxn ang="0">
                  <a:pos x="T94" y="T95"/>
                </a:cxn>
                <a:cxn ang="0">
                  <a:pos x="T96" y="T97"/>
                </a:cxn>
                <a:cxn ang="0">
                  <a:pos x="T98" y="T99"/>
                </a:cxn>
                <a:cxn ang="0">
                  <a:pos x="T100" y="T101"/>
                </a:cxn>
                <a:cxn ang="0">
                  <a:pos x="T102" y="T103"/>
                </a:cxn>
                <a:cxn ang="0">
                  <a:pos x="T104" y="T105"/>
                </a:cxn>
                <a:cxn ang="0">
                  <a:pos x="T106" y="T107"/>
                </a:cxn>
                <a:cxn ang="0">
                  <a:pos x="T108" y="T109"/>
                </a:cxn>
                <a:cxn ang="0">
                  <a:pos x="T110" y="T111"/>
                </a:cxn>
                <a:cxn ang="0">
                  <a:pos x="T112" y="T113"/>
                </a:cxn>
                <a:cxn ang="0">
                  <a:pos x="T114" y="T115"/>
                </a:cxn>
                <a:cxn ang="0">
                  <a:pos x="T116" y="T117"/>
                </a:cxn>
                <a:cxn ang="0">
                  <a:pos x="T118" y="T119"/>
                </a:cxn>
              </a:cxnLst>
              <a:rect l="0" t="0" r="r" b="b"/>
              <a:pathLst>
                <a:path w="691" h="430">
                  <a:moveTo>
                    <a:pt x="0" y="349"/>
                  </a:moveTo>
                  <a:lnTo>
                    <a:pt x="0" y="349"/>
                  </a:lnTo>
                  <a:lnTo>
                    <a:pt x="2" y="345"/>
                  </a:lnTo>
                  <a:lnTo>
                    <a:pt x="4" y="339"/>
                  </a:lnTo>
                  <a:lnTo>
                    <a:pt x="6" y="337"/>
                  </a:lnTo>
                  <a:lnTo>
                    <a:pt x="8" y="335"/>
                  </a:lnTo>
                  <a:lnTo>
                    <a:pt x="10" y="334"/>
                  </a:lnTo>
                  <a:lnTo>
                    <a:pt x="13" y="332"/>
                  </a:lnTo>
                  <a:lnTo>
                    <a:pt x="15" y="332"/>
                  </a:lnTo>
                  <a:lnTo>
                    <a:pt x="17" y="333"/>
                  </a:lnTo>
                  <a:lnTo>
                    <a:pt x="19" y="334"/>
                  </a:lnTo>
                  <a:lnTo>
                    <a:pt x="21" y="336"/>
                  </a:lnTo>
                  <a:lnTo>
                    <a:pt x="23" y="336"/>
                  </a:lnTo>
                  <a:lnTo>
                    <a:pt x="25" y="330"/>
                  </a:lnTo>
                  <a:lnTo>
                    <a:pt x="28" y="326"/>
                  </a:lnTo>
                  <a:lnTo>
                    <a:pt x="30" y="325"/>
                  </a:lnTo>
                  <a:lnTo>
                    <a:pt x="32" y="321"/>
                  </a:lnTo>
                  <a:lnTo>
                    <a:pt x="34" y="318"/>
                  </a:lnTo>
                  <a:lnTo>
                    <a:pt x="36" y="320"/>
                  </a:lnTo>
                  <a:lnTo>
                    <a:pt x="38" y="321"/>
                  </a:lnTo>
                  <a:lnTo>
                    <a:pt x="41" y="325"/>
                  </a:lnTo>
                  <a:lnTo>
                    <a:pt x="43" y="333"/>
                  </a:lnTo>
                  <a:lnTo>
                    <a:pt x="45" y="337"/>
                  </a:lnTo>
                  <a:lnTo>
                    <a:pt x="47" y="345"/>
                  </a:lnTo>
                  <a:lnTo>
                    <a:pt x="49" y="354"/>
                  </a:lnTo>
                  <a:lnTo>
                    <a:pt x="51" y="360"/>
                  </a:lnTo>
                  <a:lnTo>
                    <a:pt x="54" y="367"/>
                  </a:lnTo>
                  <a:lnTo>
                    <a:pt x="56" y="372"/>
                  </a:lnTo>
                  <a:lnTo>
                    <a:pt x="58" y="377"/>
                  </a:lnTo>
                  <a:lnTo>
                    <a:pt x="60" y="381"/>
                  </a:lnTo>
                  <a:lnTo>
                    <a:pt x="62" y="384"/>
                  </a:lnTo>
                  <a:lnTo>
                    <a:pt x="64" y="385"/>
                  </a:lnTo>
                  <a:lnTo>
                    <a:pt x="66" y="386"/>
                  </a:lnTo>
                  <a:lnTo>
                    <a:pt x="69" y="388"/>
                  </a:lnTo>
                  <a:lnTo>
                    <a:pt x="71" y="391"/>
                  </a:lnTo>
                  <a:lnTo>
                    <a:pt x="73" y="393"/>
                  </a:lnTo>
                  <a:lnTo>
                    <a:pt x="75" y="395"/>
                  </a:lnTo>
                  <a:lnTo>
                    <a:pt x="77" y="391"/>
                  </a:lnTo>
                  <a:lnTo>
                    <a:pt x="79" y="389"/>
                  </a:lnTo>
                  <a:lnTo>
                    <a:pt x="82" y="389"/>
                  </a:lnTo>
                  <a:lnTo>
                    <a:pt x="84" y="386"/>
                  </a:lnTo>
                  <a:lnTo>
                    <a:pt x="86" y="386"/>
                  </a:lnTo>
                  <a:lnTo>
                    <a:pt x="88" y="386"/>
                  </a:lnTo>
                  <a:lnTo>
                    <a:pt x="90" y="382"/>
                  </a:lnTo>
                  <a:lnTo>
                    <a:pt x="92" y="376"/>
                  </a:lnTo>
                  <a:lnTo>
                    <a:pt x="94" y="372"/>
                  </a:lnTo>
                  <a:lnTo>
                    <a:pt x="97" y="367"/>
                  </a:lnTo>
                  <a:lnTo>
                    <a:pt x="99" y="364"/>
                  </a:lnTo>
                  <a:lnTo>
                    <a:pt x="101" y="359"/>
                  </a:lnTo>
                  <a:lnTo>
                    <a:pt x="103" y="353"/>
                  </a:lnTo>
                  <a:lnTo>
                    <a:pt x="105" y="351"/>
                  </a:lnTo>
                  <a:lnTo>
                    <a:pt x="107" y="343"/>
                  </a:lnTo>
                  <a:lnTo>
                    <a:pt x="110" y="339"/>
                  </a:lnTo>
                  <a:lnTo>
                    <a:pt x="112" y="336"/>
                  </a:lnTo>
                  <a:lnTo>
                    <a:pt x="114" y="332"/>
                  </a:lnTo>
                  <a:lnTo>
                    <a:pt x="116" y="330"/>
                  </a:lnTo>
                  <a:lnTo>
                    <a:pt x="118" y="327"/>
                  </a:lnTo>
                  <a:lnTo>
                    <a:pt x="120" y="323"/>
                  </a:lnTo>
                  <a:lnTo>
                    <a:pt x="123" y="314"/>
                  </a:lnTo>
                  <a:lnTo>
                    <a:pt x="125" y="311"/>
                  </a:lnTo>
                  <a:lnTo>
                    <a:pt x="127" y="305"/>
                  </a:lnTo>
                  <a:lnTo>
                    <a:pt x="129" y="298"/>
                  </a:lnTo>
                  <a:lnTo>
                    <a:pt x="131" y="289"/>
                  </a:lnTo>
                  <a:lnTo>
                    <a:pt x="133" y="279"/>
                  </a:lnTo>
                  <a:lnTo>
                    <a:pt x="135" y="272"/>
                  </a:lnTo>
                  <a:lnTo>
                    <a:pt x="138" y="263"/>
                  </a:lnTo>
                  <a:lnTo>
                    <a:pt x="140" y="252"/>
                  </a:lnTo>
                  <a:lnTo>
                    <a:pt x="142" y="244"/>
                  </a:lnTo>
                  <a:lnTo>
                    <a:pt x="144" y="252"/>
                  </a:lnTo>
                  <a:lnTo>
                    <a:pt x="146" y="271"/>
                  </a:lnTo>
                  <a:lnTo>
                    <a:pt x="148" y="281"/>
                  </a:lnTo>
                  <a:lnTo>
                    <a:pt x="151" y="270"/>
                  </a:lnTo>
                  <a:lnTo>
                    <a:pt x="153" y="254"/>
                  </a:lnTo>
                  <a:lnTo>
                    <a:pt x="155" y="245"/>
                  </a:lnTo>
                  <a:lnTo>
                    <a:pt x="157" y="238"/>
                  </a:lnTo>
                  <a:lnTo>
                    <a:pt x="159" y="232"/>
                  </a:lnTo>
                  <a:lnTo>
                    <a:pt x="161" y="228"/>
                  </a:lnTo>
                  <a:lnTo>
                    <a:pt x="164" y="225"/>
                  </a:lnTo>
                  <a:lnTo>
                    <a:pt x="166" y="224"/>
                  </a:lnTo>
                  <a:lnTo>
                    <a:pt x="168" y="222"/>
                  </a:lnTo>
                  <a:lnTo>
                    <a:pt x="170" y="220"/>
                  </a:lnTo>
                  <a:lnTo>
                    <a:pt x="172" y="217"/>
                  </a:lnTo>
                  <a:lnTo>
                    <a:pt x="174" y="213"/>
                  </a:lnTo>
                  <a:lnTo>
                    <a:pt x="176" y="209"/>
                  </a:lnTo>
                  <a:lnTo>
                    <a:pt x="179" y="203"/>
                  </a:lnTo>
                  <a:lnTo>
                    <a:pt x="181" y="195"/>
                  </a:lnTo>
                  <a:lnTo>
                    <a:pt x="183" y="187"/>
                  </a:lnTo>
                  <a:lnTo>
                    <a:pt x="185" y="180"/>
                  </a:lnTo>
                  <a:lnTo>
                    <a:pt x="187" y="178"/>
                  </a:lnTo>
                  <a:lnTo>
                    <a:pt x="189" y="190"/>
                  </a:lnTo>
                  <a:lnTo>
                    <a:pt x="192" y="205"/>
                  </a:lnTo>
                  <a:lnTo>
                    <a:pt x="194" y="225"/>
                  </a:lnTo>
                  <a:lnTo>
                    <a:pt x="196" y="241"/>
                  </a:lnTo>
                  <a:lnTo>
                    <a:pt x="198" y="259"/>
                  </a:lnTo>
                  <a:lnTo>
                    <a:pt x="200" y="272"/>
                  </a:lnTo>
                  <a:lnTo>
                    <a:pt x="202" y="286"/>
                  </a:lnTo>
                  <a:lnTo>
                    <a:pt x="205" y="295"/>
                  </a:lnTo>
                  <a:lnTo>
                    <a:pt x="207" y="307"/>
                  </a:lnTo>
                  <a:lnTo>
                    <a:pt x="209" y="313"/>
                  </a:lnTo>
                  <a:lnTo>
                    <a:pt x="211" y="319"/>
                  </a:lnTo>
                  <a:lnTo>
                    <a:pt x="213" y="320"/>
                  </a:lnTo>
                  <a:lnTo>
                    <a:pt x="215" y="326"/>
                  </a:lnTo>
                  <a:lnTo>
                    <a:pt x="217" y="327"/>
                  </a:lnTo>
                  <a:lnTo>
                    <a:pt x="220" y="326"/>
                  </a:lnTo>
                  <a:lnTo>
                    <a:pt x="222" y="327"/>
                  </a:lnTo>
                  <a:lnTo>
                    <a:pt x="224" y="325"/>
                  </a:lnTo>
                  <a:lnTo>
                    <a:pt x="226" y="324"/>
                  </a:lnTo>
                  <a:lnTo>
                    <a:pt x="228" y="323"/>
                  </a:lnTo>
                  <a:lnTo>
                    <a:pt x="230" y="322"/>
                  </a:lnTo>
                  <a:lnTo>
                    <a:pt x="233" y="321"/>
                  </a:lnTo>
                  <a:lnTo>
                    <a:pt x="235" y="320"/>
                  </a:lnTo>
                  <a:lnTo>
                    <a:pt x="237" y="318"/>
                  </a:lnTo>
                  <a:lnTo>
                    <a:pt x="239" y="315"/>
                  </a:lnTo>
                  <a:lnTo>
                    <a:pt x="241" y="313"/>
                  </a:lnTo>
                  <a:lnTo>
                    <a:pt x="243" y="310"/>
                  </a:lnTo>
                  <a:lnTo>
                    <a:pt x="246" y="308"/>
                  </a:lnTo>
                  <a:lnTo>
                    <a:pt x="248" y="308"/>
                  </a:lnTo>
                  <a:lnTo>
                    <a:pt x="250" y="304"/>
                  </a:lnTo>
                  <a:lnTo>
                    <a:pt x="252" y="302"/>
                  </a:lnTo>
                  <a:lnTo>
                    <a:pt x="254" y="301"/>
                  </a:lnTo>
                  <a:lnTo>
                    <a:pt x="256" y="297"/>
                  </a:lnTo>
                  <a:lnTo>
                    <a:pt x="258" y="296"/>
                  </a:lnTo>
                  <a:lnTo>
                    <a:pt x="261" y="291"/>
                  </a:lnTo>
                  <a:lnTo>
                    <a:pt x="263" y="287"/>
                  </a:lnTo>
                  <a:lnTo>
                    <a:pt x="265" y="282"/>
                  </a:lnTo>
                  <a:lnTo>
                    <a:pt x="267" y="279"/>
                  </a:lnTo>
                  <a:lnTo>
                    <a:pt x="269" y="276"/>
                  </a:lnTo>
                  <a:lnTo>
                    <a:pt x="271" y="271"/>
                  </a:lnTo>
                  <a:lnTo>
                    <a:pt x="274" y="267"/>
                  </a:lnTo>
                  <a:lnTo>
                    <a:pt x="276" y="264"/>
                  </a:lnTo>
                  <a:lnTo>
                    <a:pt x="278" y="259"/>
                  </a:lnTo>
                  <a:lnTo>
                    <a:pt x="280" y="256"/>
                  </a:lnTo>
                  <a:lnTo>
                    <a:pt x="282" y="252"/>
                  </a:lnTo>
                  <a:lnTo>
                    <a:pt x="284" y="249"/>
                  </a:lnTo>
                  <a:lnTo>
                    <a:pt x="287" y="245"/>
                  </a:lnTo>
                  <a:lnTo>
                    <a:pt x="289" y="242"/>
                  </a:lnTo>
                  <a:lnTo>
                    <a:pt x="291" y="241"/>
                  </a:lnTo>
                  <a:lnTo>
                    <a:pt x="293" y="237"/>
                  </a:lnTo>
                  <a:lnTo>
                    <a:pt x="295" y="234"/>
                  </a:lnTo>
                  <a:lnTo>
                    <a:pt x="297" y="231"/>
                  </a:lnTo>
                  <a:lnTo>
                    <a:pt x="299" y="227"/>
                  </a:lnTo>
                  <a:lnTo>
                    <a:pt x="302" y="223"/>
                  </a:lnTo>
                  <a:lnTo>
                    <a:pt x="304" y="217"/>
                  </a:lnTo>
                  <a:lnTo>
                    <a:pt x="306" y="213"/>
                  </a:lnTo>
                  <a:lnTo>
                    <a:pt x="308" y="209"/>
                  </a:lnTo>
                  <a:lnTo>
                    <a:pt x="310" y="205"/>
                  </a:lnTo>
                  <a:lnTo>
                    <a:pt x="312" y="198"/>
                  </a:lnTo>
                  <a:lnTo>
                    <a:pt x="315" y="192"/>
                  </a:lnTo>
                  <a:lnTo>
                    <a:pt x="317" y="185"/>
                  </a:lnTo>
                  <a:lnTo>
                    <a:pt x="319" y="176"/>
                  </a:lnTo>
                  <a:lnTo>
                    <a:pt x="321" y="170"/>
                  </a:lnTo>
                  <a:lnTo>
                    <a:pt x="323" y="163"/>
                  </a:lnTo>
                  <a:lnTo>
                    <a:pt x="325" y="154"/>
                  </a:lnTo>
                  <a:lnTo>
                    <a:pt x="328" y="147"/>
                  </a:lnTo>
                  <a:lnTo>
                    <a:pt x="330" y="139"/>
                  </a:lnTo>
                  <a:lnTo>
                    <a:pt x="332" y="133"/>
                  </a:lnTo>
                  <a:lnTo>
                    <a:pt x="334" y="127"/>
                  </a:lnTo>
                  <a:lnTo>
                    <a:pt x="336" y="122"/>
                  </a:lnTo>
                  <a:lnTo>
                    <a:pt x="338" y="116"/>
                  </a:lnTo>
                  <a:lnTo>
                    <a:pt x="340" y="113"/>
                  </a:lnTo>
                  <a:lnTo>
                    <a:pt x="343" y="110"/>
                  </a:lnTo>
                  <a:lnTo>
                    <a:pt x="345" y="109"/>
                  </a:lnTo>
                  <a:lnTo>
                    <a:pt x="347" y="107"/>
                  </a:lnTo>
                  <a:lnTo>
                    <a:pt x="349" y="105"/>
                  </a:lnTo>
                  <a:lnTo>
                    <a:pt x="351" y="105"/>
                  </a:lnTo>
                  <a:lnTo>
                    <a:pt x="353" y="105"/>
                  </a:lnTo>
                  <a:lnTo>
                    <a:pt x="356" y="106"/>
                  </a:lnTo>
                  <a:lnTo>
                    <a:pt x="358" y="106"/>
                  </a:lnTo>
                  <a:lnTo>
                    <a:pt x="360" y="105"/>
                  </a:lnTo>
                  <a:lnTo>
                    <a:pt x="362" y="106"/>
                  </a:lnTo>
                  <a:lnTo>
                    <a:pt x="364" y="105"/>
                  </a:lnTo>
                  <a:lnTo>
                    <a:pt x="366" y="104"/>
                  </a:lnTo>
                  <a:lnTo>
                    <a:pt x="368" y="102"/>
                  </a:lnTo>
                  <a:lnTo>
                    <a:pt x="371" y="100"/>
                  </a:lnTo>
                  <a:lnTo>
                    <a:pt x="373" y="94"/>
                  </a:lnTo>
                  <a:lnTo>
                    <a:pt x="375" y="89"/>
                  </a:lnTo>
                  <a:lnTo>
                    <a:pt x="377" y="85"/>
                  </a:lnTo>
                  <a:lnTo>
                    <a:pt x="379" y="78"/>
                  </a:lnTo>
                  <a:lnTo>
                    <a:pt x="381" y="70"/>
                  </a:lnTo>
                  <a:lnTo>
                    <a:pt x="384" y="62"/>
                  </a:lnTo>
                  <a:lnTo>
                    <a:pt x="386" y="55"/>
                  </a:lnTo>
                  <a:lnTo>
                    <a:pt x="388" y="45"/>
                  </a:lnTo>
                  <a:lnTo>
                    <a:pt x="390" y="36"/>
                  </a:lnTo>
                  <a:lnTo>
                    <a:pt x="392" y="28"/>
                  </a:lnTo>
                  <a:lnTo>
                    <a:pt x="394" y="21"/>
                  </a:lnTo>
                  <a:lnTo>
                    <a:pt x="397" y="12"/>
                  </a:lnTo>
                  <a:lnTo>
                    <a:pt x="399" y="6"/>
                  </a:lnTo>
                  <a:lnTo>
                    <a:pt x="401" y="2"/>
                  </a:lnTo>
                  <a:lnTo>
                    <a:pt x="403" y="1"/>
                  </a:lnTo>
                  <a:lnTo>
                    <a:pt x="405" y="0"/>
                  </a:lnTo>
                  <a:lnTo>
                    <a:pt x="407" y="2"/>
                  </a:lnTo>
                  <a:lnTo>
                    <a:pt x="409" y="4"/>
                  </a:lnTo>
                  <a:lnTo>
                    <a:pt x="412" y="8"/>
                  </a:lnTo>
                  <a:lnTo>
                    <a:pt x="414" y="13"/>
                  </a:lnTo>
                  <a:lnTo>
                    <a:pt x="416" y="20"/>
                  </a:lnTo>
                  <a:lnTo>
                    <a:pt x="418" y="29"/>
                  </a:lnTo>
                  <a:lnTo>
                    <a:pt x="420" y="37"/>
                  </a:lnTo>
                  <a:lnTo>
                    <a:pt x="422" y="45"/>
                  </a:lnTo>
                  <a:lnTo>
                    <a:pt x="425" y="55"/>
                  </a:lnTo>
                  <a:lnTo>
                    <a:pt x="427" y="64"/>
                  </a:lnTo>
                  <a:lnTo>
                    <a:pt x="429" y="74"/>
                  </a:lnTo>
                  <a:lnTo>
                    <a:pt x="431" y="83"/>
                  </a:lnTo>
                  <a:lnTo>
                    <a:pt x="433" y="91"/>
                  </a:lnTo>
                  <a:lnTo>
                    <a:pt x="435" y="98"/>
                  </a:lnTo>
                  <a:lnTo>
                    <a:pt x="438" y="105"/>
                  </a:lnTo>
                  <a:lnTo>
                    <a:pt x="440" y="111"/>
                  </a:lnTo>
                  <a:lnTo>
                    <a:pt x="442" y="115"/>
                  </a:lnTo>
                  <a:lnTo>
                    <a:pt x="444" y="119"/>
                  </a:lnTo>
                  <a:lnTo>
                    <a:pt x="446" y="120"/>
                  </a:lnTo>
                  <a:lnTo>
                    <a:pt x="448" y="122"/>
                  </a:lnTo>
                  <a:lnTo>
                    <a:pt x="450" y="121"/>
                  </a:lnTo>
                  <a:lnTo>
                    <a:pt x="453" y="117"/>
                  </a:lnTo>
                  <a:lnTo>
                    <a:pt x="455" y="115"/>
                  </a:lnTo>
                  <a:lnTo>
                    <a:pt x="457" y="113"/>
                  </a:lnTo>
                  <a:lnTo>
                    <a:pt x="459" y="108"/>
                  </a:lnTo>
                  <a:lnTo>
                    <a:pt x="461" y="103"/>
                  </a:lnTo>
                  <a:lnTo>
                    <a:pt x="463" y="99"/>
                  </a:lnTo>
                  <a:lnTo>
                    <a:pt x="466" y="93"/>
                  </a:lnTo>
                  <a:lnTo>
                    <a:pt x="468" y="89"/>
                  </a:lnTo>
                  <a:lnTo>
                    <a:pt x="470" y="86"/>
                  </a:lnTo>
                  <a:lnTo>
                    <a:pt x="472" y="84"/>
                  </a:lnTo>
                  <a:lnTo>
                    <a:pt x="474" y="83"/>
                  </a:lnTo>
                  <a:lnTo>
                    <a:pt x="476" y="84"/>
                  </a:lnTo>
                  <a:lnTo>
                    <a:pt x="479" y="86"/>
                  </a:lnTo>
                  <a:lnTo>
                    <a:pt x="481" y="91"/>
                  </a:lnTo>
                  <a:lnTo>
                    <a:pt x="483" y="96"/>
                  </a:lnTo>
                  <a:lnTo>
                    <a:pt x="485" y="103"/>
                  </a:lnTo>
                  <a:lnTo>
                    <a:pt x="487" y="110"/>
                  </a:lnTo>
                  <a:lnTo>
                    <a:pt x="489" y="121"/>
                  </a:lnTo>
                  <a:lnTo>
                    <a:pt x="491" y="130"/>
                  </a:lnTo>
                  <a:lnTo>
                    <a:pt x="494" y="144"/>
                  </a:lnTo>
                  <a:lnTo>
                    <a:pt x="496" y="156"/>
                  </a:lnTo>
                  <a:lnTo>
                    <a:pt x="498" y="170"/>
                  </a:lnTo>
                  <a:lnTo>
                    <a:pt x="500" y="183"/>
                  </a:lnTo>
                  <a:lnTo>
                    <a:pt x="502" y="196"/>
                  </a:lnTo>
                  <a:lnTo>
                    <a:pt x="504" y="211"/>
                  </a:lnTo>
                  <a:lnTo>
                    <a:pt x="507" y="225"/>
                  </a:lnTo>
                  <a:lnTo>
                    <a:pt x="509" y="239"/>
                  </a:lnTo>
                  <a:lnTo>
                    <a:pt x="511" y="251"/>
                  </a:lnTo>
                  <a:lnTo>
                    <a:pt x="513" y="262"/>
                  </a:lnTo>
                  <a:lnTo>
                    <a:pt x="515" y="275"/>
                  </a:lnTo>
                  <a:lnTo>
                    <a:pt x="517" y="287"/>
                  </a:lnTo>
                  <a:lnTo>
                    <a:pt x="520" y="297"/>
                  </a:lnTo>
                  <a:lnTo>
                    <a:pt x="522" y="306"/>
                  </a:lnTo>
                  <a:lnTo>
                    <a:pt x="524" y="317"/>
                  </a:lnTo>
                  <a:lnTo>
                    <a:pt x="526" y="326"/>
                  </a:lnTo>
                  <a:lnTo>
                    <a:pt x="528" y="333"/>
                  </a:lnTo>
                  <a:lnTo>
                    <a:pt x="530" y="340"/>
                  </a:lnTo>
                  <a:lnTo>
                    <a:pt x="532" y="348"/>
                  </a:lnTo>
                  <a:lnTo>
                    <a:pt x="535" y="354"/>
                  </a:lnTo>
                  <a:lnTo>
                    <a:pt x="537" y="359"/>
                  </a:lnTo>
                  <a:lnTo>
                    <a:pt x="539" y="364"/>
                  </a:lnTo>
                  <a:lnTo>
                    <a:pt x="541" y="369"/>
                  </a:lnTo>
                  <a:lnTo>
                    <a:pt x="543" y="373"/>
                  </a:lnTo>
                  <a:lnTo>
                    <a:pt x="545" y="376"/>
                  </a:lnTo>
                  <a:lnTo>
                    <a:pt x="548" y="381"/>
                  </a:lnTo>
                  <a:lnTo>
                    <a:pt x="550" y="384"/>
                  </a:lnTo>
                  <a:lnTo>
                    <a:pt x="552" y="386"/>
                  </a:lnTo>
                  <a:lnTo>
                    <a:pt x="554" y="390"/>
                  </a:lnTo>
                  <a:lnTo>
                    <a:pt x="556" y="392"/>
                  </a:lnTo>
                  <a:lnTo>
                    <a:pt x="558" y="394"/>
                  </a:lnTo>
                  <a:lnTo>
                    <a:pt x="561" y="396"/>
                  </a:lnTo>
                  <a:lnTo>
                    <a:pt x="563" y="397"/>
                  </a:lnTo>
                  <a:lnTo>
                    <a:pt x="565" y="398"/>
                  </a:lnTo>
                  <a:lnTo>
                    <a:pt x="567" y="400"/>
                  </a:lnTo>
                  <a:lnTo>
                    <a:pt x="569" y="402"/>
                  </a:lnTo>
                  <a:lnTo>
                    <a:pt x="571" y="402"/>
                  </a:lnTo>
                  <a:lnTo>
                    <a:pt x="573" y="403"/>
                  </a:lnTo>
                  <a:lnTo>
                    <a:pt x="576" y="405"/>
                  </a:lnTo>
                  <a:lnTo>
                    <a:pt x="578" y="406"/>
                  </a:lnTo>
                  <a:lnTo>
                    <a:pt x="580" y="407"/>
                  </a:lnTo>
                  <a:lnTo>
                    <a:pt x="582" y="408"/>
                  </a:lnTo>
                  <a:lnTo>
                    <a:pt x="584" y="409"/>
                  </a:lnTo>
                  <a:lnTo>
                    <a:pt x="586" y="409"/>
                  </a:lnTo>
                  <a:lnTo>
                    <a:pt x="589" y="410"/>
                  </a:lnTo>
                  <a:lnTo>
                    <a:pt x="591" y="410"/>
                  </a:lnTo>
                  <a:lnTo>
                    <a:pt x="593" y="411"/>
                  </a:lnTo>
                  <a:lnTo>
                    <a:pt x="595" y="411"/>
                  </a:lnTo>
                  <a:lnTo>
                    <a:pt x="597" y="413"/>
                  </a:lnTo>
                  <a:lnTo>
                    <a:pt x="599" y="412"/>
                  </a:lnTo>
                  <a:lnTo>
                    <a:pt x="601" y="413"/>
                  </a:lnTo>
                  <a:lnTo>
                    <a:pt x="604" y="414"/>
                  </a:lnTo>
                  <a:lnTo>
                    <a:pt x="606" y="415"/>
                  </a:lnTo>
                  <a:lnTo>
                    <a:pt x="608" y="415"/>
                  </a:lnTo>
                  <a:lnTo>
                    <a:pt x="610" y="416"/>
                  </a:lnTo>
                  <a:lnTo>
                    <a:pt x="612" y="417"/>
                  </a:lnTo>
                  <a:lnTo>
                    <a:pt x="614" y="418"/>
                  </a:lnTo>
                  <a:lnTo>
                    <a:pt x="617" y="418"/>
                  </a:lnTo>
                  <a:lnTo>
                    <a:pt x="619" y="418"/>
                  </a:lnTo>
                  <a:lnTo>
                    <a:pt x="621" y="419"/>
                  </a:lnTo>
                  <a:lnTo>
                    <a:pt x="623" y="419"/>
                  </a:lnTo>
                  <a:lnTo>
                    <a:pt x="625" y="421"/>
                  </a:lnTo>
                  <a:lnTo>
                    <a:pt x="627" y="422"/>
                  </a:lnTo>
                  <a:lnTo>
                    <a:pt x="630" y="423"/>
                  </a:lnTo>
                  <a:lnTo>
                    <a:pt x="632" y="422"/>
                  </a:lnTo>
                  <a:lnTo>
                    <a:pt x="634" y="424"/>
                  </a:lnTo>
                  <a:lnTo>
                    <a:pt x="636" y="425"/>
                  </a:lnTo>
                  <a:lnTo>
                    <a:pt x="638" y="426"/>
                  </a:lnTo>
                  <a:lnTo>
                    <a:pt x="640" y="427"/>
                  </a:lnTo>
                  <a:lnTo>
                    <a:pt x="642" y="428"/>
                  </a:lnTo>
                  <a:lnTo>
                    <a:pt x="645" y="430"/>
                  </a:lnTo>
                  <a:lnTo>
                    <a:pt x="647" y="430"/>
                  </a:lnTo>
                  <a:lnTo>
                    <a:pt x="649" y="430"/>
                  </a:lnTo>
                  <a:lnTo>
                    <a:pt x="691" y="409"/>
                  </a:lnTo>
                </a:path>
              </a:pathLst>
            </a:custGeom>
            <a:noFill/>
            <a:ln w="0">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rot="0" vert="horz" wrap="square" lIns="91440" tIns="45720" rIns="91440" bIns="45720" anchor="t" anchorCtr="0" upright="1">
              <a:noAutofit/>
            </a:bodyPr>
            <a:lstStyle/>
            <a:p>
              <a:endParaRPr lang="es-CL" sz="2800"/>
            </a:p>
          </p:txBody>
        </p:sp>
        <p:sp>
          <p:nvSpPr>
            <p:cNvPr id="254" name="Rectangle 455"/>
            <p:cNvSpPr>
              <a:spLocks noChangeArrowheads="1"/>
            </p:cNvSpPr>
            <p:nvPr/>
          </p:nvSpPr>
          <p:spPr bwMode="auto">
            <a:xfrm>
              <a:off x="4606758" y="906911"/>
              <a:ext cx="149906" cy="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dirty="0">
                  <a:solidFill>
                    <a:srgbClr val="000000"/>
                  </a:solidFill>
                  <a:latin typeface="Arial"/>
                  <a:ea typeface="Calibri"/>
                </a:rPr>
                <a:t>489.00</a:t>
              </a:r>
              <a:endParaRPr lang="es-CL" dirty="0">
                <a:latin typeface="Times New Roman"/>
                <a:ea typeface="Calibri"/>
              </a:endParaRPr>
            </a:p>
          </p:txBody>
        </p:sp>
        <p:sp>
          <p:nvSpPr>
            <p:cNvPr id="255" name="Rectangle 456"/>
            <p:cNvSpPr>
              <a:spLocks noChangeArrowheads="1"/>
            </p:cNvSpPr>
            <p:nvPr/>
          </p:nvSpPr>
          <p:spPr bwMode="auto">
            <a:xfrm>
              <a:off x="4803655" y="1057090"/>
              <a:ext cx="149906" cy="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dirty="0">
                  <a:solidFill>
                    <a:srgbClr val="000000"/>
                  </a:solidFill>
                  <a:latin typeface="Arial"/>
                  <a:ea typeface="Calibri"/>
                </a:rPr>
                <a:t>521.00</a:t>
              </a:r>
              <a:endParaRPr lang="es-CL" dirty="0">
                <a:latin typeface="Times New Roman"/>
                <a:ea typeface="Calibri"/>
              </a:endParaRPr>
            </a:p>
          </p:txBody>
        </p:sp>
        <p:sp>
          <p:nvSpPr>
            <p:cNvPr id="256" name="Rectangle 457"/>
            <p:cNvSpPr>
              <a:spLocks noChangeArrowheads="1"/>
            </p:cNvSpPr>
            <p:nvPr/>
          </p:nvSpPr>
          <p:spPr bwMode="auto">
            <a:xfrm>
              <a:off x="4409862" y="1132179"/>
              <a:ext cx="149906" cy="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dirty="0">
                  <a:solidFill>
                    <a:srgbClr val="000000"/>
                  </a:solidFill>
                  <a:latin typeface="Arial"/>
                  <a:ea typeface="Calibri"/>
                </a:rPr>
                <a:t>465.00</a:t>
              </a:r>
              <a:endParaRPr lang="es-CL" dirty="0">
                <a:latin typeface="Times New Roman"/>
                <a:ea typeface="Calibri"/>
              </a:endParaRPr>
            </a:p>
          </p:txBody>
        </p:sp>
        <p:cxnSp>
          <p:nvCxnSpPr>
            <p:cNvPr id="257" name="Line 458"/>
            <p:cNvCxnSpPr/>
            <p:nvPr/>
          </p:nvCxnSpPr>
          <p:spPr bwMode="auto">
            <a:xfrm flipH="1" flipV="1">
              <a:off x="4493402" y="1277543"/>
              <a:ext cx="50586" cy="3876"/>
            </a:xfrm>
            <a:prstGeom prst="line">
              <a:avLst/>
            </a:prstGeom>
            <a:noFill/>
            <a:ln w="0">
              <a:solidFill>
                <a:srgbClr val="46B446"/>
              </a:solidFill>
              <a:prstDash val="solid"/>
              <a:round/>
              <a:headEnd/>
              <a:tailEnd/>
            </a:ln>
            <a:extLst>
              <a:ext uri="{909E8E84-426E-40DD-AFC4-6F175D3DCCD1}">
                <a14:hiddenFill xmlns:a14="http://schemas.microsoft.com/office/drawing/2010/main">
                  <a:noFill/>
                </a14:hiddenFill>
              </a:ext>
            </a:extLst>
          </p:spPr>
        </p:cxnSp>
        <p:sp>
          <p:nvSpPr>
            <p:cNvPr id="258" name="Rectangle 459"/>
            <p:cNvSpPr>
              <a:spLocks noChangeArrowheads="1"/>
            </p:cNvSpPr>
            <p:nvPr/>
          </p:nvSpPr>
          <p:spPr bwMode="auto">
            <a:xfrm>
              <a:off x="4055448" y="1244814"/>
              <a:ext cx="149906" cy="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dirty="0">
                  <a:solidFill>
                    <a:srgbClr val="000000"/>
                  </a:solidFill>
                  <a:latin typeface="Arial"/>
                  <a:ea typeface="Calibri"/>
                </a:rPr>
                <a:t>388.00</a:t>
              </a:r>
              <a:endParaRPr lang="es-CL" dirty="0">
                <a:latin typeface="Times New Roman"/>
                <a:ea typeface="Calibri"/>
              </a:endParaRPr>
            </a:p>
          </p:txBody>
        </p:sp>
        <p:sp>
          <p:nvSpPr>
            <p:cNvPr id="259" name="Rectangle 460"/>
            <p:cNvSpPr>
              <a:spLocks noChangeArrowheads="1"/>
            </p:cNvSpPr>
            <p:nvPr/>
          </p:nvSpPr>
          <p:spPr bwMode="auto">
            <a:xfrm>
              <a:off x="3869785" y="1394993"/>
              <a:ext cx="149906" cy="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dirty="0">
                  <a:solidFill>
                    <a:srgbClr val="000000"/>
                  </a:solidFill>
                  <a:latin typeface="Arial"/>
                  <a:ea typeface="Calibri"/>
                </a:rPr>
                <a:t>367.00</a:t>
              </a:r>
              <a:endParaRPr lang="es-CL" dirty="0">
                <a:latin typeface="Times New Roman"/>
                <a:ea typeface="Calibri"/>
              </a:endParaRPr>
            </a:p>
          </p:txBody>
        </p:sp>
        <p:cxnSp>
          <p:nvCxnSpPr>
            <p:cNvPr id="260" name="Line 461"/>
            <p:cNvCxnSpPr/>
            <p:nvPr/>
          </p:nvCxnSpPr>
          <p:spPr bwMode="auto">
            <a:xfrm flipH="1" flipV="1">
              <a:off x="3966355" y="1553459"/>
              <a:ext cx="40642" cy="3876"/>
            </a:xfrm>
            <a:prstGeom prst="line">
              <a:avLst/>
            </a:prstGeom>
            <a:noFill/>
            <a:ln w="0">
              <a:solidFill>
                <a:srgbClr val="46B446"/>
              </a:solidFill>
              <a:prstDash val="solid"/>
              <a:round/>
              <a:headEnd/>
              <a:tailEnd/>
            </a:ln>
            <a:extLst>
              <a:ext uri="{909E8E84-426E-40DD-AFC4-6F175D3DCCD1}">
                <a14:hiddenFill xmlns:a14="http://schemas.microsoft.com/office/drawing/2010/main">
                  <a:noFill/>
                </a14:hiddenFill>
              </a:ext>
            </a:extLst>
          </p:spPr>
        </p:cxnSp>
        <p:sp>
          <p:nvSpPr>
            <p:cNvPr id="261" name="Rectangle 462"/>
            <p:cNvSpPr>
              <a:spLocks noChangeArrowheads="1"/>
            </p:cNvSpPr>
            <p:nvPr/>
          </p:nvSpPr>
          <p:spPr bwMode="auto">
            <a:xfrm>
              <a:off x="3701034" y="1545172"/>
              <a:ext cx="149906" cy="740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rot="0" vert="horz" wrap="none" lIns="0" tIns="0" rIns="0" bIns="0" anchor="t" anchorCtr="0">
              <a:spAutoFit/>
            </a:bodyPr>
            <a:lstStyle/>
            <a:p>
              <a:pPr algn="just">
                <a:lnSpc>
                  <a:spcPct val="150000"/>
                </a:lnSpc>
                <a:spcAft>
                  <a:spcPts val="1000"/>
                </a:spcAft>
              </a:pPr>
              <a:r>
                <a:rPr lang="en-US" sz="700" dirty="0">
                  <a:solidFill>
                    <a:srgbClr val="000000"/>
                  </a:solidFill>
                  <a:latin typeface="Arial"/>
                  <a:ea typeface="Calibri"/>
                </a:rPr>
                <a:t>317.00</a:t>
              </a:r>
              <a:endParaRPr lang="es-CL" dirty="0">
                <a:latin typeface="Times New Roman"/>
                <a:ea typeface="Calibri"/>
              </a:endParaRPr>
            </a:p>
          </p:txBody>
        </p:sp>
      </p:grpSp>
      <p:sp>
        <p:nvSpPr>
          <p:cNvPr id="262" name="261 CuadroTexto"/>
          <p:cNvSpPr txBox="1"/>
          <p:nvPr/>
        </p:nvSpPr>
        <p:spPr>
          <a:xfrm>
            <a:off x="251520" y="260650"/>
            <a:ext cx="8640960" cy="461665"/>
          </a:xfrm>
          <a:prstGeom prst="rect">
            <a:avLst/>
          </a:prstGeom>
          <a:noFill/>
        </p:spPr>
        <p:txBody>
          <a:bodyPr wrap="square" rtlCol="0">
            <a:spAutoFit/>
          </a:bodyPr>
          <a:lstStyle/>
          <a:p>
            <a:pPr algn="just"/>
            <a:r>
              <a:rPr lang="es-CL" sz="1200" b="1" dirty="0">
                <a:latin typeface="Times New Roman" pitchFamily="18" charset="0"/>
                <a:cs typeface="Times New Roman" pitchFamily="18" charset="0"/>
              </a:rPr>
              <a:t>Supporting information Figure S4 B. </a:t>
            </a:r>
            <a:r>
              <a:rPr lang="es-CL" sz="1200" dirty="0">
                <a:latin typeface="Times New Roman" pitchFamily="18" charset="0"/>
                <a:cs typeface="Times New Roman" pitchFamily="18" charset="0"/>
              </a:rPr>
              <a:t>Chromatographic and spectrometric analyses of Subfraction FI-3 (retention time: 12.10 min) from methanolic extracts of </a:t>
            </a:r>
            <a:r>
              <a:rPr lang="en-US" sz="1200" i="1" dirty="0">
                <a:latin typeface="Times New Roman" pitchFamily="18" charset="0"/>
                <a:cs typeface="Times New Roman" pitchFamily="18" charset="0"/>
              </a:rPr>
              <a:t>Haloterrigena</a:t>
            </a:r>
            <a:r>
              <a:rPr lang="en-US" sz="1200" dirty="0">
                <a:latin typeface="Times New Roman" pitchFamily="18" charset="0"/>
                <a:cs typeface="Times New Roman" pitchFamily="18" charset="0"/>
              </a:rPr>
              <a:t> sp. strain SGH1. </a:t>
            </a:r>
          </a:p>
        </p:txBody>
      </p:sp>
      <p:pic>
        <p:nvPicPr>
          <p:cNvPr id="264" name="263 Imagen"/>
          <p:cNvPicPr/>
          <p:nvPr/>
        </p:nvPicPr>
        <p:blipFill rotWithShape="1">
          <a:blip r:embed="rId3"/>
          <a:srcRect l="18854" t="10730" r="7693" b="12277"/>
          <a:stretch/>
        </p:blipFill>
        <p:spPr bwMode="auto">
          <a:xfrm>
            <a:off x="1403648" y="962728"/>
            <a:ext cx="3814478" cy="2248713"/>
          </a:xfrm>
          <a:prstGeom prst="rect">
            <a:avLst/>
          </a:prstGeom>
          <a:ln>
            <a:noFill/>
          </a:ln>
          <a:extLst>
            <a:ext uri="{53640926-AAD7-44D8-BBD7-CCE9431645EC}">
              <a14:shadowObscured xmlns:a14="http://schemas.microsoft.com/office/drawing/2010/main"/>
            </a:ext>
          </a:extLst>
        </p:spPr>
      </p:pic>
    </p:spTree>
    <p:extLst>
      <p:ext uri="{BB962C8B-B14F-4D97-AF65-F5344CB8AC3E}">
        <p14:creationId xmlns:p14="http://schemas.microsoft.com/office/powerpoint/2010/main" val="358081962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2 Imagen"/>
          <p:cNvPicPr/>
          <p:nvPr/>
        </p:nvPicPr>
        <p:blipFill rotWithShape="1">
          <a:blip r:embed="rId2">
            <a:extLst>
              <a:ext uri="{28A0092B-C50C-407E-A947-70E740481C1C}">
                <a14:useLocalDpi xmlns:a14="http://schemas.microsoft.com/office/drawing/2010/main" val="0"/>
              </a:ext>
            </a:extLst>
          </a:blip>
          <a:srcRect t="38276" r="6549"/>
          <a:stretch/>
        </p:blipFill>
        <p:spPr bwMode="auto">
          <a:xfrm>
            <a:off x="323530" y="980728"/>
            <a:ext cx="4956443" cy="2088232"/>
          </a:xfrm>
          <a:prstGeom prst="rect">
            <a:avLst/>
          </a:prstGeom>
          <a:noFill/>
          <a:ln>
            <a:noFill/>
          </a:ln>
          <a:extLst>
            <a:ext uri="{53640926-AAD7-44D8-BBD7-CCE9431645EC}">
              <a14:shadowObscured xmlns:a14="http://schemas.microsoft.com/office/drawing/2010/main"/>
            </a:ext>
          </a:extLst>
        </p:spPr>
      </p:pic>
      <p:pic>
        <p:nvPicPr>
          <p:cNvPr id="4" name="3 Imagen"/>
          <p:cNvPicPr/>
          <p:nvPr/>
        </p:nvPicPr>
        <p:blipFill rotWithShape="1">
          <a:blip r:embed="rId3" cstate="print">
            <a:extLst>
              <a:ext uri="{28A0092B-C50C-407E-A947-70E740481C1C}">
                <a14:useLocalDpi xmlns:a14="http://schemas.microsoft.com/office/drawing/2010/main" val="0"/>
              </a:ext>
            </a:extLst>
          </a:blip>
          <a:srcRect t="25234" r="10156"/>
          <a:stretch/>
        </p:blipFill>
        <p:spPr bwMode="auto">
          <a:xfrm>
            <a:off x="5292080" y="800532"/>
            <a:ext cx="3672408" cy="2340436"/>
          </a:xfrm>
          <a:prstGeom prst="rect">
            <a:avLst/>
          </a:prstGeom>
          <a:noFill/>
          <a:ln>
            <a:noFill/>
          </a:ln>
          <a:extLst>
            <a:ext uri="{53640926-AAD7-44D8-BBD7-CCE9431645EC}">
              <a14:shadowObscured xmlns:a14="http://schemas.microsoft.com/office/drawing/2010/main"/>
            </a:ext>
          </a:extLst>
        </p:spPr>
      </p:pic>
      <p:pic>
        <p:nvPicPr>
          <p:cNvPr id="5" name="4 Imagen"/>
          <p:cNvPicPr/>
          <p:nvPr/>
        </p:nvPicPr>
        <p:blipFill rotWithShape="1">
          <a:blip r:embed="rId4">
            <a:extLst>
              <a:ext uri="{28A0092B-C50C-407E-A947-70E740481C1C}">
                <a14:useLocalDpi xmlns:a14="http://schemas.microsoft.com/office/drawing/2010/main" val="0"/>
              </a:ext>
            </a:extLst>
          </a:blip>
          <a:srcRect t="5911"/>
          <a:stretch/>
        </p:blipFill>
        <p:spPr bwMode="auto">
          <a:xfrm>
            <a:off x="611560" y="3331294"/>
            <a:ext cx="7848872" cy="3194050"/>
          </a:xfrm>
          <a:prstGeom prst="rect">
            <a:avLst/>
          </a:prstGeom>
          <a:noFill/>
          <a:ln>
            <a:noFill/>
          </a:ln>
          <a:extLst>
            <a:ext uri="{53640926-AAD7-44D8-BBD7-CCE9431645EC}">
              <a14:shadowObscured xmlns:a14="http://schemas.microsoft.com/office/drawing/2010/main"/>
            </a:ext>
          </a:extLst>
        </p:spPr>
      </p:pic>
      <p:sp>
        <p:nvSpPr>
          <p:cNvPr id="8" name="7 CuadroTexto"/>
          <p:cNvSpPr txBox="1"/>
          <p:nvPr/>
        </p:nvSpPr>
        <p:spPr>
          <a:xfrm>
            <a:off x="251520" y="260650"/>
            <a:ext cx="8640960" cy="461665"/>
          </a:xfrm>
          <a:prstGeom prst="rect">
            <a:avLst/>
          </a:prstGeom>
          <a:noFill/>
        </p:spPr>
        <p:txBody>
          <a:bodyPr wrap="square" rtlCol="0">
            <a:spAutoFit/>
          </a:bodyPr>
          <a:lstStyle/>
          <a:p>
            <a:pPr algn="just"/>
            <a:r>
              <a:rPr lang="es-CL" sz="1200" b="1" dirty="0">
                <a:latin typeface="Times New Roman" pitchFamily="18" charset="0"/>
                <a:cs typeface="Times New Roman" pitchFamily="18" charset="0"/>
              </a:rPr>
              <a:t>Supporting information Figure S4 C. </a:t>
            </a:r>
            <a:r>
              <a:rPr lang="es-CL" sz="1200" dirty="0">
                <a:latin typeface="Times New Roman" pitchFamily="18" charset="0"/>
                <a:cs typeface="Times New Roman" pitchFamily="18" charset="0"/>
              </a:rPr>
              <a:t>Chromatographic and spectrometric analyses of Subfraction FII-1 (retention time: 11.21 min) from methanolic extracts of </a:t>
            </a:r>
            <a:r>
              <a:rPr lang="en-US" sz="1200" i="1" dirty="0">
                <a:latin typeface="Times New Roman" pitchFamily="18" charset="0"/>
                <a:cs typeface="Times New Roman" pitchFamily="18" charset="0"/>
              </a:rPr>
              <a:t>Haloterrigena</a:t>
            </a:r>
            <a:r>
              <a:rPr lang="en-US" sz="1200" dirty="0">
                <a:latin typeface="Times New Roman" pitchFamily="18" charset="0"/>
                <a:cs typeface="Times New Roman" pitchFamily="18" charset="0"/>
              </a:rPr>
              <a:t> sp. strain SGH1. </a:t>
            </a:r>
          </a:p>
        </p:txBody>
      </p:sp>
    </p:spTree>
    <p:extLst>
      <p:ext uri="{BB962C8B-B14F-4D97-AF65-F5344CB8AC3E}">
        <p14:creationId xmlns:p14="http://schemas.microsoft.com/office/powerpoint/2010/main" val="314079670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1 Imagen"/>
          <p:cNvPicPr/>
          <p:nvPr/>
        </p:nvPicPr>
        <p:blipFill rotWithShape="1">
          <a:blip r:embed="rId2">
            <a:extLst>
              <a:ext uri="{28A0092B-C50C-407E-A947-70E740481C1C}">
                <a14:useLocalDpi xmlns:a14="http://schemas.microsoft.com/office/drawing/2010/main" val="0"/>
              </a:ext>
            </a:extLst>
          </a:blip>
          <a:srcRect r="6551"/>
          <a:stretch/>
        </p:blipFill>
        <p:spPr bwMode="auto">
          <a:xfrm>
            <a:off x="323528" y="908720"/>
            <a:ext cx="6336704" cy="2520280"/>
          </a:xfrm>
          <a:prstGeom prst="rect">
            <a:avLst/>
          </a:prstGeom>
          <a:noFill/>
          <a:ln>
            <a:noFill/>
          </a:ln>
          <a:extLst>
            <a:ext uri="{53640926-AAD7-44D8-BBD7-CCE9431645EC}">
              <a14:shadowObscured xmlns:a14="http://schemas.microsoft.com/office/drawing/2010/main"/>
            </a:ext>
          </a:extLst>
        </p:spPr>
      </p:pic>
      <p:pic>
        <p:nvPicPr>
          <p:cNvPr id="3" name="2 Imagen"/>
          <p:cNvPicPr/>
          <p:nvPr/>
        </p:nvPicPr>
        <p:blipFill rotWithShape="1">
          <a:blip r:embed="rId3">
            <a:extLst>
              <a:ext uri="{28A0092B-C50C-407E-A947-70E740481C1C}">
                <a14:useLocalDpi xmlns:a14="http://schemas.microsoft.com/office/drawing/2010/main" val="0"/>
              </a:ext>
            </a:extLst>
          </a:blip>
          <a:srcRect t="5863"/>
          <a:stretch/>
        </p:blipFill>
        <p:spPr bwMode="auto">
          <a:xfrm>
            <a:off x="395536" y="3645024"/>
            <a:ext cx="8280920" cy="2736304"/>
          </a:xfrm>
          <a:prstGeom prst="rect">
            <a:avLst/>
          </a:prstGeom>
          <a:noFill/>
          <a:ln>
            <a:noFill/>
          </a:ln>
          <a:extLst>
            <a:ext uri="{53640926-AAD7-44D8-BBD7-CCE9431645EC}">
              <a14:shadowObscured xmlns:a14="http://schemas.microsoft.com/office/drawing/2010/main"/>
            </a:ext>
          </a:extLst>
        </p:spPr>
      </p:pic>
      <p:sp>
        <p:nvSpPr>
          <p:cNvPr id="8" name="7 CuadroTexto"/>
          <p:cNvSpPr txBox="1"/>
          <p:nvPr/>
        </p:nvSpPr>
        <p:spPr>
          <a:xfrm>
            <a:off x="251520" y="260650"/>
            <a:ext cx="8640960" cy="461665"/>
          </a:xfrm>
          <a:prstGeom prst="rect">
            <a:avLst/>
          </a:prstGeom>
          <a:noFill/>
        </p:spPr>
        <p:txBody>
          <a:bodyPr wrap="square" rtlCol="0">
            <a:spAutoFit/>
          </a:bodyPr>
          <a:lstStyle/>
          <a:p>
            <a:pPr algn="just"/>
            <a:r>
              <a:rPr lang="es-CL" sz="1200" b="1" dirty="0">
                <a:latin typeface="Times New Roman" pitchFamily="18" charset="0"/>
                <a:cs typeface="Times New Roman" pitchFamily="18" charset="0"/>
              </a:rPr>
              <a:t>Supporting information Figure S4 D. </a:t>
            </a:r>
            <a:r>
              <a:rPr lang="es-CL" sz="1200" dirty="0">
                <a:latin typeface="Times New Roman" pitchFamily="18" charset="0"/>
                <a:cs typeface="Times New Roman" pitchFamily="18" charset="0"/>
              </a:rPr>
              <a:t>Chromatographic and spectrometric analyses of Subfraction FIII-1 (retention time: 10.39 min) from methanolic extracts of </a:t>
            </a:r>
            <a:r>
              <a:rPr lang="en-US" sz="1200" i="1" dirty="0">
                <a:latin typeface="Times New Roman" pitchFamily="18" charset="0"/>
                <a:cs typeface="Times New Roman" pitchFamily="18" charset="0"/>
              </a:rPr>
              <a:t>Haloterrigena</a:t>
            </a:r>
            <a:r>
              <a:rPr lang="en-US" sz="1200" dirty="0">
                <a:latin typeface="Times New Roman" pitchFamily="18" charset="0"/>
                <a:cs typeface="Times New Roman" pitchFamily="18" charset="0"/>
              </a:rPr>
              <a:t> sp. strain SGH1. </a:t>
            </a:r>
          </a:p>
        </p:txBody>
      </p:sp>
      <p:pic>
        <p:nvPicPr>
          <p:cNvPr id="4" name="3 Imagen"/>
          <p:cNvPicPr/>
          <p:nvPr/>
        </p:nvPicPr>
        <p:blipFill rotWithShape="1">
          <a:blip r:embed="rId4" cstate="print">
            <a:extLst>
              <a:ext uri="{28A0092B-C50C-407E-A947-70E740481C1C}">
                <a14:useLocalDpi xmlns:a14="http://schemas.microsoft.com/office/drawing/2010/main" val="0"/>
              </a:ext>
            </a:extLst>
          </a:blip>
          <a:srcRect t="12225"/>
          <a:stretch/>
        </p:blipFill>
        <p:spPr bwMode="auto">
          <a:xfrm>
            <a:off x="5724128" y="980728"/>
            <a:ext cx="3096344" cy="2160240"/>
          </a:xfrm>
          <a:prstGeom prst="rect">
            <a:avLst/>
          </a:prstGeom>
          <a:solidFill>
            <a:schemeClr val="bg1"/>
          </a:solidFill>
          <a:ln>
            <a:noFill/>
          </a:ln>
          <a:extLst>
            <a:ext uri="{53640926-AAD7-44D8-BBD7-CCE9431645EC}">
              <a14:shadowObscured xmlns:a14="http://schemas.microsoft.com/office/drawing/2010/main"/>
            </a:ext>
          </a:extLst>
        </p:spPr>
      </p:pic>
    </p:spTree>
    <p:extLst>
      <p:ext uri="{BB962C8B-B14F-4D97-AF65-F5344CB8AC3E}">
        <p14:creationId xmlns:p14="http://schemas.microsoft.com/office/powerpoint/2010/main" val="2411400421"/>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493</TotalTime>
  <Words>1140</Words>
  <Application>Microsoft Office PowerPoint</Application>
  <PresentationFormat>Presentación en pantalla (4:3)</PresentationFormat>
  <Paragraphs>81</Paragraphs>
  <Slides>14</Slides>
  <Notes>1</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14</vt:i4>
      </vt:variant>
    </vt:vector>
  </HeadingPairs>
  <TitlesOfParts>
    <vt:vector size="19" baseType="lpstr">
      <vt:lpstr>Arial</vt:lpstr>
      <vt:lpstr>Calibri</vt:lpstr>
      <vt:lpstr>Symbol</vt:lpstr>
      <vt:lpstr>Times New Roman</vt:lpstr>
      <vt:lpstr>Tema de Office</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Company>Hewlett-Packard Compan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Benito Gomez</dc:creator>
  <cp:lastModifiedBy>Benito Gomez</cp:lastModifiedBy>
  <cp:revision>91</cp:revision>
  <dcterms:created xsi:type="dcterms:W3CDTF">2019-07-04T20:28:43Z</dcterms:created>
  <dcterms:modified xsi:type="dcterms:W3CDTF">2020-02-12T01:07:48Z</dcterms:modified>
</cp:coreProperties>
</file>